
<file path=[Content_Types].xml><?xml version="1.0" encoding="utf-8"?>
<Types xmlns="http://schemas.openxmlformats.org/package/2006/content-types">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354" r:id="rId2"/>
    <p:sldId id="258" r:id="rId3"/>
    <p:sldId id="356" r:id="rId4"/>
    <p:sldId id="352" r:id="rId5"/>
    <p:sldId id="285" r:id="rId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DBB99"/>
    <a:srgbClr val="E59866"/>
    <a:srgbClr val="F6DDCC"/>
    <a:srgbClr val="FBEEE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FF03036-CD6D-4DF2-877F-2FC965683AD8}" v="4" dt="2020-09-17T19:04:03.65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985" autoAdjust="0"/>
    <p:restoredTop sz="92042" autoAdjust="0"/>
  </p:normalViewPr>
  <p:slideViewPr>
    <p:cSldViewPr snapToGrid="0">
      <p:cViewPr>
        <p:scale>
          <a:sx n="66" d="100"/>
          <a:sy n="66" d="100"/>
        </p:scale>
        <p:origin x="1368" y="9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vijay kumar" userId="0eb738f014aa4543" providerId="LiveId" clId="{FFF03036-CD6D-4DF2-877F-2FC965683AD8}"/>
    <pc:docChg chg="undo custSel modSld">
      <pc:chgData name="vijay kumar" userId="0eb738f014aa4543" providerId="LiveId" clId="{FFF03036-CD6D-4DF2-877F-2FC965683AD8}" dt="2020-09-17T19:04:03.657" v="186" actId="164"/>
      <pc:docMkLst>
        <pc:docMk/>
      </pc:docMkLst>
      <pc:sldChg chg="addSp delSp modSp mod">
        <pc:chgData name="vijay kumar" userId="0eb738f014aa4543" providerId="LiveId" clId="{FFF03036-CD6D-4DF2-877F-2FC965683AD8}" dt="2020-09-17T19:04:03.657" v="186" actId="164"/>
        <pc:sldMkLst>
          <pc:docMk/>
          <pc:sldMk cId="2361193530" sldId="352"/>
        </pc:sldMkLst>
        <pc:spChg chg="add mod">
          <ac:chgData name="vijay kumar" userId="0eb738f014aa4543" providerId="LiveId" clId="{FFF03036-CD6D-4DF2-877F-2FC965683AD8}" dt="2020-09-17T19:04:03.657" v="186" actId="164"/>
          <ac:spMkLst>
            <pc:docMk/>
            <pc:sldMk cId="2361193530" sldId="352"/>
            <ac:spMk id="2" creationId="{79BCAFA9-F9F3-48F1-9B27-40740B0A6D54}"/>
          </ac:spMkLst>
        </pc:spChg>
        <pc:spChg chg="add mod">
          <ac:chgData name="vijay kumar" userId="0eb738f014aa4543" providerId="LiveId" clId="{FFF03036-CD6D-4DF2-877F-2FC965683AD8}" dt="2020-09-17T19:04:03.657" v="186" actId="164"/>
          <ac:spMkLst>
            <pc:docMk/>
            <pc:sldMk cId="2361193530" sldId="352"/>
            <ac:spMk id="4" creationId="{9ECDAFA2-21F9-46F3-8471-E50FB2D58C44}"/>
          </ac:spMkLst>
        </pc:spChg>
        <pc:spChg chg="add mod">
          <ac:chgData name="vijay kumar" userId="0eb738f014aa4543" providerId="LiveId" clId="{FFF03036-CD6D-4DF2-877F-2FC965683AD8}" dt="2020-09-17T19:04:03.657" v="186" actId="164"/>
          <ac:spMkLst>
            <pc:docMk/>
            <pc:sldMk cId="2361193530" sldId="352"/>
            <ac:spMk id="9" creationId="{CC1B2478-3950-455E-B061-9456FE2BDCEA}"/>
          </ac:spMkLst>
        </pc:spChg>
        <pc:spChg chg="add mod">
          <ac:chgData name="vijay kumar" userId="0eb738f014aa4543" providerId="LiveId" clId="{FFF03036-CD6D-4DF2-877F-2FC965683AD8}" dt="2020-09-17T19:04:03.657" v="186" actId="164"/>
          <ac:spMkLst>
            <pc:docMk/>
            <pc:sldMk cId="2361193530" sldId="352"/>
            <ac:spMk id="10" creationId="{3564886C-C3A3-401F-B989-CBCDFC63ADEE}"/>
          </ac:spMkLst>
        </pc:spChg>
        <pc:grpChg chg="mod">
          <ac:chgData name="vijay kumar" userId="0eb738f014aa4543" providerId="LiveId" clId="{FFF03036-CD6D-4DF2-877F-2FC965683AD8}" dt="2020-09-17T19:04:03.657" v="186" actId="164"/>
          <ac:grpSpMkLst>
            <pc:docMk/>
            <pc:sldMk cId="2361193530" sldId="352"/>
            <ac:grpSpMk id="3" creationId="{84392485-1A4B-4CCE-B2D0-A0F67F143354}"/>
          </ac:grpSpMkLst>
        </pc:grpChg>
        <pc:grpChg chg="add mod">
          <ac:chgData name="vijay kumar" userId="0eb738f014aa4543" providerId="LiveId" clId="{FFF03036-CD6D-4DF2-877F-2FC965683AD8}" dt="2020-09-17T19:04:03.657" v="186" actId="164"/>
          <ac:grpSpMkLst>
            <pc:docMk/>
            <pc:sldMk cId="2361193530" sldId="352"/>
            <ac:grpSpMk id="11" creationId="{8A2BA454-BFC7-4FA5-AC72-E660C8A1DD85}"/>
          </ac:grpSpMkLst>
        </pc:grpChg>
        <pc:cxnChg chg="add mod">
          <ac:chgData name="vijay kumar" userId="0eb738f014aa4543" providerId="LiveId" clId="{FFF03036-CD6D-4DF2-877F-2FC965683AD8}" dt="2020-09-17T19:04:03.657" v="186" actId="164"/>
          <ac:cxnSpMkLst>
            <pc:docMk/>
            <pc:sldMk cId="2361193530" sldId="352"/>
            <ac:cxnSpMk id="6" creationId="{A682883C-A06F-4EDD-B95C-2145F9EAE5CF}"/>
          </ac:cxnSpMkLst>
        </pc:cxnChg>
        <pc:cxnChg chg="add del">
          <ac:chgData name="vijay kumar" userId="0eb738f014aa4543" providerId="LiveId" clId="{FFF03036-CD6D-4DF2-877F-2FC965683AD8}" dt="2020-09-17T17:51:58.155" v="39" actId="478"/>
          <ac:cxnSpMkLst>
            <pc:docMk/>
            <pc:sldMk cId="2361193530" sldId="352"/>
            <ac:cxnSpMk id="8" creationId="{4D23056E-5F04-49B7-ACD9-8A0019C72018}"/>
          </ac:cxnSpMkLst>
        </pc:cxnChg>
        <pc:cxnChg chg="add mod">
          <ac:chgData name="vijay kumar" userId="0eb738f014aa4543" providerId="LiveId" clId="{FFF03036-CD6D-4DF2-877F-2FC965683AD8}" dt="2020-09-17T19:04:03.657" v="186" actId="164"/>
          <ac:cxnSpMkLst>
            <pc:docMk/>
            <pc:sldMk cId="2361193530" sldId="352"/>
            <ac:cxnSpMk id="23" creationId="{0737ECCC-E1C2-4EFB-9F91-9A1D374F10E4}"/>
          </ac:cxnSpMkLst>
        </pc:cxnChg>
      </pc:sldChg>
    </pc:docChg>
  </pc:docChgLst>
  <pc:docChgLst>
    <pc:chgData name="vijay kumar" userId="0eb738f014aa4543" providerId="LiveId" clId="{B4DB2928-3EFF-4507-ABD0-3894F091460A}"/>
    <pc:docChg chg="undo redo custSel addSld delSld modSld sldOrd">
      <pc:chgData name="vijay kumar" userId="0eb738f014aa4543" providerId="LiveId" clId="{B4DB2928-3EFF-4507-ABD0-3894F091460A}" dt="2020-05-24T19:31:55.002" v="15202" actId="20577"/>
      <pc:docMkLst>
        <pc:docMk/>
      </pc:docMkLst>
      <pc:sldChg chg="addSp delSp modSp add mod ord">
        <pc:chgData name="vijay kumar" userId="0eb738f014aa4543" providerId="LiveId" clId="{B4DB2928-3EFF-4507-ABD0-3894F091460A}" dt="2020-05-24T14:29:11.794" v="15181" actId="14100"/>
        <pc:sldMkLst>
          <pc:docMk/>
          <pc:sldMk cId="0" sldId="258"/>
        </pc:sldMkLst>
        <pc:spChg chg="del">
          <ac:chgData name="vijay kumar" userId="0eb738f014aa4543" providerId="LiveId" clId="{B4DB2928-3EFF-4507-ABD0-3894F091460A}" dt="2020-05-04T11:36:29.879" v="7429" actId="478"/>
          <ac:spMkLst>
            <pc:docMk/>
            <pc:sldMk cId="0" sldId="258"/>
            <ac:spMk id="3" creationId="{00000000-0000-0000-0000-000000000000}"/>
          </ac:spMkLst>
        </pc:spChg>
        <pc:spChg chg="del mod topLvl">
          <ac:chgData name="vijay kumar" userId="0eb738f014aa4543" providerId="LiveId" clId="{B4DB2928-3EFF-4507-ABD0-3894F091460A}" dt="2020-04-28T08:18:43.297" v="769" actId="478"/>
          <ac:spMkLst>
            <pc:docMk/>
            <pc:sldMk cId="0" sldId="258"/>
            <ac:spMk id="9" creationId="{FA3E330A-1553-46DE-9C29-4E00CC35E838}"/>
          </ac:spMkLst>
        </pc:spChg>
        <pc:spChg chg="del mod topLvl">
          <ac:chgData name="vijay kumar" userId="0eb738f014aa4543" providerId="LiveId" clId="{B4DB2928-3EFF-4507-ABD0-3894F091460A}" dt="2020-04-28T08:18:42.500" v="768" actId="478"/>
          <ac:spMkLst>
            <pc:docMk/>
            <pc:sldMk cId="0" sldId="258"/>
            <ac:spMk id="10" creationId="{84F4CF7B-5C2B-4639-A4ED-D305A450E512}"/>
          </ac:spMkLst>
        </pc:spChg>
        <pc:spChg chg="del mod topLvl">
          <ac:chgData name="vijay kumar" userId="0eb738f014aa4543" providerId="LiveId" clId="{B4DB2928-3EFF-4507-ABD0-3894F091460A}" dt="2020-04-28T09:07:29.949" v="1872" actId="478"/>
          <ac:spMkLst>
            <pc:docMk/>
            <pc:sldMk cId="0" sldId="258"/>
            <ac:spMk id="11" creationId="{34A259E5-56B4-4D61-8610-9FE9FD375997}"/>
          </ac:spMkLst>
        </pc:spChg>
        <pc:spChg chg="del mod topLvl">
          <ac:chgData name="vijay kumar" userId="0eb738f014aa4543" providerId="LiveId" clId="{B4DB2928-3EFF-4507-ABD0-3894F091460A}" dt="2020-04-28T09:26:17.384" v="3135" actId="478"/>
          <ac:spMkLst>
            <pc:docMk/>
            <pc:sldMk cId="0" sldId="258"/>
            <ac:spMk id="14" creationId="{51A021F0-1CCB-454E-9589-61CEE6F6374F}"/>
          </ac:spMkLst>
        </pc:spChg>
        <pc:spChg chg="add del mod topLvl">
          <ac:chgData name="vijay kumar" userId="0eb738f014aa4543" providerId="LiveId" clId="{B4DB2928-3EFF-4507-ABD0-3894F091460A}" dt="2020-04-28T09:16:39.292" v="2534" actId="478"/>
          <ac:spMkLst>
            <pc:docMk/>
            <pc:sldMk cId="0" sldId="258"/>
            <ac:spMk id="15" creationId="{E4FB4AE8-9736-44A4-BC83-39F49FB4ABBE}"/>
          </ac:spMkLst>
        </pc:spChg>
        <pc:spChg chg="mod topLvl">
          <ac:chgData name="vijay kumar" userId="0eb738f014aa4543" providerId="LiveId" clId="{B4DB2928-3EFF-4507-ABD0-3894F091460A}" dt="2020-05-09T15:05:53.967" v="14501" actId="1038"/>
          <ac:spMkLst>
            <pc:docMk/>
            <pc:sldMk cId="0" sldId="258"/>
            <ac:spMk id="16" creationId="{D855CE17-BFF0-48C4-8230-65C652E09FA0}"/>
          </ac:spMkLst>
        </pc:spChg>
        <pc:spChg chg="mod topLvl">
          <ac:chgData name="vijay kumar" userId="0eb738f014aa4543" providerId="LiveId" clId="{B4DB2928-3EFF-4507-ABD0-3894F091460A}" dt="2020-05-09T15:05:53.967" v="14501" actId="1038"/>
          <ac:spMkLst>
            <pc:docMk/>
            <pc:sldMk cId="0" sldId="258"/>
            <ac:spMk id="17" creationId="{87E99EBF-942B-435A-AAB3-A1D7E9C22A4D}"/>
          </ac:spMkLst>
        </pc:spChg>
        <pc:spChg chg="del mod topLvl">
          <ac:chgData name="vijay kumar" userId="0eb738f014aa4543" providerId="LiveId" clId="{B4DB2928-3EFF-4507-ABD0-3894F091460A}" dt="2020-04-28T08:36:12.508" v="1043" actId="478"/>
          <ac:spMkLst>
            <pc:docMk/>
            <pc:sldMk cId="0" sldId="258"/>
            <ac:spMk id="18" creationId="{CEC6B3C9-1A03-4BC8-80CD-BB4420D6BC77}"/>
          </ac:spMkLst>
        </pc:spChg>
        <pc:spChg chg="mod topLvl">
          <ac:chgData name="vijay kumar" userId="0eb738f014aa4543" providerId="LiveId" clId="{B4DB2928-3EFF-4507-ABD0-3894F091460A}" dt="2020-05-09T15:05:53.967" v="14501" actId="1038"/>
          <ac:spMkLst>
            <pc:docMk/>
            <pc:sldMk cId="0" sldId="258"/>
            <ac:spMk id="19" creationId="{81E804B0-69D0-4A0F-A479-520E91EF5908}"/>
          </ac:spMkLst>
        </pc:spChg>
        <pc:spChg chg="mod topLvl">
          <ac:chgData name="vijay kumar" userId="0eb738f014aa4543" providerId="LiveId" clId="{B4DB2928-3EFF-4507-ABD0-3894F091460A}" dt="2020-05-09T15:05:53.967" v="14501" actId="1038"/>
          <ac:spMkLst>
            <pc:docMk/>
            <pc:sldMk cId="0" sldId="258"/>
            <ac:spMk id="20" creationId="{440A4A00-DE76-4960-9F4F-B945A9CDBE12}"/>
          </ac:spMkLst>
        </pc:spChg>
        <pc:spChg chg="mod topLvl">
          <ac:chgData name="vijay kumar" userId="0eb738f014aa4543" providerId="LiveId" clId="{B4DB2928-3EFF-4507-ABD0-3894F091460A}" dt="2020-05-09T15:05:53.967" v="14501" actId="1038"/>
          <ac:spMkLst>
            <pc:docMk/>
            <pc:sldMk cId="0" sldId="258"/>
            <ac:spMk id="21" creationId="{6705BC7F-FF39-48F0-A2C0-F0A336E1FCBB}"/>
          </ac:spMkLst>
        </pc:spChg>
        <pc:spChg chg="del mod topLvl">
          <ac:chgData name="vijay kumar" userId="0eb738f014aa4543" providerId="LiveId" clId="{B4DB2928-3EFF-4507-ABD0-3894F091460A}" dt="2020-05-02T17:47:34.843" v="4821" actId="478"/>
          <ac:spMkLst>
            <pc:docMk/>
            <pc:sldMk cId="0" sldId="258"/>
            <ac:spMk id="22" creationId="{379AD600-C315-447F-9BA5-B534F1BB1315}"/>
          </ac:spMkLst>
        </pc:spChg>
        <pc:spChg chg="mod topLvl">
          <ac:chgData name="vijay kumar" userId="0eb738f014aa4543" providerId="LiveId" clId="{B4DB2928-3EFF-4507-ABD0-3894F091460A}" dt="2020-05-09T15:05:53.967" v="14501" actId="1038"/>
          <ac:spMkLst>
            <pc:docMk/>
            <pc:sldMk cId="0" sldId="258"/>
            <ac:spMk id="23" creationId="{68347386-7277-4975-B7A0-2C5FB4FCDC0B}"/>
          </ac:spMkLst>
        </pc:spChg>
        <pc:spChg chg="del mod topLvl">
          <ac:chgData name="vijay kumar" userId="0eb738f014aa4543" providerId="LiveId" clId="{B4DB2928-3EFF-4507-ABD0-3894F091460A}" dt="2020-05-02T17:47:40.680" v="4822" actId="478"/>
          <ac:spMkLst>
            <pc:docMk/>
            <pc:sldMk cId="0" sldId="258"/>
            <ac:spMk id="24" creationId="{1CE12382-4620-49C9-9E0C-CE758296FB70}"/>
          </ac:spMkLst>
        </pc:spChg>
        <pc:spChg chg="mod topLvl">
          <ac:chgData name="vijay kumar" userId="0eb738f014aa4543" providerId="LiveId" clId="{B4DB2928-3EFF-4507-ABD0-3894F091460A}" dt="2020-05-09T15:05:53.967" v="14501" actId="1038"/>
          <ac:spMkLst>
            <pc:docMk/>
            <pc:sldMk cId="0" sldId="258"/>
            <ac:spMk id="25" creationId="{7CCA44C5-39F5-40AB-8747-1C6BE71DE67B}"/>
          </ac:spMkLst>
        </pc:spChg>
        <pc:spChg chg="mod topLvl">
          <ac:chgData name="vijay kumar" userId="0eb738f014aa4543" providerId="LiveId" clId="{B4DB2928-3EFF-4507-ABD0-3894F091460A}" dt="2020-05-09T15:05:53.967" v="14501" actId="1038"/>
          <ac:spMkLst>
            <pc:docMk/>
            <pc:sldMk cId="0" sldId="258"/>
            <ac:spMk id="26" creationId="{C238F8BC-0061-41D6-B178-1AAC3CAB348E}"/>
          </ac:spMkLst>
        </pc:spChg>
        <pc:spChg chg="mod topLvl">
          <ac:chgData name="vijay kumar" userId="0eb738f014aa4543" providerId="LiveId" clId="{B4DB2928-3EFF-4507-ABD0-3894F091460A}" dt="2020-05-09T15:05:53.967" v="14501" actId="1038"/>
          <ac:spMkLst>
            <pc:docMk/>
            <pc:sldMk cId="0" sldId="258"/>
            <ac:spMk id="27" creationId="{684CB4F6-02C6-45BA-B6D3-BAF74C2AD871}"/>
          </ac:spMkLst>
        </pc:spChg>
        <pc:spChg chg="mod topLvl">
          <ac:chgData name="vijay kumar" userId="0eb738f014aa4543" providerId="LiveId" clId="{B4DB2928-3EFF-4507-ABD0-3894F091460A}" dt="2020-05-09T15:05:53.967" v="14501" actId="1038"/>
          <ac:spMkLst>
            <pc:docMk/>
            <pc:sldMk cId="0" sldId="258"/>
            <ac:spMk id="28" creationId="{882F2E7F-646C-4B1B-90AA-EA66DACF86E7}"/>
          </ac:spMkLst>
        </pc:spChg>
        <pc:spChg chg="mod topLvl">
          <ac:chgData name="vijay kumar" userId="0eb738f014aa4543" providerId="LiveId" clId="{B4DB2928-3EFF-4507-ABD0-3894F091460A}" dt="2020-05-09T15:05:53.967" v="14501" actId="1038"/>
          <ac:spMkLst>
            <pc:docMk/>
            <pc:sldMk cId="0" sldId="258"/>
            <ac:spMk id="29" creationId="{E6EFF97D-DF10-4F02-9723-C442807DAABA}"/>
          </ac:spMkLst>
        </pc:spChg>
        <pc:spChg chg="del mod topLvl">
          <ac:chgData name="vijay kumar" userId="0eb738f014aa4543" providerId="LiveId" clId="{B4DB2928-3EFF-4507-ABD0-3894F091460A}" dt="2020-04-28T08:18:45.170" v="770" actId="478"/>
          <ac:spMkLst>
            <pc:docMk/>
            <pc:sldMk cId="0" sldId="258"/>
            <ac:spMk id="30" creationId="{C1B16868-B97F-440D-AFF0-3A3F2AD18698}"/>
          </ac:spMkLst>
        </pc:spChg>
        <pc:spChg chg="del mod topLvl">
          <ac:chgData name="vijay kumar" userId="0eb738f014aa4543" providerId="LiveId" clId="{B4DB2928-3EFF-4507-ABD0-3894F091460A}" dt="2020-04-28T08:22:03.598" v="798" actId="478"/>
          <ac:spMkLst>
            <pc:docMk/>
            <pc:sldMk cId="0" sldId="258"/>
            <ac:spMk id="65" creationId="{09CE6EF2-EE62-4C2F-BC5F-5BAE36714507}"/>
          </ac:spMkLst>
        </pc:spChg>
        <pc:spChg chg="del mod topLvl">
          <ac:chgData name="vijay kumar" userId="0eb738f014aa4543" providerId="LiveId" clId="{B4DB2928-3EFF-4507-ABD0-3894F091460A}" dt="2020-04-28T08:22:02.600" v="797" actId="478"/>
          <ac:spMkLst>
            <pc:docMk/>
            <pc:sldMk cId="0" sldId="258"/>
            <ac:spMk id="66" creationId="{50FE7A20-27C8-477F-A561-2600B5C5AC15}"/>
          </ac:spMkLst>
        </pc:spChg>
        <pc:spChg chg="del mod topLvl">
          <ac:chgData name="vijay kumar" userId="0eb738f014aa4543" providerId="LiveId" clId="{B4DB2928-3EFF-4507-ABD0-3894F091460A}" dt="2020-04-28T09:32:21.026" v="3261" actId="478"/>
          <ac:spMkLst>
            <pc:docMk/>
            <pc:sldMk cId="0" sldId="258"/>
            <ac:spMk id="67" creationId="{4758DE9B-77E0-478F-A6E4-3DA55A0A73DF}"/>
          </ac:spMkLst>
        </pc:spChg>
        <pc:spChg chg="del mod topLvl">
          <ac:chgData name="vijay kumar" userId="0eb738f014aa4543" providerId="LiveId" clId="{B4DB2928-3EFF-4507-ABD0-3894F091460A}" dt="2020-04-28T09:32:21.026" v="3261" actId="478"/>
          <ac:spMkLst>
            <pc:docMk/>
            <pc:sldMk cId="0" sldId="258"/>
            <ac:spMk id="68" creationId="{A0A768B0-9369-43A9-B649-E840D46ABD69}"/>
          </ac:spMkLst>
        </pc:spChg>
        <pc:spChg chg="del mod topLvl">
          <ac:chgData name="vijay kumar" userId="0eb738f014aa4543" providerId="LiveId" clId="{B4DB2928-3EFF-4507-ABD0-3894F091460A}" dt="2020-04-28T09:32:21.026" v="3261" actId="478"/>
          <ac:spMkLst>
            <pc:docMk/>
            <pc:sldMk cId="0" sldId="258"/>
            <ac:spMk id="69" creationId="{AAC527D7-0B07-4DA6-B6B2-6D2C7059A9BD}"/>
          </ac:spMkLst>
        </pc:spChg>
        <pc:spChg chg="del mod topLvl">
          <ac:chgData name="vijay kumar" userId="0eb738f014aa4543" providerId="LiveId" clId="{B4DB2928-3EFF-4507-ABD0-3894F091460A}" dt="2020-04-28T09:32:21.026" v="3261" actId="478"/>
          <ac:spMkLst>
            <pc:docMk/>
            <pc:sldMk cId="0" sldId="258"/>
            <ac:spMk id="70" creationId="{E1952515-65C3-4093-93DA-CEC6828CB700}"/>
          </ac:spMkLst>
        </pc:spChg>
        <pc:spChg chg="del mod topLvl">
          <ac:chgData name="vijay kumar" userId="0eb738f014aa4543" providerId="LiveId" clId="{B4DB2928-3EFF-4507-ABD0-3894F091460A}" dt="2020-04-28T09:32:21.026" v="3261" actId="478"/>
          <ac:spMkLst>
            <pc:docMk/>
            <pc:sldMk cId="0" sldId="258"/>
            <ac:spMk id="71" creationId="{76E4BEF9-96FD-4A8F-ACBB-06B54B8E0983}"/>
          </ac:spMkLst>
        </pc:spChg>
        <pc:spChg chg="del mod topLvl">
          <ac:chgData name="vijay kumar" userId="0eb738f014aa4543" providerId="LiveId" clId="{B4DB2928-3EFF-4507-ABD0-3894F091460A}" dt="2020-04-28T09:32:21.026" v="3261" actId="478"/>
          <ac:spMkLst>
            <pc:docMk/>
            <pc:sldMk cId="0" sldId="258"/>
            <ac:spMk id="72" creationId="{0CFB16A1-EACC-4D47-A8E3-6A80427B2936}"/>
          </ac:spMkLst>
        </pc:spChg>
        <pc:spChg chg="del mod topLvl">
          <ac:chgData name="vijay kumar" userId="0eb738f014aa4543" providerId="LiveId" clId="{B4DB2928-3EFF-4507-ABD0-3894F091460A}" dt="2020-04-28T09:32:21.026" v="3261" actId="478"/>
          <ac:spMkLst>
            <pc:docMk/>
            <pc:sldMk cId="0" sldId="258"/>
            <ac:spMk id="73" creationId="{26931638-07AC-4AAE-A174-2BE1789B081C}"/>
          </ac:spMkLst>
        </pc:spChg>
        <pc:spChg chg="del mod topLvl">
          <ac:chgData name="vijay kumar" userId="0eb738f014aa4543" providerId="LiveId" clId="{B4DB2928-3EFF-4507-ABD0-3894F091460A}" dt="2020-04-28T09:32:21.026" v="3261" actId="478"/>
          <ac:spMkLst>
            <pc:docMk/>
            <pc:sldMk cId="0" sldId="258"/>
            <ac:spMk id="74" creationId="{F1A9F36D-84DC-4636-9A2C-0F4C88E56510}"/>
          </ac:spMkLst>
        </pc:spChg>
        <pc:spChg chg="del mod topLvl">
          <ac:chgData name="vijay kumar" userId="0eb738f014aa4543" providerId="LiveId" clId="{B4DB2928-3EFF-4507-ABD0-3894F091460A}" dt="2020-04-28T09:32:21.026" v="3261" actId="478"/>
          <ac:spMkLst>
            <pc:docMk/>
            <pc:sldMk cId="0" sldId="258"/>
            <ac:spMk id="75" creationId="{6CA9335A-67FD-4F7C-A833-78B1E677CB2B}"/>
          </ac:spMkLst>
        </pc:spChg>
        <pc:spChg chg="del mod topLvl">
          <ac:chgData name="vijay kumar" userId="0eb738f014aa4543" providerId="LiveId" clId="{B4DB2928-3EFF-4507-ABD0-3894F091460A}" dt="2020-04-28T09:32:21.026" v="3261" actId="478"/>
          <ac:spMkLst>
            <pc:docMk/>
            <pc:sldMk cId="0" sldId="258"/>
            <ac:spMk id="76" creationId="{C1323A07-2580-4B5D-ACB2-E8410744C41C}"/>
          </ac:spMkLst>
        </pc:spChg>
        <pc:spChg chg="del mod topLvl">
          <ac:chgData name="vijay kumar" userId="0eb738f014aa4543" providerId="LiveId" clId="{B4DB2928-3EFF-4507-ABD0-3894F091460A}" dt="2020-04-28T09:32:21.026" v="3261" actId="478"/>
          <ac:spMkLst>
            <pc:docMk/>
            <pc:sldMk cId="0" sldId="258"/>
            <ac:spMk id="77" creationId="{AE640855-A619-4834-94FE-E34D0B868139}"/>
          </ac:spMkLst>
        </pc:spChg>
        <pc:spChg chg="del mod topLvl">
          <ac:chgData name="vijay kumar" userId="0eb738f014aa4543" providerId="LiveId" clId="{B4DB2928-3EFF-4507-ABD0-3894F091460A}" dt="2020-04-28T09:32:21.026" v="3261" actId="478"/>
          <ac:spMkLst>
            <pc:docMk/>
            <pc:sldMk cId="0" sldId="258"/>
            <ac:spMk id="78" creationId="{B7017FBA-5B53-4147-8A34-B18E4169AF4D}"/>
          </ac:spMkLst>
        </pc:spChg>
        <pc:spChg chg="del mod topLvl">
          <ac:chgData name="vijay kumar" userId="0eb738f014aa4543" providerId="LiveId" clId="{B4DB2928-3EFF-4507-ABD0-3894F091460A}" dt="2020-04-28T09:32:21.026" v="3261" actId="478"/>
          <ac:spMkLst>
            <pc:docMk/>
            <pc:sldMk cId="0" sldId="258"/>
            <ac:spMk id="83" creationId="{80BC2E11-6B4B-44CF-9D7A-2CF4352D18E2}"/>
          </ac:spMkLst>
        </pc:spChg>
        <pc:spChg chg="del mod topLvl">
          <ac:chgData name="vijay kumar" userId="0eb738f014aa4543" providerId="LiveId" clId="{B4DB2928-3EFF-4507-ABD0-3894F091460A}" dt="2020-04-28T09:32:21.026" v="3261" actId="478"/>
          <ac:spMkLst>
            <pc:docMk/>
            <pc:sldMk cId="0" sldId="258"/>
            <ac:spMk id="84" creationId="{A100CEF4-541B-420A-994B-79D221A28067}"/>
          </ac:spMkLst>
        </pc:spChg>
        <pc:spChg chg="del mod topLvl">
          <ac:chgData name="vijay kumar" userId="0eb738f014aa4543" providerId="LiveId" clId="{B4DB2928-3EFF-4507-ABD0-3894F091460A}" dt="2020-04-28T09:32:21.026" v="3261" actId="478"/>
          <ac:spMkLst>
            <pc:docMk/>
            <pc:sldMk cId="0" sldId="258"/>
            <ac:spMk id="85" creationId="{8B578E8A-0FCB-4F26-92D3-AB4C542E0700}"/>
          </ac:spMkLst>
        </pc:spChg>
        <pc:spChg chg="del mod topLvl">
          <ac:chgData name="vijay kumar" userId="0eb738f014aa4543" providerId="LiveId" clId="{B4DB2928-3EFF-4507-ABD0-3894F091460A}" dt="2020-04-28T09:32:21.026" v="3261" actId="478"/>
          <ac:spMkLst>
            <pc:docMk/>
            <pc:sldMk cId="0" sldId="258"/>
            <ac:spMk id="86" creationId="{6BFE5672-920D-400E-A2ED-A59B7F2B4E9C}"/>
          </ac:spMkLst>
        </pc:spChg>
        <pc:spChg chg="del mod topLvl">
          <ac:chgData name="vijay kumar" userId="0eb738f014aa4543" providerId="LiveId" clId="{B4DB2928-3EFF-4507-ABD0-3894F091460A}" dt="2020-04-28T09:32:21.026" v="3261" actId="478"/>
          <ac:spMkLst>
            <pc:docMk/>
            <pc:sldMk cId="0" sldId="258"/>
            <ac:spMk id="87" creationId="{BC4A93B7-A3D7-4C0B-9175-D3AFCCDA1B2B}"/>
          </ac:spMkLst>
        </pc:spChg>
        <pc:spChg chg="del mod topLvl">
          <ac:chgData name="vijay kumar" userId="0eb738f014aa4543" providerId="LiveId" clId="{B4DB2928-3EFF-4507-ABD0-3894F091460A}" dt="2020-04-28T08:22:05.141" v="799" actId="478"/>
          <ac:spMkLst>
            <pc:docMk/>
            <pc:sldMk cId="0" sldId="258"/>
            <ac:spMk id="88" creationId="{25B2158E-58B4-4518-9795-8E54C070AF64}"/>
          </ac:spMkLst>
        </pc:spChg>
        <pc:spChg chg="mod">
          <ac:chgData name="vijay kumar" userId="0eb738f014aa4543" providerId="LiveId" clId="{B4DB2928-3EFF-4507-ABD0-3894F091460A}" dt="2020-05-09T15:05:53.967" v="14501" actId="1038"/>
          <ac:spMkLst>
            <pc:docMk/>
            <pc:sldMk cId="0" sldId="258"/>
            <ac:spMk id="273" creationId="{D71AD09F-B64E-4FDC-B161-5AC618B7090C}"/>
          </ac:spMkLst>
        </pc:spChg>
        <pc:spChg chg="mod">
          <ac:chgData name="vijay kumar" userId="0eb738f014aa4543" providerId="LiveId" clId="{B4DB2928-3EFF-4507-ABD0-3894F091460A}" dt="2020-05-09T15:05:53.967" v="14501" actId="1038"/>
          <ac:spMkLst>
            <pc:docMk/>
            <pc:sldMk cId="0" sldId="258"/>
            <ac:spMk id="274" creationId="{E85DA654-DAC0-4F93-B25E-DB58C01A0F86}"/>
          </ac:spMkLst>
        </pc:spChg>
        <pc:spChg chg="mod">
          <ac:chgData name="vijay kumar" userId="0eb738f014aa4543" providerId="LiveId" clId="{B4DB2928-3EFF-4507-ABD0-3894F091460A}" dt="2020-05-09T15:05:53.967" v="14501" actId="1038"/>
          <ac:spMkLst>
            <pc:docMk/>
            <pc:sldMk cId="0" sldId="258"/>
            <ac:spMk id="275" creationId="{398FE25E-286E-42E7-A5A2-B39F29C67D07}"/>
          </ac:spMkLst>
        </pc:spChg>
        <pc:spChg chg="mod">
          <ac:chgData name="vijay kumar" userId="0eb738f014aa4543" providerId="LiveId" clId="{B4DB2928-3EFF-4507-ABD0-3894F091460A}" dt="2020-05-09T15:05:53.967" v="14501" actId="1038"/>
          <ac:spMkLst>
            <pc:docMk/>
            <pc:sldMk cId="0" sldId="258"/>
            <ac:spMk id="277" creationId="{826DA361-D41D-446D-B4FA-188F465B1E34}"/>
          </ac:spMkLst>
        </pc:spChg>
        <pc:spChg chg="mod">
          <ac:chgData name="vijay kumar" userId="0eb738f014aa4543" providerId="LiveId" clId="{B4DB2928-3EFF-4507-ABD0-3894F091460A}" dt="2020-05-09T15:05:53.967" v="14501" actId="1038"/>
          <ac:spMkLst>
            <pc:docMk/>
            <pc:sldMk cId="0" sldId="258"/>
            <ac:spMk id="280" creationId="{4EC808F6-D0C8-4A33-8968-F28BD0923D9F}"/>
          </ac:spMkLst>
        </pc:spChg>
        <pc:spChg chg="mod">
          <ac:chgData name="vijay kumar" userId="0eb738f014aa4543" providerId="LiveId" clId="{B4DB2928-3EFF-4507-ABD0-3894F091460A}" dt="2020-05-09T15:05:53.967" v="14501" actId="1038"/>
          <ac:spMkLst>
            <pc:docMk/>
            <pc:sldMk cId="0" sldId="258"/>
            <ac:spMk id="281" creationId="{C6817E45-4E2C-4EAE-B958-CF8AB63EEB5A}"/>
          </ac:spMkLst>
        </pc:spChg>
        <pc:spChg chg="del mod topLvl">
          <ac:chgData name="vijay kumar" userId="0eb738f014aa4543" providerId="LiveId" clId="{B4DB2928-3EFF-4507-ABD0-3894F091460A}" dt="2020-05-02T17:47:34.843" v="4821" actId="478"/>
          <ac:spMkLst>
            <pc:docMk/>
            <pc:sldMk cId="0" sldId="258"/>
            <ac:spMk id="295" creationId="{D690BBE3-2C9E-49BB-8DCE-C1E478B11C55}"/>
          </ac:spMkLst>
        </pc:spChg>
        <pc:spChg chg="mod topLvl">
          <ac:chgData name="vijay kumar" userId="0eb738f014aa4543" providerId="LiveId" clId="{B4DB2928-3EFF-4507-ABD0-3894F091460A}" dt="2020-05-09T15:05:53.967" v="14501" actId="1038"/>
          <ac:spMkLst>
            <pc:docMk/>
            <pc:sldMk cId="0" sldId="258"/>
            <ac:spMk id="296" creationId="{B687F8AD-0967-4D41-8899-D9271C2A806A}"/>
          </ac:spMkLst>
        </pc:spChg>
        <pc:spChg chg="del mod topLvl">
          <ac:chgData name="vijay kumar" userId="0eb738f014aa4543" providerId="LiveId" clId="{B4DB2928-3EFF-4507-ABD0-3894F091460A}" dt="2020-04-28T08:38:58.446" v="1176" actId="478"/>
          <ac:spMkLst>
            <pc:docMk/>
            <pc:sldMk cId="0" sldId="258"/>
            <ac:spMk id="297" creationId="{6205D035-47E7-4F3D-8EB2-FAC80451376C}"/>
          </ac:spMkLst>
        </pc:spChg>
        <pc:spChg chg="del mod topLvl">
          <ac:chgData name="vijay kumar" userId="0eb738f014aa4543" providerId="LiveId" clId="{B4DB2928-3EFF-4507-ABD0-3894F091460A}" dt="2020-05-02T17:47:40.680" v="4822" actId="478"/>
          <ac:spMkLst>
            <pc:docMk/>
            <pc:sldMk cId="0" sldId="258"/>
            <ac:spMk id="298" creationId="{BCEDBEFA-835E-4FC2-974F-DFEB0C588D48}"/>
          </ac:spMkLst>
        </pc:spChg>
        <pc:spChg chg="mod topLvl">
          <ac:chgData name="vijay kumar" userId="0eb738f014aa4543" providerId="LiveId" clId="{B4DB2928-3EFF-4507-ABD0-3894F091460A}" dt="2020-05-09T15:05:53.967" v="14501" actId="1038"/>
          <ac:spMkLst>
            <pc:docMk/>
            <pc:sldMk cId="0" sldId="258"/>
            <ac:spMk id="299" creationId="{676A35F6-0D95-4346-BD18-B74828258556}"/>
          </ac:spMkLst>
        </pc:spChg>
        <pc:spChg chg="mod topLvl">
          <ac:chgData name="vijay kumar" userId="0eb738f014aa4543" providerId="LiveId" clId="{B4DB2928-3EFF-4507-ABD0-3894F091460A}" dt="2020-05-09T15:05:53.967" v="14501" actId="1038"/>
          <ac:spMkLst>
            <pc:docMk/>
            <pc:sldMk cId="0" sldId="258"/>
            <ac:spMk id="300" creationId="{A161D342-EDDD-429F-AEBB-268D13E7260A}"/>
          </ac:spMkLst>
        </pc:spChg>
        <pc:spChg chg="mod topLvl">
          <ac:chgData name="vijay kumar" userId="0eb738f014aa4543" providerId="LiveId" clId="{B4DB2928-3EFF-4507-ABD0-3894F091460A}" dt="2020-05-09T15:05:53.967" v="14501" actId="1038"/>
          <ac:spMkLst>
            <pc:docMk/>
            <pc:sldMk cId="0" sldId="258"/>
            <ac:spMk id="301" creationId="{1B4CAF15-C7D2-49E0-8A7C-BF320BE04EF6}"/>
          </ac:spMkLst>
        </pc:spChg>
        <pc:spChg chg="mod topLvl">
          <ac:chgData name="vijay kumar" userId="0eb738f014aa4543" providerId="LiveId" clId="{B4DB2928-3EFF-4507-ABD0-3894F091460A}" dt="2020-05-09T15:05:53.967" v="14501" actId="1038"/>
          <ac:spMkLst>
            <pc:docMk/>
            <pc:sldMk cId="0" sldId="258"/>
            <ac:spMk id="302" creationId="{3EB470DD-4274-46D4-A4CA-0889AA118852}"/>
          </ac:spMkLst>
        </pc:spChg>
        <pc:spChg chg="mod topLvl">
          <ac:chgData name="vijay kumar" userId="0eb738f014aa4543" providerId="LiveId" clId="{B4DB2928-3EFF-4507-ABD0-3894F091460A}" dt="2020-05-09T15:05:53.967" v="14501" actId="1038"/>
          <ac:spMkLst>
            <pc:docMk/>
            <pc:sldMk cId="0" sldId="258"/>
            <ac:spMk id="303" creationId="{FA822960-05CB-4738-9E36-A9A3DED6AD89}"/>
          </ac:spMkLst>
        </pc:spChg>
        <pc:spChg chg="del mod topLvl">
          <ac:chgData name="vijay kumar" userId="0eb738f014aa4543" providerId="LiveId" clId="{B4DB2928-3EFF-4507-ABD0-3894F091460A}" dt="2020-04-28T08:27:12.628" v="802" actId="478"/>
          <ac:spMkLst>
            <pc:docMk/>
            <pc:sldMk cId="0" sldId="258"/>
            <ac:spMk id="304" creationId="{21B52E0E-DF52-4374-8921-D1C906ACD957}"/>
          </ac:spMkLst>
        </pc:spChg>
        <pc:spChg chg="del mod topLvl">
          <ac:chgData name="vijay kumar" userId="0eb738f014aa4543" providerId="LiveId" clId="{B4DB2928-3EFF-4507-ABD0-3894F091460A}" dt="2020-04-28T08:27:12.628" v="802" actId="478"/>
          <ac:spMkLst>
            <pc:docMk/>
            <pc:sldMk cId="0" sldId="258"/>
            <ac:spMk id="305" creationId="{E5C0F797-DC50-4E7B-B145-D5146CC0F6D4}"/>
          </ac:spMkLst>
        </pc:spChg>
        <pc:spChg chg="del mod topLvl">
          <ac:chgData name="vijay kumar" userId="0eb738f014aa4543" providerId="LiveId" clId="{B4DB2928-3EFF-4507-ABD0-3894F091460A}" dt="2020-04-28T08:27:12.628" v="802" actId="478"/>
          <ac:spMkLst>
            <pc:docMk/>
            <pc:sldMk cId="0" sldId="258"/>
            <ac:spMk id="306" creationId="{0209EAC8-C270-4887-8200-104B39B42B11}"/>
          </ac:spMkLst>
        </pc:spChg>
        <pc:spChg chg="del mod topLvl">
          <ac:chgData name="vijay kumar" userId="0eb738f014aa4543" providerId="LiveId" clId="{B4DB2928-3EFF-4507-ABD0-3894F091460A}" dt="2020-04-28T08:27:12.628" v="802" actId="478"/>
          <ac:spMkLst>
            <pc:docMk/>
            <pc:sldMk cId="0" sldId="258"/>
            <ac:spMk id="307" creationId="{62170EEB-25CA-428F-A3E5-F5499BA764E7}"/>
          </ac:spMkLst>
        </pc:spChg>
        <pc:spChg chg="del mod topLvl">
          <ac:chgData name="vijay kumar" userId="0eb738f014aa4543" providerId="LiveId" clId="{B4DB2928-3EFF-4507-ABD0-3894F091460A}" dt="2020-04-28T08:27:12.628" v="802" actId="478"/>
          <ac:spMkLst>
            <pc:docMk/>
            <pc:sldMk cId="0" sldId="258"/>
            <ac:spMk id="308" creationId="{23E6F8E7-5982-4693-8BBA-403107FF4588}"/>
          </ac:spMkLst>
        </pc:spChg>
        <pc:spChg chg="del mod topLvl">
          <ac:chgData name="vijay kumar" userId="0eb738f014aa4543" providerId="LiveId" clId="{B4DB2928-3EFF-4507-ABD0-3894F091460A}" dt="2020-04-28T08:27:12.628" v="802" actId="478"/>
          <ac:spMkLst>
            <pc:docMk/>
            <pc:sldMk cId="0" sldId="258"/>
            <ac:spMk id="309" creationId="{C407654D-8399-44A7-934F-3B7E43CB01CA}"/>
          </ac:spMkLst>
        </pc:spChg>
        <pc:spChg chg="del mod topLvl">
          <ac:chgData name="vijay kumar" userId="0eb738f014aa4543" providerId="LiveId" clId="{B4DB2928-3EFF-4507-ABD0-3894F091460A}" dt="2020-05-02T17:47:34.843" v="4821" actId="478"/>
          <ac:spMkLst>
            <pc:docMk/>
            <pc:sldMk cId="0" sldId="258"/>
            <ac:spMk id="310" creationId="{51FB0AC2-F00E-4F72-B785-665F49F0D211}"/>
          </ac:spMkLst>
        </pc:spChg>
        <pc:spChg chg="mod topLvl">
          <ac:chgData name="vijay kumar" userId="0eb738f014aa4543" providerId="LiveId" clId="{B4DB2928-3EFF-4507-ABD0-3894F091460A}" dt="2020-05-09T15:05:53.967" v="14501" actId="1038"/>
          <ac:spMkLst>
            <pc:docMk/>
            <pc:sldMk cId="0" sldId="258"/>
            <ac:spMk id="311" creationId="{D7410B51-9DF0-4522-B186-8AFB544C0676}"/>
          </ac:spMkLst>
        </pc:spChg>
        <pc:spChg chg="del mod topLvl">
          <ac:chgData name="vijay kumar" userId="0eb738f014aa4543" providerId="LiveId" clId="{B4DB2928-3EFF-4507-ABD0-3894F091460A}" dt="2020-04-28T08:38:58.446" v="1176" actId="478"/>
          <ac:spMkLst>
            <pc:docMk/>
            <pc:sldMk cId="0" sldId="258"/>
            <ac:spMk id="312" creationId="{02776FAE-3EA0-423E-B06C-B22E8C15953B}"/>
          </ac:spMkLst>
        </pc:spChg>
        <pc:spChg chg="del mod topLvl">
          <ac:chgData name="vijay kumar" userId="0eb738f014aa4543" providerId="LiveId" clId="{B4DB2928-3EFF-4507-ABD0-3894F091460A}" dt="2020-05-02T17:47:40.680" v="4822" actId="478"/>
          <ac:spMkLst>
            <pc:docMk/>
            <pc:sldMk cId="0" sldId="258"/>
            <ac:spMk id="313" creationId="{9D5FE0C0-1C4A-4A94-AE09-9DA1D78FF92D}"/>
          </ac:spMkLst>
        </pc:spChg>
        <pc:spChg chg="mod topLvl">
          <ac:chgData name="vijay kumar" userId="0eb738f014aa4543" providerId="LiveId" clId="{B4DB2928-3EFF-4507-ABD0-3894F091460A}" dt="2020-05-09T15:05:53.967" v="14501" actId="1038"/>
          <ac:spMkLst>
            <pc:docMk/>
            <pc:sldMk cId="0" sldId="258"/>
            <ac:spMk id="314" creationId="{446B9A85-DAEC-4538-A134-91FC14E77BC2}"/>
          </ac:spMkLst>
        </pc:spChg>
        <pc:spChg chg="mod topLvl">
          <ac:chgData name="vijay kumar" userId="0eb738f014aa4543" providerId="LiveId" clId="{B4DB2928-3EFF-4507-ABD0-3894F091460A}" dt="2020-05-09T15:05:53.967" v="14501" actId="1038"/>
          <ac:spMkLst>
            <pc:docMk/>
            <pc:sldMk cId="0" sldId="258"/>
            <ac:spMk id="315" creationId="{E06A8FA7-2514-4699-A9EB-ABC3C80764DD}"/>
          </ac:spMkLst>
        </pc:spChg>
        <pc:spChg chg="mod topLvl">
          <ac:chgData name="vijay kumar" userId="0eb738f014aa4543" providerId="LiveId" clId="{B4DB2928-3EFF-4507-ABD0-3894F091460A}" dt="2020-05-09T15:05:53.967" v="14501" actId="1038"/>
          <ac:spMkLst>
            <pc:docMk/>
            <pc:sldMk cId="0" sldId="258"/>
            <ac:spMk id="316" creationId="{9796FCDB-9058-480B-8EDD-D0BA5D45DDB5}"/>
          </ac:spMkLst>
        </pc:spChg>
        <pc:spChg chg="mod topLvl">
          <ac:chgData name="vijay kumar" userId="0eb738f014aa4543" providerId="LiveId" clId="{B4DB2928-3EFF-4507-ABD0-3894F091460A}" dt="2020-05-09T15:05:53.967" v="14501" actId="1038"/>
          <ac:spMkLst>
            <pc:docMk/>
            <pc:sldMk cId="0" sldId="258"/>
            <ac:spMk id="317" creationId="{261ADAD6-D9E3-44E0-BFFA-987ACE13A36C}"/>
          </ac:spMkLst>
        </pc:spChg>
        <pc:spChg chg="mod topLvl">
          <ac:chgData name="vijay kumar" userId="0eb738f014aa4543" providerId="LiveId" clId="{B4DB2928-3EFF-4507-ABD0-3894F091460A}" dt="2020-05-09T15:05:53.967" v="14501" actId="1038"/>
          <ac:spMkLst>
            <pc:docMk/>
            <pc:sldMk cId="0" sldId="258"/>
            <ac:spMk id="318" creationId="{61D18DD5-C53D-474A-A078-6ADC3C0D0388}"/>
          </ac:spMkLst>
        </pc:spChg>
        <pc:spChg chg="add del mod">
          <ac:chgData name="vijay kumar" userId="0eb738f014aa4543" providerId="LiveId" clId="{B4DB2928-3EFF-4507-ABD0-3894F091460A}" dt="2020-05-04T18:02:52.044" v="10482" actId="478"/>
          <ac:spMkLst>
            <pc:docMk/>
            <pc:sldMk cId="0" sldId="258"/>
            <ac:spMk id="319" creationId="{09F2DD24-BEED-40EF-9BF7-6B8284456309}"/>
          </ac:spMkLst>
        </pc:spChg>
        <pc:spChg chg="del mod topLvl">
          <ac:chgData name="vijay kumar" userId="0eb738f014aa4543" providerId="LiveId" clId="{B4DB2928-3EFF-4507-ABD0-3894F091460A}" dt="2020-04-28T08:27:12.628" v="802" actId="478"/>
          <ac:spMkLst>
            <pc:docMk/>
            <pc:sldMk cId="0" sldId="258"/>
            <ac:spMk id="319" creationId="{BE890A36-A69B-4E13-93C9-C3490418EB66}"/>
          </ac:spMkLst>
        </pc:spChg>
        <pc:spChg chg="add del mod">
          <ac:chgData name="vijay kumar" userId="0eb738f014aa4543" providerId="LiveId" clId="{B4DB2928-3EFF-4507-ABD0-3894F091460A}" dt="2020-05-24T14:26:14.145" v="15153" actId="478"/>
          <ac:spMkLst>
            <pc:docMk/>
            <pc:sldMk cId="0" sldId="258"/>
            <ac:spMk id="319" creationId="{DD54757F-74E5-4377-B6F2-BFB6BE4E14C7}"/>
          </ac:spMkLst>
        </pc:spChg>
        <pc:spChg chg="del mod topLvl">
          <ac:chgData name="vijay kumar" userId="0eb738f014aa4543" providerId="LiveId" clId="{B4DB2928-3EFF-4507-ABD0-3894F091460A}" dt="2020-04-28T08:27:12.628" v="802" actId="478"/>
          <ac:spMkLst>
            <pc:docMk/>
            <pc:sldMk cId="0" sldId="258"/>
            <ac:spMk id="320" creationId="{2DD4698C-028A-4D9B-BAAC-6B999983BB9F}"/>
          </ac:spMkLst>
        </pc:spChg>
        <pc:spChg chg="add mod">
          <ac:chgData name="vijay kumar" userId="0eb738f014aa4543" providerId="LiveId" clId="{B4DB2928-3EFF-4507-ABD0-3894F091460A}" dt="2020-05-09T15:05:09.413" v="14449" actId="1036"/>
          <ac:spMkLst>
            <pc:docMk/>
            <pc:sldMk cId="0" sldId="258"/>
            <ac:spMk id="320" creationId="{9998EE37-B268-47C6-A768-7894B3C0E8C8}"/>
          </ac:spMkLst>
        </pc:spChg>
        <pc:spChg chg="del mod topLvl">
          <ac:chgData name="vijay kumar" userId="0eb738f014aa4543" providerId="LiveId" clId="{B4DB2928-3EFF-4507-ABD0-3894F091460A}" dt="2020-04-28T08:27:12.628" v="802" actId="478"/>
          <ac:spMkLst>
            <pc:docMk/>
            <pc:sldMk cId="0" sldId="258"/>
            <ac:spMk id="321" creationId="{3968C523-9C5C-4788-96F8-B1D2A96CEBC8}"/>
          </ac:spMkLst>
        </pc:spChg>
        <pc:spChg chg="add mod topLvl">
          <ac:chgData name="vijay kumar" userId="0eb738f014aa4543" providerId="LiveId" clId="{B4DB2928-3EFF-4507-ABD0-3894F091460A}" dt="2020-05-09T15:05:14.980" v="14450" actId="165"/>
          <ac:spMkLst>
            <pc:docMk/>
            <pc:sldMk cId="0" sldId="258"/>
            <ac:spMk id="321" creationId="{D7805A35-D426-4431-8A69-C4772F2B58F6}"/>
          </ac:spMkLst>
        </pc:spChg>
        <pc:spChg chg="del mod topLvl">
          <ac:chgData name="vijay kumar" userId="0eb738f014aa4543" providerId="LiveId" clId="{B4DB2928-3EFF-4507-ABD0-3894F091460A}" dt="2020-04-28T08:27:12.628" v="802" actId="478"/>
          <ac:spMkLst>
            <pc:docMk/>
            <pc:sldMk cId="0" sldId="258"/>
            <ac:spMk id="322" creationId="{E720E44D-B6C2-4F1C-A547-4800FC086EA1}"/>
          </ac:spMkLst>
        </pc:spChg>
        <pc:spChg chg="del mod topLvl">
          <ac:chgData name="vijay kumar" userId="0eb738f014aa4543" providerId="LiveId" clId="{B4DB2928-3EFF-4507-ABD0-3894F091460A}" dt="2020-04-28T08:27:12.628" v="802" actId="478"/>
          <ac:spMkLst>
            <pc:docMk/>
            <pc:sldMk cId="0" sldId="258"/>
            <ac:spMk id="323" creationId="{31643C04-B1E1-4A76-82B5-27D5A046274C}"/>
          </ac:spMkLst>
        </pc:spChg>
        <pc:spChg chg="add mod">
          <ac:chgData name="vijay kumar" userId="0eb738f014aa4543" providerId="LiveId" clId="{B4DB2928-3EFF-4507-ABD0-3894F091460A}" dt="2020-05-09T15:06:13.105" v="14504" actId="164"/>
          <ac:spMkLst>
            <pc:docMk/>
            <pc:sldMk cId="0" sldId="258"/>
            <ac:spMk id="324" creationId="{42052856-F850-4E82-822C-2603FFE1DA65}"/>
          </ac:spMkLst>
        </pc:spChg>
        <pc:spChg chg="del mod topLvl">
          <ac:chgData name="vijay kumar" userId="0eb738f014aa4543" providerId="LiveId" clId="{B4DB2928-3EFF-4507-ABD0-3894F091460A}" dt="2020-04-28T08:27:12.628" v="802" actId="478"/>
          <ac:spMkLst>
            <pc:docMk/>
            <pc:sldMk cId="0" sldId="258"/>
            <ac:spMk id="324" creationId="{636386B7-8CE0-4D50-BBFA-4FE89B09020B}"/>
          </ac:spMkLst>
        </pc:spChg>
        <pc:spChg chg="mod topLvl">
          <ac:chgData name="vijay kumar" userId="0eb738f014aa4543" providerId="LiveId" clId="{B4DB2928-3EFF-4507-ABD0-3894F091460A}" dt="2020-05-09T15:05:53.967" v="14501" actId="1038"/>
          <ac:spMkLst>
            <pc:docMk/>
            <pc:sldMk cId="0" sldId="258"/>
            <ac:spMk id="325" creationId="{18F802C6-366A-4C1D-BEC1-0CD4949F3F0F}"/>
          </ac:spMkLst>
        </pc:spChg>
        <pc:spChg chg="del mod topLvl">
          <ac:chgData name="vijay kumar" userId="0eb738f014aa4543" providerId="LiveId" clId="{B4DB2928-3EFF-4507-ABD0-3894F091460A}" dt="2020-05-02T17:47:34.843" v="4821" actId="478"/>
          <ac:spMkLst>
            <pc:docMk/>
            <pc:sldMk cId="0" sldId="258"/>
            <ac:spMk id="326" creationId="{1072B928-D241-4EFC-A27A-E4EEEFF3EE8B}"/>
          </ac:spMkLst>
        </pc:spChg>
        <pc:spChg chg="mod topLvl">
          <ac:chgData name="vijay kumar" userId="0eb738f014aa4543" providerId="LiveId" clId="{B4DB2928-3EFF-4507-ABD0-3894F091460A}" dt="2020-05-09T15:05:53.967" v="14501" actId="1038"/>
          <ac:spMkLst>
            <pc:docMk/>
            <pc:sldMk cId="0" sldId="258"/>
            <ac:spMk id="327" creationId="{115EF5AE-4A05-4E6D-9DC2-BF22C3E3BB8E}"/>
          </ac:spMkLst>
        </pc:spChg>
        <pc:spChg chg="add mod topLvl">
          <ac:chgData name="vijay kumar" userId="0eb738f014aa4543" providerId="LiveId" clId="{B4DB2928-3EFF-4507-ABD0-3894F091460A}" dt="2020-05-09T15:05:53.967" v="14501" actId="1038"/>
          <ac:spMkLst>
            <pc:docMk/>
            <pc:sldMk cId="0" sldId="258"/>
            <ac:spMk id="328" creationId="{0E54D013-1413-4FE5-91A4-171678E2AE17}"/>
          </ac:spMkLst>
        </pc:spChg>
        <pc:spChg chg="del mod topLvl">
          <ac:chgData name="vijay kumar" userId="0eb738f014aa4543" providerId="LiveId" clId="{B4DB2928-3EFF-4507-ABD0-3894F091460A}" dt="2020-04-28T08:38:58.446" v="1176" actId="478"/>
          <ac:spMkLst>
            <pc:docMk/>
            <pc:sldMk cId="0" sldId="258"/>
            <ac:spMk id="328" creationId="{F7010491-00C7-4B0C-A072-5CD39F8F6A15}"/>
          </ac:spMkLst>
        </pc:spChg>
        <pc:spChg chg="del mod topLvl">
          <ac:chgData name="vijay kumar" userId="0eb738f014aa4543" providerId="LiveId" clId="{B4DB2928-3EFF-4507-ABD0-3894F091460A}" dt="2020-05-02T17:47:40.680" v="4822" actId="478"/>
          <ac:spMkLst>
            <pc:docMk/>
            <pc:sldMk cId="0" sldId="258"/>
            <ac:spMk id="329" creationId="{10F39647-5A1C-41DF-BF70-A73E367F8220}"/>
          </ac:spMkLst>
        </pc:spChg>
        <pc:spChg chg="mod topLvl">
          <ac:chgData name="vijay kumar" userId="0eb738f014aa4543" providerId="LiveId" clId="{B4DB2928-3EFF-4507-ABD0-3894F091460A}" dt="2020-05-09T15:05:53.967" v="14501" actId="1038"/>
          <ac:spMkLst>
            <pc:docMk/>
            <pc:sldMk cId="0" sldId="258"/>
            <ac:spMk id="330" creationId="{4CF57E8C-AB4F-43EC-B248-EF9DE454DDC5}"/>
          </ac:spMkLst>
        </pc:spChg>
        <pc:spChg chg="mod topLvl">
          <ac:chgData name="vijay kumar" userId="0eb738f014aa4543" providerId="LiveId" clId="{B4DB2928-3EFF-4507-ABD0-3894F091460A}" dt="2020-05-09T15:05:53.967" v="14501" actId="1038"/>
          <ac:spMkLst>
            <pc:docMk/>
            <pc:sldMk cId="0" sldId="258"/>
            <ac:spMk id="331" creationId="{08F6A189-40E8-49CE-9D4B-BBA2B5D3C34C}"/>
          </ac:spMkLst>
        </pc:spChg>
        <pc:spChg chg="mod topLvl">
          <ac:chgData name="vijay kumar" userId="0eb738f014aa4543" providerId="LiveId" clId="{B4DB2928-3EFF-4507-ABD0-3894F091460A}" dt="2020-05-09T15:05:53.967" v="14501" actId="1038"/>
          <ac:spMkLst>
            <pc:docMk/>
            <pc:sldMk cId="0" sldId="258"/>
            <ac:spMk id="332" creationId="{87D50BDC-CF77-41AA-A1F6-F52C3A9EA02B}"/>
          </ac:spMkLst>
        </pc:spChg>
        <pc:spChg chg="mod topLvl">
          <ac:chgData name="vijay kumar" userId="0eb738f014aa4543" providerId="LiveId" clId="{B4DB2928-3EFF-4507-ABD0-3894F091460A}" dt="2020-05-09T15:05:53.967" v="14501" actId="1038"/>
          <ac:spMkLst>
            <pc:docMk/>
            <pc:sldMk cId="0" sldId="258"/>
            <ac:spMk id="333" creationId="{1A94954C-29F8-44A6-9223-B223E193757C}"/>
          </ac:spMkLst>
        </pc:spChg>
        <pc:spChg chg="mod topLvl">
          <ac:chgData name="vijay kumar" userId="0eb738f014aa4543" providerId="LiveId" clId="{B4DB2928-3EFF-4507-ABD0-3894F091460A}" dt="2020-05-09T15:05:53.967" v="14501" actId="1038"/>
          <ac:spMkLst>
            <pc:docMk/>
            <pc:sldMk cId="0" sldId="258"/>
            <ac:spMk id="334" creationId="{3704401E-669E-4E20-9540-FA2BC2E828EC}"/>
          </ac:spMkLst>
        </pc:spChg>
        <pc:spChg chg="del mod topLvl">
          <ac:chgData name="vijay kumar" userId="0eb738f014aa4543" providerId="LiveId" clId="{B4DB2928-3EFF-4507-ABD0-3894F091460A}" dt="2020-04-28T08:27:12.628" v="802" actId="478"/>
          <ac:spMkLst>
            <pc:docMk/>
            <pc:sldMk cId="0" sldId="258"/>
            <ac:spMk id="335" creationId="{88A0BBD5-BE86-4E63-ACCE-81FFDD05E2A3}"/>
          </ac:spMkLst>
        </pc:spChg>
        <pc:spChg chg="add mod">
          <ac:chgData name="vijay kumar" userId="0eb738f014aa4543" providerId="LiveId" clId="{B4DB2928-3EFF-4507-ABD0-3894F091460A}" dt="2020-05-09T15:03:32.552" v="14202" actId="164"/>
          <ac:spMkLst>
            <pc:docMk/>
            <pc:sldMk cId="0" sldId="258"/>
            <ac:spMk id="335" creationId="{A5CA1251-033C-4760-BA3A-DA46C7AB85AF}"/>
          </ac:spMkLst>
        </pc:spChg>
        <pc:spChg chg="del mod topLvl">
          <ac:chgData name="vijay kumar" userId="0eb738f014aa4543" providerId="LiveId" clId="{B4DB2928-3EFF-4507-ABD0-3894F091460A}" dt="2020-04-28T08:27:12.628" v="802" actId="478"/>
          <ac:spMkLst>
            <pc:docMk/>
            <pc:sldMk cId="0" sldId="258"/>
            <ac:spMk id="336" creationId="{A1B5DF8B-D59A-444D-A059-F93D5D7BFCE8}"/>
          </ac:spMkLst>
        </pc:spChg>
        <pc:spChg chg="del mod topLvl">
          <ac:chgData name="vijay kumar" userId="0eb738f014aa4543" providerId="LiveId" clId="{B4DB2928-3EFF-4507-ABD0-3894F091460A}" dt="2020-04-28T08:27:12.628" v="802" actId="478"/>
          <ac:spMkLst>
            <pc:docMk/>
            <pc:sldMk cId="0" sldId="258"/>
            <ac:spMk id="337" creationId="{76EB7245-D203-4E3A-A48A-75953D1BE421}"/>
          </ac:spMkLst>
        </pc:spChg>
        <pc:spChg chg="del mod topLvl">
          <ac:chgData name="vijay kumar" userId="0eb738f014aa4543" providerId="LiveId" clId="{B4DB2928-3EFF-4507-ABD0-3894F091460A}" dt="2020-04-28T08:27:12.628" v="802" actId="478"/>
          <ac:spMkLst>
            <pc:docMk/>
            <pc:sldMk cId="0" sldId="258"/>
            <ac:spMk id="338" creationId="{BC096876-9819-47FC-93DD-2DB9473267B8}"/>
          </ac:spMkLst>
        </pc:spChg>
        <pc:spChg chg="del mod topLvl">
          <ac:chgData name="vijay kumar" userId="0eb738f014aa4543" providerId="LiveId" clId="{B4DB2928-3EFF-4507-ABD0-3894F091460A}" dt="2020-04-28T08:27:12.628" v="802" actId="478"/>
          <ac:spMkLst>
            <pc:docMk/>
            <pc:sldMk cId="0" sldId="258"/>
            <ac:spMk id="339" creationId="{3917A0C5-E095-4DE2-8A23-C394DD6EC1A7}"/>
          </ac:spMkLst>
        </pc:spChg>
        <pc:spChg chg="del mod topLvl">
          <ac:chgData name="vijay kumar" userId="0eb738f014aa4543" providerId="LiveId" clId="{B4DB2928-3EFF-4507-ABD0-3894F091460A}" dt="2020-04-28T08:27:12.628" v="802" actId="478"/>
          <ac:spMkLst>
            <pc:docMk/>
            <pc:sldMk cId="0" sldId="258"/>
            <ac:spMk id="340" creationId="{763CC9B4-A3DD-4EA5-8795-EACDF3A08335}"/>
          </ac:spMkLst>
        </pc:spChg>
        <pc:spChg chg="mod topLvl">
          <ac:chgData name="vijay kumar" userId="0eb738f014aa4543" providerId="LiveId" clId="{B4DB2928-3EFF-4507-ABD0-3894F091460A}" dt="2020-05-09T15:05:53.967" v="14501" actId="1038"/>
          <ac:spMkLst>
            <pc:docMk/>
            <pc:sldMk cId="0" sldId="258"/>
            <ac:spMk id="344" creationId="{14C6140C-5182-4616-9065-B123124F8BD2}"/>
          </ac:spMkLst>
        </pc:spChg>
        <pc:spChg chg="del mod topLvl">
          <ac:chgData name="vijay kumar" userId="0eb738f014aa4543" providerId="LiveId" clId="{B4DB2928-3EFF-4507-ABD0-3894F091460A}" dt="2020-04-28T08:37:20.476" v="1097" actId="478"/>
          <ac:spMkLst>
            <pc:docMk/>
            <pc:sldMk cId="0" sldId="258"/>
            <ac:spMk id="345" creationId="{BE275947-9978-44B4-AD29-B3492BD4B942}"/>
          </ac:spMkLst>
        </pc:spChg>
        <pc:spChg chg="mod topLvl">
          <ac:chgData name="vijay kumar" userId="0eb738f014aa4543" providerId="LiveId" clId="{B4DB2928-3EFF-4507-ABD0-3894F091460A}" dt="2020-05-09T15:05:53.967" v="14501" actId="1038"/>
          <ac:spMkLst>
            <pc:docMk/>
            <pc:sldMk cId="0" sldId="258"/>
            <ac:spMk id="346" creationId="{053BAD05-E541-4E2F-8910-074F983D3ADC}"/>
          </ac:spMkLst>
        </pc:spChg>
        <pc:spChg chg="mod">
          <ac:chgData name="vijay kumar" userId="0eb738f014aa4543" providerId="LiveId" clId="{B4DB2928-3EFF-4507-ABD0-3894F091460A}" dt="2020-04-28T08:33:13.690" v="895" actId="1037"/>
          <ac:spMkLst>
            <pc:docMk/>
            <pc:sldMk cId="0" sldId="258"/>
            <ac:spMk id="348" creationId="{8917436D-49A5-40EF-A507-5D0C75E41CE0}"/>
          </ac:spMkLst>
        </pc:spChg>
        <pc:spChg chg="add del mod">
          <ac:chgData name="vijay kumar" userId="0eb738f014aa4543" providerId="LiveId" clId="{B4DB2928-3EFF-4507-ABD0-3894F091460A}" dt="2020-04-28T09:07:27.974" v="1871" actId="478"/>
          <ac:spMkLst>
            <pc:docMk/>
            <pc:sldMk cId="0" sldId="258"/>
            <ac:spMk id="361" creationId="{12A9685B-CD04-459F-B341-8378295CD1A3}"/>
          </ac:spMkLst>
        </pc:spChg>
        <pc:spChg chg="del mod topLvl">
          <ac:chgData name="vijay kumar" userId="0eb738f014aa4543" providerId="LiveId" clId="{B4DB2928-3EFF-4507-ABD0-3894F091460A}" dt="2020-04-28T08:23:15.422" v="800" actId="478"/>
          <ac:spMkLst>
            <pc:docMk/>
            <pc:sldMk cId="0" sldId="258"/>
            <ac:spMk id="456" creationId="{00000000-0000-0000-0000-000000000000}"/>
          </ac:spMkLst>
        </pc:spChg>
        <pc:spChg chg="mod topLvl">
          <ac:chgData name="vijay kumar" userId="0eb738f014aa4543" providerId="LiveId" clId="{B4DB2928-3EFF-4507-ABD0-3894F091460A}" dt="2020-04-27T17:55:37.663" v="627" actId="164"/>
          <ac:spMkLst>
            <pc:docMk/>
            <pc:sldMk cId="0" sldId="258"/>
            <ac:spMk id="457" creationId="{00000000-0000-0000-0000-000000000000}"/>
          </ac:spMkLst>
        </pc:spChg>
        <pc:spChg chg="mod topLvl">
          <ac:chgData name="vijay kumar" userId="0eb738f014aa4543" providerId="LiveId" clId="{B4DB2928-3EFF-4507-ABD0-3894F091460A}" dt="2020-04-27T17:49:42.568" v="124" actId="164"/>
          <ac:spMkLst>
            <pc:docMk/>
            <pc:sldMk cId="0" sldId="258"/>
            <ac:spMk id="459" creationId="{00000000-0000-0000-0000-000000000000}"/>
          </ac:spMkLst>
        </pc:spChg>
        <pc:spChg chg="mod topLvl">
          <ac:chgData name="vijay kumar" userId="0eb738f014aa4543" providerId="LiveId" clId="{B4DB2928-3EFF-4507-ABD0-3894F091460A}" dt="2020-04-27T17:49:42.568" v="124" actId="164"/>
          <ac:spMkLst>
            <pc:docMk/>
            <pc:sldMk cId="0" sldId="258"/>
            <ac:spMk id="460" creationId="{00000000-0000-0000-0000-000000000000}"/>
          </ac:spMkLst>
        </pc:spChg>
        <pc:spChg chg="mod topLvl">
          <ac:chgData name="vijay kumar" userId="0eb738f014aa4543" providerId="LiveId" clId="{B4DB2928-3EFF-4507-ABD0-3894F091460A}" dt="2020-04-27T17:49:42.568" v="124" actId="164"/>
          <ac:spMkLst>
            <pc:docMk/>
            <pc:sldMk cId="0" sldId="258"/>
            <ac:spMk id="461" creationId="{00000000-0000-0000-0000-000000000000}"/>
          </ac:spMkLst>
        </pc:spChg>
        <pc:spChg chg="mod topLvl">
          <ac:chgData name="vijay kumar" userId="0eb738f014aa4543" providerId="LiveId" clId="{B4DB2928-3EFF-4507-ABD0-3894F091460A}" dt="2020-04-27T17:49:42.568" v="124" actId="164"/>
          <ac:spMkLst>
            <pc:docMk/>
            <pc:sldMk cId="0" sldId="258"/>
            <ac:spMk id="462" creationId="{00000000-0000-0000-0000-000000000000}"/>
          </ac:spMkLst>
        </pc:spChg>
        <pc:spChg chg="mod topLvl">
          <ac:chgData name="vijay kumar" userId="0eb738f014aa4543" providerId="LiveId" clId="{B4DB2928-3EFF-4507-ABD0-3894F091460A}" dt="2020-04-27T17:49:42.568" v="124" actId="164"/>
          <ac:spMkLst>
            <pc:docMk/>
            <pc:sldMk cId="0" sldId="258"/>
            <ac:spMk id="463" creationId="{00000000-0000-0000-0000-000000000000}"/>
          </ac:spMkLst>
        </pc:spChg>
        <pc:spChg chg="mod topLvl">
          <ac:chgData name="vijay kumar" userId="0eb738f014aa4543" providerId="LiveId" clId="{B4DB2928-3EFF-4507-ABD0-3894F091460A}" dt="2020-04-27T17:49:54.952" v="127" actId="164"/>
          <ac:spMkLst>
            <pc:docMk/>
            <pc:sldMk cId="0" sldId="258"/>
            <ac:spMk id="466" creationId="{00000000-0000-0000-0000-000000000000}"/>
          </ac:spMkLst>
        </pc:spChg>
        <pc:spChg chg="mod topLvl">
          <ac:chgData name="vijay kumar" userId="0eb738f014aa4543" providerId="LiveId" clId="{B4DB2928-3EFF-4507-ABD0-3894F091460A}" dt="2020-04-27T17:49:54.952" v="127" actId="164"/>
          <ac:spMkLst>
            <pc:docMk/>
            <pc:sldMk cId="0" sldId="258"/>
            <ac:spMk id="467" creationId="{00000000-0000-0000-0000-000000000000}"/>
          </ac:spMkLst>
        </pc:spChg>
        <pc:spChg chg="mod topLvl">
          <ac:chgData name="vijay kumar" userId="0eb738f014aa4543" providerId="LiveId" clId="{B4DB2928-3EFF-4507-ABD0-3894F091460A}" dt="2020-04-27T17:49:54.952" v="127" actId="164"/>
          <ac:spMkLst>
            <pc:docMk/>
            <pc:sldMk cId="0" sldId="258"/>
            <ac:spMk id="468" creationId="{00000000-0000-0000-0000-000000000000}"/>
          </ac:spMkLst>
        </pc:spChg>
        <pc:spChg chg="mod topLvl">
          <ac:chgData name="vijay kumar" userId="0eb738f014aa4543" providerId="LiveId" clId="{B4DB2928-3EFF-4507-ABD0-3894F091460A}" dt="2020-04-27T17:49:54.952" v="127" actId="164"/>
          <ac:spMkLst>
            <pc:docMk/>
            <pc:sldMk cId="0" sldId="258"/>
            <ac:spMk id="469" creationId="{00000000-0000-0000-0000-000000000000}"/>
          </ac:spMkLst>
        </pc:spChg>
        <pc:spChg chg="mod topLvl">
          <ac:chgData name="vijay kumar" userId="0eb738f014aa4543" providerId="LiveId" clId="{B4DB2928-3EFF-4507-ABD0-3894F091460A}" dt="2020-04-27T17:49:42.568" v="124" actId="164"/>
          <ac:spMkLst>
            <pc:docMk/>
            <pc:sldMk cId="0" sldId="258"/>
            <ac:spMk id="470" creationId="{00000000-0000-0000-0000-000000000000}"/>
          </ac:spMkLst>
        </pc:spChg>
        <pc:spChg chg="mod topLvl">
          <ac:chgData name="vijay kumar" userId="0eb738f014aa4543" providerId="LiveId" clId="{B4DB2928-3EFF-4507-ABD0-3894F091460A}" dt="2020-04-27T17:49:42.568" v="124" actId="164"/>
          <ac:spMkLst>
            <pc:docMk/>
            <pc:sldMk cId="0" sldId="258"/>
            <ac:spMk id="471" creationId="{00000000-0000-0000-0000-000000000000}"/>
          </ac:spMkLst>
        </pc:spChg>
        <pc:spChg chg="mod topLvl">
          <ac:chgData name="vijay kumar" userId="0eb738f014aa4543" providerId="LiveId" clId="{B4DB2928-3EFF-4507-ABD0-3894F091460A}" dt="2020-04-27T17:49:42.568" v="124" actId="164"/>
          <ac:spMkLst>
            <pc:docMk/>
            <pc:sldMk cId="0" sldId="258"/>
            <ac:spMk id="472" creationId="{00000000-0000-0000-0000-000000000000}"/>
          </ac:spMkLst>
        </pc:spChg>
        <pc:spChg chg="mod topLvl">
          <ac:chgData name="vijay kumar" userId="0eb738f014aa4543" providerId="LiveId" clId="{B4DB2928-3EFF-4507-ABD0-3894F091460A}" dt="2020-04-27T17:49:42.568" v="124" actId="164"/>
          <ac:spMkLst>
            <pc:docMk/>
            <pc:sldMk cId="0" sldId="258"/>
            <ac:spMk id="473" creationId="{00000000-0000-0000-0000-000000000000}"/>
          </ac:spMkLst>
        </pc:spChg>
        <pc:spChg chg="mod topLvl">
          <ac:chgData name="vijay kumar" userId="0eb738f014aa4543" providerId="LiveId" clId="{B4DB2928-3EFF-4507-ABD0-3894F091460A}" dt="2020-04-27T17:49:42.568" v="124" actId="164"/>
          <ac:spMkLst>
            <pc:docMk/>
            <pc:sldMk cId="0" sldId="258"/>
            <ac:spMk id="474" creationId="{00000000-0000-0000-0000-000000000000}"/>
          </ac:spMkLst>
        </pc:spChg>
        <pc:spChg chg="mod topLvl">
          <ac:chgData name="vijay kumar" userId="0eb738f014aa4543" providerId="LiveId" clId="{B4DB2928-3EFF-4507-ABD0-3894F091460A}" dt="2020-04-27T17:49:42.568" v="124" actId="164"/>
          <ac:spMkLst>
            <pc:docMk/>
            <pc:sldMk cId="0" sldId="258"/>
            <ac:spMk id="475" creationId="{00000000-0000-0000-0000-000000000000}"/>
          </ac:spMkLst>
        </pc:spChg>
        <pc:spChg chg="mod topLvl">
          <ac:chgData name="vijay kumar" userId="0eb738f014aa4543" providerId="LiveId" clId="{B4DB2928-3EFF-4507-ABD0-3894F091460A}" dt="2020-04-27T17:49:42.568" v="124" actId="164"/>
          <ac:spMkLst>
            <pc:docMk/>
            <pc:sldMk cId="0" sldId="258"/>
            <ac:spMk id="476" creationId="{00000000-0000-0000-0000-000000000000}"/>
          </ac:spMkLst>
        </pc:spChg>
        <pc:spChg chg="mod topLvl">
          <ac:chgData name="vijay kumar" userId="0eb738f014aa4543" providerId="LiveId" clId="{B4DB2928-3EFF-4507-ABD0-3894F091460A}" dt="2020-04-27T17:49:42.568" v="124" actId="164"/>
          <ac:spMkLst>
            <pc:docMk/>
            <pc:sldMk cId="0" sldId="258"/>
            <ac:spMk id="477" creationId="{00000000-0000-0000-0000-000000000000}"/>
          </ac:spMkLst>
        </pc:spChg>
        <pc:spChg chg="mod topLvl">
          <ac:chgData name="vijay kumar" userId="0eb738f014aa4543" providerId="LiveId" clId="{B4DB2928-3EFF-4507-ABD0-3894F091460A}" dt="2020-04-27T17:49:42.568" v="124" actId="164"/>
          <ac:spMkLst>
            <pc:docMk/>
            <pc:sldMk cId="0" sldId="258"/>
            <ac:spMk id="478" creationId="{00000000-0000-0000-0000-000000000000}"/>
          </ac:spMkLst>
        </pc:spChg>
        <pc:spChg chg="mod topLvl">
          <ac:chgData name="vijay kumar" userId="0eb738f014aa4543" providerId="LiveId" clId="{B4DB2928-3EFF-4507-ABD0-3894F091460A}" dt="2020-04-27T17:49:42.568" v="124" actId="164"/>
          <ac:spMkLst>
            <pc:docMk/>
            <pc:sldMk cId="0" sldId="258"/>
            <ac:spMk id="479" creationId="{00000000-0000-0000-0000-000000000000}"/>
          </ac:spMkLst>
        </pc:spChg>
        <pc:spChg chg="mod topLvl">
          <ac:chgData name="vijay kumar" userId="0eb738f014aa4543" providerId="LiveId" clId="{B4DB2928-3EFF-4507-ABD0-3894F091460A}" dt="2020-04-27T17:49:42.568" v="124" actId="164"/>
          <ac:spMkLst>
            <pc:docMk/>
            <pc:sldMk cId="0" sldId="258"/>
            <ac:spMk id="480" creationId="{00000000-0000-0000-0000-000000000000}"/>
          </ac:spMkLst>
        </pc:spChg>
        <pc:spChg chg="mod topLvl">
          <ac:chgData name="vijay kumar" userId="0eb738f014aa4543" providerId="LiveId" clId="{B4DB2928-3EFF-4507-ABD0-3894F091460A}" dt="2020-04-27T17:49:42.568" v="124" actId="164"/>
          <ac:spMkLst>
            <pc:docMk/>
            <pc:sldMk cId="0" sldId="258"/>
            <ac:spMk id="481" creationId="{00000000-0000-0000-0000-000000000000}"/>
          </ac:spMkLst>
        </pc:spChg>
        <pc:spChg chg="mod topLvl">
          <ac:chgData name="vijay kumar" userId="0eb738f014aa4543" providerId="LiveId" clId="{B4DB2928-3EFF-4507-ABD0-3894F091460A}" dt="2020-04-27T17:49:42.568" v="124" actId="164"/>
          <ac:spMkLst>
            <pc:docMk/>
            <pc:sldMk cId="0" sldId="258"/>
            <ac:spMk id="482" creationId="{00000000-0000-0000-0000-000000000000}"/>
          </ac:spMkLst>
        </pc:spChg>
        <pc:spChg chg="mod topLvl">
          <ac:chgData name="vijay kumar" userId="0eb738f014aa4543" providerId="LiveId" clId="{B4DB2928-3EFF-4507-ABD0-3894F091460A}" dt="2020-04-27T17:49:42.568" v="124" actId="164"/>
          <ac:spMkLst>
            <pc:docMk/>
            <pc:sldMk cId="0" sldId="258"/>
            <ac:spMk id="483" creationId="{00000000-0000-0000-0000-000000000000}"/>
          </ac:spMkLst>
        </pc:spChg>
        <pc:spChg chg="mod topLvl">
          <ac:chgData name="vijay kumar" userId="0eb738f014aa4543" providerId="LiveId" clId="{B4DB2928-3EFF-4507-ABD0-3894F091460A}" dt="2020-04-27T17:49:42.568" v="124" actId="164"/>
          <ac:spMkLst>
            <pc:docMk/>
            <pc:sldMk cId="0" sldId="258"/>
            <ac:spMk id="484" creationId="{00000000-0000-0000-0000-000000000000}"/>
          </ac:spMkLst>
        </pc:spChg>
        <pc:spChg chg="mod topLvl">
          <ac:chgData name="vijay kumar" userId="0eb738f014aa4543" providerId="LiveId" clId="{B4DB2928-3EFF-4507-ABD0-3894F091460A}" dt="2020-04-27T17:49:42.568" v="124" actId="164"/>
          <ac:spMkLst>
            <pc:docMk/>
            <pc:sldMk cId="0" sldId="258"/>
            <ac:spMk id="485" creationId="{00000000-0000-0000-0000-000000000000}"/>
          </ac:spMkLst>
        </pc:spChg>
        <pc:spChg chg="mod topLvl">
          <ac:chgData name="vijay kumar" userId="0eb738f014aa4543" providerId="LiveId" clId="{B4DB2928-3EFF-4507-ABD0-3894F091460A}" dt="2020-04-27T17:49:42.568" v="124" actId="164"/>
          <ac:spMkLst>
            <pc:docMk/>
            <pc:sldMk cId="0" sldId="258"/>
            <ac:spMk id="486" creationId="{00000000-0000-0000-0000-000000000000}"/>
          </ac:spMkLst>
        </pc:spChg>
        <pc:spChg chg="mod topLvl">
          <ac:chgData name="vijay kumar" userId="0eb738f014aa4543" providerId="LiveId" clId="{B4DB2928-3EFF-4507-ABD0-3894F091460A}" dt="2020-04-27T17:49:42.568" v="124" actId="164"/>
          <ac:spMkLst>
            <pc:docMk/>
            <pc:sldMk cId="0" sldId="258"/>
            <ac:spMk id="487" creationId="{00000000-0000-0000-0000-000000000000}"/>
          </ac:spMkLst>
        </pc:spChg>
        <pc:spChg chg="mod topLvl">
          <ac:chgData name="vijay kumar" userId="0eb738f014aa4543" providerId="LiveId" clId="{B4DB2928-3EFF-4507-ABD0-3894F091460A}" dt="2020-04-27T17:49:42.568" v="124" actId="164"/>
          <ac:spMkLst>
            <pc:docMk/>
            <pc:sldMk cId="0" sldId="258"/>
            <ac:spMk id="488" creationId="{00000000-0000-0000-0000-000000000000}"/>
          </ac:spMkLst>
        </pc:spChg>
        <pc:spChg chg="mod topLvl">
          <ac:chgData name="vijay kumar" userId="0eb738f014aa4543" providerId="LiveId" clId="{B4DB2928-3EFF-4507-ABD0-3894F091460A}" dt="2020-04-27T17:49:42.568" v="124" actId="164"/>
          <ac:spMkLst>
            <pc:docMk/>
            <pc:sldMk cId="0" sldId="258"/>
            <ac:spMk id="489" creationId="{00000000-0000-0000-0000-000000000000}"/>
          </ac:spMkLst>
        </pc:spChg>
        <pc:spChg chg="mod topLvl">
          <ac:chgData name="vijay kumar" userId="0eb738f014aa4543" providerId="LiveId" clId="{B4DB2928-3EFF-4507-ABD0-3894F091460A}" dt="2020-04-27T17:49:42.568" v="124" actId="164"/>
          <ac:spMkLst>
            <pc:docMk/>
            <pc:sldMk cId="0" sldId="258"/>
            <ac:spMk id="490" creationId="{00000000-0000-0000-0000-000000000000}"/>
          </ac:spMkLst>
        </pc:spChg>
        <pc:spChg chg="mod topLvl">
          <ac:chgData name="vijay kumar" userId="0eb738f014aa4543" providerId="LiveId" clId="{B4DB2928-3EFF-4507-ABD0-3894F091460A}" dt="2020-04-27T17:49:42.568" v="124" actId="164"/>
          <ac:spMkLst>
            <pc:docMk/>
            <pc:sldMk cId="0" sldId="258"/>
            <ac:spMk id="491" creationId="{00000000-0000-0000-0000-000000000000}"/>
          </ac:spMkLst>
        </pc:spChg>
        <pc:spChg chg="mod topLvl">
          <ac:chgData name="vijay kumar" userId="0eb738f014aa4543" providerId="LiveId" clId="{B4DB2928-3EFF-4507-ABD0-3894F091460A}" dt="2020-04-27T17:49:42.568" v="124" actId="164"/>
          <ac:spMkLst>
            <pc:docMk/>
            <pc:sldMk cId="0" sldId="258"/>
            <ac:spMk id="492" creationId="{00000000-0000-0000-0000-000000000000}"/>
          </ac:spMkLst>
        </pc:spChg>
        <pc:spChg chg="mod topLvl">
          <ac:chgData name="vijay kumar" userId="0eb738f014aa4543" providerId="LiveId" clId="{B4DB2928-3EFF-4507-ABD0-3894F091460A}" dt="2020-04-27T17:49:42.568" v="124" actId="164"/>
          <ac:spMkLst>
            <pc:docMk/>
            <pc:sldMk cId="0" sldId="258"/>
            <ac:spMk id="493" creationId="{00000000-0000-0000-0000-000000000000}"/>
          </ac:spMkLst>
        </pc:spChg>
        <pc:spChg chg="mod topLvl">
          <ac:chgData name="vijay kumar" userId="0eb738f014aa4543" providerId="LiveId" clId="{B4DB2928-3EFF-4507-ABD0-3894F091460A}" dt="2020-04-27T17:49:42.568" v="124" actId="164"/>
          <ac:spMkLst>
            <pc:docMk/>
            <pc:sldMk cId="0" sldId="258"/>
            <ac:spMk id="494" creationId="{00000000-0000-0000-0000-000000000000}"/>
          </ac:spMkLst>
        </pc:spChg>
        <pc:spChg chg="mod topLvl">
          <ac:chgData name="vijay kumar" userId="0eb738f014aa4543" providerId="LiveId" clId="{B4DB2928-3EFF-4507-ABD0-3894F091460A}" dt="2020-04-27T17:49:42.568" v="124" actId="164"/>
          <ac:spMkLst>
            <pc:docMk/>
            <pc:sldMk cId="0" sldId="258"/>
            <ac:spMk id="495" creationId="{00000000-0000-0000-0000-000000000000}"/>
          </ac:spMkLst>
        </pc:spChg>
        <pc:spChg chg="mod topLvl">
          <ac:chgData name="vijay kumar" userId="0eb738f014aa4543" providerId="LiveId" clId="{B4DB2928-3EFF-4507-ABD0-3894F091460A}" dt="2020-04-27T17:49:42.568" v="124" actId="164"/>
          <ac:spMkLst>
            <pc:docMk/>
            <pc:sldMk cId="0" sldId="258"/>
            <ac:spMk id="496" creationId="{00000000-0000-0000-0000-000000000000}"/>
          </ac:spMkLst>
        </pc:spChg>
        <pc:spChg chg="mod topLvl">
          <ac:chgData name="vijay kumar" userId="0eb738f014aa4543" providerId="LiveId" clId="{B4DB2928-3EFF-4507-ABD0-3894F091460A}" dt="2020-04-27T17:49:42.568" v="124" actId="164"/>
          <ac:spMkLst>
            <pc:docMk/>
            <pc:sldMk cId="0" sldId="258"/>
            <ac:spMk id="497" creationId="{00000000-0000-0000-0000-000000000000}"/>
          </ac:spMkLst>
        </pc:spChg>
        <pc:spChg chg="mod topLvl">
          <ac:chgData name="vijay kumar" userId="0eb738f014aa4543" providerId="LiveId" clId="{B4DB2928-3EFF-4507-ABD0-3894F091460A}" dt="2020-04-27T17:49:42.568" v="124" actId="164"/>
          <ac:spMkLst>
            <pc:docMk/>
            <pc:sldMk cId="0" sldId="258"/>
            <ac:spMk id="498" creationId="{00000000-0000-0000-0000-000000000000}"/>
          </ac:spMkLst>
        </pc:spChg>
        <pc:spChg chg="mod topLvl">
          <ac:chgData name="vijay kumar" userId="0eb738f014aa4543" providerId="LiveId" clId="{B4DB2928-3EFF-4507-ABD0-3894F091460A}" dt="2020-04-27T17:48:08.543" v="97" actId="164"/>
          <ac:spMkLst>
            <pc:docMk/>
            <pc:sldMk cId="0" sldId="258"/>
            <ac:spMk id="500" creationId="{00000000-0000-0000-0000-000000000000}"/>
          </ac:spMkLst>
        </pc:spChg>
        <pc:spChg chg="mod topLvl">
          <ac:chgData name="vijay kumar" userId="0eb738f014aa4543" providerId="LiveId" clId="{B4DB2928-3EFF-4507-ABD0-3894F091460A}" dt="2020-04-27T17:48:08.543" v="97" actId="164"/>
          <ac:spMkLst>
            <pc:docMk/>
            <pc:sldMk cId="0" sldId="258"/>
            <ac:spMk id="501" creationId="{00000000-0000-0000-0000-000000000000}"/>
          </ac:spMkLst>
        </pc:spChg>
        <pc:spChg chg="mod topLvl">
          <ac:chgData name="vijay kumar" userId="0eb738f014aa4543" providerId="LiveId" clId="{B4DB2928-3EFF-4507-ABD0-3894F091460A}" dt="2020-04-27T17:48:08.543" v="97" actId="164"/>
          <ac:spMkLst>
            <pc:docMk/>
            <pc:sldMk cId="0" sldId="258"/>
            <ac:spMk id="502" creationId="{00000000-0000-0000-0000-000000000000}"/>
          </ac:spMkLst>
        </pc:spChg>
        <pc:spChg chg="mod topLvl">
          <ac:chgData name="vijay kumar" userId="0eb738f014aa4543" providerId="LiveId" clId="{B4DB2928-3EFF-4507-ABD0-3894F091460A}" dt="2020-04-27T17:48:08.543" v="97" actId="164"/>
          <ac:spMkLst>
            <pc:docMk/>
            <pc:sldMk cId="0" sldId="258"/>
            <ac:spMk id="503" creationId="{00000000-0000-0000-0000-000000000000}"/>
          </ac:spMkLst>
        </pc:spChg>
        <pc:spChg chg="mod topLvl">
          <ac:chgData name="vijay kumar" userId="0eb738f014aa4543" providerId="LiveId" clId="{B4DB2928-3EFF-4507-ABD0-3894F091460A}" dt="2020-04-27T17:48:08.543" v="97" actId="164"/>
          <ac:spMkLst>
            <pc:docMk/>
            <pc:sldMk cId="0" sldId="258"/>
            <ac:spMk id="504" creationId="{00000000-0000-0000-0000-000000000000}"/>
          </ac:spMkLst>
        </pc:spChg>
        <pc:spChg chg="mod topLvl">
          <ac:chgData name="vijay kumar" userId="0eb738f014aa4543" providerId="LiveId" clId="{B4DB2928-3EFF-4507-ABD0-3894F091460A}" dt="2020-04-27T17:48:08.543" v="97" actId="164"/>
          <ac:spMkLst>
            <pc:docMk/>
            <pc:sldMk cId="0" sldId="258"/>
            <ac:spMk id="507" creationId="{00000000-0000-0000-0000-000000000000}"/>
          </ac:spMkLst>
        </pc:spChg>
        <pc:spChg chg="mod topLvl">
          <ac:chgData name="vijay kumar" userId="0eb738f014aa4543" providerId="LiveId" clId="{B4DB2928-3EFF-4507-ABD0-3894F091460A}" dt="2020-04-27T17:48:08.543" v="97" actId="164"/>
          <ac:spMkLst>
            <pc:docMk/>
            <pc:sldMk cId="0" sldId="258"/>
            <ac:spMk id="508" creationId="{00000000-0000-0000-0000-000000000000}"/>
          </ac:spMkLst>
        </pc:spChg>
        <pc:spChg chg="mod topLvl">
          <ac:chgData name="vijay kumar" userId="0eb738f014aa4543" providerId="LiveId" clId="{B4DB2928-3EFF-4507-ABD0-3894F091460A}" dt="2020-04-27T17:48:08.543" v="97" actId="164"/>
          <ac:spMkLst>
            <pc:docMk/>
            <pc:sldMk cId="0" sldId="258"/>
            <ac:spMk id="509" creationId="{00000000-0000-0000-0000-000000000000}"/>
          </ac:spMkLst>
        </pc:spChg>
        <pc:spChg chg="mod topLvl">
          <ac:chgData name="vijay kumar" userId="0eb738f014aa4543" providerId="LiveId" clId="{B4DB2928-3EFF-4507-ABD0-3894F091460A}" dt="2020-04-27T17:48:08.543" v="97" actId="164"/>
          <ac:spMkLst>
            <pc:docMk/>
            <pc:sldMk cId="0" sldId="258"/>
            <ac:spMk id="510" creationId="{00000000-0000-0000-0000-000000000000}"/>
          </ac:spMkLst>
        </pc:spChg>
        <pc:spChg chg="mod topLvl">
          <ac:chgData name="vijay kumar" userId="0eb738f014aa4543" providerId="LiveId" clId="{B4DB2928-3EFF-4507-ABD0-3894F091460A}" dt="2020-04-27T17:48:08.543" v="97" actId="164"/>
          <ac:spMkLst>
            <pc:docMk/>
            <pc:sldMk cId="0" sldId="258"/>
            <ac:spMk id="511" creationId="{00000000-0000-0000-0000-000000000000}"/>
          </ac:spMkLst>
        </pc:spChg>
        <pc:spChg chg="mod topLvl">
          <ac:chgData name="vijay kumar" userId="0eb738f014aa4543" providerId="LiveId" clId="{B4DB2928-3EFF-4507-ABD0-3894F091460A}" dt="2020-04-27T17:48:08.543" v="97" actId="164"/>
          <ac:spMkLst>
            <pc:docMk/>
            <pc:sldMk cId="0" sldId="258"/>
            <ac:spMk id="512" creationId="{00000000-0000-0000-0000-000000000000}"/>
          </ac:spMkLst>
        </pc:spChg>
        <pc:spChg chg="mod topLvl">
          <ac:chgData name="vijay kumar" userId="0eb738f014aa4543" providerId="LiveId" clId="{B4DB2928-3EFF-4507-ABD0-3894F091460A}" dt="2020-04-27T17:48:08.543" v="97" actId="164"/>
          <ac:spMkLst>
            <pc:docMk/>
            <pc:sldMk cId="0" sldId="258"/>
            <ac:spMk id="513" creationId="{00000000-0000-0000-0000-000000000000}"/>
          </ac:spMkLst>
        </pc:spChg>
        <pc:spChg chg="mod topLvl">
          <ac:chgData name="vijay kumar" userId="0eb738f014aa4543" providerId="LiveId" clId="{B4DB2928-3EFF-4507-ABD0-3894F091460A}" dt="2020-04-27T17:48:08.543" v="97" actId="164"/>
          <ac:spMkLst>
            <pc:docMk/>
            <pc:sldMk cId="0" sldId="258"/>
            <ac:spMk id="514" creationId="{00000000-0000-0000-0000-000000000000}"/>
          </ac:spMkLst>
        </pc:spChg>
        <pc:spChg chg="mod topLvl">
          <ac:chgData name="vijay kumar" userId="0eb738f014aa4543" providerId="LiveId" clId="{B4DB2928-3EFF-4507-ABD0-3894F091460A}" dt="2020-04-27T17:48:08.543" v="97" actId="164"/>
          <ac:spMkLst>
            <pc:docMk/>
            <pc:sldMk cId="0" sldId="258"/>
            <ac:spMk id="515" creationId="{00000000-0000-0000-0000-000000000000}"/>
          </ac:spMkLst>
        </pc:spChg>
        <pc:spChg chg="mod topLvl">
          <ac:chgData name="vijay kumar" userId="0eb738f014aa4543" providerId="LiveId" clId="{B4DB2928-3EFF-4507-ABD0-3894F091460A}" dt="2020-04-27T17:48:08.543" v="97" actId="164"/>
          <ac:spMkLst>
            <pc:docMk/>
            <pc:sldMk cId="0" sldId="258"/>
            <ac:spMk id="516" creationId="{00000000-0000-0000-0000-000000000000}"/>
          </ac:spMkLst>
        </pc:spChg>
        <pc:spChg chg="mod topLvl">
          <ac:chgData name="vijay kumar" userId="0eb738f014aa4543" providerId="LiveId" clId="{B4DB2928-3EFF-4507-ABD0-3894F091460A}" dt="2020-04-27T17:48:08.543" v="97" actId="164"/>
          <ac:spMkLst>
            <pc:docMk/>
            <pc:sldMk cId="0" sldId="258"/>
            <ac:spMk id="517" creationId="{00000000-0000-0000-0000-000000000000}"/>
          </ac:spMkLst>
        </pc:spChg>
        <pc:spChg chg="mod topLvl">
          <ac:chgData name="vijay kumar" userId="0eb738f014aa4543" providerId="LiveId" clId="{B4DB2928-3EFF-4507-ABD0-3894F091460A}" dt="2020-04-27T17:48:08.543" v="97" actId="164"/>
          <ac:spMkLst>
            <pc:docMk/>
            <pc:sldMk cId="0" sldId="258"/>
            <ac:spMk id="518" creationId="{00000000-0000-0000-0000-000000000000}"/>
          </ac:spMkLst>
        </pc:spChg>
        <pc:spChg chg="mod topLvl">
          <ac:chgData name="vijay kumar" userId="0eb738f014aa4543" providerId="LiveId" clId="{B4DB2928-3EFF-4507-ABD0-3894F091460A}" dt="2020-04-27T17:48:08.543" v="97" actId="164"/>
          <ac:spMkLst>
            <pc:docMk/>
            <pc:sldMk cId="0" sldId="258"/>
            <ac:spMk id="519" creationId="{00000000-0000-0000-0000-000000000000}"/>
          </ac:spMkLst>
        </pc:spChg>
        <pc:spChg chg="mod topLvl">
          <ac:chgData name="vijay kumar" userId="0eb738f014aa4543" providerId="LiveId" clId="{B4DB2928-3EFF-4507-ABD0-3894F091460A}" dt="2020-04-27T17:48:08.543" v="97" actId="164"/>
          <ac:spMkLst>
            <pc:docMk/>
            <pc:sldMk cId="0" sldId="258"/>
            <ac:spMk id="520" creationId="{00000000-0000-0000-0000-000000000000}"/>
          </ac:spMkLst>
        </pc:spChg>
        <pc:spChg chg="mod topLvl">
          <ac:chgData name="vijay kumar" userId="0eb738f014aa4543" providerId="LiveId" clId="{B4DB2928-3EFF-4507-ABD0-3894F091460A}" dt="2020-04-27T17:48:08.543" v="97" actId="164"/>
          <ac:spMkLst>
            <pc:docMk/>
            <pc:sldMk cId="0" sldId="258"/>
            <ac:spMk id="521" creationId="{00000000-0000-0000-0000-000000000000}"/>
          </ac:spMkLst>
        </pc:spChg>
        <pc:spChg chg="mod topLvl">
          <ac:chgData name="vijay kumar" userId="0eb738f014aa4543" providerId="LiveId" clId="{B4DB2928-3EFF-4507-ABD0-3894F091460A}" dt="2020-04-27T17:48:08.543" v="97" actId="164"/>
          <ac:spMkLst>
            <pc:docMk/>
            <pc:sldMk cId="0" sldId="258"/>
            <ac:spMk id="522" creationId="{00000000-0000-0000-0000-000000000000}"/>
          </ac:spMkLst>
        </pc:spChg>
        <pc:spChg chg="mod topLvl">
          <ac:chgData name="vijay kumar" userId="0eb738f014aa4543" providerId="LiveId" clId="{B4DB2928-3EFF-4507-ABD0-3894F091460A}" dt="2020-04-27T17:48:08.543" v="97" actId="164"/>
          <ac:spMkLst>
            <pc:docMk/>
            <pc:sldMk cId="0" sldId="258"/>
            <ac:spMk id="523" creationId="{00000000-0000-0000-0000-000000000000}"/>
          </ac:spMkLst>
        </pc:spChg>
        <pc:spChg chg="mod topLvl">
          <ac:chgData name="vijay kumar" userId="0eb738f014aa4543" providerId="LiveId" clId="{B4DB2928-3EFF-4507-ABD0-3894F091460A}" dt="2020-04-27T17:48:08.543" v="97" actId="164"/>
          <ac:spMkLst>
            <pc:docMk/>
            <pc:sldMk cId="0" sldId="258"/>
            <ac:spMk id="524" creationId="{00000000-0000-0000-0000-000000000000}"/>
          </ac:spMkLst>
        </pc:spChg>
        <pc:spChg chg="mod topLvl">
          <ac:chgData name="vijay kumar" userId="0eb738f014aa4543" providerId="LiveId" clId="{B4DB2928-3EFF-4507-ABD0-3894F091460A}" dt="2020-04-27T17:48:08.543" v="97" actId="164"/>
          <ac:spMkLst>
            <pc:docMk/>
            <pc:sldMk cId="0" sldId="258"/>
            <ac:spMk id="525" creationId="{00000000-0000-0000-0000-000000000000}"/>
          </ac:spMkLst>
        </pc:spChg>
        <pc:spChg chg="mod topLvl">
          <ac:chgData name="vijay kumar" userId="0eb738f014aa4543" providerId="LiveId" clId="{B4DB2928-3EFF-4507-ABD0-3894F091460A}" dt="2020-04-27T17:48:08.543" v="97" actId="164"/>
          <ac:spMkLst>
            <pc:docMk/>
            <pc:sldMk cId="0" sldId="258"/>
            <ac:spMk id="526" creationId="{00000000-0000-0000-0000-000000000000}"/>
          </ac:spMkLst>
        </pc:spChg>
        <pc:spChg chg="mod topLvl">
          <ac:chgData name="vijay kumar" userId="0eb738f014aa4543" providerId="LiveId" clId="{B4DB2928-3EFF-4507-ABD0-3894F091460A}" dt="2020-04-27T17:48:08.543" v="97" actId="164"/>
          <ac:spMkLst>
            <pc:docMk/>
            <pc:sldMk cId="0" sldId="258"/>
            <ac:spMk id="527" creationId="{00000000-0000-0000-0000-000000000000}"/>
          </ac:spMkLst>
        </pc:spChg>
        <pc:spChg chg="mod topLvl">
          <ac:chgData name="vijay kumar" userId="0eb738f014aa4543" providerId="LiveId" clId="{B4DB2928-3EFF-4507-ABD0-3894F091460A}" dt="2020-04-27T17:48:08.543" v="97" actId="164"/>
          <ac:spMkLst>
            <pc:docMk/>
            <pc:sldMk cId="0" sldId="258"/>
            <ac:spMk id="528" creationId="{00000000-0000-0000-0000-000000000000}"/>
          </ac:spMkLst>
        </pc:spChg>
        <pc:spChg chg="mod topLvl">
          <ac:chgData name="vijay kumar" userId="0eb738f014aa4543" providerId="LiveId" clId="{B4DB2928-3EFF-4507-ABD0-3894F091460A}" dt="2020-04-27T17:48:08.543" v="97" actId="164"/>
          <ac:spMkLst>
            <pc:docMk/>
            <pc:sldMk cId="0" sldId="258"/>
            <ac:spMk id="529" creationId="{00000000-0000-0000-0000-000000000000}"/>
          </ac:spMkLst>
        </pc:spChg>
        <pc:spChg chg="mod topLvl">
          <ac:chgData name="vijay kumar" userId="0eb738f014aa4543" providerId="LiveId" clId="{B4DB2928-3EFF-4507-ABD0-3894F091460A}" dt="2020-04-27T17:48:08.543" v="97" actId="164"/>
          <ac:spMkLst>
            <pc:docMk/>
            <pc:sldMk cId="0" sldId="258"/>
            <ac:spMk id="530" creationId="{00000000-0000-0000-0000-000000000000}"/>
          </ac:spMkLst>
        </pc:spChg>
        <pc:spChg chg="mod topLvl">
          <ac:chgData name="vijay kumar" userId="0eb738f014aa4543" providerId="LiveId" clId="{B4DB2928-3EFF-4507-ABD0-3894F091460A}" dt="2020-04-27T17:48:08.543" v="97" actId="164"/>
          <ac:spMkLst>
            <pc:docMk/>
            <pc:sldMk cId="0" sldId="258"/>
            <ac:spMk id="531" creationId="{00000000-0000-0000-0000-000000000000}"/>
          </ac:spMkLst>
        </pc:spChg>
        <pc:spChg chg="mod topLvl">
          <ac:chgData name="vijay kumar" userId="0eb738f014aa4543" providerId="LiveId" clId="{B4DB2928-3EFF-4507-ABD0-3894F091460A}" dt="2020-04-27T17:48:08.543" v="97" actId="164"/>
          <ac:spMkLst>
            <pc:docMk/>
            <pc:sldMk cId="0" sldId="258"/>
            <ac:spMk id="532" creationId="{00000000-0000-0000-0000-000000000000}"/>
          </ac:spMkLst>
        </pc:spChg>
        <pc:spChg chg="mod topLvl">
          <ac:chgData name="vijay kumar" userId="0eb738f014aa4543" providerId="LiveId" clId="{B4DB2928-3EFF-4507-ABD0-3894F091460A}" dt="2020-04-27T17:48:08.543" v="97" actId="164"/>
          <ac:spMkLst>
            <pc:docMk/>
            <pc:sldMk cId="0" sldId="258"/>
            <ac:spMk id="533" creationId="{00000000-0000-0000-0000-000000000000}"/>
          </ac:spMkLst>
        </pc:spChg>
        <pc:spChg chg="mod topLvl">
          <ac:chgData name="vijay kumar" userId="0eb738f014aa4543" providerId="LiveId" clId="{B4DB2928-3EFF-4507-ABD0-3894F091460A}" dt="2020-04-27T17:48:08.543" v="97" actId="164"/>
          <ac:spMkLst>
            <pc:docMk/>
            <pc:sldMk cId="0" sldId="258"/>
            <ac:spMk id="534" creationId="{00000000-0000-0000-0000-000000000000}"/>
          </ac:spMkLst>
        </pc:spChg>
        <pc:spChg chg="mod topLvl">
          <ac:chgData name="vijay kumar" userId="0eb738f014aa4543" providerId="LiveId" clId="{B4DB2928-3EFF-4507-ABD0-3894F091460A}" dt="2020-04-27T17:48:08.543" v="97" actId="164"/>
          <ac:spMkLst>
            <pc:docMk/>
            <pc:sldMk cId="0" sldId="258"/>
            <ac:spMk id="535" creationId="{00000000-0000-0000-0000-000000000000}"/>
          </ac:spMkLst>
        </pc:spChg>
        <pc:spChg chg="mod topLvl">
          <ac:chgData name="vijay kumar" userId="0eb738f014aa4543" providerId="LiveId" clId="{B4DB2928-3EFF-4507-ABD0-3894F091460A}" dt="2020-04-27T17:48:08.543" v="97" actId="164"/>
          <ac:spMkLst>
            <pc:docMk/>
            <pc:sldMk cId="0" sldId="258"/>
            <ac:spMk id="536" creationId="{00000000-0000-0000-0000-000000000000}"/>
          </ac:spMkLst>
        </pc:spChg>
        <pc:spChg chg="mod topLvl">
          <ac:chgData name="vijay kumar" userId="0eb738f014aa4543" providerId="LiveId" clId="{B4DB2928-3EFF-4507-ABD0-3894F091460A}" dt="2020-04-27T17:48:08.543" v="97" actId="164"/>
          <ac:spMkLst>
            <pc:docMk/>
            <pc:sldMk cId="0" sldId="258"/>
            <ac:spMk id="537" creationId="{00000000-0000-0000-0000-000000000000}"/>
          </ac:spMkLst>
        </pc:spChg>
        <pc:spChg chg="mod topLvl">
          <ac:chgData name="vijay kumar" userId="0eb738f014aa4543" providerId="LiveId" clId="{B4DB2928-3EFF-4507-ABD0-3894F091460A}" dt="2020-04-27T17:48:08.543" v="97" actId="164"/>
          <ac:spMkLst>
            <pc:docMk/>
            <pc:sldMk cId="0" sldId="258"/>
            <ac:spMk id="538" creationId="{00000000-0000-0000-0000-000000000000}"/>
          </ac:spMkLst>
        </pc:spChg>
        <pc:spChg chg="mod topLvl">
          <ac:chgData name="vijay kumar" userId="0eb738f014aa4543" providerId="LiveId" clId="{B4DB2928-3EFF-4507-ABD0-3894F091460A}" dt="2020-04-27T17:48:08.543" v="97" actId="164"/>
          <ac:spMkLst>
            <pc:docMk/>
            <pc:sldMk cId="0" sldId="258"/>
            <ac:spMk id="539" creationId="{00000000-0000-0000-0000-000000000000}"/>
          </ac:spMkLst>
        </pc:spChg>
        <pc:spChg chg="mod topLvl">
          <ac:chgData name="vijay kumar" userId="0eb738f014aa4543" providerId="LiveId" clId="{B4DB2928-3EFF-4507-ABD0-3894F091460A}" dt="2020-04-27T17:48:08.543" v="97" actId="164"/>
          <ac:spMkLst>
            <pc:docMk/>
            <pc:sldMk cId="0" sldId="258"/>
            <ac:spMk id="540" creationId="{00000000-0000-0000-0000-000000000000}"/>
          </ac:spMkLst>
        </pc:spChg>
        <pc:spChg chg="mod topLvl">
          <ac:chgData name="vijay kumar" userId="0eb738f014aa4543" providerId="LiveId" clId="{B4DB2928-3EFF-4507-ABD0-3894F091460A}" dt="2020-04-27T17:48:08.543" v="97" actId="164"/>
          <ac:spMkLst>
            <pc:docMk/>
            <pc:sldMk cId="0" sldId="258"/>
            <ac:spMk id="541" creationId="{00000000-0000-0000-0000-000000000000}"/>
          </ac:spMkLst>
        </pc:spChg>
        <pc:spChg chg="mod topLvl">
          <ac:chgData name="vijay kumar" userId="0eb738f014aa4543" providerId="LiveId" clId="{B4DB2928-3EFF-4507-ABD0-3894F091460A}" dt="2020-04-27T17:48:08.543" v="97" actId="164"/>
          <ac:spMkLst>
            <pc:docMk/>
            <pc:sldMk cId="0" sldId="258"/>
            <ac:spMk id="542" creationId="{00000000-0000-0000-0000-000000000000}"/>
          </ac:spMkLst>
        </pc:spChg>
        <pc:spChg chg="add del mod topLvl">
          <ac:chgData name="vijay kumar" userId="0eb738f014aa4543" providerId="LiveId" clId="{B4DB2928-3EFF-4507-ABD0-3894F091460A}" dt="2020-04-27T17:52:35.651" v="331" actId="164"/>
          <ac:spMkLst>
            <pc:docMk/>
            <pc:sldMk cId="0" sldId="258"/>
            <ac:spMk id="544" creationId="{00000000-0000-0000-0000-000000000000}"/>
          </ac:spMkLst>
        </pc:spChg>
        <pc:spChg chg="add del mod topLvl">
          <ac:chgData name="vijay kumar" userId="0eb738f014aa4543" providerId="LiveId" clId="{B4DB2928-3EFF-4507-ABD0-3894F091460A}" dt="2020-04-27T17:52:35.651" v="331" actId="164"/>
          <ac:spMkLst>
            <pc:docMk/>
            <pc:sldMk cId="0" sldId="258"/>
            <ac:spMk id="550" creationId="{00000000-0000-0000-0000-000000000000}"/>
          </ac:spMkLst>
        </pc:spChg>
        <pc:spChg chg="mod topLvl">
          <ac:chgData name="vijay kumar" userId="0eb738f014aa4543" providerId="LiveId" clId="{B4DB2928-3EFF-4507-ABD0-3894F091460A}" dt="2020-04-27T17:53:18.987" v="334" actId="164"/>
          <ac:spMkLst>
            <pc:docMk/>
            <pc:sldMk cId="0" sldId="258"/>
            <ac:spMk id="552" creationId="{00000000-0000-0000-0000-000000000000}"/>
          </ac:spMkLst>
        </pc:spChg>
        <pc:spChg chg="mod topLvl">
          <ac:chgData name="vijay kumar" userId="0eb738f014aa4543" providerId="LiveId" clId="{B4DB2928-3EFF-4507-ABD0-3894F091460A}" dt="2020-04-27T17:53:18.987" v="334" actId="164"/>
          <ac:spMkLst>
            <pc:docMk/>
            <pc:sldMk cId="0" sldId="258"/>
            <ac:spMk id="553" creationId="{00000000-0000-0000-0000-000000000000}"/>
          </ac:spMkLst>
        </pc:spChg>
        <pc:spChg chg="mod topLvl">
          <ac:chgData name="vijay kumar" userId="0eb738f014aa4543" providerId="LiveId" clId="{B4DB2928-3EFF-4507-ABD0-3894F091460A}" dt="2020-04-27T17:53:18.987" v="334" actId="164"/>
          <ac:spMkLst>
            <pc:docMk/>
            <pc:sldMk cId="0" sldId="258"/>
            <ac:spMk id="554" creationId="{00000000-0000-0000-0000-000000000000}"/>
          </ac:spMkLst>
        </pc:spChg>
        <pc:spChg chg="mod topLvl">
          <ac:chgData name="vijay kumar" userId="0eb738f014aa4543" providerId="LiveId" clId="{B4DB2928-3EFF-4507-ABD0-3894F091460A}" dt="2020-04-27T17:53:18.987" v="334" actId="164"/>
          <ac:spMkLst>
            <pc:docMk/>
            <pc:sldMk cId="0" sldId="258"/>
            <ac:spMk id="555" creationId="{00000000-0000-0000-0000-000000000000}"/>
          </ac:spMkLst>
        </pc:spChg>
        <pc:spChg chg="mod topLvl">
          <ac:chgData name="vijay kumar" userId="0eb738f014aa4543" providerId="LiveId" clId="{B4DB2928-3EFF-4507-ABD0-3894F091460A}" dt="2020-04-27T17:53:18.987" v="334" actId="164"/>
          <ac:spMkLst>
            <pc:docMk/>
            <pc:sldMk cId="0" sldId="258"/>
            <ac:spMk id="556" creationId="{00000000-0000-0000-0000-000000000000}"/>
          </ac:spMkLst>
        </pc:spChg>
        <pc:spChg chg="mod topLvl">
          <ac:chgData name="vijay kumar" userId="0eb738f014aa4543" providerId="LiveId" clId="{B4DB2928-3EFF-4507-ABD0-3894F091460A}" dt="2020-04-27T17:53:18.987" v="334" actId="164"/>
          <ac:spMkLst>
            <pc:docMk/>
            <pc:sldMk cId="0" sldId="258"/>
            <ac:spMk id="565" creationId="{00000000-0000-0000-0000-000000000000}"/>
          </ac:spMkLst>
        </pc:spChg>
        <pc:spChg chg="mod topLvl">
          <ac:chgData name="vijay kumar" userId="0eb738f014aa4543" providerId="LiveId" clId="{B4DB2928-3EFF-4507-ABD0-3894F091460A}" dt="2020-04-27T17:53:18.987" v="334" actId="164"/>
          <ac:spMkLst>
            <pc:docMk/>
            <pc:sldMk cId="0" sldId="258"/>
            <ac:spMk id="566" creationId="{00000000-0000-0000-0000-000000000000}"/>
          </ac:spMkLst>
        </pc:spChg>
        <pc:spChg chg="mod topLvl">
          <ac:chgData name="vijay kumar" userId="0eb738f014aa4543" providerId="LiveId" clId="{B4DB2928-3EFF-4507-ABD0-3894F091460A}" dt="2020-04-27T17:53:18.987" v="334" actId="164"/>
          <ac:spMkLst>
            <pc:docMk/>
            <pc:sldMk cId="0" sldId="258"/>
            <ac:spMk id="567" creationId="{00000000-0000-0000-0000-000000000000}"/>
          </ac:spMkLst>
        </pc:spChg>
        <pc:spChg chg="mod topLvl">
          <ac:chgData name="vijay kumar" userId="0eb738f014aa4543" providerId="LiveId" clId="{B4DB2928-3EFF-4507-ABD0-3894F091460A}" dt="2020-04-27T17:53:18.987" v="334" actId="164"/>
          <ac:spMkLst>
            <pc:docMk/>
            <pc:sldMk cId="0" sldId="258"/>
            <ac:spMk id="568" creationId="{00000000-0000-0000-0000-000000000000}"/>
          </ac:spMkLst>
        </pc:spChg>
        <pc:spChg chg="mod topLvl">
          <ac:chgData name="vijay kumar" userId="0eb738f014aa4543" providerId="LiveId" clId="{B4DB2928-3EFF-4507-ABD0-3894F091460A}" dt="2020-04-27T17:53:18.987" v="334" actId="164"/>
          <ac:spMkLst>
            <pc:docMk/>
            <pc:sldMk cId="0" sldId="258"/>
            <ac:spMk id="569" creationId="{00000000-0000-0000-0000-000000000000}"/>
          </ac:spMkLst>
        </pc:spChg>
        <pc:spChg chg="mod topLvl">
          <ac:chgData name="vijay kumar" userId="0eb738f014aa4543" providerId="LiveId" clId="{B4DB2928-3EFF-4507-ABD0-3894F091460A}" dt="2020-04-27T17:53:18.987" v="334" actId="164"/>
          <ac:spMkLst>
            <pc:docMk/>
            <pc:sldMk cId="0" sldId="258"/>
            <ac:spMk id="578" creationId="{00000000-0000-0000-0000-000000000000}"/>
          </ac:spMkLst>
        </pc:spChg>
        <pc:spChg chg="mod topLvl">
          <ac:chgData name="vijay kumar" userId="0eb738f014aa4543" providerId="LiveId" clId="{B4DB2928-3EFF-4507-ABD0-3894F091460A}" dt="2020-04-27T17:53:18.987" v="334" actId="164"/>
          <ac:spMkLst>
            <pc:docMk/>
            <pc:sldMk cId="0" sldId="258"/>
            <ac:spMk id="579" creationId="{00000000-0000-0000-0000-000000000000}"/>
          </ac:spMkLst>
        </pc:spChg>
        <pc:spChg chg="mod topLvl">
          <ac:chgData name="vijay kumar" userId="0eb738f014aa4543" providerId="LiveId" clId="{B4DB2928-3EFF-4507-ABD0-3894F091460A}" dt="2020-04-27T17:53:18.987" v="334" actId="164"/>
          <ac:spMkLst>
            <pc:docMk/>
            <pc:sldMk cId="0" sldId="258"/>
            <ac:spMk id="580" creationId="{00000000-0000-0000-0000-000000000000}"/>
          </ac:spMkLst>
        </pc:spChg>
        <pc:spChg chg="mod topLvl">
          <ac:chgData name="vijay kumar" userId="0eb738f014aa4543" providerId="LiveId" clId="{B4DB2928-3EFF-4507-ABD0-3894F091460A}" dt="2020-04-27T17:53:18.987" v="334" actId="164"/>
          <ac:spMkLst>
            <pc:docMk/>
            <pc:sldMk cId="0" sldId="258"/>
            <ac:spMk id="581" creationId="{00000000-0000-0000-0000-000000000000}"/>
          </ac:spMkLst>
        </pc:spChg>
        <pc:spChg chg="mod topLvl">
          <ac:chgData name="vijay kumar" userId="0eb738f014aa4543" providerId="LiveId" clId="{B4DB2928-3EFF-4507-ABD0-3894F091460A}" dt="2020-04-27T17:53:18.987" v="334" actId="164"/>
          <ac:spMkLst>
            <pc:docMk/>
            <pc:sldMk cId="0" sldId="258"/>
            <ac:spMk id="582" creationId="{00000000-0000-0000-0000-000000000000}"/>
          </ac:spMkLst>
        </pc:spChg>
        <pc:spChg chg="mod topLvl">
          <ac:chgData name="vijay kumar" userId="0eb738f014aa4543" providerId="LiveId" clId="{B4DB2928-3EFF-4507-ABD0-3894F091460A}" dt="2020-04-27T17:53:18.987" v="334" actId="164"/>
          <ac:spMkLst>
            <pc:docMk/>
            <pc:sldMk cId="0" sldId="258"/>
            <ac:spMk id="583" creationId="{00000000-0000-0000-0000-000000000000}"/>
          </ac:spMkLst>
        </pc:spChg>
        <pc:spChg chg="mod topLvl">
          <ac:chgData name="vijay kumar" userId="0eb738f014aa4543" providerId="LiveId" clId="{B4DB2928-3EFF-4507-ABD0-3894F091460A}" dt="2020-04-27T17:53:18.987" v="334" actId="164"/>
          <ac:spMkLst>
            <pc:docMk/>
            <pc:sldMk cId="0" sldId="258"/>
            <ac:spMk id="584" creationId="{00000000-0000-0000-0000-000000000000}"/>
          </ac:spMkLst>
        </pc:spChg>
        <pc:spChg chg="mod topLvl">
          <ac:chgData name="vijay kumar" userId="0eb738f014aa4543" providerId="LiveId" clId="{B4DB2928-3EFF-4507-ABD0-3894F091460A}" dt="2020-04-27T17:53:18.987" v="334" actId="164"/>
          <ac:spMkLst>
            <pc:docMk/>
            <pc:sldMk cId="0" sldId="258"/>
            <ac:spMk id="585" creationId="{00000000-0000-0000-0000-000000000000}"/>
          </ac:spMkLst>
        </pc:spChg>
        <pc:spChg chg="mod topLvl">
          <ac:chgData name="vijay kumar" userId="0eb738f014aa4543" providerId="LiveId" clId="{B4DB2928-3EFF-4507-ABD0-3894F091460A}" dt="2020-04-27T17:53:18.987" v="334" actId="164"/>
          <ac:spMkLst>
            <pc:docMk/>
            <pc:sldMk cId="0" sldId="258"/>
            <ac:spMk id="586" creationId="{00000000-0000-0000-0000-000000000000}"/>
          </ac:spMkLst>
        </pc:spChg>
        <pc:spChg chg="mod topLvl">
          <ac:chgData name="vijay kumar" userId="0eb738f014aa4543" providerId="LiveId" clId="{B4DB2928-3EFF-4507-ABD0-3894F091460A}" dt="2020-04-27T17:53:18.987" v="334" actId="164"/>
          <ac:spMkLst>
            <pc:docMk/>
            <pc:sldMk cId="0" sldId="258"/>
            <ac:spMk id="587" creationId="{00000000-0000-0000-0000-000000000000}"/>
          </ac:spMkLst>
        </pc:spChg>
        <pc:spChg chg="mod topLvl">
          <ac:chgData name="vijay kumar" userId="0eb738f014aa4543" providerId="LiveId" clId="{B4DB2928-3EFF-4507-ABD0-3894F091460A}" dt="2020-04-27T17:53:18.987" v="334" actId="164"/>
          <ac:spMkLst>
            <pc:docMk/>
            <pc:sldMk cId="0" sldId="258"/>
            <ac:spMk id="588" creationId="{00000000-0000-0000-0000-000000000000}"/>
          </ac:spMkLst>
        </pc:spChg>
        <pc:spChg chg="mod topLvl">
          <ac:chgData name="vijay kumar" userId="0eb738f014aa4543" providerId="LiveId" clId="{B4DB2928-3EFF-4507-ABD0-3894F091460A}" dt="2020-04-27T17:53:18.987" v="334" actId="164"/>
          <ac:spMkLst>
            <pc:docMk/>
            <pc:sldMk cId="0" sldId="258"/>
            <ac:spMk id="589" creationId="{00000000-0000-0000-0000-000000000000}"/>
          </ac:spMkLst>
        </pc:spChg>
        <pc:spChg chg="mod topLvl">
          <ac:chgData name="vijay kumar" userId="0eb738f014aa4543" providerId="LiveId" clId="{B4DB2928-3EFF-4507-ABD0-3894F091460A}" dt="2020-04-27T17:53:18.987" v="334" actId="164"/>
          <ac:spMkLst>
            <pc:docMk/>
            <pc:sldMk cId="0" sldId="258"/>
            <ac:spMk id="590" creationId="{00000000-0000-0000-0000-000000000000}"/>
          </ac:spMkLst>
        </pc:spChg>
        <pc:spChg chg="mod topLvl">
          <ac:chgData name="vijay kumar" userId="0eb738f014aa4543" providerId="LiveId" clId="{B4DB2928-3EFF-4507-ABD0-3894F091460A}" dt="2020-04-27T17:53:18.987" v="334" actId="164"/>
          <ac:spMkLst>
            <pc:docMk/>
            <pc:sldMk cId="0" sldId="258"/>
            <ac:spMk id="591" creationId="{00000000-0000-0000-0000-000000000000}"/>
          </ac:spMkLst>
        </pc:spChg>
        <pc:spChg chg="mod topLvl">
          <ac:chgData name="vijay kumar" userId="0eb738f014aa4543" providerId="LiveId" clId="{B4DB2928-3EFF-4507-ABD0-3894F091460A}" dt="2020-04-27T17:53:18.987" v="334" actId="164"/>
          <ac:spMkLst>
            <pc:docMk/>
            <pc:sldMk cId="0" sldId="258"/>
            <ac:spMk id="592" creationId="{00000000-0000-0000-0000-000000000000}"/>
          </ac:spMkLst>
        </pc:spChg>
        <pc:spChg chg="mod topLvl">
          <ac:chgData name="vijay kumar" userId="0eb738f014aa4543" providerId="LiveId" clId="{B4DB2928-3EFF-4507-ABD0-3894F091460A}" dt="2020-04-27T17:53:18.987" v="334" actId="164"/>
          <ac:spMkLst>
            <pc:docMk/>
            <pc:sldMk cId="0" sldId="258"/>
            <ac:spMk id="593" creationId="{00000000-0000-0000-0000-000000000000}"/>
          </ac:spMkLst>
        </pc:spChg>
        <pc:spChg chg="mod topLvl">
          <ac:chgData name="vijay kumar" userId="0eb738f014aa4543" providerId="LiveId" clId="{B4DB2928-3EFF-4507-ABD0-3894F091460A}" dt="2020-04-27T17:53:18.987" v="334" actId="164"/>
          <ac:spMkLst>
            <pc:docMk/>
            <pc:sldMk cId="0" sldId="258"/>
            <ac:spMk id="594" creationId="{00000000-0000-0000-0000-000000000000}"/>
          </ac:spMkLst>
        </pc:spChg>
        <pc:spChg chg="mod topLvl">
          <ac:chgData name="vijay kumar" userId="0eb738f014aa4543" providerId="LiveId" clId="{B4DB2928-3EFF-4507-ABD0-3894F091460A}" dt="2020-04-27T17:53:18.987" v="334" actId="164"/>
          <ac:spMkLst>
            <pc:docMk/>
            <pc:sldMk cId="0" sldId="258"/>
            <ac:spMk id="595" creationId="{00000000-0000-0000-0000-000000000000}"/>
          </ac:spMkLst>
        </pc:spChg>
        <pc:spChg chg="mod topLvl">
          <ac:chgData name="vijay kumar" userId="0eb738f014aa4543" providerId="LiveId" clId="{B4DB2928-3EFF-4507-ABD0-3894F091460A}" dt="2020-04-27T17:53:18.987" v="334" actId="164"/>
          <ac:spMkLst>
            <pc:docMk/>
            <pc:sldMk cId="0" sldId="258"/>
            <ac:spMk id="596" creationId="{00000000-0000-0000-0000-000000000000}"/>
          </ac:spMkLst>
        </pc:spChg>
        <pc:spChg chg="mod topLvl">
          <ac:chgData name="vijay kumar" userId="0eb738f014aa4543" providerId="LiveId" clId="{B4DB2928-3EFF-4507-ABD0-3894F091460A}" dt="2020-04-27T17:53:18.987" v="334" actId="164"/>
          <ac:spMkLst>
            <pc:docMk/>
            <pc:sldMk cId="0" sldId="258"/>
            <ac:spMk id="597" creationId="{00000000-0000-0000-0000-000000000000}"/>
          </ac:spMkLst>
        </pc:spChg>
        <pc:spChg chg="mod topLvl">
          <ac:chgData name="vijay kumar" userId="0eb738f014aa4543" providerId="LiveId" clId="{B4DB2928-3EFF-4507-ABD0-3894F091460A}" dt="2020-04-27T17:53:18.987" v="334" actId="164"/>
          <ac:spMkLst>
            <pc:docMk/>
            <pc:sldMk cId="0" sldId="258"/>
            <ac:spMk id="598" creationId="{00000000-0000-0000-0000-000000000000}"/>
          </ac:spMkLst>
        </pc:spChg>
        <pc:spChg chg="mod topLvl">
          <ac:chgData name="vijay kumar" userId="0eb738f014aa4543" providerId="LiveId" clId="{B4DB2928-3EFF-4507-ABD0-3894F091460A}" dt="2020-04-27T17:53:18.987" v="334" actId="164"/>
          <ac:spMkLst>
            <pc:docMk/>
            <pc:sldMk cId="0" sldId="258"/>
            <ac:spMk id="599" creationId="{00000000-0000-0000-0000-000000000000}"/>
          </ac:spMkLst>
        </pc:spChg>
        <pc:spChg chg="mod topLvl">
          <ac:chgData name="vijay kumar" userId="0eb738f014aa4543" providerId="LiveId" clId="{B4DB2928-3EFF-4507-ABD0-3894F091460A}" dt="2020-04-27T17:53:18.987" v="334" actId="164"/>
          <ac:spMkLst>
            <pc:docMk/>
            <pc:sldMk cId="0" sldId="258"/>
            <ac:spMk id="600" creationId="{00000000-0000-0000-0000-000000000000}"/>
          </ac:spMkLst>
        </pc:spChg>
        <pc:spChg chg="mod topLvl">
          <ac:chgData name="vijay kumar" userId="0eb738f014aa4543" providerId="LiveId" clId="{B4DB2928-3EFF-4507-ABD0-3894F091460A}" dt="2020-04-27T17:53:18.987" v="334" actId="164"/>
          <ac:spMkLst>
            <pc:docMk/>
            <pc:sldMk cId="0" sldId="258"/>
            <ac:spMk id="601" creationId="{00000000-0000-0000-0000-000000000000}"/>
          </ac:spMkLst>
        </pc:spChg>
        <pc:spChg chg="mod topLvl">
          <ac:chgData name="vijay kumar" userId="0eb738f014aa4543" providerId="LiveId" clId="{B4DB2928-3EFF-4507-ABD0-3894F091460A}" dt="2020-04-27T17:53:18.987" v="334" actId="164"/>
          <ac:spMkLst>
            <pc:docMk/>
            <pc:sldMk cId="0" sldId="258"/>
            <ac:spMk id="602" creationId="{00000000-0000-0000-0000-000000000000}"/>
          </ac:spMkLst>
        </pc:spChg>
        <pc:spChg chg="mod topLvl">
          <ac:chgData name="vijay kumar" userId="0eb738f014aa4543" providerId="LiveId" clId="{B4DB2928-3EFF-4507-ABD0-3894F091460A}" dt="2020-04-27T17:53:18.987" v="334" actId="164"/>
          <ac:spMkLst>
            <pc:docMk/>
            <pc:sldMk cId="0" sldId="258"/>
            <ac:spMk id="603" creationId="{00000000-0000-0000-0000-000000000000}"/>
          </ac:spMkLst>
        </pc:spChg>
        <pc:spChg chg="mod topLvl">
          <ac:chgData name="vijay kumar" userId="0eb738f014aa4543" providerId="LiveId" clId="{B4DB2928-3EFF-4507-ABD0-3894F091460A}" dt="2020-04-27T17:53:18.987" v="334" actId="164"/>
          <ac:spMkLst>
            <pc:docMk/>
            <pc:sldMk cId="0" sldId="258"/>
            <ac:spMk id="604" creationId="{00000000-0000-0000-0000-000000000000}"/>
          </ac:spMkLst>
        </pc:spChg>
        <pc:spChg chg="mod topLvl">
          <ac:chgData name="vijay kumar" userId="0eb738f014aa4543" providerId="LiveId" clId="{B4DB2928-3EFF-4507-ABD0-3894F091460A}" dt="2020-04-27T17:53:18.987" v="334" actId="164"/>
          <ac:spMkLst>
            <pc:docMk/>
            <pc:sldMk cId="0" sldId="258"/>
            <ac:spMk id="605" creationId="{00000000-0000-0000-0000-000000000000}"/>
          </ac:spMkLst>
        </pc:spChg>
        <pc:spChg chg="mod topLvl">
          <ac:chgData name="vijay kumar" userId="0eb738f014aa4543" providerId="LiveId" clId="{B4DB2928-3EFF-4507-ABD0-3894F091460A}" dt="2020-04-27T17:53:18.987" v="334" actId="164"/>
          <ac:spMkLst>
            <pc:docMk/>
            <pc:sldMk cId="0" sldId="258"/>
            <ac:spMk id="606" creationId="{00000000-0000-0000-0000-000000000000}"/>
          </ac:spMkLst>
        </pc:spChg>
        <pc:spChg chg="mod">
          <ac:chgData name="vijay kumar" userId="0eb738f014aa4543" providerId="LiveId" clId="{B4DB2928-3EFF-4507-ABD0-3894F091460A}" dt="2020-04-27T17:51:42.604" v="256" actId="164"/>
          <ac:spMkLst>
            <pc:docMk/>
            <pc:sldMk cId="0" sldId="258"/>
            <ac:spMk id="667" creationId="{00000000-0000-0000-0000-000000000000}"/>
          </ac:spMkLst>
        </pc:spChg>
        <pc:spChg chg="mod">
          <ac:chgData name="vijay kumar" userId="0eb738f014aa4543" providerId="LiveId" clId="{B4DB2928-3EFF-4507-ABD0-3894F091460A}" dt="2020-05-24T14:29:11.794" v="15181" actId="14100"/>
          <ac:spMkLst>
            <pc:docMk/>
            <pc:sldMk cId="0" sldId="258"/>
            <ac:spMk id="696" creationId="{00000000-0000-0000-0000-000000000000}"/>
          </ac:spMkLst>
        </pc:spChg>
        <pc:spChg chg="del">
          <ac:chgData name="vijay kumar" userId="0eb738f014aa4543" providerId="LiveId" clId="{B4DB2928-3EFF-4507-ABD0-3894F091460A}" dt="2020-04-27T17:47:26.739" v="94" actId="478"/>
          <ac:spMkLst>
            <pc:docMk/>
            <pc:sldMk cId="0" sldId="258"/>
            <ac:spMk id="1630" creationId="{00000000-0000-0000-0000-000000000000}"/>
          </ac:spMkLst>
        </pc:spChg>
        <pc:spChg chg="del">
          <ac:chgData name="vijay kumar" userId="0eb738f014aa4543" providerId="LiveId" clId="{B4DB2928-3EFF-4507-ABD0-3894F091460A}" dt="2020-04-27T17:44:52.225" v="2" actId="21"/>
          <ac:spMkLst>
            <pc:docMk/>
            <pc:sldMk cId="0" sldId="258"/>
            <ac:spMk id="1631" creationId="{00000000-0000-0000-0000-000000000000}"/>
          </ac:spMkLst>
        </pc:spChg>
        <pc:grpChg chg="add mod topLvl">
          <ac:chgData name="vijay kumar" userId="0eb738f014aa4543" providerId="LiveId" clId="{B4DB2928-3EFF-4507-ABD0-3894F091460A}" dt="2020-05-09T15:05:53.967" v="14501" actId="1038"/>
          <ac:grpSpMkLst>
            <pc:docMk/>
            <pc:sldMk cId="0" sldId="258"/>
            <ac:grpSpMk id="2" creationId="{03F665BC-36B0-4F15-BBC6-9A33B14644EE}"/>
          </ac:grpSpMkLst>
        </pc:grpChg>
        <pc:grpChg chg="add del mod">
          <ac:chgData name="vijay kumar" userId="0eb738f014aa4543" providerId="LiveId" clId="{B4DB2928-3EFF-4507-ABD0-3894F091460A}" dt="2020-04-27T17:48:10.967" v="98" actId="21"/>
          <ac:grpSpMkLst>
            <pc:docMk/>
            <pc:sldMk cId="0" sldId="258"/>
            <ac:grpSpMk id="2" creationId="{795A5C05-6395-43EA-ADE5-1E54EB21982D}"/>
          </ac:grpSpMkLst>
        </pc:grpChg>
        <pc:grpChg chg="add del mod">
          <ac:chgData name="vijay kumar" userId="0eb738f014aa4543" providerId="LiveId" clId="{B4DB2928-3EFF-4507-ABD0-3894F091460A}" dt="2020-04-28T09:32:54.009" v="3319" actId="165"/>
          <ac:grpSpMkLst>
            <pc:docMk/>
            <pc:sldMk cId="0" sldId="258"/>
            <ac:grpSpMk id="2" creationId="{CFF124EB-9C22-48BC-8FC0-5617B8CDFA28}"/>
          </ac:grpSpMkLst>
        </pc:grpChg>
        <pc:grpChg chg="add mod">
          <ac:chgData name="vijay kumar" userId="0eb738f014aa4543" providerId="LiveId" clId="{B4DB2928-3EFF-4507-ABD0-3894F091460A}" dt="2020-05-09T15:03:32.552" v="14202" actId="164"/>
          <ac:grpSpMkLst>
            <pc:docMk/>
            <pc:sldMk cId="0" sldId="258"/>
            <ac:grpSpMk id="3" creationId="{9941CA08-5927-4D83-8A42-2CE40CA37532}"/>
          </ac:grpSpMkLst>
        </pc:grpChg>
        <pc:grpChg chg="add mod">
          <ac:chgData name="vijay kumar" userId="0eb738f014aa4543" providerId="LiveId" clId="{B4DB2928-3EFF-4507-ABD0-3894F091460A}" dt="2020-05-09T15:05:38.574" v="14469" actId="1037"/>
          <ac:grpSpMkLst>
            <pc:docMk/>
            <pc:sldMk cId="0" sldId="258"/>
            <ac:grpSpMk id="4" creationId="{32DC1154-811E-4B54-8582-E84FFE7DFDF1}"/>
          </ac:grpSpMkLst>
        </pc:grpChg>
        <pc:grpChg chg="add del mod">
          <ac:chgData name="vijay kumar" userId="0eb738f014aa4543" providerId="LiveId" clId="{B4DB2928-3EFF-4507-ABD0-3894F091460A}" dt="2020-05-02T17:47:19.979" v="4820" actId="165"/>
          <ac:grpSpMkLst>
            <pc:docMk/>
            <pc:sldMk cId="0" sldId="258"/>
            <ac:grpSpMk id="4" creationId="{3DC392B3-D091-4EFF-ACCA-08171B5C1985}"/>
          </ac:grpSpMkLst>
        </pc:grpChg>
        <pc:grpChg chg="add mod">
          <ac:chgData name="vijay kumar" userId="0eb738f014aa4543" providerId="LiveId" clId="{B4DB2928-3EFF-4507-ABD0-3894F091460A}" dt="2020-04-27T17:49:34.620" v="123" actId="164"/>
          <ac:grpSpMkLst>
            <pc:docMk/>
            <pc:sldMk cId="0" sldId="258"/>
            <ac:grpSpMk id="4" creationId="{6B30DFE8-E3E5-41FF-AD42-7A892E8245FF}"/>
          </ac:grpSpMkLst>
        </pc:grpChg>
        <pc:grpChg chg="del mod">
          <ac:chgData name="vijay kumar" userId="0eb738f014aa4543" providerId="LiveId" clId="{B4DB2928-3EFF-4507-ABD0-3894F091460A}" dt="2020-04-28T08:16:41.555" v="732" actId="165"/>
          <ac:grpSpMkLst>
            <pc:docMk/>
            <pc:sldMk cId="0" sldId="258"/>
            <ac:grpSpMk id="4" creationId="{84EA2F92-2EF5-4686-A90F-19D4E121738E}"/>
          </ac:grpSpMkLst>
        </pc:grpChg>
        <pc:grpChg chg="add mod">
          <ac:chgData name="vijay kumar" userId="0eb738f014aa4543" providerId="LiveId" clId="{B4DB2928-3EFF-4507-ABD0-3894F091460A}" dt="2020-04-27T17:49:54.952" v="127" actId="164"/>
          <ac:grpSpMkLst>
            <pc:docMk/>
            <pc:sldMk cId="0" sldId="258"/>
            <ac:grpSpMk id="5" creationId="{1DA79131-20C4-4CAC-BFD0-2B0C60F850E6}"/>
          </ac:grpSpMkLst>
        </pc:grpChg>
        <pc:grpChg chg="add mod">
          <ac:chgData name="vijay kumar" userId="0eb738f014aa4543" providerId="LiveId" clId="{B4DB2928-3EFF-4507-ABD0-3894F091460A}" dt="2020-04-27T17:55:37.663" v="627" actId="164"/>
          <ac:grpSpMkLst>
            <pc:docMk/>
            <pc:sldMk cId="0" sldId="258"/>
            <ac:grpSpMk id="6" creationId="{46EC89F1-DC55-4330-8349-AEDEC3DC8C9A}"/>
          </ac:grpSpMkLst>
        </pc:grpChg>
        <pc:grpChg chg="add mod">
          <ac:chgData name="vijay kumar" userId="0eb738f014aa4543" providerId="LiveId" clId="{B4DB2928-3EFF-4507-ABD0-3894F091460A}" dt="2020-04-27T17:51:42.604" v="256" actId="164"/>
          <ac:grpSpMkLst>
            <pc:docMk/>
            <pc:sldMk cId="0" sldId="258"/>
            <ac:grpSpMk id="7" creationId="{CFDE8DE9-EB1F-400F-83D0-5C61691B6EEB}"/>
          </ac:grpSpMkLst>
        </pc:grpChg>
        <pc:grpChg chg="add mod">
          <ac:chgData name="vijay kumar" userId="0eb738f014aa4543" providerId="LiveId" clId="{B4DB2928-3EFF-4507-ABD0-3894F091460A}" dt="2020-05-09T15:03:25.080" v="14201" actId="164"/>
          <ac:grpSpMkLst>
            <pc:docMk/>
            <pc:sldMk cId="0" sldId="258"/>
            <ac:grpSpMk id="8" creationId="{01CCE78F-9115-472C-AAA8-75D5D2294768}"/>
          </ac:grpSpMkLst>
        </pc:grpChg>
        <pc:grpChg chg="add del mod">
          <ac:chgData name="vijay kumar" userId="0eb738f014aa4543" providerId="LiveId" clId="{B4DB2928-3EFF-4507-ABD0-3894F091460A}" dt="2020-05-09T15:05:14.980" v="14450" actId="165"/>
          <ac:grpSpMkLst>
            <pc:docMk/>
            <pc:sldMk cId="0" sldId="258"/>
            <ac:grpSpMk id="9" creationId="{3D056979-AFE6-40D1-993C-A91B7188948B}"/>
          </ac:grpSpMkLst>
        </pc:grpChg>
        <pc:grpChg chg="add mod">
          <ac:chgData name="vijay kumar" userId="0eb738f014aa4543" providerId="LiveId" clId="{B4DB2928-3EFF-4507-ABD0-3894F091460A}" dt="2020-05-09T15:06:13.105" v="14504" actId="164"/>
          <ac:grpSpMkLst>
            <pc:docMk/>
            <pc:sldMk cId="0" sldId="258"/>
            <ac:grpSpMk id="10" creationId="{24901B3A-A639-4077-96B6-0BAE79489A94}"/>
          </ac:grpSpMkLst>
        </pc:grpChg>
        <pc:grpChg chg="add del mod">
          <ac:chgData name="vijay kumar" userId="0eb738f014aa4543" providerId="LiveId" clId="{B4DB2928-3EFF-4507-ABD0-3894F091460A}" dt="2020-04-27T17:52:49.893" v="332" actId="21"/>
          <ac:grpSpMkLst>
            <pc:docMk/>
            <pc:sldMk cId="0" sldId="258"/>
            <ac:grpSpMk id="10" creationId="{95929211-E3ED-4E59-B545-F45068F0C5F7}"/>
          </ac:grpSpMkLst>
        </pc:grpChg>
        <pc:grpChg chg="add del mod">
          <ac:chgData name="vijay kumar" userId="0eb738f014aa4543" providerId="LiveId" clId="{B4DB2928-3EFF-4507-ABD0-3894F091460A}" dt="2020-04-27T17:53:22.248" v="335" actId="21"/>
          <ac:grpSpMkLst>
            <pc:docMk/>
            <pc:sldMk cId="0" sldId="258"/>
            <ac:grpSpMk id="11" creationId="{1FCE476E-8DD5-4DC4-91A9-B2B75CD3CDFF}"/>
          </ac:grpSpMkLst>
        </pc:grpChg>
        <pc:grpChg chg="add mod">
          <ac:chgData name="vijay kumar" userId="0eb738f014aa4543" providerId="LiveId" clId="{B4DB2928-3EFF-4507-ABD0-3894F091460A}" dt="2020-05-09T15:06:13.105" v="14504" actId="164"/>
          <ac:grpSpMkLst>
            <pc:docMk/>
            <pc:sldMk cId="0" sldId="258"/>
            <ac:grpSpMk id="11" creationId="{FC8A20FC-E6B1-4C15-9097-2AB9459561E6}"/>
          </ac:grpSpMkLst>
        </pc:grpChg>
        <pc:grpChg chg="add mod">
          <ac:chgData name="vijay kumar" userId="0eb738f014aa4543" providerId="LiveId" clId="{B4DB2928-3EFF-4507-ABD0-3894F091460A}" dt="2020-05-09T15:03:25.080" v="14201" actId="164"/>
          <ac:grpSpMkLst>
            <pc:docMk/>
            <pc:sldMk cId="0" sldId="258"/>
            <ac:grpSpMk id="12" creationId="{CE09A932-7F0B-493A-884E-E6D61A4A5749}"/>
          </ac:grpSpMkLst>
        </pc:grpChg>
        <pc:grpChg chg="del mod">
          <ac:chgData name="vijay kumar" userId="0eb738f014aa4543" providerId="LiveId" clId="{B4DB2928-3EFF-4507-ABD0-3894F091460A}" dt="2020-04-28T08:17:58.061" v="749" actId="165"/>
          <ac:grpSpMkLst>
            <pc:docMk/>
            <pc:sldMk cId="0" sldId="258"/>
            <ac:grpSpMk id="64" creationId="{C1115049-5550-4B27-8EAE-025DF7DF5083}"/>
          </ac:grpSpMkLst>
        </pc:grpChg>
        <pc:grpChg chg="add del mod">
          <ac:chgData name="vijay kumar" userId="0eb738f014aa4543" providerId="LiveId" clId="{B4DB2928-3EFF-4507-ABD0-3894F091460A}" dt="2020-04-28T08:32:01.258" v="827" actId="165"/>
          <ac:grpSpMkLst>
            <pc:docMk/>
            <pc:sldMk cId="0" sldId="258"/>
            <ac:grpSpMk id="89" creationId="{283CB557-43C1-4BFE-84D7-BE4B2A89C2E0}"/>
          </ac:grpSpMkLst>
        </pc:grpChg>
        <pc:grpChg chg="add del mod">
          <ac:chgData name="vijay kumar" userId="0eb738f014aa4543" providerId="LiveId" clId="{B4DB2928-3EFF-4507-ABD0-3894F091460A}" dt="2020-04-28T08:31:43.537" v="818" actId="165"/>
          <ac:grpSpMkLst>
            <pc:docMk/>
            <pc:sldMk cId="0" sldId="258"/>
            <ac:grpSpMk id="90" creationId="{4234D767-A0A9-4C31-A214-838EA1E6A4ED}"/>
          </ac:grpSpMkLst>
        </pc:grpChg>
        <pc:grpChg chg="add mod topLvl">
          <ac:chgData name="vijay kumar" userId="0eb738f014aa4543" providerId="LiveId" clId="{B4DB2928-3EFF-4507-ABD0-3894F091460A}" dt="2020-05-09T15:05:53.967" v="14501" actId="1038"/>
          <ac:grpSpMkLst>
            <pc:docMk/>
            <pc:sldMk cId="0" sldId="258"/>
            <ac:grpSpMk id="92" creationId="{07D4C826-8AFE-46EC-AF00-0A9D3AFF5D13}"/>
          </ac:grpSpMkLst>
        </pc:grpChg>
        <pc:grpChg chg="add del mod">
          <ac:chgData name="vijay kumar" userId="0eb738f014aa4543" providerId="LiveId" clId="{B4DB2928-3EFF-4507-ABD0-3894F091460A}" dt="2020-04-28T08:37:14.271" v="1096" actId="165"/>
          <ac:grpSpMkLst>
            <pc:docMk/>
            <pc:sldMk cId="0" sldId="258"/>
            <ac:grpSpMk id="134" creationId="{5359DB4C-01D4-4A80-8B29-7F3541E197AF}"/>
          </ac:grpSpMkLst>
        </pc:grpChg>
        <pc:grpChg chg="mod">
          <ac:chgData name="vijay kumar" userId="0eb738f014aa4543" providerId="LiveId" clId="{B4DB2928-3EFF-4507-ABD0-3894F091460A}" dt="2020-04-27T17:51:20.080" v="225" actId="164"/>
          <ac:grpSpMkLst>
            <pc:docMk/>
            <pc:sldMk cId="0" sldId="258"/>
            <ac:grpSpMk id="246" creationId="{00000000-0000-0000-0000-000000000000}"/>
          </ac:grpSpMkLst>
        </pc:grpChg>
        <pc:grpChg chg="del">
          <ac:chgData name="vijay kumar" userId="0eb738f014aa4543" providerId="LiveId" clId="{B4DB2928-3EFF-4507-ABD0-3894F091460A}" dt="2020-04-27T17:44:52.225" v="2" actId="21"/>
          <ac:grpSpMkLst>
            <pc:docMk/>
            <pc:sldMk cId="0" sldId="258"/>
            <ac:grpSpMk id="247" creationId="{00000000-0000-0000-0000-000000000000}"/>
          </ac:grpSpMkLst>
        </pc:grpChg>
        <pc:grpChg chg="mod">
          <ac:chgData name="vijay kumar" userId="0eb738f014aa4543" providerId="LiveId" clId="{B4DB2928-3EFF-4507-ABD0-3894F091460A}" dt="2020-04-27T17:51:20.080" v="225" actId="164"/>
          <ac:grpSpMkLst>
            <pc:docMk/>
            <pc:sldMk cId="0" sldId="258"/>
            <ac:grpSpMk id="248" creationId="{00000000-0000-0000-0000-000000000000}"/>
          </ac:grpSpMkLst>
        </pc:grpChg>
        <pc:grpChg chg="del">
          <ac:chgData name="vijay kumar" userId="0eb738f014aa4543" providerId="LiveId" clId="{B4DB2928-3EFF-4507-ABD0-3894F091460A}" dt="2020-04-27T17:44:52.225" v="2" actId="21"/>
          <ac:grpSpMkLst>
            <pc:docMk/>
            <pc:sldMk cId="0" sldId="258"/>
            <ac:grpSpMk id="249" creationId="{00000000-0000-0000-0000-000000000000}"/>
          </ac:grpSpMkLst>
        </pc:grpChg>
        <pc:grpChg chg="mod">
          <ac:chgData name="vijay kumar" userId="0eb738f014aa4543" providerId="LiveId" clId="{B4DB2928-3EFF-4507-ABD0-3894F091460A}" dt="2020-04-27T17:51:20.080" v="225" actId="164"/>
          <ac:grpSpMkLst>
            <pc:docMk/>
            <pc:sldMk cId="0" sldId="258"/>
            <ac:grpSpMk id="250" creationId="{00000000-0000-0000-0000-000000000000}"/>
          </ac:grpSpMkLst>
        </pc:grpChg>
        <pc:grpChg chg="del">
          <ac:chgData name="vijay kumar" userId="0eb738f014aa4543" providerId="LiveId" clId="{B4DB2928-3EFF-4507-ABD0-3894F091460A}" dt="2020-04-27T17:44:52.225" v="2" actId="21"/>
          <ac:grpSpMkLst>
            <pc:docMk/>
            <pc:sldMk cId="0" sldId="258"/>
            <ac:grpSpMk id="251" creationId="{00000000-0000-0000-0000-000000000000}"/>
          </ac:grpSpMkLst>
        </pc:grpChg>
        <pc:grpChg chg="del mod">
          <ac:chgData name="vijay kumar" userId="0eb738f014aa4543" providerId="LiveId" clId="{B4DB2928-3EFF-4507-ABD0-3894F091460A}" dt="2020-04-27T17:47:36.331" v="95" actId="165"/>
          <ac:grpSpMkLst>
            <pc:docMk/>
            <pc:sldMk cId="0" sldId="258"/>
            <ac:grpSpMk id="253" creationId="{00000000-0000-0000-0000-000000000000}"/>
          </ac:grpSpMkLst>
        </pc:grpChg>
        <pc:grpChg chg="del">
          <ac:chgData name="vijay kumar" userId="0eb738f014aa4543" providerId="LiveId" clId="{B4DB2928-3EFF-4507-ABD0-3894F091460A}" dt="2020-04-27T17:45:00.776" v="4" actId="21"/>
          <ac:grpSpMkLst>
            <pc:docMk/>
            <pc:sldMk cId="0" sldId="258"/>
            <ac:grpSpMk id="254" creationId="{00000000-0000-0000-0000-000000000000}"/>
          </ac:grpSpMkLst>
        </pc:grpChg>
        <pc:grpChg chg="add mod topLvl">
          <ac:chgData name="vijay kumar" userId="0eb738f014aa4543" providerId="LiveId" clId="{B4DB2928-3EFF-4507-ABD0-3894F091460A}" dt="2020-05-09T15:05:53.967" v="14501" actId="1038"/>
          <ac:grpSpMkLst>
            <pc:docMk/>
            <pc:sldMk cId="0" sldId="258"/>
            <ac:grpSpMk id="272" creationId="{475B80A0-9EF9-4970-8680-51923DE1967D}"/>
          </ac:grpSpMkLst>
        </pc:grpChg>
        <pc:grpChg chg="add del mod">
          <ac:chgData name="vijay kumar" userId="0eb738f014aa4543" providerId="LiveId" clId="{B4DB2928-3EFF-4507-ABD0-3894F091460A}" dt="2020-04-28T09:32:43.573" v="3318" actId="478"/>
          <ac:grpSpMkLst>
            <pc:docMk/>
            <pc:sldMk cId="0" sldId="258"/>
            <ac:grpSpMk id="282" creationId="{F59CD88B-9068-4C39-A004-9DB662638EC9}"/>
          </ac:grpSpMkLst>
        </pc:grpChg>
        <pc:grpChg chg="add del mod">
          <ac:chgData name="vijay kumar" userId="0eb738f014aa4543" providerId="LiveId" clId="{B4DB2928-3EFF-4507-ABD0-3894F091460A}" dt="2020-04-28T08:26:50.943" v="801" actId="165"/>
          <ac:grpSpMkLst>
            <pc:docMk/>
            <pc:sldMk cId="0" sldId="258"/>
            <ac:grpSpMk id="292" creationId="{0456495B-CCAB-4456-8453-E5D2963F69A3}"/>
          </ac:grpSpMkLst>
        </pc:grpChg>
        <pc:grpChg chg="del mod topLvl">
          <ac:chgData name="vijay kumar" userId="0eb738f014aa4543" providerId="LiveId" clId="{B4DB2928-3EFF-4507-ABD0-3894F091460A}" dt="2020-04-28T08:35:02.859" v="943" actId="478"/>
          <ac:grpSpMkLst>
            <pc:docMk/>
            <pc:sldMk cId="0" sldId="258"/>
            <ac:grpSpMk id="341" creationId="{1E322F84-82F9-444C-A00F-BFFF402C4E46}"/>
          </ac:grpSpMkLst>
        </pc:grpChg>
        <pc:grpChg chg="del mod topLvl">
          <ac:chgData name="vijay kumar" userId="0eb738f014aa4543" providerId="LiveId" clId="{B4DB2928-3EFF-4507-ABD0-3894F091460A}" dt="2020-04-28T08:27:12.628" v="802" actId="478"/>
          <ac:grpSpMkLst>
            <pc:docMk/>
            <pc:sldMk cId="0" sldId="258"/>
            <ac:grpSpMk id="342" creationId="{C708D3B9-4746-4447-8EFD-9B184F6FAFE6}"/>
          </ac:grpSpMkLst>
        </pc:grpChg>
        <pc:grpChg chg="add del mod topLvl">
          <ac:chgData name="vijay kumar" userId="0eb738f014aa4543" providerId="LiveId" clId="{B4DB2928-3EFF-4507-ABD0-3894F091460A}" dt="2020-04-28T09:16:55.708" v="2565" actId="478"/>
          <ac:grpSpMkLst>
            <pc:docMk/>
            <pc:sldMk cId="0" sldId="258"/>
            <ac:grpSpMk id="343" creationId="{87CD1D22-88BA-4A8C-ACAF-933FAF265246}"/>
          </ac:grpSpMkLst>
        </pc:grpChg>
        <pc:grpChg chg="mod topLvl">
          <ac:chgData name="vijay kumar" userId="0eb738f014aa4543" providerId="LiveId" clId="{B4DB2928-3EFF-4507-ABD0-3894F091460A}" dt="2020-04-27T17:55:37.663" v="627" actId="164"/>
          <ac:grpSpMkLst>
            <pc:docMk/>
            <pc:sldMk cId="0" sldId="258"/>
            <ac:grpSpMk id="499" creationId="{00000000-0000-0000-0000-000000000000}"/>
          </ac:grpSpMkLst>
        </pc:grpChg>
        <pc:grpChg chg="mod topLvl">
          <ac:chgData name="vijay kumar" userId="0eb738f014aa4543" providerId="LiveId" clId="{B4DB2928-3EFF-4507-ABD0-3894F091460A}" dt="2020-04-27T17:52:35.651" v="331" actId="164"/>
          <ac:grpSpMkLst>
            <pc:docMk/>
            <pc:sldMk cId="0" sldId="258"/>
            <ac:grpSpMk id="543" creationId="{00000000-0000-0000-0000-000000000000}"/>
          </ac:grpSpMkLst>
        </pc:grpChg>
        <pc:grpChg chg="mod topLvl">
          <ac:chgData name="vijay kumar" userId="0eb738f014aa4543" providerId="LiveId" clId="{B4DB2928-3EFF-4507-ABD0-3894F091460A}" dt="2020-04-27T17:53:18.987" v="334" actId="164"/>
          <ac:grpSpMkLst>
            <pc:docMk/>
            <pc:sldMk cId="0" sldId="258"/>
            <ac:grpSpMk id="551" creationId="{00000000-0000-0000-0000-000000000000}"/>
          </ac:grpSpMkLst>
        </pc:grpChg>
        <pc:grpChg chg="add mod">
          <ac:chgData name="vijay kumar" userId="0eb738f014aa4543" providerId="LiveId" clId="{B4DB2928-3EFF-4507-ABD0-3894F091460A}" dt="2020-04-27T17:55:37.663" v="627" actId="164"/>
          <ac:grpSpMkLst>
            <pc:docMk/>
            <pc:sldMk cId="0" sldId="258"/>
            <ac:grpSpMk id="697" creationId="{1E42AFDC-7C72-47E5-B651-B835CAB81805}"/>
          </ac:grpSpMkLst>
        </pc:grpChg>
        <pc:picChg chg="del mod">
          <ac:chgData name="vijay kumar" userId="0eb738f014aa4543" providerId="LiveId" clId="{B4DB2928-3EFF-4507-ABD0-3894F091460A}" dt="2020-04-28T08:16:37.175" v="731" actId="338"/>
          <ac:picMkLst>
            <pc:docMk/>
            <pc:sldMk cId="0" sldId="258"/>
            <ac:picMk id="2" creationId="{F85B3C37-6D0C-4311-89D1-5FE0BCCBACE5}"/>
          </ac:picMkLst>
        </pc:picChg>
        <pc:picChg chg="del mod">
          <ac:chgData name="vijay kumar" userId="0eb738f014aa4543" providerId="LiveId" clId="{B4DB2928-3EFF-4507-ABD0-3894F091460A}" dt="2020-04-28T08:17:52.993" v="748" actId="338"/>
          <ac:picMkLst>
            <pc:docMk/>
            <pc:sldMk cId="0" sldId="258"/>
            <ac:picMk id="31" creationId="{973FA7DE-63DF-46F9-A37F-4D935B4E383B}"/>
          </ac:picMkLst>
        </pc:picChg>
        <pc:cxnChg chg="mod">
          <ac:chgData name="vijay kumar" userId="0eb738f014aa4543" providerId="LiveId" clId="{B4DB2928-3EFF-4507-ABD0-3894F091460A}" dt="2020-05-09T15:05:53.967" v="14501" actId="1038"/>
          <ac:cxnSpMkLst>
            <pc:docMk/>
            <pc:sldMk cId="0" sldId="258"/>
            <ac:cxnSpMk id="276" creationId="{4FF62159-0D3E-4CFE-9A33-5627050EC1E7}"/>
          </ac:cxnSpMkLst>
        </pc:cxnChg>
        <pc:cxnChg chg="mod">
          <ac:chgData name="vijay kumar" userId="0eb738f014aa4543" providerId="LiveId" clId="{B4DB2928-3EFF-4507-ABD0-3894F091460A}" dt="2020-05-09T15:05:53.967" v="14501" actId="1038"/>
          <ac:cxnSpMkLst>
            <pc:docMk/>
            <pc:sldMk cId="0" sldId="258"/>
            <ac:cxnSpMk id="278" creationId="{404E5293-79D3-43D4-A217-EB89C4BA90D7}"/>
          </ac:cxnSpMkLst>
        </pc:cxnChg>
        <pc:cxnChg chg="mod">
          <ac:chgData name="vijay kumar" userId="0eb738f014aa4543" providerId="LiveId" clId="{B4DB2928-3EFF-4507-ABD0-3894F091460A}" dt="2020-05-09T15:05:53.967" v="14501" actId="1038"/>
          <ac:cxnSpMkLst>
            <pc:docMk/>
            <pc:sldMk cId="0" sldId="258"/>
            <ac:cxnSpMk id="279" creationId="{7781288E-2E3C-4DC0-8CB2-E4751107F5F1}"/>
          </ac:cxnSpMkLst>
        </pc:cxnChg>
        <pc:cxnChg chg="mod topLvl">
          <ac:chgData name="vijay kumar" userId="0eb738f014aa4543" providerId="LiveId" clId="{B4DB2928-3EFF-4507-ABD0-3894F091460A}" dt="2020-05-09T15:05:53.967" v="14501" actId="1038"/>
          <ac:cxnSpMkLst>
            <pc:docMk/>
            <pc:sldMk cId="0" sldId="258"/>
            <ac:cxnSpMk id="293" creationId="{26717664-DC73-44AD-A509-77A1ABF443A6}"/>
          </ac:cxnSpMkLst>
        </pc:cxnChg>
        <pc:cxnChg chg="del mod topLvl">
          <ac:chgData name="vijay kumar" userId="0eb738f014aa4543" providerId="LiveId" clId="{B4DB2928-3EFF-4507-ABD0-3894F091460A}" dt="2020-04-28T08:37:22.289" v="1098" actId="478"/>
          <ac:cxnSpMkLst>
            <pc:docMk/>
            <pc:sldMk cId="0" sldId="258"/>
            <ac:cxnSpMk id="294" creationId="{C773ACDB-5C0E-447F-BA6F-1634503DE5F5}"/>
          </ac:cxnSpMkLst>
        </pc:cxnChg>
        <pc:cxnChg chg="add del mod">
          <ac:chgData name="vijay kumar" userId="0eb738f014aa4543" providerId="LiveId" clId="{B4DB2928-3EFF-4507-ABD0-3894F091460A}" dt="2020-04-28T08:47:05.472" v="1387" actId="478"/>
          <ac:cxnSpMkLst>
            <pc:docMk/>
            <pc:sldMk cId="0" sldId="258"/>
            <ac:cxnSpMk id="417" creationId="{56BF4EED-9A56-4B87-A22B-5AD9015CDB1E}"/>
          </ac:cxnSpMkLst>
        </pc:cxnChg>
        <pc:cxnChg chg="mod topLvl">
          <ac:chgData name="vijay kumar" userId="0eb738f014aa4543" providerId="LiveId" clId="{B4DB2928-3EFF-4507-ABD0-3894F091460A}" dt="2020-04-27T17:49:42.568" v="124" actId="164"/>
          <ac:cxnSpMkLst>
            <pc:docMk/>
            <pc:sldMk cId="0" sldId="258"/>
            <ac:cxnSpMk id="464" creationId="{00000000-0000-0000-0000-000000000000}"/>
          </ac:cxnSpMkLst>
        </pc:cxnChg>
        <pc:cxnChg chg="mod topLvl">
          <ac:chgData name="vijay kumar" userId="0eb738f014aa4543" providerId="LiveId" clId="{B4DB2928-3EFF-4507-ABD0-3894F091460A}" dt="2020-04-27T17:49:42.568" v="124" actId="164"/>
          <ac:cxnSpMkLst>
            <pc:docMk/>
            <pc:sldMk cId="0" sldId="258"/>
            <ac:cxnSpMk id="465" creationId="{00000000-0000-0000-0000-000000000000}"/>
          </ac:cxnSpMkLst>
        </pc:cxnChg>
        <pc:cxnChg chg="mod topLvl">
          <ac:chgData name="vijay kumar" userId="0eb738f014aa4543" providerId="LiveId" clId="{B4DB2928-3EFF-4507-ABD0-3894F091460A}" dt="2020-04-27T17:48:08.543" v="97" actId="164"/>
          <ac:cxnSpMkLst>
            <pc:docMk/>
            <pc:sldMk cId="0" sldId="258"/>
            <ac:cxnSpMk id="505" creationId="{00000000-0000-0000-0000-000000000000}"/>
          </ac:cxnSpMkLst>
        </pc:cxnChg>
        <pc:cxnChg chg="mod topLvl">
          <ac:chgData name="vijay kumar" userId="0eb738f014aa4543" providerId="LiveId" clId="{B4DB2928-3EFF-4507-ABD0-3894F091460A}" dt="2020-04-27T17:48:08.543" v="97" actId="164"/>
          <ac:cxnSpMkLst>
            <pc:docMk/>
            <pc:sldMk cId="0" sldId="258"/>
            <ac:cxnSpMk id="506" creationId="{00000000-0000-0000-0000-000000000000}"/>
          </ac:cxnSpMkLst>
        </pc:cxnChg>
        <pc:cxnChg chg="mod topLvl">
          <ac:chgData name="vijay kumar" userId="0eb738f014aa4543" providerId="LiveId" clId="{B4DB2928-3EFF-4507-ABD0-3894F091460A}" dt="2020-04-27T17:53:18.987" v="334" actId="164"/>
          <ac:cxnSpMkLst>
            <pc:docMk/>
            <pc:sldMk cId="0" sldId="258"/>
            <ac:cxnSpMk id="557" creationId="{00000000-0000-0000-0000-000000000000}"/>
          </ac:cxnSpMkLst>
        </pc:cxnChg>
        <pc:cxnChg chg="mod topLvl">
          <ac:chgData name="vijay kumar" userId="0eb738f014aa4543" providerId="LiveId" clId="{B4DB2928-3EFF-4507-ABD0-3894F091460A}" dt="2020-04-27T17:53:18.987" v="334" actId="164"/>
          <ac:cxnSpMkLst>
            <pc:docMk/>
            <pc:sldMk cId="0" sldId="258"/>
            <ac:cxnSpMk id="564" creationId="{00000000-0000-0000-0000-000000000000}"/>
          </ac:cxnSpMkLst>
        </pc:cxnChg>
      </pc:sldChg>
      <pc:sldChg chg="addSp delSp modSp add del mod ord">
        <pc:chgData name="vijay kumar" userId="0eb738f014aa4543" providerId="LiveId" clId="{B4DB2928-3EFF-4507-ABD0-3894F091460A}" dt="2020-05-07T13:52:41.028" v="13052" actId="47"/>
        <pc:sldMkLst>
          <pc:docMk/>
          <pc:sldMk cId="0" sldId="263"/>
        </pc:sldMkLst>
        <pc:spChg chg="add mod">
          <ac:chgData name="vijay kumar" userId="0eb738f014aa4543" providerId="LiveId" clId="{B4DB2928-3EFF-4507-ABD0-3894F091460A}" dt="2020-05-07T13:45:48.740" v="13014" actId="1076"/>
          <ac:spMkLst>
            <pc:docMk/>
            <pc:sldMk cId="0" sldId="263"/>
            <ac:spMk id="137" creationId="{18233772-3356-40A6-AD8A-26E300FC10B1}"/>
          </ac:spMkLst>
        </pc:spChg>
        <pc:spChg chg="del">
          <ac:chgData name="vijay kumar" userId="0eb738f014aa4543" providerId="LiveId" clId="{B4DB2928-3EFF-4507-ABD0-3894F091460A}" dt="2020-05-07T13:44:02.528" v="12994" actId="478"/>
          <ac:spMkLst>
            <pc:docMk/>
            <pc:sldMk cId="0" sldId="263"/>
            <ac:spMk id="448" creationId="{00000000-0000-0000-0000-000000000000}"/>
          </ac:spMkLst>
        </pc:spChg>
        <pc:grpChg chg="del">
          <ac:chgData name="vijay kumar" userId="0eb738f014aa4543" providerId="LiveId" clId="{B4DB2928-3EFF-4507-ABD0-3894F091460A}" dt="2020-05-07T13:42:56.974" v="12993" actId="21"/>
          <ac:grpSpMkLst>
            <pc:docMk/>
            <pc:sldMk cId="0" sldId="263"/>
            <ac:grpSpMk id="136" creationId="{00000000-0000-0000-0000-000000000000}"/>
          </ac:grpSpMkLst>
        </pc:grpChg>
      </pc:sldChg>
      <pc:sldChg chg="addSp delSp modSp add del mod ord">
        <pc:chgData name="vijay kumar" userId="0eb738f014aa4543" providerId="LiveId" clId="{B4DB2928-3EFF-4507-ABD0-3894F091460A}" dt="2020-05-24T14:51:14.289" v="15198" actId="2696"/>
        <pc:sldMkLst>
          <pc:docMk/>
          <pc:sldMk cId="0" sldId="273"/>
        </pc:sldMkLst>
        <pc:spChg chg="mod topLvl">
          <ac:chgData name="vijay kumar" userId="0eb738f014aa4543" providerId="LiveId" clId="{B4DB2928-3EFF-4507-ABD0-3894F091460A}" dt="2020-05-24T14:30:25.958" v="15196" actId="1076"/>
          <ac:spMkLst>
            <pc:docMk/>
            <pc:sldMk cId="0" sldId="273"/>
            <ac:spMk id="8" creationId="{00000000-0000-0000-0000-000000000000}"/>
          </ac:spMkLst>
        </pc:spChg>
        <pc:spChg chg="mod topLvl">
          <ac:chgData name="vijay kumar" userId="0eb738f014aa4543" providerId="LiveId" clId="{B4DB2928-3EFF-4507-ABD0-3894F091460A}" dt="2020-05-08T11:41:46.164" v="14073" actId="1076"/>
          <ac:spMkLst>
            <pc:docMk/>
            <pc:sldMk cId="0" sldId="273"/>
            <ac:spMk id="77" creationId="{00000000-0000-0000-0000-000000000000}"/>
          </ac:spMkLst>
        </pc:spChg>
        <pc:spChg chg="mod topLvl">
          <ac:chgData name="vijay kumar" userId="0eb738f014aa4543" providerId="LiveId" clId="{B4DB2928-3EFF-4507-ABD0-3894F091460A}" dt="2020-04-27T17:46:13.028" v="18" actId="164"/>
          <ac:spMkLst>
            <pc:docMk/>
            <pc:sldMk cId="0" sldId="273"/>
            <ac:spMk id="78" creationId="{00000000-0000-0000-0000-000000000000}"/>
          </ac:spMkLst>
        </pc:spChg>
        <pc:spChg chg="mod topLvl">
          <ac:chgData name="vijay kumar" userId="0eb738f014aa4543" providerId="LiveId" clId="{B4DB2928-3EFF-4507-ABD0-3894F091460A}" dt="2020-05-08T11:41:56.603" v="14077" actId="1076"/>
          <ac:spMkLst>
            <pc:docMk/>
            <pc:sldMk cId="0" sldId="273"/>
            <ac:spMk id="79" creationId="{00000000-0000-0000-0000-000000000000}"/>
          </ac:spMkLst>
        </pc:spChg>
        <pc:spChg chg="mod topLvl">
          <ac:chgData name="vijay kumar" userId="0eb738f014aa4543" providerId="LiveId" clId="{B4DB2928-3EFF-4507-ABD0-3894F091460A}" dt="2020-05-18T09:30:14.998" v="14748" actId="164"/>
          <ac:spMkLst>
            <pc:docMk/>
            <pc:sldMk cId="0" sldId="273"/>
            <ac:spMk id="103" creationId="{00000000-0000-0000-0000-000000000000}"/>
          </ac:spMkLst>
        </pc:spChg>
        <pc:spChg chg="add del mod">
          <ac:chgData name="vijay kumar" userId="0eb738f014aa4543" providerId="LiveId" clId="{B4DB2928-3EFF-4507-ABD0-3894F091460A}" dt="2020-05-24T14:26:20.504" v="15156" actId="478"/>
          <ac:spMkLst>
            <pc:docMk/>
            <pc:sldMk cId="0" sldId="273"/>
            <ac:spMk id="116" creationId="{C5DDF574-6985-4629-B811-02955BBC23DE}"/>
          </ac:spMkLst>
        </pc:spChg>
        <pc:spChg chg="mod topLvl">
          <ac:chgData name="vijay kumar" userId="0eb738f014aa4543" providerId="LiveId" clId="{B4DB2928-3EFF-4507-ABD0-3894F091460A}" dt="2020-05-18T09:30:14.998" v="14748" actId="164"/>
          <ac:spMkLst>
            <pc:docMk/>
            <pc:sldMk cId="0" sldId="273"/>
            <ac:spMk id="175" creationId="{00000000-0000-0000-0000-000000000000}"/>
          </ac:spMkLst>
        </pc:spChg>
        <pc:spChg chg="mod topLvl">
          <ac:chgData name="vijay kumar" userId="0eb738f014aa4543" providerId="LiveId" clId="{B4DB2928-3EFF-4507-ABD0-3894F091460A}" dt="2020-05-18T09:30:04.731" v="14747" actId="164"/>
          <ac:spMkLst>
            <pc:docMk/>
            <pc:sldMk cId="0" sldId="273"/>
            <ac:spMk id="176" creationId="{00000000-0000-0000-0000-000000000000}"/>
          </ac:spMkLst>
        </pc:spChg>
        <pc:spChg chg="mod topLvl">
          <ac:chgData name="vijay kumar" userId="0eb738f014aa4543" providerId="LiveId" clId="{B4DB2928-3EFF-4507-ABD0-3894F091460A}" dt="2020-04-27T17:46:13.028" v="18" actId="164"/>
          <ac:spMkLst>
            <pc:docMk/>
            <pc:sldMk cId="0" sldId="273"/>
            <ac:spMk id="177" creationId="{00000000-0000-0000-0000-000000000000}"/>
          </ac:spMkLst>
        </pc:spChg>
        <pc:spChg chg="mod topLvl">
          <ac:chgData name="vijay kumar" userId="0eb738f014aa4543" providerId="LiveId" clId="{B4DB2928-3EFF-4507-ABD0-3894F091460A}" dt="2020-05-18T09:30:14.998" v="14748" actId="164"/>
          <ac:spMkLst>
            <pc:docMk/>
            <pc:sldMk cId="0" sldId="273"/>
            <ac:spMk id="326" creationId="{00000000-0000-0000-0000-000000000000}"/>
          </ac:spMkLst>
        </pc:spChg>
        <pc:spChg chg="mod topLvl">
          <ac:chgData name="vijay kumar" userId="0eb738f014aa4543" providerId="LiveId" clId="{B4DB2928-3EFF-4507-ABD0-3894F091460A}" dt="2020-05-18T09:30:04.731" v="14747" actId="164"/>
          <ac:spMkLst>
            <pc:docMk/>
            <pc:sldMk cId="0" sldId="273"/>
            <ac:spMk id="327" creationId="{00000000-0000-0000-0000-000000000000}"/>
          </ac:spMkLst>
        </pc:spChg>
        <pc:spChg chg="mod topLvl">
          <ac:chgData name="vijay kumar" userId="0eb738f014aa4543" providerId="LiveId" clId="{B4DB2928-3EFF-4507-ABD0-3894F091460A}" dt="2020-04-27T17:46:13.028" v="18" actId="164"/>
          <ac:spMkLst>
            <pc:docMk/>
            <pc:sldMk cId="0" sldId="273"/>
            <ac:spMk id="328" creationId="{00000000-0000-0000-0000-000000000000}"/>
          </ac:spMkLst>
        </pc:spChg>
        <pc:spChg chg="mod topLvl">
          <ac:chgData name="vijay kumar" userId="0eb738f014aa4543" providerId="LiveId" clId="{B4DB2928-3EFF-4507-ABD0-3894F091460A}" dt="2020-05-07T13:40:54.138" v="12874" actId="164"/>
          <ac:spMkLst>
            <pc:docMk/>
            <pc:sldMk cId="0" sldId="273"/>
            <ac:spMk id="454" creationId="{00000000-0000-0000-0000-000000000000}"/>
          </ac:spMkLst>
        </pc:spChg>
        <pc:spChg chg="mod topLvl">
          <ac:chgData name="vijay kumar" userId="0eb738f014aa4543" providerId="LiveId" clId="{B4DB2928-3EFF-4507-ABD0-3894F091460A}" dt="2020-05-07T13:40:54.138" v="12874" actId="164"/>
          <ac:spMkLst>
            <pc:docMk/>
            <pc:sldMk cId="0" sldId="273"/>
            <ac:spMk id="455" creationId="{00000000-0000-0000-0000-000000000000}"/>
          </ac:spMkLst>
        </pc:spChg>
        <pc:spChg chg="mod topLvl">
          <ac:chgData name="vijay kumar" userId="0eb738f014aa4543" providerId="LiveId" clId="{B4DB2928-3EFF-4507-ABD0-3894F091460A}" dt="2020-05-07T13:40:54.138" v="12874" actId="164"/>
          <ac:spMkLst>
            <pc:docMk/>
            <pc:sldMk cId="0" sldId="273"/>
            <ac:spMk id="456" creationId="{00000000-0000-0000-0000-000000000000}"/>
          </ac:spMkLst>
        </pc:spChg>
        <pc:spChg chg="mod topLvl">
          <ac:chgData name="vijay kumar" userId="0eb738f014aa4543" providerId="LiveId" clId="{B4DB2928-3EFF-4507-ABD0-3894F091460A}" dt="2020-05-07T13:40:54.138" v="12874" actId="164"/>
          <ac:spMkLst>
            <pc:docMk/>
            <pc:sldMk cId="0" sldId="273"/>
            <ac:spMk id="457" creationId="{00000000-0000-0000-0000-000000000000}"/>
          </ac:spMkLst>
        </pc:spChg>
        <pc:spChg chg="mod topLvl">
          <ac:chgData name="vijay kumar" userId="0eb738f014aa4543" providerId="LiveId" clId="{B4DB2928-3EFF-4507-ABD0-3894F091460A}" dt="2020-05-07T13:40:54.138" v="12874" actId="164"/>
          <ac:spMkLst>
            <pc:docMk/>
            <pc:sldMk cId="0" sldId="273"/>
            <ac:spMk id="459" creationId="{00000000-0000-0000-0000-000000000000}"/>
          </ac:spMkLst>
        </pc:spChg>
        <pc:spChg chg="mod topLvl">
          <ac:chgData name="vijay kumar" userId="0eb738f014aa4543" providerId="LiveId" clId="{B4DB2928-3EFF-4507-ABD0-3894F091460A}" dt="2020-05-07T13:40:54.138" v="12874" actId="164"/>
          <ac:spMkLst>
            <pc:docMk/>
            <pc:sldMk cId="0" sldId="273"/>
            <ac:spMk id="460" creationId="{00000000-0000-0000-0000-000000000000}"/>
          </ac:spMkLst>
        </pc:spChg>
        <pc:spChg chg="mod topLvl">
          <ac:chgData name="vijay kumar" userId="0eb738f014aa4543" providerId="LiveId" clId="{B4DB2928-3EFF-4507-ABD0-3894F091460A}" dt="2020-05-07T13:40:54.138" v="12874" actId="164"/>
          <ac:spMkLst>
            <pc:docMk/>
            <pc:sldMk cId="0" sldId="273"/>
            <ac:spMk id="461" creationId="{00000000-0000-0000-0000-000000000000}"/>
          </ac:spMkLst>
        </pc:spChg>
        <pc:spChg chg="mod topLvl">
          <ac:chgData name="vijay kumar" userId="0eb738f014aa4543" providerId="LiveId" clId="{B4DB2928-3EFF-4507-ABD0-3894F091460A}" dt="2020-05-07T13:40:54.138" v="12874" actId="164"/>
          <ac:spMkLst>
            <pc:docMk/>
            <pc:sldMk cId="0" sldId="273"/>
            <ac:spMk id="462" creationId="{00000000-0000-0000-0000-000000000000}"/>
          </ac:spMkLst>
        </pc:spChg>
        <pc:spChg chg="mod topLvl">
          <ac:chgData name="vijay kumar" userId="0eb738f014aa4543" providerId="LiveId" clId="{B4DB2928-3EFF-4507-ABD0-3894F091460A}" dt="2020-05-07T13:40:54.138" v="12874" actId="164"/>
          <ac:spMkLst>
            <pc:docMk/>
            <pc:sldMk cId="0" sldId="273"/>
            <ac:spMk id="463" creationId="{00000000-0000-0000-0000-000000000000}"/>
          </ac:spMkLst>
        </pc:spChg>
        <pc:spChg chg="mod topLvl">
          <ac:chgData name="vijay kumar" userId="0eb738f014aa4543" providerId="LiveId" clId="{B4DB2928-3EFF-4507-ABD0-3894F091460A}" dt="2020-05-07T13:40:54.138" v="12874" actId="164"/>
          <ac:spMkLst>
            <pc:docMk/>
            <pc:sldMk cId="0" sldId="273"/>
            <ac:spMk id="480" creationId="{00000000-0000-0000-0000-000000000000}"/>
          </ac:spMkLst>
        </pc:spChg>
        <pc:spChg chg="mod topLvl">
          <ac:chgData name="vijay kumar" userId="0eb738f014aa4543" providerId="LiveId" clId="{B4DB2928-3EFF-4507-ABD0-3894F091460A}" dt="2020-05-07T13:40:54.138" v="12874" actId="164"/>
          <ac:spMkLst>
            <pc:docMk/>
            <pc:sldMk cId="0" sldId="273"/>
            <ac:spMk id="46244" creationId="{00000000-0000-0000-0000-000000000000}"/>
          </ac:spMkLst>
        </pc:spChg>
        <pc:spChg chg="mod topLvl">
          <ac:chgData name="vijay kumar" userId="0eb738f014aa4543" providerId="LiveId" clId="{B4DB2928-3EFF-4507-ABD0-3894F091460A}" dt="2020-05-07T13:40:54.138" v="12874" actId="164"/>
          <ac:spMkLst>
            <pc:docMk/>
            <pc:sldMk cId="0" sldId="273"/>
            <ac:spMk id="46246" creationId="{00000000-0000-0000-0000-000000000000}"/>
          </ac:spMkLst>
        </pc:spChg>
        <pc:spChg chg="mod topLvl">
          <ac:chgData name="vijay kumar" userId="0eb738f014aa4543" providerId="LiveId" clId="{B4DB2928-3EFF-4507-ABD0-3894F091460A}" dt="2020-05-07T13:40:54.138" v="12874" actId="164"/>
          <ac:spMkLst>
            <pc:docMk/>
            <pc:sldMk cId="0" sldId="273"/>
            <ac:spMk id="46248" creationId="{00000000-0000-0000-0000-000000000000}"/>
          </ac:spMkLst>
        </pc:spChg>
        <pc:spChg chg="mod topLvl">
          <ac:chgData name="vijay kumar" userId="0eb738f014aa4543" providerId="LiveId" clId="{B4DB2928-3EFF-4507-ABD0-3894F091460A}" dt="2020-05-07T13:40:54.138" v="12874" actId="164"/>
          <ac:spMkLst>
            <pc:docMk/>
            <pc:sldMk cId="0" sldId="273"/>
            <ac:spMk id="46250" creationId="{00000000-0000-0000-0000-000000000000}"/>
          </ac:spMkLst>
        </pc:spChg>
        <pc:spChg chg="mod topLvl">
          <ac:chgData name="vijay kumar" userId="0eb738f014aa4543" providerId="LiveId" clId="{B4DB2928-3EFF-4507-ABD0-3894F091460A}" dt="2020-05-07T13:40:54.138" v="12874" actId="164"/>
          <ac:spMkLst>
            <pc:docMk/>
            <pc:sldMk cId="0" sldId="273"/>
            <ac:spMk id="46252" creationId="{00000000-0000-0000-0000-000000000000}"/>
          </ac:spMkLst>
        </pc:spChg>
        <pc:spChg chg="mod topLvl">
          <ac:chgData name="vijay kumar" userId="0eb738f014aa4543" providerId="LiveId" clId="{B4DB2928-3EFF-4507-ABD0-3894F091460A}" dt="2020-05-07T13:40:54.138" v="12874" actId="164"/>
          <ac:spMkLst>
            <pc:docMk/>
            <pc:sldMk cId="0" sldId="273"/>
            <ac:spMk id="46253" creationId="{00000000-0000-0000-0000-000000000000}"/>
          </ac:spMkLst>
        </pc:spChg>
        <pc:spChg chg="mod topLvl">
          <ac:chgData name="vijay kumar" userId="0eb738f014aa4543" providerId="LiveId" clId="{B4DB2928-3EFF-4507-ABD0-3894F091460A}" dt="2020-05-07T13:40:54.138" v="12874" actId="164"/>
          <ac:spMkLst>
            <pc:docMk/>
            <pc:sldMk cId="0" sldId="273"/>
            <ac:spMk id="46254" creationId="{00000000-0000-0000-0000-000000000000}"/>
          </ac:spMkLst>
        </pc:spChg>
        <pc:spChg chg="mod topLvl">
          <ac:chgData name="vijay kumar" userId="0eb738f014aa4543" providerId="LiveId" clId="{B4DB2928-3EFF-4507-ABD0-3894F091460A}" dt="2020-05-07T13:40:54.138" v="12874" actId="164"/>
          <ac:spMkLst>
            <pc:docMk/>
            <pc:sldMk cId="0" sldId="273"/>
            <ac:spMk id="46255" creationId="{00000000-0000-0000-0000-000000000000}"/>
          </ac:spMkLst>
        </pc:spChg>
        <pc:spChg chg="mod topLvl">
          <ac:chgData name="vijay kumar" userId="0eb738f014aa4543" providerId="LiveId" clId="{B4DB2928-3EFF-4507-ABD0-3894F091460A}" dt="2020-05-07T13:40:54.138" v="12874" actId="164"/>
          <ac:spMkLst>
            <pc:docMk/>
            <pc:sldMk cId="0" sldId="273"/>
            <ac:spMk id="46256" creationId="{00000000-0000-0000-0000-000000000000}"/>
          </ac:spMkLst>
        </pc:spChg>
        <pc:spChg chg="mod topLvl">
          <ac:chgData name="vijay kumar" userId="0eb738f014aa4543" providerId="LiveId" clId="{B4DB2928-3EFF-4507-ABD0-3894F091460A}" dt="2020-05-07T13:40:54.138" v="12874" actId="164"/>
          <ac:spMkLst>
            <pc:docMk/>
            <pc:sldMk cId="0" sldId="273"/>
            <ac:spMk id="46257" creationId="{00000000-0000-0000-0000-000000000000}"/>
          </ac:spMkLst>
        </pc:spChg>
        <pc:spChg chg="mod topLvl">
          <ac:chgData name="vijay kumar" userId="0eb738f014aa4543" providerId="LiveId" clId="{B4DB2928-3EFF-4507-ABD0-3894F091460A}" dt="2020-05-07T13:40:54.138" v="12874" actId="164"/>
          <ac:spMkLst>
            <pc:docMk/>
            <pc:sldMk cId="0" sldId="273"/>
            <ac:spMk id="46258" creationId="{00000000-0000-0000-0000-000000000000}"/>
          </ac:spMkLst>
        </pc:spChg>
        <pc:grpChg chg="del">
          <ac:chgData name="vijay kumar" userId="0eb738f014aa4543" providerId="LiveId" clId="{B4DB2928-3EFF-4507-ABD0-3894F091460A}" dt="2020-04-27T17:46:04.613" v="17" actId="165"/>
          <ac:grpSpMkLst>
            <pc:docMk/>
            <pc:sldMk cId="0" sldId="273"/>
            <ac:grpSpMk id="2" creationId="{00000000-0000-0000-0000-000000000000}"/>
          </ac:grpSpMkLst>
        </pc:grpChg>
        <pc:grpChg chg="add mod">
          <ac:chgData name="vijay kumar" userId="0eb738f014aa4543" providerId="LiveId" clId="{B4DB2928-3EFF-4507-ABD0-3894F091460A}" dt="2020-05-18T09:30:04.731" v="14747" actId="164"/>
          <ac:grpSpMkLst>
            <pc:docMk/>
            <pc:sldMk cId="0" sldId="273"/>
            <ac:grpSpMk id="2" creationId="{E6900E61-9436-4EED-BDFB-23A24B0FD669}"/>
          </ac:grpSpMkLst>
        </pc:grpChg>
        <pc:grpChg chg="mod topLvl">
          <ac:chgData name="vijay kumar" userId="0eb738f014aa4543" providerId="LiveId" clId="{B4DB2928-3EFF-4507-ABD0-3894F091460A}" dt="2020-05-18T09:30:14.998" v="14748" actId="164"/>
          <ac:grpSpMkLst>
            <pc:docMk/>
            <pc:sldMk cId="0" sldId="273"/>
            <ac:grpSpMk id="3" creationId="{00000000-0000-0000-0000-000000000000}"/>
          </ac:grpSpMkLst>
        </pc:grpChg>
        <pc:grpChg chg="mod topLvl">
          <ac:chgData name="vijay kumar" userId="0eb738f014aa4543" providerId="LiveId" clId="{B4DB2928-3EFF-4507-ABD0-3894F091460A}" dt="2020-05-18T09:30:14.998" v="14748" actId="164"/>
          <ac:grpSpMkLst>
            <pc:docMk/>
            <pc:sldMk cId="0" sldId="273"/>
            <ac:grpSpMk id="4" creationId="{00000000-0000-0000-0000-000000000000}"/>
          </ac:grpSpMkLst>
        </pc:grpChg>
        <pc:grpChg chg="mod topLvl">
          <ac:chgData name="vijay kumar" userId="0eb738f014aa4543" providerId="LiveId" clId="{B4DB2928-3EFF-4507-ABD0-3894F091460A}" dt="2020-05-18T09:30:04.731" v="14747" actId="164"/>
          <ac:grpSpMkLst>
            <pc:docMk/>
            <pc:sldMk cId="0" sldId="273"/>
            <ac:grpSpMk id="5" creationId="{00000000-0000-0000-0000-000000000000}"/>
          </ac:grpSpMkLst>
        </pc:grpChg>
        <pc:grpChg chg="mod topLvl">
          <ac:chgData name="vijay kumar" userId="0eb738f014aa4543" providerId="LiveId" clId="{B4DB2928-3EFF-4507-ABD0-3894F091460A}" dt="2020-04-27T17:46:13.028" v="18" actId="164"/>
          <ac:grpSpMkLst>
            <pc:docMk/>
            <pc:sldMk cId="0" sldId="273"/>
            <ac:grpSpMk id="6" creationId="{00000000-0000-0000-0000-000000000000}"/>
          </ac:grpSpMkLst>
        </pc:grpChg>
        <pc:grpChg chg="add mod">
          <ac:chgData name="vijay kumar" userId="0eb738f014aa4543" providerId="LiveId" clId="{B4DB2928-3EFF-4507-ABD0-3894F091460A}" dt="2020-05-18T09:30:29.269" v="14853" actId="1038"/>
          <ac:grpSpMkLst>
            <pc:docMk/>
            <pc:sldMk cId="0" sldId="273"/>
            <ac:grpSpMk id="6" creationId="{CBF474C7-AA66-471C-8D4D-1489D1DCF052}"/>
          </ac:grpSpMkLst>
        </pc:grpChg>
        <pc:grpChg chg="mod topLvl">
          <ac:chgData name="vijay kumar" userId="0eb738f014aa4543" providerId="LiveId" clId="{B4DB2928-3EFF-4507-ABD0-3894F091460A}" dt="2020-04-27T17:46:13.028" v="18" actId="164"/>
          <ac:grpSpMkLst>
            <pc:docMk/>
            <pc:sldMk cId="0" sldId="273"/>
            <ac:grpSpMk id="7" creationId="{00000000-0000-0000-0000-000000000000}"/>
          </ac:grpSpMkLst>
        </pc:grpChg>
        <pc:grpChg chg="add mod">
          <ac:chgData name="vijay kumar" userId="0eb738f014aa4543" providerId="LiveId" clId="{B4DB2928-3EFF-4507-ABD0-3894F091460A}" dt="2020-05-18T09:30:42.783" v="14915" actId="1038"/>
          <ac:grpSpMkLst>
            <pc:docMk/>
            <pc:sldMk cId="0" sldId="273"/>
            <ac:grpSpMk id="7" creationId="{28CC8A29-1275-42E9-B507-C74DE21AB7BA}"/>
          </ac:grpSpMkLst>
        </pc:grpChg>
        <pc:grpChg chg="add del mod">
          <ac:chgData name="vijay kumar" userId="0eb738f014aa4543" providerId="LiveId" clId="{B4DB2928-3EFF-4507-ABD0-3894F091460A}" dt="2020-04-27T17:46:14.911" v="19" actId="21"/>
          <ac:grpSpMkLst>
            <pc:docMk/>
            <pc:sldMk cId="0" sldId="273"/>
            <ac:grpSpMk id="9" creationId="{647E07B0-C271-4FE3-A167-CB18CC8DA174}"/>
          </ac:grpSpMkLst>
        </pc:grpChg>
        <pc:cxnChg chg="mod topLvl">
          <ac:chgData name="vijay kumar" userId="0eb738f014aa4543" providerId="LiveId" clId="{B4DB2928-3EFF-4507-ABD0-3894F091460A}" dt="2020-05-07T13:40:54.138" v="12874" actId="164"/>
          <ac:cxnSpMkLst>
            <pc:docMk/>
            <pc:sldMk cId="0" sldId="273"/>
            <ac:cxnSpMk id="458" creationId="{00000000-0000-0000-0000-000000000000}"/>
          </ac:cxnSpMkLst>
        </pc:cxnChg>
      </pc:sldChg>
      <pc:sldChg chg="add del ord">
        <pc:chgData name="vijay kumar" userId="0eb738f014aa4543" providerId="LiveId" clId="{B4DB2928-3EFF-4507-ABD0-3894F091460A}" dt="2020-04-28T09:41:19.534" v="3352" actId="2696"/>
        <pc:sldMkLst>
          <pc:docMk/>
          <pc:sldMk cId="0" sldId="277"/>
        </pc:sldMkLst>
      </pc:sldChg>
      <pc:sldChg chg="addSp delSp modSp add mod ord">
        <pc:chgData name="vijay kumar" userId="0eb738f014aa4543" providerId="LiveId" clId="{B4DB2928-3EFF-4507-ABD0-3894F091460A}" dt="2020-05-24T19:31:55.002" v="15202" actId="20577"/>
        <pc:sldMkLst>
          <pc:docMk/>
          <pc:sldMk cId="0" sldId="285"/>
        </pc:sldMkLst>
        <pc:spChg chg="del mod topLvl">
          <ac:chgData name="vijay kumar" userId="0eb738f014aa4543" providerId="LiveId" clId="{B4DB2928-3EFF-4507-ABD0-3894F091460A}" dt="2020-04-29T08:33:40.034" v="3440" actId="478"/>
          <ac:spMkLst>
            <pc:docMk/>
            <pc:sldMk cId="0" sldId="285"/>
            <ac:spMk id="5" creationId="{F08488B3-8C0B-4387-B47C-C5E8D9D7C56C}"/>
          </ac:spMkLst>
        </pc:spChg>
        <pc:spChg chg="del mod topLvl">
          <ac:chgData name="vijay kumar" userId="0eb738f014aa4543" providerId="LiveId" clId="{B4DB2928-3EFF-4507-ABD0-3894F091460A}" dt="2020-04-29T08:33:25.376" v="3437" actId="478"/>
          <ac:spMkLst>
            <pc:docMk/>
            <pc:sldMk cId="0" sldId="285"/>
            <ac:spMk id="6" creationId="{DD7BC940-BE06-443E-A2F7-47F8BFB440F4}"/>
          </ac:spMkLst>
        </pc:spChg>
        <pc:spChg chg="del mod topLvl">
          <ac:chgData name="vijay kumar" userId="0eb738f014aa4543" providerId="LiveId" clId="{B4DB2928-3EFF-4507-ABD0-3894F091460A}" dt="2020-04-29T08:33:26.347" v="3438" actId="478"/>
          <ac:spMkLst>
            <pc:docMk/>
            <pc:sldMk cId="0" sldId="285"/>
            <ac:spMk id="7" creationId="{74815779-CBCC-4F2A-B0BD-C14339001F79}"/>
          </ac:spMkLst>
        </pc:spChg>
        <pc:spChg chg="del mod topLvl">
          <ac:chgData name="vijay kumar" userId="0eb738f014aa4543" providerId="LiveId" clId="{B4DB2928-3EFF-4507-ABD0-3894F091460A}" dt="2020-04-29T09:29:13.424" v="3533" actId="478"/>
          <ac:spMkLst>
            <pc:docMk/>
            <pc:sldMk cId="0" sldId="285"/>
            <ac:spMk id="8" creationId="{43254561-03A2-439B-AEA9-81797CB8ABC5}"/>
          </ac:spMkLst>
        </pc:spChg>
        <pc:spChg chg="del mod topLvl">
          <ac:chgData name="vijay kumar" userId="0eb738f014aa4543" providerId="LiveId" clId="{B4DB2928-3EFF-4507-ABD0-3894F091460A}" dt="2020-04-29T09:36:06.832" v="3968" actId="478"/>
          <ac:spMkLst>
            <pc:docMk/>
            <pc:sldMk cId="0" sldId="285"/>
            <ac:spMk id="9" creationId="{85C633B0-DA82-4FF0-A215-BC974C316C7A}"/>
          </ac:spMkLst>
        </pc:spChg>
        <pc:spChg chg="mod topLvl">
          <ac:chgData name="vijay kumar" userId="0eb738f014aa4543" providerId="LiveId" clId="{B4DB2928-3EFF-4507-ABD0-3894F091460A}" dt="2020-05-24T14:25:51.634" v="15151" actId="1036"/>
          <ac:spMkLst>
            <pc:docMk/>
            <pc:sldMk cId="0" sldId="285"/>
            <ac:spMk id="10" creationId="{6D42F8B8-D37E-4469-ADE5-DAE629F1BCB0}"/>
          </ac:spMkLst>
        </pc:spChg>
        <pc:spChg chg="mod topLvl">
          <ac:chgData name="vijay kumar" userId="0eb738f014aa4543" providerId="LiveId" clId="{B4DB2928-3EFF-4507-ABD0-3894F091460A}" dt="2020-05-24T14:25:51.634" v="15151" actId="1036"/>
          <ac:spMkLst>
            <pc:docMk/>
            <pc:sldMk cId="0" sldId="285"/>
            <ac:spMk id="11" creationId="{936998DF-F8B8-45CE-8684-903ACF81BC9E}"/>
          </ac:spMkLst>
        </pc:spChg>
        <pc:spChg chg="del mod topLvl">
          <ac:chgData name="vijay kumar" userId="0eb738f014aa4543" providerId="LiveId" clId="{B4DB2928-3EFF-4507-ABD0-3894F091460A}" dt="2020-04-29T09:36:06.832" v="3968" actId="478"/>
          <ac:spMkLst>
            <pc:docMk/>
            <pc:sldMk cId="0" sldId="285"/>
            <ac:spMk id="12" creationId="{EEDB1C58-E08D-4F3E-9F1B-808BC40FBD17}"/>
          </ac:spMkLst>
        </pc:spChg>
        <pc:spChg chg="mod topLvl">
          <ac:chgData name="vijay kumar" userId="0eb738f014aa4543" providerId="LiveId" clId="{B4DB2928-3EFF-4507-ABD0-3894F091460A}" dt="2020-05-24T14:25:51.634" v="15151" actId="1036"/>
          <ac:spMkLst>
            <pc:docMk/>
            <pc:sldMk cId="0" sldId="285"/>
            <ac:spMk id="13" creationId="{E097214B-D01B-4D56-A01D-13249F320072}"/>
          </ac:spMkLst>
        </pc:spChg>
        <pc:spChg chg="del mod topLvl">
          <ac:chgData name="vijay kumar" userId="0eb738f014aa4543" providerId="LiveId" clId="{B4DB2928-3EFF-4507-ABD0-3894F091460A}" dt="2020-04-29T09:36:06.832" v="3968" actId="478"/>
          <ac:spMkLst>
            <pc:docMk/>
            <pc:sldMk cId="0" sldId="285"/>
            <ac:spMk id="14" creationId="{52D632CE-C315-47B0-9FB8-407B383D46CE}"/>
          </ac:spMkLst>
        </pc:spChg>
        <pc:spChg chg="mod topLvl">
          <ac:chgData name="vijay kumar" userId="0eb738f014aa4543" providerId="LiveId" clId="{B4DB2928-3EFF-4507-ABD0-3894F091460A}" dt="2020-05-24T14:25:51.634" v="15151" actId="1036"/>
          <ac:spMkLst>
            <pc:docMk/>
            <pc:sldMk cId="0" sldId="285"/>
            <ac:spMk id="15" creationId="{F2EB0060-8D7A-4D1D-A7A9-83E653189841}"/>
          </ac:spMkLst>
        </pc:spChg>
        <pc:spChg chg="del mod topLvl">
          <ac:chgData name="vijay kumar" userId="0eb738f014aa4543" providerId="LiveId" clId="{B4DB2928-3EFF-4507-ABD0-3894F091460A}" dt="2020-04-29T09:36:06.832" v="3968" actId="478"/>
          <ac:spMkLst>
            <pc:docMk/>
            <pc:sldMk cId="0" sldId="285"/>
            <ac:spMk id="16" creationId="{8C936C70-7BF3-40BB-8AD4-E32D60499E88}"/>
          </ac:spMkLst>
        </pc:spChg>
        <pc:spChg chg="mod topLvl">
          <ac:chgData name="vijay kumar" userId="0eb738f014aa4543" providerId="LiveId" clId="{B4DB2928-3EFF-4507-ABD0-3894F091460A}" dt="2020-05-24T14:25:51.634" v="15151" actId="1036"/>
          <ac:spMkLst>
            <pc:docMk/>
            <pc:sldMk cId="0" sldId="285"/>
            <ac:spMk id="17" creationId="{FA75543B-A120-40FF-B55D-94B83AF57E73}"/>
          </ac:spMkLst>
        </pc:spChg>
        <pc:spChg chg="del mod topLvl">
          <ac:chgData name="vijay kumar" userId="0eb738f014aa4543" providerId="LiveId" clId="{B4DB2928-3EFF-4507-ABD0-3894F091460A}" dt="2020-04-29T09:36:06.832" v="3968" actId="478"/>
          <ac:spMkLst>
            <pc:docMk/>
            <pc:sldMk cId="0" sldId="285"/>
            <ac:spMk id="18" creationId="{C10F2777-C9DA-4481-B60C-E529461C4D18}"/>
          </ac:spMkLst>
        </pc:spChg>
        <pc:spChg chg="del mod topLvl">
          <ac:chgData name="vijay kumar" userId="0eb738f014aa4543" providerId="LiveId" clId="{B4DB2928-3EFF-4507-ABD0-3894F091460A}" dt="2020-04-29T09:36:06.832" v="3968" actId="478"/>
          <ac:spMkLst>
            <pc:docMk/>
            <pc:sldMk cId="0" sldId="285"/>
            <ac:spMk id="19" creationId="{DAAAEC20-76A1-4702-89B4-6212B68E50A0}"/>
          </ac:spMkLst>
        </pc:spChg>
        <pc:spChg chg="del mod topLvl">
          <ac:chgData name="vijay kumar" userId="0eb738f014aa4543" providerId="LiveId" clId="{B4DB2928-3EFF-4507-ABD0-3894F091460A}" dt="2020-04-29T09:36:06.832" v="3968" actId="478"/>
          <ac:spMkLst>
            <pc:docMk/>
            <pc:sldMk cId="0" sldId="285"/>
            <ac:spMk id="20" creationId="{54B9469F-CA13-43D5-93F1-74FF28C2AD5B}"/>
          </ac:spMkLst>
        </pc:spChg>
        <pc:spChg chg="del mod topLvl">
          <ac:chgData name="vijay kumar" userId="0eb738f014aa4543" providerId="LiveId" clId="{B4DB2928-3EFF-4507-ABD0-3894F091460A}" dt="2020-04-29T09:36:06.832" v="3968" actId="478"/>
          <ac:spMkLst>
            <pc:docMk/>
            <pc:sldMk cId="0" sldId="285"/>
            <ac:spMk id="21" creationId="{151CC3CF-A924-484B-BAD2-5DF0619D5634}"/>
          </ac:spMkLst>
        </pc:spChg>
        <pc:spChg chg="del mod topLvl">
          <ac:chgData name="vijay kumar" userId="0eb738f014aa4543" providerId="LiveId" clId="{B4DB2928-3EFF-4507-ABD0-3894F091460A}" dt="2020-04-29T09:36:06.832" v="3968" actId="478"/>
          <ac:spMkLst>
            <pc:docMk/>
            <pc:sldMk cId="0" sldId="285"/>
            <ac:spMk id="22" creationId="{599ABD8E-34FF-4771-ADA6-2400D83021DF}"/>
          </ac:spMkLst>
        </pc:spChg>
        <pc:spChg chg="del mod topLvl">
          <ac:chgData name="vijay kumar" userId="0eb738f014aa4543" providerId="LiveId" clId="{B4DB2928-3EFF-4507-ABD0-3894F091460A}" dt="2020-04-29T09:36:06.832" v="3968" actId="478"/>
          <ac:spMkLst>
            <pc:docMk/>
            <pc:sldMk cId="0" sldId="285"/>
            <ac:spMk id="23" creationId="{840DE62C-9DF2-4616-A4E7-9981E5619850}"/>
          </ac:spMkLst>
        </pc:spChg>
        <pc:spChg chg="del mod topLvl">
          <ac:chgData name="vijay kumar" userId="0eb738f014aa4543" providerId="LiveId" clId="{B4DB2928-3EFF-4507-ABD0-3894F091460A}" dt="2020-04-29T09:36:06.832" v="3968" actId="478"/>
          <ac:spMkLst>
            <pc:docMk/>
            <pc:sldMk cId="0" sldId="285"/>
            <ac:spMk id="24" creationId="{4C4EECF5-C4FF-4E52-9DC6-7AFF216059B8}"/>
          </ac:spMkLst>
        </pc:spChg>
        <pc:spChg chg="del mod topLvl">
          <ac:chgData name="vijay kumar" userId="0eb738f014aa4543" providerId="LiveId" clId="{B4DB2928-3EFF-4507-ABD0-3894F091460A}" dt="2020-04-29T09:36:06.832" v="3968" actId="478"/>
          <ac:spMkLst>
            <pc:docMk/>
            <pc:sldMk cId="0" sldId="285"/>
            <ac:spMk id="25" creationId="{2B5D1925-127E-417F-95FF-28CAE92843FC}"/>
          </ac:spMkLst>
        </pc:spChg>
        <pc:spChg chg="del mod topLvl">
          <ac:chgData name="vijay kumar" userId="0eb738f014aa4543" providerId="LiveId" clId="{B4DB2928-3EFF-4507-ABD0-3894F091460A}" dt="2020-04-29T09:36:06.832" v="3968" actId="478"/>
          <ac:spMkLst>
            <pc:docMk/>
            <pc:sldMk cId="0" sldId="285"/>
            <ac:spMk id="26" creationId="{34B9EE18-04B5-4A38-B562-2F06FE80C5FB}"/>
          </ac:spMkLst>
        </pc:spChg>
        <pc:spChg chg="del mod topLvl">
          <ac:chgData name="vijay kumar" userId="0eb738f014aa4543" providerId="LiveId" clId="{B4DB2928-3EFF-4507-ABD0-3894F091460A}" dt="2020-04-29T09:36:06.832" v="3968" actId="478"/>
          <ac:spMkLst>
            <pc:docMk/>
            <pc:sldMk cId="0" sldId="285"/>
            <ac:spMk id="27" creationId="{C794F846-D979-4C93-9EDB-8EE1BA82CF95}"/>
          </ac:spMkLst>
        </pc:spChg>
        <pc:spChg chg="del mod topLvl">
          <ac:chgData name="vijay kumar" userId="0eb738f014aa4543" providerId="LiveId" clId="{B4DB2928-3EFF-4507-ABD0-3894F091460A}" dt="2020-04-29T09:36:06.832" v="3968" actId="478"/>
          <ac:spMkLst>
            <pc:docMk/>
            <pc:sldMk cId="0" sldId="285"/>
            <ac:spMk id="28" creationId="{F0320617-E504-4A38-934C-7DE90F533E09}"/>
          </ac:spMkLst>
        </pc:spChg>
        <pc:spChg chg="del mod topLvl">
          <ac:chgData name="vijay kumar" userId="0eb738f014aa4543" providerId="LiveId" clId="{B4DB2928-3EFF-4507-ABD0-3894F091460A}" dt="2020-04-29T08:33:24.147" v="3435" actId="478"/>
          <ac:spMkLst>
            <pc:docMk/>
            <pc:sldMk cId="0" sldId="285"/>
            <ac:spMk id="29" creationId="{05805EB6-9E48-480F-B245-2D484E9E7BCA}"/>
          </ac:spMkLst>
        </pc:spChg>
        <pc:spChg chg="del mod topLvl">
          <ac:chgData name="vijay kumar" userId="0eb738f014aa4543" providerId="LiveId" clId="{B4DB2928-3EFF-4507-ABD0-3894F091460A}" dt="2020-04-29T08:33:27.458" v="3439" actId="478"/>
          <ac:spMkLst>
            <pc:docMk/>
            <pc:sldMk cId="0" sldId="285"/>
            <ac:spMk id="31" creationId="{7BAC193F-68BE-474B-BFEB-27584E3C38A3}"/>
          </ac:spMkLst>
        </pc:spChg>
        <pc:spChg chg="del mod topLvl">
          <ac:chgData name="vijay kumar" userId="0eb738f014aa4543" providerId="LiveId" clId="{B4DB2928-3EFF-4507-ABD0-3894F091460A}" dt="2020-04-29T08:33:15.026" v="3432" actId="478"/>
          <ac:spMkLst>
            <pc:docMk/>
            <pc:sldMk cId="0" sldId="285"/>
            <ac:spMk id="64" creationId="{F58A9C24-0CA8-435D-A724-EC208D620D54}"/>
          </ac:spMkLst>
        </pc:spChg>
        <pc:spChg chg="del mod topLvl">
          <ac:chgData name="vijay kumar" userId="0eb738f014aa4543" providerId="LiveId" clId="{B4DB2928-3EFF-4507-ABD0-3894F091460A}" dt="2020-04-29T09:41:14.115" v="4338" actId="478"/>
          <ac:spMkLst>
            <pc:docMk/>
            <pc:sldMk cId="0" sldId="285"/>
            <ac:spMk id="65" creationId="{E98BC03B-6D96-42BF-8646-5E3FEAC392A7}"/>
          </ac:spMkLst>
        </pc:spChg>
        <pc:spChg chg="del mod topLvl">
          <ac:chgData name="vijay kumar" userId="0eb738f014aa4543" providerId="LiveId" clId="{B4DB2928-3EFF-4507-ABD0-3894F091460A}" dt="2020-04-29T09:46:13.016" v="4509" actId="478"/>
          <ac:spMkLst>
            <pc:docMk/>
            <pc:sldMk cId="0" sldId="285"/>
            <ac:spMk id="66" creationId="{DEB6DF3B-09FE-4137-BB2D-CCC54E011C37}"/>
          </ac:spMkLst>
        </pc:spChg>
        <pc:spChg chg="mod topLvl">
          <ac:chgData name="vijay kumar" userId="0eb738f014aa4543" providerId="LiveId" clId="{B4DB2928-3EFF-4507-ABD0-3894F091460A}" dt="2020-05-24T14:25:51.634" v="15151" actId="1036"/>
          <ac:spMkLst>
            <pc:docMk/>
            <pc:sldMk cId="0" sldId="285"/>
            <ac:spMk id="67" creationId="{5589543A-EAC0-48A4-97A3-478FE4CC3960}"/>
          </ac:spMkLst>
        </pc:spChg>
        <pc:spChg chg="mod topLvl">
          <ac:chgData name="vijay kumar" userId="0eb738f014aa4543" providerId="LiveId" clId="{B4DB2928-3EFF-4507-ABD0-3894F091460A}" dt="2020-05-24T14:25:51.634" v="15151" actId="1036"/>
          <ac:spMkLst>
            <pc:docMk/>
            <pc:sldMk cId="0" sldId="285"/>
            <ac:spMk id="68" creationId="{68AFBE2D-926D-4949-AE99-8BFD9A5F32A8}"/>
          </ac:spMkLst>
        </pc:spChg>
        <pc:spChg chg="mod topLvl">
          <ac:chgData name="vijay kumar" userId="0eb738f014aa4543" providerId="LiveId" clId="{B4DB2928-3EFF-4507-ABD0-3894F091460A}" dt="2020-05-24T14:25:51.634" v="15151" actId="1036"/>
          <ac:spMkLst>
            <pc:docMk/>
            <pc:sldMk cId="0" sldId="285"/>
            <ac:spMk id="69" creationId="{F08433CA-C0DC-4230-A0D6-48BFB4B0E112}"/>
          </ac:spMkLst>
        </pc:spChg>
        <pc:spChg chg="mod topLvl">
          <ac:chgData name="vijay kumar" userId="0eb738f014aa4543" providerId="LiveId" clId="{B4DB2928-3EFF-4507-ABD0-3894F091460A}" dt="2020-05-24T14:25:51.634" v="15151" actId="1036"/>
          <ac:spMkLst>
            <pc:docMk/>
            <pc:sldMk cId="0" sldId="285"/>
            <ac:spMk id="70" creationId="{207F2878-3D0C-49F6-BECC-204897AAD255}"/>
          </ac:spMkLst>
        </pc:spChg>
        <pc:spChg chg="del mod topLvl">
          <ac:chgData name="vijay kumar" userId="0eb738f014aa4543" providerId="LiveId" clId="{B4DB2928-3EFF-4507-ABD0-3894F091460A}" dt="2020-04-29T09:46:13.016" v="4509" actId="478"/>
          <ac:spMkLst>
            <pc:docMk/>
            <pc:sldMk cId="0" sldId="285"/>
            <ac:spMk id="71" creationId="{2FC624C4-DDED-4AB9-8FEC-CE4C09889AA8}"/>
          </ac:spMkLst>
        </pc:spChg>
        <pc:spChg chg="del mod topLvl">
          <ac:chgData name="vijay kumar" userId="0eb738f014aa4543" providerId="LiveId" clId="{B4DB2928-3EFF-4507-ABD0-3894F091460A}" dt="2020-04-29T09:46:13.016" v="4509" actId="478"/>
          <ac:spMkLst>
            <pc:docMk/>
            <pc:sldMk cId="0" sldId="285"/>
            <ac:spMk id="72" creationId="{F404B028-6CFA-4DEF-8FB6-470B5346DD7D}"/>
          </ac:spMkLst>
        </pc:spChg>
        <pc:spChg chg="del mod topLvl">
          <ac:chgData name="vijay kumar" userId="0eb738f014aa4543" providerId="LiveId" clId="{B4DB2928-3EFF-4507-ABD0-3894F091460A}" dt="2020-04-29T09:46:13.016" v="4509" actId="478"/>
          <ac:spMkLst>
            <pc:docMk/>
            <pc:sldMk cId="0" sldId="285"/>
            <ac:spMk id="73" creationId="{4639C3A8-B128-453B-9D11-6571F199CFD4}"/>
          </ac:spMkLst>
        </pc:spChg>
        <pc:spChg chg="del mod topLvl">
          <ac:chgData name="vijay kumar" userId="0eb738f014aa4543" providerId="LiveId" clId="{B4DB2928-3EFF-4507-ABD0-3894F091460A}" dt="2020-04-29T09:46:13.016" v="4509" actId="478"/>
          <ac:spMkLst>
            <pc:docMk/>
            <pc:sldMk cId="0" sldId="285"/>
            <ac:spMk id="74" creationId="{70EF6C37-4B8D-45B0-9E18-9BE65C2CB20C}"/>
          </ac:spMkLst>
        </pc:spChg>
        <pc:spChg chg="del mod topLvl">
          <ac:chgData name="vijay kumar" userId="0eb738f014aa4543" providerId="LiveId" clId="{B4DB2928-3EFF-4507-ABD0-3894F091460A}" dt="2020-04-29T09:46:13.016" v="4509" actId="478"/>
          <ac:spMkLst>
            <pc:docMk/>
            <pc:sldMk cId="0" sldId="285"/>
            <ac:spMk id="75" creationId="{3D4DCDD3-44A0-477A-864D-FFC2B528047B}"/>
          </ac:spMkLst>
        </pc:spChg>
        <pc:spChg chg="del mod topLvl">
          <ac:chgData name="vijay kumar" userId="0eb738f014aa4543" providerId="LiveId" clId="{B4DB2928-3EFF-4507-ABD0-3894F091460A}" dt="2020-04-29T09:46:13.016" v="4509" actId="478"/>
          <ac:spMkLst>
            <pc:docMk/>
            <pc:sldMk cId="0" sldId="285"/>
            <ac:spMk id="76" creationId="{46D9904D-A533-48AE-9D27-444EA0498A03}"/>
          </ac:spMkLst>
        </pc:spChg>
        <pc:spChg chg="add del mod">
          <ac:chgData name="vijay kumar" userId="0eb738f014aa4543" providerId="LiveId" clId="{B4DB2928-3EFF-4507-ABD0-3894F091460A}" dt="2020-05-04T11:37:34.750" v="7435" actId="478"/>
          <ac:spMkLst>
            <pc:docMk/>
            <pc:sldMk cId="0" sldId="285"/>
            <ac:spMk id="76" creationId="{573AEA71-6811-4BCB-8D10-BF91FE9DA258}"/>
          </ac:spMkLst>
        </pc:spChg>
        <pc:spChg chg="del mod topLvl">
          <ac:chgData name="vijay kumar" userId="0eb738f014aa4543" providerId="LiveId" clId="{B4DB2928-3EFF-4507-ABD0-3894F091460A}" dt="2020-04-29T09:46:13.016" v="4509" actId="478"/>
          <ac:spMkLst>
            <pc:docMk/>
            <pc:sldMk cId="0" sldId="285"/>
            <ac:spMk id="77" creationId="{2E4E0168-1501-4148-95BC-04E5BD281C6D}"/>
          </ac:spMkLst>
        </pc:spChg>
        <pc:spChg chg="add mod">
          <ac:chgData name="vijay kumar" userId="0eb738f014aa4543" providerId="LiveId" clId="{B4DB2928-3EFF-4507-ABD0-3894F091460A}" dt="2020-05-24T14:52:17.730" v="15199" actId="20577"/>
          <ac:spMkLst>
            <pc:docMk/>
            <pc:sldMk cId="0" sldId="285"/>
            <ac:spMk id="77" creationId="{C47B253B-2AEA-4BEF-8F19-4EDFA2CEE544}"/>
          </ac:spMkLst>
        </pc:spChg>
        <pc:spChg chg="add del mod">
          <ac:chgData name="vijay kumar" userId="0eb738f014aa4543" providerId="LiveId" clId="{B4DB2928-3EFF-4507-ABD0-3894F091460A}" dt="2020-05-24T14:26:22.629" v="15157" actId="478"/>
          <ac:spMkLst>
            <pc:docMk/>
            <pc:sldMk cId="0" sldId="285"/>
            <ac:spMk id="78" creationId="{989B600D-3718-4B92-80FA-0E20F87DDF7D}"/>
          </ac:spMkLst>
        </pc:spChg>
        <pc:spChg chg="del mod topLvl">
          <ac:chgData name="vijay kumar" userId="0eb738f014aa4543" providerId="LiveId" clId="{B4DB2928-3EFF-4507-ABD0-3894F091460A}" dt="2020-04-29T09:46:13.016" v="4509" actId="478"/>
          <ac:spMkLst>
            <pc:docMk/>
            <pc:sldMk cId="0" sldId="285"/>
            <ac:spMk id="78" creationId="{A4F052D4-2636-4E08-8DED-00DC213FCE6D}"/>
          </ac:spMkLst>
        </pc:spChg>
        <pc:spChg chg="del mod topLvl">
          <ac:chgData name="vijay kumar" userId="0eb738f014aa4543" providerId="LiveId" clId="{B4DB2928-3EFF-4507-ABD0-3894F091460A}" dt="2020-04-29T09:46:13.016" v="4509" actId="478"/>
          <ac:spMkLst>
            <pc:docMk/>
            <pc:sldMk cId="0" sldId="285"/>
            <ac:spMk id="79" creationId="{419ACBE3-9AB5-4149-84AA-103687822AA5}"/>
          </ac:spMkLst>
        </pc:spChg>
        <pc:spChg chg="add mod">
          <ac:chgData name="vijay kumar" userId="0eb738f014aa4543" providerId="LiveId" clId="{B4DB2928-3EFF-4507-ABD0-3894F091460A}" dt="2020-05-24T14:25:51.634" v="15151" actId="1036"/>
          <ac:spMkLst>
            <pc:docMk/>
            <pc:sldMk cId="0" sldId="285"/>
            <ac:spMk id="79" creationId="{8CCF493C-76B2-4134-B3D3-74DB8D704E64}"/>
          </ac:spMkLst>
        </pc:spChg>
        <pc:spChg chg="del mod topLvl">
          <ac:chgData name="vijay kumar" userId="0eb738f014aa4543" providerId="LiveId" clId="{B4DB2928-3EFF-4507-ABD0-3894F091460A}" dt="2020-04-29T09:46:13.016" v="4509" actId="478"/>
          <ac:spMkLst>
            <pc:docMk/>
            <pc:sldMk cId="0" sldId="285"/>
            <ac:spMk id="80" creationId="{15A70CF3-6778-49A1-A580-A5910FCB5422}"/>
          </ac:spMkLst>
        </pc:spChg>
        <pc:spChg chg="add del mod">
          <ac:chgData name="vijay kumar" userId="0eb738f014aa4543" providerId="LiveId" clId="{B4DB2928-3EFF-4507-ABD0-3894F091460A}" dt="2020-05-24T14:23:14.396" v="15089" actId="478"/>
          <ac:spMkLst>
            <pc:docMk/>
            <pc:sldMk cId="0" sldId="285"/>
            <ac:spMk id="80" creationId="{D176AEA0-4090-4F75-B725-AD8AFBE6B968}"/>
          </ac:spMkLst>
        </pc:spChg>
        <pc:spChg chg="del mod topLvl">
          <ac:chgData name="vijay kumar" userId="0eb738f014aa4543" providerId="LiveId" clId="{B4DB2928-3EFF-4507-ABD0-3894F091460A}" dt="2020-04-29T08:33:22.755" v="3434" actId="478"/>
          <ac:spMkLst>
            <pc:docMk/>
            <pc:sldMk cId="0" sldId="285"/>
            <ac:spMk id="81" creationId="{CF4A7CC3-2EEF-49E8-AB8F-D1A8F0EFCE24}"/>
          </ac:spMkLst>
        </pc:spChg>
        <pc:spChg chg="add del mod">
          <ac:chgData name="vijay kumar" userId="0eb738f014aa4543" providerId="LiveId" clId="{B4DB2928-3EFF-4507-ABD0-3894F091460A}" dt="2020-05-24T14:22:27.828" v="14974" actId="478"/>
          <ac:spMkLst>
            <pc:docMk/>
            <pc:sldMk cId="0" sldId="285"/>
            <ac:spMk id="81" creationId="{D518E7D6-4EA7-48A2-B118-BD006F5237A9}"/>
          </ac:spMkLst>
        </pc:spChg>
        <pc:spChg chg="add mod">
          <ac:chgData name="vijay kumar" userId="0eb738f014aa4543" providerId="LiveId" clId="{B4DB2928-3EFF-4507-ABD0-3894F091460A}" dt="2020-05-24T14:25:51.634" v="15151" actId="1036"/>
          <ac:spMkLst>
            <pc:docMk/>
            <pc:sldMk cId="0" sldId="285"/>
            <ac:spMk id="82" creationId="{41117237-C045-4244-84D8-EBCCB6994A32}"/>
          </ac:spMkLst>
        </pc:spChg>
        <pc:spChg chg="mod topLvl">
          <ac:chgData name="vijay kumar" userId="0eb738f014aa4543" providerId="LiveId" clId="{B4DB2928-3EFF-4507-ABD0-3894F091460A}" dt="2020-05-24T14:25:51.634" v="15151" actId="1036"/>
          <ac:spMkLst>
            <pc:docMk/>
            <pc:sldMk cId="0" sldId="285"/>
            <ac:spMk id="83" creationId="{98BC9CD6-7795-4186-9DF3-7468DDFD3A79}"/>
          </ac:spMkLst>
        </pc:spChg>
        <pc:spChg chg="mod topLvl">
          <ac:chgData name="vijay kumar" userId="0eb738f014aa4543" providerId="LiveId" clId="{B4DB2928-3EFF-4507-ABD0-3894F091460A}" dt="2020-05-09T19:26:20.847" v="14746" actId="13926"/>
          <ac:spMkLst>
            <pc:docMk/>
            <pc:sldMk cId="0" sldId="285"/>
            <ac:spMk id="84" creationId="{00000000-0000-0000-0000-000000000000}"/>
          </ac:spMkLst>
        </pc:spChg>
        <pc:spChg chg="mod topLvl">
          <ac:chgData name="vijay kumar" userId="0eb738f014aa4543" providerId="LiveId" clId="{B4DB2928-3EFF-4507-ABD0-3894F091460A}" dt="2020-05-24T14:25:51.634" v="15151" actId="1036"/>
          <ac:spMkLst>
            <pc:docMk/>
            <pc:sldMk cId="0" sldId="285"/>
            <ac:spMk id="85" creationId="{A9901149-7AF0-46CD-8A1B-FB7912BE443A}"/>
          </ac:spMkLst>
        </pc:spChg>
        <pc:spChg chg="mod topLvl">
          <ac:chgData name="vijay kumar" userId="0eb738f014aa4543" providerId="LiveId" clId="{B4DB2928-3EFF-4507-ABD0-3894F091460A}" dt="2020-05-24T14:25:51.634" v="15151" actId="1036"/>
          <ac:spMkLst>
            <pc:docMk/>
            <pc:sldMk cId="0" sldId="285"/>
            <ac:spMk id="86" creationId="{B30BFF04-D847-48EB-8558-E5F8D9465CEE}"/>
          </ac:spMkLst>
        </pc:spChg>
        <pc:spChg chg="mod topLvl">
          <ac:chgData name="vijay kumar" userId="0eb738f014aa4543" providerId="LiveId" clId="{B4DB2928-3EFF-4507-ABD0-3894F091460A}" dt="2020-05-24T14:25:51.634" v="15151" actId="1036"/>
          <ac:spMkLst>
            <pc:docMk/>
            <pc:sldMk cId="0" sldId="285"/>
            <ac:spMk id="87" creationId="{10DEBBC5-DBF9-4C99-A957-09DFD5BB996C}"/>
          </ac:spMkLst>
        </pc:spChg>
        <pc:spChg chg="mod topLvl">
          <ac:chgData name="vijay kumar" userId="0eb738f014aa4543" providerId="LiveId" clId="{B4DB2928-3EFF-4507-ABD0-3894F091460A}" dt="2020-05-24T14:25:51.634" v="15151" actId="1036"/>
          <ac:spMkLst>
            <pc:docMk/>
            <pc:sldMk cId="0" sldId="285"/>
            <ac:spMk id="88" creationId="{EEDA7325-B3EF-4F8A-8D12-326D70A35122}"/>
          </ac:spMkLst>
        </pc:spChg>
        <pc:spChg chg="mod topLvl">
          <ac:chgData name="vijay kumar" userId="0eb738f014aa4543" providerId="LiveId" clId="{B4DB2928-3EFF-4507-ABD0-3894F091460A}" dt="2020-05-24T14:25:51.634" v="15151" actId="1036"/>
          <ac:spMkLst>
            <pc:docMk/>
            <pc:sldMk cId="0" sldId="285"/>
            <ac:spMk id="89" creationId="{20E85F8D-1BD5-4966-97B0-1E551E735114}"/>
          </ac:spMkLst>
        </pc:spChg>
        <pc:spChg chg="mod topLvl">
          <ac:chgData name="vijay kumar" userId="0eb738f014aa4543" providerId="LiveId" clId="{B4DB2928-3EFF-4507-ABD0-3894F091460A}" dt="2020-05-24T14:25:51.634" v="15151" actId="1036"/>
          <ac:spMkLst>
            <pc:docMk/>
            <pc:sldMk cId="0" sldId="285"/>
            <ac:spMk id="90" creationId="{1FFD48A8-8576-41A7-8DDA-A400C1C59A48}"/>
          </ac:spMkLst>
        </pc:spChg>
        <pc:spChg chg="mod topLvl">
          <ac:chgData name="vijay kumar" userId="0eb738f014aa4543" providerId="LiveId" clId="{B4DB2928-3EFF-4507-ABD0-3894F091460A}" dt="2020-05-24T14:25:51.634" v="15151" actId="1036"/>
          <ac:spMkLst>
            <pc:docMk/>
            <pc:sldMk cId="0" sldId="285"/>
            <ac:spMk id="91" creationId="{C7E68A15-C0A9-464F-A12A-5926695CA24D}"/>
          </ac:spMkLst>
        </pc:spChg>
        <pc:spChg chg="mod topLvl">
          <ac:chgData name="vijay kumar" userId="0eb738f014aa4543" providerId="LiveId" clId="{B4DB2928-3EFF-4507-ABD0-3894F091460A}" dt="2020-05-24T14:25:51.634" v="15151" actId="1036"/>
          <ac:spMkLst>
            <pc:docMk/>
            <pc:sldMk cId="0" sldId="285"/>
            <ac:spMk id="92" creationId="{05F9510A-976C-426E-A5C0-467B86151CD9}"/>
          </ac:spMkLst>
        </pc:spChg>
        <pc:spChg chg="mod topLvl">
          <ac:chgData name="vijay kumar" userId="0eb738f014aa4543" providerId="LiveId" clId="{B4DB2928-3EFF-4507-ABD0-3894F091460A}" dt="2020-05-24T14:25:51.634" v="15151" actId="1036"/>
          <ac:spMkLst>
            <pc:docMk/>
            <pc:sldMk cId="0" sldId="285"/>
            <ac:spMk id="93" creationId="{23D78771-DED8-4B66-96C8-B0897F0D6C55}"/>
          </ac:spMkLst>
        </pc:spChg>
        <pc:spChg chg="mod topLvl">
          <ac:chgData name="vijay kumar" userId="0eb738f014aa4543" providerId="LiveId" clId="{B4DB2928-3EFF-4507-ABD0-3894F091460A}" dt="2020-05-24T14:25:51.634" v="15151" actId="1036"/>
          <ac:spMkLst>
            <pc:docMk/>
            <pc:sldMk cId="0" sldId="285"/>
            <ac:spMk id="94" creationId="{AB3C78E1-A1BA-43E3-AD8D-24A6632A8505}"/>
          </ac:spMkLst>
        </pc:spChg>
        <pc:spChg chg="mod topLvl">
          <ac:chgData name="vijay kumar" userId="0eb738f014aa4543" providerId="LiveId" clId="{B4DB2928-3EFF-4507-ABD0-3894F091460A}" dt="2020-05-24T14:25:51.634" v="15151" actId="1036"/>
          <ac:spMkLst>
            <pc:docMk/>
            <pc:sldMk cId="0" sldId="285"/>
            <ac:spMk id="95" creationId="{ED4BFF3B-DB09-42F9-8414-1D2FC1498227}"/>
          </ac:spMkLst>
        </pc:spChg>
        <pc:spChg chg="mod topLvl">
          <ac:chgData name="vijay kumar" userId="0eb738f014aa4543" providerId="LiveId" clId="{B4DB2928-3EFF-4507-ABD0-3894F091460A}" dt="2020-05-24T14:25:51.634" v="15151" actId="1036"/>
          <ac:spMkLst>
            <pc:docMk/>
            <pc:sldMk cId="0" sldId="285"/>
            <ac:spMk id="96" creationId="{8C279465-6B82-4BD8-B829-CC17C1C12CA2}"/>
          </ac:spMkLst>
        </pc:spChg>
        <pc:spChg chg="mod topLvl">
          <ac:chgData name="vijay kumar" userId="0eb738f014aa4543" providerId="LiveId" clId="{B4DB2928-3EFF-4507-ABD0-3894F091460A}" dt="2020-05-24T14:25:51.634" v="15151" actId="1036"/>
          <ac:spMkLst>
            <pc:docMk/>
            <pc:sldMk cId="0" sldId="285"/>
            <ac:spMk id="97" creationId="{FFCAA162-D6B2-404D-92B1-EA9AA7046CC6}"/>
          </ac:spMkLst>
        </pc:spChg>
        <pc:spChg chg="mod topLvl">
          <ac:chgData name="vijay kumar" userId="0eb738f014aa4543" providerId="LiveId" clId="{B4DB2928-3EFF-4507-ABD0-3894F091460A}" dt="2020-05-24T14:25:51.634" v="15151" actId="1036"/>
          <ac:spMkLst>
            <pc:docMk/>
            <pc:sldMk cId="0" sldId="285"/>
            <ac:spMk id="98" creationId="{89616BEA-FCE9-4323-836C-CFE2541E5300}"/>
          </ac:spMkLst>
        </pc:spChg>
        <pc:spChg chg="add mod">
          <ac:chgData name="vijay kumar" userId="0eb738f014aa4543" providerId="LiveId" clId="{B4DB2928-3EFF-4507-ABD0-3894F091460A}" dt="2020-05-24T14:25:51.634" v="15151" actId="1036"/>
          <ac:spMkLst>
            <pc:docMk/>
            <pc:sldMk cId="0" sldId="285"/>
            <ac:spMk id="99" creationId="{22A553D8-21C9-47CB-AD3E-BD3BF3B0A2BB}"/>
          </ac:spMkLst>
        </pc:spChg>
        <pc:spChg chg="del mod topLvl">
          <ac:chgData name="vijay kumar" userId="0eb738f014aa4543" providerId="LiveId" clId="{B4DB2928-3EFF-4507-ABD0-3894F091460A}" dt="2020-04-29T09:45:03.027" v="4474" actId="478"/>
          <ac:spMkLst>
            <pc:docMk/>
            <pc:sldMk cId="0" sldId="285"/>
            <ac:spMk id="99" creationId="{882C424F-3B31-49AD-AE5D-B2DD55EE9D81}"/>
          </ac:spMkLst>
        </pc:spChg>
        <pc:spChg chg="del mod topLvl">
          <ac:chgData name="vijay kumar" userId="0eb738f014aa4543" providerId="LiveId" clId="{B4DB2928-3EFF-4507-ABD0-3894F091460A}" dt="2020-05-04T17:09:58.374" v="8905" actId="478"/>
          <ac:spMkLst>
            <pc:docMk/>
            <pc:sldMk cId="0" sldId="285"/>
            <ac:spMk id="100" creationId="{407FFFDB-BC37-4C2B-B1BF-AE201720D06B}"/>
          </ac:spMkLst>
        </pc:spChg>
        <pc:spChg chg="add mod">
          <ac:chgData name="vijay kumar" userId="0eb738f014aa4543" providerId="LiveId" clId="{B4DB2928-3EFF-4507-ABD0-3894F091460A}" dt="2020-05-24T14:25:51.634" v="15151" actId="1036"/>
          <ac:spMkLst>
            <pc:docMk/>
            <pc:sldMk cId="0" sldId="285"/>
            <ac:spMk id="100" creationId="{EFA34FC7-B58C-48D2-A28C-F7993AAC3DD2}"/>
          </ac:spMkLst>
        </pc:spChg>
        <pc:spChg chg="mod topLvl">
          <ac:chgData name="vijay kumar" userId="0eb738f014aa4543" providerId="LiveId" clId="{B4DB2928-3EFF-4507-ABD0-3894F091460A}" dt="2020-05-24T14:25:51.634" v="15151" actId="1036"/>
          <ac:spMkLst>
            <pc:docMk/>
            <pc:sldMk cId="0" sldId="285"/>
            <ac:spMk id="103" creationId="{968BEB47-7C99-4E57-BD40-C9F5A9D4B353}"/>
          </ac:spMkLst>
        </pc:spChg>
        <pc:spChg chg="mod topLvl">
          <ac:chgData name="vijay kumar" userId="0eb738f014aa4543" providerId="LiveId" clId="{B4DB2928-3EFF-4507-ABD0-3894F091460A}" dt="2020-05-24T14:25:51.634" v="15151" actId="1036"/>
          <ac:spMkLst>
            <pc:docMk/>
            <pc:sldMk cId="0" sldId="285"/>
            <ac:spMk id="104" creationId="{E0D019F2-3269-4E5D-B5E7-B3EE84E54EBA}"/>
          </ac:spMkLst>
        </pc:spChg>
        <pc:spChg chg="mod topLvl">
          <ac:chgData name="vijay kumar" userId="0eb738f014aa4543" providerId="LiveId" clId="{B4DB2928-3EFF-4507-ABD0-3894F091460A}" dt="2020-05-24T14:25:51.634" v="15151" actId="1036"/>
          <ac:spMkLst>
            <pc:docMk/>
            <pc:sldMk cId="0" sldId="285"/>
            <ac:spMk id="105" creationId="{464C7B15-122F-4FA5-9D69-D9A207B0EA27}"/>
          </ac:spMkLst>
        </pc:spChg>
        <pc:spChg chg="mod topLvl">
          <ac:chgData name="vijay kumar" userId="0eb738f014aa4543" providerId="LiveId" clId="{B4DB2928-3EFF-4507-ABD0-3894F091460A}" dt="2020-05-24T14:25:51.634" v="15151" actId="1036"/>
          <ac:spMkLst>
            <pc:docMk/>
            <pc:sldMk cId="0" sldId="285"/>
            <ac:spMk id="106" creationId="{EFA1107F-AB41-4FB0-BC8C-B1792BC9D56C}"/>
          </ac:spMkLst>
        </pc:spChg>
        <pc:spChg chg="del mod">
          <ac:chgData name="vijay kumar" userId="0eb738f014aa4543" providerId="LiveId" clId="{B4DB2928-3EFF-4507-ABD0-3894F091460A}" dt="2020-05-04T11:37:31.812" v="7434" actId="478"/>
          <ac:spMkLst>
            <pc:docMk/>
            <pc:sldMk cId="0" sldId="285"/>
            <ac:spMk id="108" creationId="{F40675F3-C4B8-4DDA-9B98-C72825CCD468}"/>
          </ac:spMkLst>
        </pc:spChg>
        <pc:spChg chg="del">
          <ac:chgData name="vijay kumar" userId="0eb738f014aa4543" providerId="LiveId" clId="{B4DB2928-3EFF-4507-ABD0-3894F091460A}" dt="2020-04-29T08:33:20.780" v="3433" actId="478"/>
          <ac:spMkLst>
            <pc:docMk/>
            <pc:sldMk cId="0" sldId="285"/>
            <ac:spMk id="109" creationId="{00000000-0000-0000-0000-000000000000}"/>
          </ac:spMkLst>
        </pc:spChg>
        <pc:spChg chg="mod topLvl">
          <ac:chgData name="vijay kumar" userId="0eb738f014aa4543" providerId="LiveId" clId="{B4DB2928-3EFF-4507-ABD0-3894F091460A}" dt="2020-05-24T14:25:51.634" v="15151" actId="1036"/>
          <ac:spMkLst>
            <pc:docMk/>
            <pc:sldMk cId="0" sldId="285"/>
            <ac:spMk id="110" creationId="{E042F74A-BA14-4B6A-A790-FC6458C49E1D}"/>
          </ac:spMkLst>
        </pc:spChg>
        <pc:spChg chg="mod topLvl">
          <ac:chgData name="vijay kumar" userId="0eb738f014aa4543" providerId="LiveId" clId="{B4DB2928-3EFF-4507-ABD0-3894F091460A}" dt="2020-05-24T14:25:51.634" v="15151" actId="1036"/>
          <ac:spMkLst>
            <pc:docMk/>
            <pc:sldMk cId="0" sldId="285"/>
            <ac:spMk id="111" creationId="{C462E35F-CADE-4051-A778-0A1E26842F10}"/>
          </ac:spMkLst>
        </pc:spChg>
        <pc:spChg chg="mod topLvl">
          <ac:chgData name="vijay kumar" userId="0eb738f014aa4543" providerId="LiveId" clId="{B4DB2928-3EFF-4507-ABD0-3894F091460A}" dt="2020-05-24T14:25:51.634" v="15151" actId="1036"/>
          <ac:spMkLst>
            <pc:docMk/>
            <pc:sldMk cId="0" sldId="285"/>
            <ac:spMk id="112" creationId="{6EF90077-03F9-4546-A042-D2EFB23E27C6}"/>
          </ac:spMkLst>
        </pc:spChg>
        <pc:spChg chg="mod topLvl">
          <ac:chgData name="vijay kumar" userId="0eb738f014aa4543" providerId="LiveId" clId="{B4DB2928-3EFF-4507-ABD0-3894F091460A}" dt="2020-05-24T14:25:51.634" v="15151" actId="1036"/>
          <ac:spMkLst>
            <pc:docMk/>
            <pc:sldMk cId="0" sldId="285"/>
            <ac:spMk id="113" creationId="{BC808DAE-CD22-4C66-98F0-BD04B90ECF72}"/>
          </ac:spMkLst>
        </pc:spChg>
        <pc:spChg chg="mod topLvl">
          <ac:chgData name="vijay kumar" userId="0eb738f014aa4543" providerId="LiveId" clId="{B4DB2928-3EFF-4507-ABD0-3894F091460A}" dt="2020-05-24T14:25:51.634" v="15151" actId="1036"/>
          <ac:spMkLst>
            <pc:docMk/>
            <pc:sldMk cId="0" sldId="285"/>
            <ac:spMk id="114" creationId="{809CD2CB-E348-4087-80F8-EBB3E3334311}"/>
          </ac:spMkLst>
        </pc:spChg>
        <pc:spChg chg="mod topLvl">
          <ac:chgData name="vijay kumar" userId="0eb738f014aa4543" providerId="LiveId" clId="{B4DB2928-3EFF-4507-ABD0-3894F091460A}" dt="2020-05-24T14:25:51.634" v="15151" actId="1036"/>
          <ac:spMkLst>
            <pc:docMk/>
            <pc:sldMk cId="0" sldId="285"/>
            <ac:spMk id="115" creationId="{19CED920-5418-4EA2-9BD9-B86F75422A3E}"/>
          </ac:spMkLst>
        </pc:spChg>
        <pc:spChg chg="mod topLvl">
          <ac:chgData name="vijay kumar" userId="0eb738f014aa4543" providerId="LiveId" clId="{B4DB2928-3EFF-4507-ABD0-3894F091460A}" dt="2020-05-24T14:25:51.634" v="15151" actId="1036"/>
          <ac:spMkLst>
            <pc:docMk/>
            <pc:sldMk cId="0" sldId="285"/>
            <ac:spMk id="116" creationId="{0B952FDF-FB7F-4416-9528-9CEBC1B935B4}"/>
          </ac:spMkLst>
        </pc:spChg>
        <pc:spChg chg="mod topLvl">
          <ac:chgData name="vijay kumar" userId="0eb738f014aa4543" providerId="LiveId" clId="{B4DB2928-3EFF-4507-ABD0-3894F091460A}" dt="2020-05-24T14:25:51.634" v="15151" actId="1036"/>
          <ac:spMkLst>
            <pc:docMk/>
            <pc:sldMk cId="0" sldId="285"/>
            <ac:spMk id="117" creationId="{77CBE1E0-DCC5-48E1-9008-910DF2B8CB89}"/>
          </ac:spMkLst>
        </pc:spChg>
        <pc:spChg chg="mod topLvl">
          <ac:chgData name="vijay kumar" userId="0eb738f014aa4543" providerId="LiveId" clId="{B4DB2928-3EFF-4507-ABD0-3894F091460A}" dt="2020-05-24T14:25:51.634" v="15151" actId="1036"/>
          <ac:spMkLst>
            <pc:docMk/>
            <pc:sldMk cId="0" sldId="285"/>
            <ac:spMk id="118" creationId="{FD0CEA20-0A3D-4F12-A11A-C4079C064B95}"/>
          </ac:spMkLst>
        </pc:spChg>
        <pc:spChg chg="mod topLvl">
          <ac:chgData name="vijay kumar" userId="0eb738f014aa4543" providerId="LiveId" clId="{B4DB2928-3EFF-4507-ABD0-3894F091460A}" dt="2020-05-24T14:25:51.634" v="15151" actId="1036"/>
          <ac:spMkLst>
            <pc:docMk/>
            <pc:sldMk cId="0" sldId="285"/>
            <ac:spMk id="119" creationId="{8BF9D139-3184-4A42-901F-2C425CFC922C}"/>
          </ac:spMkLst>
        </pc:spChg>
        <pc:spChg chg="mod topLvl">
          <ac:chgData name="vijay kumar" userId="0eb738f014aa4543" providerId="LiveId" clId="{B4DB2928-3EFF-4507-ABD0-3894F091460A}" dt="2020-05-24T14:25:51.634" v="15151" actId="1036"/>
          <ac:spMkLst>
            <pc:docMk/>
            <pc:sldMk cId="0" sldId="285"/>
            <ac:spMk id="120" creationId="{281139FD-0A2D-4E68-BFC4-38AD31138945}"/>
          </ac:spMkLst>
        </pc:spChg>
        <pc:spChg chg="del mod topLvl">
          <ac:chgData name="vijay kumar" userId="0eb738f014aa4543" providerId="LiveId" clId="{B4DB2928-3EFF-4507-ABD0-3894F091460A}" dt="2020-04-29T09:36:12.441" v="3969" actId="478"/>
          <ac:spMkLst>
            <pc:docMk/>
            <pc:sldMk cId="0" sldId="285"/>
            <ac:spMk id="121" creationId="{BD962282-EE91-413C-AF36-F9B3B930CA95}"/>
          </ac:spMkLst>
        </pc:spChg>
        <pc:spChg chg="del mod topLvl">
          <ac:chgData name="vijay kumar" userId="0eb738f014aa4543" providerId="LiveId" clId="{B4DB2928-3EFF-4507-ABD0-3894F091460A}" dt="2020-04-29T09:48:43.149" v="4567" actId="478"/>
          <ac:spMkLst>
            <pc:docMk/>
            <pc:sldMk cId="0" sldId="285"/>
            <ac:spMk id="122" creationId="{8524BC54-6D92-4E72-87F6-104D2ED8365F}"/>
          </ac:spMkLst>
        </pc:spChg>
        <pc:spChg chg="add mod topLvl">
          <ac:chgData name="vijay kumar" userId="0eb738f014aa4543" providerId="LiveId" clId="{B4DB2928-3EFF-4507-ABD0-3894F091460A}" dt="2020-05-24T19:31:55.002" v="15202" actId="20577"/>
          <ac:spMkLst>
            <pc:docMk/>
            <pc:sldMk cId="0" sldId="285"/>
            <ac:spMk id="128" creationId="{8FC57E31-3552-4AB3-B239-087878EF8CCD}"/>
          </ac:spMkLst>
        </pc:spChg>
        <pc:spChg chg="add mod">
          <ac:chgData name="vijay kumar" userId="0eb738f014aa4543" providerId="LiveId" clId="{B4DB2928-3EFF-4507-ABD0-3894F091460A}" dt="2020-05-24T14:25:51.634" v="15151" actId="1036"/>
          <ac:spMkLst>
            <pc:docMk/>
            <pc:sldMk cId="0" sldId="285"/>
            <ac:spMk id="129" creationId="{3F0899B2-BA6E-400F-8968-978E33CA9582}"/>
          </ac:spMkLst>
        </pc:spChg>
        <pc:spChg chg="add mod topLvl">
          <ac:chgData name="vijay kumar" userId="0eb738f014aa4543" providerId="LiveId" clId="{B4DB2928-3EFF-4507-ABD0-3894F091460A}" dt="2020-05-24T14:25:51.634" v="15151" actId="1036"/>
          <ac:spMkLst>
            <pc:docMk/>
            <pc:sldMk cId="0" sldId="285"/>
            <ac:spMk id="130" creationId="{20F79E32-9678-4CA4-BEC6-4FE302A11C64}"/>
          </ac:spMkLst>
        </pc:spChg>
        <pc:spChg chg="del mod topLvl">
          <ac:chgData name="vijay kumar" userId="0eb738f014aa4543" providerId="LiveId" clId="{B4DB2928-3EFF-4507-ABD0-3894F091460A}" dt="2020-04-29T09:49:45.705" v="4569" actId="478"/>
          <ac:spMkLst>
            <pc:docMk/>
            <pc:sldMk cId="0" sldId="285"/>
            <ac:spMk id="142" creationId="{00000000-0000-0000-0000-000000000000}"/>
          </ac:spMkLst>
        </pc:spChg>
        <pc:spChg chg="del mod">
          <ac:chgData name="vijay kumar" userId="0eb738f014aa4543" providerId="LiveId" clId="{B4DB2928-3EFF-4507-ABD0-3894F091460A}" dt="2020-04-29T10:15:04.152" v="4625" actId="478"/>
          <ac:spMkLst>
            <pc:docMk/>
            <pc:sldMk cId="0" sldId="285"/>
            <ac:spMk id="143" creationId="{00000000-0000-0000-0000-000000000000}"/>
          </ac:spMkLst>
        </pc:spChg>
        <pc:spChg chg="add mod">
          <ac:chgData name="vijay kumar" userId="0eb738f014aa4543" providerId="LiveId" clId="{B4DB2928-3EFF-4507-ABD0-3894F091460A}" dt="2020-04-29T10:17:07.851" v="4720" actId="571"/>
          <ac:spMkLst>
            <pc:docMk/>
            <pc:sldMk cId="0" sldId="285"/>
            <ac:spMk id="159" creationId="{48E2E719-6F74-415F-A45C-7A7EDCF63D51}"/>
          </ac:spMkLst>
        </pc:spChg>
        <pc:spChg chg="mod topLvl">
          <ac:chgData name="vijay kumar" userId="0eb738f014aa4543" providerId="LiveId" clId="{B4DB2928-3EFF-4507-ABD0-3894F091460A}" dt="2020-04-29T09:53:03.382" v="4570" actId="164"/>
          <ac:spMkLst>
            <pc:docMk/>
            <pc:sldMk cId="0" sldId="285"/>
            <ac:spMk id="6150" creationId="{00000000-0000-0000-0000-000000000000}"/>
          </ac:spMkLst>
        </pc:spChg>
        <pc:spChg chg="mod topLvl">
          <ac:chgData name="vijay kumar" userId="0eb738f014aa4543" providerId="LiveId" clId="{B4DB2928-3EFF-4507-ABD0-3894F091460A}" dt="2020-04-29T09:53:03.382" v="4570" actId="164"/>
          <ac:spMkLst>
            <pc:docMk/>
            <pc:sldMk cId="0" sldId="285"/>
            <ac:spMk id="6152" creationId="{00000000-0000-0000-0000-000000000000}"/>
          </ac:spMkLst>
        </pc:spChg>
        <pc:spChg chg="mod topLvl">
          <ac:chgData name="vijay kumar" userId="0eb738f014aa4543" providerId="LiveId" clId="{B4DB2928-3EFF-4507-ABD0-3894F091460A}" dt="2020-04-29T09:53:03.382" v="4570" actId="164"/>
          <ac:spMkLst>
            <pc:docMk/>
            <pc:sldMk cId="0" sldId="285"/>
            <ac:spMk id="6154" creationId="{00000000-0000-0000-0000-000000000000}"/>
          </ac:spMkLst>
        </pc:spChg>
        <pc:spChg chg="mod topLvl">
          <ac:chgData name="vijay kumar" userId="0eb738f014aa4543" providerId="LiveId" clId="{B4DB2928-3EFF-4507-ABD0-3894F091460A}" dt="2020-04-29T09:53:03.382" v="4570" actId="164"/>
          <ac:spMkLst>
            <pc:docMk/>
            <pc:sldMk cId="0" sldId="285"/>
            <ac:spMk id="6156" creationId="{00000000-0000-0000-0000-000000000000}"/>
          </ac:spMkLst>
        </pc:spChg>
        <pc:spChg chg="mod topLvl">
          <ac:chgData name="vijay kumar" userId="0eb738f014aa4543" providerId="LiveId" clId="{B4DB2928-3EFF-4507-ABD0-3894F091460A}" dt="2020-04-29T09:53:03.382" v="4570" actId="164"/>
          <ac:spMkLst>
            <pc:docMk/>
            <pc:sldMk cId="0" sldId="285"/>
            <ac:spMk id="6158" creationId="{00000000-0000-0000-0000-000000000000}"/>
          </ac:spMkLst>
        </pc:spChg>
        <pc:spChg chg="mod topLvl">
          <ac:chgData name="vijay kumar" userId="0eb738f014aa4543" providerId="LiveId" clId="{B4DB2928-3EFF-4507-ABD0-3894F091460A}" dt="2020-04-29T09:53:03.382" v="4570" actId="164"/>
          <ac:spMkLst>
            <pc:docMk/>
            <pc:sldMk cId="0" sldId="285"/>
            <ac:spMk id="6159" creationId="{00000000-0000-0000-0000-000000000000}"/>
          </ac:spMkLst>
        </pc:spChg>
        <pc:spChg chg="mod topLvl">
          <ac:chgData name="vijay kumar" userId="0eb738f014aa4543" providerId="LiveId" clId="{B4DB2928-3EFF-4507-ABD0-3894F091460A}" dt="2020-04-29T09:53:03.382" v="4570" actId="164"/>
          <ac:spMkLst>
            <pc:docMk/>
            <pc:sldMk cId="0" sldId="285"/>
            <ac:spMk id="6160" creationId="{00000000-0000-0000-0000-000000000000}"/>
          </ac:spMkLst>
        </pc:spChg>
        <pc:spChg chg="mod topLvl">
          <ac:chgData name="vijay kumar" userId="0eb738f014aa4543" providerId="LiveId" clId="{B4DB2928-3EFF-4507-ABD0-3894F091460A}" dt="2020-04-29T09:53:03.382" v="4570" actId="164"/>
          <ac:spMkLst>
            <pc:docMk/>
            <pc:sldMk cId="0" sldId="285"/>
            <ac:spMk id="6161" creationId="{00000000-0000-0000-0000-000000000000}"/>
          </ac:spMkLst>
        </pc:spChg>
        <pc:spChg chg="mod topLvl">
          <ac:chgData name="vijay kumar" userId="0eb738f014aa4543" providerId="LiveId" clId="{B4DB2928-3EFF-4507-ABD0-3894F091460A}" dt="2020-04-29T09:53:03.382" v="4570" actId="164"/>
          <ac:spMkLst>
            <pc:docMk/>
            <pc:sldMk cId="0" sldId="285"/>
            <ac:spMk id="6162" creationId="{00000000-0000-0000-0000-000000000000}"/>
          </ac:spMkLst>
        </pc:spChg>
        <pc:spChg chg="mod topLvl">
          <ac:chgData name="vijay kumar" userId="0eb738f014aa4543" providerId="LiveId" clId="{B4DB2928-3EFF-4507-ABD0-3894F091460A}" dt="2020-04-29T09:53:03.382" v="4570" actId="164"/>
          <ac:spMkLst>
            <pc:docMk/>
            <pc:sldMk cId="0" sldId="285"/>
            <ac:spMk id="6163" creationId="{00000000-0000-0000-0000-000000000000}"/>
          </ac:spMkLst>
        </pc:spChg>
        <pc:spChg chg="mod topLvl">
          <ac:chgData name="vijay kumar" userId="0eb738f014aa4543" providerId="LiveId" clId="{B4DB2928-3EFF-4507-ABD0-3894F091460A}" dt="2020-04-29T09:53:03.382" v="4570" actId="164"/>
          <ac:spMkLst>
            <pc:docMk/>
            <pc:sldMk cId="0" sldId="285"/>
            <ac:spMk id="6164" creationId="{00000000-0000-0000-0000-000000000000}"/>
          </ac:spMkLst>
        </pc:spChg>
        <pc:spChg chg="mod topLvl">
          <ac:chgData name="vijay kumar" userId="0eb738f014aa4543" providerId="LiveId" clId="{B4DB2928-3EFF-4507-ABD0-3894F091460A}" dt="2020-04-29T09:53:03.382" v="4570" actId="164"/>
          <ac:spMkLst>
            <pc:docMk/>
            <pc:sldMk cId="0" sldId="285"/>
            <ac:spMk id="6165" creationId="{00000000-0000-0000-0000-000000000000}"/>
          </ac:spMkLst>
        </pc:spChg>
        <pc:spChg chg="mod topLvl">
          <ac:chgData name="vijay kumar" userId="0eb738f014aa4543" providerId="LiveId" clId="{B4DB2928-3EFF-4507-ABD0-3894F091460A}" dt="2020-04-29T09:53:03.382" v="4570" actId="164"/>
          <ac:spMkLst>
            <pc:docMk/>
            <pc:sldMk cId="0" sldId="285"/>
            <ac:spMk id="6166" creationId="{00000000-0000-0000-0000-000000000000}"/>
          </ac:spMkLst>
        </pc:spChg>
        <pc:spChg chg="mod topLvl">
          <ac:chgData name="vijay kumar" userId="0eb738f014aa4543" providerId="LiveId" clId="{B4DB2928-3EFF-4507-ABD0-3894F091460A}" dt="2020-04-29T09:53:03.382" v="4570" actId="164"/>
          <ac:spMkLst>
            <pc:docMk/>
            <pc:sldMk cId="0" sldId="285"/>
            <ac:spMk id="6167" creationId="{00000000-0000-0000-0000-000000000000}"/>
          </ac:spMkLst>
        </pc:spChg>
        <pc:spChg chg="mod topLvl">
          <ac:chgData name="vijay kumar" userId="0eb738f014aa4543" providerId="LiveId" clId="{B4DB2928-3EFF-4507-ABD0-3894F091460A}" dt="2020-04-29T09:53:03.382" v="4570" actId="164"/>
          <ac:spMkLst>
            <pc:docMk/>
            <pc:sldMk cId="0" sldId="285"/>
            <ac:spMk id="6168" creationId="{00000000-0000-0000-0000-000000000000}"/>
          </ac:spMkLst>
        </pc:spChg>
        <pc:grpChg chg="add mod">
          <ac:chgData name="vijay kumar" userId="0eb738f014aa4543" providerId="LiveId" clId="{B4DB2928-3EFF-4507-ABD0-3894F091460A}" dt="2020-05-24T14:25:51.634" v="15151" actId="1036"/>
          <ac:grpSpMkLst>
            <pc:docMk/>
            <pc:sldMk cId="0" sldId="285"/>
            <ac:grpSpMk id="2" creationId="{C31E4DC6-5586-431F-889B-42F95543FC94}"/>
          </ac:grpSpMkLst>
        </pc:grpChg>
        <pc:grpChg chg="add mod">
          <ac:chgData name="vijay kumar" userId="0eb738f014aa4543" providerId="LiveId" clId="{B4DB2928-3EFF-4507-ABD0-3894F091460A}" dt="2020-05-24T14:25:51.634" v="15151" actId="1036"/>
          <ac:grpSpMkLst>
            <pc:docMk/>
            <pc:sldMk cId="0" sldId="285"/>
            <ac:grpSpMk id="3" creationId="{6616E53D-547D-478D-8754-A6328F9B2873}"/>
          </ac:grpSpMkLst>
        </pc:grpChg>
        <pc:grpChg chg="del mod">
          <ac:chgData name="vijay kumar" userId="0eb738f014aa4543" providerId="LiveId" clId="{B4DB2928-3EFF-4507-ABD0-3894F091460A}" dt="2020-04-29T09:49:41.816" v="4568" actId="165"/>
          <ac:grpSpMkLst>
            <pc:docMk/>
            <pc:sldMk cId="0" sldId="285"/>
            <ac:grpSpMk id="3" creationId="{89C26361-F2F8-4E71-9B0E-617BDD7F715F}"/>
          </ac:grpSpMkLst>
        </pc:grpChg>
        <pc:grpChg chg="add mod">
          <ac:chgData name="vijay kumar" userId="0eb738f014aa4543" providerId="LiveId" clId="{B4DB2928-3EFF-4507-ABD0-3894F091460A}" dt="2020-05-24T14:25:51.634" v="15151" actId="1036"/>
          <ac:grpSpMkLst>
            <pc:docMk/>
            <pc:sldMk cId="0" sldId="285"/>
            <ac:grpSpMk id="4" creationId="{6F42CE82-A740-4EE9-8FB1-CAAFC2B944D1}"/>
          </ac:grpSpMkLst>
        </pc:grpChg>
        <pc:grpChg chg="del mod">
          <ac:chgData name="vijay kumar" userId="0eb738f014aa4543" providerId="LiveId" clId="{B4DB2928-3EFF-4507-ABD0-3894F091460A}" dt="2020-04-29T08:24:37.421" v="3359" actId="165"/>
          <ac:grpSpMkLst>
            <pc:docMk/>
            <pc:sldMk cId="0" sldId="285"/>
            <ac:grpSpMk id="4" creationId="{6F59249A-B70D-4A03-814A-777B86797A43}"/>
          </ac:grpSpMkLst>
        </pc:grpChg>
        <pc:grpChg chg="del mod">
          <ac:chgData name="vijay kumar" userId="0eb738f014aa4543" providerId="LiveId" clId="{B4DB2928-3EFF-4507-ABD0-3894F091460A}" dt="2020-04-29T08:24:44.811" v="3361" actId="165"/>
          <ac:grpSpMkLst>
            <pc:docMk/>
            <pc:sldMk cId="0" sldId="285"/>
            <ac:grpSpMk id="30" creationId="{91788E65-E473-4972-9E3C-8D73BA4E4660}"/>
          </ac:grpSpMkLst>
        </pc:grpChg>
        <pc:grpChg chg="add del mod">
          <ac:chgData name="vijay kumar" userId="0eb738f014aa4543" providerId="LiveId" clId="{B4DB2928-3EFF-4507-ABD0-3894F091460A}" dt="2020-04-29T09:40:56.890" v="4319" actId="165"/>
          <ac:grpSpMkLst>
            <pc:docMk/>
            <pc:sldMk cId="0" sldId="285"/>
            <ac:grpSpMk id="82" creationId="{C50307E4-DB1B-42CE-B876-CAC4A714CE34}"/>
          </ac:grpSpMkLst>
        </pc:grpChg>
        <pc:grpChg chg="add del mod">
          <ac:chgData name="vijay kumar" userId="0eb738f014aa4543" providerId="LiveId" clId="{B4DB2928-3EFF-4507-ABD0-3894F091460A}" dt="2020-04-29T08:34:59.954" v="3527" actId="165"/>
          <ac:grpSpMkLst>
            <pc:docMk/>
            <pc:sldMk cId="0" sldId="285"/>
            <ac:grpSpMk id="101" creationId="{2339EAC0-05CF-4825-BBC9-09CD7DB9FA49}"/>
          </ac:grpSpMkLst>
        </pc:grpChg>
        <pc:grpChg chg="add del mod">
          <ac:chgData name="vijay kumar" userId="0eb738f014aa4543" providerId="LiveId" clId="{B4DB2928-3EFF-4507-ABD0-3894F091460A}" dt="2020-04-29T08:51:53.998" v="3530" actId="165"/>
          <ac:grpSpMkLst>
            <pc:docMk/>
            <pc:sldMk cId="0" sldId="285"/>
            <ac:grpSpMk id="102" creationId="{BDBA803C-0F68-4025-81F9-05B3D7F76826}"/>
          </ac:grpSpMkLst>
        </pc:grpChg>
        <pc:grpChg chg="add del mod">
          <ac:chgData name="vijay kumar" userId="0eb738f014aa4543" providerId="LiveId" clId="{B4DB2928-3EFF-4507-ABD0-3894F091460A}" dt="2020-04-29T09:30:17.139" v="3660" actId="165"/>
          <ac:grpSpMkLst>
            <pc:docMk/>
            <pc:sldMk cId="0" sldId="285"/>
            <ac:grpSpMk id="123" creationId="{7462CD77-54A3-4F9D-A53C-1BF6D6C3836B}"/>
          </ac:grpSpMkLst>
        </pc:grpChg>
        <pc:grpChg chg="add mod">
          <ac:chgData name="vijay kumar" userId="0eb738f014aa4543" providerId="LiveId" clId="{B4DB2928-3EFF-4507-ABD0-3894F091460A}" dt="2020-05-24T14:25:51.634" v="15151" actId="1036"/>
          <ac:grpSpMkLst>
            <pc:docMk/>
            <pc:sldMk cId="0" sldId="285"/>
            <ac:grpSpMk id="124" creationId="{B036F89E-B2F5-42C0-85B8-3D51ADD87D14}"/>
          </ac:grpSpMkLst>
        </pc:grpChg>
        <pc:grpChg chg="add mod topLvl">
          <ac:chgData name="vijay kumar" userId="0eb738f014aa4543" providerId="LiveId" clId="{B4DB2928-3EFF-4507-ABD0-3894F091460A}" dt="2020-05-24T14:25:51.634" v="15151" actId="1036"/>
          <ac:grpSpMkLst>
            <pc:docMk/>
            <pc:sldMk cId="0" sldId="285"/>
            <ac:grpSpMk id="125" creationId="{08A33C7F-9425-448E-A1F3-2F031840FA76}"/>
          </ac:grpSpMkLst>
        </pc:grpChg>
        <pc:grpChg chg="add mod topLvl">
          <ac:chgData name="vijay kumar" userId="0eb738f014aa4543" providerId="LiveId" clId="{B4DB2928-3EFF-4507-ABD0-3894F091460A}" dt="2020-05-24T14:25:51.634" v="15151" actId="1036"/>
          <ac:grpSpMkLst>
            <pc:docMk/>
            <pc:sldMk cId="0" sldId="285"/>
            <ac:grpSpMk id="126" creationId="{63A9E844-22AE-46DC-90C7-C5F734906FBE}"/>
          </ac:grpSpMkLst>
        </pc:grpChg>
        <pc:grpChg chg="add mod topLvl">
          <ac:chgData name="vijay kumar" userId="0eb738f014aa4543" providerId="LiveId" clId="{B4DB2928-3EFF-4507-ABD0-3894F091460A}" dt="2020-05-24T14:25:51.634" v="15151" actId="1036"/>
          <ac:grpSpMkLst>
            <pc:docMk/>
            <pc:sldMk cId="0" sldId="285"/>
            <ac:grpSpMk id="127" creationId="{83B31E63-F12D-4FD1-8945-9234155FFAFE}"/>
          </ac:grpSpMkLst>
        </pc:grpChg>
        <pc:grpChg chg="add mod">
          <ac:chgData name="vijay kumar" userId="0eb738f014aa4543" providerId="LiveId" clId="{B4DB2928-3EFF-4507-ABD0-3894F091460A}" dt="2020-04-29T10:17:07.851" v="4720" actId="571"/>
          <ac:grpSpMkLst>
            <pc:docMk/>
            <pc:sldMk cId="0" sldId="285"/>
            <ac:grpSpMk id="131" creationId="{2224F224-A138-4452-873D-59D86E39458E}"/>
          </ac:grpSpMkLst>
        </pc:grpChg>
        <pc:grpChg chg="mod">
          <ac:chgData name="vijay kumar" userId="0eb738f014aa4543" providerId="LiveId" clId="{B4DB2928-3EFF-4507-ABD0-3894F091460A}" dt="2020-04-29T10:17:07.851" v="4720" actId="571"/>
          <ac:grpSpMkLst>
            <pc:docMk/>
            <pc:sldMk cId="0" sldId="285"/>
            <ac:grpSpMk id="145" creationId="{D5E493EF-D082-4FD0-931D-0FEB92F07ED3}"/>
          </ac:grpSpMkLst>
        </pc:grpChg>
        <pc:grpChg chg="mod">
          <ac:chgData name="vijay kumar" userId="0eb738f014aa4543" providerId="LiveId" clId="{B4DB2928-3EFF-4507-ABD0-3894F091460A}" dt="2020-04-29T10:17:07.851" v="4720" actId="571"/>
          <ac:grpSpMkLst>
            <pc:docMk/>
            <pc:sldMk cId="0" sldId="285"/>
            <ac:grpSpMk id="146" creationId="{70C8E93C-247C-4F99-A897-EB3C9AC878AD}"/>
          </ac:grpSpMkLst>
        </pc:grpChg>
        <pc:grpChg chg="mod">
          <ac:chgData name="vijay kumar" userId="0eb738f014aa4543" providerId="LiveId" clId="{B4DB2928-3EFF-4507-ABD0-3894F091460A}" dt="2020-04-29T10:17:07.851" v="4720" actId="571"/>
          <ac:grpSpMkLst>
            <pc:docMk/>
            <pc:sldMk cId="0" sldId="285"/>
            <ac:grpSpMk id="147" creationId="{F5D18DC4-935A-4181-B016-8A3E31240F84}"/>
          </ac:grpSpMkLst>
        </pc:grpChg>
        <pc:grpChg chg="mod">
          <ac:chgData name="vijay kumar" userId="0eb738f014aa4543" providerId="LiveId" clId="{B4DB2928-3EFF-4507-ABD0-3894F091460A}" dt="2020-04-29T10:17:07.851" v="4720" actId="571"/>
          <ac:grpSpMkLst>
            <pc:docMk/>
            <pc:sldMk cId="0" sldId="285"/>
            <ac:grpSpMk id="148" creationId="{17E7EC2A-69A3-4133-A5B6-930658B80B4A}"/>
          </ac:grpSpMkLst>
        </pc:grpChg>
        <pc:grpChg chg="mod">
          <ac:chgData name="vijay kumar" userId="0eb738f014aa4543" providerId="LiveId" clId="{B4DB2928-3EFF-4507-ABD0-3894F091460A}" dt="2020-04-29T10:17:07.851" v="4720" actId="571"/>
          <ac:grpSpMkLst>
            <pc:docMk/>
            <pc:sldMk cId="0" sldId="285"/>
            <ac:grpSpMk id="155" creationId="{5E592D2F-D3A8-477F-B058-DE2D370162AC}"/>
          </ac:grpSpMkLst>
        </pc:grpChg>
        <pc:grpChg chg="add mod topLvl">
          <ac:chgData name="vijay kumar" userId="0eb738f014aa4543" providerId="LiveId" clId="{B4DB2928-3EFF-4507-ABD0-3894F091460A}" dt="2020-05-24T14:25:51.634" v="15151" actId="1036"/>
          <ac:grpSpMkLst>
            <pc:docMk/>
            <pc:sldMk cId="0" sldId="285"/>
            <ac:grpSpMk id="6144" creationId="{39C6F97A-8894-4631-845F-4DFD30495D5E}"/>
          </ac:grpSpMkLst>
        </pc:grpChg>
        <pc:grpChg chg="add del mod">
          <ac:chgData name="vijay kumar" userId="0eb738f014aa4543" providerId="LiveId" clId="{B4DB2928-3EFF-4507-ABD0-3894F091460A}" dt="2020-05-24T14:25:51.634" v="15151" actId="1036"/>
          <ac:grpSpMkLst>
            <pc:docMk/>
            <pc:sldMk cId="0" sldId="285"/>
            <ac:grpSpMk id="6145" creationId="{C4B08E29-E0C9-4F9E-B5AC-41B1930BDE39}"/>
          </ac:grpSpMkLst>
        </pc:grpChg>
        <pc:grpChg chg="add del mod">
          <ac:chgData name="vijay kumar" userId="0eb738f014aa4543" providerId="LiveId" clId="{B4DB2928-3EFF-4507-ABD0-3894F091460A}" dt="2020-04-29T09:40:48.578" v="4316" actId="165"/>
          <ac:grpSpMkLst>
            <pc:docMk/>
            <pc:sldMk cId="0" sldId="285"/>
            <ac:grpSpMk id="6146" creationId="{83EE87B7-65CE-4033-B928-295B64BC2A27}"/>
          </ac:grpSpMkLst>
        </pc:grpChg>
        <pc:grpChg chg="add mod topLvl">
          <ac:chgData name="vijay kumar" userId="0eb738f014aa4543" providerId="LiveId" clId="{B4DB2928-3EFF-4507-ABD0-3894F091460A}" dt="2020-05-24T14:25:51.634" v="15151" actId="1036"/>
          <ac:grpSpMkLst>
            <pc:docMk/>
            <pc:sldMk cId="0" sldId="285"/>
            <ac:grpSpMk id="6147" creationId="{81B28253-3351-44DF-B808-E33AFD9C1F5F}"/>
          </ac:grpSpMkLst>
        </pc:grpChg>
        <pc:grpChg chg="add mod topLvl">
          <ac:chgData name="vijay kumar" userId="0eb738f014aa4543" providerId="LiveId" clId="{B4DB2928-3EFF-4507-ABD0-3894F091460A}" dt="2020-05-24T14:25:51.634" v="15151" actId="1036"/>
          <ac:grpSpMkLst>
            <pc:docMk/>
            <pc:sldMk cId="0" sldId="285"/>
            <ac:grpSpMk id="6148" creationId="{E33051E4-CDF1-4432-987B-3AAED57DA1A0}"/>
          </ac:grpSpMkLst>
        </pc:grpChg>
        <pc:grpChg chg="add mod topLvl">
          <ac:chgData name="vijay kumar" userId="0eb738f014aa4543" providerId="LiveId" clId="{B4DB2928-3EFF-4507-ABD0-3894F091460A}" dt="2020-05-24T14:25:51.634" v="15151" actId="1036"/>
          <ac:grpSpMkLst>
            <pc:docMk/>
            <pc:sldMk cId="0" sldId="285"/>
            <ac:grpSpMk id="6149" creationId="{FCA71BAD-D444-4BE7-A61E-97C04C5F2F04}"/>
          </ac:grpSpMkLst>
        </pc:grpChg>
        <pc:grpChg chg="add mod topLvl">
          <ac:chgData name="vijay kumar" userId="0eb738f014aa4543" providerId="LiveId" clId="{B4DB2928-3EFF-4507-ABD0-3894F091460A}" dt="2020-05-24T14:25:51.634" v="15151" actId="1036"/>
          <ac:grpSpMkLst>
            <pc:docMk/>
            <pc:sldMk cId="0" sldId="285"/>
            <ac:grpSpMk id="6151" creationId="{8D971540-9964-4687-AB1F-87A2974C5994}"/>
          </ac:grpSpMkLst>
        </pc:grpChg>
        <pc:grpChg chg="add del mod">
          <ac:chgData name="vijay kumar" userId="0eb738f014aa4543" providerId="LiveId" clId="{B4DB2928-3EFF-4507-ABD0-3894F091460A}" dt="2020-04-29T09:56:32.911" v="4587" actId="165"/>
          <ac:grpSpMkLst>
            <pc:docMk/>
            <pc:sldMk cId="0" sldId="285"/>
            <ac:grpSpMk id="6153" creationId="{BAA718E2-07E1-4BB4-937D-CB081CC8857F}"/>
          </ac:grpSpMkLst>
        </pc:grpChg>
        <pc:grpChg chg="add del mod">
          <ac:chgData name="vijay kumar" userId="0eb738f014aa4543" providerId="LiveId" clId="{B4DB2928-3EFF-4507-ABD0-3894F091460A}" dt="2020-05-24T14:22:24.719" v="14973" actId="478"/>
          <ac:grpSpMkLst>
            <pc:docMk/>
            <pc:sldMk cId="0" sldId="285"/>
            <ac:grpSpMk id="6155" creationId="{20BD7959-5336-4F35-BBAD-DB27542958F9}"/>
          </ac:grpSpMkLst>
        </pc:grpChg>
        <pc:grpChg chg="add del mod topLvl">
          <ac:chgData name="vijay kumar" userId="0eb738f014aa4543" providerId="LiveId" clId="{B4DB2928-3EFF-4507-ABD0-3894F091460A}" dt="2020-05-04T16:55:00.295" v="7562" actId="165"/>
          <ac:grpSpMkLst>
            <pc:docMk/>
            <pc:sldMk cId="0" sldId="285"/>
            <ac:grpSpMk id="6157" creationId="{D472024F-CBF4-4D3A-A3B7-5E66925DD884}"/>
          </ac:grpSpMkLst>
        </pc:grpChg>
        <pc:grpChg chg="add mod topLvl">
          <ac:chgData name="vijay kumar" userId="0eb738f014aa4543" providerId="LiveId" clId="{B4DB2928-3EFF-4507-ABD0-3894F091460A}" dt="2020-05-24T14:25:51.634" v="15151" actId="1036"/>
          <ac:grpSpMkLst>
            <pc:docMk/>
            <pc:sldMk cId="0" sldId="285"/>
            <ac:grpSpMk id="6169" creationId="{4EFCAA08-18D1-461F-BB0F-2D1B71FF381E}"/>
          </ac:grpSpMkLst>
        </pc:grpChg>
        <pc:grpChg chg="add del mod">
          <ac:chgData name="vijay kumar" userId="0eb738f014aa4543" providerId="LiveId" clId="{B4DB2928-3EFF-4507-ABD0-3894F091460A}" dt="2020-05-04T16:54:07.723" v="7443" actId="165"/>
          <ac:grpSpMkLst>
            <pc:docMk/>
            <pc:sldMk cId="0" sldId="285"/>
            <ac:grpSpMk id="6170" creationId="{F79C8599-0345-48B2-9C47-C43B8DB10ACE}"/>
          </ac:grpSpMkLst>
        </pc:grpChg>
        <pc:picChg chg="del mod">
          <ac:chgData name="vijay kumar" userId="0eb738f014aa4543" providerId="LiveId" clId="{B4DB2928-3EFF-4507-ABD0-3894F091460A}" dt="2020-04-29T08:24:42.433" v="3360" actId="338"/>
          <ac:picMkLst>
            <pc:docMk/>
            <pc:sldMk cId="0" sldId="285"/>
            <ac:picMk id="2" creationId="{EBB95933-E70E-4193-A9AB-CEBCD7D561BA}"/>
          </ac:picMkLst>
        </pc:picChg>
        <pc:picChg chg="del mod">
          <ac:chgData name="vijay kumar" userId="0eb738f014aa4543" providerId="LiveId" clId="{B4DB2928-3EFF-4507-ABD0-3894F091460A}" dt="2020-04-29T08:24:33.218" v="3358" actId="338"/>
          <ac:picMkLst>
            <pc:docMk/>
            <pc:sldMk cId="0" sldId="285"/>
            <ac:picMk id="107" creationId="{03553850-A40A-40EF-BDB8-F5B4B15B328A}"/>
          </ac:picMkLst>
        </pc:picChg>
      </pc:sldChg>
      <pc:sldChg chg="addSp delSp modSp add mod ord">
        <pc:chgData name="vijay kumar" userId="0eb738f014aa4543" providerId="LiveId" clId="{B4DB2928-3EFF-4507-ABD0-3894F091460A}" dt="2020-05-24T14:30:03.844" v="15193" actId="1038"/>
        <pc:sldMkLst>
          <pc:docMk/>
          <pc:sldMk cId="2361193530" sldId="352"/>
        </pc:sldMkLst>
        <pc:spChg chg="del">
          <ac:chgData name="vijay kumar" userId="0eb738f014aa4543" providerId="LiveId" clId="{B4DB2928-3EFF-4507-ABD0-3894F091460A}" dt="2020-05-04T11:37:48.247" v="7439" actId="478"/>
          <ac:spMkLst>
            <pc:docMk/>
            <pc:sldMk cId="2361193530" sldId="352"/>
            <ac:spMk id="2" creationId="{57337D0B-DE50-4200-A363-12BBAFC52FAE}"/>
          </ac:spMkLst>
        </pc:spChg>
        <pc:spChg chg="add mod">
          <ac:chgData name="vijay kumar" userId="0eb738f014aa4543" providerId="LiveId" clId="{B4DB2928-3EFF-4507-ABD0-3894F091460A}" dt="2020-05-24T14:30:03.844" v="15193" actId="1038"/>
          <ac:spMkLst>
            <pc:docMk/>
            <pc:sldMk cId="2361193530" sldId="352"/>
            <ac:spMk id="15" creationId="{F6744776-F5AF-4DD2-985B-26AAFB44076B}"/>
          </ac:spMkLst>
        </pc:spChg>
        <pc:spChg chg="add del mod">
          <ac:chgData name="vijay kumar" userId="0eb738f014aa4543" providerId="LiveId" clId="{B4DB2928-3EFF-4507-ABD0-3894F091460A}" dt="2020-05-24T14:26:18.410" v="15155" actId="478"/>
          <ac:spMkLst>
            <pc:docMk/>
            <pc:sldMk cId="2361193530" sldId="352"/>
            <ac:spMk id="16" creationId="{46B4EAAB-1861-4077-AD49-AE55A41C2ABA}"/>
          </ac:spMkLst>
        </pc:spChg>
        <pc:spChg chg="mod">
          <ac:chgData name="vijay kumar" userId="0eb738f014aa4543" providerId="LiveId" clId="{B4DB2928-3EFF-4507-ABD0-3894F091460A}" dt="2020-05-04T17:43:35.839" v="9382" actId="164"/>
          <ac:spMkLst>
            <pc:docMk/>
            <pc:sldMk cId="2361193530" sldId="352"/>
            <ac:spMk id="46" creationId="{5910E60E-BE15-414E-BC51-89BF1FF9C26E}"/>
          </ac:spMkLst>
        </pc:spChg>
        <pc:spChg chg="mod">
          <ac:chgData name="vijay kumar" userId="0eb738f014aa4543" providerId="LiveId" clId="{B4DB2928-3EFF-4507-ABD0-3894F091460A}" dt="2020-05-04T17:43:35.839" v="9382" actId="164"/>
          <ac:spMkLst>
            <pc:docMk/>
            <pc:sldMk cId="2361193530" sldId="352"/>
            <ac:spMk id="47" creationId="{4B93E268-9FF1-4FDB-BA47-CB814DA631DF}"/>
          </ac:spMkLst>
        </pc:spChg>
        <pc:spChg chg="mod">
          <ac:chgData name="vijay kumar" userId="0eb738f014aa4543" providerId="LiveId" clId="{B4DB2928-3EFF-4507-ABD0-3894F091460A}" dt="2020-05-04T17:43:35.839" v="9382" actId="164"/>
          <ac:spMkLst>
            <pc:docMk/>
            <pc:sldMk cId="2361193530" sldId="352"/>
            <ac:spMk id="48" creationId="{89F1290E-9056-4BF3-BB6F-D7EDB3E7AD8F}"/>
          </ac:spMkLst>
        </pc:spChg>
        <pc:spChg chg="mod">
          <ac:chgData name="vijay kumar" userId="0eb738f014aa4543" providerId="LiveId" clId="{B4DB2928-3EFF-4507-ABD0-3894F091460A}" dt="2020-05-04T17:43:35.839" v="9382" actId="164"/>
          <ac:spMkLst>
            <pc:docMk/>
            <pc:sldMk cId="2361193530" sldId="352"/>
            <ac:spMk id="49" creationId="{055BE9AF-382A-4443-9ADF-2462E2DA1344}"/>
          </ac:spMkLst>
        </pc:spChg>
        <pc:grpChg chg="add mod">
          <ac:chgData name="vijay kumar" userId="0eb738f014aa4543" providerId="LiveId" clId="{B4DB2928-3EFF-4507-ABD0-3894F091460A}" dt="2020-05-04T17:43:40.447" v="9411" actId="1035"/>
          <ac:grpSpMkLst>
            <pc:docMk/>
            <pc:sldMk cId="2361193530" sldId="352"/>
            <ac:grpSpMk id="3" creationId="{84392485-1A4B-4CCE-B2D0-A0F67F143354}"/>
          </ac:grpSpMkLst>
        </pc:grpChg>
        <pc:picChg chg="mod">
          <ac:chgData name="vijay kumar" userId="0eb738f014aa4543" providerId="LiveId" clId="{B4DB2928-3EFF-4507-ABD0-3894F091460A}" dt="2020-05-04T17:43:35.839" v="9382" actId="164"/>
          <ac:picMkLst>
            <pc:docMk/>
            <pc:sldMk cId="2361193530" sldId="352"/>
            <ac:picMk id="24" creationId="{99BD8C92-7E31-474E-AA7E-43DC35F8AC83}"/>
          </ac:picMkLst>
        </pc:picChg>
        <pc:picChg chg="mod">
          <ac:chgData name="vijay kumar" userId="0eb738f014aa4543" providerId="LiveId" clId="{B4DB2928-3EFF-4507-ABD0-3894F091460A}" dt="2020-05-04T17:43:35.839" v="9382" actId="164"/>
          <ac:picMkLst>
            <pc:docMk/>
            <pc:sldMk cId="2361193530" sldId="352"/>
            <ac:picMk id="28" creationId="{B96FCC6E-0FBA-4B26-B4A1-5B8DCE7F8303}"/>
          </ac:picMkLst>
        </pc:picChg>
        <pc:picChg chg="mod">
          <ac:chgData name="vijay kumar" userId="0eb738f014aa4543" providerId="LiveId" clId="{B4DB2928-3EFF-4507-ABD0-3894F091460A}" dt="2020-05-04T17:43:35.839" v="9382" actId="164"/>
          <ac:picMkLst>
            <pc:docMk/>
            <pc:sldMk cId="2361193530" sldId="352"/>
            <ac:picMk id="37" creationId="{AE9EEBCD-831A-41FA-8D53-D90BB245AAAF}"/>
          </ac:picMkLst>
        </pc:picChg>
        <pc:picChg chg="mod">
          <ac:chgData name="vijay kumar" userId="0eb738f014aa4543" providerId="LiveId" clId="{B4DB2928-3EFF-4507-ABD0-3894F091460A}" dt="2020-05-04T17:43:35.839" v="9382" actId="164"/>
          <ac:picMkLst>
            <pc:docMk/>
            <pc:sldMk cId="2361193530" sldId="352"/>
            <ac:picMk id="39" creationId="{E2814623-E8EB-4B35-AAC9-4E5A0C0B797D}"/>
          </ac:picMkLst>
        </pc:picChg>
        <pc:picChg chg="mod">
          <ac:chgData name="vijay kumar" userId="0eb738f014aa4543" providerId="LiveId" clId="{B4DB2928-3EFF-4507-ABD0-3894F091460A}" dt="2020-05-04T17:43:35.839" v="9382" actId="164"/>
          <ac:picMkLst>
            <pc:docMk/>
            <pc:sldMk cId="2361193530" sldId="352"/>
            <ac:picMk id="41" creationId="{70D9E0A2-4236-4B96-A219-57CCC8B0E08E}"/>
          </ac:picMkLst>
        </pc:picChg>
        <pc:picChg chg="mod">
          <ac:chgData name="vijay kumar" userId="0eb738f014aa4543" providerId="LiveId" clId="{B4DB2928-3EFF-4507-ABD0-3894F091460A}" dt="2020-05-04T17:43:35.839" v="9382" actId="164"/>
          <ac:picMkLst>
            <pc:docMk/>
            <pc:sldMk cId="2361193530" sldId="352"/>
            <ac:picMk id="43" creationId="{C6F68931-ADFE-4ACA-B0EA-67AE81048A64}"/>
          </ac:picMkLst>
        </pc:picChg>
        <pc:picChg chg="mod">
          <ac:chgData name="vijay kumar" userId="0eb738f014aa4543" providerId="LiveId" clId="{B4DB2928-3EFF-4507-ABD0-3894F091460A}" dt="2020-05-04T17:43:35.839" v="9382" actId="164"/>
          <ac:picMkLst>
            <pc:docMk/>
            <pc:sldMk cId="2361193530" sldId="352"/>
            <ac:picMk id="45" creationId="{668666E5-3079-419A-A5FD-633962227803}"/>
          </ac:picMkLst>
        </pc:picChg>
        <pc:picChg chg="mod">
          <ac:chgData name="vijay kumar" userId="0eb738f014aa4543" providerId="LiveId" clId="{B4DB2928-3EFF-4507-ABD0-3894F091460A}" dt="2020-05-04T17:43:35.839" v="9382" actId="164"/>
          <ac:picMkLst>
            <pc:docMk/>
            <pc:sldMk cId="2361193530" sldId="352"/>
            <ac:picMk id="53" creationId="{2A0D09E6-B994-4935-AFD6-680B006E8655}"/>
          </ac:picMkLst>
        </pc:picChg>
      </pc:sldChg>
      <pc:sldChg chg="modSp add del mod">
        <pc:chgData name="vijay kumar" userId="0eb738f014aa4543" providerId="LiveId" clId="{B4DB2928-3EFF-4507-ABD0-3894F091460A}" dt="2020-05-07T11:05:16.507" v="12721" actId="47"/>
        <pc:sldMkLst>
          <pc:docMk/>
          <pc:sldMk cId="2475799442" sldId="353"/>
        </pc:sldMkLst>
        <pc:spChg chg="mod">
          <ac:chgData name="vijay kumar" userId="0eb738f014aa4543" providerId="LiveId" clId="{B4DB2928-3EFF-4507-ABD0-3894F091460A}" dt="2020-05-04T11:35:52.009" v="7421" actId="20577"/>
          <ac:spMkLst>
            <pc:docMk/>
            <pc:sldMk cId="2475799442" sldId="353"/>
            <ac:spMk id="2" creationId="{1BB80A21-2C38-41C7-ABEF-FC6C99C64F51}"/>
          </ac:spMkLst>
        </pc:spChg>
        <pc:spChg chg="mod">
          <ac:chgData name="vijay kumar" userId="0eb738f014aa4543" providerId="LiveId" clId="{B4DB2928-3EFF-4507-ABD0-3894F091460A}" dt="2020-04-29T12:49:39.477" v="4812" actId="20577"/>
          <ac:spMkLst>
            <pc:docMk/>
            <pc:sldMk cId="2475799442" sldId="353"/>
            <ac:spMk id="3" creationId="{94FF9A33-1407-44DC-B989-98EA07D3A0B2}"/>
          </ac:spMkLst>
        </pc:spChg>
      </pc:sldChg>
      <pc:sldChg chg="addSp delSp modSp new del mod ord">
        <pc:chgData name="vijay kumar" userId="0eb738f014aa4543" providerId="LiveId" clId="{B4DB2928-3EFF-4507-ABD0-3894F091460A}" dt="2020-04-28T09:41:19.534" v="3352" actId="2696"/>
        <pc:sldMkLst>
          <pc:docMk/>
          <pc:sldMk cId="2578547695" sldId="354"/>
        </pc:sldMkLst>
        <pc:spChg chg="add mod">
          <ac:chgData name="vijay kumar" userId="0eb738f014aa4543" providerId="LiveId" clId="{B4DB2928-3EFF-4507-ABD0-3894F091460A}" dt="2020-04-27T17:46:43.359" v="48" actId="1076"/>
          <ac:spMkLst>
            <pc:docMk/>
            <pc:sldMk cId="2578547695" sldId="354"/>
            <ac:spMk id="2" creationId="{4DB64DC6-E2C4-4A32-8463-E5A924F0D060}"/>
          </ac:spMkLst>
        </pc:spChg>
        <pc:spChg chg="add mod">
          <ac:chgData name="vijay kumar" userId="0eb738f014aa4543" providerId="LiveId" clId="{B4DB2928-3EFF-4507-ABD0-3894F091460A}" dt="2020-04-27T17:48:25.814" v="101" actId="1076"/>
          <ac:spMkLst>
            <pc:docMk/>
            <pc:sldMk cId="2578547695" sldId="354"/>
            <ac:spMk id="317" creationId="{55205C30-5381-4C4F-9D9C-CC8B2D9B5B8C}"/>
          </ac:spMkLst>
        </pc:spChg>
        <pc:spChg chg="add mod">
          <ac:chgData name="vijay kumar" userId="0eb738f014aa4543" providerId="LiveId" clId="{B4DB2928-3EFF-4507-ABD0-3894F091460A}" dt="2020-04-27T17:48:34.745" v="108" actId="20577"/>
          <ac:spMkLst>
            <pc:docMk/>
            <pc:sldMk cId="2578547695" sldId="354"/>
            <ac:spMk id="418" creationId="{6CD737D6-62AC-435C-928B-5EDF74A83D2C}"/>
          </ac:spMkLst>
        </pc:spChg>
        <pc:grpChg chg="add mod">
          <ac:chgData name="vijay kumar" userId="0eb738f014aa4543" providerId="LiveId" clId="{B4DB2928-3EFF-4507-ABD0-3894F091460A}" dt="2020-04-27T17:46:31.721" v="38" actId="1038"/>
          <ac:grpSpMkLst>
            <pc:docMk/>
            <pc:sldMk cId="2578547695" sldId="354"/>
            <ac:grpSpMk id="3" creationId="{779C9E99-C6F0-4591-9EAB-D30DE3D01C30}"/>
          </ac:grpSpMkLst>
        </pc:grpChg>
        <pc:grpChg chg="add mod">
          <ac:chgData name="vijay kumar" userId="0eb738f014aa4543" providerId="LiveId" clId="{B4DB2928-3EFF-4507-ABD0-3894F091460A}" dt="2020-04-27T17:46:31.721" v="38" actId="1038"/>
          <ac:grpSpMkLst>
            <pc:docMk/>
            <pc:sldMk cId="2578547695" sldId="354"/>
            <ac:grpSpMk id="39" creationId="{FB8B5257-CD59-4FE7-9DD5-EBB390E22BDD}"/>
          </ac:grpSpMkLst>
        </pc:grpChg>
        <pc:grpChg chg="add mod">
          <ac:chgData name="vijay kumar" userId="0eb738f014aa4543" providerId="LiveId" clId="{B4DB2928-3EFF-4507-ABD0-3894F091460A}" dt="2020-04-27T17:46:31.721" v="38" actId="1038"/>
          <ac:grpSpMkLst>
            <pc:docMk/>
            <pc:sldMk cId="2578547695" sldId="354"/>
            <ac:grpSpMk id="75" creationId="{A56E733C-DC35-4F90-B757-7704ACE658CD}"/>
          </ac:grpSpMkLst>
        </pc:grpChg>
        <pc:grpChg chg="add mod">
          <ac:chgData name="vijay kumar" userId="0eb738f014aa4543" providerId="LiveId" clId="{B4DB2928-3EFF-4507-ABD0-3894F091460A}" dt="2020-04-27T17:46:36.103" v="47" actId="1037"/>
          <ac:grpSpMkLst>
            <pc:docMk/>
            <pc:sldMk cId="2578547695" sldId="354"/>
            <ac:grpSpMk id="116" creationId="{CFD0B8C3-D779-4547-9773-E5D4F203264C}"/>
          </ac:grpSpMkLst>
        </pc:grpChg>
        <pc:grpChg chg="add mod topLvl">
          <ac:chgData name="vijay kumar" userId="0eb738f014aa4543" providerId="LiveId" clId="{B4DB2928-3EFF-4507-ABD0-3894F091460A}" dt="2020-04-27T17:54:08.530" v="370" actId="165"/>
          <ac:grpSpMkLst>
            <pc:docMk/>
            <pc:sldMk cId="2578547695" sldId="354"/>
            <ac:grpSpMk id="318" creationId="{6DE80A7F-F5E3-426A-8967-2C5D55F62EBE}"/>
          </ac:grpSpMkLst>
        </pc:grpChg>
        <pc:grpChg chg="add mod topLvl">
          <ac:chgData name="vijay kumar" userId="0eb738f014aa4543" providerId="LiveId" clId="{B4DB2928-3EFF-4507-ABD0-3894F091460A}" dt="2020-04-27T17:54:18.035" v="371" actId="164"/>
          <ac:grpSpMkLst>
            <pc:docMk/>
            <pc:sldMk cId="2578547695" sldId="354"/>
            <ac:grpSpMk id="374" creationId="{7EA41657-E309-4857-8691-757C1ADDCEF1}"/>
          </ac:grpSpMkLst>
        </pc:grpChg>
        <pc:grpChg chg="add del mod">
          <ac:chgData name="vijay kumar" userId="0eb738f014aa4543" providerId="LiveId" clId="{B4DB2928-3EFF-4507-ABD0-3894F091460A}" dt="2020-04-27T17:54:08.530" v="370" actId="165"/>
          <ac:grpSpMkLst>
            <pc:docMk/>
            <pc:sldMk cId="2578547695" sldId="354"/>
            <ac:grpSpMk id="419" creationId="{1EEB49BB-12FA-44E6-9A18-C203DB4F8B7A}"/>
          </ac:grpSpMkLst>
        </pc:grpChg>
        <pc:grpChg chg="add mod">
          <ac:chgData name="vijay kumar" userId="0eb738f014aa4543" providerId="LiveId" clId="{B4DB2928-3EFF-4507-ABD0-3894F091460A}" dt="2020-04-27T17:54:18.035" v="371" actId="164"/>
          <ac:grpSpMkLst>
            <pc:docMk/>
            <pc:sldMk cId="2578547695" sldId="354"/>
            <ac:grpSpMk id="420" creationId="{77AEF86B-4B1B-488D-B709-2D1162C6165B}"/>
          </ac:grpSpMkLst>
        </pc:grpChg>
        <pc:grpChg chg="add mod">
          <ac:chgData name="vijay kumar" userId="0eb738f014aa4543" providerId="LiveId" clId="{B4DB2928-3EFF-4507-ABD0-3894F091460A}" dt="2020-04-27T17:54:18.035" v="371" actId="164"/>
          <ac:grpSpMkLst>
            <pc:docMk/>
            <pc:sldMk cId="2578547695" sldId="354"/>
            <ac:grpSpMk id="467" creationId="{171C947A-9EFD-4A51-96CF-EC552B52612E}"/>
          </ac:grpSpMkLst>
        </pc:grpChg>
      </pc:sldChg>
      <pc:sldChg chg="addSp delSp modSp new mod ord">
        <pc:chgData name="vijay kumar" userId="0eb738f014aa4543" providerId="LiveId" clId="{B4DB2928-3EFF-4507-ABD0-3894F091460A}" dt="2020-05-24T14:29:02.247" v="15179" actId="1076"/>
        <pc:sldMkLst>
          <pc:docMk/>
          <pc:sldMk cId="2863535548" sldId="354"/>
        </pc:sldMkLst>
        <pc:spChg chg="add del mod ord topLvl">
          <ac:chgData name="vijay kumar" userId="0eb738f014aa4543" providerId="LiveId" clId="{B4DB2928-3EFF-4507-ABD0-3894F091460A}" dt="2020-05-08T11:50:48.269" v="14200" actId="478"/>
          <ac:spMkLst>
            <pc:docMk/>
            <pc:sldMk cId="2863535548" sldId="354"/>
            <ac:spMk id="3" creationId="{5F102DB7-3E51-411F-B13B-3235711957A8}"/>
          </ac:spMkLst>
        </pc:spChg>
        <pc:spChg chg="mod topLvl">
          <ac:chgData name="vijay kumar" userId="0eb738f014aa4543" providerId="LiveId" clId="{B4DB2928-3EFF-4507-ABD0-3894F091460A}" dt="2020-05-07T11:07:59.161" v="12726" actId="1076"/>
          <ac:spMkLst>
            <pc:docMk/>
            <pc:sldMk cId="2863535548" sldId="354"/>
            <ac:spMk id="4" creationId="{98DABFBC-4288-455C-997C-745E4C29565D}"/>
          </ac:spMkLst>
        </pc:spChg>
        <pc:spChg chg="mod topLvl">
          <ac:chgData name="vijay kumar" userId="0eb738f014aa4543" providerId="LiveId" clId="{B4DB2928-3EFF-4507-ABD0-3894F091460A}" dt="2020-05-07T11:07:59.161" v="12726" actId="1076"/>
          <ac:spMkLst>
            <pc:docMk/>
            <pc:sldMk cId="2863535548" sldId="354"/>
            <ac:spMk id="5" creationId="{A2626088-79A1-40BB-8A76-FB28653D0FF2}"/>
          </ac:spMkLst>
        </pc:spChg>
        <pc:spChg chg="mod topLvl">
          <ac:chgData name="vijay kumar" userId="0eb738f014aa4543" providerId="LiveId" clId="{B4DB2928-3EFF-4507-ABD0-3894F091460A}" dt="2020-05-07T11:07:59.161" v="12726" actId="1076"/>
          <ac:spMkLst>
            <pc:docMk/>
            <pc:sldMk cId="2863535548" sldId="354"/>
            <ac:spMk id="6" creationId="{B867B508-1497-48D9-9A99-EBD6B7BD8B3F}"/>
          </ac:spMkLst>
        </pc:spChg>
        <pc:spChg chg="mod topLvl">
          <ac:chgData name="vijay kumar" userId="0eb738f014aa4543" providerId="LiveId" clId="{B4DB2928-3EFF-4507-ABD0-3894F091460A}" dt="2020-05-07T11:07:59.161" v="12726" actId="1076"/>
          <ac:spMkLst>
            <pc:docMk/>
            <pc:sldMk cId="2863535548" sldId="354"/>
            <ac:spMk id="7" creationId="{96C85427-1D6E-4387-948D-55591E1E8325}"/>
          </ac:spMkLst>
        </pc:spChg>
        <pc:spChg chg="mod topLvl">
          <ac:chgData name="vijay kumar" userId="0eb738f014aa4543" providerId="LiveId" clId="{B4DB2928-3EFF-4507-ABD0-3894F091460A}" dt="2020-05-07T11:07:59.161" v="12726" actId="1076"/>
          <ac:spMkLst>
            <pc:docMk/>
            <pc:sldMk cId="2863535548" sldId="354"/>
            <ac:spMk id="8" creationId="{24B4A969-A938-46CF-982E-BB1B8BFECB91}"/>
          </ac:spMkLst>
        </pc:spChg>
        <pc:spChg chg="mod topLvl">
          <ac:chgData name="vijay kumar" userId="0eb738f014aa4543" providerId="LiveId" clId="{B4DB2928-3EFF-4507-ABD0-3894F091460A}" dt="2020-05-07T11:07:59.161" v="12726" actId="1076"/>
          <ac:spMkLst>
            <pc:docMk/>
            <pc:sldMk cId="2863535548" sldId="354"/>
            <ac:spMk id="10" creationId="{8BB69EC3-7E88-43DE-A0C3-97789DD5644B}"/>
          </ac:spMkLst>
        </pc:spChg>
        <pc:spChg chg="del mod topLvl">
          <ac:chgData name="vijay kumar" userId="0eb738f014aa4543" providerId="LiveId" clId="{B4DB2928-3EFF-4507-ABD0-3894F091460A}" dt="2020-05-02T21:09:38.282" v="6981" actId="478"/>
          <ac:spMkLst>
            <pc:docMk/>
            <pc:sldMk cId="2863535548" sldId="354"/>
            <ac:spMk id="11" creationId="{E6D41087-9ADB-46A8-8538-7E9050BA59F2}"/>
          </ac:spMkLst>
        </pc:spChg>
        <pc:spChg chg="del mod topLvl">
          <ac:chgData name="vijay kumar" userId="0eb738f014aa4543" providerId="LiveId" clId="{B4DB2928-3EFF-4507-ABD0-3894F091460A}" dt="2020-05-07T09:45:55.780" v="10817" actId="478"/>
          <ac:spMkLst>
            <pc:docMk/>
            <pc:sldMk cId="2863535548" sldId="354"/>
            <ac:spMk id="12" creationId="{7A0B1400-5E09-42C6-9C19-9C7B1A7FBB96}"/>
          </ac:spMkLst>
        </pc:spChg>
        <pc:spChg chg="del mod topLvl">
          <ac:chgData name="vijay kumar" userId="0eb738f014aa4543" providerId="LiveId" clId="{B4DB2928-3EFF-4507-ABD0-3894F091460A}" dt="2020-05-02T21:09:38.282" v="6981" actId="478"/>
          <ac:spMkLst>
            <pc:docMk/>
            <pc:sldMk cId="2863535548" sldId="354"/>
            <ac:spMk id="12" creationId="{AADFAC10-1A9E-4D5E-9FC7-97CCAF4E33D6}"/>
          </ac:spMkLst>
        </pc:spChg>
        <pc:spChg chg="del mod topLvl">
          <ac:chgData name="vijay kumar" userId="0eb738f014aa4543" providerId="LiveId" clId="{B4DB2928-3EFF-4507-ABD0-3894F091460A}" dt="2020-05-02T21:09:38.282" v="6981" actId="478"/>
          <ac:spMkLst>
            <pc:docMk/>
            <pc:sldMk cId="2863535548" sldId="354"/>
            <ac:spMk id="13" creationId="{08F88910-D4FB-4E49-A22D-224322029D29}"/>
          </ac:spMkLst>
        </pc:spChg>
        <pc:spChg chg="mod ord topLvl">
          <ac:chgData name="vijay kumar" userId="0eb738f014aa4543" providerId="LiveId" clId="{B4DB2928-3EFF-4507-ABD0-3894F091460A}" dt="2020-05-07T11:07:59.161" v="12726" actId="1076"/>
          <ac:spMkLst>
            <pc:docMk/>
            <pc:sldMk cId="2863535548" sldId="354"/>
            <ac:spMk id="13" creationId="{4A72DA99-DF2D-4CE1-9AC7-C7DB6B9F62D6}"/>
          </ac:spMkLst>
        </pc:spChg>
        <pc:spChg chg="del mod topLvl">
          <ac:chgData name="vijay kumar" userId="0eb738f014aa4543" providerId="LiveId" clId="{B4DB2928-3EFF-4507-ABD0-3894F091460A}" dt="2020-05-02T21:09:32.805" v="6980" actId="478"/>
          <ac:spMkLst>
            <pc:docMk/>
            <pc:sldMk cId="2863535548" sldId="354"/>
            <ac:spMk id="14" creationId="{B8D22BD3-8ADE-4751-AEB2-702FF5F3371B}"/>
          </ac:spMkLst>
        </pc:spChg>
        <pc:spChg chg="mod ord topLvl">
          <ac:chgData name="vijay kumar" userId="0eb738f014aa4543" providerId="LiveId" clId="{B4DB2928-3EFF-4507-ABD0-3894F091460A}" dt="2020-05-07T11:07:59.161" v="12726" actId="1076"/>
          <ac:spMkLst>
            <pc:docMk/>
            <pc:sldMk cId="2863535548" sldId="354"/>
            <ac:spMk id="14" creationId="{C45326E0-9259-4363-B75A-24F785468293}"/>
          </ac:spMkLst>
        </pc:spChg>
        <pc:spChg chg="del mod topLvl">
          <ac:chgData name="vijay kumar" userId="0eb738f014aa4543" providerId="LiveId" clId="{B4DB2928-3EFF-4507-ABD0-3894F091460A}" dt="2020-05-02T21:09:20.637" v="6978" actId="478"/>
          <ac:spMkLst>
            <pc:docMk/>
            <pc:sldMk cId="2863535548" sldId="354"/>
            <ac:spMk id="15" creationId="{9A22D131-6EE2-40E0-B693-29B12A44B86F}"/>
          </ac:spMkLst>
        </pc:spChg>
        <pc:spChg chg="mod ord topLvl">
          <ac:chgData name="vijay kumar" userId="0eb738f014aa4543" providerId="LiveId" clId="{B4DB2928-3EFF-4507-ABD0-3894F091460A}" dt="2020-05-07T11:07:59.161" v="12726" actId="1076"/>
          <ac:spMkLst>
            <pc:docMk/>
            <pc:sldMk cId="2863535548" sldId="354"/>
            <ac:spMk id="15" creationId="{9B3562D6-3FA2-4D38-BCFD-16E99DA62FB5}"/>
          </ac:spMkLst>
        </pc:spChg>
        <pc:spChg chg="del mod topLvl">
          <ac:chgData name="vijay kumar" userId="0eb738f014aa4543" providerId="LiveId" clId="{B4DB2928-3EFF-4507-ABD0-3894F091460A}" dt="2020-05-02T21:09:32.805" v="6980" actId="478"/>
          <ac:spMkLst>
            <pc:docMk/>
            <pc:sldMk cId="2863535548" sldId="354"/>
            <ac:spMk id="16" creationId="{1F7E5436-8C16-4311-915B-F95812540224}"/>
          </ac:spMkLst>
        </pc:spChg>
        <pc:spChg chg="mod ord topLvl">
          <ac:chgData name="vijay kumar" userId="0eb738f014aa4543" providerId="LiveId" clId="{B4DB2928-3EFF-4507-ABD0-3894F091460A}" dt="2020-05-07T11:07:59.161" v="12726" actId="1076"/>
          <ac:spMkLst>
            <pc:docMk/>
            <pc:sldMk cId="2863535548" sldId="354"/>
            <ac:spMk id="16" creationId="{F39D7A16-20F5-494A-9640-4B2BD6002982}"/>
          </ac:spMkLst>
        </pc:spChg>
        <pc:spChg chg="del mod topLvl">
          <ac:chgData name="vijay kumar" userId="0eb738f014aa4543" providerId="LiveId" clId="{B4DB2928-3EFF-4507-ABD0-3894F091460A}" dt="2020-05-02T21:09:38.282" v="6981" actId="478"/>
          <ac:spMkLst>
            <pc:docMk/>
            <pc:sldMk cId="2863535548" sldId="354"/>
            <ac:spMk id="17" creationId="{ED756A74-C669-47C8-995B-EF477F591AA9}"/>
          </ac:spMkLst>
        </pc:spChg>
        <pc:spChg chg="mod ord topLvl">
          <ac:chgData name="vijay kumar" userId="0eb738f014aa4543" providerId="LiveId" clId="{B4DB2928-3EFF-4507-ABD0-3894F091460A}" dt="2020-05-07T11:07:59.161" v="12726" actId="1076"/>
          <ac:spMkLst>
            <pc:docMk/>
            <pc:sldMk cId="2863535548" sldId="354"/>
            <ac:spMk id="17" creationId="{EE1162E0-B8A9-4637-B7E2-275453EAB249}"/>
          </ac:spMkLst>
        </pc:spChg>
        <pc:spChg chg="mod ord topLvl">
          <ac:chgData name="vijay kumar" userId="0eb738f014aa4543" providerId="LiveId" clId="{B4DB2928-3EFF-4507-ABD0-3894F091460A}" dt="2020-05-07T11:07:59.161" v="12726" actId="1076"/>
          <ac:spMkLst>
            <pc:docMk/>
            <pc:sldMk cId="2863535548" sldId="354"/>
            <ac:spMk id="18" creationId="{2C01F0E4-9CAD-42CB-A55F-9055BC265AE7}"/>
          </ac:spMkLst>
        </pc:spChg>
        <pc:spChg chg="del mod topLvl">
          <ac:chgData name="vijay kumar" userId="0eb738f014aa4543" providerId="LiveId" clId="{B4DB2928-3EFF-4507-ABD0-3894F091460A}" dt="2020-05-02T21:09:38.282" v="6981" actId="478"/>
          <ac:spMkLst>
            <pc:docMk/>
            <pc:sldMk cId="2863535548" sldId="354"/>
            <ac:spMk id="18" creationId="{D3F891DB-36B4-457D-8F4A-55FF463211D3}"/>
          </ac:spMkLst>
        </pc:spChg>
        <pc:spChg chg="del mod topLvl">
          <ac:chgData name="vijay kumar" userId="0eb738f014aa4543" providerId="LiveId" clId="{B4DB2928-3EFF-4507-ABD0-3894F091460A}" dt="2020-05-02T21:09:20.637" v="6978" actId="478"/>
          <ac:spMkLst>
            <pc:docMk/>
            <pc:sldMk cId="2863535548" sldId="354"/>
            <ac:spMk id="19" creationId="{A6A51CB4-4D1F-49B7-8ADC-282BB137D21F}"/>
          </ac:spMkLst>
        </pc:spChg>
        <pc:spChg chg="mod ord topLvl">
          <ac:chgData name="vijay kumar" userId="0eb738f014aa4543" providerId="LiveId" clId="{B4DB2928-3EFF-4507-ABD0-3894F091460A}" dt="2020-05-07T11:07:59.161" v="12726" actId="1076"/>
          <ac:spMkLst>
            <pc:docMk/>
            <pc:sldMk cId="2863535548" sldId="354"/>
            <ac:spMk id="19" creationId="{D11D5E71-4D03-49FC-93C6-F3F018DEFEDD}"/>
          </ac:spMkLst>
        </pc:spChg>
        <pc:spChg chg="mod ord topLvl">
          <ac:chgData name="vijay kumar" userId="0eb738f014aa4543" providerId="LiveId" clId="{B4DB2928-3EFF-4507-ABD0-3894F091460A}" dt="2020-05-07T11:07:59.161" v="12726" actId="1076"/>
          <ac:spMkLst>
            <pc:docMk/>
            <pc:sldMk cId="2863535548" sldId="354"/>
            <ac:spMk id="20" creationId="{23E92A54-23B0-41C3-976D-952DC2BAF634}"/>
          </ac:spMkLst>
        </pc:spChg>
        <pc:spChg chg="del mod topLvl">
          <ac:chgData name="vijay kumar" userId="0eb738f014aa4543" providerId="LiveId" clId="{B4DB2928-3EFF-4507-ABD0-3894F091460A}" dt="2020-05-02T21:09:32.805" v="6980" actId="478"/>
          <ac:spMkLst>
            <pc:docMk/>
            <pc:sldMk cId="2863535548" sldId="354"/>
            <ac:spMk id="20" creationId="{AFA0C69D-63F5-493D-B576-2D886ED06255}"/>
          </ac:spMkLst>
        </pc:spChg>
        <pc:spChg chg="mod topLvl">
          <ac:chgData name="vijay kumar" userId="0eb738f014aa4543" providerId="LiveId" clId="{B4DB2928-3EFF-4507-ABD0-3894F091460A}" dt="2020-05-07T11:07:59.161" v="12726" actId="1076"/>
          <ac:spMkLst>
            <pc:docMk/>
            <pc:sldMk cId="2863535548" sldId="354"/>
            <ac:spMk id="21" creationId="{F7D19F5B-F3D1-446C-AF8F-B2B0ABF36D8E}"/>
          </ac:spMkLst>
        </pc:spChg>
        <pc:spChg chg="mod ord topLvl">
          <ac:chgData name="vijay kumar" userId="0eb738f014aa4543" providerId="LiveId" clId="{B4DB2928-3EFF-4507-ABD0-3894F091460A}" dt="2020-05-07T11:07:59.161" v="12726" actId="1076"/>
          <ac:spMkLst>
            <pc:docMk/>
            <pc:sldMk cId="2863535548" sldId="354"/>
            <ac:spMk id="22" creationId="{5CDEE8CE-43DC-46D0-AB2B-0F0461F89B72}"/>
          </ac:spMkLst>
        </pc:spChg>
        <pc:spChg chg="mod topLvl">
          <ac:chgData name="vijay kumar" userId="0eb738f014aa4543" providerId="LiveId" clId="{B4DB2928-3EFF-4507-ABD0-3894F091460A}" dt="2020-05-07T11:07:59.161" v="12726" actId="1076"/>
          <ac:spMkLst>
            <pc:docMk/>
            <pc:sldMk cId="2863535548" sldId="354"/>
            <ac:spMk id="23" creationId="{FB4CAD06-62E0-4D6F-AC96-34F34BB63B0D}"/>
          </ac:spMkLst>
        </pc:spChg>
        <pc:spChg chg="del mod topLvl">
          <ac:chgData name="vijay kumar" userId="0eb738f014aa4543" providerId="LiveId" clId="{B4DB2928-3EFF-4507-ABD0-3894F091460A}" dt="2020-05-02T18:02:44.266" v="5157" actId="478"/>
          <ac:spMkLst>
            <pc:docMk/>
            <pc:sldMk cId="2863535548" sldId="354"/>
            <ac:spMk id="24" creationId="{43608F0B-F866-4BA3-8706-1CB182D5F320}"/>
          </ac:spMkLst>
        </pc:spChg>
        <pc:spChg chg="mod topLvl">
          <ac:chgData name="vijay kumar" userId="0eb738f014aa4543" providerId="LiveId" clId="{B4DB2928-3EFF-4507-ABD0-3894F091460A}" dt="2020-05-07T11:07:59.161" v="12726" actId="1076"/>
          <ac:spMkLst>
            <pc:docMk/>
            <pc:sldMk cId="2863535548" sldId="354"/>
            <ac:spMk id="24" creationId="{F1BF17C7-1F97-4C78-9B0A-BE61FBD9C5B8}"/>
          </ac:spMkLst>
        </pc:spChg>
        <pc:spChg chg="mod topLvl">
          <ac:chgData name="vijay kumar" userId="0eb738f014aa4543" providerId="LiveId" clId="{B4DB2928-3EFF-4507-ABD0-3894F091460A}" dt="2020-05-07T11:07:59.161" v="12726" actId="1076"/>
          <ac:spMkLst>
            <pc:docMk/>
            <pc:sldMk cId="2863535548" sldId="354"/>
            <ac:spMk id="25" creationId="{53FDE51C-A1A1-48B2-B488-8EC8BA1673B6}"/>
          </ac:spMkLst>
        </pc:spChg>
        <pc:spChg chg="mod topLvl">
          <ac:chgData name="vijay kumar" userId="0eb738f014aa4543" providerId="LiveId" clId="{B4DB2928-3EFF-4507-ABD0-3894F091460A}" dt="2020-05-07T11:07:59.161" v="12726" actId="1076"/>
          <ac:spMkLst>
            <pc:docMk/>
            <pc:sldMk cId="2863535548" sldId="354"/>
            <ac:spMk id="26" creationId="{A2DCAE6E-ADB5-45E7-8FC0-AD2618C15CEC}"/>
          </ac:spMkLst>
        </pc:spChg>
        <pc:spChg chg="mod topLvl">
          <ac:chgData name="vijay kumar" userId="0eb738f014aa4543" providerId="LiveId" clId="{B4DB2928-3EFF-4507-ABD0-3894F091460A}" dt="2020-05-07T11:07:59.161" v="12726" actId="1076"/>
          <ac:spMkLst>
            <pc:docMk/>
            <pc:sldMk cId="2863535548" sldId="354"/>
            <ac:spMk id="27" creationId="{639DA128-CD4B-4C43-8988-C4B3259A0FC9}"/>
          </ac:spMkLst>
        </pc:spChg>
        <pc:spChg chg="mod topLvl">
          <ac:chgData name="vijay kumar" userId="0eb738f014aa4543" providerId="LiveId" clId="{B4DB2928-3EFF-4507-ABD0-3894F091460A}" dt="2020-05-07T11:07:59.161" v="12726" actId="1076"/>
          <ac:spMkLst>
            <pc:docMk/>
            <pc:sldMk cId="2863535548" sldId="354"/>
            <ac:spMk id="28" creationId="{E081905C-B129-41D3-8EE2-5DFCEA946BD2}"/>
          </ac:spMkLst>
        </pc:spChg>
        <pc:spChg chg="mod topLvl">
          <ac:chgData name="vijay kumar" userId="0eb738f014aa4543" providerId="LiveId" clId="{B4DB2928-3EFF-4507-ABD0-3894F091460A}" dt="2020-05-07T11:07:59.161" v="12726" actId="1076"/>
          <ac:spMkLst>
            <pc:docMk/>
            <pc:sldMk cId="2863535548" sldId="354"/>
            <ac:spMk id="29" creationId="{49417560-CAB5-4DC0-9EAD-DA52BF8D20F3}"/>
          </ac:spMkLst>
        </pc:spChg>
        <pc:spChg chg="mod topLvl">
          <ac:chgData name="vijay kumar" userId="0eb738f014aa4543" providerId="LiveId" clId="{B4DB2928-3EFF-4507-ABD0-3894F091460A}" dt="2020-05-07T11:07:59.161" v="12726" actId="1076"/>
          <ac:spMkLst>
            <pc:docMk/>
            <pc:sldMk cId="2863535548" sldId="354"/>
            <ac:spMk id="30" creationId="{0116732A-877A-464C-8BD4-386573FD4615}"/>
          </ac:spMkLst>
        </pc:spChg>
        <pc:spChg chg="mod topLvl">
          <ac:chgData name="vijay kumar" userId="0eb738f014aa4543" providerId="LiveId" clId="{B4DB2928-3EFF-4507-ABD0-3894F091460A}" dt="2020-05-07T11:07:59.161" v="12726" actId="1076"/>
          <ac:spMkLst>
            <pc:docMk/>
            <pc:sldMk cId="2863535548" sldId="354"/>
            <ac:spMk id="31" creationId="{8EA641A4-FA1E-4D79-9217-0AF24F441EE5}"/>
          </ac:spMkLst>
        </pc:spChg>
        <pc:spChg chg="mod topLvl">
          <ac:chgData name="vijay kumar" userId="0eb738f014aa4543" providerId="LiveId" clId="{B4DB2928-3EFF-4507-ABD0-3894F091460A}" dt="2020-05-07T11:07:59.161" v="12726" actId="1076"/>
          <ac:spMkLst>
            <pc:docMk/>
            <pc:sldMk cId="2863535548" sldId="354"/>
            <ac:spMk id="32" creationId="{59A2F765-779B-467C-B8DE-4C6224A50788}"/>
          </ac:spMkLst>
        </pc:spChg>
        <pc:spChg chg="mod topLvl">
          <ac:chgData name="vijay kumar" userId="0eb738f014aa4543" providerId="LiveId" clId="{B4DB2928-3EFF-4507-ABD0-3894F091460A}" dt="2020-05-07T11:07:59.161" v="12726" actId="1076"/>
          <ac:spMkLst>
            <pc:docMk/>
            <pc:sldMk cId="2863535548" sldId="354"/>
            <ac:spMk id="33" creationId="{B1860DAB-9420-4159-88A4-E36E535F15BB}"/>
          </ac:spMkLst>
        </pc:spChg>
        <pc:spChg chg="mod topLvl">
          <ac:chgData name="vijay kumar" userId="0eb738f014aa4543" providerId="LiveId" clId="{B4DB2928-3EFF-4507-ABD0-3894F091460A}" dt="2020-05-07T11:07:59.161" v="12726" actId="1076"/>
          <ac:spMkLst>
            <pc:docMk/>
            <pc:sldMk cId="2863535548" sldId="354"/>
            <ac:spMk id="34" creationId="{257E49AF-240F-4C76-8E58-6088EAD7C52F}"/>
          </ac:spMkLst>
        </pc:spChg>
        <pc:spChg chg="mod topLvl">
          <ac:chgData name="vijay kumar" userId="0eb738f014aa4543" providerId="LiveId" clId="{B4DB2928-3EFF-4507-ABD0-3894F091460A}" dt="2020-05-07T11:07:59.161" v="12726" actId="1076"/>
          <ac:spMkLst>
            <pc:docMk/>
            <pc:sldMk cId="2863535548" sldId="354"/>
            <ac:spMk id="35" creationId="{5E0DDEAC-4AD6-4474-B747-AE57949A7E6C}"/>
          </ac:spMkLst>
        </pc:spChg>
        <pc:spChg chg="mod topLvl">
          <ac:chgData name="vijay kumar" userId="0eb738f014aa4543" providerId="LiveId" clId="{B4DB2928-3EFF-4507-ABD0-3894F091460A}" dt="2020-05-07T11:07:59.161" v="12726" actId="1076"/>
          <ac:spMkLst>
            <pc:docMk/>
            <pc:sldMk cId="2863535548" sldId="354"/>
            <ac:spMk id="36" creationId="{8F07116D-EB94-4813-96FE-7E5AEA594EFD}"/>
          </ac:spMkLst>
        </pc:spChg>
        <pc:spChg chg="mod topLvl">
          <ac:chgData name="vijay kumar" userId="0eb738f014aa4543" providerId="LiveId" clId="{B4DB2928-3EFF-4507-ABD0-3894F091460A}" dt="2020-05-07T11:07:59.161" v="12726" actId="1076"/>
          <ac:spMkLst>
            <pc:docMk/>
            <pc:sldMk cId="2863535548" sldId="354"/>
            <ac:spMk id="37" creationId="{5B29110E-8E07-42EF-9771-6BD830F09D87}"/>
          </ac:spMkLst>
        </pc:spChg>
        <pc:spChg chg="mod topLvl">
          <ac:chgData name="vijay kumar" userId="0eb738f014aa4543" providerId="LiveId" clId="{B4DB2928-3EFF-4507-ABD0-3894F091460A}" dt="2020-05-07T11:07:59.161" v="12726" actId="1076"/>
          <ac:spMkLst>
            <pc:docMk/>
            <pc:sldMk cId="2863535548" sldId="354"/>
            <ac:spMk id="38" creationId="{80F42AE3-F09C-4FC7-8270-EE3E632F75BB}"/>
          </ac:spMkLst>
        </pc:spChg>
        <pc:spChg chg="mod topLvl">
          <ac:chgData name="vijay kumar" userId="0eb738f014aa4543" providerId="LiveId" clId="{B4DB2928-3EFF-4507-ABD0-3894F091460A}" dt="2020-05-07T11:07:59.161" v="12726" actId="1076"/>
          <ac:spMkLst>
            <pc:docMk/>
            <pc:sldMk cId="2863535548" sldId="354"/>
            <ac:spMk id="39" creationId="{194C2BC8-19EC-48D2-8CC2-86C64C422FF6}"/>
          </ac:spMkLst>
        </pc:spChg>
        <pc:spChg chg="mod topLvl">
          <ac:chgData name="vijay kumar" userId="0eb738f014aa4543" providerId="LiveId" clId="{B4DB2928-3EFF-4507-ABD0-3894F091460A}" dt="2020-05-07T11:07:59.161" v="12726" actId="1076"/>
          <ac:spMkLst>
            <pc:docMk/>
            <pc:sldMk cId="2863535548" sldId="354"/>
            <ac:spMk id="40" creationId="{4BBC34B1-56FE-44F9-9CEE-99CE7F4F1AAE}"/>
          </ac:spMkLst>
        </pc:spChg>
        <pc:spChg chg="mod topLvl">
          <ac:chgData name="vijay kumar" userId="0eb738f014aa4543" providerId="LiveId" clId="{B4DB2928-3EFF-4507-ABD0-3894F091460A}" dt="2020-05-07T11:07:59.161" v="12726" actId="1076"/>
          <ac:spMkLst>
            <pc:docMk/>
            <pc:sldMk cId="2863535548" sldId="354"/>
            <ac:spMk id="41" creationId="{C5270026-91B4-41A7-9A2C-5867F750FF14}"/>
          </ac:spMkLst>
        </pc:spChg>
        <pc:spChg chg="mod topLvl">
          <ac:chgData name="vijay kumar" userId="0eb738f014aa4543" providerId="LiveId" clId="{B4DB2928-3EFF-4507-ABD0-3894F091460A}" dt="2020-05-07T11:07:59.161" v="12726" actId="1076"/>
          <ac:spMkLst>
            <pc:docMk/>
            <pc:sldMk cId="2863535548" sldId="354"/>
            <ac:spMk id="42" creationId="{6D7B2159-95C5-4497-A8CD-471E7927E9BE}"/>
          </ac:spMkLst>
        </pc:spChg>
        <pc:spChg chg="mod topLvl">
          <ac:chgData name="vijay kumar" userId="0eb738f014aa4543" providerId="LiveId" clId="{B4DB2928-3EFF-4507-ABD0-3894F091460A}" dt="2020-05-07T11:07:59.161" v="12726" actId="1076"/>
          <ac:spMkLst>
            <pc:docMk/>
            <pc:sldMk cId="2863535548" sldId="354"/>
            <ac:spMk id="43" creationId="{6656284E-726E-4750-8B74-3131089F4CAE}"/>
          </ac:spMkLst>
        </pc:spChg>
        <pc:spChg chg="mod topLvl">
          <ac:chgData name="vijay kumar" userId="0eb738f014aa4543" providerId="LiveId" clId="{B4DB2928-3EFF-4507-ABD0-3894F091460A}" dt="2020-05-07T11:07:59.161" v="12726" actId="1076"/>
          <ac:spMkLst>
            <pc:docMk/>
            <pc:sldMk cId="2863535548" sldId="354"/>
            <ac:spMk id="44" creationId="{F61C8E59-E92A-424A-AF47-974754FE714A}"/>
          </ac:spMkLst>
        </pc:spChg>
        <pc:spChg chg="mod topLvl">
          <ac:chgData name="vijay kumar" userId="0eb738f014aa4543" providerId="LiveId" clId="{B4DB2928-3EFF-4507-ABD0-3894F091460A}" dt="2020-05-07T11:07:59.161" v="12726" actId="1076"/>
          <ac:spMkLst>
            <pc:docMk/>
            <pc:sldMk cId="2863535548" sldId="354"/>
            <ac:spMk id="45" creationId="{1D97CF28-95D7-4221-A767-7B021D959384}"/>
          </ac:spMkLst>
        </pc:spChg>
        <pc:spChg chg="del mod topLvl">
          <ac:chgData name="vijay kumar" userId="0eb738f014aa4543" providerId="LiveId" clId="{B4DB2928-3EFF-4507-ABD0-3894F091460A}" dt="2020-05-02T18:01:58.364" v="5156" actId="478"/>
          <ac:spMkLst>
            <pc:docMk/>
            <pc:sldMk cId="2863535548" sldId="354"/>
            <ac:spMk id="45" creationId="{F019035B-E650-4745-BF8A-9ED2CF939249}"/>
          </ac:spMkLst>
        </pc:spChg>
        <pc:spChg chg="del mod topLvl">
          <ac:chgData name="vijay kumar" userId="0eb738f014aa4543" providerId="LiveId" clId="{B4DB2928-3EFF-4507-ABD0-3894F091460A}" dt="2020-05-02T18:01:58.364" v="5156" actId="478"/>
          <ac:spMkLst>
            <pc:docMk/>
            <pc:sldMk cId="2863535548" sldId="354"/>
            <ac:spMk id="46" creationId="{CFEB3536-8728-42DD-8FC9-41E20BF32671}"/>
          </ac:spMkLst>
        </pc:spChg>
        <pc:spChg chg="mod topLvl">
          <ac:chgData name="vijay kumar" userId="0eb738f014aa4543" providerId="LiveId" clId="{B4DB2928-3EFF-4507-ABD0-3894F091460A}" dt="2020-05-07T11:07:59.161" v="12726" actId="1076"/>
          <ac:spMkLst>
            <pc:docMk/>
            <pc:sldMk cId="2863535548" sldId="354"/>
            <ac:spMk id="46" creationId="{F9B2D4E7-0E85-4745-BE07-D06B5797EDDA}"/>
          </ac:spMkLst>
        </pc:spChg>
        <pc:spChg chg="del mod topLvl">
          <ac:chgData name="vijay kumar" userId="0eb738f014aa4543" providerId="LiveId" clId="{B4DB2928-3EFF-4507-ABD0-3894F091460A}" dt="2020-05-02T18:01:58.364" v="5156" actId="478"/>
          <ac:spMkLst>
            <pc:docMk/>
            <pc:sldMk cId="2863535548" sldId="354"/>
            <ac:spMk id="47" creationId="{31189AE2-08C9-49D4-B989-1E74B283D624}"/>
          </ac:spMkLst>
        </pc:spChg>
        <pc:spChg chg="mod topLvl">
          <ac:chgData name="vijay kumar" userId="0eb738f014aa4543" providerId="LiveId" clId="{B4DB2928-3EFF-4507-ABD0-3894F091460A}" dt="2020-05-07T11:07:59.161" v="12726" actId="1076"/>
          <ac:spMkLst>
            <pc:docMk/>
            <pc:sldMk cId="2863535548" sldId="354"/>
            <ac:spMk id="47" creationId="{9E519A2D-67D9-4A20-96BE-D8A5A33FFEA1}"/>
          </ac:spMkLst>
        </pc:spChg>
        <pc:spChg chg="del mod topLvl">
          <ac:chgData name="vijay kumar" userId="0eb738f014aa4543" providerId="LiveId" clId="{B4DB2928-3EFF-4507-ABD0-3894F091460A}" dt="2020-05-02T18:03:04.632" v="5160" actId="478"/>
          <ac:spMkLst>
            <pc:docMk/>
            <pc:sldMk cId="2863535548" sldId="354"/>
            <ac:spMk id="48" creationId="{479EFE27-455C-4981-BC28-40BC9102BFF7}"/>
          </ac:spMkLst>
        </pc:spChg>
        <pc:spChg chg="mod topLvl">
          <ac:chgData name="vijay kumar" userId="0eb738f014aa4543" providerId="LiveId" clId="{B4DB2928-3EFF-4507-ABD0-3894F091460A}" dt="2020-05-07T11:07:59.161" v="12726" actId="1076"/>
          <ac:spMkLst>
            <pc:docMk/>
            <pc:sldMk cId="2863535548" sldId="354"/>
            <ac:spMk id="48" creationId="{BB31F422-4415-4C33-AC9C-B19E35BD2CF2}"/>
          </ac:spMkLst>
        </pc:spChg>
        <pc:spChg chg="mod topLvl">
          <ac:chgData name="vijay kumar" userId="0eb738f014aa4543" providerId="LiveId" clId="{B4DB2928-3EFF-4507-ABD0-3894F091460A}" dt="2020-05-07T11:07:59.161" v="12726" actId="1076"/>
          <ac:spMkLst>
            <pc:docMk/>
            <pc:sldMk cId="2863535548" sldId="354"/>
            <ac:spMk id="49" creationId="{16FF8F4F-86DA-40C6-8398-70AAD7C02610}"/>
          </ac:spMkLst>
        </pc:spChg>
        <pc:spChg chg="del mod topLvl">
          <ac:chgData name="vijay kumar" userId="0eb738f014aa4543" providerId="LiveId" clId="{B4DB2928-3EFF-4507-ABD0-3894F091460A}" dt="2020-05-02T18:03:02.166" v="5159" actId="478"/>
          <ac:spMkLst>
            <pc:docMk/>
            <pc:sldMk cId="2863535548" sldId="354"/>
            <ac:spMk id="49" creationId="{48FFA23D-B40F-4A5A-8842-20693836A0FA}"/>
          </ac:spMkLst>
        </pc:spChg>
        <pc:spChg chg="del mod topLvl">
          <ac:chgData name="vijay kumar" userId="0eb738f014aa4543" providerId="LiveId" clId="{B4DB2928-3EFF-4507-ABD0-3894F091460A}" dt="2020-05-02T18:01:53.830" v="5155" actId="478"/>
          <ac:spMkLst>
            <pc:docMk/>
            <pc:sldMk cId="2863535548" sldId="354"/>
            <ac:spMk id="50" creationId="{07804517-0440-4824-B40C-673ACB75C57B}"/>
          </ac:spMkLst>
        </pc:spChg>
        <pc:spChg chg="mod topLvl">
          <ac:chgData name="vijay kumar" userId="0eb738f014aa4543" providerId="LiveId" clId="{B4DB2928-3EFF-4507-ABD0-3894F091460A}" dt="2020-05-07T11:07:59.161" v="12726" actId="1076"/>
          <ac:spMkLst>
            <pc:docMk/>
            <pc:sldMk cId="2863535548" sldId="354"/>
            <ac:spMk id="50" creationId="{2D4675FB-6673-491F-94ED-3FC827351056}"/>
          </ac:spMkLst>
        </pc:spChg>
        <pc:spChg chg="del mod topLvl">
          <ac:chgData name="vijay kumar" userId="0eb738f014aa4543" providerId="LiveId" clId="{B4DB2928-3EFF-4507-ABD0-3894F091460A}" dt="2020-05-02T18:01:53.830" v="5155" actId="478"/>
          <ac:spMkLst>
            <pc:docMk/>
            <pc:sldMk cId="2863535548" sldId="354"/>
            <ac:spMk id="51" creationId="{7AB61BC9-0EBC-45C9-8C05-F2FB46BF2C8D}"/>
          </ac:spMkLst>
        </pc:spChg>
        <pc:spChg chg="mod topLvl">
          <ac:chgData name="vijay kumar" userId="0eb738f014aa4543" providerId="LiveId" clId="{B4DB2928-3EFF-4507-ABD0-3894F091460A}" dt="2020-05-07T11:07:59.161" v="12726" actId="1076"/>
          <ac:spMkLst>
            <pc:docMk/>
            <pc:sldMk cId="2863535548" sldId="354"/>
            <ac:spMk id="51" creationId="{E7FC00B0-8E2A-4E19-BCF4-1B8D1ECE6EE9}"/>
          </ac:spMkLst>
        </pc:spChg>
        <pc:spChg chg="mod topLvl">
          <ac:chgData name="vijay kumar" userId="0eb738f014aa4543" providerId="LiveId" clId="{B4DB2928-3EFF-4507-ABD0-3894F091460A}" dt="2020-05-07T11:07:59.161" v="12726" actId="1076"/>
          <ac:spMkLst>
            <pc:docMk/>
            <pc:sldMk cId="2863535548" sldId="354"/>
            <ac:spMk id="52" creationId="{97C698F9-2C09-4197-9715-BC75F555F42D}"/>
          </ac:spMkLst>
        </pc:spChg>
        <pc:spChg chg="del mod topLvl">
          <ac:chgData name="vijay kumar" userId="0eb738f014aa4543" providerId="LiveId" clId="{B4DB2928-3EFF-4507-ABD0-3894F091460A}" dt="2020-05-02T18:03:16.214" v="5161" actId="478"/>
          <ac:spMkLst>
            <pc:docMk/>
            <pc:sldMk cId="2863535548" sldId="354"/>
            <ac:spMk id="52" creationId="{DB1836FE-22AB-428D-9596-53CAC8F47D5A}"/>
          </ac:spMkLst>
        </pc:spChg>
        <pc:spChg chg="mod topLvl">
          <ac:chgData name="vijay kumar" userId="0eb738f014aa4543" providerId="LiveId" clId="{B4DB2928-3EFF-4507-ABD0-3894F091460A}" dt="2020-05-07T11:07:59.161" v="12726" actId="1076"/>
          <ac:spMkLst>
            <pc:docMk/>
            <pc:sldMk cId="2863535548" sldId="354"/>
            <ac:spMk id="53" creationId="{199C2969-EACE-47B7-906A-080A329D788E}"/>
          </ac:spMkLst>
        </pc:spChg>
        <pc:spChg chg="del mod topLvl">
          <ac:chgData name="vijay kumar" userId="0eb738f014aa4543" providerId="LiveId" clId="{B4DB2928-3EFF-4507-ABD0-3894F091460A}" dt="2020-05-02T18:02:59.213" v="5158" actId="478"/>
          <ac:spMkLst>
            <pc:docMk/>
            <pc:sldMk cId="2863535548" sldId="354"/>
            <ac:spMk id="53" creationId="{5C6632D4-D230-4828-B20A-82FD72446BB1}"/>
          </ac:spMkLst>
        </pc:spChg>
        <pc:spChg chg="del mod topLvl">
          <ac:chgData name="vijay kumar" userId="0eb738f014aa4543" providerId="LiveId" clId="{B4DB2928-3EFF-4507-ABD0-3894F091460A}" dt="2020-05-02T21:11:06.877" v="7035" actId="478"/>
          <ac:spMkLst>
            <pc:docMk/>
            <pc:sldMk cId="2863535548" sldId="354"/>
            <ac:spMk id="54" creationId="{0C63750B-0D76-4E95-A524-A01A66AF261F}"/>
          </ac:spMkLst>
        </pc:spChg>
        <pc:spChg chg="del mod topLvl">
          <ac:chgData name="vijay kumar" userId="0eb738f014aa4543" providerId="LiveId" clId="{B4DB2928-3EFF-4507-ABD0-3894F091460A}" dt="2020-05-02T18:03:16.214" v="5161" actId="478"/>
          <ac:spMkLst>
            <pc:docMk/>
            <pc:sldMk cId="2863535548" sldId="354"/>
            <ac:spMk id="54" creationId="{2B156669-2AD8-416C-80C0-19706825548D}"/>
          </ac:spMkLst>
        </pc:spChg>
        <pc:spChg chg="mod ord topLvl">
          <ac:chgData name="vijay kumar" userId="0eb738f014aa4543" providerId="LiveId" clId="{B4DB2928-3EFF-4507-ABD0-3894F091460A}" dt="2020-05-07T11:07:59.161" v="12726" actId="1076"/>
          <ac:spMkLst>
            <pc:docMk/>
            <pc:sldMk cId="2863535548" sldId="354"/>
            <ac:spMk id="54" creationId="{E9AC5400-41C4-4D21-9596-EF963F0D87D8}"/>
          </ac:spMkLst>
        </pc:spChg>
        <pc:spChg chg="mod ord topLvl">
          <ac:chgData name="vijay kumar" userId="0eb738f014aa4543" providerId="LiveId" clId="{B4DB2928-3EFF-4507-ABD0-3894F091460A}" dt="2020-05-07T11:07:59.161" v="12726" actId="1076"/>
          <ac:spMkLst>
            <pc:docMk/>
            <pc:sldMk cId="2863535548" sldId="354"/>
            <ac:spMk id="55" creationId="{0BE4E1C1-5EC6-4512-B103-44B4B9C9E8C1}"/>
          </ac:spMkLst>
        </pc:spChg>
        <pc:spChg chg="del mod topLvl">
          <ac:chgData name="vijay kumar" userId="0eb738f014aa4543" providerId="LiveId" clId="{B4DB2928-3EFF-4507-ABD0-3894F091460A}" dt="2020-05-02T21:11:06.877" v="7035" actId="478"/>
          <ac:spMkLst>
            <pc:docMk/>
            <pc:sldMk cId="2863535548" sldId="354"/>
            <ac:spMk id="55" creationId="{16005F95-1C55-42F5-B812-BE9303615898}"/>
          </ac:spMkLst>
        </pc:spChg>
        <pc:spChg chg="del mod topLvl">
          <ac:chgData name="vijay kumar" userId="0eb738f014aa4543" providerId="LiveId" clId="{B4DB2928-3EFF-4507-ABD0-3894F091460A}" dt="2020-05-02T18:02:59.213" v="5158" actId="478"/>
          <ac:spMkLst>
            <pc:docMk/>
            <pc:sldMk cId="2863535548" sldId="354"/>
            <ac:spMk id="55" creationId="{57D08B16-6710-4242-BF22-19F0BA5FA9EE}"/>
          </ac:spMkLst>
        </pc:spChg>
        <pc:spChg chg="mod ord topLvl">
          <ac:chgData name="vijay kumar" userId="0eb738f014aa4543" providerId="LiveId" clId="{B4DB2928-3EFF-4507-ABD0-3894F091460A}" dt="2020-05-07T11:07:59.161" v="12726" actId="1076"/>
          <ac:spMkLst>
            <pc:docMk/>
            <pc:sldMk cId="2863535548" sldId="354"/>
            <ac:spMk id="56" creationId="{1EBD79B3-6884-48A3-9FF3-32023CF68D74}"/>
          </ac:spMkLst>
        </pc:spChg>
        <pc:spChg chg="del mod topLvl">
          <ac:chgData name="vijay kumar" userId="0eb738f014aa4543" providerId="LiveId" clId="{B4DB2928-3EFF-4507-ABD0-3894F091460A}" dt="2020-05-02T21:11:06.877" v="7035" actId="478"/>
          <ac:spMkLst>
            <pc:docMk/>
            <pc:sldMk cId="2863535548" sldId="354"/>
            <ac:spMk id="56" creationId="{8747F069-3D64-4486-A91F-52FA354CD007}"/>
          </ac:spMkLst>
        </pc:spChg>
        <pc:spChg chg="del mod topLvl">
          <ac:chgData name="vijay kumar" userId="0eb738f014aa4543" providerId="LiveId" clId="{B4DB2928-3EFF-4507-ABD0-3894F091460A}" dt="2020-05-02T18:03:16.214" v="5161" actId="478"/>
          <ac:spMkLst>
            <pc:docMk/>
            <pc:sldMk cId="2863535548" sldId="354"/>
            <ac:spMk id="56" creationId="{BBEADC24-DC57-49A9-9E83-8732E68D8F37}"/>
          </ac:spMkLst>
        </pc:spChg>
        <pc:spChg chg="del mod topLvl">
          <ac:chgData name="vijay kumar" userId="0eb738f014aa4543" providerId="LiveId" clId="{B4DB2928-3EFF-4507-ABD0-3894F091460A}" dt="2020-05-02T18:02:59.213" v="5158" actId="478"/>
          <ac:spMkLst>
            <pc:docMk/>
            <pc:sldMk cId="2863535548" sldId="354"/>
            <ac:spMk id="57" creationId="{128324E6-91BD-4DA5-9813-6E2FBA2A7484}"/>
          </ac:spMkLst>
        </pc:spChg>
        <pc:spChg chg="mod ord topLvl">
          <ac:chgData name="vijay kumar" userId="0eb738f014aa4543" providerId="LiveId" clId="{B4DB2928-3EFF-4507-ABD0-3894F091460A}" dt="2020-05-07T11:07:59.161" v="12726" actId="1076"/>
          <ac:spMkLst>
            <pc:docMk/>
            <pc:sldMk cId="2863535548" sldId="354"/>
            <ac:spMk id="57" creationId="{3B564B32-8352-4A7E-BCAA-D198D619D137}"/>
          </ac:spMkLst>
        </pc:spChg>
        <pc:spChg chg="del mod topLvl">
          <ac:chgData name="vijay kumar" userId="0eb738f014aa4543" providerId="LiveId" clId="{B4DB2928-3EFF-4507-ABD0-3894F091460A}" dt="2020-05-02T21:11:06.877" v="7035" actId="478"/>
          <ac:spMkLst>
            <pc:docMk/>
            <pc:sldMk cId="2863535548" sldId="354"/>
            <ac:spMk id="57" creationId="{4DB5983E-4423-4D73-B30E-E8BE9F47FF1B}"/>
          </ac:spMkLst>
        </pc:spChg>
        <pc:spChg chg="del mod topLvl">
          <ac:chgData name="vijay kumar" userId="0eb738f014aa4543" providerId="LiveId" clId="{B4DB2928-3EFF-4507-ABD0-3894F091460A}" dt="2020-05-02T18:03:16.214" v="5161" actId="478"/>
          <ac:spMkLst>
            <pc:docMk/>
            <pc:sldMk cId="2863535548" sldId="354"/>
            <ac:spMk id="58" creationId="{3B187792-7359-4DCF-BEFC-1C87E63FF0AF}"/>
          </ac:spMkLst>
        </pc:spChg>
        <pc:spChg chg="del mod topLvl">
          <ac:chgData name="vijay kumar" userId="0eb738f014aa4543" providerId="LiveId" clId="{B4DB2928-3EFF-4507-ABD0-3894F091460A}" dt="2020-05-02T21:11:06.877" v="7035" actId="478"/>
          <ac:spMkLst>
            <pc:docMk/>
            <pc:sldMk cId="2863535548" sldId="354"/>
            <ac:spMk id="58" creationId="{6C0548E1-D04F-4247-95FC-2B9DF60688E4}"/>
          </ac:spMkLst>
        </pc:spChg>
        <pc:spChg chg="mod ord topLvl">
          <ac:chgData name="vijay kumar" userId="0eb738f014aa4543" providerId="LiveId" clId="{B4DB2928-3EFF-4507-ABD0-3894F091460A}" dt="2020-05-07T11:07:59.161" v="12726" actId="1076"/>
          <ac:spMkLst>
            <pc:docMk/>
            <pc:sldMk cId="2863535548" sldId="354"/>
            <ac:spMk id="58" creationId="{A53B80C2-C3BB-482A-81BD-0A3376632A7F}"/>
          </ac:spMkLst>
        </pc:spChg>
        <pc:spChg chg="del mod topLvl">
          <ac:chgData name="vijay kumar" userId="0eb738f014aa4543" providerId="LiveId" clId="{B4DB2928-3EFF-4507-ABD0-3894F091460A}" dt="2020-05-02T18:02:59.213" v="5158" actId="478"/>
          <ac:spMkLst>
            <pc:docMk/>
            <pc:sldMk cId="2863535548" sldId="354"/>
            <ac:spMk id="59" creationId="{6CD51536-59A6-4A7C-9C28-7EFA279EDFE2}"/>
          </ac:spMkLst>
        </pc:spChg>
        <pc:spChg chg="mod ord topLvl">
          <ac:chgData name="vijay kumar" userId="0eb738f014aa4543" providerId="LiveId" clId="{B4DB2928-3EFF-4507-ABD0-3894F091460A}" dt="2020-05-07T11:07:59.161" v="12726" actId="1076"/>
          <ac:spMkLst>
            <pc:docMk/>
            <pc:sldMk cId="2863535548" sldId="354"/>
            <ac:spMk id="59" creationId="{CA391BEC-8E5F-4837-91A0-6370D21E24B3}"/>
          </ac:spMkLst>
        </pc:spChg>
        <pc:spChg chg="del mod topLvl">
          <ac:chgData name="vijay kumar" userId="0eb738f014aa4543" providerId="LiveId" clId="{B4DB2928-3EFF-4507-ABD0-3894F091460A}" dt="2020-05-02T21:11:06.877" v="7035" actId="478"/>
          <ac:spMkLst>
            <pc:docMk/>
            <pc:sldMk cId="2863535548" sldId="354"/>
            <ac:spMk id="59" creationId="{DF1EDB1C-3BDC-4EE6-A3AB-215AFD87661B}"/>
          </ac:spMkLst>
        </pc:spChg>
        <pc:spChg chg="del mod topLvl">
          <ac:chgData name="vijay kumar" userId="0eb738f014aa4543" providerId="LiveId" clId="{B4DB2928-3EFF-4507-ABD0-3894F091460A}" dt="2020-05-02T18:03:16.214" v="5161" actId="478"/>
          <ac:spMkLst>
            <pc:docMk/>
            <pc:sldMk cId="2863535548" sldId="354"/>
            <ac:spMk id="60" creationId="{11BBED78-2225-47F0-B077-E083CED1DBD7}"/>
          </ac:spMkLst>
        </pc:spChg>
        <pc:spChg chg="del mod topLvl">
          <ac:chgData name="vijay kumar" userId="0eb738f014aa4543" providerId="LiveId" clId="{B4DB2928-3EFF-4507-ABD0-3894F091460A}" dt="2020-05-02T21:11:06.877" v="7035" actId="478"/>
          <ac:spMkLst>
            <pc:docMk/>
            <pc:sldMk cId="2863535548" sldId="354"/>
            <ac:spMk id="60" creationId="{90C4D069-3E31-4661-8123-9D52CBDF2704}"/>
          </ac:spMkLst>
        </pc:spChg>
        <pc:spChg chg="mod ord topLvl">
          <ac:chgData name="vijay kumar" userId="0eb738f014aa4543" providerId="LiveId" clId="{B4DB2928-3EFF-4507-ABD0-3894F091460A}" dt="2020-05-07T11:07:59.161" v="12726" actId="1076"/>
          <ac:spMkLst>
            <pc:docMk/>
            <pc:sldMk cId="2863535548" sldId="354"/>
            <ac:spMk id="60" creationId="{E07ADA72-22C8-4152-9565-A2ABABF2F537}"/>
          </ac:spMkLst>
        </pc:spChg>
        <pc:spChg chg="mod ord topLvl">
          <ac:chgData name="vijay kumar" userId="0eb738f014aa4543" providerId="LiveId" clId="{B4DB2928-3EFF-4507-ABD0-3894F091460A}" dt="2020-05-07T11:07:59.161" v="12726" actId="1076"/>
          <ac:spMkLst>
            <pc:docMk/>
            <pc:sldMk cId="2863535548" sldId="354"/>
            <ac:spMk id="61" creationId="{009E9140-959E-43F1-9BC4-E0AFED31D2F2}"/>
          </ac:spMkLst>
        </pc:spChg>
        <pc:spChg chg="del mod topLvl">
          <ac:chgData name="vijay kumar" userId="0eb738f014aa4543" providerId="LiveId" clId="{B4DB2928-3EFF-4507-ABD0-3894F091460A}" dt="2020-05-02T21:11:06.877" v="7035" actId="478"/>
          <ac:spMkLst>
            <pc:docMk/>
            <pc:sldMk cId="2863535548" sldId="354"/>
            <ac:spMk id="61" creationId="{55A9C8E4-AD0F-4484-A4BD-F88B20969A76}"/>
          </ac:spMkLst>
        </pc:spChg>
        <pc:spChg chg="del mod topLvl">
          <ac:chgData name="vijay kumar" userId="0eb738f014aa4543" providerId="LiveId" clId="{B4DB2928-3EFF-4507-ABD0-3894F091460A}" dt="2020-05-02T18:02:59.213" v="5158" actId="478"/>
          <ac:spMkLst>
            <pc:docMk/>
            <pc:sldMk cId="2863535548" sldId="354"/>
            <ac:spMk id="61" creationId="{897A562A-EC68-49BD-9A2A-9B23CA72E479}"/>
          </ac:spMkLst>
        </pc:spChg>
        <pc:spChg chg="del mod topLvl">
          <ac:chgData name="vijay kumar" userId="0eb738f014aa4543" providerId="LiveId" clId="{B4DB2928-3EFF-4507-ABD0-3894F091460A}" dt="2020-05-02T18:03:16.214" v="5161" actId="478"/>
          <ac:spMkLst>
            <pc:docMk/>
            <pc:sldMk cId="2863535548" sldId="354"/>
            <ac:spMk id="62" creationId="{08D5AFD8-D3B7-4F21-8585-F36223A8B6F5}"/>
          </ac:spMkLst>
        </pc:spChg>
        <pc:spChg chg="del mod topLvl">
          <ac:chgData name="vijay kumar" userId="0eb738f014aa4543" providerId="LiveId" clId="{B4DB2928-3EFF-4507-ABD0-3894F091460A}" dt="2020-05-02T21:11:06.877" v="7035" actId="478"/>
          <ac:spMkLst>
            <pc:docMk/>
            <pc:sldMk cId="2863535548" sldId="354"/>
            <ac:spMk id="62" creationId="{1015FC6F-3D5E-47EC-8D83-17280F111250}"/>
          </ac:spMkLst>
        </pc:spChg>
        <pc:spChg chg="mod topLvl">
          <ac:chgData name="vijay kumar" userId="0eb738f014aa4543" providerId="LiveId" clId="{B4DB2928-3EFF-4507-ABD0-3894F091460A}" dt="2020-05-07T09:59:44.797" v="11343" actId="338"/>
          <ac:spMkLst>
            <pc:docMk/>
            <pc:sldMk cId="2863535548" sldId="354"/>
            <ac:spMk id="62" creationId="{94380E91-E9EE-4C53-8469-06E322BBD89C}"/>
          </ac:spMkLst>
        </pc:spChg>
        <pc:spChg chg="mod topLvl">
          <ac:chgData name="vijay kumar" userId="0eb738f014aa4543" providerId="LiveId" clId="{B4DB2928-3EFF-4507-ABD0-3894F091460A}" dt="2020-05-07T09:59:44.797" v="11343" actId="338"/>
          <ac:spMkLst>
            <pc:docMk/>
            <pc:sldMk cId="2863535548" sldId="354"/>
            <ac:spMk id="63" creationId="{06B3FE89-03BD-4EBE-8426-465BECB4DD86}"/>
          </ac:spMkLst>
        </pc:spChg>
        <pc:spChg chg="del mod topLvl">
          <ac:chgData name="vijay kumar" userId="0eb738f014aa4543" providerId="LiveId" clId="{B4DB2928-3EFF-4507-ABD0-3894F091460A}" dt="2020-05-02T18:02:59.213" v="5158" actId="478"/>
          <ac:spMkLst>
            <pc:docMk/>
            <pc:sldMk cId="2863535548" sldId="354"/>
            <ac:spMk id="63" creationId="{965653BC-6EB2-47DA-9FF3-4E47EC883084}"/>
          </ac:spMkLst>
        </pc:spChg>
        <pc:spChg chg="del mod topLvl">
          <ac:chgData name="vijay kumar" userId="0eb738f014aa4543" providerId="LiveId" clId="{B4DB2928-3EFF-4507-ABD0-3894F091460A}" dt="2020-05-02T21:11:06.877" v="7035" actId="478"/>
          <ac:spMkLst>
            <pc:docMk/>
            <pc:sldMk cId="2863535548" sldId="354"/>
            <ac:spMk id="63" creationId="{B9AB1220-B282-4D5F-917E-3A95F7B1F827}"/>
          </ac:spMkLst>
        </pc:spChg>
        <pc:spChg chg="del mod topLvl">
          <ac:chgData name="vijay kumar" userId="0eb738f014aa4543" providerId="LiveId" clId="{B4DB2928-3EFF-4507-ABD0-3894F091460A}" dt="2020-05-02T18:03:16.214" v="5161" actId="478"/>
          <ac:spMkLst>
            <pc:docMk/>
            <pc:sldMk cId="2863535548" sldId="354"/>
            <ac:spMk id="64" creationId="{5D433CEA-EDE4-4382-A925-A8333730A62D}"/>
          </ac:spMkLst>
        </pc:spChg>
        <pc:spChg chg="del mod topLvl">
          <ac:chgData name="vijay kumar" userId="0eb738f014aa4543" providerId="LiveId" clId="{B4DB2928-3EFF-4507-ABD0-3894F091460A}" dt="2020-05-02T21:11:06.877" v="7035" actId="478"/>
          <ac:spMkLst>
            <pc:docMk/>
            <pc:sldMk cId="2863535548" sldId="354"/>
            <ac:spMk id="64" creationId="{63CD04A1-2E19-406A-A38F-DD18000516F8}"/>
          </ac:spMkLst>
        </pc:spChg>
        <pc:spChg chg="mod topLvl">
          <ac:chgData name="vijay kumar" userId="0eb738f014aa4543" providerId="LiveId" clId="{B4DB2928-3EFF-4507-ABD0-3894F091460A}" dt="2020-05-07T09:59:44.797" v="11343" actId="338"/>
          <ac:spMkLst>
            <pc:docMk/>
            <pc:sldMk cId="2863535548" sldId="354"/>
            <ac:spMk id="64" creationId="{D79F6E41-363D-4FB2-82DC-B98254666CDA}"/>
          </ac:spMkLst>
        </pc:spChg>
        <pc:spChg chg="mod topLvl">
          <ac:chgData name="vijay kumar" userId="0eb738f014aa4543" providerId="LiveId" clId="{B4DB2928-3EFF-4507-ABD0-3894F091460A}" dt="2020-05-07T11:07:59.161" v="12726" actId="1076"/>
          <ac:spMkLst>
            <pc:docMk/>
            <pc:sldMk cId="2863535548" sldId="354"/>
            <ac:spMk id="65" creationId="{26935F9E-6E71-410B-966F-8CB02EB1BAAD}"/>
          </ac:spMkLst>
        </pc:spChg>
        <pc:spChg chg="del mod topLvl">
          <ac:chgData name="vijay kumar" userId="0eb738f014aa4543" providerId="LiveId" clId="{B4DB2928-3EFF-4507-ABD0-3894F091460A}" dt="2020-05-02T18:02:59.213" v="5158" actId="478"/>
          <ac:spMkLst>
            <pc:docMk/>
            <pc:sldMk cId="2863535548" sldId="354"/>
            <ac:spMk id="65" creationId="{E0654AF9-AEFA-4716-A3BA-F86A6150524A}"/>
          </ac:spMkLst>
        </pc:spChg>
        <pc:spChg chg="mod topLvl">
          <ac:chgData name="vijay kumar" userId="0eb738f014aa4543" providerId="LiveId" clId="{B4DB2928-3EFF-4507-ABD0-3894F091460A}" dt="2020-05-07T11:07:59.161" v="12726" actId="1076"/>
          <ac:spMkLst>
            <pc:docMk/>
            <pc:sldMk cId="2863535548" sldId="354"/>
            <ac:spMk id="66" creationId="{7E574F66-9210-489C-B9C3-F2F174943C93}"/>
          </ac:spMkLst>
        </pc:spChg>
        <pc:spChg chg="del mod topLvl">
          <ac:chgData name="vijay kumar" userId="0eb738f014aa4543" providerId="LiveId" clId="{B4DB2928-3EFF-4507-ABD0-3894F091460A}" dt="2020-05-02T18:03:16.214" v="5161" actId="478"/>
          <ac:spMkLst>
            <pc:docMk/>
            <pc:sldMk cId="2863535548" sldId="354"/>
            <ac:spMk id="66" creationId="{8983F84A-A06C-4EBC-8CAE-53BA5728877E}"/>
          </ac:spMkLst>
        </pc:spChg>
        <pc:spChg chg="mod topLvl">
          <ac:chgData name="vijay kumar" userId="0eb738f014aa4543" providerId="LiveId" clId="{B4DB2928-3EFF-4507-ABD0-3894F091460A}" dt="2020-05-07T11:07:59.161" v="12726" actId="1076"/>
          <ac:spMkLst>
            <pc:docMk/>
            <pc:sldMk cId="2863535548" sldId="354"/>
            <ac:spMk id="67" creationId="{1160653D-3557-4CEA-9DBC-4946A1093756}"/>
          </ac:spMkLst>
        </pc:spChg>
        <pc:spChg chg="del mod topLvl">
          <ac:chgData name="vijay kumar" userId="0eb738f014aa4543" providerId="LiveId" clId="{B4DB2928-3EFF-4507-ABD0-3894F091460A}" dt="2020-05-02T18:02:59.213" v="5158" actId="478"/>
          <ac:spMkLst>
            <pc:docMk/>
            <pc:sldMk cId="2863535548" sldId="354"/>
            <ac:spMk id="67" creationId="{FF0D68F7-FB86-4663-8E25-0DCE45E81B11}"/>
          </ac:spMkLst>
        </pc:spChg>
        <pc:spChg chg="mod topLvl">
          <ac:chgData name="vijay kumar" userId="0eb738f014aa4543" providerId="LiveId" clId="{B4DB2928-3EFF-4507-ABD0-3894F091460A}" dt="2020-05-07T11:07:59.161" v="12726" actId="1076"/>
          <ac:spMkLst>
            <pc:docMk/>
            <pc:sldMk cId="2863535548" sldId="354"/>
            <ac:spMk id="68" creationId="{01E095C6-AAB4-4678-8AC4-2B92A5848096}"/>
          </ac:spMkLst>
        </pc:spChg>
        <pc:spChg chg="del mod topLvl">
          <ac:chgData name="vijay kumar" userId="0eb738f014aa4543" providerId="LiveId" clId="{B4DB2928-3EFF-4507-ABD0-3894F091460A}" dt="2020-05-02T18:02:59.213" v="5158" actId="478"/>
          <ac:spMkLst>
            <pc:docMk/>
            <pc:sldMk cId="2863535548" sldId="354"/>
            <ac:spMk id="68" creationId="{9D72C696-5757-405C-B4BD-BE8F38697AC9}"/>
          </ac:spMkLst>
        </pc:spChg>
        <pc:spChg chg="del mod topLvl">
          <ac:chgData name="vijay kumar" userId="0eb738f014aa4543" providerId="LiveId" clId="{B4DB2928-3EFF-4507-ABD0-3894F091460A}" dt="2020-05-02T18:02:59.213" v="5158" actId="478"/>
          <ac:spMkLst>
            <pc:docMk/>
            <pc:sldMk cId="2863535548" sldId="354"/>
            <ac:spMk id="69" creationId="{D7F5DE14-C804-47C6-9DF5-C7287C149D6A}"/>
          </ac:spMkLst>
        </pc:spChg>
        <pc:spChg chg="mod topLvl">
          <ac:chgData name="vijay kumar" userId="0eb738f014aa4543" providerId="LiveId" clId="{B4DB2928-3EFF-4507-ABD0-3894F091460A}" dt="2020-05-07T11:07:59.161" v="12726" actId="1076"/>
          <ac:spMkLst>
            <pc:docMk/>
            <pc:sldMk cId="2863535548" sldId="354"/>
            <ac:spMk id="69" creationId="{DF2D046F-B22F-4B1B-9B53-0330BEF2F46C}"/>
          </ac:spMkLst>
        </pc:spChg>
        <pc:spChg chg="mod topLvl">
          <ac:chgData name="vijay kumar" userId="0eb738f014aa4543" providerId="LiveId" clId="{B4DB2928-3EFF-4507-ABD0-3894F091460A}" dt="2020-05-07T11:07:59.161" v="12726" actId="1076"/>
          <ac:spMkLst>
            <pc:docMk/>
            <pc:sldMk cId="2863535548" sldId="354"/>
            <ac:spMk id="70" creationId="{2BA818E3-37A1-4EEC-8E47-3BD2CB848A78}"/>
          </ac:spMkLst>
        </pc:spChg>
        <pc:spChg chg="del mod topLvl">
          <ac:chgData name="vijay kumar" userId="0eb738f014aa4543" providerId="LiveId" clId="{B4DB2928-3EFF-4507-ABD0-3894F091460A}" dt="2020-05-02T18:03:16.214" v="5161" actId="478"/>
          <ac:spMkLst>
            <pc:docMk/>
            <pc:sldMk cId="2863535548" sldId="354"/>
            <ac:spMk id="70" creationId="{76D970F7-199C-4E5D-A3CB-53F03647F0A7}"/>
          </ac:spMkLst>
        </pc:spChg>
        <pc:spChg chg="del mod topLvl">
          <ac:chgData name="vijay kumar" userId="0eb738f014aa4543" providerId="LiveId" clId="{B4DB2928-3EFF-4507-ABD0-3894F091460A}" dt="2020-05-02T18:02:59.213" v="5158" actId="478"/>
          <ac:spMkLst>
            <pc:docMk/>
            <pc:sldMk cId="2863535548" sldId="354"/>
            <ac:spMk id="71" creationId="{15CD3F62-D560-435B-AA95-AB3C85D23228}"/>
          </ac:spMkLst>
        </pc:spChg>
        <pc:spChg chg="mod topLvl">
          <ac:chgData name="vijay kumar" userId="0eb738f014aa4543" providerId="LiveId" clId="{B4DB2928-3EFF-4507-ABD0-3894F091460A}" dt="2020-05-07T11:07:59.161" v="12726" actId="1076"/>
          <ac:spMkLst>
            <pc:docMk/>
            <pc:sldMk cId="2863535548" sldId="354"/>
            <ac:spMk id="71" creationId="{E5E3307E-63C1-4CCF-B490-F58211A7B3DC}"/>
          </ac:spMkLst>
        </pc:spChg>
        <pc:spChg chg="del mod topLvl">
          <ac:chgData name="vijay kumar" userId="0eb738f014aa4543" providerId="LiveId" clId="{B4DB2928-3EFF-4507-ABD0-3894F091460A}" dt="2020-05-02T18:03:16.214" v="5161" actId="478"/>
          <ac:spMkLst>
            <pc:docMk/>
            <pc:sldMk cId="2863535548" sldId="354"/>
            <ac:spMk id="72" creationId="{6A52E638-EB1F-46EA-A6E6-0C39F953D776}"/>
          </ac:spMkLst>
        </pc:spChg>
        <pc:spChg chg="mod topLvl">
          <ac:chgData name="vijay kumar" userId="0eb738f014aa4543" providerId="LiveId" clId="{B4DB2928-3EFF-4507-ABD0-3894F091460A}" dt="2020-05-07T11:07:59.161" v="12726" actId="1076"/>
          <ac:spMkLst>
            <pc:docMk/>
            <pc:sldMk cId="2863535548" sldId="354"/>
            <ac:spMk id="72" creationId="{C315B43A-648C-4DE3-B9FC-C6DEDBF89B3F}"/>
          </ac:spMkLst>
        </pc:spChg>
        <pc:spChg chg="del mod topLvl">
          <ac:chgData name="vijay kumar" userId="0eb738f014aa4543" providerId="LiveId" clId="{B4DB2928-3EFF-4507-ABD0-3894F091460A}" dt="2020-05-02T18:02:59.213" v="5158" actId="478"/>
          <ac:spMkLst>
            <pc:docMk/>
            <pc:sldMk cId="2863535548" sldId="354"/>
            <ac:spMk id="73" creationId="{733D3405-553E-4DC5-B0C9-E5A803285C28}"/>
          </ac:spMkLst>
        </pc:spChg>
        <pc:spChg chg="mod topLvl">
          <ac:chgData name="vijay kumar" userId="0eb738f014aa4543" providerId="LiveId" clId="{B4DB2928-3EFF-4507-ABD0-3894F091460A}" dt="2020-05-07T11:07:59.161" v="12726" actId="1076"/>
          <ac:spMkLst>
            <pc:docMk/>
            <pc:sldMk cId="2863535548" sldId="354"/>
            <ac:spMk id="73" creationId="{F6166161-9DC7-4FEF-B3A7-3BC381ACC41B}"/>
          </ac:spMkLst>
        </pc:spChg>
        <pc:spChg chg="mod topLvl">
          <ac:chgData name="vijay kumar" userId="0eb738f014aa4543" providerId="LiveId" clId="{B4DB2928-3EFF-4507-ABD0-3894F091460A}" dt="2020-05-07T11:07:59.161" v="12726" actId="1076"/>
          <ac:spMkLst>
            <pc:docMk/>
            <pc:sldMk cId="2863535548" sldId="354"/>
            <ac:spMk id="74" creationId="{CA599F91-D685-4114-A095-73E4BB31EBEC}"/>
          </ac:spMkLst>
        </pc:spChg>
        <pc:spChg chg="mod topLvl">
          <ac:chgData name="vijay kumar" userId="0eb738f014aa4543" providerId="LiveId" clId="{B4DB2928-3EFF-4507-ABD0-3894F091460A}" dt="2020-05-07T11:07:59.161" v="12726" actId="1076"/>
          <ac:spMkLst>
            <pc:docMk/>
            <pc:sldMk cId="2863535548" sldId="354"/>
            <ac:spMk id="77" creationId="{39BABC45-06A0-4F7C-8072-9B1703E0C5C3}"/>
          </ac:spMkLst>
        </pc:spChg>
        <pc:spChg chg="mod topLvl">
          <ac:chgData name="vijay kumar" userId="0eb738f014aa4543" providerId="LiveId" clId="{B4DB2928-3EFF-4507-ABD0-3894F091460A}" dt="2020-05-07T11:07:59.161" v="12726" actId="1076"/>
          <ac:spMkLst>
            <pc:docMk/>
            <pc:sldMk cId="2863535548" sldId="354"/>
            <ac:spMk id="78" creationId="{B2D64F0C-337E-49A5-A78F-FB523CB15B83}"/>
          </ac:spMkLst>
        </pc:spChg>
        <pc:spChg chg="del mod topLvl">
          <ac:chgData name="vijay kumar" userId="0eb738f014aa4543" providerId="LiveId" clId="{B4DB2928-3EFF-4507-ABD0-3894F091460A}" dt="2020-05-02T18:25:27.252" v="6032" actId="478"/>
          <ac:spMkLst>
            <pc:docMk/>
            <pc:sldMk cId="2863535548" sldId="354"/>
            <ac:spMk id="79" creationId="{94E54781-98CC-407D-B6F7-A84AB8B57F58}"/>
          </ac:spMkLst>
        </pc:spChg>
        <pc:spChg chg="mod topLvl">
          <ac:chgData name="vijay kumar" userId="0eb738f014aa4543" providerId="LiveId" clId="{B4DB2928-3EFF-4507-ABD0-3894F091460A}" dt="2020-05-07T11:07:59.161" v="12726" actId="1076"/>
          <ac:spMkLst>
            <pc:docMk/>
            <pc:sldMk cId="2863535548" sldId="354"/>
            <ac:spMk id="79" creationId="{A6D01FB8-7BF5-4333-847C-4E5346430A34}"/>
          </ac:spMkLst>
        </pc:spChg>
        <pc:spChg chg="mod topLvl">
          <ac:chgData name="vijay kumar" userId="0eb738f014aa4543" providerId="LiveId" clId="{B4DB2928-3EFF-4507-ABD0-3894F091460A}" dt="2020-05-07T11:07:59.161" v="12726" actId="1076"/>
          <ac:spMkLst>
            <pc:docMk/>
            <pc:sldMk cId="2863535548" sldId="354"/>
            <ac:spMk id="80" creationId="{4CB78A01-A12C-4BB4-AB12-B2B2DA5ED600}"/>
          </ac:spMkLst>
        </pc:spChg>
        <pc:spChg chg="mod topLvl">
          <ac:chgData name="vijay kumar" userId="0eb738f014aa4543" providerId="LiveId" clId="{B4DB2928-3EFF-4507-ABD0-3894F091460A}" dt="2020-05-07T11:07:59.161" v="12726" actId="1076"/>
          <ac:spMkLst>
            <pc:docMk/>
            <pc:sldMk cId="2863535548" sldId="354"/>
            <ac:spMk id="81" creationId="{2E204374-5A6F-460C-8BC7-F4D54F53BDD6}"/>
          </ac:spMkLst>
        </pc:spChg>
        <pc:spChg chg="mod topLvl">
          <ac:chgData name="vijay kumar" userId="0eb738f014aa4543" providerId="LiveId" clId="{B4DB2928-3EFF-4507-ABD0-3894F091460A}" dt="2020-05-07T11:07:59.161" v="12726" actId="1076"/>
          <ac:spMkLst>
            <pc:docMk/>
            <pc:sldMk cId="2863535548" sldId="354"/>
            <ac:spMk id="82" creationId="{37512341-307C-4045-900C-7498F4EA2F2E}"/>
          </ac:spMkLst>
        </pc:spChg>
        <pc:spChg chg="mod topLvl">
          <ac:chgData name="vijay kumar" userId="0eb738f014aa4543" providerId="LiveId" clId="{B4DB2928-3EFF-4507-ABD0-3894F091460A}" dt="2020-05-07T11:07:59.161" v="12726" actId="1076"/>
          <ac:spMkLst>
            <pc:docMk/>
            <pc:sldMk cId="2863535548" sldId="354"/>
            <ac:spMk id="83" creationId="{C4965C8A-3608-46F0-B91E-278A69FDACB2}"/>
          </ac:spMkLst>
        </pc:spChg>
        <pc:spChg chg="mod topLvl">
          <ac:chgData name="vijay kumar" userId="0eb738f014aa4543" providerId="LiveId" clId="{B4DB2928-3EFF-4507-ABD0-3894F091460A}" dt="2020-05-07T11:07:59.161" v="12726" actId="1076"/>
          <ac:spMkLst>
            <pc:docMk/>
            <pc:sldMk cId="2863535548" sldId="354"/>
            <ac:spMk id="84" creationId="{ADAA67C6-A22F-4545-A6E2-BE51E59ED468}"/>
          </ac:spMkLst>
        </pc:spChg>
        <pc:spChg chg="mod topLvl">
          <ac:chgData name="vijay kumar" userId="0eb738f014aa4543" providerId="LiveId" clId="{B4DB2928-3EFF-4507-ABD0-3894F091460A}" dt="2020-05-07T11:07:59.161" v="12726" actId="1076"/>
          <ac:spMkLst>
            <pc:docMk/>
            <pc:sldMk cId="2863535548" sldId="354"/>
            <ac:spMk id="85" creationId="{B7BAE8C5-82FF-4889-B82C-956BD5F76B47}"/>
          </ac:spMkLst>
        </pc:spChg>
        <pc:spChg chg="mod topLvl">
          <ac:chgData name="vijay kumar" userId="0eb738f014aa4543" providerId="LiveId" clId="{B4DB2928-3EFF-4507-ABD0-3894F091460A}" dt="2020-05-07T11:07:59.161" v="12726" actId="1076"/>
          <ac:spMkLst>
            <pc:docMk/>
            <pc:sldMk cId="2863535548" sldId="354"/>
            <ac:spMk id="86" creationId="{532A9927-8114-4796-B3B3-79E181E2DC23}"/>
          </ac:spMkLst>
        </pc:spChg>
        <pc:spChg chg="mod topLvl">
          <ac:chgData name="vijay kumar" userId="0eb738f014aa4543" providerId="LiveId" clId="{B4DB2928-3EFF-4507-ABD0-3894F091460A}" dt="2020-05-07T11:07:59.161" v="12726" actId="1076"/>
          <ac:spMkLst>
            <pc:docMk/>
            <pc:sldMk cId="2863535548" sldId="354"/>
            <ac:spMk id="87" creationId="{35FC934C-4077-4723-9DFE-860DB7DDF67C}"/>
          </ac:spMkLst>
        </pc:spChg>
        <pc:spChg chg="mod topLvl">
          <ac:chgData name="vijay kumar" userId="0eb738f014aa4543" providerId="LiveId" clId="{B4DB2928-3EFF-4507-ABD0-3894F091460A}" dt="2020-05-07T11:07:59.161" v="12726" actId="1076"/>
          <ac:spMkLst>
            <pc:docMk/>
            <pc:sldMk cId="2863535548" sldId="354"/>
            <ac:spMk id="88" creationId="{64DF4373-AFAA-4FF1-8B48-5ED495D0AC54}"/>
          </ac:spMkLst>
        </pc:spChg>
        <pc:spChg chg="mod topLvl">
          <ac:chgData name="vijay kumar" userId="0eb738f014aa4543" providerId="LiveId" clId="{B4DB2928-3EFF-4507-ABD0-3894F091460A}" dt="2020-05-07T11:07:59.161" v="12726" actId="1076"/>
          <ac:spMkLst>
            <pc:docMk/>
            <pc:sldMk cId="2863535548" sldId="354"/>
            <ac:spMk id="89" creationId="{DFDCB209-6D6E-4470-9A32-05C9C6EB0BE2}"/>
          </ac:spMkLst>
        </pc:spChg>
        <pc:spChg chg="mod topLvl">
          <ac:chgData name="vijay kumar" userId="0eb738f014aa4543" providerId="LiveId" clId="{B4DB2928-3EFF-4507-ABD0-3894F091460A}" dt="2020-05-07T11:07:59.161" v="12726" actId="1076"/>
          <ac:spMkLst>
            <pc:docMk/>
            <pc:sldMk cId="2863535548" sldId="354"/>
            <ac:spMk id="90" creationId="{C4E6585D-64A8-498C-899B-97EEFA7066EB}"/>
          </ac:spMkLst>
        </pc:spChg>
        <pc:spChg chg="mod topLvl">
          <ac:chgData name="vijay kumar" userId="0eb738f014aa4543" providerId="LiveId" clId="{B4DB2928-3EFF-4507-ABD0-3894F091460A}" dt="2020-05-07T11:07:59.161" v="12726" actId="1076"/>
          <ac:spMkLst>
            <pc:docMk/>
            <pc:sldMk cId="2863535548" sldId="354"/>
            <ac:spMk id="91" creationId="{514DE3DA-31C9-431E-9D42-36212199883F}"/>
          </ac:spMkLst>
        </pc:spChg>
        <pc:spChg chg="mod topLvl">
          <ac:chgData name="vijay kumar" userId="0eb738f014aa4543" providerId="LiveId" clId="{B4DB2928-3EFF-4507-ABD0-3894F091460A}" dt="2020-05-07T11:07:59.161" v="12726" actId="1076"/>
          <ac:spMkLst>
            <pc:docMk/>
            <pc:sldMk cId="2863535548" sldId="354"/>
            <ac:spMk id="92" creationId="{B82C4594-CC9A-42B4-95FB-8A2F24AF721C}"/>
          </ac:spMkLst>
        </pc:spChg>
        <pc:spChg chg="mod topLvl">
          <ac:chgData name="vijay kumar" userId="0eb738f014aa4543" providerId="LiveId" clId="{B4DB2928-3EFF-4507-ABD0-3894F091460A}" dt="2020-05-07T11:07:59.161" v="12726" actId="1076"/>
          <ac:spMkLst>
            <pc:docMk/>
            <pc:sldMk cId="2863535548" sldId="354"/>
            <ac:spMk id="93" creationId="{02F4BD7A-F141-41C4-9617-5DB6D562FBBE}"/>
          </ac:spMkLst>
        </pc:spChg>
        <pc:spChg chg="mod topLvl">
          <ac:chgData name="vijay kumar" userId="0eb738f014aa4543" providerId="LiveId" clId="{B4DB2928-3EFF-4507-ABD0-3894F091460A}" dt="2020-05-07T11:07:59.161" v="12726" actId="1076"/>
          <ac:spMkLst>
            <pc:docMk/>
            <pc:sldMk cId="2863535548" sldId="354"/>
            <ac:spMk id="94" creationId="{51B3F090-31B7-4B3E-9EEF-7E023501E9A2}"/>
          </ac:spMkLst>
        </pc:spChg>
        <pc:spChg chg="mod topLvl">
          <ac:chgData name="vijay kumar" userId="0eb738f014aa4543" providerId="LiveId" clId="{B4DB2928-3EFF-4507-ABD0-3894F091460A}" dt="2020-05-07T11:07:59.161" v="12726" actId="1076"/>
          <ac:spMkLst>
            <pc:docMk/>
            <pc:sldMk cId="2863535548" sldId="354"/>
            <ac:spMk id="95" creationId="{3C42B359-86E8-4520-8189-3CB109074EBA}"/>
          </ac:spMkLst>
        </pc:spChg>
        <pc:spChg chg="mod topLvl">
          <ac:chgData name="vijay kumar" userId="0eb738f014aa4543" providerId="LiveId" clId="{B4DB2928-3EFF-4507-ABD0-3894F091460A}" dt="2020-05-07T11:07:59.161" v="12726" actId="1076"/>
          <ac:spMkLst>
            <pc:docMk/>
            <pc:sldMk cId="2863535548" sldId="354"/>
            <ac:spMk id="96" creationId="{7815D7B7-5B0A-4DF9-B217-A4AE25EE139E}"/>
          </ac:spMkLst>
        </pc:spChg>
        <pc:spChg chg="mod topLvl">
          <ac:chgData name="vijay kumar" userId="0eb738f014aa4543" providerId="LiveId" clId="{B4DB2928-3EFF-4507-ABD0-3894F091460A}" dt="2020-05-07T11:07:59.161" v="12726" actId="1076"/>
          <ac:spMkLst>
            <pc:docMk/>
            <pc:sldMk cId="2863535548" sldId="354"/>
            <ac:spMk id="97" creationId="{6BAE63E1-EE3E-427C-BEDA-FA40B8AAA2A1}"/>
          </ac:spMkLst>
        </pc:spChg>
        <pc:spChg chg="mod topLvl">
          <ac:chgData name="vijay kumar" userId="0eb738f014aa4543" providerId="LiveId" clId="{B4DB2928-3EFF-4507-ABD0-3894F091460A}" dt="2020-05-07T11:07:59.161" v="12726" actId="1076"/>
          <ac:spMkLst>
            <pc:docMk/>
            <pc:sldMk cId="2863535548" sldId="354"/>
            <ac:spMk id="98" creationId="{3AA475A9-AD57-4A6F-90A7-184AE3871343}"/>
          </ac:spMkLst>
        </pc:spChg>
        <pc:spChg chg="mod topLvl">
          <ac:chgData name="vijay kumar" userId="0eb738f014aa4543" providerId="LiveId" clId="{B4DB2928-3EFF-4507-ABD0-3894F091460A}" dt="2020-05-07T11:07:59.161" v="12726" actId="1076"/>
          <ac:spMkLst>
            <pc:docMk/>
            <pc:sldMk cId="2863535548" sldId="354"/>
            <ac:spMk id="99" creationId="{E87D04C7-2CC7-4DA3-82E7-B8592973709C}"/>
          </ac:spMkLst>
        </pc:spChg>
        <pc:spChg chg="mod topLvl">
          <ac:chgData name="vijay kumar" userId="0eb738f014aa4543" providerId="LiveId" clId="{B4DB2928-3EFF-4507-ABD0-3894F091460A}" dt="2020-05-07T11:07:59.161" v="12726" actId="1076"/>
          <ac:spMkLst>
            <pc:docMk/>
            <pc:sldMk cId="2863535548" sldId="354"/>
            <ac:spMk id="100" creationId="{B90388B2-E5EC-405B-B1AB-FA56F314DAB1}"/>
          </ac:spMkLst>
        </pc:spChg>
        <pc:spChg chg="mod topLvl">
          <ac:chgData name="vijay kumar" userId="0eb738f014aa4543" providerId="LiveId" clId="{B4DB2928-3EFF-4507-ABD0-3894F091460A}" dt="2020-05-07T11:07:59.161" v="12726" actId="1076"/>
          <ac:spMkLst>
            <pc:docMk/>
            <pc:sldMk cId="2863535548" sldId="354"/>
            <ac:spMk id="101" creationId="{04BB6191-6A1D-4211-92F5-060CC03825B8}"/>
          </ac:spMkLst>
        </pc:spChg>
        <pc:spChg chg="mod topLvl">
          <ac:chgData name="vijay kumar" userId="0eb738f014aa4543" providerId="LiveId" clId="{B4DB2928-3EFF-4507-ABD0-3894F091460A}" dt="2020-05-07T11:07:59.161" v="12726" actId="1076"/>
          <ac:spMkLst>
            <pc:docMk/>
            <pc:sldMk cId="2863535548" sldId="354"/>
            <ac:spMk id="102" creationId="{5FA74492-573C-407E-8B27-EB42E78DFC57}"/>
          </ac:spMkLst>
        </pc:spChg>
        <pc:spChg chg="mod topLvl">
          <ac:chgData name="vijay kumar" userId="0eb738f014aa4543" providerId="LiveId" clId="{B4DB2928-3EFF-4507-ABD0-3894F091460A}" dt="2020-05-07T11:07:59.161" v="12726" actId="1076"/>
          <ac:spMkLst>
            <pc:docMk/>
            <pc:sldMk cId="2863535548" sldId="354"/>
            <ac:spMk id="103" creationId="{374E11B3-A06A-4CE9-9972-E80585ACE190}"/>
          </ac:spMkLst>
        </pc:spChg>
        <pc:spChg chg="mod topLvl">
          <ac:chgData name="vijay kumar" userId="0eb738f014aa4543" providerId="LiveId" clId="{B4DB2928-3EFF-4507-ABD0-3894F091460A}" dt="2020-05-07T11:07:59.161" v="12726" actId="1076"/>
          <ac:spMkLst>
            <pc:docMk/>
            <pc:sldMk cId="2863535548" sldId="354"/>
            <ac:spMk id="104" creationId="{F70C0688-7EDF-45D1-90FC-AC8DB8DDBBE6}"/>
          </ac:spMkLst>
        </pc:spChg>
        <pc:spChg chg="mod topLvl">
          <ac:chgData name="vijay kumar" userId="0eb738f014aa4543" providerId="LiveId" clId="{B4DB2928-3EFF-4507-ABD0-3894F091460A}" dt="2020-05-07T11:07:59.161" v="12726" actId="1076"/>
          <ac:spMkLst>
            <pc:docMk/>
            <pc:sldMk cId="2863535548" sldId="354"/>
            <ac:spMk id="105" creationId="{38A8EF3F-88FF-4BE1-9C2C-2181AE86BBCD}"/>
          </ac:spMkLst>
        </pc:spChg>
        <pc:spChg chg="mod topLvl">
          <ac:chgData name="vijay kumar" userId="0eb738f014aa4543" providerId="LiveId" clId="{B4DB2928-3EFF-4507-ABD0-3894F091460A}" dt="2020-05-07T11:07:59.161" v="12726" actId="1076"/>
          <ac:spMkLst>
            <pc:docMk/>
            <pc:sldMk cId="2863535548" sldId="354"/>
            <ac:spMk id="106" creationId="{4BEA7905-41B5-4A78-B589-32E1E2E99957}"/>
          </ac:spMkLst>
        </pc:spChg>
        <pc:spChg chg="mod topLvl">
          <ac:chgData name="vijay kumar" userId="0eb738f014aa4543" providerId="LiveId" clId="{B4DB2928-3EFF-4507-ABD0-3894F091460A}" dt="2020-05-07T11:07:59.161" v="12726" actId="1076"/>
          <ac:spMkLst>
            <pc:docMk/>
            <pc:sldMk cId="2863535548" sldId="354"/>
            <ac:spMk id="107" creationId="{2CD5F4FE-F6FC-485A-9855-1FCCE81ECA49}"/>
          </ac:spMkLst>
        </pc:spChg>
        <pc:spChg chg="mod topLvl">
          <ac:chgData name="vijay kumar" userId="0eb738f014aa4543" providerId="LiveId" clId="{B4DB2928-3EFF-4507-ABD0-3894F091460A}" dt="2020-05-07T11:07:59.161" v="12726" actId="1076"/>
          <ac:spMkLst>
            <pc:docMk/>
            <pc:sldMk cId="2863535548" sldId="354"/>
            <ac:spMk id="108" creationId="{1DB24888-8E6D-4EF8-9A15-245172B69011}"/>
          </ac:spMkLst>
        </pc:spChg>
        <pc:spChg chg="mod topLvl">
          <ac:chgData name="vijay kumar" userId="0eb738f014aa4543" providerId="LiveId" clId="{B4DB2928-3EFF-4507-ABD0-3894F091460A}" dt="2020-05-07T11:07:59.161" v="12726" actId="1076"/>
          <ac:spMkLst>
            <pc:docMk/>
            <pc:sldMk cId="2863535548" sldId="354"/>
            <ac:spMk id="109" creationId="{0816D424-B4F8-4988-BD58-1E4E10F28B56}"/>
          </ac:spMkLst>
        </pc:spChg>
        <pc:spChg chg="mod topLvl">
          <ac:chgData name="vijay kumar" userId="0eb738f014aa4543" providerId="LiveId" clId="{B4DB2928-3EFF-4507-ABD0-3894F091460A}" dt="2020-05-07T09:59:44.797" v="11343" actId="338"/>
          <ac:spMkLst>
            <pc:docMk/>
            <pc:sldMk cId="2863535548" sldId="354"/>
            <ac:spMk id="110" creationId="{11B62781-B0DD-4A39-9F9E-6B72E180BDB8}"/>
          </ac:spMkLst>
        </pc:spChg>
        <pc:spChg chg="mod topLvl">
          <ac:chgData name="vijay kumar" userId="0eb738f014aa4543" providerId="LiveId" clId="{B4DB2928-3EFF-4507-ABD0-3894F091460A}" dt="2020-05-07T09:59:44.797" v="11343" actId="338"/>
          <ac:spMkLst>
            <pc:docMk/>
            <pc:sldMk cId="2863535548" sldId="354"/>
            <ac:spMk id="111" creationId="{61FFA323-A9E3-44C7-95BF-17EA8A1E8725}"/>
          </ac:spMkLst>
        </pc:spChg>
        <pc:spChg chg="mod topLvl">
          <ac:chgData name="vijay kumar" userId="0eb738f014aa4543" providerId="LiveId" clId="{B4DB2928-3EFF-4507-ABD0-3894F091460A}" dt="2020-05-07T09:59:44.797" v="11343" actId="338"/>
          <ac:spMkLst>
            <pc:docMk/>
            <pc:sldMk cId="2863535548" sldId="354"/>
            <ac:spMk id="112" creationId="{D48F27CF-AB8D-4519-A3FF-704C38CBF365}"/>
          </ac:spMkLst>
        </pc:spChg>
        <pc:spChg chg="mod topLvl">
          <ac:chgData name="vijay kumar" userId="0eb738f014aa4543" providerId="LiveId" clId="{B4DB2928-3EFF-4507-ABD0-3894F091460A}" dt="2020-05-07T09:59:44.797" v="11343" actId="338"/>
          <ac:spMkLst>
            <pc:docMk/>
            <pc:sldMk cId="2863535548" sldId="354"/>
            <ac:spMk id="113" creationId="{847E16FC-3965-4939-9B69-68A3578A31D0}"/>
          </ac:spMkLst>
        </pc:spChg>
        <pc:spChg chg="mod topLvl">
          <ac:chgData name="vijay kumar" userId="0eb738f014aa4543" providerId="LiveId" clId="{B4DB2928-3EFF-4507-ABD0-3894F091460A}" dt="2020-05-07T09:59:44.797" v="11343" actId="338"/>
          <ac:spMkLst>
            <pc:docMk/>
            <pc:sldMk cId="2863535548" sldId="354"/>
            <ac:spMk id="114" creationId="{CBF79572-34FE-4B3E-8459-39CAAB8BB7E4}"/>
          </ac:spMkLst>
        </pc:spChg>
        <pc:spChg chg="mod topLvl">
          <ac:chgData name="vijay kumar" userId="0eb738f014aa4543" providerId="LiveId" clId="{B4DB2928-3EFF-4507-ABD0-3894F091460A}" dt="2020-05-07T09:59:44.797" v="11343" actId="338"/>
          <ac:spMkLst>
            <pc:docMk/>
            <pc:sldMk cId="2863535548" sldId="354"/>
            <ac:spMk id="115" creationId="{9B35741E-6877-4321-842A-08649BCCD1E2}"/>
          </ac:spMkLst>
        </pc:spChg>
        <pc:spChg chg="mod topLvl">
          <ac:chgData name="vijay kumar" userId="0eb738f014aa4543" providerId="LiveId" clId="{B4DB2928-3EFF-4507-ABD0-3894F091460A}" dt="2020-05-07T09:59:44.797" v="11343" actId="338"/>
          <ac:spMkLst>
            <pc:docMk/>
            <pc:sldMk cId="2863535548" sldId="354"/>
            <ac:spMk id="116" creationId="{44FACCA4-2CAE-4A2A-852D-AF63DC2265B8}"/>
          </ac:spMkLst>
        </pc:spChg>
        <pc:spChg chg="mod topLvl">
          <ac:chgData name="vijay kumar" userId="0eb738f014aa4543" providerId="LiveId" clId="{B4DB2928-3EFF-4507-ABD0-3894F091460A}" dt="2020-05-07T09:59:44.797" v="11343" actId="338"/>
          <ac:spMkLst>
            <pc:docMk/>
            <pc:sldMk cId="2863535548" sldId="354"/>
            <ac:spMk id="117" creationId="{EAB0842B-B33A-408D-BC6E-ACA73D52D4DC}"/>
          </ac:spMkLst>
        </pc:spChg>
        <pc:spChg chg="mod topLvl">
          <ac:chgData name="vijay kumar" userId="0eb738f014aa4543" providerId="LiveId" clId="{B4DB2928-3EFF-4507-ABD0-3894F091460A}" dt="2020-05-07T09:59:44.797" v="11343" actId="338"/>
          <ac:spMkLst>
            <pc:docMk/>
            <pc:sldMk cId="2863535548" sldId="354"/>
            <ac:spMk id="118" creationId="{C644D807-BB4F-461B-94DA-01A2742F2F1D}"/>
          </ac:spMkLst>
        </pc:spChg>
        <pc:spChg chg="mod topLvl">
          <ac:chgData name="vijay kumar" userId="0eb738f014aa4543" providerId="LiveId" clId="{B4DB2928-3EFF-4507-ABD0-3894F091460A}" dt="2020-05-07T09:59:44.797" v="11343" actId="338"/>
          <ac:spMkLst>
            <pc:docMk/>
            <pc:sldMk cId="2863535548" sldId="354"/>
            <ac:spMk id="119" creationId="{C0E90BDC-C224-40A0-8661-9BF9831AA8D9}"/>
          </ac:spMkLst>
        </pc:spChg>
        <pc:spChg chg="mod topLvl">
          <ac:chgData name="vijay kumar" userId="0eb738f014aa4543" providerId="LiveId" clId="{B4DB2928-3EFF-4507-ABD0-3894F091460A}" dt="2020-05-07T09:59:44.797" v="11343" actId="338"/>
          <ac:spMkLst>
            <pc:docMk/>
            <pc:sldMk cId="2863535548" sldId="354"/>
            <ac:spMk id="120" creationId="{1DF5FE58-2221-4171-8310-1BD92E4C5B7A}"/>
          </ac:spMkLst>
        </pc:spChg>
        <pc:spChg chg="mod topLvl">
          <ac:chgData name="vijay kumar" userId="0eb738f014aa4543" providerId="LiveId" clId="{B4DB2928-3EFF-4507-ABD0-3894F091460A}" dt="2020-05-07T09:59:44.797" v="11343" actId="338"/>
          <ac:spMkLst>
            <pc:docMk/>
            <pc:sldMk cId="2863535548" sldId="354"/>
            <ac:spMk id="121" creationId="{5433EE86-04A4-4E65-A9CE-FA129FE9F159}"/>
          </ac:spMkLst>
        </pc:spChg>
        <pc:spChg chg="mod topLvl">
          <ac:chgData name="vijay kumar" userId="0eb738f014aa4543" providerId="LiveId" clId="{B4DB2928-3EFF-4507-ABD0-3894F091460A}" dt="2020-05-07T09:59:44.797" v="11343" actId="338"/>
          <ac:spMkLst>
            <pc:docMk/>
            <pc:sldMk cId="2863535548" sldId="354"/>
            <ac:spMk id="122" creationId="{93B9857F-42C3-4A16-960F-386DF9496CB0}"/>
          </ac:spMkLst>
        </pc:spChg>
        <pc:spChg chg="mod topLvl">
          <ac:chgData name="vijay kumar" userId="0eb738f014aa4543" providerId="LiveId" clId="{B4DB2928-3EFF-4507-ABD0-3894F091460A}" dt="2020-05-07T09:59:44.797" v="11343" actId="338"/>
          <ac:spMkLst>
            <pc:docMk/>
            <pc:sldMk cId="2863535548" sldId="354"/>
            <ac:spMk id="123" creationId="{E985A584-4A73-474D-8DF1-B6134682125F}"/>
          </ac:spMkLst>
        </pc:spChg>
        <pc:spChg chg="mod topLvl">
          <ac:chgData name="vijay kumar" userId="0eb738f014aa4543" providerId="LiveId" clId="{B4DB2928-3EFF-4507-ABD0-3894F091460A}" dt="2020-05-07T09:59:44.797" v="11343" actId="338"/>
          <ac:spMkLst>
            <pc:docMk/>
            <pc:sldMk cId="2863535548" sldId="354"/>
            <ac:spMk id="124" creationId="{E674DFC6-3DAB-4BFF-83AF-0B927E13DEE4}"/>
          </ac:spMkLst>
        </pc:spChg>
        <pc:spChg chg="mod topLvl">
          <ac:chgData name="vijay kumar" userId="0eb738f014aa4543" providerId="LiveId" clId="{B4DB2928-3EFF-4507-ABD0-3894F091460A}" dt="2020-05-07T09:59:44.797" v="11343" actId="338"/>
          <ac:spMkLst>
            <pc:docMk/>
            <pc:sldMk cId="2863535548" sldId="354"/>
            <ac:spMk id="125" creationId="{C1937403-B2CF-4A34-835F-691C50BEDD38}"/>
          </ac:spMkLst>
        </pc:spChg>
        <pc:spChg chg="mod topLvl">
          <ac:chgData name="vijay kumar" userId="0eb738f014aa4543" providerId="LiveId" clId="{B4DB2928-3EFF-4507-ABD0-3894F091460A}" dt="2020-05-07T09:59:44.797" v="11343" actId="338"/>
          <ac:spMkLst>
            <pc:docMk/>
            <pc:sldMk cId="2863535548" sldId="354"/>
            <ac:spMk id="126" creationId="{B7749986-D6A5-45BA-8CF5-DF142948108B}"/>
          </ac:spMkLst>
        </pc:spChg>
        <pc:spChg chg="mod topLvl">
          <ac:chgData name="vijay kumar" userId="0eb738f014aa4543" providerId="LiveId" clId="{B4DB2928-3EFF-4507-ABD0-3894F091460A}" dt="2020-05-07T09:59:44.797" v="11343" actId="338"/>
          <ac:spMkLst>
            <pc:docMk/>
            <pc:sldMk cId="2863535548" sldId="354"/>
            <ac:spMk id="127" creationId="{58963D4C-9036-4A01-BB25-62B1EF052E44}"/>
          </ac:spMkLst>
        </pc:spChg>
        <pc:spChg chg="mod topLvl">
          <ac:chgData name="vijay kumar" userId="0eb738f014aa4543" providerId="LiveId" clId="{B4DB2928-3EFF-4507-ABD0-3894F091460A}" dt="2020-05-07T09:59:44.797" v="11343" actId="338"/>
          <ac:spMkLst>
            <pc:docMk/>
            <pc:sldMk cId="2863535548" sldId="354"/>
            <ac:spMk id="128" creationId="{935A4CA2-206D-481A-ABD4-7EE334766717}"/>
          </ac:spMkLst>
        </pc:spChg>
        <pc:spChg chg="mod topLvl">
          <ac:chgData name="vijay kumar" userId="0eb738f014aa4543" providerId="LiveId" clId="{B4DB2928-3EFF-4507-ABD0-3894F091460A}" dt="2020-05-07T09:59:44.797" v="11343" actId="338"/>
          <ac:spMkLst>
            <pc:docMk/>
            <pc:sldMk cId="2863535548" sldId="354"/>
            <ac:spMk id="129" creationId="{5AC4D9DF-C3DF-4BC3-8365-186F3B1F26C1}"/>
          </ac:spMkLst>
        </pc:spChg>
        <pc:spChg chg="mod topLvl">
          <ac:chgData name="vijay kumar" userId="0eb738f014aa4543" providerId="LiveId" clId="{B4DB2928-3EFF-4507-ABD0-3894F091460A}" dt="2020-05-07T09:59:44.797" v="11343" actId="338"/>
          <ac:spMkLst>
            <pc:docMk/>
            <pc:sldMk cId="2863535548" sldId="354"/>
            <ac:spMk id="130" creationId="{42D41460-F57C-432F-8F5F-1197B9B7C827}"/>
          </ac:spMkLst>
        </pc:spChg>
        <pc:spChg chg="mod topLvl">
          <ac:chgData name="vijay kumar" userId="0eb738f014aa4543" providerId="LiveId" clId="{B4DB2928-3EFF-4507-ABD0-3894F091460A}" dt="2020-05-07T09:59:44.797" v="11343" actId="338"/>
          <ac:spMkLst>
            <pc:docMk/>
            <pc:sldMk cId="2863535548" sldId="354"/>
            <ac:spMk id="131" creationId="{A2329763-A9E0-4303-9B02-12283A92295D}"/>
          </ac:spMkLst>
        </pc:spChg>
        <pc:spChg chg="mod topLvl">
          <ac:chgData name="vijay kumar" userId="0eb738f014aa4543" providerId="LiveId" clId="{B4DB2928-3EFF-4507-ABD0-3894F091460A}" dt="2020-05-07T09:59:44.797" v="11343" actId="338"/>
          <ac:spMkLst>
            <pc:docMk/>
            <pc:sldMk cId="2863535548" sldId="354"/>
            <ac:spMk id="132" creationId="{B88FEC06-8F3C-4675-9D51-94E99E603193}"/>
          </ac:spMkLst>
        </pc:spChg>
        <pc:spChg chg="mod topLvl">
          <ac:chgData name="vijay kumar" userId="0eb738f014aa4543" providerId="LiveId" clId="{B4DB2928-3EFF-4507-ABD0-3894F091460A}" dt="2020-05-07T09:59:44.797" v="11343" actId="338"/>
          <ac:spMkLst>
            <pc:docMk/>
            <pc:sldMk cId="2863535548" sldId="354"/>
            <ac:spMk id="133" creationId="{A5A276B9-0E90-43E4-8DFF-E5B777AAB0DF}"/>
          </ac:spMkLst>
        </pc:spChg>
        <pc:spChg chg="mod topLvl">
          <ac:chgData name="vijay kumar" userId="0eb738f014aa4543" providerId="LiveId" clId="{B4DB2928-3EFF-4507-ABD0-3894F091460A}" dt="2020-05-07T09:59:44.797" v="11343" actId="338"/>
          <ac:spMkLst>
            <pc:docMk/>
            <pc:sldMk cId="2863535548" sldId="354"/>
            <ac:spMk id="134" creationId="{24BCE755-9D72-474B-A25D-4242CD711792}"/>
          </ac:spMkLst>
        </pc:spChg>
        <pc:spChg chg="mod topLvl">
          <ac:chgData name="vijay kumar" userId="0eb738f014aa4543" providerId="LiveId" clId="{B4DB2928-3EFF-4507-ABD0-3894F091460A}" dt="2020-05-07T09:59:44.797" v="11343" actId="338"/>
          <ac:spMkLst>
            <pc:docMk/>
            <pc:sldMk cId="2863535548" sldId="354"/>
            <ac:spMk id="135" creationId="{4A5F84F3-61DB-421A-B454-D8DC46205B9F}"/>
          </ac:spMkLst>
        </pc:spChg>
        <pc:spChg chg="mod topLvl">
          <ac:chgData name="vijay kumar" userId="0eb738f014aa4543" providerId="LiveId" clId="{B4DB2928-3EFF-4507-ABD0-3894F091460A}" dt="2020-05-07T09:59:44.797" v="11343" actId="338"/>
          <ac:spMkLst>
            <pc:docMk/>
            <pc:sldMk cId="2863535548" sldId="354"/>
            <ac:spMk id="136" creationId="{6D3ACF5B-A439-470E-9F3A-6B56C5FF83F0}"/>
          </ac:spMkLst>
        </pc:spChg>
        <pc:spChg chg="mod topLvl">
          <ac:chgData name="vijay kumar" userId="0eb738f014aa4543" providerId="LiveId" clId="{B4DB2928-3EFF-4507-ABD0-3894F091460A}" dt="2020-05-07T09:59:44.797" v="11343" actId="338"/>
          <ac:spMkLst>
            <pc:docMk/>
            <pc:sldMk cId="2863535548" sldId="354"/>
            <ac:spMk id="137" creationId="{0BD5BD56-A7B0-40F3-BA3C-E7F70C111033}"/>
          </ac:spMkLst>
        </pc:spChg>
        <pc:spChg chg="mod topLvl">
          <ac:chgData name="vijay kumar" userId="0eb738f014aa4543" providerId="LiveId" clId="{B4DB2928-3EFF-4507-ABD0-3894F091460A}" dt="2020-05-07T09:59:44.797" v="11343" actId="338"/>
          <ac:spMkLst>
            <pc:docMk/>
            <pc:sldMk cId="2863535548" sldId="354"/>
            <ac:spMk id="138" creationId="{A3992880-6B95-47B3-A166-530B3225E175}"/>
          </ac:spMkLst>
        </pc:spChg>
        <pc:spChg chg="mod topLvl">
          <ac:chgData name="vijay kumar" userId="0eb738f014aa4543" providerId="LiveId" clId="{B4DB2928-3EFF-4507-ABD0-3894F091460A}" dt="2020-05-07T09:59:44.797" v="11343" actId="338"/>
          <ac:spMkLst>
            <pc:docMk/>
            <pc:sldMk cId="2863535548" sldId="354"/>
            <ac:spMk id="139" creationId="{1BEF7EDD-1928-49E4-A099-0B2086604AF6}"/>
          </ac:spMkLst>
        </pc:spChg>
        <pc:spChg chg="mod topLvl">
          <ac:chgData name="vijay kumar" userId="0eb738f014aa4543" providerId="LiveId" clId="{B4DB2928-3EFF-4507-ABD0-3894F091460A}" dt="2020-05-07T11:07:59.161" v="12726" actId="1076"/>
          <ac:spMkLst>
            <pc:docMk/>
            <pc:sldMk cId="2863535548" sldId="354"/>
            <ac:spMk id="140" creationId="{613AB257-69F9-48C1-8A01-E1B44BCB964B}"/>
          </ac:spMkLst>
        </pc:spChg>
        <pc:spChg chg="del mod topLvl">
          <ac:chgData name="vijay kumar" userId="0eb738f014aa4543" providerId="LiveId" clId="{B4DB2928-3EFF-4507-ABD0-3894F091460A}" dt="2020-05-02T18:34:39.863" v="6496" actId="478"/>
          <ac:spMkLst>
            <pc:docMk/>
            <pc:sldMk cId="2863535548" sldId="354"/>
            <ac:spMk id="140" creationId="{8E6E708E-B69D-45BA-9A04-A2F1DE20FD8C}"/>
          </ac:spMkLst>
        </pc:spChg>
        <pc:spChg chg="mod topLvl">
          <ac:chgData name="vijay kumar" userId="0eb738f014aa4543" providerId="LiveId" clId="{B4DB2928-3EFF-4507-ABD0-3894F091460A}" dt="2020-05-07T11:07:59.161" v="12726" actId="1076"/>
          <ac:spMkLst>
            <pc:docMk/>
            <pc:sldMk cId="2863535548" sldId="354"/>
            <ac:spMk id="141" creationId="{A49960C2-78EE-41E5-8A0D-0565C717329C}"/>
          </ac:spMkLst>
        </pc:spChg>
        <pc:spChg chg="del mod topLvl">
          <ac:chgData name="vijay kumar" userId="0eb738f014aa4543" providerId="LiveId" clId="{B4DB2928-3EFF-4507-ABD0-3894F091460A}" dt="2020-05-02T18:26:43.246" v="6042" actId="478"/>
          <ac:spMkLst>
            <pc:docMk/>
            <pc:sldMk cId="2863535548" sldId="354"/>
            <ac:spMk id="141" creationId="{D15F407B-73CC-488D-A9EA-0DC44627137A}"/>
          </ac:spMkLst>
        </pc:spChg>
        <pc:spChg chg="mod topLvl">
          <ac:chgData name="vijay kumar" userId="0eb738f014aa4543" providerId="LiveId" clId="{B4DB2928-3EFF-4507-ABD0-3894F091460A}" dt="2020-05-07T11:07:59.161" v="12726" actId="1076"/>
          <ac:spMkLst>
            <pc:docMk/>
            <pc:sldMk cId="2863535548" sldId="354"/>
            <ac:spMk id="142" creationId="{3A980D0B-11A5-47DD-B845-C2F112803811}"/>
          </ac:spMkLst>
        </pc:spChg>
        <pc:spChg chg="del mod topLvl">
          <ac:chgData name="vijay kumar" userId="0eb738f014aa4543" providerId="LiveId" clId="{B4DB2928-3EFF-4507-ABD0-3894F091460A}" dt="2020-05-02T18:22:21.860" v="5888" actId="478"/>
          <ac:spMkLst>
            <pc:docMk/>
            <pc:sldMk cId="2863535548" sldId="354"/>
            <ac:spMk id="142" creationId="{B904B25B-F35D-4D5D-AF89-3ABBA739E922}"/>
          </ac:spMkLst>
        </pc:spChg>
        <pc:spChg chg="del mod topLvl">
          <ac:chgData name="vijay kumar" userId="0eb738f014aa4543" providerId="LiveId" clId="{B4DB2928-3EFF-4507-ABD0-3894F091460A}" dt="2020-05-02T18:20:54.280" v="5886" actId="478"/>
          <ac:spMkLst>
            <pc:docMk/>
            <pc:sldMk cId="2863535548" sldId="354"/>
            <ac:spMk id="143" creationId="{8CDD3FC5-4ABB-4786-AB05-394E890EB2F4}"/>
          </ac:spMkLst>
        </pc:spChg>
        <pc:spChg chg="mod topLvl">
          <ac:chgData name="vijay kumar" userId="0eb738f014aa4543" providerId="LiveId" clId="{B4DB2928-3EFF-4507-ABD0-3894F091460A}" dt="2020-05-07T11:07:59.161" v="12726" actId="1076"/>
          <ac:spMkLst>
            <pc:docMk/>
            <pc:sldMk cId="2863535548" sldId="354"/>
            <ac:spMk id="143" creationId="{EC3B989F-8E74-4CFD-9D60-7BFC7A2A8825}"/>
          </ac:spMkLst>
        </pc:spChg>
        <pc:spChg chg="mod topLvl">
          <ac:chgData name="vijay kumar" userId="0eb738f014aa4543" providerId="LiveId" clId="{B4DB2928-3EFF-4507-ABD0-3894F091460A}" dt="2020-05-07T11:07:59.161" v="12726" actId="1076"/>
          <ac:spMkLst>
            <pc:docMk/>
            <pc:sldMk cId="2863535548" sldId="354"/>
            <ac:spMk id="144" creationId="{5F7185B6-C819-48EE-8B19-F0FB00D481A7}"/>
          </ac:spMkLst>
        </pc:spChg>
        <pc:spChg chg="del mod topLvl">
          <ac:chgData name="vijay kumar" userId="0eb738f014aa4543" providerId="LiveId" clId="{B4DB2928-3EFF-4507-ABD0-3894F091460A}" dt="2020-05-02T18:25:52.733" v="6036" actId="478"/>
          <ac:spMkLst>
            <pc:docMk/>
            <pc:sldMk cId="2863535548" sldId="354"/>
            <ac:spMk id="144" creationId="{908EACD6-97F4-485B-92C2-A44815C2C5E0}"/>
          </ac:spMkLst>
        </pc:spChg>
        <pc:spChg chg="del mod topLvl">
          <ac:chgData name="vijay kumar" userId="0eb738f014aa4543" providerId="LiveId" clId="{B4DB2928-3EFF-4507-ABD0-3894F091460A}" dt="2020-05-02T18:25:49.156" v="6035" actId="478"/>
          <ac:spMkLst>
            <pc:docMk/>
            <pc:sldMk cId="2863535548" sldId="354"/>
            <ac:spMk id="145" creationId="{1AEE1BCF-4424-4AC8-802B-5C9CBDAAF701}"/>
          </ac:spMkLst>
        </pc:spChg>
        <pc:spChg chg="mod topLvl">
          <ac:chgData name="vijay kumar" userId="0eb738f014aa4543" providerId="LiveId" clId="{B4DB2928-3EFF-4507-ABD0-3894F091460A}" dt="2020-05-07T11:07:59.161" v="12726" actId="1076"/>
          <ac:spMkLst>
            <pc:docMk/>
            <pc:sldMk cId="2863535548" sldId="354"/>
            <ac:spMk id="145" creationId="{409ADEB7-2D25-48E2-B2FE-0CD7D4F23808}"/>
          </ac:spMkLst>
        </pc:spChg>
        <pc:spChg chg="del mod topLvl">
          <ac:chgData name="vijay kumar" userId="0eb738f014aa4543" providerId="LiveId" clId="{B4DB2928-3EFF-4507-ABD0-3894F091460A}" dt="2020-05-02T18:26:12.619" v="6037" actId="478"/>
          <ac:spMkLst>
            <pc:docMk/>
            <pc:sldMk cId="2863535548" sldId="354"/>
            <ac:spMk id="146" creationId="{8220D178-4738-4713-AAED-957C4EE0F4B8}"/>
          </ac:spMkLst>
        </pc:spChg>
        <pc:spChg chg="mod topLvl">
          <ac:chgData name="vijay kumar" userId="0eb738f014aa4543" providerId="LiveId" clId="{B4DB2928-3EFF-4507-ABD0-3894F091460A}" dt="2020-05-07T11:07:59.161" v="12726" actId="1076"/>
          <ac:spMkLst>
            <pc:docMk/>
            <pc:sldMk cId="2863535548" sldId="354"/>
            <ac:spMk id="146" creationId="{AD2BD8DA-1591-434D-9969-DCB32B4EFE9A}"/>
          </ac:spMkLst>
        </pc:spChg>
        <pc:spChg chg="del mod topLvl">
          <ac:chgData name="vijay kumar" userId="0eb738f014aa4543" providerId="LiveId" clId="{B4DB2928-3EFF-4507-ABD0-3894F091460A}" dt="2020-05-02T18:26:12.619" v="6037" actId="478"/>
          <ac:spMkLst>
            <pc:docMk/>
            <pc:sldMk cId="2863535548" sldId="354"/>
            <ac:spMk id="147" creationId="{09C76873-7135-4B42-91D5-D5B8758389A8}"/>
          </ac:spMkLst>
        </pc:spChg>
        <pc:spChg chg="mod topLvl">
          <ac:chgData name="vijay kumar" userId="0eb738f014aa4543" providerId="LiveId" clId="{B4DB2928-3EFF-4507-ABD0-3894F091460A}" dt="2020-05-07T11:07:59.161" v="12726" actId="1076"/>
          <ac:spMkLst>
            <pc:docMk/>
            <pc:sldMk cId="2863535548" sldId="354"/>
            <ac:spMk id="147" creationId="{C7089F2C-1565-48EC-8BAC-158638D60640}"/>
          </ac:spMkLst>
        </pc:spChg>
        <pc:spChg chg="del mod topLvl">
          <ac:chgData name="vijay kumar" userId="0eb738f014aa4543" providerId="LiveId" clId="{B4DB2928-3EFF-4507-ABD0-3894F091460A}" dt="2020-05-02T18:22:21.860" v="5888" actId="478"/>
          <ac:spMkLst>
            <pc:docMk/>
            <pc:sldMk cId="2863535548" sldId="354"/>
            <ac:spMk id="148" creationId="{A7B877B5-E4FB-4442-AFF4-55BC2C0E756D}"/>
          </ac:spMkLst>
        </pc:spChg>
        <pc:spChg chg="mod topLvl">
          <ac:chgData name="vijay kumar" userId="0eb738f014aa4543" providerId="LiveId" clId="{B4DB2928-3EFF-4507-ABD0-3894F091460A}" dt="2020-05-07T11:07:59.161" v="12726" actId="1076"/>
          <ac:spMkLst>
            <pc:docMk/>
            <pc:sldMk cId="2863535548" sldId="354"/>
            <ac:spMk id="148" creationId="{C852597D-2A5B-4024-ACBC-03F760879F52}"/>
          </ac:spMkLst>
        </pc:spChg>
        <pc:spChg chg="del mod topLvl">
          <ac:chgData name="vijay kumar" userId="0eb738f014aa4543" providerId="LiveId" clId="{B4DB2928-3EFF-4507-ABD0-3894F091460A}" dt="2020-05-02T18:22:21.860" v="5888" actId="478"/>
          <ac:spMkLst>
            <pc:docMk/>
            <pc:sldMk cId="2863535548" sldId="354"/>
            <ac:spMk id="149" creationId="{0D5C4212-6EF3-4572-8A35-289B79DE5B7E}"/>
          </ac:spMkLst>
        </pc:spChg>
        <pc:spChg chg="mod topLvl">
          <ac:chgData name="vijay kumar" userId="0eb738f014aa4543" providerId="LiveId" clId="{B4DB2928-3EFF-4507-ABD0-3894F091460A}" dt="2020-05-07T11:07:59.161" v="12726" actId="1076"/>
          <ac:spMkLst>
            <pc:docMk/>
            <pc:sldMk cId="2863535548" sldId="354"/>
            <ac:spMk id="149" creationId="{F077FB43-1480-4887-AB37-AE2A351DEC2B}"/>
          </ac:spMkLst>
        </pc:spChg>
        <pc:spChg chg="del mod topLvl">
          <ac:chgData name="vijay kumar" userId="0eb738f014aa4543" providerId="LiveId" clId="{B4DB2928-3EFF-4507-ABD0-3894F091460A}" dt="2020-05-02T18:20:54.280" v="5886" actId="478"/>
          <ac:spMkLst>
            <pc:docMk/>
            <pc:sldMk cId="2863535548" sldId="354"/>
            <ac:spMk id="150" creationId="{427D4B8A-5EE1-439A-B527-2E8105576826}"/>
          </ac:spMkLst>
        </pc:spChg>
        <pc:spChg chg="mod topLvl">
          <ac:chgData name="vijay kumar" userId="0eb738f014aa4543" providerId="LiveId" clId="{B4DB2928-3EFF-4507-ABD0-3894F091460A}" dt="2020-05-07T11:07:59.161" v="12726" actId="1076"/>
          <ac:spMkLst>
            <pc:docMk/>
            <pc:sldMk cId="2863535548" sldId="354"/>
            <ac:spMk id="150" creationId="{A0954666-DF8E-4C8D-A785-AB5E1235206D}"/>
          </ac:spMkLst>
        </pc:spChg>
        <pc:spChg chg="mod topLvl">
          <ac:chgData name="vijay kumar" userId="0eb738f014aa4543" providerId="LiveId" clId="{B4DB2928-3EFF-4507-ABD0-3894F091460A}" dt="2020-05-07T11:07:59.161" v="12726" actId="1076"/>
          <ac:spMkLst>
            <pc:docMk/>
            <pc:sldMk cId="2863535548" sldId="354"/>
            <ac:spMk id="151" creationId="{3E187F38-AFCC-4DD9-803D-8DF9DB326182}"/>
          </ac:spMkLst>
        </pc:spChg>
        <pc:spChg chg="del mod topLvl">
          <ac:chgData name="vijay kumar" userId="0eb738f014aa4543" providerId="LiveId" clId="{B4DB2928-3EFF-4507-ABD0-3894F091460A}" dt="2020-05-02T18:20:54.280" v="5886" actId="478"/>
          <ac:spMkLst>
            <pc:docMk/>
            <pc:sldMk cId="2863535548" sldId="354"/>
            <ac:spMk id="151" creationId="{64BAD02A-2BDD-406B-9528-0EE6C52C3DCB}"/>
          </ac:spMkLst>
        </pc:spChg>
        <pc:spChg chg="del mod topLvl">
          <ac:chgData name="vijay kumar" userId="0eb738f014aa4543" providerId="LiveId" clId="{B4DB2928-3EFF-4507-ABD0-3894F091460A}" dt="2020-05-02T18:20:54.280" v="5886" actId="478"/>
          <ac:spMkLst>
            <pc:docMk/>
            <pc:sldMk cId="2863535548" sldId="354"/>
            <ac:spMk id="152" creationId="{489095CD-2962-4F18-A57C-F393A0D5338B}"/>
          </ac:spMkLst>
        </pc:spChg>
        <pc:spChg chg="mod topLvl">
          <ac:chgData name="vijay kumar" userId="0eb738f014aa4543" providerId="LiveId" clId="{B4DB2928-3EFF-4507-ABD0-3894F091460A}" dt="2020-05-07T11:07:59.161" v="12726" actId="1076"/>
          <ac:spMkLst>
            <pc:docMk/>
            <pc:sldMk cId="2863535548" sldId="354"/>
            <ac:spMk id="152" creationId="{8863C66F-755D-42A8-A627-2E68D9370302}"/>
          </ac:spMkLst>
        </pc:spChg>
        <pc:spChg chg="mod topLvl">
          <ac:chgData name="vijay kumar" userId="0eb738f014aa4543" providerId="LiveId" clId="{B4DB2928-3EFF-4507-ABD0-3894F091460A}" dt="2020-05-07T11:07:59.161" v="12726" actId="1076"/>
          <ac:spMkLst>
            <pc:docMk/>
            <pc:sldMk cId="2863535548" sldId="354"/>
            <ac:spMk id="153" creationId="{EFF66D2F-91F5-48CE-9FA0-79831A759BF8}"/>
          </ac:spMkLst>
        </pc:spChg>
        <pc:spChg chg="del mod topLvl">
          <ac:chgData name="vijay kumar" userId="0eb738f014aa4543" providerId="LiveId" clId="{B4DB2928-3EFF-4507-ABD0-3894F091460A}" dt="2020-05-02T18:20:54.280" v="5886" actId="478"/>
          <ac:spMkLst>
            <pc:docMk/>
            <pc:sldMk cId="2863535548" sldId="354"/>
            <ac:spMk id="153" creationId="{F1E2CD93-1E86-4981-818C-0501C2AF8444}"/>
          </ac:spMkLst>
        </pc:spChg>
        <pc:spChg chg="del mod topLvl">
          <ac:chgData name="vijay kumar" userId="0eb738f014aa4543" providerId="LiveId" clId="{B4DB2928-3EFF-4507-ABD0-3894F091460A}" dt="2020-05-02T18:20:54.280" v="5886" actId="478"/>
          <ac:spMkLst>
            <pc:docMk/>
            <pc:sldMk cId="2863535548" sldId="354"/>
            <ac:spMk id="154" creationId="{599DA123-A94C-41F0-BFD4-2BE8655FCAD1}"/>
          </ac:spMkLst>
        </pc:spChg>
        <pc:spChg chg="mod topLvl">
          <ac:chgData name="vijay kumar" userId="0eb738f014aa4543" providerId="LiveId" clId="{B4DB2928-3EFF-4507-ABD0-3894F091460A}" dt="2020-05-07T11:07:59.161" v="12726" actId="1076"/>
          <ac:spMkLst>
            <pc:docMk/>
            <pc:sldMk cId="2863535548" sldId="354"/>
            <ac:spMk id="154" creationId="{E4F85A8D-4CB9-423B-B154-26DCFEAB43AA}"/>
          </ac:spMkLst>
        </pc:spChg>
        <pc:spChg chg="del mod topLvl">
          <ac:chgData name="vijay kumar" userId="0eb738f014aa4543" providerId="LiveId" clId="{B4DB2928-3EFF-4507-ABD0-3894F091460A}" dt="2020-05-02T18:20:54.280" v="5886" actId="478"/>
          <ac:spMkLst>
            <pc:docMk/>
            <pc:sldMk cId="2863535548" sldId="354"/>
            <ac:spMk id="155" creationId="{CB50813A-A53A-4306-82B6-AF0B857DB602}"/>
          </ac:spMkLst>
        </pc:spChg>
        <pc:spChg chg="mod topLvl">
          <ac:chgData name="vijay kumar" userId="0eb738f014aa4543" providerId="LiveId" clId="{B4DB2928-3EFF-4507-ABD0-3894F091460A}" dt="2020-05-07T09:59:44.797" v="11343" actId="338"/>
          <ac:spMkLst>
            <pc:docMk/>
            <pc:sldMk cId="2863535548" sldId="354"/>
            <ac:spMk id="156" creationId="{78959E34-45CF-4C8D-8387-7C45C4A55C8C}"/>
          </ac:spMkLst>
        </pc:spChg>
        <pc:spChg chg="del mod topLvl">
          <ac:chgData name="vijay kumar" userId="0eb738f014aa4543" providerId="LiveId" clId="{B4DB2928-3EFF-4507-ABD0-3894F091460A}" dt="2020-05-02T18:20:54.280" v="5886" actId="478"/>
          <ac:spMkLst>
            <pc:docMk/>
            <pc:sldMk cId="2863535548" sldId="354"/>
            <ac:spMk id="156" creationId="{8466E24B-DC24-4049-B2B0-12F3C7D90BED}"/>
          </ac:spMkLst>
        </pc:spChg>
        <pc:spChg chg="mod topLvl">
          <ac:chgData name="vijay kumar" userId="0eb738f014aa4543" providerId="LiveId" clId="{B4DB2928-3EFF-4507-ABD0-3894F091460A}" dt="2020-05-07T09:59:44.797" v="11343" actId="338"/>
          <ac:spMkLst>
            <pc:docMk/>
            <pc:sldMk cId="2863535548" sldId="354"/>
            <ac:spMk id="157" creationId="{5E05B0D7-4175-4194-89DC-5971C007B5C0}"/>
          </ac:spMkLst>
        </pc:spChg>
        <pc:spChg chg="del mod topLvl">
          <ac:chgData name="vijay kumar" userId="0eb738f014aa4543" providerId="LiveId" clId="{B4DB2928-3EFF-4507-ABD0-3894F091460A}" dt="2020-05-02T18:20:54.280" v="5886" actId="478"/>
          <ac:spMkLst>
            <pc:docMk/>
            <pc:sldMk cId="2863535548" sldId="354"/>
            <ac:spMk id="157" creationId="{C58C1409-E636-4786-BEAF-605754F63CCE}"/>
          </ac:spMkLst>
        </pc:spChg>
        <pc:spChg chg="del mod topLvl">
          <ac:chgData name="vijay kumar" userId="0eb738f014aa4543" providerId="LiveId" clId="{B4DB2928-3EFF-4507-ABD0-3894F091460A}" dt="2020-05-02T18:20:54.280" v="5886" actId="478"/>
          <ac:spMkLst>
            <pc:docMk/>
            <pc:sldMk cId="2863535548" sldId="354"/>
            <ac:spMk id="158" creationId="{2F690168-77CE-4F12-839E-8A7E4069B3A0}"/>
          </ac:spMkLst>
        </pc:spChg>
        <pc:spChg chg="mod topLvl">
          <ac:chgData name="vijay kumar" userId="0eb738f014aa4543" providerId="LiveId" clId="{B4DB2928-3EFF-4507-ABD0-3894F091460A}" dt="2020-05-07T09:59:44.797" v="11343" actId="338"/>
          <ac:spMkLst>
            <pc:docMk/>
            <pc:sldMk cId="2863535548" sldId="354"/>
            <ac:spMk id="158" creationId="{89B18735-F18F-4C7C-A463-C9738DE52CBA}"/>
          </ac:spMkLst>
        </pc:spChg>
        <pc:spChg chg="mod topLvl">
          <ac:chgData name="vijay kumar" userId="0eb738f014aa4543" providerId="LiveId" clId="{B4DB2928-3EFF-4507-ABD0-3894F091460A}" dt="2020-05-07T09:59:44.797" v="11343" actId="338"/>
          <ac:spMkLst>
            <pc:docMk/>
            <pc:sldMk cId="2863535548" sldId="354"/>
            <ac:spMk id="159" creationId="{1567A922-E38D-467E-AED4-F15DB44ADDA6}"/>
          </ac:spMkLst>
        </pc:spChg>
        <pc:spChg chg="del mod topLvl">
          <ac:chgData name="vijay kumar" userId="0eb738f014aa4543" providerId="LiveId" clId="{B4DB2928-3EFF-4507-ABD0-3894F091460A}" dt="2020-05-02T18:20:54.280" v="5886" actId="478"/>
          <ac:spMkLst>
            <pc:docMk/>
            <pc:sldMk cId="2863535548" sldId="354"/>
            <ac:spMk id="159" creationId="{77BD3C7A-C5C5-40E6-836A-D43973C3D9A5}"/>
          </ac:spMkLst>
        </pc:spChg>
        <pc:spChg chg="del mod topLvl">
          <ac:chgData name="vijay kumar" userId="0eb738f014aa4543" providerId="LiveId" clId="{B4DB2928-3EFF-4507-ABD0-3894F091460A}" dt="2020-05-02T18:20:54.280" v="5886" actId="478"/>
          <ac:spMkLst>
            <pc:docMk/>
            <pc:sldMk cId="2863535548" sldId="354"/>
            <ac:spMk id="160" creationId="{0364E916-D4CB-4E4A-B37D-2FF3E6B9631A}"/>
          </ac:spMkLst>
        </pc:spChg>
        <pc:spChg chg="del mod topLvl">
          <ac:chgData name="vijay kumar" userId="0eb738f014aa4543" providerId="LiveId" clId="{B4DB2928-3EFF-4507-ABD0-3894F091460A}" dt="2020-05-02T21:23:42.138" v="7357" actId="478"/>
          <ac:spMkLst>
            <pc:docMk/>
            <pc:sldMk cId="2863535548" sldId="354"/>
            <ac:spMk id="160" creationId="{BF96CA88-6AC8-42E8-9C10-ABAFEFAFAFCB}"/>
          </ac:spMkLst>
        </pc:spChg>
        <pc:spChg chg="mod topLvl">
          <ac:chgData name="vijay kumar" userId="0eb738f014aa4543" providerId="LiveId" clId="{B4DB2928-3EFF-4507-ABD0-3894F091460A}" dt="2020-05-07T09:59:44.797" v="11343" actId="338"/>
          <ac:spMkLst>
            <pc:docMk/>
            <pc:sldMk cId="2863535548" sldId="354"/>
            <ac:spMk id="160" creationId="{F17250D8-83AD-46B7-B904-E74909CEEEE9}"/>
          </ac:spMkLst>
        </pc:spChg>
        <pc:spChg chg="del mod topLvl">
          <ac:chgData name="vijay kumar" userId="0eb738f014aa4543" providerId="LiveId" clId="{B4DB2928-3EFF-4507-ABD0-3894F091460A}" dt="2020-05-02T21:23:42.138" v="7357" actId="478"/>
          <ac:spMkLst>
            <pc:docMk/>
            <pc:sldMk cId="2863535548" sldId="354"/>
            <ac:spMk id="161" creationId="{03C2AA47-D487-4535-9985-61AA870E8DB3}"/>
          </ac:spMkLst>
        </pc:spChg>
        <pc:spChg chg="del mod topLvl">
          <ac:chgData name="vijay kumar" userId="0eb738f014aa4543" providerId="LiveId" clId="{B4DB2928-3EFF-4507-ABD0-3894F091460A}" dt="2020-05-02T18:20:54.280" v="5886" actId="478"/>
          <ac:spMkLst>
            <pc:docMk/>
            <pc:sldMk cId="2863535548" sldId="354"/>
            <ac:spMk id="161" creationId="{1AAD8FC4-0E36-4447-A85F-D7499377B883}"/>
          </ac:spMkLst>
        </pc:spChg>
        <pc:spChg chg="mod topLvl">
          <ac:chgData name="vijay kumar" userId="0eb738f014aa4543" providerId="LiveId" clId="{B4DB2928-3EFF-4507-ABD0-3894F091460A}" dt="2020-05-07T09:59:44.797" v="11343" actId="338"/>
          <ac:spMkLst>
            <pc:docMk/>
            <pc:sldMk cId="2863535548" sldId="354"/>
            <ac:spMk id="161" creationId="{58F5166F-C92B-4AB5-9775-D226E8C6D2D8}"/>
          </ac:spMkLst>
        </pc:spChg>
        <pc:spChg chg="mod topLvl">
          <ac:chgData name="vijay kumar" userId="0eb738f014aa4543" providerId="LiveId" clId="{B4DB2928-3EFF-4507-ABD0-3894F091460A}" dt="2020-05-07T09:59:44.797" v="11343" actId="338"/>
          <ac:spMkLst>
            <pc:docMk/>
            <pc:sldMk cId="2863535548" sldId="354"/>
            <ac:spMk id="162" creationId="{58C3F892-7CA6-45D2-BB4E-F47C3D648714}"/>
          </ac:spMkLst>
        </pc:spChg>
        <pc:spChg chg="del mod topLvl">
          <ac:chgData name="vijay kumar" userId="0eb738f014aa4543" providerId="LiveId" clId="{B4DB2928-3EFF-4507-ABD0-3894F091460A}" dt="2020-05-02T18:20:54.280" v="5886" actId="478"/>
          <ac:spMkLst>
            <pc:docMk/>
            <pc:sldMk cId="2863535548" sldId="354"/>
            <ac:spMk id="162" creationId="{ADDEE3FF-B7F9-4750-A473-7D66033534ED}"/>
          </ac:spMkLst>
        </pc:spChg>
        <pc:spChg chg="del mod topLvl">
          <ac:chgData name="vijay kumar" userId="0eb738f014aa4543" providerId="LiveId" clId="{B4DB2928-3EFF-4507-ABD0-3894F091460A}" dt="2020-05-02T21:23:42.138" v="7357" actId="478"/>
          <ac:spMkLst>
            <pc:docMk/>
            <pc:sldMk cId="2863535548" sldId="354"/>
            <ac:spMk id="162" creationId="{DAA5B8FE-735E-4C0D-B403-A3D2129A6D92}"/>
          </ac:spMkLst>
        </pc:spChg>
        <pc:spChg chg="mod topLvl">
          <ac:chgData name="vijay kumar" userId="0eb738f014aa4543" providerId="LiveId" clId="{B4DB2928-3EFF-4507-ABD0-3894F091460A}" dt="2020-05-07T09:59:44.797" v="11343" actId="338"/>
          <ac:spMkLst>
            <pc:docMk/>
            <pc:sldMk cId="2863535548" sldId="354"/>
            <ac:spMk id="163" creationId="{553FB327-3E6C-49ED-B234-5534796C944E}"/>
          </ac:spMkLst>
        </pc:spChg>
        <pc:spChg chg="del mod topLvl">
          <ac:chgData name="vijay kumar" userId="0eb738f014aa4543" providerId="LiveId" clId="{B4DB2928-3EFF-4507-ABD0-3894F091460A}" dt="2020-05-02T18:20:54.280" v="5886" actId="478"/>
          <ac:spMkLst>
            <pc:docMk/>
            <pc:sldMk cId="2863535548" sldId="354"/>
            <ac:spMk id="163" creationId="{C291B2F5-AD69-4DC4-AE34-65D51AFB0280}"/>
          </ac:spMkLst>
        </pc:spChg>
        <pc:spChg chg="del mod topLvl">
          <ac:chgData name="vijay kumar" userId="0eb738f014aa4543" providerId="LiveId" clId="{B4DB2928-3EFF-4507-ABD0-3894F091460A}" dt="2020-05-02T21:23:42.138" v="7357" actId="478"/>
          <ac:spMkLst>
            <pc:docMk/>
            <pc:sldMk cId="2863535548" sldId="354"/>
            <ac:spMk id="163" creationId="{D3A71B71-1691-4843-AD05-70C22BD4B663}"/>
          </ac:spMkLst>
        </pc:spChg>
        <pc:spChg chg="del mod topLvl">
          <ac:chgData name="vijay kumar" userId="0eb738f014aa4543" providerId="LiveId" clId="{B4DB2928-3EFF-4507-ABD0-3894F091460A}" dt="2020-05-02T18:20:54.280" v="5886" actId="478"/>
          <ac:spMkLst>
            <pc:docMk/>
            <pc:sldMk cId="2863535548" sldId="354"/>
            <ac:spMk id="164" creationId="{17ACC6D9-13EA-4AEE-9D65-E47B1F699F2E}"/>
          </ac:spMkLst>
        </pc:spChg>
        <pc:spChg chg="mod topLvl">
          <ac:chgData name="vijay kumar" userId="0eb738f014aa4543" providerId="LiveId" clId="{B4DB2928-3EFF-4507-ABD0-3894F091460A}" dt="2020-05-07T09:59:44.797" v="11343" actId="338"/>
          <ac:spMkLst>
            <pc:docMk/>
            <pc:sldMk cId="2863535548" sldId="354"/>
            <ac:spMk id="164" creationId="{22BAEDFF-07E2-4EEA-A3B5-D27B48868494}"/>
          </ac:spMkLst>
        </pc:spChg>
        <pc:spChg chg="del mod topLvl">
          <ac:chgData name="vijay kumar" userId="0eb738f014aa4543" providerId="LiveId" clId="{B4DB2928-3EFF-4507-ABD0-3894F091460A}" dt="2020-05-02T21:23:42.138" v="7357" actId="478"/>
          <ac:spMkLst>
            <pc:docMk/>
            <pc:sldMk cId="2863535548" sldId="354"/>
            <ac:spMk id="164" creationId="{9B2BC7BE-2616-49DE-9DA7-B3520539708D}"/>
          </ac:spMkLst>
        </pc:spChg>
        <pc:spChg chg="del mod topLvl">
          <ac:chgData name="vijay kumar" userId="0eb738f014aa4543" providerId="LiveId" clId="{B4DB2928-3EFF-4507-ABD0-3894F091460A}" dt="2020-05-02T21:23:42.138" v="7357" actId="478"/>
          <ac:spMkLst>
            <pc:docMk/>
            <pc:sldMk cId="2863535548" sldId="354"/>
            <ac:spMk id="165" creationId="{75E6CED7-E9C6-4308-92EC-66BBD16C9161}"/>
          </ac:spMkLst>
        </pc:spChg>
        <pc:spChg chg="mod topLvl">
          <ac:chgData name="vijay kumar" userId="0eb738f014aa4543" providerId="LiveId" clId="{B4DB2928-3EFF-4507-ABD0-3894F091460A}" dt="2020-05-07T09:59:44.797" v="11343" actId="338"/>
          <ac:spMkLst>
            <pc:docMk/>
            <pc:sldMk cId="2863535548" sldId="354"/>
            <ac:spMk id="165" creationId="{8890ED79-C0F9-48DB-B1D7-7A0C74E8A452}"/>
          </ac:spMkLst>
        </pc:spChg>
        <pc:spChg chg="del mod topLvl">
          <ac:chgData name="vijay kumar" userId="0eb738f014aa4543" providerId="LiveId" clId="{B4DB2928-3EFF-4507-ABD0-3894F091460A}" dt="2020-05-02T18:20:54.280" v="5886" actId="478"/>
          <ac:spMkLst>
            <pc:docMk/>
            <pc:sldMk cId="2863535548" sldId="354"/>
            <ac:spMk id="165" creationId="{BD6F277A-ED2F-4891-B37B-DA41D099DBDA}"/>
          </ac:spMkLst>
        </pc:spChg>
        <pc:spChg chg="del mod topLvl">
          <ac:chgData name="vijay kumar" userId="0eb738f014aa4543" providerId="LiveId" clId="{B4DB2928-3EFF-4507-ABD0-3894F091460A}" dt="2020-05-02T21:23:42.138" v="7357" actId="478"/>
          <ac:spMkLst>
            <pc:docMk/>
            <pc:sldMk cId="2863535548" sldId="354"/>
            <ac:spMk id="166" creationId="{7BB74C84-9D1A-4F76-BDA0-725BB39B04EA}"/>
          </ac:spMkLst>
        </pc:spChg>
        <pc:spChg chg="mod topLvl">
          <ac:chgData name="vijay kumar" userId="0eb738f014aa4543" providerId="LiveId" clId="{B4DB2928-3EFF-4507-ABD0-3894F091460A}" dt="2020-05-07T09:59:44.797" v="11343" actId="338"/>
          <ac:spMkLst>
            <pc:docMk/>
            <pc:sldMk cId="2863535548" sldId="354"/>
            <ac:spMk id="166" creationId="{C843675B-D157-4E7A-94C8-6363B7D3DFBE}"/>
          </ac:spMkLst>
        </pc:spChg>
        <pc:spChg chg="del mod topLvl">
          <ac:chgData name="vijay kumar" userId="0eb738f014aa4543" providerId="LiveId" clId="{B4DB2928-3EFF-4507-ABD0-3894F091460A}" dt="2020-05-02T18:20:54.280" v="5886" actId="478"/>
          <ac:spMkLst>
            <pc:docMk/>
            <pc:sldMk cId="2863535548" sldId="354"/>
            <ac:spMk id="166" creationId="{E69AF843-5186-43B3-8A49-D56C96D9A09B}"/>
          </ac:spMkLst>
        </pc:spChg>
        <pc:spChg chg="del mod topLvl">
          <ac:chgData name="vijay kumar" userId="0eb738f014aa4543" providerId="LiveId" clId="{B4DB2928-3EFF-4507-ABD0-3894F091460A}" dt="2020-05-02T18:20:54.280" v="5886" actId="478"/>
          <ac:spMkLst>
            <pc:docMk/>
            <pc:sldMk cId="2863535548" sldId="354"/>
            <ac:spMk id="167" creationId="{127E23BD-EDF3-43CE-AC6F-22C0B3CFC0AC}"/>
          </ac:spMkLst>
        </pc:spChg>
        <pc:spChg chg="del mod topLvl">
          <ac:chgData name="vijay kumar" userId="0eb738f014aa4543" providerId="LiveId" clId="{B4DB2928-3EFF-4507-ABD0-3894F091460A}" dt="2020-05-02T21:23:42.138" v="7357" actId="478"/>
          <ac:spMkLst>
            <pc:docMk/>
            <pc:sldMk cId="2863535548" sldId="354"/>
            <ac:spMk id="167" creationId="{65533656-57CA-4E3E-9EB4-31F0B5F97B49}"/>
          </ac:spMkLst>
        </pc:spChg>
        <pc:spChg chg="mod topLvl">
          <ac:chgData name="vijay kumar" userId="0eb738f014aa4543" providerId="LiveId" clId="{B4DB2928-3EFF-4507-ABD0-3894F091460A}" dt="2020-05-07T09:59:44.797" v="11343" actId="338"/>
          <ac:spMkLst>
            <pc:docMk/>
            <pc:sldMk cId="2863535548" sldId="354"/>
            <ac:spMk id="167" creationId="{C51F6153-C510-4B73-8973-7546B11BBC9D}"/>
          </ac:spMkLst>
        </pc:spChg>
        <pc:spChg chg="mod topLvl">
          <ac:chgData name="vijay kumar" userId="0eb738f014aa4543" providerId="LiveId" clId="{B4DB2928-3EFF-4507-ABD0-3894F091460A}" dt="2020-05-07T09:59:44.797" v="11343" actId="338"/>
          <ac:spMkLst>
            <pc:docMk/>
            <pc:sldMk cId="2863535548" sldId="354"/>
            <ac:spMk id="168" creationId="{9BD1D197-39B2-48E3-8E2B-FF9DD6A5A7DF}"/>
          </ac:spMkLst>
        </pc:spChg>
        <pc:spChg chg="del mod topLvl">
          <ac:chgData name="vijay kumar" userId="0eb738f014aa4543" providerId="LiveId" clId="{B4DB2928-3EFF-4507-ABD0-3894F091460A}" dt="2020-05-02T18:20:54.280" v="5886" actId="478"/>
          <ac:spMkLst>
            <pc:docMk/>
            <pc:sldMk cId="2863535548" sldId="354"/>
            <ac:spMk id="168" creationId="{F27BB5C7-64FD-4BF2-83C3-7129C015D5EB}"/>
          </ac:spMkLst>
        </pc:spChg>
        <pc:spChg chg="del mod topLvl">
          <ac:chgData name="vijay kumar" userId="0eb738f014aa4543" providerId="LiveId" clId="{B4DB2928-3EFF-4507-ABD0-3894F091460A}" dt="2020-05-02T18:20:54.280" v="5886" actId="478"/>
          <ac:spMkLst>
            <pc:docMk/>
            <pc:sldMk cId="2863535548" sldId="354"/>
            <ac:spMk id="169" creationId="{0B99C1EC-EFA8-4890-8345-74C3D970316B}"/>
          </ac:spMkLst>
        </pc:spChg>
        <pc:spChg chg="add del mod">
          <ac:chgData name="vijay kumar" userId="0eb738f014aa4543" providerId="LiveId" clId="{B4DB2928-3EFF-4507-ABD0-3894F091460A}" dt="2020-05-24T14:26:11.623" v="15152" actId="478"/>
          <ac:spMkLst>
            <pc:docMk/>
            <pc:sldMk cId="2863535548" sldId="354"/>
            <ac:spMk id="170" creationId="{85C57314-A62F-4C67-99C2-410C1DEB4E70}"/>
          </ac:spMkLst>
        </pc:spChg>
        <pc:spChg chg="del mod topLvl">
          <ac:chgData name="vijay kumar" userId="0eb738f014aa4543" providerId="LiveId" clId="{B4DB2928-3EFF-4507-ABD0-3894F091460A}" dt="2020-05-02T18:20:54.280" v="5886" actId="478"/>
          <ac:spMkLst>
            <pc:docMk/>
            <pc:sldMk cId="2863535548" sldId="354"/>
            <ac:spMk id="170" creationId="{8F08AD04-4634-48F7-A224-6A9C2ABCDDFB}"/>
          </ac:spMkLst>
        </pc:spChg>
        <pc:spChg chg="del mod topLvl">
          <ac:chgData name="vijay kumar" userId="0eb738f014aa4543" providerId="LiveId" clId="{B4DB2928-3EFF-4507-ABD0-3894F091460A}" dt="2020-05-02T18:20:54.280" v="5886" actId="478"/>
          <ac:spMkLst>
            <pc:docMk/>
            <pc:sldMk cId="2863535548" sldId="354"/>
            <ac:spMk id="171" creationId="{965B4B43-186C-4B63-BFAA-9364314D6E75}"/>
          </ac:spMkLst>
        </pc:spChg>
        <pc:spChg chg="del mod topLvl">
          <ac:chgData name="vijay kumar" userId="0eb738f014aa4543" providerId="LiveId" clId="{B4DB2928-3EFF-4507-ABD0-3894F091460A}" dt="2020-05-02T18:20:54.280" v="5886" actId="478"/>
          <ac:spMkLst>
            <pc:docMk/>
            <pc:sldMk cId="2863535548" sldId="354"/>
            <ac:spMk id="172" creationId="{422FB953-9E34-4196-9A8C-0938870FAE03}"/>
          </ac:spMkLst>
        </pc:spChg>
        <pc:spChg chg="mod">
          <ac:chgData name="vijay kumar" userId="0eb738f014aa4543" providerId="LiveId" clId="{B4DB2928-3EFF-4507-ABD0-3894F091460A}" dt="2020-05-07T09:59:44.797" v="11343" actId="338"/>
          <ac:spMkLst>
            <pc:docMk/>
            <pc:sldMk cId="2863535548" sldId="354"/>
            <ac:spMk id="173" creationId="{D4D1C83A-E7A1-49D4-8535-84ADDBC86C3A}"/>
          </ac:spMkLst>
        </pc:spChg>
        <pc:spChg chg="del mod topLvl">
          <ac:chgData name="vijay kumar" userId="0eb738f014aa4543" providerId="LiveId" clId="{B4DB2928-3EFF-4507-ABD0-3894F091460A}" dt="2020-05-02T18:20:54.280" v="5886" actId="478"/>
          <ac:spMkLst>
            <pc:docMk/>
            <pc:sldMk cId="2863535548" sldId="354"/>
            <ac:spMk id="173" creationId="{F41EEFA3-92E6-43E8-8B38-54AE3E04E592}"/>
          </ac:spMkLst>
        </pc:spChg>
        <pc:spChg chg="mod">
          <ac:chgData name="vijay kumar" userId="0eb738f014aa4543" providerId="LiveId" clId="{B4DB2928-3EFF-4507-ABD0-3894F091460A}" dt="2020-05-07T09:59:44.797" v="11343" actId="338"/>
          <ac:spMkLst>
            <pc:docMk/>
            <pc:sldMk cId="2863535548" sldId="354"/>
            <ac:spMk id="174" creationId="{CCAF6771-2B94-4C25-9F51-F568B3DC3A07}"/>
          </ac:spMkLst>
        </pc:spChg>
        <pc:spChg chg="mod">
          <ac:chgData name="vijay kumar" userId="0eb738f014aa4543" providerId="LiveId" clId="{B4DB2928-3EFF-4507-ABD0-3894F091460A}" dt="2020-05-07T09:59:44.797" v="11343" actId="338"/>
          <ac:spMkLst>
            <pc:docMk/>
            <pc:sldMk cId="2863535548" sldId="354"/>
            <ac:spMk id="175" creationId="{5DEB5F24-58A2-43F1-B02D-DD29BD1109FA}"/>
          </ac:spMkLst>
        </pc:spChg>
        <pc:spChg chg="mod">
          <ac:chgData name="vijay kumar" userId="0eb738f014aa4543" providerId="LiveId" clId="{B4DB2928-3EFF-4507-ABD0-3894F091460A}" dt="2020-05-07T09:59:44.797" v="11343" actId="338"/>
          <ac:spMkLst>
            <pc:docMk/>
            <pc:sldMk cId="2863535548" sldId="354"/>
            <ac:spMk id="176" creationId="{32C49013-546C-4F80-A765-F026B139D550}"/>
          </ac:spMkLst>
        </pc:spChg>
        <pc:spChg chg="mod">
          <ac:chgData name="vijay kumar" userId="0eb738f014aa4543" providerId="LiveId" clId="{B4DB2928-3EFF-4507-ABD0-3894F091460A}" dt="2020-05-07T09:59:44.797" v="11343" actId="338"/>
          <ac:spMkLst>
            <pc:docMk/>
            <pc:sldMk cId="2863535548" sldId="354"/>
            <ac:spMk id="177" creationId="{CA61A1D1-CD2C-4331-A5E2-D28E2A0BB69A}"/>
          </ac:spMkLst>
        </pc:spChg>
        <pc:spChg chg="mod">
          <ac:chgData name="vijay kumar" userId="0eb738f014aa4543" providerId="LiveId" clId="{B4DB2928-3EFF-4507-ABD0-3894F091460A}" dt="2020-05-07T09:59:44.797" v="11343" actId="338"/>
          <ac:spMkLst>
            <pc:docMk/>
            <pc:sldMk cId="2863535548" sldId="354"/>
            <ac:spMk id="178" creationId="{4A0E2260-F2ED-46D6-9C51-9F1F6C1677FF}"/>
          </ac:spMkLst>
        </pc:spChg>
        <pc:spChg chg="mod">
          <ac:chgData name="vijay kumar" userId="0eb738f014aa4543" providerId="LiveId" clId="{B4DB2928-3EFF-4507-ABD0-3894F091460A}" dt="2020-05-07T09:59:44.797" v="11343" actId="338"/>
          <ac:spMkLst>
            <pc:docMk/>
            <pc:sldMk cId="2863535548" sldId="354"/>
            <ac:spMk id="179" creationId="{4C92441C-632D-413B-A78C-2B42B5BC06D0}"/>
          </ac:spMkLst>
        </pc:spChg>
        <pc:spChg chg="mod">
          <ac:chgData name="vijay kumar" userId="0eb738f014aa4543" providerId="LiveId" clId="{B4DB2928-3EFF-4507-ABD0-3894F091460A}" dt="2020-05-07T09:59:44.797" v="11343" actId="338"/>
          <ac:spMkLst>
            <pc:docMk/>
            <pc:sldMk cId="2863535548" sldId="354"/>
            <ac:spMk id="180" creationId="{065737F1-35DD-442D-83C2-BC6B413E54CC}"/>
          </ac:spMkLst>
        </pc:spChg>
        <pc:spChg chg="mod">
          <ac:chgData name="vijay kumar" userId="0eb738f014aa4543" providerId="LiveId" clId="{B4DB2928-3EFF-4507-ABD0-3894F091460A}" dt="2020-05-07T09:59:44.797" v="11343" actId="338"/>
          <ac:spMkLst>
            <pc:docMk/>
            <pc:sldMk cId="2863535548" sldId="354"/>
            <ac:spMk id="181" creationId="{BEEC946F-064C-4E55-9886-B452808F35C4}"/>
          </ac:spMkLst>
        </pc:spChg>
        <pc:spChg chg="mod">
          <ac:chgData name="vijay kumar" userId="0eb738f014aa4543" providerId="LiveId" clId="{B4DB2928-3EFF-4507-ABD0-3894F091460A}" dt="2020-05-07T09:59:44.797" v="11343" actId="338"/>
          <ac:spMkLst>
            <pc:docMk/>
            <pc:sldMk cId="2863535548" sldId="354"/>
            <ac:spMk id="182" creationId="{7DDC005E-8F7C-4C91-99A1-31E532F4F619}"/>
          </ac:spMkLst>
        </pc:spChg>
        <pc:spChg chg="mod">
          <ac:chgData name="vijay kumar" userId="0eb738f014aa4543" providerId="LiveId" clId="{B4DB2928-3EFF-4507-ABD0-3894F091460A}" dt="2020-05-07T09:59:44.797" v="11343" actId="338"/>
          <ac:spMkLst>
            <pc:docMk/>
            <pc:sldMk cId="2863535548" sldId="354"/>
            <ac:spMk id="183" creationId="{1D96FEE2-15AF-4E04-A407-845855DEA1B4}"/>
          </ac:spMkLst>
        </pc:spChg>
        <pc:spChg chg="mod">
          <ac:chgData name="vijay kumar" userId="0eb738f014aa4543" providerId="LiveId" clId="{B4DB2928-3EFF-4507-ABD0-3894F091460A}" dt="2020-05-07T09:59:44.797" v="11343" actId="338"/>
          <ac:spMkLst>
            <pc:docMk/>
            <pc:sldMk cId="2863535548" sldId="354"/>
            <ac:spMk id="194" creationId="{A4C205B0-FAF3-4598-B5A7-7285AF0E0A51}"/>
          </ac:spMkLst>
        </pc:spChg>
        <pc:spChg chg="mod">
          <ac:chgData name="vijay kumar" userId="0eb738f014aa4543" providerId="LiveId" clId="{B4DB2928-3EFF-4507-ABD0-3894F091460A}" dt="2020-05-07T09:59:44.797" v="11343" actId="338"/>
          <ac:spMkLst>
            <pc:docMk/>
            <pc:sldMk cId="2863535548" sldId="354"/>
            <ac:spMk id="196" creationId="{F5B220B5-4444-4161-BD75-0E08D3F80C9A}"/>
          </ac:spMkLst>
        </pc:spChg>
        <pc:spChg chg="add mod topLvl">
          <ac:chgData name="vijay kumar" userId="0eb738f014aa4543" providerId="LiveId" clId="{B4DB2928-3EFF-4507-ABD0-3894F091460A}" dt="2020-05-07T11:07:59.161" v="12726" actId="1076"/>
          <ac:spMkLst>
            <pc:docMk/>
            <pc:sldMk cId="2863535548" sldId="354"/>
            <ac:spMk id="197" creationId="{D887ECD8-290D-4AF4-BBE5-8A240995A38A}"/>
          </ac:spMkLst>
        </pc:spChg>
        <pc:spChg chg="mod">
          <ac:chgData name="vijay kumar" userId="0eb738f014aa4543" providerId="LiveId" clId="{B4DB2928-3EFF-4507-ABD0-3894F091460A}" dt="2020-05-07T09:59:44.797" v="11343" actId="338"/>
          <ac:spMkLst>
            <pc:docMk/>
            <pc:sldMk cId="2863535548" sldId="354"/>
            <ac:spMk id="199" creationId="{C550CA2A-E54F-402C-B6D6-CAC0EE61632E}"/>
          </ac:spMkLst>
        </pc:spChg>
        <pc:spChg chg="mod topLvl">
          <ac:chgData name="vijay kumar" userId="0eb738f014aa4543" providerId="LiveId" clId="{B4DB2928-3EFF-4507-ABD0-3894F091460A}" dt="2020-05-07T09:59:44.797" v="11343" actId="338"/>
          <ac:spMkLst>
            <pc:docMk/>
            <pc:sldMk cId="2863535548" sldId="354"/>
            <ac:spMk id="200" creationId="{43927135-89B6-42FD-BEA4-0E4E055365FB}"/>
          </ac:spMkLst>
        </pc:spChg>
        <pc:spChg chg="mod topLvl">
          <ac:chgData name="vijay kumar" userId="0eb738f014aa4543" providerId="LiveId" clId="{B4DB2928-3EFF-4507-ABD0-3894F091460A}" dt="2020-05-07T09:59:44.797" v="11343" actId="338"/>
          <ac:spMkLst>
            <pc:docMk/>
            <pc:sldMk cId="2863535548" sldId="354"/>
            <ac:spMk id="201" creationId="{9D371ACF-35A3-4F4F-8636-F29E9D37FB10}"/>
          </ac:spMkLst>
        </pc:spChg>
        <pc:spChg chg="mod topLvl">
          <ac:chgData name="vijay kumar" userId="0eb738f014aa4543" providerId="LiveId" clId="{B4DB2928-3EFF-4507-ABD0-3894F091460A}" dt="2020-05-07T09:59:44.797" v="11343" actId="338"/>
          <ac:spMkLst>
            <pc:docMk/>
            <pc:sldMk cId="2863535548" sldId="354"/>
            <ac:spMk id="202" creationId="{82C9C6A8-F1C4-4CBA-A334-E183FB8EA22C}"/>
          </ac:spMkLst>
        </pc:spChg>
        <pc:spChg chg="mod topLvl">
          <ac:chgData name="vijay kumar" userId="0eb738f014aa4543" providerId="LiveId" clId="{B4DB2928-3EFF-4507-ABD0-3894F091460A}" dt="2020-05-07T09:59:44.797" v="11343" actId="338"/>
          <ac:spMkLst>
            <pc:docMk/>
            <pc:sldMk cId="2863535548" sldId="354"/>
            <ac:spMk id="203" creationId="{A62BB164-0DC0-4D53-A821-FE1D60584102}"/>
          </ac:spMkLst>
        </pc:spChg>
        <pc:spChg chg="mod topLvl">
          <ac:chgData name="vijay kumar" userId="0eb738f014aa4543" providerId="LiveId" clId="{B4DB2928-3EFF-4507-ABD0-3894F091460A}" dt="2020-05-07T09:59:44.797" v="11343" actId="338"/>
          <ac:spMkLst>
            <pc:docMk/>
            <pc:sldMk cId="2863535548" sldId="354"/>
            <ac:spMk id="204" creationId="{77153EE2-FCE2-4C92-9400-0E5BFB99A715}"/>
          </ac:spMkLst>
        </pc:spChg>
        <pc:spChg chg="mod topLvl">
          <ac:chgData name="vijay kumar" userId="0eb738f014aa4543" providerId="LiveId" clId="{B4DB2928-3EFF-4507-ABD0-3894F091460A}" dt="2020-05-07T09:59:44.797" v="11343" actId="338"/>
          <ac:spMkLst>
            <pc:docMk/>
            <pc:sldMk cId="2863535548" sldId="354"/>
            <ac:spMk id="205" creationId="{2CD2D19B-1F31-4E92-BE28-61B18D88B654}"/>
          </ac:spMkLst>
        </pc:spChg>
        <pc:spChg chg="mod topLvl">
          <ac:chgData name="vijay kumar" userId="0eb738f014aa4543" providerId="LiveId" clId="{B4DB2928-3EFF-4507-ABD0-3894F091460A}" dt="2020-05-07T09:59:44.797" v="11343" actId="338"/>
          <ac:spMkLst>
            <pc:docMk/>
            <pc:sldMk cId="2863535548" sldId="354"/>
            <ac:spMk id="206" creationId="{BC9521CC-00A6-4B23-9A35-6EC9F2D9607A}"/>
          </ac:spMkLst>
        </pc:spChg>
        <pc:spChg chg="mod topLvl">
          <ac:chgData name="vijay kumar" userId="0eb738f014aa4543" providerId="LiveId" clId="{B4DB2928-3EFF-4507-ABD0-3894F091460A}" dt="2020-05-07T09:59:44.797" v="11343" actId="338"/>
          <ac:spMkLst>
            <pc:docMk/>
            <pc:sldMk cId="2863535548" sldId="354"/>
            <ac:spMk id="207" creationId="{946D6D0B-05EC-40DC-A668-0414A600AE9B}"/>
          </ac:spMkLst>
        </pc:spChg>
        <pc:spChg chg="mod topLvl">
          <ac:chgData name="vijay kumar" userId="0eb738f014aa4543" providerId="LiveId" clId="{B4DB2928-3EFF-4507-ABD0-3894F091460A}" dt="2020-05-07T09:59:44.797" v="11343" actId="338"/>
          <ac:spMkLst>
            <pc:docMk/>
            <pc:sldMk cId="2863535548" sldId="354"/>
            <ac:spMk id="208" creationId="{FC1DDEAE-3B09-45B8-9B0C-4C2E4CA8E137}"/>
          </ac:spMkLst>
        </pc:spChg>
        <pc:spChg chg="mod">
          <ac:chgData name="vijay kumar" userId="0eb738f014aa4543" providerId="LiveId" clId="{B4DB2928-3EFF-4507-ABD0-3894F091460A}" dt="2020-05-04T19:30:01.406" v="10636" actId="165"/>
          <ac:spMkLst>
            <pc:docMk/>
            <pc:sldMk cId="2863535548" sldId="354"/>
            <ac:spMk id="209" creationId="{815A11AA-4979-4327-B0D2-C8B3378BEA1D}"/>
          </ac:spMkLst>
        </pc:spChg>
        <pc:spChg chg="mod topLvl">
          <ac:chgData name="vijay kumar" userId="0eb738f014aa4543" providerId="LiveId" clId="{B4DB2928-3EFF-4507-ABD0-3894F091460A}" dt="2020-05-07T09:59:44.797" v="11343" actId="338"/>
          <ac:spMkLst>
            <pc:docMk/>
            <pc:sldMk cId="2863535548" sldId="354"/>
            <ac:spMk id="209" creationId="{E10CBF3D-C820-4F1C-8FB4-F070EEE56374}"/>
          </ac:spMkLst>
        </pc:spChg>
        <pc:spChg chg="mod topLvl">
          <ac:chgData name="vijay kumar" userId="0eb738f014aa4543" providerId="LiveId" clId="{B4DB2928-3EFF-4507-ABD0-3894F091460A}" dt="2020-05-07T09:59:44.797" v="11343" actId="338"/>
          <ac:spMkLst>
            <pc:docMk/>
            <pc:sldMk cId="2863535548" sldId="354"/>
            <ac:spMk id="210" creationId="{7A29BD3C-98D4-470D-BCF8-6C2530370193}"/>
          </ac:spMkLst>
        </pc:spChg>
        <pc:spChg chg="mod">
          <ac:chgData name="vijay kumar" userId="0eb738f014aa4543" providerId="LiveId" clId="{B4DB2928-3EFF-4507-ABD0-3894F091460A}" dt="2020-05-04T19:30:01.406" v="10636" actId="165"/>
          <ac:spMkLst>
            <pc:docMk/>
            <pc:sldMk cId="2863535548" sldId="354"/>
            <ac:spMk id="210" creationId="{EEA9D8FA-5322-472A-858F-5C8D05E671AD}"/>
          </ac:spMkLst>
        </pc:spChg>
        <pc:spChg chg="mod">
          <ac:chgData name="vijay kumar" userId="0eb738f014aa4543" providerId="LiveId" clId="{B4DB2928-3EFF-4507-ABD0-3894F091460A}" dt="2020-05-04T19:30:01.406" v="10636" actId="165"/>
          <ac:spMkLst>
            <pc:docMk/>
            <pc:sldMk cId="2863535548" sldId="354"/>
            <ac:spMk id="211" creationId="{0116B3D3-9C83-42DC-9B1A-266175902213}"/>
          </ac:spMkLst>
        </pc:spChg>
        <pc:spChg chg="mod topLvl">
          <ac:chgData name="vijay kumar" userId="0eb738f014aa4543" providerId="LiveId" clId="{B4DB2928-3EFF-4507-ABD0-3894F091460A}" dt="2020-05-07T09:59:44.797" v="11343" actId="338"/>
          <ac:spMkLst>
            <pc:docMk/>
            <pc:sldMk cId="2863535548" sldId="354"/>
            <ac:spMk id="211" creationId="{25C263B2-45CD-4C3E-89A2-8C65E57AC908}"/>
          </ac:spMkLst>
        </pc:spChg>
        <pc:spChg chg="mod">
          <ac:chgData name="vijay kumar" userId="0eb738f014aa4543" providerId="LiveId" clId="{B4DB2928-3EFF-4507-ABD0-3894F091460A}" dt="2020-05-04T19:30:01.406" v="10636" actId="165"/>
          <ac:spMkLst>
            <pc:docMk/>
            <pc:sldMk cId="2863535548" sldId="354"/>
            <ac:spMk id="212" creationId="{3321EE20-8F8B-40F8-AD20-5F3ED1B44315}"/>
          </ac:spMkLst>
        </pc:spChg>
        <pc:spChg chg="del mod topLvl">
          <ac:chgData name="vijay kumar" userId="0eb738f014aa4543" providerId="LiveId" clId="{B4DB2928-3EFF-4507-ABD0-3894F091460A}" dt="2020-05-07T09:44:56.490" v="10809" actId="478"/>
          <ac:spMkLst>
            <pc:docMk/>
            <pc:sldMk cId="2863535548" sldId="354"/>
            <ac:spMk id="212" creationId="{495D160C-F135-4572-955E-003E83C87D6E}"/>
          </ac:spMkLst>
        </pc:spChg>
        <pc:spChg chg="del mod topLvl">
          <ac:chgData name="vijay kumar" userId="0eb738f014aa4543" providerId="LiveId" clId="{B4DB2928-3EFF-4507-ABD0-3894F091460A}" dt="2020-05-07T09:44:56.490" v="10809" actId="478"/>
          <ac:spMkLst>
            <pc:docMk/>
            <pc:sldMk cId="2863535548" sldId="354"/>
            <ac:spMk id="213" creationId="{B7AFD166-2174-4251-B785-2B2DF106B142}"/>
          </ac:spMkLst>
        </pc:spChg>
        <pc:spChg chg="mod">
          <ac:chgData name="vijay kumar" userId="0eb738f014aa4543" providerId="LiveId" clId="{B4DB2928-3EFF-4507-ABD0-3894F091460A}" dt="2020-05-04T19:30:01.406" v="10636" actId="165"/>
          <ac:spMkLst>
            <pc:docMk/>
            <pc:sldMk cId="2863535548" sldId="354"/>
            <ac:spMk id="213" creationId="{BC0E8198-C083-46A4-8012-DAE454D44EF0}"/>
          </ac:spMkLst>
        </pc:spChg>
        <pc:spChg chg="mod">
          <ac:chgData name="vijay kumar" userId="0eb738f014aa4543" providerId="LiveId" clId="{B4DB2928-3EFF-4507-ABD0-3894F091460A}" dt="2020-05-04T19:30:01.406" v="10636" actId="165"/>
          <ac:spMkLst>
            <pc:docMk/>
            <pc:sldMk cId="2863535548" sldId="354"/>
            <ac:spMk id="214" creationId="{621CDE45-4697-4E67-B405-21B1D2C8267D}"/>
          </ac:spMkLst>
        </pc:spChg>
        <pc:spChg chg="del mod topLvl">
          <ac:chgData name="vijay kumar" userId="0eb738f014aa4543" providerId="LiveId" clId="{B4DB2928-3EFF-4507-ABD0-3894F091460A}" dt="2020-05-07T09:44:44.249" v="10806" actId="478"/>
          <ac:spMkLst>
            <pc:docMk/>
            <pc:sldMk cId="2863535548" sldId="354"/>
            <ac:spMk id="214" creationId="{D4A2F5B7-E118-4F85-844E-4A68C037CE98}"/>
          </ac:spMkLst>
        </pc:spChg>
        <pc:spChg chg="del mod topLvl">
          <ac:chgData name="vijay kumar" userId="0eb738f014aa4543" providerId="LiveId" clId="{B4DB2928-3EFF-4507-ABD0-3894F091460A}" dt="2020-05-07T09:44:44.249" v="10806" actId="478"/>
          <ac:spMkLst>
            <pc:docMk/>
            <pc:sldMk cId="2863535548" sldId="354"/>
            <ac:spMk id="215" creationId="{0498B9A1-E290-4824-9929-EA4993D34A74}"/>
          </ac:spMkLst>
        </pc:spChg>
        <pc:spChg chg="mod">
          <ac:chgData name="vijay kumar" userId="0eb738f014aa4543" providerId="LiveId" clId="{B4DB2928-3EFF-4507-ABD0-3894F091460A}" dt="2020-05-04T19:30:01.406" v="10636" actId="165"/>
          <ac:spMkLst>
            <pc:docMk/>
            <pc:sldMk cId="2863535548" sldId="354"/>
            <ac:spMk id="215" creationId="{44C75D45-EE6D-4DFA-9987-C2735F0BB8A0}"/>
          </ac:spMkLst>
        </pc:spChg>
        <pc:spChg chg="del mod topLvl">
          <ac:chgData name="vijay kumar" userId="0eb738f014aa4543" providerId="LiveId" clId="{B4DB2928-3EFF-4507-ABD0-3894F091460A}" dt="2020-05-07T09:44:52.615" v="10808" actId="478"/>
          <ac:spMkLst>
            <pc:docMk/>
            <pc:sldMk cId="2863535548" sldId="354"/>
            <ac:spMk id="216" creationId="{45C829E6-74C3-4B34-96D0-E6C0A3C3FBDA}"/>
          </ac:spMkLst>
        </pc:spChg>
        <pc:spChg chg="mod">
          <ac:chgData name="vijay kumar" userId="0eb738f014aa4543" providerId="LiveId" clId="{B4DB2928-3EFF-4507-ABD0-3894F091460A}" dt="2020-05-04T19:30:01.406" v="10636" actId="165"/>
          <ac:spMkLst>
            <pc:docMk/>
            <pc:sldMk cId="2863535548" sldId="354"/>
            <ac:spMk id="216" creationId="{C9C332C4-9326-46E4-B23D-55D2B472A5A5}"/>
          </ac:spMkLst>
        </pc:spChg>
        <pc:spChg chg="del mod topLvl">
          <ac:chgData name="vijay kumar" userId="0eb738f014aa4543" providerId="LiveId" clId="{B4DB2928-3EFF-4507-ABD0-3894F091460A}" dt="2020-05-07T09:44:52.615" v="10808" actId="478"/>
          <ac:spMkLst>
            <pc:docMk/>
            <pc:sldMk cId="2863535548" sldId="354"/>
            <ac:spMk id="217" creationId="{9BA86191-5FFE-4536-9CF0-C1375C05C66C}"/>
          </ac:spMkLst>
        </pc:spChg>
        <pc:spChg chg="mod">
          <ac:chgData name="vijay kumar" userId="0eb738f014aa4543" providerId="LiveId" clId="{B4DB2928-3EFF-4507-ABD0-3894F091460A}" dt="2020-05-04T19:30:01.406" v="10636" actId="165"/>
          <ac:spMkLst>
            <pc:docMk/>
            <pc:sldMk cId="2863535548" sldId="354"/>
            <ac:spMk id="217" creationId="{9DEC3524-219E-4F25-BE06-1F7460BBE055}"/>
          </ac:spMkLst>
        </pc:spChg>
        <pc:spChg chg="mod">
          <ac:chgData name="vijay kumar" userId="0eb738f014aa4543" providerId="LiveId" clId="{B4DB2928-3EFF-4507-ABD0-3894F091460A}" dt="2020-05-04T19:30:01.406" v="10636" actId="165"/>
          <ac:spMkLst>
            <pc:docMk/>
            <pc:sldMk cId="2863535548" sldId="354"/>
            <ac:spMk id="218" creationId="{4AADD0F4-1B74-415C-ADF0-C2A6EBE51200}"/>
          </ac:spMkLst>
        </pc:spChg>
        <pc:spChg chg="del mod topLvl">
          <ac:chgData name="vijay kumar" userId="0eb738f014aa4543" providerId="LiveId" clId="{B4DB2928-3EFF-4507-ABD0-3894F091460A}" dt="2020-05-07T09:44:48.897" v="10807" actId="478"/>
          <ac:spMkLst>
            <pc:docMk/>
            <pc:sldMk cId="2863535548" sldId="354"/>
            <ac:spMk id="218" creationId="{D9AE1C3E-6CEE-4228-85BB-BD483EC0AA56}"/>
          </ac:spMkLst>
        </pc:spChg>
        <pc:spChg chg="mod">
          <ac:chgData name="vijay kumar" userId="0eb738f014aa4543" providerId="LiveId" clId="{B4DB2928-3EFF-4507-ABD0-3894F091460A}" dt="2020-05-07T09:59:44.797" v="11343" actId="338"/>
          <ac:spMkLst>
            <pc:docMk/>
            <pc:sldMk cId="2863535548" sldId="354"/>
            <ac:spMk id="220" creationId="{2C8C86C9-5B9C-4BB7-81B6-A19476BEA372}"/>
          </ac:spMkLst>
        </pc:spChg>
        <pc:spChg chg="mod">
          <ac:chgData name="vijay kumar" userId="0eb738f014aa4543" providerId="LiveId" clId="{B4DB2928-3EFF-4507-ABD0-3894F091460A}" dt="2020-05-07T09:59:44.797" v="11343" actId="338"/>
          <ac:spMkLst>
            <pc:docMk/>
            <pc:sldMk cId="2863535548" sldId="354"/>
            <ac:spMk id="221" creationId="{D1423F18-C638-46C6-8D43-DB904B2C9510}"/>
          </ac:spMkLst>
        </pc:spChg>
        <pc:spChg chg="mod">
          <ac:chgData name="vijay kumar" userId="0eb738f014aa4543" providerId="LiveId" clId="{B4DB2928-3EFF-4507-ABD0-3894F091460A}" dt="2020-05-07T09:59:44.797" v="11343" actId="338"/>
          <ac:spMkLst>
            <pc:docMk/>
            <pc:sldMk cId="2863535548" sldId="354"/>
            <ac:spMk id="222" creationId="{276D8B71-93AC-489D-A7DC-94315A9A5B7A}"/>
          </ac:spMkLst>
        </pc:spChg>
        <pc:spChg chg="mod">
          <ac:chgData name="vijay kumar" userId="0eb738f014aa4543" providerId="LiveId" clId="{B4DB2928-3EFF-4507-ABD0-3894F091460A}" dt="2020-05-07T09:59:44.797" v="11343" actId="338"/>
          <ac:spMkLst>
            <pc:docMk/>
            <pc:sldMk cId="2863535548" sldId="354"/>
            <ac:spMk id="223" creationId="{2FDB545D-A882-40D7-9CC6-1C524B8D5C25}"/>
          </ac:spMkLst>
        </pc:spChg>
        <pc:spChg chg="mod">
          <ac:chgData name="vijay kumar" userId="0eb738f014aa4543" providerId="LiveId" clId="{B4DB2928-3EFF-4507-ABD0-3894F091460A}" dt="2020-05-07T09:59:44.797" v="11343" actId="338"/>
          <ac:spMkLst>
            <pc:docMk/>
            <pc:sldMk cId="2863535548" sldId="354"/>
            <ac:spMk id="224" creationId="{EF1CC72B-155C-45C3-B1AE-5410A8BB144F}"/>
          </ac:spMkLst>
        </pc:spChg>
        <pc:spChg chg="mod">
          <ac:chgData name="vijay kumar" userId="0eb738f014aa4543" providerId="LiveId" clId="{B4DB2928-3EFF-4507-ABD0-3894F091460A}" dt="2020-05-07T09:59:44.797" v="11343" actId="338"/>
          <ac:spMkLst>
            <pc:docMk/>
            <pc:sldMk cId="2863535548" sldId="354"/>
            <ac:spMk id="225" creationId="{7E4F43CF-D91B-455D-81E3-2560FADC7F8C}"/>
          </ac:spMkLst>
        </pc:spChg>
        <pc:spChg chg="mod">
          <ac:chgData name="vijay kumar" userId="0eb738f014aa4543" providerId="LiveId" clId="{B4DB2928-3EFF-4507-ABD0-3894F091460A}" dt="2020-05-07T09:59:44.797" v="11343" actId="338"/>
          <ac:spMkLst>
            <pc:docMk/>
            <pc:sldMk cId="2863535548" sldId="354"/>
            <ac:spMk id="226" creationId="{65039E69-485E-40F3-8E86-D5E8006C2204}"/>
          </ac:spMkLst>
        </pc:spChg>
        <pc:spChg chg="mod">
          <ac:chgData name="vijay kumar" userId="0eb738f014aa4543" providerId="LiveId" clId="{B4DB2928-3EFF-4507-ABD0-3894F091460A}" dt="2020-05-07T09:59:44.797" v="11343" actId="338"/>
          <ac:spMkLst>
            <pc:docMk/>
            <pc:sldMk cId="2863535548" sldId="354"/>
            <ac:spMk id="227" creationId="{58DBD8EA-85BF-441B-B172-693F96311087}"/>
          </ac:spMkLst>
        </pc:spChg>
        <pc:spChg chg="mod">
          <ac:chgData name="vijay kumar" userId="0eb738f014aa4543" providerId="LiveId" clId="{B4DB2928-3EFF-4507-ABD0-3894F091460A}" dt="2020-05-07T09:59:44.797" v="11343" actId="338"/>
          <ac:spMkLst>
            <pc:docMk/>
            <pc:sldMk cId="2863535548" sldId="354"/>
            <ac:spMk id="228" creationId="{E66163AC-97C7-4574-AD96-9E945046F9CA}"/>
          </ac:spMkLst>
        </pc:spChg>
        <pc:spChg chg="mod">
          <ac:chgData name="vijay kumar" userId="0eb738f014aa4543" providerId="LiveId" clId="{B4DB2928-3EFF-4507-ABD0-3894F091460A}" dt="2020-05-07T09:59:44.797" v="11343" actId="338"/>
          <ac:spMkLst>
            <pc:docMk/>
            <pc:sldMk cId="2863535548" sldId="354"/>
            <ac:spMk id="229" creationId="{CF06DEBA-FC9C-4D3C-8C44-6554940CA829}"/>
          </ac:spMkLst>
        </pc:spChg>
        <pc:spChg chg="mod">
          <ac:chgData name="vijay kumar" userId="0eb738f014aa4543" providerId="LiveId" clId="{B4DB2928-3EFF-4507-ABD0-3894F091460A}" dt="2020-05-07T09:59:44.797" v="11343" actId="338"/>
          <ac:spMkLst>
            <pc:docMk/>
            <pc:sldMk cId="2863535548" sldId="354"/>
            <ac:spMk id="230" creationId="{DAA73842-7498-4DD4-8CD5-95ECCA48B175}"/>
          </ac:spMkLst>
        </pc:spChg>
        <pc:spChg chg="mod">
          <ac:chgData name="vijay kumar" userId="0eb738f014aa4543" providerId="LiveId" clId="{B4DB2928-3EFF-4507-ABD0-3894F091460A}" dt="2020-05-07T09:59:44.797" v="11343" actId="338"/>
          <ac:spMkLst>
            <pc:docMk/>
            <pc:sldMk cId="2863535548" sldId="354"/>
            <ac:spMk id="231" creationId="{46428BB4-23FC-4DAA-BF4D-46AE0F95CB58}"/>
          </ac:spMkLst>
        </pc:spChg>
        <pc:spChg chg="add mod topLvl">
          <ac:chgData name="vijay kumar" userId="0eb738f014aa4543" providerId="LiveId" clId="{B4DB2928-3EFF-4507-ABD0-3894F091460A}" dt="2020-05-07T11:07:59.161" v="12726" actId="1076"/>
          <ac:spMkLst>
            <pc:docMk/>
            <pc:sldMk cId="2863535548" sldId="354"/>
            <ac:spMk id="232" creationId="{266E1138-4749-455D-BBC7-A9E1662C0799}"/>
          </ac:spMkLst>
        </pc:spChg>
        <pc:spChg chg="add mod topLvl">
          <ac:chgData name="vijay kumar" userId="0eb738f014aa4543" providerId="LiveId" clId="{B4DB2928-3EFF-4507-ABD0-3894F091460A}" dt="2020-05-07T11:07:59.161" v="12726" actId="1076"/>
          <ac:spMkLst>
            <pc:docMk/>
            <pc:sldMk cId="2863535548" sldId="354"/>
            <ac:spMk id="233" creationId="{5866FDF0-713B-4F0D-A140-388003454D1E}"/>
          </ac:spMkLst>
        </pc:spChg>
        <pc:spChg chg="add mod topLvl">
          <ac:chgData name="vijay kumar" userId="0eb738f014aa4543" providerId="LiveId" clId="{B4DB2928-3EFF-4507-ABD0-3894F091460A}" dt="2020-05-07T11:07:59.161" v="12726" actId="1076"/>
          <ac:spMkLst>
            <pc:docMk/>
            <pc:sldMk cId="2863535548" sldId="354"/>
            <ac:spMk id="234" creationId="{21095107-B21F-476D-9E0C-B86FFF4BD42A}"/>
          </ac:spMkLst>
        </pc:spChg>
        <pc:spChg chg="del mod topLvl">
          <ac:chgData name="vijay kumar" userId="0eb738f014aa4543" providerId="LiveId" clId="{B4DB2928-3EFF-4507-ABD0-3894F091460A}" dt="2020-05-02T21:21:29.129" v="7125" actId="478"/>
          <ac:spMkLst>
            <pc:docMk/>
            <pc:sldMk cId="2863535548" sldId="354"/>
            <ac:spMk id="235" creationId="{04E17A05-0292-4B3B-A2F3-D98914027E06}"/>
          </ac:spMkLst>
        </pc:spChg>
        <pc:spChg chg="mod">
          <ac:chgData name="vijay kumar" userId="0eb738f014aa4543" providerId="LiveId" clId="{B4DB2928-3EFF-4507-ABD0-3894F091460A}" dt="2020-05-07T09:59:44.797" v="11343" actId="338"/>
          <ac:spMkLst>
            <pc:docMk/>
            <pc:sldMk cId="2863535548" sldId="354"/>
            <ac:spMk id="235" creationId="{97D817E8-6BF2-4A46-BA49-70CD30D979EC}"/>
          </ac:spMkLst>
        </pc:spChg>
        <pc:spChg chg="mod topLvl">
          <ac:chgData name="vijay kumar" userId="0eb738f014aa4543" providerId="LiveId" clId="{B4DB2928-3EFF-4507-ABD0-3894F091460A}" dt="2020-05-02T21:20:48.089" v="7080" actId="164"/>
          <ac:spMkLst>
            <pc:docMk/>
            <pc:sldMk cId="2863535548" sldId="354"/>
            <ac:spMk id="236" creationId="{4BD90B8B-B25E-4E4E-9C75-77A5C3E5C8E9}"/>
          </ac:spMkLst>
        </pc:spChg>
        <pc:spChg chg="mod">
          <ac:chgData name="vijay kumar" userId="0eb738f014aa4543" providerId="LiveId" clId="{B4DB2928-3EFF-4507-ABD0-3894F091460A}" dt="2020-05-07T09:59:44.797" v="11343" actId="338"/>
          <ac:spMkLst>
            <pc:docMk/>
            <pc:sldMk cId="2863535548" sldId="354"/>
            <ac:spMk id="236" creationId="{713D3239-9312-4964-BE3D-21232B6A4E56}"/>
          </ac:spMkLst>
        </pc:spChg>
        <pc:spChg chg="mod topLvl">
          <ac:chgData name="vijay kumar" userId="0eb738f014aa4543" providerId="LiveId" clId="{B4DB2928-3EFF-4507-ABD0-3894F091460A}" dt="2020-05-02T21:20:48.089" v="7080" actId="164"/>
          <ac:spMkLst>
            <pc:docMk/>
            <pc:sldMk cId="2863535548" sldId="354"/>
            <ac:spMk id="237" creationId="{1B9D3724-11C2-412E-AF20-B43E5206DAF4}"/>
          </ac:spMkLst>
        </pc:spChg>
        <pc:spChg chg="mod">
          <ac:chgData name="vijay kumar" userId="0eb738f014aa4543" providerId="LiveId" clId="{B4DB2928-3EFF-4507-ABD0-3894F091460A}" dt="2020-05-07T09:59:44.797" v="11343" actId="338"/>
          <ac:spMkLst>
            <pc:docMk/>
            <pc:sldMk cId="2863535548" sldId="354"/>
            <ac:spMk id="237" creationId="{DB9B49C1-AEEF-4F3C-A5A7-57C6AB21433E}"/>
          </ac:spMkLst>
        </pc:spChg>
        <pc:spChg chg="mod topLvl">
          <ac:chgData name="vijay kumar" userId="0eb738f014aa4543" providerId="LiveId" clId="{B4DB2928-3EFF-4507-ABD0-3894F091460A}" dt="2020-05-02T21:20:48.089" v="7080" actId="164"/>
          <ac:spMkLst>
            <pc:docMk/>
            <pc:sldMk cId="2863535548" sldId="354"/>
            <ac:spMk id="238" creationId="{35911162-3E26-4B2A-B4A1-62557CB2F5E6}"/>
          </ac:spMkLst>
        </pc:spChg>
        <pc:spChg chg="mod">
          <ac:chgData name="vijay kumar" userId="0eb738f014aa4543" providerId="LiveId" clId="{B4DB2928-3EFF-4507-ABD0-3894F091460A}" dt="2020-05-07T09:59:44.797" v="11343" actId="338"/>
          <ac:spMkLst>
            <pc:docMk/>
            <pc:sldMk cId="2863535548" sldId="354"/>
            <ac:spMk id="238" creationId="{9FFC4B4D-5E7E-4674-B4D0-28B2A527BDE0}"/>
          </ac:spMkLst>
        </pc:spChg>
        <pc:spChg chg="mod">
          <ac:chgData name="vijay kumar" userId="0eb738f014aa4543" providerId="LiveId" clId="{B4DB2928-3EFF-4507-ABD0-3894F091460A}" dt="2020-05-07T09:59:44.797" v="11343" actId="338"/>
          <ac:spMkLst>
            <pc:docMk/>
            <pc:sldMk cId="2863535548" sldId="354"/>
            <ac:spMk id="239" creationId="{5205693F-3180-4B30-944F-8AA5E14A75CC}"/>
          </ac:spMkLst>
        </pc:spChg>
        <pc:spChg chg="mod topLvl">
          <ac:chgData name="vijay kumar" userId="0eb738f014aa4543" providerId="LiveId" clId="{B4DB2928-3EFF-4507-ABD0-3894F091460A}" dt="2020-05-02T21:20:48.089" v="7080" actId="164"/>
          <ac:spMkLst>
            <pc:docMk/>
            <pc:sldMk cId="2863535548" sldId="354"/>
            <ac:spMk id="239" creationId="{F3F6257A-2F49-4581-8170-C3B937A986B2}"/>
          </ac:spMkLst>
        </pc:spChg>
        <pc:spChg chg="mod">
          <ac:chgData name="vijay kumar" userId="0eb738f014aa4543" providerId="LiveId" clId="{B4DB2928-3EFF-4507-ABD0-3894F091460A}" dt="2020-05-07T09:59:44.797" v="11343" actId="338"/>
          <ac:spMkLst>
            <pc:docMk/>
            <pc:sldMk cId="2863535548" sldId="354"/>
            <ac:spMk id="240" creationId="{687C1722-DF7F-41BD-A325-1BF3EEE5A237}"/>
          </ac:spMkLst>
        </pc:spChg>
        <pc:spChg chg="mod topLvl">
          <ac:chgData name="vijay kumar" userId="0eb738f014aa4543" providerId="LiveId" clId="{B4DB2928-3EFF-4507-ABD0-3894F091460A}" dt="2020-05-02T21:20:48.089" v="7080" actId="164"/>
          <ac:spMkLst>
            <pc:docMk/>
            <pc:sldMk cId="2863535548" sldId="354"/>
            <ac:spMk id="240" creationId="{7CD3CC3D-48B7-44DA-A5B5-3D972BF38F50}"/>
          </ac:spMkLst>
        </pc:spChg>
        <pc:spChg chg="mod">
          <ac:chgData name="vijay kumar" userId="0eb738f014aa4543" providerId="LiveId" clId="{B4DB2928-3EFF-4507-ABD0-3894F091460A}" dt="2020-05-07T09:59:44.797" v="11343" actId="338"/>
          <ac:spMkLst>
            <pc:docMk/>
            <pc:sldMk cId="2863535548" sldId="354"/>
            <ac:spMk id="241" creationId="{B418569F-CA59-4CF3-9A43-177BF73A58C3}"/>
          </ac:spMkLst>
        </pc:spChg>
        <pc:spChg chg="mod topLvl">
          <ac:chgData name="vijay kumar" userId="0eb738f014aa4543" providerId="LiveId" clId="{B4DB2928-3EFF-4507-ABD0-3894F091460A}" dt="2020-05-02T21:20:48.089" v="7080" actId="164"/>
          <ac:spMkLst>
            <pc:docMk/>
            <pc:sldMk cId="2863535548" sldId="354"/>
            <ac:spMk id="241" creationId="{CCAB8DAB-0DEE-490B-902B-C640415DEE1F}"/>
          </ac:spMkLst>
        </pc:spChg>
        <pc:spChg chg="mod">
          <ac:chgData name="vijay kumar" userId="0eb738f014aa4543" providerId="LiveId" clId="{B4DB2928-3EFF-4507-ABD0-3894F091460A}" dt="2020-05-07T09:59:44.797" v="11343" actId="338"/>
          <ac:spMkLst>
            <pc:docMk/>
            <pc:sldMk cId="2863535548" sldId="354"/>
            <ac:spMk id="242" creationId="{2C66FC56-C919-42EB-B4E1-775695A8A9B2}"/>
          </ac:spMkLst>
        </pc:spChg>
        <pc:spChg chg="mod topLvl">
          <ac:chgData name="vijay kumar" userId="0eb738f014aa4543" providerId="LiveId" clId="{B4DB2928-3EFF-4507-ABD0-3894F091460A}" dt="2020-05-02T21:20:48.089" v="7080" actId="164"/>
          <ac:spMkLst>
            <pc:docMk/>
            <pc:sldMk cId="2863535548" sldId="354"/>
            <ac:spMk id="242" creationId="{31AF6BD0-8DD5-43FB-AB77-92E39A930EF0}"/>
          </ac:spMkLst>
        </pc:spChg>
        <pc:spChg chg="mod topLvl">
          <ac:chgData name="vijay kumar" userId="0eb738f014aa4543" providerId="LiveId" clId="{B4DB2928-3EFF-4507-ABD0-3894F091460A}" dt="2020-05-02T21:20:48.089" v="7080" actId="164"/>
          <ac:spMkLst>
            <pc:docMk/>
            <pc:sldMk cId="2863535548" sldId="354"/>
            <ac:spMk id="243" creationId="{BAA41DA8-4136-4E6D-BE8C-C6915E686DEA}"/>
          </ac:spMkLst>
        </pc:spChg>
        <pc:spChg chg="mod">
          <ac:chgData name="vijay kumar" userId="0eb738f014aa4543" providerId="LiveId" clId="{B4DB2928-3EFF-4507-ABD0-3894F091460A}" dt="2020-05-07T09:59:44.797" v="11343" actId="338"/>
          <ac:spMkLst>
            <pc:docMk/>
            <pc:sldMk cId="2863535548" sldId="354"/>
            <ac:spMk id="243" creationId="{E857D0B6-97EC-4B93-93D1-CD6CC9C476F3}"/>
          </ac:spMkLst>
        </pc:spChg>
        <pc:spChg chg="mod">
          <ac:chgData name="vijay kumar" userId="0eb738f014aa4543" providerId="LiveId" clId="{B4DB2928-3EFF-4507-ABD0-3894F091460A}" dt="2020-05-07T09:59:44.797" v="11343" actId="338"/>
          <ac:spMkLst>
            <pc:docMk/>
            <pc:sldMk cId="2863535548" sldId="354"/>
            <ac:spMk id="244" creationId="{020F0A1C-569D-46FD-8A11-3C36F1118DA3}"/>
          </ac:spMkLst>
        </pc:spChg>
        <pc:spChg chg="mod topLvl">
          <ac:chgData name="vijay kumar" userId="0eb738f014aa4543" providerId="LiveId" clId="{B4DB2928-3EFF-4507-ABD0-3894F091460A}" dt="2020-05-02T21:20:48.089" v="7080" actId="164"/>
          <ac:spMkLst>
            <pc:docMk/>
            <pc:sldMk cId="2863535548" sldId="354"/>
            <ac:spMk id="244" creationId="{9D1D3E59-18FE-4408-8EAE-AAA926016A5C}"/>
          </ac:spMkLst>
        </pc:spChg>
        <pc:spChg chg="mod">
          <ac:chgData name="vijay kumar" userId="0eb738f014aa4543" providerId="LiveId" clId="{B4DB2928-3EFF-4507-ABD0-3894F091460A}" dt="2020-05-07T09:59:44.797" v="11343" actId="338"/>
          <ac:spMkLst>
            <pc:docMk/>
            <pc:sldMk cId="2863535548" sldId="354"/>
            <ac:spMk id="245" creationId="{8F08BC18-205F-46A7-92E0-B299E333D0EA}"/>
          </ac:spMkLst>
        </pc:spChg>
        <pc:spChg chg="del mod topLvl">
          <ac:chgData name="vijay kumar" userId="0eb738f014aa4543" providerId="LiveId" clId="{B4DB2928-3EFF-4507-ABD0-3894F091460A}" dt="2020-05-02T21:19:12.587" v="7041" actId="478"/>
          <ac:spMkLst>
            <pc:docMk/>
            <pc:sldMk cId="2863535548" sldId="354"/>
            <ac:spMk id="245" creationId="{C4CD01AA-054F-480E-BE81-2F8DD0D04F55}"/>
          </ac:spMkLst>
        </pc:spChg>
        <pc:spChg chg="mod">
          <ac:chgData name="vijay kumar" userId="0eb738f014aa4543" providerId="LiveId" clId="{B4DB2928-3EFF-4507-ABD0-3894F091460A}" dt="2020-05-07T09:59:44.797" v="11343" actId="338"/>
          <ac:spMkLst>
            <pc:docMk/>
            <pc:sldMk cId="2863535548" sldId="354"/>
            <ac:spMk id="246" creationId="{6B3A568D-4D33-46FE-BBE3-7888F89FE34E}"/>
          </ac:spMkLst>
        </pc:spChg>
        <pc:spChg chg="del mod topLvl">
          <ac:chgData name="vijay kumar" userId="0eb738f014aa4543" providerId="LiveId" clId="{B4DB2928-3EFF-4507-ABD0-3894F091460A}" dt="2020-05-02T21:19:12.587" v="7041" actId="478"/>
          <ac:spMkLst>
            <pc:docMk/>
            <pc:sldMk cId="2863535548" sldId="354"/>
            <ac:spMk id="246" creationId="{6DFF2D53-9E49-4FBD-AF71-01A4FA9BAA32}"/>
          </ac:spMkLst>
        </pc:spChg>
        <pc:spChg chg="mod">
          <ac:chgData name="vijay kumar" userId="0eb738f014aa4543" providerId="LiveId" clId="{B4DB2928-3EFF-4507-ABD0-3894F091460A}" dt="2020-05-07T09:59:44.797" v="11343" actId="338"/>
          <ac:spMkLst>
            <pc:docMk/>
            <pc:sldMk cId="2863535548" sldId="354"/>
            <ac:spMk id="247" creationId="{26E45D99-3817-44DC-A627-EBF600C6E31D}"/>
          </ac:spMkLst>
        </pc:spChg>
        <pc:spChg chg="del mod topLvl">
          <ac:chgData name="vijay kumar" userId="0eb738f014aa4543" providerId="LiveId" clId="{B4DB2928-3EFF-4507-ABD0-3894F091460A}" dt="2020-05-02T21:19:12.587" v="7041" actId="478"/>
          <ac:spMkLst>
            <pc:docMk/>
            <pc:sldMk cId="2863535548" sldId="354"/>
            <ac:spMk id="247" creationId="{4629300D-C602-4746-8658-88CDB36184C8}"/>
          </ac:spMkLst>
        </pc:spChg>
        <pc:spChg chg="del mod topLvl">
          <ac:chgData name="vijay kumar" userId="0eb738f014aa4543" providerId="LiveId" clId="{B4DB2928-3EFF-4507-ABD0-3894F091460A}" dt="2020-05-02T21:19:12.587" v="7041" actId="478"/>
          <ac:spMkLst>
            <pc:docMk/>
            <pc:sldMk cId="2863535548" sldId="354"/>
            <ac:spMk id="248" creationId="{A873743F-FFE9-4DF7-9476-A9380C5182C1}"/>
          </ac:spMkLst>
        </pc:spChg>
        <pc:spChg chg="mod">
          <ac:chgData name="vijay kumar" userId="0eb738f014aa4543" providerId="LiveId" clId="{B4DB2928-3EFF-4507-ABD0-3894F091460A}" dt="2020-05-07T09:59:44.797" v="11343" actId="338"/>
          <ac:spMkLst>
            <pc:docMk/>
            <pc:sldMk cId="2863535548" sldId="354"/>
            <ac:spMk id="248" creationId="{BBD92F09-7E33-49CB-A8AF-29456C8B3D57}"/>
          </ac:spMkLst>
        </pc:spChg>
        <pc:spChg chg="mod">
          <ac:chgData name="vijay kumar" userId="0eb738f014aa4543" providerId="LiveId" clId="{B4DB2928-3EFF-4507-ABD0-3894F091460A}" dt="2020-05-07T09:59:44.797" v="11343" actId="338"/>
          <ac:spMkLst>
            <pc:docMk/>
            <pc:sldMk cId="2863535548" sldId="354"/>
            <ac:spMk id="249" creationId="{54F942F0-4875-403F-A7AE-FD75E3AA1107}"/>
          </ac:spMkLst>
        </pc:spChg>
        <pc:spChg chg="del mod topLvl">
          <ac:chgData name="vijay kumar" userId="0eb738f014aa4543" providerId="LiveId" clId="{B4DB2928-3EFF-4507-ABD0-3894F091460A}" dt="2020-05-02T21:19:12.587" v="7041" actId="478"/>
          <ac:spMkLst>
            <pc:docMk/>
            <pc:sldMk cId="2863535548" sldId="354"/>
            <ac:spMk id="249" creationId="{93326546-28BB-4A86-943A-F3E763C63246}"/>
          </ac:spMkLst>
        </pc:spChg>
        <pc:spChg chg="mod">
          <ac:chgData name="vijay kumar" userId="0eb738f014aa4543" providerId="LiveId" clId="{B4DB2928-3EFF-4507-ABD0-3894F091460A}" dt="2020-05-07T09:59:44.797" v="11343" actId="338"/>
          <ac:spMkLst>
            <pc:docMk/>
            <pc:sldMk cId="2863535548" sldId="354"/>
            <ac:spMk id="250" creationId="{0BFD16A1-5C76-46E7-8856-19E10A93C84C}"/>
          </ac:spMkLst>
        </pc:spChg>
        <pc:spChg chg="del mod topLvl">
          <ac:chgData name="vijay kumar" userId="0eb738f014aa4543" providerId="LiveId" clId="{B4DB2928-3EFF-4507-ABD0-3894F091460A}" dt="2020-05-02T21:19:12.587" v="7041" actId="478"/>
          <ac:spMkLst>
            <pc:docMk/>
            <pc:sldMk cId="2863535548" sldId="354"/>
            <ac:spMk id="250" creationId="{921FE842-F7AA-43E0-AFAF-96DA947F7FDA}"/>
          </ac:spMkLst>
        </pc:spChg>
        <pc:spChg chg="del mod topLvl">
          <ac:chgData name="vijay kumar" userId="0eb738f014aa4543" providerId="LiveId" clId="{B4DB2928-3EFF-4507-ABD0-3894F091460A}" dt="2020-05-02T21:19:12.587" v="7041" actId="478"/>
          <ac:spMkLst>
            <pc:docMk/>
            <pc:sldMk cId="2863535548" sldId="354"/>
            <ac:spMk id="251" creationId="{687CD3BE-ED7B-472E-A7E3-F822672337EC}"/>
          </ac:spMkLst>
        </pc:spChg>
        <pc:spChg chg="mod">
          <ac:chgData name="vijay kumar" userId="0eb738f014aa4543" providerId="LiveId" clId="{B4DB2928-3EFF-4507-ABD0-3894F091460A}" dt="2020-05-07T09:59:44.797" v="11343" actId="338"/>
          <ac:spMkLst>
            <pc:docMk/>
            <pc:sldMk cId="2863535548" sldId="354"/>
            <ac:spMk id="251" creationId="{FF2E1B29-4365-4B2A-9C3F-D5647E16366A}"/>
          </ac:spMkLst>
        </pc:spChg>
        <pc:spChg chg="mod ord topLvl">
          <ac:chgData name="vijay kumar" userId="0eb738f014aa4543" providerId="LiveId" clId="{B4DB2928-3EFF-4507-ABD0-3894F091460A}" dt="2020-05-07T11:07:59.161" v="12726" actId="1076"/>
          <ac:spMkLst>
            <pc:docMk/>
            <pc:sldMk cId="2863535548" sldId="354"/>
            <ac:spMk id="252" creationId="{23B01161-9F5A-4F66-B392-3E32D1B03E5A}"/>
          </ac:spMkLst>
        </pc:spChg>
        <pc:spChg chg="del mod topLvl">
          <ac:chgData name="vijay kumar" userId="0eb738f014aa4543" providerId="LiveId" clId="{B4DB2928-3EFF-4507-ABD0-3894F091460A}" dt="2020-05-02T21:19:12.587" v="7041" actId="478"/>
          <ac:spMkLst>
            <pc:docMk/>
            <pc:sldMk cId="2863535548" sldId="354"/>
            <ac:spMk id="252" creationId="{FEFC2EB7-99F8-4D7B-8E2F-15C2D8CEF14B}"/>
          </ac:spMkLst>
        </pc:spChg>
        <pc:spChg chg="del mod topLvl">
          <ac:chgData name="vijay kumar" userId="0eb738f014aa4543" providerId="LiveId" clId="{B4DB2928-3EFF-4507-ABD0-3894F091460A}" dt="2020-05-02T21:19:12.587" v="7041" actId="478"/>
          <ac:spMkLst>
            <pc:docMk/>
            <pc:sldMk cId="2863535548" sldId="354"/>
            <ac:spMk id="253" creationId="{13721A85-E1D3-4DB3-B1CD-70F9D1C91A88}"/>
          </ac:spMkLst>
        </pc:spChg>
        <pc:spChg chg="mod ord topLvl">
          <ac:chgData name="vijay kumar" userId="0eb738f014aa4543" providerId="LiveId" clId="{B4DB2928-3EFF-4507-ABD0-3894F091460A}" dt="2020-05-07T11:07:59.161" v="12726" actId="1076"/>
          <ac:spMkLst>
            <pc:docMk/>
            <pc:sldMk cId="2863535548" sldId="354"/>
            <ac:spMk id="253" creationId="{546C9F8C-8741-4C1A-95AC-45FDE888DEDD}"/>
          </ac:spMkLst>
        </pc:spChg>
        <pc:spChg chg="del mod topLvl">
          <ac:chgData name="vijay kumar" userId="0eb738f014aa4543" providerId="LiveId" clId="{B4DB2928-3EFF-4507-ABD0-3894F091460A}" dt="2020-05-02T21:19:12.587" v="7041" actId="478"/>
          <ac:spMkLst>
            <pc:docMk/>
            <pc:sldMk cId="2863535548" sldId="354"/>
            <ac:spMk id="254" creationId="{6FF4BB6A-3059-4651-AECE-D61935D12768}"/>
          </ac:spMkLst>
        </pc:spChg>
        <pc:spChg chg="mod ord topLvl">
          <ac:chgData name="vijay kumar" userId="0eb738f014aa4543" providerId="LiveId" clId="{B4DB2928-3EFF-4507-ABD0-3894F091460A}" dt="2020-05-07T11:07:59.161" v="12726" actId="1076"/>
          <ac:spMkLst>
            <pc:docMk/>
            <pc:sldMk cId="2863535548" sldId="354"/>
            <ac:spMk id="254" creationId="{8BA69BF4-BDD7-4F2D-B716-C28E04C8972D}"/>
          </ac:spMkLst>
        </pc:spChg>
        <pc:spChg chg="mod ord topLvl">
          <ac:chgData name="vijay kumar" userId="0eb738f014aa4543" providerId="LiveId" clId="{B4DB2928-3EFF-4507-ABD0-3894F091460A}" dt="2020-05-07T11:07:59.161" v="12726" actId="1076"/>
          <ac:spMkLst>
            <pc:docMk/>
            <pc:sldMk cId="2863535548" sldId="354"/>
            <ac:spMk id="255" creationId="{03E79502-2324-464A-B3FD-EC49AA645C5E}"/>
          </ac:spMkLst>
        </pc:spChg>
        <pc:spChg chg="del mod topLvl">
          <ac:chgData name="vijay kumar" userId="0eb738f014aa4543" providerId="LiveId" clId="{B4DB2928-3EFF-4507-ABD0-3894F091460A}" dt="2020-05-02T21:23:42.138" v="7357" actId="478"/>
          <ac:spMkLst>
            <pc:docMk/>
            <pc:sldMk cId="2863535548" sldId="354"/>
            <ac:spMk id="255" creationId="{8C61B19A-2B23-4C0E-A27D-6C5010675C9A}"/>
          </ac:spMkLst>
        </pc:spChg>
        <pc:spChg chg="add mod">
          <ac:chgData name="vijay kumar" userId="0eb738f014aa4543" providerId="LiveId" clId="{B4DB2928-3EFF-4507-ABD0-3894F091460A}" dt="2020-05-02T21:23:37.928" v="7356" actId="164"/>
          <ac:spMkLst>
            <pc:docMk/>
            <pc:sldMk cId="2863535548" sldId="354"/>
            <ac:spMk id="256" creationId="{502B4A6E-5B62-4BC0-BA03-17CE5DAAF827}"/>
          </ac:spMkLst>
        </pc:spChg>
        <pc:spChg chg="del mod topLvl">
          <ac:chgData name="vijay kumar" userId="0eb738f014aa4543" providerId="LiveId" clId="{B4DB2928-3EFF-4507-ABD0-3894F091460A}" dt="2020-05-07T09:44:48.897" v="10807" actId="478"/>
          <ac:spMkLst>
            <pc:docMk/>
            <pc:sldMk cId="2863535548" sldId="354"/>
            <ac:spMk id="256" creationId="{C0BA585D-5462-4BBB-8095-73B1FEE7B575}"/>
          </ac:spMkLst>
        </pc:spChg>
        <pc:spChg chg="del mod topLvl">
          <ac:chgData name="vijay kumar" userId="0eb738f014aa4543" providerId="LiveId" clId="{B4DB2928-3EFF-4507-ABD0-3894F091460A}" dt="2020-05-07T09:44:44.249" v="10806" actId="478"/>
          <ac:spMkLst>
            <pc:docMk/>
            <pc:sldMk cId="2863535548" sldId="354"/>
            <ac:spMk id="257" creationId="{2EA4739D-BE48-4297-8DAB-9961931ECC17}"/>
          </ac:spMkLst>
        </pc:spChg>
        <pc:spChg chg="add mod">
          <ac:chgData name="vijay kumar" userId="0eb738f014aa4543" providerId="LiveId" clId="{B4DB2928-3EFF-4507-ABD0-3894F091460A}" dt="2020-05-02T21:23:37.928" v="7356" actId="164"/>
          <ac:spMkLst>
            <pc:docMk/>
            <pc:sldMk cId="2863535548" sldId="354"/>
            <ac:spMk id="257" creationId="{AC881B62-BF00-497E-927F-C14041A8D51B}"/>
          </ac:spMkLst>
        </pc:spChg>
        <pc:spChg chg="del mod topLvl">
          <ac:chgData name="vijay kumar" userId="0eb738f014aa4543" providerId="LiveId" clId="{B4DB2928-3EFF-4507-ABD0-3894F091460A}" dt="2020-05-07T09:44:44.249" v="10806" actId="478"/>
          <ac:spMkLst>
            <pc:docMk/>
            <pc:sldMk cId="2863535548" sldId="354"/>
            <ac:spMk id="258" creationId="{4A71DD94-A6A9-4500-A6BA-99889E63B1EA}"/>
          </ac:spMkLst>
        </pc:spChg>
        <pc:spChg chg="add mod">
          <ac:chgData name="vijay kumar" userId="0eb738f014aa4543" providerId="LiveId" clId="{B4DB2928-3EFF-4507-ABD0-3894F091460A}" dt="2020-05-02T21:23:37.928" v="7356" actId="164"/>
          <ac:spMkLst>
            <pc:docMk/>
            <pc:sldMk cId="2863535548" sldId="354"/>
            <ac:spMk id="258" creationId="{908192DC-CE1D-4EAB-BCE9-48A9B888E2E7}"/>
          </ac:spMkLst>
        </pc:spChg>
        <pc:spChg chg="del mod topLvl">
          <ac:chgData name="vijay kumar" userId="0eb738f014aa4543" providerId="LiveId" clId="{B4DB2928-3EFF-4507-ABD0-3894F091460A}" dt="2020-05-07T09:44:44.249" v="10806" actId="478"/>
          <ac:spMkLst>
            <pc:docMk/>
            <pc:sldMk cId="2863535548" sldId="354"/>
            <ac:spMk id="259" creationId="{E4F4B83B-3E44-4130-B52D-79D9074E9802}"/>
          </ac:spMkLst>
        </pc:spChg>
        <pc:spChg chg="del mod topLvl">
          <ac:chgData name="vijay kumar" userId="0eb738f014aa4543" providerId="LiveId" clId="{B4DB2928-3EFF-4507-ABD0-3894F091460A}" dt="2020-05-07T09:44:44.249" v="10806" actId="478"/>
          <ac:spMkLst>
            <pc:docMk/>
            <pc:sldMk cId="2863535548" sldId="354"/>
            <ac:spMk id="260" creationId="{51DBC77A-414C-4252-BC33-9F09ABA10164}"/>
          </ac:spMkLst>
        </pc:spChg>
        <pc:spChg chg="del mod topLvl">
          <ac:chgData name="vijay kumar" userId="0eb738f014aa4543" providerId="LiveId" clId="{B4DB2928-3EFF-4507-ABD0-3894F091460A}" dt="2020-05-07T09:44:44.249" v="10806" actId="478"/>
          <ac:spMkLst>
            <pc:docMk/>
            <pc:sldMk cId="2863535548" sldId="354"/>
            <ac:spMk id="261" creationId="{CACD4DE7-F825-4DFF-9CF0-D99060149246}"/>
          </ac:spMkLst>
        </pc:spChg>
        <pc:spChg chg="del mod topLvl">
          <ac:chgData name="vijay kumar" userId="0eb738f014aa4543" providerId="LiveId" clId="{B4DB2928-3EFF-4507-ABD0-3894F091460A}" dt="2020-05-07T09:44:44.249" v="10806" actId="478"/>
          <ac:spMkLst>
            <pc:docMk/>
            <pc:sldMk cId="2863535548" sldId="354"/>
            <ac:spMk id="262" creationId="{96650BEB-D03E-4E65-8624-1207D2F304B5}"/>
          </ac:spMkLst>
        </pc:spChg>
        <pc:spChg chg="del mod topLvl">
          <ac:chgData name="vijay kumar" userId="0eb738f014aa4543" providerId="LiveId" clId="{B4DB2928-3EFF-4507-ABD0-3894F091460A}" dt="2020-05-07T09:44:44.249" v="10806" actId="478"/>
          <ac:spMkLst>
            <pc:docMk/>
            <pc:sldMk cId="2863535548" sldId="354"/>
            <ac:spMk id="263" creationId="{3E58CFD7-C140-4FC3-8429-DC290A2B8C5C}"/>
          </ac:spMkLst>
        </pc:spChg>
        <pc:spChg chg="del mod topLvl">
          <ac:chgData name="vijay kumar" userId="0eb738f014aa4543" providerId="LiveId" clId="{B4DB2928-3EFF-4507-ABD0-3894F091460A}" dt="2020-05-07T09:44:44.249" v="10806" actId="478"/>
          <ac:spMkLst>
            <pc:docMk/>
            <pc:sldMk cId="2863535548" sldId="354"/>
            <ac:spMk id="264" creationId="{3266197A-8DC1-4935-8331-662CFD1A17AB}"/>
          </ac:spMkLst>
        </pc:spChg>
        <pc:spChg chg="del mod topLvl">
          <ac:chgData name="vijay kumar" userId="0eb738f014aa4543" providerId="LiveId" clId="{B4DB2928-3EFF-4507-ABD0-3894F091460A}" dt="2020-05-07T09:44:44.249" v="10806" actId="478"/>
          <ac:spMkLst>
            <pc:docMk/>
            <pc:sldMk cId="2863535548" sldId="354"/>
            <ac:spMk id="265" creationId="{A119300E-EEE4-4679-BE18-9205B5CBBC34}"/>
          </ac:spMkLst>
        </pc:spChg>
        <pc:spChg chg="del mod topLvl">
          <ac:chgData name="vijay kumar" userId="0eb738f014aa4543" providerId="LiveId" clId="{B4DB2928-3EFF-4507-ABD0-3894F091460A}" dt="2020-05-07T09:44:44.249" v="10806" actId="478"/>
          <ac:spMkLst>
            <pc:docMk/>
            <pc:sldMk cId="2863535548" sldId="354"/>
            <ac:spMk id="266" creationId="{FF234EDE-26D0-44C6-80CE-38004C769D03}"/>
          </ac:spMkLst>
        </pc:spChg>
        <pc:spChg chg="del mod topLvl">
          <ac:chgData name="vijay kumar" userId="0eb738f014aa4543" providerId="LiveId" clId="{B4DB2928-3EFF-4507-ABD0-3894F091460A}" dt="2020-05-07T09:44:44.249" v="10806" actId="478"/>
          <ac:spMkLst>
            <pc:docMk/>
            <pc:sldMk cId="2863535548" sldId="354"/>
            <ac:spMk id="267" creationId="{4406FB5A-7EAE-4D41-965B-3879C568713E}"/>
          </ac:spMkLst>
        </pc:spChg>
        <pc:spChg chg="del mod topLvl">
          <ac:chgData name="vijay kumar" userId="0eb738f014aa4543" providerId="LiveId" clId="{B4DB2928-3EFF-4507-ABD0-3894F091460A}" dt="2020-05-07T09:44:44.249" v="10806" actId="478"/>
          <ac:spMkLst>
            <pc:docMk/>
            <pc:sldMk cId="2863535548" sldId="354"/>
            <ac:spMk id="268" creationId="{A30E725F-D4BA-4225-A1B9-4A096C9C9FE8}"/>
          </ac:spMkLst>
        </pc:spChg>
        <pc:spChg chg="del mod topLvl">
          <ac:chgData name="vijay kumar" userId="0eb738f014aa4543" providerId="LiveId" clId="{B4DB2928-3EFF-4507-ABD0-3894F091460A}" dt="2020-05-07T09:44:44.249" v="10806" actId="478"/>
          <ac:spMkLst>
            <pc:docMk/>
            <pc:sldMk cId="2863535548" sldId="354"/>
            <ac:spMk id="269" creationId="{F6B087F0-D4D4-4B24-9592-02B41448737C}"/>
          </ac:spMkLst>
        </pc:spChg>
        <pc:spChg chg="del mod topLvl">
          <ac:chgData name="vijay kumar" userId="0eb738f014aa4543" providerId="LiveId" clId="{B4DB2928-3EFF-4507-ABD0-3894F091460A}" dt="2020-05-07T09:44:44.249" v="10806" actId="478"/>
          <ac:spMkLst>
            <pc:docMk/>
            <pc:sldMk cId="2863535548" sldId="354"/>
            <ac:spMk id="270" creationId="{F582CDA5-A6C0-44EF-A1D9-6994703FEA4F}"/>
          </ac:spMkLst>
        </pc:spChg>
        <pc:spChg chg="del mod topLvl">
          <ac:chgData name="vijay kumar" userId="0eb738f014aa4543" providerId="LiveId" clId="{B4DB2928-3EFF-4507-ABD0-3894F091460A}" dt="2020-05-07T09:44:44.249" v="10806" actId="478"/>
          <ac:spMkLst>
            <pc:docMk/>
            <pc:sldMk cId="2863535548" sldId="354"/>
            <ac:spMk id="271" creationId="{41611903-8E1F-495F-95DF-D1193FC62120}"/>
          </ac:spMkLst>
        </pc:spChg>
        <pc:spChg chg="del mod topLvl">
          <ac:chgData name="vijay kumar" userId="0eb738f014aa4543" providerId="LiveId" clId="{B4DB2928-3EFF-4507-ABD0-3894F091460A}" dt="2020-05-07T09:44:44.249" v="10806" actId="478"/>
          <ac:spMkLst>
            <pc:docMk/>
            <pc:sldMk cId="2863535548" sldId="354"/>
            <ac:spMk id="272" creationId="{ABD0267A-3799-4DAE-AD4A-E9112898A583}"/>
          </ac:spMkLst>
        </pc:spChg>
        <pc:spChg chg="add mod">
          <ac:chgData name="vijay kumar" userId="0eb738f014aa4543" providerId="LiveId" clId="{B4DB2928-3EFF-4507-ABD0-3894F091460A}" dt="2020-05-07T09:52:51.476" v="11176" actId="571"/>
          <ac:spMkLst>
            <pc:docMk/>
            <pc:sldMk cId="2863535548" sldId="354"/>
            <ac:spMk id="281" creationId="{BE8E171F-A377-46CE-A290-DE9EBBDE3A01}"/>
          </ac:spMkLst>
        </pc:spChg>
        <pc:spChg chg="add mod">
          <ac:chgData name="vijay kumar" userId="0eb738f014aa4543" providerId="LiveId" clId="{B4DB2928-3EFF-4507-ABD0-3894F091460A}" dt="2020-05-07T09:52:51.476" v="11176" actId="571"/>
          <ac:spMkLst>
            <pc:docMk/>
            <pc:sldMk cId="2863535548" sldId="354"/>
            <ac:spMk id="282" creationId="{3BD44FE3-30D9-4ECB-BF48-E46AAA6F249A}"/>
          </ac:spMkLst>
        </pc:spChg>
        <pc:spChg chg="del mod topLvl">
          <ac:chgData name="vijay kumar" userId="0eb738f014aa4543" providerId="LiveId" clId="{B4DB2928-3EFF-4507-ABD0-3894F091460A}" dt="2020-05-07T10:00:14.819" v="11349" actId="478"/>
          <ac:spMkLst>
            <pc:docMk/>
            <pc:sldMk cId="2863535548" sldId="354"/>
            <ac:spMk id="302" creationId="{96F682CF-FED8-415F-9887-33C934255924}"/>
          </ac:spMkLst>
        </pc:spChg>
        <pc:spChg chg="mod topLvl">
          <ac:chgData name="vijay kumar" userId="0eb738f014aa4543" providerId="LiveId" clId="{B4DB2928-3EFF-4507-ABD0-3894F091460A}" dt="2020-05-07T11:07:59.161" v="12726" actId="1076"/>
          <ac:spMkLst>
            <pc:docMk/>
            <pc:sldMk cId="2863535548" sldId="354"/>
            <ac:spMk id="303" creationId="{11AF54DC-F598-4288-9419-0A7454B21D98}"/>
          </ac:spMkLst>
        </pc:spChg>
        <pc:spChg chg="mod topLvl">
          <ac:chgData name="vijay kumar" userId="0eb738f014aa4543" providerId="LiveId" clId="{B4DB2928-3EFF-4507-ABD0-3894F091460A}" dt="2020-05-07T11:07:59.161" v="12726" actId="1076"/>
          <ac:spMkLst>
            <pc:docMk/>
            <pc:sldMk cId="2863535548" sldId="354"/>
            <ac:spMk id="304" creationId="{02B5066A-5077-4DC1-A59B-E6733214B7A2}"/>
          </ac:spMkLst>
        </pc:spChg>
        <pc:spChg chg="mod topLvl">
          <ac:chgData name="vijay kumar" userId="0eb738f014aa4543" providerId="LiveId" clId="{B4DB2928-3EFF-4507-ABD0-3894F091460A}" dt="2020-05-07T11:07:59.161" v="12726" actId="1076"/>
          <ac:spMkLst>
            <pc:docMk/>
            <pc:sldMk cId="2863535548" sldId="354"/>
            <ac:spMk id="305" creationId="{751600EB-1272-48F8-938A-2DECB24AFDBA}"/>
          </ac:spMkLst>
        </pc:spChg>
        <pc:spChg chg="mod topLvl">
          <ac:chgData name="vijay kumar" userId="0eb738f014aa4543" providerId="LiveId" clId="{B4DB2928-3EFF-4507-ABD0-3894F091460A}" dt="2020-05-07T11:07:59.161" v="12726" actId="1076"/>
          <ac:spMkLst>
            <pc:docMk/>
            <pc:sldMk cId="2863535548" sldId="354"/>
            <ac:spMk id="306" creationId="{2403E2F3-65F7-466C-87F1-D9CBAA0B5DAD}"/>
          </ac:spMkLst>
        </pc:spChg>
        <pc:spChg chg="mod topLvl">
          <ac:chgData name="vijay kumar" userId="0eb738f014aa4543" providerId="LiveId" clId="{B4DB2928-3EFF-4507-ABD0-3894F091460A}" dt="2020-05-07T11:07:59.161" v="12726" actId="1076"/>
          <ac:spMkLst>
            <pc:docMk/>
            <pc:sldMk cId="2863535548" sldId="354"/>
            <ac:spMk id="307" creationId="{D8DDB1A0-88AE-4B67-BAD0-A7BF2D23BF42}"/>
          </ac:spMkLst>
        </pc:spChg>
        <pc:spChg chg="mod topLvl">
          <ac:chgData name="vijay kumar" userId="0eb738f014aa4543" providerId="LiveId" clId="{B4DB2928-3EFF-4507-ABD0-3894F091460A}" dt="2020-05-07T11:07:59.161" v="12726" actId="1076"/>
          <ac:spMkLst>
            <pc:docMk/>
            <pc:sldMk cId="2863535548" sldId="354"/>
            <ac:spMk id="308" creationId="{51D70088-3069-4EF7-8E3D-355374C0B948}"/>
          </ac:spMkLst>
        </pc:spChg>
        <pc:spChg chg="mod topLvl">
          <ac:chgData name="vijay kumar" userId="0eb738f014aa4543" providerId="LiveId" clId="{B4DB2928-3EFF-4507-ABD0-3894F091460A}" dt="2020-05-07T11:07:59.161" v="12726" actId="1076"/>
          <ac:spMkLst>
            <pc:docMk/>
            <pc:sldMk cId="2863535548" sldId="354"/>
            <ac:spMk id="309" creationId="{38F276F2-B15D-4786-9F4B-7BED8F2CD0E4}"/>
          </ac:spMkLst>
        </pc:spChg>
        <pc:spChg chg="mod topLvl">
          <ac:chgData name="vijay kumar" userId="0eb738f014aa4543" providerId="LiveId" clId="{B4DB2928-3EFF-4507-ABD0-3894F091460A}" dt="2020-05-07T11:07:59.161" v="12726" actId="1076"/>
          <ac:spMkLst>
            <pc:docMk/>
            <pc:sldMk cId="2863535548" sldId="354"/>
            <ac:spMk id="310" creationId="{465BBB42-9771-45CB-B8B6-3BAE436AAE3B}"/>
          </ac:spMkLst>
        </pc:spChg>
        <pc:spChg chg="mod topLvl">
          <ac:chgData name="vijay kumar" userId="0eb738f014aa4543" providerId="LiveId" clId="{B4DB2928-3EFF-4507-ABD0-3894F091460A}" dt="2020-05-07T11:07:59.161" v="12726" actId="1076"/>
          <ac:spMkLst>
            <pc:docMk/>
            <pc:sldMk cId="2863535548" sldId="354"/>
            <ac:spMk id="311" creationId="{46E6B046-B102-4415-9C94-B8CE9BE3DED2}"/>
          </ac:spMkLst>
        </pc:spChg>
        <pc:spChg chg="mod topLvl">
          <ac:chgData name="vijay kumar" userId="0eb738f014aa4543" providerId="LiveId" clId="{B4DB2928-3EFF-4507-ABD0-3894F091460A}" dt="2020-05-07T11:07:59.161" v="12726" actId="1076"/>
          <ac:spMkLst>
            <pc:docMk/>
            <pc:sldMk cId="2863535548" sldId="354"/>
            <ac:spMk id="312" creationId="{AE48F6BF-5FA2-4B52-A9D1-D6DDC687B319}"/>
          </ac:spMkLst>
        </pc:spChg>
        <pc:spChg chg="mod topLvl">
          <ac:chgData name="vijay kumar" userId="0eb738f014aa4543" providerId="LiveId" clId="{B4DB2928-3EFF-4507-ABD0-3894F091460A}" dt="2020-05-07T11:07:59.161" v="12726" actId="1076"/>
          <ac:spMkLst>
            <pc:docMk/>
            <pc:sldMk cId="2863535548" sldId="354"/>
            <ac:spMk id="313" creationId="{6E50D59E-4B40-40AC-A580-67176C4E4B26}"/>
          </ac:spMkLst>
        </pc:spChg>
        <pc:spChg chg="mod topLvl">
          <ac:chgData name="vijay kumar" userId="0eb738f014aa4543" providerId="LiveId" clId="{B4DB2928-3EFF-4507-ABD0-3894F091460A}" dt="2020-05-07T11:07:59.161" v="12726" actId="1076"/>
          <ac:spMkLst>
            <pc:docMk/>
            <pc:sldMk cId="2863535548" sldId="354"/>
            <ac:spMk id="314" creationId="{85B57068-148E-46AC-BC29-7B1820A2C4F6}"/>
          </ac:spMkLst>
        </pc:spChg>
        <pc:spChg chg="mod topLvl">
          <ac:chgData name="vijay kumar" userId="0eb738f014aa4543" providerId="LiveId" clId="{B4DB2928-3EFF-4507-ABD0-3894F091460A}" dt="2020-05-07T11:07:59.161" v="12726" actId="1076"/>
          <ac:spMkLst>
            <pc:docMk/>
            <pc:sldMk cId="2863535548" sldId="354"/>
            <ac:spMk id="315" creationId="{8CA6B247-95A8-4E9E-8319-2E5926E47BAA}"/>
          </ac:spMkLst>
        </pc:spChg>
        <pc:spChg chg="mod topLvl">
          <ac:chgData name="vijay kumar" userId="0eb738f014aa4543" providerId="LiveId" clId="{B4DB2928-3EFF-4507-ABD0-3894F091460A}" dt="2020-05-07T11:07:59.161" v="12726" actId="1076"/>
          <ac:spMkLst>
            <pc:docMk/>
            <pc:sldMk cId="2863535548" sldId="354"/>
            <ac:spMk id="316" creationId="{4E5327BD-9A8E-4E48-9993-EB358349ECCC}"/>
          </ac:spMkLst>
        </pc:spChg>
        <pc:spChg chg="del mod topLvl">
          <ac:chgData name="vijay kumar" userId="0eb738f014aa4543" providerId="LiveId" clId="{B4DB2928-3EFF-4507-ABD0-3894F091460A}" dt="2020-05-07T10:00:14.819" v="11349" actId="478"/>
          <ac:spMkLst>
            <pc:docMk/>
            <pc:sldMk cId="2863535548" sldId="354"/>
            <ac:spMk id="317" creationId="{97A2B19F-CC72-4A23-B7AF-E33A40CB9C6A}"/>
          </ac:spMkLst>
        </pc:spChg>
        <pc:spChg chg="del mod topLvl">
          <ac:chgData name="vijay kumar" userId="0eb738f014aa4543" providerId="LiveId" clId="{B4DB2928-3EFF-4507-ABD0-3894F091460A}" dt="2020-05-07T10:00:14.819" v="11349" actId="478"/>
          <ac:spMkLst>
            <pc:docMk/>
            <pc:sldMk cId="2863535548" sldId="354"/>
            <ac:spMk id="318" creationId="{4F77C8EE-8031-43EF-8529-9027D6C127FF}"/>
          </ac:spMkLst>
        </pc:spChg>
        <pc:spChg chg="del mod topLvl">
          <ac:chgData name="vijay kumar" userId="0eb738f014aa4543" providerId="LiveId" clId="{B4DB2928-3EFF-4507-ABD0-3894F091460A}" dt="2020-05-07T10:00:18.303" v="11350" actId="478"/>
          <ac:spMkLst>
            <pc:docMk/>
            <pc:sldMk cId="2863535548" sldId="354"/>
            <ac:spMk id="319" creationId="{316DB51F-1367-4516-8490-9E5B3B941993}"/>
          </ac:spMkLst>
        </pc:spChg>
        <pc:spChg chg="del mod topLvl">
          <ac:chgData name="vijay kumar" userId="0eb738f014aa4543" providerId="LiveId" clId="{B4DB2928-3EFF-4507-ABD0-3894F091460A}" dt="2020-05-07T10:00:14.819" v="11349" actId="478"/>
          <ac:spMkLst>
            <pc:docMk/>
            <pc:sldMk cId="2863535548" sldId="354"/>
            <ac:spMk id="320" creationId="{3ABE8846-8BAD-43D2-9AF7-CC90C37E2873}"/>
          </ac:spMkLst>
        </pc:spChg>
        <pc:spChg chg="del mod topLvl">
          <ac:chgData name="vijay kumar" userId="0eb738f014aa4543" providerId="LiveId" clId="{B4DB2928-3EFF-4507-ABD0-3894F091460A}" dt="2020-05-07T10:00:14.819" v="11349" actId="478"/>
          <ac:spMkLst>
            <pc:docMk/>
            <pc:sldMk cId="2863535548" sldId="354"/>
            <ac:spMk id="321" creationId="{378A8775-6048-460B-B8B6-ECA60D71D5A8}"/>
          </ac:spMkLst>
        </pc:spChg>
        <pc:spChg chg="del mod topLvl">
          <ac:chgData name="vijay kumar" userId="0eb738f014aa4543" providerId="LiveId" clId="{B4DB2928-3EFF-4507-ABD0-3894F091460A}" dt="2020-05-07T10:00:14.819" v="11349" actId="478"/>
          <ac:spMkLst>
            <pc:docMk/>
            <pc:sldMk cId="2863535548" sldId="354"/>
            <ac:spMk id="322" creationId="{70335A53-2D55-45D5-8917-5EE4E7614B51}"/>
          </ac:spMkLst>
        </pc:spChg>
        <pc:spChg chg="del mod topLvl">
          <ac:chgData name="vijay kumar" userId="0eb738f014aa4543" providerId="LiveId" clId="{B4DB2928-3EFF-4507-ABD0-3894F091460A}" dt="2020-05-07T10:00:14.819" v="11349" actId="478"/>
          <ac:spMkLst>
            <pc:docMk/>
            <pc:sldMk cId="2863535548" sldId="354"/>
            <ac:spMk id="323" creationId="{4C7CF966-A65E-44DC-B85D-2B34F0B1EE8F}"/>
          </ac:spMkLst>
        </pc:spChg>
        <pc:spChg chg="del mod topLvl">
          <ac:chgData name="vijay kumar" userId="0eb738f014aa4543" providerId="LiveId" clId="{B4DB2928-3EFF-4507-ABD0-3894F091460A}" dt="2020-05-07T10:00:14.819" v="11349" actId="478"/>
          <ac:spMkLst>
            <pc:docMk/>
            <pc:sldMk cId="2863535548" sldId="354"/>
            <ac:spMk id="324" creationId="{61461820-D058-4471-A9F4-FB16417CF88A}"/>
          </ac:spMkLst>
        </pc:spChg>
        <pc:spChg chg="del mod topLvl">
          <ac:chgData name="vijay kumar" userId="0eb738f014aa4543" providerId="LiveId" clId="{B4DB2928-3EFF-4507-ABD0-3894F091460A}" dt="2020-05-07T10:00:14.819" v="11349" actId="478"/>
          <ac:spMkLst>
            <pc:docMk/>
            <pc:sldMk cId="2863535548" sldId="354"/>
            <ac:spMk id="325" creationId="{F297435D-5D2E-425E-9F40-C9F9D6512773}"/>
          </ac:spMkLst>
        </pc:spChg>
        <pc:spChg chg="del mod topLvl">
          <ac:chgData name="vijay kumar" userId="0eb738f014aa4543" providerId="LiveId" clId="{B4DB2928-3EFF-4507-ABD0-3894F091460A}" dt="2020-05-07T10:00:14.819" v="11349" actId="478"/>
          <ac:spMkLst>
            <pc:docMk/>
            <pc:sldMk cId="2863535548" sldId="354"/>
            <ac:spMk id="326" creationId="{04D6C514-AEE8-4A62-8DD7-D9AC3B9C516E}"/>
          </ac:spMkLst>
        </pc:spChg>
        <pc:spChg chg="del mod topLvl">
          <ac:chgData name="vijay kumar" userId="0eb738f014aa4543" providerId="LiveId" clId="{B4DB2928-3EFF-4507-ABD0-3894F091460A}" dt="2020-05-07T10:00:14.819" v="11349" actId="478"/>
          <ac:spMkLst>
            <pc:docMk/>
            <pc:sldMk cId="2863535548" sldId="354"/>
            <ac:spMk id="327" creationId="{49E2D581-8357-42E6-B4DE-3C51EEDE5E45}"/>
          </ac:spMkLst>
        </pc:spChg>
        <pc:spChg chg="del mod topLvl">
          <ac:chgData name="vijay kumar" userId="0eb738f014aa4543" providerId="LiveId" clId="{B4DB2928-3EFF-4507-ABD0-3894F091460A}" dt="2020-05-07T10:00:14.819" v="11349" actId="478"/>
          <ac:spMkLst>
            <pc:docMk/>
            <pc:sldMk cId="2863535548" sldId="354"/>
            <ac:spMk id="328" creationId="{B7493EC2-2454-48A3-AC48-528C46F7B8EE}"/>
          </ac:spMkLst>
        </pc:spChg>
        <pc:spChg chg="del mod topLvl">
          <ac:chgData name="vijay kumar" userId="0eb738f014aa4543" providerId="LiveId" clId="{B4DB2928-3EFF-4507-ABD0-3894F091460A}" dt="2020-05-07T10:00:14.819" v="11349" actId="478"/>
          <ac:spMkLst>
            <pc:docMk/>
            <pc:sldMk cId="2863535548" sldId="354"/>
            <ac:spMk id="329" creationId="{37E17307-FCE0-4309-96F9-CF41342B0331}"/>
          </ac:spMkLst>
        </pc:spChg>
        <pc:spChg chg="del mod topLvl">
          <ac:chgData name="vijay kumar" userId="0eb738f014aa4543" providerId="LiveId" clId="{B4DB2928-3EFF-4507-ABD0-3894F091460A}" dt="2020-05-07T10:00:14.819" v="11349" actId="478"/>
          <ac:spMkLst>
            <pc:docMk/>
            <pc:sldMk cId="2863535548" sldId="354"/>
            <ac:spMk id="330" creationId="{19EB5C43-B55F-4854-A32A-BC12169D86EB}"/>
          </ac:spMkLst>
        </pc:spChg>
        <pc:spChg chg="del mod topLvl">
          <ac:chgData name="vijay kumar" userId="0eb738f014aa4543" providerId="LiveId" clId="{B4DB2928-3EFF-4507-ABD0-3894F091460A}" dt="2020-05-07T10:00:14.819" v="11349" actId="478"/>
          <ac:spMkLst>
            <pc:docMk/>
            <pc:sldMk cId="2863535548" sldId="354"/>
            <ac:spMk id="331" creationId="{51F4E594-5119-4553-A98F-7350DFA209A5}"/>
          </ac:spMkLst>
        </pc:spChg>
        <pc:spChg chg="del mod topLvl">
          <ac:chgData name="vijay kumar" userId="0eb738f014aa4543" providerId="LiveId" clId="{B4DB2928-3EFF-4507-ABD0-3894F091460A}" dt="2020-05-07T10:00:14.819" v="11349" actId="478"/>
          <ac:spMkLst>
            <pc:docMk/>
            <pc:sldMk cId="2863535548" sldId="354"/>
            <ac:spMk id="332" creationId="{F603D5E8-6C6D-4886-A904-C98F14D3F5EF}"/>
          </ac:spMkLst>
        </pc:spChg>
        <pc:spChg chg="del mod topLvl">
          <ac:chgData name="vijay kumar" userId="0eb738f014aa4543" providerId="LiveId" clId="{B4DB2928-3EFF-4507-ABD0-3894F091460A}" dt="2020-05-07T10:00:14.819" v="11349" actId="478"/>
          <ac:spMkLst>
            <pc:docMk/>
            <pc:sldMk cId="2863535548" sldId="354"/>
            <ac:spMk id="333" creationId="{D4F6F3F2-E8FD-4E70-9F00-A4F76145F24D}"/>
          </ac:spMkLst>
        </pc:spChg>
        <pc:spChg chg="del mod topLvl">
          <ac:chgData name="vijay kumar" userId="0eb738f014aa4543" providerId="LiveId" clId="{B4DB2928-3EFF-4507-ABD0-3894F091460A}" dt="2020-05-07T10:00:14.819" v="11349" actId="478"/>
          <ac:spMkLst>
            <pc:docMk/>
            <pc:sldMk cId="2863535548" sldId="354"/>
            <ac:spMk id="334" creationId="{CF8A95E1-A636-4CE8-92C0-703E1FBDB489}"/>
          </ac:spMkLst>
        </pc:spChg>
        <pc:spChg chg="del mod topLvl">
          <ac:chgData name="vijay kumar" userId="0eb738f014aa4543" providerId="LiveId" clId="{B4DB2928-3EFF-4507-ABD0-3894F091460A}" dt="2020-05-07T10:00:14.819" v="11349" actId="478"/>
          <ac:spMkLst>
            <pc:docMk/>
            <pc:sldMk cId="2863535548" sldId="354"/>
            <ac:spMk id="335" creationId="{3E141CC6-4822-4521-B9FD-8AF428F04DCE}"/>
          </ac:spMkLst>
        </pc:spChg>
        <pc:spChg chg="del mod topLvl">
          <ac:chgData name="vijay kumar" userId="0eb738f014aa4543" providerId="LiveId" clId="{B4DB2928-3EFF-4507-ABD0-3894F091460A}" dt="2020-05-07T10:00:14.819" v="11349" actId="478"/>
          <ac:spMkLst>
            <pc:docMk/>
            <pc:sldMk cId="2863535548" sldId="354"/>
            <ac:spMk id="336" creationId="{35B17C40-C218-4FA5-B94F-E851DE892839}"/>
          </ac:spMkLst>
        </pc:spChg>
        <pc:spChg chg="del mod topLvl">
          <ac:chgData name="vijay kumar" userId="0eb738f014aa4543" providerId="LiveId" clId="{B4DB2928-3EFF-4507-ABD0-3894F091460A}" dt="2020-05-07T10:00:14.819" v="11349" actId="478"/>
          <ac:spMkLst>
            <pc:docMk/>
            <pc:sldMk cId="2863535548" sldId="354"/>
            <ac:spMk id="337" creationId="{2B86DCA2-C7F4-4F1C-8EF1-FDAB7D74E2E9}"/>
          </ac:spMkLst>
        </pc:spChg>
        <pc:spChg chg="del mod topLvl">
          <ac:chgData name="vijay kumar" userId="0eb738f014aa4543" providerId="LiveId" clId="{B4DB2928-3EFF-4507-ABD0-3894F091460A}" dt="2020-05-07T10:00:14.819" v="11349" actId="478"/>
          <ac:spMkLst>
            <pc:docMk/>
            <pc:sldMk cId="2863535548" sldId="354"/>
            <ac:spMk id="338" creationId="{B78C6C38-654B-4822-BDCB-C1C5DF7BA52B}"/>
          </ac:spMkLst>
        </pc:spChg>
        <pc:spChg chg="add mod topLvl">
          <ac:chgData name="vijay kumar" userId="0eb738f014aa4543" providerId="LiveId" clId="{B4DB2928-3EFF-4507-ABD0-3894F091460A}" dt="2020-05-07T11:07:59.161" v="12726" actId="1076"/>
          <ac:spMkLst>
            <pc:docMk/>
            <pc:sldMk cId="2863535548" sldId="354"/>
            <ac:spMk id="344" creationId="{8F0B2DCC-517F-485E-A8F5-4B03AD9078F7}"/>
          </ac:spMkLst>
        </pc:spChg>
        <pc:spChg chg="add mod topLvl">
          <ac:chgData name="vijay kumar" userId="0eb738f014aa4543" providerId="LiveId" clId="{B4DB2928-3EFF-4507-ABD0-3894F091460A}" dt="2020-05-07T11:07:59.161" v="12726" actId="1076"/>
          <ac:spMkLst>
            <pc:docMk/>
            <pc:sldMk cId="2863535548" sldId="354"/>
            <ac:spMk id="345" creationId="{B485BF07-F847-47C1-B6EF-CD7933146518}"/>
          </ac:spMkLst>
        </pc:spChg>
        <pc:spChg chg="add mod topLvl">
          <ac:chgData name="vijay kumar" userId="0eb738f014aa4543" providerId="LiveId" clId="{B4DB2928-3EFF-4507-ABD0-3894F091460A}" dt="2020-05-07T11:07:59.161" v="12726" actId="1076"/>
          <ac:spMkLst>
            <pc:docMk/>
            <pc:sldMk cId="2863535548" sldId="354"/>
            <ac:spMk id="346" creationId="{492370CB-CBEB-4538-91F5-A367157B223A}"/>
          </ac:spMkLst>
        </pc:spChg>
        <pc:spChg chg="add mod">
          <ac:chgData name="vijay kumar" userId="0eb738f014aa4543" providerId="LiveId" clId="{B4DB2928-3EFF-4507-ABD0-3894F091460A}" dt="2020-05-24T14:29:02.247" v="15179" actId="1076"/>
          <ac:spMkLst>
            <pc:docMk/>
            <pc:sldMk cId="2863535548" sldId="354"/>
            <ac:spMk id="350" creationId="{143B535A-B940-49FF-8B52-8D618FA8E9DA}"/>
          </ac:spMkLst>
        </pc:spChg>
        <pc:grpChg chg="mod">
          <ac:chgData name="vijay kumar" userId="0eb738f014aa4543" providerId="LiveId" clId="{B4DB2928-3EFF-4507-ABD0-3894F091460A}" dt="2020-05-07T09:59:44.797" v="11343" actId="338"/>
          <ac:grpSpMkLst>
            <pc:docMk/>
            <pc:sldMk cId="2863535548" sldId="354"/>
            <ac:grpSpMk id="1" creationId="{00000000-0000-0000-0000-000000000000}"/>
          </ac:grpSpMkLst>
        </pc:grpChg>
        <pc:grpChg chg="add del mod">
          <ac:chgData name="vijay kumar" userId="0eb738f014aa4543" providerId="LiveId" clId="{B4DB2928-3EFF-4507-ABD0-3894F091460A}" dt="2020-05-07T13:48:30.531" v="13040" actId="478"/>
          <ac:grpSpMkLst>
            <pc:docMk/>
            <pc:sldMk cId="2863535548" sldId="354"/>
            <ac:grpSpMk id="2" creationId="{27FB1A46-7BC0-4210-9E5B-9D1DC39CFB68}"/>
          </ac:grpSpMkLst>
        </pc:grpChg>
        <pc:grpChg chg="add del mod">
          <ac:chgData name="vijay kumar" userId="0eb738f014aa4543" providerId="LiveId" clId="{B4DB2928-3EFF-4507-ABD0-3894F091460A}" dt="2020-05-02T17:58:10.788" v="5095" actId="165"/>
          <ac:grpSpMkLst>
            <pc:docMk/>
            <pc:sldMk cId="2863535548" sldId="354"/>
            <ac:grpSpMk id="2" creationId="{6CD5066B-281D-4788-ACA8-479A239AE700}"/>
          </ac:grpSpMkLst>
        </pc:grpChg>
        <pc:grpChg chg="del mod">
          <ac:chgData name="vijay kumar" userId="0eb738f014aa4543" providerId="LiveId" clId="{B4DB2928-3EFF-4507-ABD0-3894F091460A}" dt="2020-05-02T21:03:27.672" v="6634" actId="165"/>
          <ac:grpSpMkLst>
            <pc:docMk/>
            <pc:sldMk cId="2863535548" sldId="354"/>
            <ac:grpSpMk id="9" creationId="{2660BFEB-4DEF-4048-8C08-793AC716F349}"/>
          </ac:grpSpMkLst>
        </pc:grpChg>
        <pc:grpChg chg="del mod topLvl">
          <ac:chgData name="vijay kumar" userId="0eb738f014aa4543" providerId="LiveId" clId="{B4DB2928-3EFF-4507-ABD0-3894F091460A}" dt="2020-05-02T17:59:55.908" v="5098" actId="165"/>
          <ac:grpSpMkLst>
            <pc:docMk/>
            <pc:sldMk cId="2863535548" sldId="354"/>
            <ac:grpSpMk id="9" creationId="{2FECB8F5-226B-4465-953D-C0FEDDE8E76C}"/>
          </ac:grpSpMkLst>
        </pc:grpChg>
        <pc:grpChg chg="del mod">
          <ac:chgData name="vijay kumar" userId="0eb738f014aa4543" providerId="LiveId" clId="{B4DB2928-3EFF-4507-ABD0-3894F091460A}" dt="2020-05-07T09:42:58.806" v="10779" actId="165"/>
          <ac:grpSpMkLst>
            <pc:docMk/>
            <pc:sldMk cId="2863535548" sldId="354"/>
            <ac:grpSpMk id="11" creationId="{C77061BF-3BFC-4095-A894-4A7950D076A3}"/>
          </ac:grpSpMkLst>
        </pc:grpChg>
        <pc:grpChg chg="add del mod topLvl">
          <ac:chgData name="vijay kumar" userId="0eb738f014aa4543" providerId="LiveId" clId="{B4DB2928-3EFF-4507-ABD0-3894F091460A}" dt="2020-05-02T21:09:16.808" v="6977" actId="165"/>
          <ac:grpSpMkLst>
            <pc:docMk/>
            <pc:sldMk cId="2863535548" sldId="354"/>
            <ac:grpSpMk id="22" creationId="{39BB0C43-E81E-41E7-9EFA-3F432C02A73B}"/>
          </ac:grpSpMkLst>
        </pc:grpChg>
        <pc:grpChg chg="del mod">
          <ac:chgData name="vijay kumar" userId="0eb738f014aa4543" providerId="LiveId" clId="{B4DB2928-3EFF-4507-ABD0-3894F091460A}" dt="2020-05-02T18:01:49.546" v="5154" actId="165"/>
          <ac:grpSpMkLst>
            <pc:docMk/>
            <pc:sldMk cId="2863535548" sldId="354"/>
            <ac:grpSpMk id="23" creationId="{0D5C3251-CC38-4D5E-BF48-138ECD6DE3CD}"/>
          </ac:grpSpMkLst>
        </pc:grpChg>
        <pc:grpChg chg="add mod">
          <ac:chgData name="vijay kumar" userId="0eb738f014aa4543" providerId="LiveId" clId="{B4DB2928-3EFF-4507-ABD0-3894F091460A}" dt="2020-05-02T18:09:00.507" v="5624" actId="164"/>
          <ac:grpSpMkLst>
            <pc:docMk/>
            <pc:sldMk cId="2863535548" sldId="354"/>
            <ac:grpSpMk id="74" creationId="{9AD60831-55E2-4B42-B012-C949E49AAD2A}"/>
          </ac:grpSpMkLst>
        </pc:grpChg>
        <pc:grpChg chg="add del mod topLvl">
          <ac:chgData name="vijay kumar" userId="0eb738f014aa4543" providerId="LiveId" clId="{B4DB2928-3EFF-4507-ABD0-3894F091460A}" dt="2020-05-07T10:06:32.851" v="11898" actId="165"/>
          <ac:grpSpMkLst>
            <pc:docMk/>
            <pc:sldMk cId="2863535548" sldId="354"/>
            <ac:grpSpMk id="75" creationId="{53A9F1C9-AAC7-4492-A347-1813315B3086}"/>
          </ac:grpSpMkLst>
        </pc:grpChg>
        <pc:grpChg chg="add del mod topLvl">
          <ac:chgData name="vijay kumar" userId="0eb738f014aa4543" providerId="LiveId" clId="{B4DB2928-3EFF-4507-ABD0-3894F091460A}" dt="2020-05-07T10:02:51.938" v="11608" actId="165"/>
          <ac:grpSpMkLst>
            <pc:docMk/>
            <pc:sldMk cId="2863535548" sldId="354"/>
            <ac:grpSpMk id="76" creationId="{F9B354E6-073A-4C8C-AF1C-37EE3CE4F1D3}"/>
          </ac:grpSpMkLst>
        </pc:grpChg>
        <pc:grpChg chg="del mod">
          <ac:chgData name="vijay kumar" userId="0eb738f014aa4543" providerId="LiveId" clId="{B4DB2928-3EFF-4507-ABD0-3894F091460A}" dt="2020-05-02T18:20:50.839" v="5885" actId="165"/>
          <ac:grpSpMkLst>
            <pc:docMk/>
            <pc:sldMk cId="2863535548" sldId="354"/>
            <ac:grpSpMk id="78" creationId="{882034F2-A4E3-4C26-BA89-47971EEC6B1B}"/>
          </ac:grpSpMkLst>
        </pc:grpChg>
        <pc:grpChg chg="add mod topLvl">
          <ac:chgData name="vijay kumar" userId="0eb738f014aa4543" providerId="LiveId" clId="{B4DB2928-3EFF-4507-ABD0-3894F091460A}" dt="2020-05-07T11:07:59.161" v="12726" actId="1076"/>
          <ac:grpSpMkLst>
            <pc:docMk/>
            <pc:sldMk cId="2863535548" sldId="354"/>
            <ac:grpSpMk id="155" creationId="{CC1A0E35-150B-44DB-9F27-9C01B35874FD}"/>
          </ac:grpSpMkLst>
        </pc:grpChg>
        <pc:grpChg chg="add del mod topLvl">
          <ac:chgData name="vijay kumar" userId="0eb738f014aa4543" providerId="LiveId" clId="{B4DB2928-3EFF-4507-ABD0-3894F091460A}" dt="2020-05-02T21:20:19.132" v="7073" actId="165"/>
          <ac:grpSpMkLst>
            <pc:docMk/>
            <pc:sldMk cId="2863535548" sldId="354"/>
            <ac:grpSpMk id="156" creationId="{09BE0666-8C90-443D-A7E6-821A391C2B48}"/>
          </ac:grpSpMkLst>
        </pc:grpChg>
        <pc:grpChg chg="add del mod">
          <ac:chgData name="vijay kumar" userId="0eb738f014aa4543" providerId="LiveId" clId="{B4DB2928-3EFF-4507-ABD0-3894F091460A}" dt="2020-05-02T21:11:37.773" v="7037" actId="165"/>
          <ac:grpSpMkLst>
            <pc:docMk/>
            <pc:sldMk cId="2863535548" sldId="354"/>
            <ac:grpSpMk id="157" creationId="{AFE71BCD-3421-44B9-BDF6-68738D98598D}"/>
          </ac:grpSpMkLst>
        </pc:grpChg>
        <pc:grpChg chg="del mod">
          <ac:chgData name="vijay kumar" userId="0eb738f014aa4543" providerId="LiveId" clId="{B4DB2928-3EFF-4507-ABD0-3894F091460A}" dt="2020-05-02T21:19:00.859" v="7040" actId="165"/>
          <ac:grpSpMkLst>
            <pc:docMk/>
            <pc:sldMk cId="2863535548" sldId="354"/>
            <ac:grpSpMk id="159" creationId="{991DBDB2-C650-4B24-83F2-90E136464EF1}"/>
          </ac:grpSpMkLst>
        </pc:grpChg>
        <pc:grpChg chg="add mod">
          <ac:chgData name="vijay kumar" userId="0eb738f014aa4543" providerId="LiveId" clId="{B4DB2928-3EFF-4507-ABD0-3894F091460A}" dt="2020-05-02T21:23:37.928" v="7356" actId="164"/>
          <ac:grpSpMkLst>
            <pc:docMk/>
            <pc:sldMk cId="2863535548" sldId="354"/>
            <ac:grpSpMk id="168" creationId="{D01E04C4-EF5C-4234-81B4-758BE21DD771}"/>
          </ac:grpSpMkLst>
        </pc:grpChg>
        <pc:grpChg chg="add mod topLvl">
          <ac:chgData name="vijay kumar" userId="0eb738f014aa4543" providerId="LiveId" clId="{B4DB2928-3EFF-4507-ABD0-3894F091460A}" dt="2020-05-07T11:07:59.161" v="12726" actId="1076"/>
          <ac:grpSpMkLst>
            <pc:docMk/>
            <pc:sldMk cId="2863535548" sldId="354"/>
            <ac:grpSpMk id="169" creationId="{1EBF326C-2996-4900-83B7-B619A418DFEB}"/>
          </ac:grpSpMkLst>
        </pc:grpChg>
        <pc:grpChg chg="add del mod">
          <ac:chgData name="vijay kumar" userId="0eb738f014aa4543" providerId="LiveId" clId="{B4DB2928-3EFF-4507-ABD0-3894F091460A}" dt="2020-05-02T21:23:45.699" v="7358" actId="21"/>
          <ac:grpSpMkLst>
            <pc:docMk/>
            <pc:sldMk cId="2863535548" sldId="354"/>
            <ac:grpSpMk id="170" creationId="{6A745691-2E31-43BC-86BB-FBC6D6E1DAB3}"/>
          </ac:grpSpMkLst>
        </pc:grpChg>
        <pc:grpChg chg="add mod">
          <ac:chgData name="vijay kumar" userId="0eb738f014aa4543" providerId="LiveId" clId="{B4DB2928-3EFF-4507-ABD0-3894F091460A}" dt="2020-05-07T09:59:44.797" v="11343" actId="338"/>
          <ac:grpSpMkLst>
            <pc:docMk/>
            <pc:sldMk cId="2863535548" sldId="354"/>
            <ac:grpSpMk id="171" creationId="{40323F3F-EEFA-4B9F-A120-1FD7A05D8CF5}"/>
          </ac:grpSpMkLst>
        </pc:grpChg>
        <pc:grpChg chg="mod">
          <ac:chgData name="vijay kumar" userId="0eb738f014aa4543" providerId="LiveId" clId="{B4DB2928-3EFF-4507-ABD0-3894F091460A}" dt="2020-05-07T09:59:44.797" v="11343" actId="338"/>
          <ac:grpSpMkLst>
            <pc:docMk/>
            <pc:sldMk cId="2863535548" sldId="354"/>
            <ac:grpSpMk id="172" creationId="{48D002F8-D734-49DC-96AC-0F144B3274C7}"/>
          </ac:grpSpMkLst>
        </pc:grpChg>
        <pc:grpChg chg="add del mod">
          <ac:chgData name="vijay kumar" userId="0eb738f014aa4543" providerId="LiveId" clId="{B4DB2928-3EFF-4507-ABD0-3894F091460A}" dt="2020-05-02T18:32:47.979" v="6368" actId="165"/>
          <ac:grpSpMkLst>
            <pc:docMk/>
            <pc:sldMk cId="2863535548" sldId="354"/>
            <ac:grpSpMk id="174" creationId="{CC549275-6A7A-497F-AFD3-6D8CB5AAB465}"/>
          </ac:grpSpMkLst>
        </pc:grpChg>
        <pc:grpChg chg="add del mod">
          <ac:chgData name="vijay kumar" userId="0eb738f014aa4543" providerId="LiveId" clId="{B4DB2928-3EFF-4507-ABD0-3894F091460A}" dt="2020-05-02T18:32:47.979" v="6368" actId="165"/>
          <ac:grpSpMkLst>
            <pc:docMk/>
            <pc:sldMk cId="2863535548" sldId="354"/>
            <ac:grpSpMk id="175" creationId="{998E4663-0080-41B5-9BA2-FB09A93DF6B0}"/>
          </ac:grpSpMkLst>
        </pc:grpChg>
        <pc:grpChg chg="add del mod">
          <ac:chgData name="vijay kumar" userId="0eb738f014aa4543" providerId="LiveId" clId="{B4DB2928-3EFF-4507-ABD0-3894F091460A}" dt="2020-05-02T18:32:47.979" v="6368" actId="165"/>
          <ac:grpSpMkLst>
            <pc:docMk/>
            <pc:sldMk cId="2863535548" sldId="354"/>
            <ac:grpSpMk id="176" creationId="{9B279704-7102-4852-B57D-5E02862A0F85}"/>
          </ac:grpSpMkLst>
        </pc:grpChg>
        <pc:grpChg chg="add del mod">
          <ac:chgData name="vijay kumar" userId="0eb738f014aa4543" providerId="LiveId" clId="{B4DB2928-3EFF-4507-ABD0-3894F091460A}" dt="2020-05-02T18:32:47.979" v="6368" actId="165"/>
          <ac:grpSpMkLst>
            <pc:docMk/>
            <pc:sldMk cId="2863535548" sldId="354"/>
            <ac:grpSpMk id="177" creationId="{B6B6E686-4828-4DB3-802E-4358903DA5B0}"/>
          </ac:grpSpMkLst>
        </pc:grpChg>
        <pc:grpChg chg="add del mod">
          <ac:chgData name="vijay kumar" userId="0eb738f014aa4543" providerId="LiveId" clId="{B4DB2928-3EFF-4507-ABD0-3894F091460A}" dt="2020-05-02T18:32:47.979" v="6368" actId="165"/>
          <ac:grpSpMkLst>
            <pc:docMk/>
            <pc:sldMk cId="2863535548" sldId="354"/>
            <ac:grpSpMk id="178" creationId="{8E28D7CE-4984-450D-8305-9CD7DB5CC0E6}"/>
          </ac:grpSpMkLst>
        </pc:grpChg>
        <pc:grpChg chg="add del mod">
          <ac:chgData name="vijay kumar" userId="0eb738f014aa4543" providerId="LiveId" clId="{B4DB2928-3EFF-4507-ABD0-3894F091460A}" dt="2020-05-02T18:32:47.979" v="6368" actId="165"/>
          <ac:grpSpMkLst>
            <pc:docMk/>
            <pc:sldMk cId="2863535548" sldId="354"/>
            <ac:grpSpMk id="179" creationId="{5F71C05C-A87D-4BFA-981B-4FE3BB1FC450}"/>
          </ac:grpSpMkLst>
        </pc:grpChg>
        <pc:grpChg chg="add del mod">
          <ac:chgData name="vijay kumar" userId="0eb738f014aa4543" providerId="LiveId" clId="{B4DB2928-3EFF-4507-ABD0-3894F091460A}" dt="2020-05-02T18:32:47.979" v="6368" actId="165"/>
          <ac:grpSpMkLst>
            <pc:docMk/>
            <pc:sldMk cId="2863535548" sldId="354"/>
            <ac:grpSpMk id="180" creationId="{09970805-05C5-4E4C-B16D-0F8850DC67FB}"/>
          </ac:grpSpMkLst>
        </pc:grpChg>
        <pc:grpChg chg="add del mod">
          <ac:chgData name="vijay kumar" userId="0eb738f014aa4543" providerId="LiveId" clId="{B4DB2928-3EFF-4507-ABD0-3894F091460A}" dt="2020-05-02T18:32:47.979" v="6368" actId="165"/>
          <ac:grpSpMkLst>
            <pc:docMk/>
            <pc:sldMk cId="2863535548" sldId="354"/>
            <ac:grpSpMk id="181" creationId="{BDC6944A-F660-40EF-8578-9898CBC98047}"/>
          </ac:grpSpMkLst>
        </pc:grpChg>
        <pc:grpChg chg="add del mod">
          <ac:chgData name="vijay kumar" userId="0eb738f014aa4543" providerId="LiveId" clId="{B4DB2928-3EFF-4507-ABD0-3894F091460A}" dt="2020-05-02T18:32:47.979" v="6368" actId="165"/>
          <ac:grpSpMkLst>
            <pc:docMk/>
            <pc:sldMk cId="2863535548" sldId="354"/>
            <ac:grpSpMk id="182" creationId="{C5A981B8-3DB1-42DD-98C3-55E76B5E3E98}"/>
          </ac:grpSpMkLst>
        </pc:grpChg>
        <pc:grpChg chg="add del mod">
          <ac:chgData name="vijay kumar" userId="0eb738f014aa4543" providerId="LiveId" clId="{B4DB2928-3EFF-4507-ABD0-3894F091460A}" dt="2020-05-02T18:32:47.979" v="6368" actId="165"/>
          <ac:grpSpMkLst>
            <pc:docMk/>
            <pc:sldMk cId="2863535548" sldId="354"/>
            <ac:grpSpMk id="183" creationId="{365F9AD6-3771-4BBA-B35A-7C6D090BC792}"/>
          </ac:grpSpMkLst>
        </pc:grpChg>
        <pc:grpChg chg="add del mod topLvl">
          <ac:chgData name="vijay kumar" userId="0eb738f014aa4543" providerId="LiveId" clId="{B4DB2928-3EFF-4507-ABD0-3894F091460A}" dt="2020-05-07T09:51:00.610" v="11173" actId="165"/>
          <ac:grpSpMkLst>
            <pc:docMk/>
            <pc:sldMk cId="2863535548" sldId="354"/>
            <ac:grpSpMk id="184" creationId="{21FD7BE4-EF6B-47D5-A3B6-CB8358F22FB5}"/>
          </ac:grpSpMkLst>
        </pc:grpChg>
        <pc:grpChg chg="add del mod topLvl">
          <ac:chgData name="vijay kumar" userId="0eb738f014aa4543" providerId="LiveId" clId="{B4DB2928-3EFF-4507-ABD0-3894F091460A}" dt="2020-05-07T09:52:35.063" v="11174" actId="165"/>
          <ac:grpSpMkLst>
            <pc:docMk/>
            <pc:sldMk cId="2863535548" sldId="354"/>
            <ac:grpSpMk id="185" creationId="{2F1B975B-8476-41D3-9ECB-FDFE4CC0E944}"/>
          </ac:grpSpMkLst>
        </pc:grpChg>
        <pc:grpChg chg="add del mod topLvl">
          <ac:chgData name="vijay kumar" userId="0eb738f014aa4543" providerId="LiveId" clId="{B4DB2928-3EFF-4507-ABD0-3894F091460A}" dt="2020-05-07T09:52:35.063" v="11174" actId="165"/>
          <ac:grpSpMkLst>
            <pc:docMk/>
            <pc:sldMk cId="2863535548" sldId="354"/>
            <ac:grpSpMk id="186" creationId="{37D4138C-67F2-4FF7-A2AF-985A3AFC0299}"/>
          </ac:grpSpMkLst>
        </pc:grpChg>
        <pc:grpChg chg="add del mod topLvl">
          <ac:chgData name="vijay kumar" userId="0eb738f014aa4543" providerId="LiveId" clId="{B4DB2928-3EFF-4507-ABD0-3894F091460A}" dt="2020-05-07T09:52:35.063" v="11174" actId="165"/>
          <ac:grpSpMkLst>
            <pc:docMk/>
            <pc:sldMk cId="2863535548" sldId="354"/>
            <ac:grpSpMk id="187" creationId="{9771C73A-5C36-4807-AF10-56E3E7AB229D}"/>
          </ac:grpSpMkLst>
        </pc:grpChg>
        <pc:grpChg chg="add del mod topLvl">
          <ac:chgData name="vijay kumar" userId="0eb738f014aa4543" providerId="LiveId" clId="{B4DB2928-3EFF-4507-ABD0-3894F091460A}" dt="2020-05-07T09:52:35.063" v="11174" actId="165"/>
          <ac:grpSpMkLst>
            <pc:docMk/>
            <pc:sldMk cId="2863535548" sldId="354"/>
            <ac:grpSpMk id="188" creationId="{890B6507-DAF1-4A88-AB1D-77588B3169A8}"/>
          </ac:grpSpMkLst>
        </pc:grpChg>
        <pc:grpChg chg="add del mod topLvl">
          <ac:chgData name="vijay kumar" userId="0eb738f014aa4543" providerId="LiveId" clId="{B4DB2928-3EFF-4507-ABD0-3894F091460A}" dt="2020-05-07T09:52:35.063" v="11174" actId="165"/>
          <ac:grpSpMkLst>
            <pc:docMk/>
            <pc:sldMk cId="2863535548" sldId="354"/>
            <ac:grpSpMk id="189" creationId="{E8E07735-E8DA-4DCB-92F7-045FD5FF02E5}"/>
          </ac:grpSpMkLst>
        </pc:grpChg>
        <pc:grpChg chg="add del mod topLvl">
          <ac:chgData name="vijay kumar" userId="0eb738f014aa4543" providerId="LiveId" clId="{B4DB2928-3EFF-4507-ABD0-3894F091460A}" dt="2020-05-07T09:52:35.063" v="11174" actId="165"/>
          <ac:grpSpMkLst>
            <pc:docMk/>
            <pc:sldMk cId="2863535548" sldId="354"/>
            <ac:grpSpMk id="190" creationId="{C0BB0611-D353-43B6-A269-EB15D7FF85D1}"/>
          </ac:grpSpMkLst>
        </pc:grpChg>
        <pc:grpChg chg="add del mod topLvl">
          <ac:chgData name="vijay kumar" userId="0eb738f014aa4543" providerId="LiveId" clId="{B4DB2928-3EFF-4507-ABD0-3894F091460A}" dt="2020-05-07T09:52:35.063" v="11174" actId="165"/>
          <ac:grpSpMkLst>
            <pc:docMk/>
            <pc:sldMk cId="2863535548" sldId="354"/>
            <ac:grpSpMk id="191" creationId="{1FED6FD7-FACC-486F-B4B4-841EFF69E96C}"/>
          </ac:grpSpMkLst>
        </pc:grpChg>
        <pc:grpChg chg="add del mod topLvl">
          <ac:chgData name="vijay kumar" userId="0eb738f014aa4543" providerId="LiveId" clId="{B4DB2928-3EFF-4507-ABD0-3894F091460A}" dt="2020-05-07T09:52:35.063" v="11174" actId="165"/>
          <ac:grpSpMkLst>
            <pc:docMk/>
            <pc:sldMk cId="2863535548" sldId="354"/>
            <ac:grpSpMk id="192" creationId="{BD5A762E-362B-4D2C-9302-F2751192B2F1}"/>
          </ac:grpSpMkLst>
        </pc:grpChg>
        <pc:grpChg chg="add del mod topLvl">
          <ac:chgData name="vijay kumar" userId="0eb738f014aa4543" providerId="LiveId" clId="{B4DB2928-3EFF-4507-ABD0-3894F091460A}" dt="2020-05-07T09:52:35.063" v="11174" actId="165"/>
          <ac:grpSpMkLst>
            <pc:docMk/>
            <pc:sldMk cId="2863535548" sldId="354"/>
            <ac:grpSpMk id="193" creationId="{6FFA00AC-2657-4B38-954D-91761A84DC2D}"/>
          </ac:grpSpMkLst>
        </pc:grpChg>
        <pc:grpChg chg="add del">
          <ac:chgData name="vijay kumar" userId="0eb738f014aa4543" providerId="LiveId" clId="{B4DB2928-3EFF-4507-ABD0-3894F091460A}" dt="2020-05-02T21:09:27.069" v="6979" actId="478"/>
          <ac:grpSpMkLst>
            <pc:docMk/>
            <pc:sldMk cId="2863535548" sldId="354"/>
            <ac:grpSpMk id="194" creationId="{94397ECC-D47E-4FB5-A032-487DC55795BF}"/>
          </ac:grpSpMkLst>
        </pc:grpChg>
        <pc:grpChg chg="add del mod topLvl">
          <ac:chgData name="vijay kumar" userId="0eb738f014aa4543" providerId="LiveId" clId="{B4DB2928-3EFF-4507-ABD0-3894F091460A}" dt="2020-05-02T18:37:26.655" v="6600" actId="165"/>
          <ac:grpSpMkLst>
            <pc:docMk/>
            <pc:sldMk cId="2863535548" sldId="354"/>
            <ac:grpSpMk id="194" creationId="{FF2F89C7-E653-4B05-AEB0-AFDD28969496}"/>
          </ac:grpSpMkLst>
        </pc:grpChg>
        <pc:grpChg chg="add del mod topLvl">
          <ac:chgData name="vijay kumar" userId="0eb738f014aa4543" providerId="LiveId" clId="{B4DB2928-3EFF-4507-ABD0-3894F091460A}" dt="2020-05-07T10:06:29.101" v="11897" actId="165"/>
          <ac:grpSpMkLst>
            <pc:docMk/>
            <pc:sldMk cId="2863535548" sldId="354"/>
            <ac:grpSpMk id="195" creationId="{4A6973B1-B919-452D-9ECD-B734307C2016}"/>
          </ac:grpSpMkLst>
        </pc:grpChg>
        <pc:grpChg chg="add del mod">
          <ac:chgData name="vijay kumar" userId="0eb738f014aa4543" providerId="LiveId" clId="{B4DB2928-3EFF-4507-ABD0-3894F091460A}" dt="2020-05-02T18:37:20.161" v="6599" actId="165"/>
          <ac:grpSpMkLst>
            <pc:docMk/>
            <pc:sldMk cId="2863535548" sldId="354"/>
            <ac:grpSpMk id="196" creationId="{D200FFF2-E424-4CD8-A553-F773BF4E3E85}"/>
          </ac:grpSpMkLst>
        </pc:grpChg>
        <pc:grpChg chg="add del mod topLvl">
          <ac:chgData name="vijay kumar" userId="0eb738f014aa4543" providerId="LiveId" clId="{B4DB2928-3EFF-4507-ABD0-3894F091460A}" dt="2020-05-07T09:50:55.594" v="11172" actId="165"/>
          <ac:grpSpMkLst>
            <pc:docMk/>
            <pc:sldMk cId="2863535548" sldId="354"/>
            <ac:grpSpMk id="198" creationId="{D0570A37-C9C2-4B5D-A52D-81E663C64D92}"/>
          </ac:grpSpMkLst>
        </pc:grpChg>
        <pc:grpChg chg="add del mod">
          <ac:chgData name="vijay kumar" userId="0eb738f014aa4543" providerId="LiveId" clId="{B4DB2928-3EFF-4507-ABD0-3894F091460A}" dt="2020-05-02T21:09:11.586" v="6976" actId="165"/>
          <ac:grpSpMkLst>
            <pc:docMk/>
            <pc:sldMk cId="2863535548" sldId="354"/>
            <ac:grpSpMk id="199" creationId="{340BBEEC-55A9-46B0-8304-E7A700F66E75}"/>
          </ac:grpSpMkLst>
        </pc:grpChg>
        <pc:grpChg chg="add del mod">
          <ac:chgData name="vijay kumar" userId="0eb738f014aa4543" providerId="LiveId" clId="{B4DB2928-3EFF-4507-ABD0-3894F091460A}" dt="2020-05-04T19:30:01.406" v="10636" actId="165"/>
          <ac:grpSpMkLst>
            <pc:docMk/>
            <pc:sldMk cId="2863535548" sldId="354"/>
            <ac:grpSpMk id="200" creationId="{58DA13DA-B52F-49EF-9F22-D72F430650D0}"/>
          </ac:grpSpMkLst>
        </pc:grpChg>
        <pc:grpChg chg="del mod topLvl">
          <ac:chgData name="vijay kumar" userId="0eb738f014aa4543" providerId="LiveId" clId="{B4DB2928-3EFF-4507-ABD0-3894F091460A}" dt="2020-05-04T19:30:04.235" v="10637" actId="478"/>
          <ac:grpSpMkLst>
            <pc:docMk/>
            <pc:sldMk cId="2863535548" sldId="354"/>
            <ac:grpSpMk id="207" creationId="{26F0F6A8-C906-436E-8B44-82105427A8B4}"/>
          </ac:grpSpMkLst>
        </pc:grpChg>
        <pc:grpChg chg="add del mod">
          <ac:chgData name="vijay kumar" userId="0eb738f014aa4543" providerId="LiveId" clId="{B4DB2928-3EFF-4507-ABD0-3894F091460A}" dt="2020-05-07T09:43:40.893" v="10784" actId="165"/>
          <ac:grpSpMkLst>
            <pc:docMk/>
            <pc:sldMk cId="2863535548" sldId="354"/>
            <ac:grpSpMk id="219" creationId="{E5B822B2-600E-4008-9C82-1C78D0A8FB61}"/>
          </ac:grpSpMkLst>
        </pc:grpChg>
        <pc:grpChg chg="add del mod">
          <ac:chgData name="vijay kumar" userId="0eb738f014aa4543" providerId="LiveId" clId="{B4DB2928-3EFF-4507-ABD0-3894F091460A}" dt="2020-05-08T11:50:48.269" v="14200" actId="478"/>
          <ac:grpSpMkLst>
            <pc:docMk/>
            <pc:sldMk cId="2863535548" sldId="354"/>
            <ac:grpSpMk id="273" creationId="{CDD92AB9-9DC7-4C93-80FC-FDADB4CAFECC}"/>
          </ac:grpSpMkLst>
        </pc:grpChg>
        <pc:grpChg chg="add del mod">
          <ac:chgData name="vijay kumar" userId="0eb738f014aa4543" providerId="LiveId" clId="{B4DB2928-3EFF-4507-ABD0-3894F091460A}" dt="2020-05-07T09:52:35.063" v="11174" actId="165"/>
          <ac:grpSpMkLst>
            <pc:docMk/>
            <pc:sldMk cId="2863535548" sldId="354"/>
            <ac:grpSpMk id="274" creationId="{09AFA309-D6EB-45C2-BC2B-7B11FC49BFFE}"/>
          </ac:grpSpMkLst>
        </pc:grpChg>
        <pc:grpChg chg="add del mod">
          <ac:chgData name="vijay kumar" userId="0eb738f014aa4543" providerId="LiveId" clId="{B4DB2928-3EFF-4507-ABD0-3894F091460A}" dt="2020-05-07T09:54:25.263" v="11282" actId="165"/>
          <ac:grpSpMkLst>
            <pc:docMk/>
            <pc:sldMk cId="2863535548" sldId="354"/>
            <ac:grpSpMk id="275" creationId="{69819AE4-583C-4EF6-99C6-F773D62C7DF9}"/>
          </ac:grpSpMkLst>
        </pc:grpChg>
        <pc:grpChg chg="add del mod">
          <ac:chgData name="vijay kumar" userId="0eb738f014aa4543" providerId="LiveId" clId="{B4DB2928-3EFF-4507-ABD0-3894F091460A}" dt="2020-05-07T09:54:25.263" v="11282" actId="165"/>
          <ac:grpSpMkLst>
            <pc:docMk/>
            <pc:sldMk cId="2863535548" sldId="354"/>
            <ac:grpSpMk id="276" creationId="{BA8D1C1D-6927-4077-819C-29195463920B}"/>
          </ac:grpSpMkLst>
        </pc:grpChg>
        <pc:grpChg chg="add del mod">
          <ac:chgData name="vijay kumar" userId="0eb738f014aa4543" providerId="LiveId" clId="{B4DB2928-3EFF-4507-ABD0-3894F091460A}" dt="2020-05-07T09:54:25.263" v="11282" actId="165"/>
          <ac:grpSpMkLst>
            <pc:docMk/>
            <pc:sldMk cId="2863535548" sldId="354"/>
            <ac:grpSpMk id="277" creationId="{7843AEDA-6691-4AAE-A340-69E377868CE4}"/>
          </ac:grpSpMkLst>
        </pc:grpChg>
        <pc:grpChg chg="add del mod">
          <ac:chgData name="vijay kumar" userId="0eb738f014aa4543" providerId="LiveId" clId="{B4DB2928-3EFF-4507-ABD0-3894F091460A}" dt="2020-05-07T09:54:25.263" v="11282" actId="165"/>
          <ac:grpSpMkLst>
            <pc:docMk/>
            <pc:sldMk cId="2863535548" sldId="354"/>
            <ac:grpSpMk id="278" creationId="{8D496ECC-7C8B-410D-AB7B-88D22B2650B7}"/>
          </ac:grpSpMkLst>
        </pc:grpChg>
        <pc:grpChg chg="add del mod">
          <ac:chgData name="vijay kumar" userId="0eb738f014aa4543" providerId="LiveId" clId="{B4DB2928-3EFF-4507-ABD0-3894F091460A}" dt="2020-05-07T09:54:25.263" v="11282" actId="165"/>
          <ac:grpSpMkLst>
            <pc:docMk/>
            <pc:sldMk cId="2863535548" sldId="354"/>
            <ac:grpSpMk id="279" creationId="{F5D0F89F-3DFE-42E9-A833-2D01C6AD5312}"/>
          </ac:grpSpMkLst>
        </pc:grpChg>
        <pc:grpChg chg="add del mod">
          <ac:chgData name="vijay kumar" userId="0eb738f014aa4543" providerId="LiveId" clId="{B4DB2928-3EFF-4507-ABD0-3894F091460A}" dt="2020-05-07T09:54:25.263" v="11282" actId="165"/>
          <ac:grpSpMkLst>
            <pc:docMk/>
            <pc:sldMk cId="2863535548" sldId="354"/>
            <ac:grpSpMk id="280" creationId="{3A8BA9CF-6C37-4FDA-8DCC-72061F744A7E}"/>
          </ac:grpSpMkLst>
        </pc:grpChg>
        <pc:grpChg chg="add del mod">
          <ac:chgData name="vijay kumar" userId="0eb738f014aa4543" providerId="LiveId" clId="{B4DB2928-3EFF-4507-ABD0-3894F091460A}" dt="2020-05-07T10:30:46.342" v="11952" actId="165"/>
          <ac:grpSpMkLst>
            <pc:docMk/>
            <pc:sldMk cId="2863535548" sldId="354"/>
            <ac:grpSpMk id="283" creationId="{E4277574-3CB4-4E82-B1EE-F383D86896AC}"/>
          </ac:grpSpMkLst>
        </pc:grpChg>
        <pc:grpChg chg="add del mod">
          <ac:chgData name="vijay kumar" userId="0eb738f014aa4543" providerId="LiveId" clId="{B4DB2928-3EFF-4507-ABD0-3894F091460A}" dt="2020-05-07T10:30:46.342" v="11952" actId="165"/>
          <ac:grpSpMkLst>
            <pc:docMk/>
            <pc:sldMk cId="2863535548" sldId="354"/>
            <ac:grpSpMk id="284" creationId="{7EE438FE-E47D-4B15-81BB-BDBC5C827EF6}"/>
          </ac:grpSpMkLst>
        </pc:grpChg>
        <pc:grpChg chg="add del mod">
          <ac:chgData name="vijay kumar" userId="0eb738f014aa4543" providerId="LiveId" clId="{B4DB2928-3EFF-4507-ABD0-3894F091460A}" dt="2020-05-07T10:30:46.342" v="11952" actId="165"/>
          <ac:grpSpMkLst>
            <pc:docMk/>
            <pc:sldMk cId="2863535548" sldId="354"/>
            <ac:grpSpMk id="285" creationId="{9B1ADB53-504A-498C-B9FF-99FE56B5AB2A}"/>
          </ac:grpSpMkLst>
        </pc:grpChg>
        <pc:grpChg chg="add del mod">
          <ac:chgData name="vijay kumar" userId="0eb738f014aa4543" providerId="LiveId" clId="{B4DB2928-3EFF-4507-ABD0-3894F091460A}" dt="2020-05-07T10:30:46.342" v="11952" actId="165"/>
          <ac:grpSpMkLst>
            <pc:docMk/>
            <pc:sldMk cId="2863535548" sldId="354"/>
            <ac:grpSpMk id="286" creationId="{04470245-73FC-4E33-ADFB-288B92B5B070}"/>
          </ac:grpSpMkLst>
        </pc:grpChg>
        <pc:grpChg chg="add del mod">
          <ac:chgData name="vijay kumar" userId="0eb738f014aa4543" providerId="LiveId" clId="{B4DB2928-3EFF-4507-ABD0-3894F091460A}" dt="2020-05-07T10:30:46.342" v="11952" actId="165"/>
          <ac:grpSpMkLst>
            <pc:docMk/>
            <pc:sldMk cId="2863535548" sldId="354"/>
            <ac:grpSpMk id="287" creationId="{6F670F1E-581E-433E-9CE9-7187612B8678}"/>
          </ac:grpSpMkLst>
        </pc:grpChg>
        <pc:grpChg chg="add del mod">
          <ac:chgData name="vijay kumar" userId="0eb738f014aa4543" providerId="LiveId" clId="{B4DB2928-3EFF-4507-ABD0-3894F091460A}" dt="2020-05-07T10:30:46.342" v="11952" actId="165"/>
          <ac:grpSpMkLst>
            <pc:docMk/>
            <pc:sldMk cId="2863535548" sldId="354"/>
            <ac:grpSpMk id="288" creationId="{D799B513-0754-40FA-A46B-7DDC4E497D9B}"/>
          </ac:grpSpMkLst>
        </pc:grpChg>
        <pc:grpChg chg="add del mod">
          <ac:chgData name="vijay kumar" userId="0eb738f014aa4543" providerId="LiveId" clId="{B4DB2928-3EFF-4507-ABD0-3894F091460A}" dt="2020-05-07T10:30:46.342" v="11952" actId="165"/>
          <ac:grpSpMkLst>
            <pc:docMk/>
            <pc:sldMk cId="2863535548" sldId="354"/>
            <ac:grpSpMk id="289" creationId="{85881088-1733-4DB1-98C7-076304CF981C}"/>
          </ac:grpSpMkLst>
        </pc:grpChg>
        <pc:grpChg chg="add mod topLvl">
          <ac:chgData name="vijay kumar" userId="0eb738f014aa4543" providerId="LiveId" clId="{B4DB2928-3EFF-4507-ABD0-3894F091460A}" dt="2020-05-07T11:07:59.161" v="12726" actId="1076"/>
          <ac:grpSpMkLst>
            <pc:docMk/>
            <pc:sldMk cId="2863535548" sldId="354"/>
            <ac:grpSpMk id="290" creationId="{63ACF65D-A7DC-45D4-9544-0BA347D6D2B8}"/>
          </ac:grpSpMkLst>
        </pc:grpChg>
        <pc:grpChg chg="add mod topLvl">
          <ac:chgData name="vijay kumar" userId="0eb738f014aa4543" providerId="LiveId" clId="{B4DB2928-3EFF-4507-ABD0-3894F091460A}" dt="2020-05-07T11:07:59.161" v="12726" actId="1076"/>
          <ac:grpSpMkLst>
            <pc:docMk/>
            <pc:sldMk cId="2863535548" sldId="354"/>
            <ac:grpSpMk id="291" creationId="{2E8A2F14-48B0-4228-941C-5E03330F66EF}"/>
          </ac:grpSpMkLst>
        </pc:grpChg>
        <pc:grpChg chg="add mod topLvl">
          <ac:chgData name="vijay kumar" userId="0eb738f014aa4543" providerId="LiveId" clId="{B4DB2928-3EFF-4507-ABD0-3894F091460A}" dt="2020-05-07T11:07:59.161" v="12726" actId="1076"/>
          <ac:grpSpMkLst>
            <pc:docMk/>
            <pc:sldMk cId="2863535548" sldId="354"/>
            <ac:grpSpMk id="292" creationId="{5AE4B1A7-0BEE-4567-B7F9-E3110C521700}"/>
          </ac:grpSpMkLst>
        </pc:grpChg>
        <pc:grpChg chg="add mod topLvl">
          <ac:chgData name="vijay kumar" userId="0eb738f014aa4543" providerId="LiveId" clId="{B4DB2928-3EFF-4507-ABD0-3894F091460A}" dt="2020-05-07T11:07:59.161" v="12726" actId="1076"/>
          <ac:grpSpMkLst>
            <pc:docMk/>
            <pc:sldMk cId="2863535548" sldId="354"/>
            <ac:grpSpMk id="293" creationId="{F07B7DE1-3FB3-4CB3-8114-10E133D69434}"/>
          </ac:grpSpMkLst>
        </pc:grpChg>
        <pc:grpChg chg="add mod topLvl">
          <ac:chgData name="vijay kumar" userId="0eb738f014aa4543" providerId="LiveId" clId="{B4DB2928-3EFF-4507-ABD0-3894F091460A}" dt="2020-05-07T11:07:59.161" v="12726" actId="1076"/>
          <ac:grpSpMkLst>
            <pc:docMk/>
            <pc:sldMk cId="2863535548" sldId="354"/>
            <ac:grpSpMk id="294" creationId="{B9741E57-3CB2-4C71-A3F4-F04E15DC8FB9}"/>
          </ac:grpSpMkLst>
        </pc:grpChg>
        <pc:grpChg chg="add mod topLvl">
          <ac:chgData name="vijay kumar" userId="0eb738f014aa4543" providerId="LiveId" clId="{B4DB2928-3EFF-4507-ABD0-3894F091460A}" dt="2020-05-07T11:07:59.161" v="12726" actId="1076"/>
          <ac:grpSpMkLst>
            <pc:docMk/>
            <pc:sldMk cId="2863535548" sldId="354"/>
            <ac:grpSpMk id="295" creationId="{A5E15E00-4E81-4F38-A39F-1A41D8A3F805}"/>
          </ac:grpSpMkLst>
        </pc:grpChg>
        <pc:grpChg chg="add mod topLvl">
          <ac:chgData name="vijay kumar" userId="0eb738f014aa4543" providerId="LiveId" clId="{B4DB2928-3EFF-4507-ABD0-3894F091460A}" dt="2020-05-07T11:07:59.161" v="12726" actId="1076"/>
          <ac:grpSpMkLst>
            <pc:docMk/>
            <pc:sldMk cId="2863535548" sldId="354"/>
            <ac:grpSpMk id="296" creationId="{414F40D4-8C1C-406F-8048-12B491877337}"/>
          </ac:grpSpMkLst>
        </pc:grpChg>
        <pc:grpChg chg="add mod topLvl">
          <ac:chgData name="vijay kumar" userId="0eb738f014aa4543" providerId="LiveId" clId="{B4DB2928-3EFF-4507-ABD0-3894F091460A}" dt="2020-05-07T11:07:59.161" v="12726" actId="1076"/>
          <ac:grpSpMkLst>
            <pc:docMk/>
            <pc:sldMk cId="2863535548" sldId="354"/>
            <ac:grpSpMk id="297" creationId="{8569BF38-3788-430A-B086-89763C13A37F}"/>
          </ac:grpSpMkLst>
        </pc:grpChg>
        <pc:grpChg chg="add mod topLvl">
          <ac:chgData name="vijay kumar" userId="0eb738f014aa4543" providerId="LiveId" clId="{B4DB2928-3EFF-4507-ABD0-3894F091460A}" dt="2020-05-07T11:07:59.161" v="12726" actId="1076"/>
          <ac:grpSpMkLst>
            <pc:docMk/>
            <pc:sldMk cId="2863535548" sldId="354"/>
            <ac:grpSpMk id="298" creationId="{5988C251-B87D-43E2-8B97-51B349059B05}"/>
          </ac:grpSpMkLst>
        </pc:grpChg>
        <pc:grpChg chg="add mod topLvl">
          <ac:chgData name="vijay kumar" userId="0eb738f014aa4543" providerId="LiveId" clId="{B4DB2928-3EFF-4507-ABD0-3894F091460A}" dt="2020-05-07T11:07:59.161" v="12726" actId="1076"/>
          <ac:grpSpMkLst>
            <pc:docMk/>
            <pc:sldMk cId="2863535548" sldId="354"/>
            <ac:grpSpMk id="299" creationId="{CB2F80FD-F7F8-4227-9FAB-00AB610071C9}"/>
          </ac:grpSpMkLst>
        </pc:grpChg>
        <pc:grpChg chg="del mod">
          <ac:chgData name="vijay kumar" userId="0eb738f014aa4543" providerId="LiveId" clId="{B4DB2928-3EFF-4507-ABD0-3894F091460A}" dt="2020-05-07T09:59:48.329" v="11344" actId="165"/>
          <ac:grpSpMkLst>
            <pc:docMk/>
            <pc:sldMk cId="2863535548" sldId="354"/>
            <ac:grpSpMk id="301" creationId="{2DF61494-EC1D-47A6-995C-ED533AC41E07}"/>
          </ac:grpSpMkLst>
        </pc:grpChg>
        <pc:grpChg chg="add del mod">
          <ac:chgData name="vijay kumar" userId="0eb738f014aa4543" providerId="LiveId" clId="{B4DB2928-3EFF-4507-ABD0-3894F091460A}" dt="2020-05-07T10:02:59.502" v="11609" actId="165"/>
          <ac:grpSpMkLst>
            <pc:docMk/>
            <pc:sldMk cId="2863535548" sldId="354"/>
            <ac:grpSpMk id="339" creationId="{E245CAE7-4227-4888-A695-9D40FB9F7AC2}"/>
          </ac:grpSpMkLst>
        </pc:grpChg>
        <pc:grpChg chg="add del mod">
          <ac:chgData name="vijay kumar" userId="0eb738f014aa4543" providerId="LiveId" clId="{B4DB2928-3EFF-4507-ABD0-3894F091460A}" dt="2020-05-07T10:03:33.695" v="11613" actId="165"/>
          <ac:grpSpMkLst>
            <pc:docMk/>
            <pc:sldMk cId="2863535548" sldId="354"/>
            <ac:grpSpMk id="340" creationId="{929A9F8D-8F6F-4846-A06D-D8FCCCED8977}"/>
          </ac:grpSpMkLst>
        </pc:grpChg>
        <pc:grpChg chg="add mod topLvl">
          <ac:chgData name="vijay kumar" userId="0eb738f014aa4543" providerId="LiveId" clId="{B4DB2928-3EFF-4507-ABD0-3894F091460A}" dt="2020-05-07T11:07:59.161" v="12726" actId="1076"/>
          <ac:grpSpMkLst>
            <pc:docMk/>
            <pc:sldMk cId="2863535548" sldId="354"/>
            <ac:grpSpMk id="341" creationId="{1B0242D6-D979-41B9-83C8-5ED753189872}"/>
          </ac:grpSpMkLst>
        </pc:grpChg>
        <pc:grpChg chg="add del mod">
          <ac:chgData name="vijay kumar" userId="0eb738f014aa4543" providerId="LiveId" clId="{B4DB2928-3EFF-4507-ABD0-3894F091460A}" dt="2020-05-07T10:06:15.240" v="11896" actId="165"/>
          <ac:grpSpMkLst>
            <pc:docMk/>
            <pc:sldMk cId="2863535548" sldId="354"/>
            <ac:grpSpMk id="342" creationId="{4C4ED1DE-6EA8-46E8-8194-829E51393364}"/>
          </ac:grpSpMkLst>
        </pc:grpChg>
        <pc:grpChg chg="add mod topLvl">
          <ac:chgData name="vijay kumar" userId="0eb738f014aa4543" providerId="LiveId" clId="{B4DB2928-3EFF-4507-ABD0-3894F091460A}" dt="2020-05-07T11:07:59.161" v="12726" actId="1076"/>
          <ac:grpSpMkLst>
            <pc:docMk/>
            <pc:sldMk cId="2863535548" sldId="354"/>
            <ac:grpSpMk id="343" creationId="{9C9B559B-0701-478D-AB45-0BE6513BBE67}"/>
          </ac:grpSpMkLst>
        </pc:grpChg>
        <pc:grpChg chg="add del mod topLvl">
          <ac:chgData name="vijay kumar" userId="0eb738f014aa4543" providerId="LiveId" clId="{B4DB2928-3EFF-4507-ABD0-3894F091460A}" dt="2020-05-07T10:43:13.639" v="11985" actId="165"/>
          <ac:grpSpMkLst>
            <pc:docMk/>
            <pc:sldMk cId="2863535548" sldId="354"/>
            <ac:grpSpMk id="347" creationId="{212BFCF4-A00C-4594-BB40-73449EA2CBF9}"/>
          </ac:grpSpMkLst>
        </pc:grpChg>
        <pc:grpChg chg="add del mod">
          <ac:chgData name="vijay kumar" userId="0eb738f014aa4543" providerId="LiveId" clId="{B4DB2928-3EFF-4507-ABD0-3894F091460A}" dt="2020-05-07T10:40:27.064" v="11964" actId="165"/>
          <ac:grpSpMkLst>
            <pc:docMk/>
            <pc:sldMk cId="2863535548" sldId="354"/>
            <ac:grpSpMk id="348" creationId="{08CEB317-48D7-46B0-B620-858BCA518FCD}"/>
          </ac:grpSpMkLst>
        </pc:grpChg>
        <pc:grpChg chg="add del mod">
          <ac:chgData name="vijay kumar" userId="0eb738f014aa4543" providerId="LiveId" clId="{B4DB2928-3EFF-4507-ABD0-3894F091460A}" dt="2020-05-07T10:43:06.843" v="11984" actId="165"/>
          <ac:grpSpMkLst>
            <pc:docMk/>
            <pc:sldMk cId="2863535548" sldId="354"/>
            <ac:grpSpMk id="349" creationId="{849F8723-4531-4788-80A4-BEC4DA76CE59}"/>
          </ac:grpSpMkLst>
        </pc:grpChg>
        <pc:grpChg chg="add mod">
          <ac:chgData name="vijay kumar" userId="0eb738f014aa4543" providerId="LiveId" clId="{B4DB2928-3EFF-4507-ABD0-3894F091460A}" dt="2020-05-07T11:07:59.161" v="12726" actId="1076"/>
          <ac:grpSpMkLst>
            <pc:docMk/>
            <pc:sldMk cId="2863535548" sldId="354"/>
            <ac:grpSpMk id="351" creationId="{80EE3C93-28AA-4B59-9D73-B00DACC7D960}"/>
          </ac:grpSpMkLst>
        </pc:grpChg>
        <pc:grpChg chg="add mod">
          <ac:chgData name="vijay kumar" userId="0eb738f014aa4543" providerId="LiveId" clId="{B4DB2928-3EFF-4507-ABD0-3894F091460A}" dt="2020-05-07T11:07:59.161" v="12726" actId="1076"/>
          <ac:grpSpMkLst>
            <pc:docMk/>
            <pc:sldMk cId="2863535548" sldId="354"/>
            <ac:grpSpMk id="352" creationId="{22A838DB-3A77-47D6-97DE-B002C753C71B}"/>
          </ac:grpSpMkLst>
        </pc:grpChg>
        <pc:grpChg chg="add mod">
          <ac:chgData name="vijay kumar" userId="0eb738f014aa4543" providerId="LiveId" clId="{B4DB2928-3EFF-4507-ABD0-3894F091460A}" dt="2020-05-07T11:07:59.161" v="12726" actId="1076"/>
          <ac:grpSpMkLst>
            <pc:docMk/>
            <pc:sldMk cId="2863535548" sldId="354"/>
            <ac:grpSpMk id="353" creationId="{B96B1AD0-4913-4C91-8232-46D18FD2B8B5}"/>
          </ac:grpSpMkLst>
        </pc:grpChg>
        <pc:grpChg chg="add mod">
          <ac:chgData name="vijay kumar" userId="0eb738f014aa4543" providerId="LiveId" clId="{B4DB2928-3EFF-4507-ABD0-3894F091460A}" dt="2020-05-07T11:07:59.161" v="12726" actId="1076"/>
          <ac:grpSpMkLst>
            <pc:docMk/>
            <pc:sldMk cId="2863535548" sldId="354"/>
            <ac:grpSpMk id="354" creationId="{143C6C7C-AADB-46C9-8050-16C843A15859}"/>
          </ac:grpSpMkLst>
        </pc:grpChg>
        <pc:grpChg chg="add mod">
          <ac:chgData name="vijay kumar" userId="0eb738f014aa4543" providerId="LiveId" clId="{B4DB2928-3EFF-4507-ABD0-3894F091460A}" dt="2020-05-07T11:07:59.161" v="12726" actId="1076"/>
          <ac:grpSpMkLst>
            <pc:docMk/>
            <pc:sldMk cId="2863535548" sldId="354"/>
            <ac:grpSpMk id="355" creationId="{8E60AB69-1971-493C-B8E4-512F28D8D4F5}"/>
          </ac:grpSpMkLst>
        </pc:grpChg>
        <pc:grpChg chg="add mod">
          <ac:chgData name="vijay kumar" userId="0eb738f014aa4543" providerId="LiveId" clId="{B4DB2928-3EFF-4507-ABD0-3894F091460A}" dt="2020-05-07T11:07:59.161" v="12726" actId="1076"/>
          <ac:grpSpMkLst>
            <pc:docMk/>
            <pc:sldMk cId="2863535548" sldId="354"/>
            <ac:grpSpMk id="356" creationId="{5EBF5DFF-500D-4EEA-9BFD-DAF4A2935E81}"/>
          </ac:grpSpMkLst>
        </pc:grpChg>
        <pc:grpChg chg="add mod">
          <ac:chgData name="vijay kumar" userId="0eb738f014aa4543" providerId="LiveId" clId="{B4DB2928-3EFF-4507-ABD0-3894F091460A}" dt="2020-05-07T11:07:59.161" v="12726" actId="1076"/>
          <ac:grpSpMkLst>
            <pc:docMk/>
            <pc:sldMk cId="2863535548" sldId="354"/>
            <ac:grpSpMk id="357" creationId="{0C7E8DCF-2EE0-42EE-BFF0-2B75E154BBD9}"/>
          </ac:grpSpMkLst>
        </pc:grpChg>
        <pc:grpChg chg="add del mod">
          <ac:chgData name="vijay kumar" userId="0eb738f014aa4543" providerId="LiveId" clId="{B4DB2928-3EFF-4507-ABD0-3894F091460A}" dt="2020-05-07T10:51:52.891" v="12467" actId="165"/>
          <ac:grpSpMkLst>
            <pc:docMk/>
            <pc:sldMk cId="2863535548" sldId="354"/>
            <ac:grpSpMk id="358" creationId="{964C5CA8-A2DB-4B6A-9B50-0905AA22F8CB}"/>
          </ac:grpSpMkLst>
        </pc:grpChg>
        <pc:grpChg chg="add mod">
          <ac:chgData name="vijay kumar" userId="0eb738f014aa4543" providerId="LiveId" clId="{B4DB2928-3EFF-4507-ABD0-3894F091460A}" dt="2020-05-07T11:07:59.161" v="12726" actId="1076"/>
          <ac:grpSpMkLst>
            <pc:docMk/>
            <pc:sldMk cId="2863535548" sldId="354"/>
            <ac:grpSpMk id="359" creationId="{272C2C14-7D9A-4DC6-A554-B4041D3E7151}"/>
          </ac:grpSpMkLst>
        </pc:grpChg>
        <pc:grpChg chg="add mod">
          <ac:chgData name="vijay kumar" userId="0eb738f014aa4543" providerId="LiveId" clId="{B4DB2928-3EFF-4507-ABD0-3894F091460A}" dt="2020-05-07T11:07:59.161" v="12726" actId="1076"/>
          <ac:grpSpMkLst>
            <pc:docMk/>
            <pc:sldMk cId="2863535548" sldId="354"/>
            <ac:grpSpMk id="360" creationId="{9DB0FDBB-4700-429F-9943-BCBE70DE2EB4}"/>
          </ac:grpSpMkLst>
        </pc:grpChg>
        <pc:grpChg chg="add mod">
          <ac:chgData name="vijay kumar" userId="0eb738f014aa4543" providerId="LiveId" clId="{B4DB2928-3EFF-4507-ABD0-3894F091460A}" dt="2020-05-07T11:07:59.161" v="12726" actId="1076"/>
          <ac:grpSpMkLst>
            <pc:docMk/>
            <pc:sldMk cId="2863535548" sldId="354"/>
            <ac:grpSpMk id="361" creationId="{E8534E62-05EE-4085-AB8C-722D0ED81529}"/>
          </ac:grpSpMkLst>
        </pc:grpChg>
        <pc:picChg chg="del mod">
          <ac:chgData name="vijay kumar" userId="0eb738f014aa4543" providerId="LiveId" clId="{B4DB2928-3EFF-4507-ABD0-3894F091460A}" dt="2020-05-02T21:03:24.283" v="6633" actId="338"/>
          <ac:picMkLst>
            <pc:docMk/>
            <pc:sldMk cId="2863535548" sldId="354"/>
            <ac:picMk id="2" creationId="{39B7FACC-2AF3-4F24-8E2A-054209075495}"/>
          </ac:picMkLst>
        </pc:picChg>
        <pc:picChg chg="del mod">
          <ac:chgData name="vijay kumar" userId="0eb738f014aa4543" providerId="LiveId" clId="{B4DB2928-3EFF-4507-ABD0-3894F091460A}" dt="2020-05-07T09:42:52.523" v="10778" actId="338"/>
          <ac:picMkLst>
            <pc:docMk/>
            <pc:sldMk cId="2863535548" sldId="354"/>
            <ac:picMk id="9" creationId="{8501C141-8F48-48BE-8E9C-0AF9F4453D58}"/>
          </ac:picMkLst>
        </pc:picChg>
        <pc:picChg chg="add del mod">
          <ac:chgData name="vijay kumar" userId="0eb738f014aa4543" providerId="LiveId" clId="{B4DB2928-3EFF-4507-ABD0-3894F091460A}" dt="2020-05-02T18:01:46.090" v="5153" actId="338"/>
          <ac:picMkLst>
            <pc:docMk/>
            <pc:sldMk cId="2863535548" sldId="354"/>
            <ac:picMk id="21" creationId="{F079FA3C-899F-4B59-80AE-695DB478A6CB}"/>
          </ac:picMkLst>
        </pc:picChg>
        <pc:picChg chg="del mod">
          <ac:chgData name="vijay kumar" userId="0eb738f014aa4543" providerId="LiveId" clId="{B4DB2928-3EFF-4507-ABD0-3894F091460A}" dt="2020-05-02T18:20:45.930" v="5884" actId="338"/>
          <ac:picMkLst>
            <pc:docMk/>
            <pc:sldMk cId="2863535548" sldId="354"/>
            <ac:picMk id="77" creationId="{1AC714C4-4607-46BF-8663-4116D9BC971C}"/>
          </ac:picMkLst>
        </pc:picChg>
        <pc:picChg chg="del mod">
          <ac:chgData name="vijay kumar" userId="0eb738f014aa4543" providerId="LiveId" clId="{B4DB2928-3EFF-4507-ABD0-3894F091460A}" dt="2020-05-02T21:18:52.159" v="7039" actId="338"/>
          <ac:picMkLst>
            <pc:docMk/>
            <pc:sldMk cId="2863535548" sldId="354"/>
            <ac:picMk id="158" creationId="{9BF54710-261C-4D23-B14F-F2ADBB4B2785}"/>
          </ac:picMkLst>
        </pc:picChg>
        <pc:picChg chg="del mod">
          <ac:chgData name="vijay kumar" userId="0eb738f014aa4543" providerId="LiveId" clId="{B4DB2928-3EFF-4507-ABD0-3894F091460A}" dt="2020-05-07T09:59:44.797" v="11343" actId="338"/>
          <ac:picMkLst>
            <pc:docMk/>
            <pc:sldMk cId="2863535548" sldId="354"/>
            <ac:picMk id="300" creationId="{FC14911A-BD6C-439B-98FA-FF3F6358FD9E}"/>
          </ac:picMkLst>
        </pc:picChg>
      </pc:sldChg>
      <pc:sldChg chg="addSp delSp modSp add del mod">
        <pc:chgData name="vijay kumar" userId="0eb738f014aa4543" providerId="LiveId" clId="{B4DB2928-3EFF-4507-ABD0-3894F091460A}" dt="2020-05-24T14:17:40.633" v="14964" actId="47"/>
        <pc:sldMkLst>
          <pc:docMk/>
          <pc:sldMk cId="3432391947" sldId="355"/>
        </pc:sldMkLst>
        <pc:spChg chg="mod">
          <ac:chgData name="vijay kumar" userId="0eb738f014aa4543" providerId="LiveId" clId="{B4DB2928-3EFF-4507-ABD0-3894F091460A}" dt="2020-05-07T13:45:44.412" v="13013" actId="1076"/>
          <ac:spMkLst>
            <pc:docMk/>
            <pc:sldMk cId="3432391947" sldId="355"/>
            <ac:spMk id="2" creationId="{1BB80A21-2C38-41C7-ABEF-FC6C99C64F51}"/>
          </ac:spMkLst>
        </pc:spChg>
        <pc:spChg chg="mod">
          <ac:chgData name="vijay kumar" userId="0eb738f014aa4543" providerId="LiveId" clId="{B4DB2928-3EFF-4507-ABD0-3894F091460A}" dt="2020-05-07T13:52:32.622" v="13051" actId="20577"/>
          <ac:spMkLst>
            <pc:docMk/>
            <pc:sldMk cId="3432391947" sldId="355"/>
            <ac:spMk id="3" creationId="{94FF9A33-1407-44DC-B989-98EA07D3A0B2}"/>
          </ac:spMkLst>
        </pc:spChg>
        <pc:spChg chg="add del mod">
          <ac:chgData name="vijay kumar" userId="0eb738f014aa4543" providerId="LiveId" clId="{B4DB2928-3EFF-4507-ABD0-3894F091460A}" dt="2020-05-04T11:36:10.813" v="7426"/>
          <ac:spMkLst>
            <pc:docMk/>
            <pc:sldMk cId="3432391947" sldId="355"/>
            <ac:spMk id="4" creationId="{D74681ED-CB97-4BB7-9743-94356166E7A2}"/>
          </ac:spMkLst>
        </pc:spChg>
      </pc:sldChg>
      <pc:sldChg chg="addSp delSp modSp new mod">
        <pc:chgData name="vijay kumar" userId="0eb738f014aa4543" providerId="LiveId" clId="{B4DB2928-3EFF-4507-ABD0-3894F091460A}" dt="2020-05-24T14:29:38.140" v="15186" actId="1076"/>
        <pc:sldMkLst>
          <pc:docMk/>
          <pc:sldMk cId="3700445330" sldId="356"/>
        </pc:sldMkLst>
        <pc:spChg chg="add del mod">
          <ac:chgData name="vijay kumar" userId="0eb738f014aa4543" providerId="LiveId" clId="{B4DB2928-3EFF-4507-ABD0-3894F091460A}" dt="2020-05-24T14:26:16.379" v="15154" actId="478"/>
          <ac:spMkLst>
            <pc:docMk/>
            <pc:sldMk cId="3700445330" sldId="356"/>
            <ac:spMk id="2" creationId="{C46CB521-3FB1-4E3E-9D10-9A9E5FDECFC9}"/>
          </ac:spMkLst>
        </pc:spChg>
        <pc:spChg chg="mod">
          <ac:chgData name="vijay kumar" userId="0eb738f014aa4543" providerId="LiveId" clId="{B4DB2928-3EFF-4507-ABD0-3894F091460A}" dt="2020-05-09T17:34:24.279" v="14566" actId="1076"/>
          <ac:spMkLst>
            <pc:docMk/>
            <pc:sldMk cId="3700445330" sldId="356"/>
            <ac:spMk id="4" creationId="{417F6BA1-5F78-4410-9D50-3E549EC34D26}"/>
          </ac:spMkLst>
        </pc:spChg>
        <pc:spChg chg="mod">
          <ac:chgData name="vijay kumar" userId="0eb738f014aa4543" providerId="LiveId" clId="{B4DB2928-3EFF-4507-ABD0-3894F091460A}" dt="2020-05-09T17:34:24.279" v="14566" actId="1076"/>
          <ac:spMkLst>
            <pc:docMk/>
            <pc:sldMk cId="3700445330" sldId="356"/>
            <ac:spMk id="5" creationId="{7D8863F6-B651-4D67-95C4-9FC39805E147}"/>
          </ac:spMkLst>
        </pc:spChg>
        <pc:spChg chg="mod">
          <ac:chgData name="vijay kumar" userId="0eb738f014aa4543" providerId="LiveId" clId="{B4DB2928-3EFF-4507-ABD0-3894F091460A}" dt="2020-05-09T17:34:24.279" v="14566" actId="1076"/>
          <ac:spMkLst>
            <pc:docMk/>
            <pc:sldMk cId="3700445330" sldId="356"/>
            <ac:spMk id="6" creationId="{0ECD6783-10DE-4293-B951-D53C0B58D3F9}"/>
          </ac:spMkLst>
        </pc:spChg>
        <pc:spChg chg="mod">
          <ac:chgData name="vijay kumar" userId="0eb738f014aa4543" providerId="LiveId" clId="{B4DB2928-3EFF-4507-ABD0-3894F091460A}" dt="2020-05-09T17:34:24.279" v="14566" actId="1076"/>
          <ac:spMkLst>
            <pc:docMk/>
            <pc:sldMk cId="3700445330" sldId="356"/>
            <ac:spMk id="7" creationId="{0571DFE8-A6AA-420B-9083-2A0560CB4282}"/>
          </ac:spMkLst>
        </pc:spChg>
        <pc:spChg chg="mod">
          <ac:chgData name="vijay kumar" userId="0eb738f014aa4543" providerId="LiveId" clId="{B4DB2928-3EFF-4507-ABD0-3894F091460A}" dt="2020-05-09T17:34:24.279" v="14566" actId="1076"/>
          <ac:spMkLst>
            <pc:docMk/>
            <pc:sldMk cId="3700445330" sldId="356"/>
            <ac:spMk id="8" creationId="{562D31B4-3703-4463-BF78-1C751670D6EF}"/>
          </ac:spMkLst>
        </pc:spChg>
        <pc:spChg chg="mod">
          <ac:chgData name="vijay kumar" userId="0eb738f014aa4543" providerId="LiveId" clId="{B4DB2928-3EFF-4507-ABD0-3894F091460A}" dt="2020-05-09T17:34:24.279" v="14566" actId="1076"/>
          <ac:spMkLst>
            <pc:docMk/>
            <pc:sldMk cId="3700445330" sldId="356"/>
            <ac:spMk id="9" creationId="{275DD676-6752-4365-BFF8-D7C342BD683E}"/>
          </ac:spMkLst>
        </pc:spChg>
        <pc:spChg chg="mod">
          <ac:chgData name="vijay kumar" userId="0eb738f014aa4543" providerId="LiveId" clId="{B4DB2928-3EFF-4507-ABD0-3894F091460A}" dt="2020-05-09T17:34:24.279" v="14566" actId="1076"/>
          <ac:spMkLst>
            <pc:docMk/>
            <pc:sldMk cId="3700445330" sldId="356"/>
            <ac:spMk id="10" creationId="{4AD4CB43-0557-4A8B-9783-6CFEE3D87359}"/>
          </ac:spMkLst>
        </pc:spChg>
        <pc:spChg chg="mod">
          <ac:chgData name="vijay kumar" userId="0eb738f014aa4543" providerId="LiveId" clId="{B4DB2928-3EFF-4507-ABD0-3894F091460A}" dt="2020-05-09T17:34:24.279" v="14566" actId="1076"/>
          <ac:spMkLst>
            <pc:docMk/>
            <pc:sldMk cId="3700445330" sldId="356"/>
            <ac:spMk id="11" creationId="{595B4E3A-900B-4D8C-9442-D21C80E1C684}"/>
          </ac:spMkLst>
        </pc:spChg>
        <pc:spChg chg="mod">
          <ac:chgData name="vijay kumar" userId="0eb738f014aa4543" providerId="LiveId" clId="{B4DB2928-3EFF-4507-ABD0-3894F091460A}" dt="2020-05-09T17:34:24.279" v="14566" actId="1076"/>
          <ac:spMkLst>
            <pc:docMk/>
            <pc:sldMk cId="3700445330" sldId="356"/>
            <ac:spMk id="12" creationId="{73970FE6-2D79-42FC-B897-8848177A639E}"/>
          </ac:spMkLst>
        </pc:spChg>
        <pc:spChg chg="mod">
          <ac:chgData name="vijay kumar" userId="0eb738f014aa4543" providerId="LiveId" clId="{B4DB2928-3EFF-4507-ABD0-3894F091460A}" dt="2020-05-09T17:55:21.769" v="14745" actId="1037"/>
          <ac:spMkLst>
            <pc:docMk/>
            <pc:sldMk cId="3700445330" sldId="356"/>
            <ac:spMk id="13" creationId="{0428E957-ED3D-48D8-A7E3-488BB8185CF5}"/>
          </ac:spMkLst>
        </pc:spChg>
        <pc:spChg chg="mod">
          <ac:chgData name="vijay kumar" userId="0eb738f014aa4543" providerId="LiveId" clId="{B4DB2928-3EFF-4507-ABD0-3894F091460A}" dt="2020-05-09T17:34:24.279" v="14566" actId="1076"/>
          <ac:spMkLst>
            <pc:docMk/>
            <pc:sldMk cId="3700445330" sldId="356"/>
            <ac:spMk id="15" creationId="{D4AC9025-B379-4AFB-ADC3-5C1F52ACDCEF}"/>
          </ac:spMkLst>
        </pc:spChg>
        <pc:spChg chg="mod">
          <ac:chgData name="vijay kumar" userId="0eb738f014aa4543" providerId="LiveId" clId="{B4DB2928-3EFF-4507-ABD0-3894F091460A}" dt="2020-05-09T17:34:24.279" v="14566" actId="1076"/>
          <ac:spMkLst>
            <pc:docMk/>
            <pc:sldMk cId="3700445330" sldId="356"/>
            <ac:spMk id="16" creationId="{87360A50-659D-4805-98C7-5858E4AC40C4}"/>
          </ac:spMkLst>
        </pc:spChg>
        <pc:spChg chg="mod">
          <ac:chgData name="vijay kumar" userId="0eb738f014aa4543" providerId="LiveId" clId="{B4DB2928-3EFF-4507-ABD0-3894F091460A}" dt="2020-05-09T17:34:24.279" v="14566" actId="1076"/>
          <ac:spMkLst>
            <pc:docMk/>
            <pc:sldMk cId="3700445330" sldId="356"/>
            <ac:spMk id="17" creationId="{E737399B-8799-4C23-B351-D2AF1E115BAF}"/>
          </ac:spMkLst>
        </pc:spChg>
        <pc:spChg chg="mod">
          <ac:chgData name="vijay kumar" userId="0eb738f014aa4543" providerId="LiveId" clId="{B4DB2928-3EFF-4507-ABD0-3894F091460A}" dt="2020-05-09T17:34:24.279" v="14566" actId="1076"/>
          <ac:spMkLst>
            <pc:docMk/>
            <pc:sldMk cId="3700445330" sldId="356"/>
            <ac:spMk id="18" creationId="{DB7440D5-0EDB-4934-AFC9-FCBAEAB40B6A}"/>
          </ac:spMkLst>
        </pc:spChg>
        <pc:spChg chg="mod">
          <ac:chgData name="vijay kumar" userId="0eb738f014aa4543" providerId="LiveId" clId="{B4DB2928-3EFF-4507-ABD0-3894F091460A}" dt="2020-05-09T17:34:24.279" v="14566" actId="1076"/>
          <ac:spMkLst>
            <pc:docMk/>
            <pc:sldMk cId="3700445330" sldId="356"/>
            <ac:spMk id="23" creationId="{0B467A37-1B84-42C4-8E47-71ACEABBF355}"/>
          </ac:spMkLst>
        </pc:spChg>
        <pc:spChg chg="mod">
          <ac:chgData name="vijay kumar" userId="0eb738f014aa4543" providerId="LiveId" clId="{B4DB2928-3EFF-4507-ABD0-3894F091460A}" dt="2020-05-09T17:34:24.279" v="14566" actId="1076"/>
          <ac:spMkLst>
            <pc:docMk/>
            <pc:sldMk cId="3700445330" sldId="356"/>
            <ac:spMk id="24" creationId="{349B936A-DF5D-4435-AB46-8BCA03EACC7E}"/>
          </ac:spMkLst>
        </pc:spChg>
        <pc:spChg chg="mod">
          <ac:chgData name="vijay kumar" userId="0eb738f014aa4543" providerId="LiveId" clId="{B4DB2928-3EFF-4507-ABD0-3894F091460A}" dt="2020-05-09T17:34:24.279" v="14566" actId="1076"/>
          <ac:spMkLst>
            <pc:docMk/>
            <pc:sldMk cId="3700445330" sldId="356"/>
            <ac:spMk id="25" creationId="{37E64C27-4A90-43B0-B335-67135206CA21}"/>
          </ac:spMkLst>
        </pc:spChg>
        <pc:spChg chg="mod">
          <ac:chgData name="vijay kumar" userId="0eb738f014aa4543" providerId="LiveId" clId="{B4DB2928-3EFF-4507-ABD0-3894F091460A}" dt="2020-05-09T17:34:24.279" v="14566" actId="1076"/>
          <ac:spMkLst>
            <pc:docMk/>
            <pc:sldMk cId="3700445330" sldId="356"/>
            <ac:spMk id="26" creationId="{F924839B-6619-4241-BA27-51F8CCF5735E}"/>
          </ac:spMkLst>
        </pc:spChg>
        <pc:spChg chg="mod">
          <ac:chgData name="vijay kumar" userId="0eb738f014aa4543" providerId="LiveId" clId="{B4DB2928-3EFF-4507-ABD0-3894F091460A}" dt="2020-05-09T17:34:24.279" v="14566" actId="1076"/>
          <ac:spMkLst>
            <pc:docMk/>
            <pc:sldMk cId="3700445330" sldId="356"/>
            <ac:spMk id="27" creationId="{DBDB33CE-103D-47DE-B452-DF7EF684E1C9}"/>
          </ac:spMkLst>
        </pc:spChg>
        <pc:spChg chg="mod">
          <ac:chgData name="vijay kumar" userId="0eb738f014aa4543" providerId="LiveId" clId="{B4DB2928-3EFF-4507-ABD0-3894F091460A}" dt="2020-05-09T17:34:24.279" v="14566" actId="1076"/>
          <ac:spMkLst>
            <pc:docMk/>
            <pc:sldMk cId="3700445330" sldId="356"/>
            <ac:spMk id="28" creationId="{3312A2C5-A6C5-4358-A6C7-769CF6C6A1B4}"/>
          </ac:spMkLst>
        </pc:spChg>
        <pc:spChg chg="mod">
          <ac:chgData name="vijay kumar" userId="0eb738f014aa4543" providerId="LiveId" clId="{B4DB2928-3EFF-4507-ABD0-3894F091460A}" dt="2020-05-09T17:34:24.279" v="14566" actId="1076"/>
          <ac:spMkLst>
            <pc:docMk/>
            <pc:sldMk cId="3700445330" sldId="356"/>
            <ac:spMk id="29" creationId="{9C8FD83D-0D93-4AD4-9E76-82364E521067}"/>
          </ac:spMkLst>
        </pc:spChg>
        <pc:spChg chg="mod">
          <ac:chgData name="vijay kumar" userId="0eb738f014aa4543" providerId="LiveId" clId="{B4DB2928-3EFF-4507-ABD0-3894F091460A}" dt="2020-05-09T17:34:24.279" v="14566" actId="1076"/>
          <ac:spMkLst>
            <pc:docMk/>
            <pc:sldMk cId="3700445330" sldId="356"/>
            <ac:spMk id="30" creationId="{CD76B286-78DD-4FA0-9084-8D4FD5B2E46E}"/>
          </ac:spMkLst>
        </pc:spChg>
        <pc:spChg chg="add del mod">
          <ac:chgData name="vijay kumar" userId="0eb738f014aa4543" providerId="LiveId" clId="{B4DB2928-3EFF-4507-ABD0-3894F091460A}" dt="2020-05-09T17:54:11.623" v="14706" actId="478"/>
          <ac:spMkLst>
            <pc:docMk/>
            <pc:sldMk cId="3700445330" sldId="356"/>
            <ac:spMk id="31" creationId="{DDBFE2C2-3826-4C65-8082-E299AE6249AB}"/>
          </ac:spMkLst>
        </pc:spChg>
        <pc:spChg chg="add mod">
          <ac:chgData name="vijay kumar" userId="0eb738f014aa4543" providerId="LiveId" clId="{B4DB2928-3EFF-4507-ABD0-3894F091460A}" dt="2020-05-24T14:29:38.140" v="15186" actId="1076"/>
          <ac:spMkLst>
            <pc:docMk/>
            <pc:sldMk cId="3700445330" sldId="356"/>
            <ac:spMk id="32" creationId="{130A4858-F547-4D8C-A2FF-082E5E9C6F7E}"/>
          </ac:spMkLst>
        </pc:spChg>
        <pc:grpChg chg="add mod">
          <ac:chgData name="vijay kumar" userId="0eb738f014aa4543" providerId="LiveId" clId="{B4DB2928-3EFF-4507-ABD0-3894F091460A}" dt="2020-05-09T17:34:24.279" v="14566" actId="1076"/>
          <ac:grpSpMkLst>
            <pc:docMk/>
            <pc:sldMk cId="3700445330" sldId="356"/>
            <ac:grpSpMk id="3" creationId="{66C105B6-59EA-4750-A838-914E25E80CD8}"/>
          </ac:grpSpMkLst>
        </pc:grpChg>
        <pc:grpChg chg="mod">
          <ac:chgData name="vijay kumar" userId="0eb738f014aa4543" providerId="LiveId" clId="{B4DB2928-3EFF-4507-ABD0-3894F091460A}" dt="2020-05-09T17:34:24.279" v="14566" actId="1076"/>
          <ac:grpSpMkLst>
            <pc:docMk/>
            <pc:sldMk cId="3700445330" sldId="356"/>
            <ac:grpSpMk id="19" creationId="{3D11511F-095C-4ADC-8DD1-2D566108EA3A}"/>
          </ac:grpSpMkLst>
        </pc:grpChg>
        <pc:grpChg chg="mod">
          <ac:chgData name="vijay kumar" userId="0eb738f014aa4543" providerId="LiveId" clId="{B4DB2928-3EFF-4507-ABD0-3894F091460A}" dt="2020-05-09T17:34:24.279" v="14566" actId="1076"/>
          <ac:grpSpMkLst>
            <pc:docMk/>
            <pc:sldMk cId="3700445330" sldId="356"/>
            <ac:grpSpMk id="20" creationId="{C732BD53-9D94-4734-BC4D-E1D59E5BF513}"/>
          </ac:grpSpMkLst>
        </pc:grpChg>
        <pc:grpChg chg="mod">
          <ac:chgData name="vijay kumar" userId="0eb738f014aa4543" providerId="LiveId" clId="{B4DB2928-3EFF-4507-ABD0-3894F091460A}" dt="2020-05-09T17:34:24.279" v="14566" actId="1076"/>
          <ac:grpSpMkLst>
            <pc:docMk/>
            <pc:sldMk cId="3700445330" sldId="356"/>
            <ac:grpSpMk id="21" creationId="{207875A5-CFDB-4369-B301-3199FE4238EE}"/>
          </ac:grpSpMkLst>
        </pc:grpChg>
        <pc:grpChg chg="mod">
          <ac:chgData name="vijay kumar" userId="0eb738f014aa4543" providerId="LiveId" clId="{B4DB2928-3EFF-4507-ABD0-3894F091460A}" dt="2020-05-09T17:34:24.279" v="14566" actId="1076"/>
          <ac:grpSpMkLst>
            <pc:docMk/>
            <pc:sldMk cId="3700445330" sldId="356"/>
            <ac:grpSpMk id="22" creationId="{169C9C83-700A-4622-B749-5827CC93C813}"/>
          </ac:grpSpMkLst>
        </pc:grpChg>
        <pc:cxnChg chg="mod">
          <ac:chgData name="vijay kumar" userId="0eb738f014aa4543" providerId="LiveId" clId="{B4DB2928-3EFF-4507-ABD0-3894F091460A}" dt="2020-05-09T17:34:24.279" v="14566" actId="1076"/>
          <ac:cxnSpMkLst>
            <pc:docMk/>
            <pc:sldMk cId="3700445330" sldId="356"/>
            <ac:cxnSpMk id="14" creationId="{E248DCA2-D50F-4F67-8976-38259941E2ED}"/>
          </ac:cxnSpMkLst>
        </pc:cxn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CC20C68-7EC2-47D8-A250-904CF12D634B}" type="datetimeFigureOut">
              <a:rPr lang="en-IN" smtClean="0"/>
              <a:t>17-09-2020</a:t>
            </a:fld>
            <a:endParaRPr lang="en-IN"/>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8C9670D-4E0A-4E9A-ADB4-92B50D16E2ED}" type="slidenum">
              <a:rPr lang="en-IN" smtClean="0"/>
              <a:t>‹#›</a:t>
            </a:fld>
            <a:endParaRPr lang="en-IN"/>
          </a:p>
        </p:txBody>
      </p:sp>
    </p:spTree>
    <p:extLst>
      <p:ext uri="{BB962C8B-B14F-4D97-AF65-F5344CB8AC3E}">
        <p14:creationId xmlns:p14="http://schemas.microsoft.com/office/powerpoint/2010/main" val="22381933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B8C9670D-4E0A-4E9A-ADB4-92B50D16E2ED}" type="slidenum">
              <a:rPr lang="en-IN" smtClean="0"/>
              <a:t>1</a:t>
            </a:fld>
            <a:endParaRPr lang="en-IN"/>
          </a:p>
        </p:txBody>
      </p:sp>
    </p:spTree>
    <p:extLst>
      <p:ext uri="{BB962C8B-B14F-4D97-AF65-F5344CB8AC3E}">
        <p14:creationId xmlns:p14="http://schemas.microsoft.com/office/powerpoint/2010/main" val="168656570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IN"/>
          </a:p>
        </p:txBody>
      </p:sp>
      <p:sp>
        <p:nvSpPr>
          <p:cNvPr id="4" name="Slide Number Placeholder 3"/>
          <p:cNvSpPr>
            <a:spLocks noGrp="1"/>
          </p:cNvSpPr>
          <p:nvPr>
            <p:ph type="sldNum" sz="quarter" idx="10"/>
          </p:nvPr>
        </p:nvSpPr>
        <p:spPr/>
        <p:txBody>
          <a:bodyPr/>
          <a:lstStyle/>
          <a:p>
            <a:fld id="{EE8A6A93-C5AB-488A-BB58-B99BDEE1ED75}" type="slidenum">
              <a:rPr lang="en-IN" smtClean="0"/>
              <a:pPr/>
              <a:t>2</a:t>
            </a:fld>
            <a:endParaRPr lang="en-IN"/>
          </a:p>
        </p:txBody>
      </p:sp>
    </p:spTree>
    <p:extLst>
      <p:ext uri="{BB962C8B-B14F-4D97-AF65-F5344CB8AC3E}">
        <p14:creationId xmlns:p14="http://schemas.microsoft.com/office/powerpoint/2010/main" val="228949163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B8C9670D-4E0A-4E9A-ADB4-92B50D16E2ED}" type="slidenum">
              <a:rPr lang="en-IN" smtClean="0"/>
              <a:t>5</a:t>
            </a:fld>
            <a:endParaRPr lang="en-IN"/>
          </a:p>
        </p:txBody>
      </p:sp>
    </p:spTree>
    <p:extLst>
      <p:ext uri="{BB962C8B-B14F-4D97-AF65-F5344CB8AC3E}">
        <p14:creationId xmlns:p14="http://schemas.microsoft.com/office/powerpoint/2010/main" val="10334447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9/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9/1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9/17/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9/1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17/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1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1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9/17/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7.tiff"/><Relationship Id="rId3" Type="http://schemas.openxmlformats.org/officeDocument/2006/relationships/image" Target="../media/image2.tiff"/><Relationship Id="rId7" Type="http://schemas.openxmlformats.org/officeDocument/2006/relationships/image" Target="../media/image6.tiff"/><Relationship Id="rId2" Type="http://schemas.openxmlformats.org/officeDocument/2006/relationships/image" Target="../media/image1.tiff"/><Relationship Id="rId1" Type="http://schemas.openxmlformats.org/officeDocument/2006/relationships/slideLayout" Target="../slideLayouts/slideLayout7.xml"/><Relationship Id="rId6" Type="http://schemas.openxmlformats.org/officeDocument/2006/relationships/image" Target="../media/image5.tiff"/><Relationship Id="rId5" Type="http://schemas.openxmlformats.org/officeDocument/2006/relationships/image" Target="../media/image4.tiff"/><Relationship Id="rId4" Type="http://schemas.openxmlformats.org/officeDocument/2006/relationships/image" Target="../media/image3.tiff"/><Relationship Id="rId9" Type="http://schemas.openxmlformats.org/officeDocument/2006/relationships/image" Target="../media/image8.tiff"/></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1" name="Group 360">
            <a:extLst>
              <a:ext uri="{FF2B5EF4-FFF2-40B4-BE49-F238E27FC236}">
                <a16:creationId xmlns:a16="http://schemas.microsoft.com/office/drawing/2014/main" id="{E8534E62-05EE-4085-AB8C-722D0ED81529}"/>
              </a:ext>
            </a:extLst>
          </p:cNvPr>
          <p:cNvGrpSpPr/>
          <p:nvPr/>
        </p:nvGrpSpPr>
        <p:grpSpPr>
          <a:xfrm>
            <a:off x="2188688" y="388938"/>
            <a:ext cx="4926744" cy="4783181"/>
            <a:chOff x="1964952" y="355891"/>
            <a:chExt cx="4926744" cy="4783181"/>
          </a:xfrm>
        </p:grpSpPr>
        <p:sp>
          <p:nvSpPr>
            <p:cNvPr id="10" name="TextBox 9">
              <a:extLst>
                <a:ext uri="{FF2B5EF4-FFF2-40B4-BE49-F238E27FC236}">
                  <a16:creationId xmlns:a16="http://schemas.microsoft.com/office/drawing/2014/main" id="{8BB69EC3-7E88-43DE-A0C3-97789DD5644B}"/>
                </a:ext>
              </a:extLst>
            </p:cNvPr>
            <p:cNvSpPr txBox="1"/>
            <p:nvPr/>
          </p:nvSpPr>
          <p:spPr>
            <a:xfrm>
              <a:off x="1964952" y="355891"/>
              <a:ext cx="4926744" cy="338554"/>
            </a:xfrm>
            <a:prstGeom prst="rect">
              <a:avLst/>
            </a:prstGeom>
            <a:noFill/>
          </p:spPr>
          <p:txBody>
            <a:bodyPr wrap="square" rtlCol="0">
              <a:spAutoFit/>
            </a:bodyPr>
            <a:lstStyle/>
            <a:p>
              <a:pPr algn="ctr"/>
              <a:r>
                <a:rPr lang="en-IN" sz="1600" dirty="0">
                  <a:solidFill>
                    <a:srgbClr val="31A354"/>
                  </a:solidFill>
                  <a:latin typeface=" Calibri "/>
                </a:rPr>
                <a:t>Lipid signalling and phosphatidylinositol metabolism</a:t>
              </a:r>
            </a:p>
          </p:txBody>
        </p:sp>
        <p:grpSp>
          <p:nvGrpSpPr>
            <p:cNvPr id="360" name="Group 359">
              <a:extLst>
                <a:ext uri="{FF2B5EF4-FFF2-40B4-BE49-F238E27FC236}">
                  <a16:creationId xmlns:a16="http://schemas.microsoft.com/office/drawing/2014/main" id="{9DB0FDBB-4700-429F-9943-BCBE70DE2EB4}"/>
                </a:ext>
              </a:extLst>
            </p:cNvPr>
            <p:cNvGrpSpPr/>
            <p:nvPr/>
          </p:nvGrpSpPr>
          <p:grpSpPr>
            <a:xfrm>
              <a:off x="2910276" y="715944"/>
              <a:ext cx="3027063" cy="4423128"/>
              <a:chOff x="2910276" y="715944"/>
              <a:chExt cx="3027063" cy="4423128"/>
            </a:xfrm>
          </p:grpSpPr>
          <p:grpSp>
            <p:nvGrpSpPr>
              <p:cNvPr id="169" name="Group 168">
                <a:extLst>
                  <a:ext uri="{FF2B5EF4-FFF2-40B4-BE49-F238E27FC236}">
                    <a16:creationId xmlns:a16="http://schemas.microsoft.com/office/drawing/2014/main" id="{1EBF326C-2996-4900-83B7-B619A418DFEB}"/>
                  </a:ext>
                </a:extLst>
              </p:cNvPr>
              <p:cNvGrpSpPr/>
              <p:nvPr/>
            </p:nvGrpSpPr>
            <p:grpSpPr>
              <a:xfrm>
                <a:off x="3448922" y="4745064"/>
                <a:ext cx="1591200" cy="394008"/>
                <a:chOff x="3812337" y="4336643"/>
                <a:chExt cx="1591200" cy="394008"/>
              </a:xfrm>
            </p:grpSpPr>
            <p:grpSp>
              <p:nvGrpSpPr>
                <p:cNvPr id="155" name="Group 154">
                  <a:extLst>
                    <a:ext uri="{FF2B5EF4-FFF2-40B4-BE49-F238E27FC236}">
                      <a16:creationId xmlns:a16="http://schemas.microsoft.com/office/drawing/2014/main" id="{CC1A0E35-150B-44DB-9F27-9C01B35874FD}"/>
                    </a:ext>
                  </a:extLst>
                </p:cNvPr>
                <p:cNvGrpSpPr/>
                <p:nvPr/>
              </p:nvGrpSpPr>
              <p:grpSpPr>
                <a:xfrm>
                  <a:off x="3812337" y="4336643"/>
                  <a:ext cx="1591200" cy="219075"/>
                  <a:chOff x="1344613" y="5343525"/>
                  <a:chExt cx="6734175" cy="219075"/>
                </a:xfrm>
              </p:grpSpPr>
              <p:sp>
                <p:nvSpPr>
                  <p:cNvPr id="21" name="AutoShape 3">
                    <a:extLst>
                      <a:ext uri="{FF2B5EF4-FFF2-40B4-BE49-F238E27FC236}">
                        <a16:creationId xmlns:a16="http://schemas.microsoft.com/office/drawing/2014/main" id="{F7D19F5B-F3D1-446C-AF8F-B2B0ABF36D8E}"/>
                      </a:ext>
                    </a:extLst>
                  </p:cNvPr>
                  <p:cNvSpPr>
                    <a:spLocks noChangeAspect="1" noChangeArrowheads="1" noTextEdit="1"/>
                  </p:cNvSpPr>
                  <p:nvPr/>
                </p:nvSpPr>
                <p:spPr bwMode="auto">
                  <a:xfrm>
                    <a:off x="1344613" y="5343525"/>
                    <a:ext cx="6724650" cy="209550"/>
                  </a:xfrm>
                  <a:prstGeom prst="rect">
                    <a:avLst/>
                  </a:prstGeom>
                  <a:noFill/>
                  <a:ln w="0">
                    <a:solidFill>
                      <a:schemeClr val="bg1">
                        <a:lumMod val="95000"/>
                      </a:schemeClr>
                    </a:solidFill>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sp>
                <p:nvSpPr>
                  <p:cNvPr id="23" name="Rectangle 5">
                    <a:extLst>
                      <a:ext uri="{FF2B5EF4-FFF2-40B4-BE49-F238E27FC236}">
                        <a16:creationId xmlns:a16="http://schemas.microsoft.com/office/drawing/2014/main" id="{FB4CAD06-62E0-4D6F-AC96-34F34BB63B0D}"/>
                      </a:ext>
                    </a:extLst>
                  </p:cNvPr>
                  <p:cNvSpPr>
                    <a:spLocks noChangeArrowheads="1"/>
                  </p:cNvSpPr>
                  <p:nvPr/>
                </p:nvSpPr>
                <p:spPr bwMode="auto">
                  <a:xfrm>
                    <a:off x="1344613" y="5343525"/>
                    <a:ext cx="620713" cy="209550"/>
                  </a:xfrm>
                  <a:prstGeom prst="rect">
                    <a:avLst/>
                  </a:prstGeom>
                  <a:solidFill>
                    <a:srgbClr val="E59866"/>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24" name="Rectangle 6">
                    <a:extLst>
                      <a:ext uri="{FF2B5EF4-FFF2-40B4-BE49-F238E27FC236}">
                        <a16:creationId xmlns:a16="http://schemas.microsoft.com/office/drawing/2014/main" id="{F1BF17C7-1F97-4C78-9B0A-BE61FBD9C5B8}"/>
                      </a:ext>
                    </a:extLst>
                  </p:cNvPr>
                  <p:cNvSpPr>
                    <a:spLocks noChangeArrowheads="1"/>
                  </p:cNvSpPr>
                  <p:nvPr/>
                </p:nvSpPr>
                <p:spPr bwMode="auto">
                  <a:xfrm>
                    <a:off x="1955801" y="5343525"/>
                    <a:ext cx="619125" cy="209550"/>
                  </a:xfrm>
                  <a:prstGeom prst="rect">
                    <a:avLst/>
                  </a:prstGeom>
                  <a:solidFill>
                    <a:srgbClr val="EAAC8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5" name="Rectangle 7">
                    <a:extLst>
                      <a:ext uri="{FF2B5EF4-FFF2-40B4-BE49-F238E27FC236}">
                        <a16:creationId xmlns:a16="http://schemas.microsoft.com/office/drawing/2014/main" id="{1D97CF28-95D7-4221-A767-7B021D959384}"/>
                      </a:ext>
                    </a:extLst>
                  </p:cNvPr>
                  <p:cNvSpPr>
                    <a:spLocks noChangeArrowheads="1"/>
                  </p:cNvSpPr>
                  <p:nvPr/>
                </p:nvSpPr>
                <p:spPr bwMode="auto">
                  <a:xfrm>
                    <a:off x="2565401" y="5343525"/>
                    <a:ext cx="620713" cy="209550"/>
                  </a:xfrm>
                  <a:prstGeom prst="rect">
                    <a:avLst/>
                  </a:prstGeom>
                  <a:solidFill>
                    <a:srgbClr val="EFC1A3"/>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6" name="Rectangle 8">
                    <a:extLst>
                      <a:ext uri="{FF2B5EF4-FFF2-40B4-BE49-F238E27FC236}">
                        <a16:creationId xmlns:a16="http://schemas.microsoft.com/office/drawing/2014/main" id="{F9B2D4E7-0E85-4745-BE07-D06B5797EDDA}"/>
                      </a:ext>
                    </a:extLst>
                  </p:cNvPr>
                  <p:cNvSpPr>
                    <a:spLocks noChangeArrowheads="1"/>
                  </p:cNvSpPr>
                  <p:nvPr/>
                </p:nvSpPr>
                <p:spPr bwMode="auto">
                  <a:xfrm>
                    <a:off x="3176588" y="5343525"/>
                    <a:ext cx="619125" cy="209550"/>
                  </a:xfrm>
                  <a:prstGeom prst="rect">
                    <a:avLst/>
                  </a:prstGeom>
                  <a:solidFill>
                    <a:srgbClr val="F4D5C1"/>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 name="Rectangle 9">
                    <a:extLst>
                      <a:ext uri="{FF2B5EF4-FFF2-40B4-BE49-F238E27FC236}">
                        <a16:creationId xmlns:a16="http://schemas.microsoft.com/office/drawing/2014/main" id="{9E519A2D-67D9-4A20-96BE-D8A5A33FFEA1}"/>
                      </a:ext>
                    </a:extLst>
                  </p:cNvPr>
                  <p:cNvSpPr>
                    <a:spLocks noChangeArrowheads="1"/>
                  </p:cNvSpPr>
                  <p:nvPr/>
                </p:nvSpPr>
                <p:spPr bwMode="auto">
                  <a:xfrm>
                    <a:off x="3786188" y="5343525"/>
                    <a:ext cx="620713" cy="209550"/>
                  </a:xfrm>
                  <a:prstGeom prst="rect">
                    <a:avLst/>
                  </a:prstGeom>
                  <a:solidFill>
                    <a:srgbClr val="F9EAE0"/>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8" name="Rectangle 10">
                    <a:extLst>
                      <a:ext uri="{FF2B5EF4-FFF2-40B4-BE49-F238E27FC236}">
                        <a16:creationId xmlns:a16="http://schemas.microsoft.com/office/drawing/2014/main" id="{BB31F422-4415-4C33-AC9C-B19E35BD2CF2}"/>
                      </a:ext>
                    </a:extLst>
                  </p:cNvPr>
                  <p:cNvSpPr>
                    <a:spLocks noChangeArrowheads="1"/>
                  </p:cNvSpPr>
                  <p:nvPr/>
                </p:nvSpPr>
                <p:spPr bwMode="auto">
                  <a:xfrm>
                    <a:off x="4397376" y="5343525"/>
                    <a:ext cx="619125" cy="209550"/>
                  </a:xfrm>
                  <a:prstGeom prst="rect">
                    <a:avLst/>
                  </a:prstGeom>
                  <a:solidFill>
                    <a:srgbClr val="FFFFFF"/>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9" name="Rectangle 11">
                    <a:extLst>
                      <a:ext uri="{FF2B5EF4-FFF2-40B4-BE49-F238E27FC236}">
                        <a16:creationId xmlns:a16="http://schemas.microsoft.com/office/drawing/2014/main" id="{16FF8F4F-86DA-40C6-8398-70AAD7C02610}"/>
                      </a:ext>
                    </a:extLst>
                  </p:cNvPr>
                  <p:cNvSpPr>
                    <a:spLocks noChangeArrowheads="1"/>
                  </p:cNvSpPr>
                  <p:nvPr/>
                </p:nvSpPr>
                <p:spPr bwMode="auto">
                  <a:xfrm>
                    <a:off x="5006976" y="5343525"/>
                    <a:ext cx="620713" cy="209550"/>
                  </a:xfrm>
                  <a:prstGeom prst="rect">
                    <a:avLst/>
                  </a:prstGeom>
                  <a:solidFill>
                    <a:srgbClr val="D6EDDD"/>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50" name="Rectangle 12">
                    <a:extLst>
                      <a:ext uri="{FF2B5EF4-FFF2-40B4-BE49-F238E27FC236}">
                        <a16:creationId xmlns:a16="http://schemas.microsoft.com/office/drawing/2014/main" id="{2D4675FB-6673-491F-94ED-3FC827351056}"/>
                      </a:ext>
                    </a:extLst>
                  </p:cNvPr>
                  <p:cNvSpPr>
                    <a:spLocks noChangeArrowheads="1"/>
                  </p:cNvSpPr>
                  <p:nvPr/>
                </p:nvSpPr>
                <p:spPr bwMode="auto">
                  <a:xfrm>
                    <a:off x="5618163" y="5343525"/>
                    <a:ext cx="619125" cy="209550"/>
                  </a:xfrm>
                  <a:prstGeom prst="rect">
                    <a:avLst/>
                  </a:prstGeom>
                  <a:solidFill>
                    <a:srgbClr val="ADDBBB"/>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51" name="Rectangle 13">
                    <a:extLst>
                      <a:ext uri="{FF2B5EF4-FFF2-40B4-BE49-F238E27FC236}">
                        <a16:creationId xmlns:a16="http://schemas.microsoft.com/office/drawing/2014/main" id="{E7FC00B0-8E2A-4E19-BCF4-1B8D1ECE6EE9}"/>
                      </a:ext>
                    </a:extLst>
                  </p:cNvPr>
                  <p:cNvSpPr>
                    <a:spLocks noChangeArrowheads="1"/>
                  </p:cNvSpPr>
                  <p:nvPr/>
                </p:nvSpPr>
                <p:spPr bwMode="auto">
                  <a:xfrm>
                    <a:off x="6227763" y="5343525"/>
                    <a:ext cx="620713" cy="209550"/>
                  </a:xfrm>
                  <a:prstGeom prst="rect">
                    <a:avLst/>
                  </a:prstGeom>
                  <a:solidFill>
                    <a:srgbClr val="84C899"/>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52" name="Rectangle 14">
                    <a:extLst>
                      <a:ext uri="{FF2B5EF4-FFF2-40B4-BE49-F238E27FC236}">
                        <a16:creationId xmlns:a16="http://schemas.microsoft.com/office/drawing/2014/main" id="{97C698F9-2C09-4197-9715-BC75F555F42D}"/>
                      </a:ext>
                    </a:extLst>
                  </p:cNvPr>
                  <p:cNvSpPr>
                    <a:spLocks noChangeArrowheads="1"/>
                  </p:cNvSpPr>
                  <p:nvPr/>
                </p:nvSpPr>
                <p:spPr bwMode="auto">
                  <a:xfrm>
                    <a:off x="6838951" y="5343525"/>
                    <a:ext cx="619125" cy="209550"/>
                  </a:xfrm>
                  <a:prstGeom prst="rect">
                    <a:avLst/>
                  </a:prstGeom>
                  <a:solidFill>
                    <a:srgbClr val="5BB677"/>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53" name="Rectangle 15">
                    <a:extLst>
                      <a:ext uri="{FF2B5EF4-FFF2-40B4-BE49-F238E27FC236}">
                        <a16:creationId xmlns:a16="http://schemas.microsoft.com/office/drawing/2014/main" id="{199C2969-EACE-47B7-906A-080A329D788E}"/>
                      </a:ext>
                    </a:extLst>
                  </p:cNvPr>
                  <p:cNvSpPr>
                    <a:spLocks noChangeArrowheads="1"/>
                  </p:cNvSpPr>
                  <p:nvPr/>
                </p:nvSpPr>
                <p:spPr bwMode="auto">
                  <a:xfrm>
                    <a:off x="7448551" y="5343525"/>
                    <a:ext cx="620713" cy="209550"/>
                  </a:xfrm>
                  <a:prstGeom prst="rect">
                    <a:avLst/>
                  </a:prstGeom>
                  <a:solidFill>
                    <a:srgbClr val="31A35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5" name="Line 27">
                    <a:extLst>
                      <a:ext uri="{FF2B5EF4-FFF2-40B4-BE49-F238E27FC236}">
                        <a16:creationId xmlns:a16="http://schemas.microsoft.com/office/drawing/2014/main" id="{26935F9E-6E71-410B-966F-8CB02EB1BAAD}"/>
                      </a:ext>
                    </a:extLst>
                  </p:cNvPr>
                  <p:cNvSpPr>
                    <a:spLocks noChangeShapeType="1"/>
                  </p:cNvSpPr>
                  <p:nvPr/>
                </p:nvSpPr>
                <p:spPr bwMode="auto">
                  <a:xfrm>
                    <a:off x="1344613"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66" name="Rectangle 28">
                    <a:extLst>
                      <a:ext uri="{FF2B5EF4-FFF2-40B4-BE49-F238E27FC236}">
                        <a16:creationId xmlns:a16="http://schemas.microsoft.com/office/drawing/2014/main" id="{7E574F66-9210-489C-B9C3-F2F174943C93}"/>
                      </a:ext>
                    </a:extLst>
                  </p:cNvPr>
                  <p:cNvSpPr>
                    <a:spLocks noChangeArrowheads="1"/>
                  </p:cNvSpPr>
                  <p:nvPr/>
                </p:nvSpPr>
                <p:spPr bwMode="auto">
                  <a:xfrm>
                    <a:off x="1344613"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7" name="Line 29">
                    <a:extLst>
                      <a:ext uri="{FF2B5EF4-FFF2-40B4-BE49-F238E27FC236}">
                        <a16:creationId xmlns:a16="http://schemas.microsoft.com/office/drawing/2014/main" id="{1160653D-3557-4CEA-9DBC-4946A1093756}"/>
                      </a:ext>
                    </a:extLst>
                  </p:cNvPr>
                  <p:cNvSpPr>
                    <a:spLocks noChangeShapeType="1"/>
                  </p:cNvSpPr>
                  <p:nvPr/>
                </p:nvSpPr>
                <p:spPr bwMode="auto">
                  <a:xfrm>
                    <a:off x="8059738"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68" name="Rectangle 30">
                    <a:extLst>
                      <a:ext uri="{FF2B5EF4-FFF2-40B4-BE49-F238E27FC236}">
                        <a16:creationId xmlns:a16="http://schemas.microsoft.com/office/drawing/2014/main" id="{01E095C6-AAB4-4678-8AC4-2B92A5848096}"/>
                      </a:ext>
                    </a:extLst>
                  </p:cNvPr>
                  <p:cNvSpPr>
                    <a:spLocks noChangeArrowheads="1"/>
                  </p:cNvSpPr>
                  <p:nvPr/>
                </p:nvSpPr>
                <p:spPr bwMode="auto">
                  <a:xfrm>
                    <a:off x="8059738"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9" name="Line 31">
                    <a:extLst>
                      <a:ext uri="{FF2B5EF4-FFF2-40B4-BE49-F238E27FC236}">
                        <a16:creationId xmlns:a16="http://schemas.microsoft.com/office/drawing/2014/main" id="{DF2D046F-B22F-4B1B-9B53-0330BEF2F46C}"/>
                      </a:ext>
                    </a:extLst>
                  </p:cNvPr>
                  <p:cNvSpPr>
                    <a:spLocks noChangeShapeType="1"/>
                  </p:cNvSpPr>
                  <p:nvPr/>
                </p:nvSpPr>
                <p:spPr bwMode="auto">
                  <a:xfrm>
                    <a:off x="1955801"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70" name="Rectangle 32">
                    <a:extLst>
                      <a:ext uri="{FF2B5EF4-FFF2-40B4-BE49-F238E27FC236}">
                        <a16:creationId xmlns:a16="http://schemas.microsoft.com/office/drawing/2014/main" id="{2BA818E3-37A1-4EEC-8E47-3BD2CB848A78}"/>
                      </a:ext>
                    </a:extLst>
                  </p:cNvPr>
                  <p:cNvSpPr>
                    <a:spLocks noChangeArrowheads="1"/>
                  </p:cNvSpPr>
                  <p:nvPr/>
                </p:nvSpPr>
                <p:spPr bwMode="auto">
                  <a:xfrm>
                    <a:off x="1955801"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1" name="Line 33">
                    <a:extLst>
                      <a:ext uri="{FF2B5EF4-FFF2-40B4-BE49-F238E27FC236}">
                        <a16:creationId xmlns:a16="http://schemas.microsoft.com/office/drawing/2014/main" id="{E5E3307E-63C1-4CCF-B490-F58211A7B3DC}"/>
                      </a:ext>
                    </a:extLst>
                  </p:cNvPr>
                  <p:cNvSpPr>
                    <a:spLocks noChangeShapeType="1"/>
                  </p:cNvSpPr>
                  <p:nvPr/>
                </p:nvSpPr>
                <p:spPr bwMode="auto">
                  <a:xfrm>
                    <a:off x="2565401"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72" name="Rectangle 34">
                    <a:extLst>
                      <a:ext uri="{FF2B5EF4-FFF2-40B4-BE49-F238E27FC236}">
                        <a16:creationId xmlns:a16="http://schemas.microsoft.com/office/drawing/2014/main" id="{C315B43A-648C-4DE3-B9FC-C6DEDBF89B3F}"/>
                      </a:ext>
                    </a:extLst>
                  </p:cNvPr>
                  <p:cNvSpPr>
                    <a:spLocks noChangeArrowheads="1"/>
                  </p:cNvSpPr>
                  <p:nvPr/>
                </p:nvSpPr>
                <p:spPr bwMode="auto">
                  <a:xfrm>
                    <a:off x="2565401"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3" name="Line 35">
                    <a:extLst>
                      <a:ext uri="{FF2B5EF4-FFF2-40B4-BE49-F238E27FC236}">
                        <a16:creationId xmlns:a16="http://schemas.microsoft.com/office/drawing/2014/main" id="{F6166161-9DC7-4FEF-B3A7-3BC381ACC41B}"/>
                      </a:ext>
                    </a:extLst>
                  </p:cNvPr>
                  <p:cNvSpPr>
                    <a:spLocks noChangeShapeType="1"/>
                  </p:cNvSpPr>
                  <p:nvPr/>
                </p:nvSpPr>
                <p:spPr bwMode="auto">
                  <a:xfrm>
                    <a:off x="3176588"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74" name="Rectangle 36">
                    <a:extLst>
                      <a:ext uri="{FF2B5EF4-FFF2-40B4-BE49-F238E27FC236}">
                        <a16:creationId xmlns:a16="http://schemas.microsoft.com/office/drawing/2014/main" id="{CA599F91-D685-4114-A095-73E4BB31EBEC}"/>
                      </a:ext>
                    </a:extLst>
                  </p:cNvPr>
                  <p:cNvSpPr>
                    <a:spLocks noChangeArrowheads="1"/>
                  </p:cNvSpPr>
                  <p:nvPr/>
                </p:nvSpPr>
                <p:spPr bwMode="auto">
                  <a:xfrm>
                    <a:off x="3176588"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7" name="Line 37">
                    <a:extLst>
                      <a:ext uri="{FF2B5EF4-FFF2-40B4-BE49-F238E27FC236}">
                        <a16:creationId xmlns:a16="http://schemas.microsoft.com/office/drawing/2014/main" id="{39BABC45-06A0-4F7C-8072-9B1703E0C5C3}"/>
                      </a:ext>
                    </a:extLst>
                  </p:cNvPr>
                  <p:cNvSpPr>
                    <a:spLocks noChangeShapeType="1"/>
                  </p:cNvSpPr>
                  <p:nvPr/>
                </p:nvSpPr>
                <p:spPr bwMode="auto">
                  <a:xfrm>
                    <a:off x="3786188"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78" name="Rectangle 38">
                    <a:extLst>
                      <a:ext uri="{FF2B5EF4-FFF2-40B4-BE49-F238E27FC236}">
                        <a16:creationId xmlns:a16="http://schemas.microsoft.com/office/drawing/2014/main" id="{B2D64F0C-337E-49A5-A78F-FB523CB15B83}"/>
                      </a:ext>
                    </a:extLst>
                  </p:cNvPr>
                  <p:cNvSpPr>
                    <a:spLocks noChangeArrowheads="1"/>
                  </p:cNvSpPr>
                  <p:nvPr/>
                </p:nvSpPr>
                <p:spPr bwMode="auto">
                  <a:xfrm>
                    <a:off x="3786188"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9" name="Line 39">
                    <a:extLst>
                      <a:ext uri="{FF2B5EF4-FFF2-40B4-BE49-F238E27FC236}">
                        <a16:creationId xmlns:a16="http://schemas.microsoft.com/office/drawing/2014/main" id="{A6D01FB8-7BF5-4333-847C-4E5346430A34}"/>
                      </a:ext>
                    </a:extLst>
                  </p:cNvPr>
                  <p:cNvSpPr>
                    <a:spLocks noChangeShapeType="1"/>
                  </p:cNvSpPr>
                  <p:nvPr/>
                </p:nvSpPr>
                <p:spPr bwMode="auto">
                  <a:xfrm>
                    <a:off x="4397376"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40" name="Rectangle 40">
                    <a:extLst>
                      <a:ext uri="{FF2B5EF4-FFF2-40B4-BE49-F238E27FC236}">
                        <a16:creationId xmlns:a16="http://schemas.microsoft.com/office/drawing/2014/main" id="{613AB257-69F9-48C1-8A01-E1B44BCB964B}"/>
                      </a:ext>
                    </a:extLst>
                  </p:cNvPr>
                  <p:cNvSpPr>
                    <a:spLocks noChangeArrowheads="1"/>
                  </p:cNvSpPr>
                  <p:nvPr/>
                </p:nvSpPr>
                <p:spPr bwMode="auto">
                  <a:xfrm>
                    <a:off x="4397376"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1" name="Line 41">
                    <a:extLst>
                      <a:ext uri="{FF2B5EF4-FFF2-40B4-BE49-F238E27FC236}">
                        <a16:creationId xmlns:a16="http://schemas.microsoft.com/office/drawing/2014/main" id="{A49960C2-78EE-41E5-8A0D-0565C717329C}"/>
                      </a:ext>
                    </a:extLst>
                  </p:cNvPr>
                  <p:cNvSpPr>
                    <a:spLocks noChangeShapeType="1"/>
                  </p:cNvSpPr>
                  <p:nvPr/>
                </p:nvSpPr>
                <p:spPr bwMode="auto">
                  <a:xfrm>
                    <a:off x="5006976"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42" name="Rectangle 42">
                    <a:extLst>
                      <a:ext uri="{FF2B5EF4-FFF2-40B4-BE49-F238E27FC236}">
                        <a16:creationId xmlns:a16="http://schemas.microsoft.com/office/drawing/2014/main" id="{3A980D0B-11A5-47DD-B845-C2F112803811}"/>
                      </a:ext>
                    </a:extLst>
                  </p:cNvPr>
                  <p:cNvSpPr>
                    <a:spLocks noChangeArrowheads="1"/>
                  </p:cNvSpPr>
                  <p:nvPr/>
                </p:nvSpPr>
                <p:spPr bwMode="auto">
                  <a:xfrm>
                    <a:off x="5006976"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3" name="Line 43">
                    <a:extLst>
                      <a:ext uri="{FF2B5EF4-FFF2-40B4-BE49-F238E27FC236}">
                        <a16:creationId xmlns:a16="http://schemas.microsoft.com/office/drawing/2014/main" id="{EC3B989F-8E74-4CFD-9D60-7BFC7A2A8825}"/>
                      </a:ext>
                    </a:extLst>
                  </p:cNvPr>
                  <p:cNvSpPr>
                    <a:spLocks noChangeShapeType="1"/>
                  </p:cNvSpPr>
                  <p:nvPr/>
                </p:nvSpPr>
                <p:spPr bwMode="auto">
                  <a:xfrm>
                    <a:off x="5618163"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44" name="Rectangle 44">
                    <a:extLst>
                      <a:ext uri="{FF2B5EF4-FFF2-40B4-BE49-F238E27FC236}">
                        <a16:creationId xmlns:a16="http://schemas.microsoft.com/office/drawing/2014/main" id="{5F7185B6-C819-48EE-8B19-F0FB00D481A7}"/>
                      </a:ext>
                    </a:extLst>
                  </p:cNvPr>
                  <p:cNvSpPr>
                    <a:spLocks noChangeArrowheads="1"/>
                  </p:cNvSpPr>
                  <p:nvPr/>
                </p:nvSpPr>
                <p:spPr bwMode="auto">
                  <a:xfrm>
                    <a:off x="5618163"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5" name="Line 45">
                    <a:extLst>
                      <a:ext uri="{FF2B5EF4-FFF2-40B4-BE49-F238E27FC236}">
                        <a16:creationId xmlns:a16="http://schemas.microsoft.com/office/drawing/2014/main" id="{409ADEB7-2D25-48E2-B2FE-0CD7D4F23808}"/>
                      </a:ext>
                    </a:extLst>
                  </p:cNvPr>
                  <p:cNvSpPr>
                    <a:spLocks noChangeShapeType="1"/>
                  </p:cNvSpPr>
                  <p:nvPr/>
                </p:nvSpPr>
                <p:spPr bwMode="auto">
                  <a:xfrm>
                    <a:off x="6227763"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46" name="Rectangle 46">
                    <a:extLst>
                      <a:ext uri="{FF2B5EF4-FFF2-40B4-BE49-F238E27FC236}">
                        <a16:creationId xmlns:a16="http://schemas.microsoft.com/office/drawing/2014/main" id="{AD2BD8DA-1591-434D-9969-DCB32B4EFE9A}"/>
                      </a:ext>
                    </a:extLst>
                  </p:cNvPr>
                  <p:cNvSpPr>
                    <a:spLocks noChangeArrowheads="1"/>
                  </p:cNvSpPr>
                  <p:nvPr/>
                </p:nvSpPr>
                <p:spPr bwMode="auto">
                  <a:xfrm>
                    <a:off x="6227763"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7" name="Line 47">
                    <a:extLst>
                      <a:ext uri="{FF2B5EF4-FFF2-40B4-BE49-F238E27FC236}">
                        <a16:creationId xmlns:a16="http://schemas.microsoft.com/office/drawing/2014/main" id="{C7089F2C-1565-48EC-8BAC-158638D60640}"/>
                      </a:ext>
                    </a:extLst>
                  </p:cNvPr>
                  <p:cNvSpPr>
                    <a:spLocks noChangeShapeType="1"/>
                  </p:cNvSpPr>
                  <p:nvPr/>
                </p:nvSpPr>
                <p:spPr bwMode="auto">
                  <a:xfrm>
                    <a:off x="6838951"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48" name="Rectangle 48">
                    <a:extLst>
                      <a:ext uri="{FF2B5EF4-FFF2-40B4-BE49-F238E27FC236}">
                        <a16:creationId xmlns:a16="http://schemas.microsoft.com/office/drawing/2014/main" id="{C852597D-2A5B-4024-ACBC-03F760879F52}"/>
                      </a:ext>
                    </a:extLst>
                  </p:cNvPr>
                  <p:cNvSpPr>
                    <a:spLocks noChangeArrowheads="1"/>
                  </p:cNvSpPr>
                  <p:nvPr/>
                </p:nvSpPr>
                <p:spPr bwMode="auto">
                  <a:xfrm>
                    <a:off x="6838951"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9" name="Line 49">
                    <a:extLst>
                      <a:ext uri="{FF2B5EF4-FFF2-40B4-BE49-F238E27FC236}">
                        <a16:creationId xmlns:a16="http://schemas.microsoft.com/office/drawing/2014/main" id="{F077FB43-1480-4887-AB37-AE2A351DEC2B}"/>
                      </a:ext>
                    </a:extLst>
                  </p:cNvPr>
                  <p:cNvSpPr>
                    <a:spLocks noChangeShapeType="1"/>
                  </p:cNvSpPr>
                  <p:nvPr/>
                </p:nvSpPr>
                <p:spPr bwMode="auto">
                  <a:xfrm>
                    <a:off x="7448551" y="555307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50" name="Rectangle 50">
                    <a:extLst>
                      <a:ext uri="{FF2B5EF4-FFF2-40B4-BE49-F238E27FC236}">
                        <a16:creationId xmlns:a16="http://schemas.microsoft.com/office/drawing/2014/main" id="{A0954666-DF8E-4C8D-A785-AB5E1235206D}"/>
                      </a:ext>
                    </a:extLst>
                  </p:cNvPr>
                  <p:cNvSpPr>
                    <a:spLocks noChangeArrowheads="1"/>
                  </p:cNvSpPr>
                  <p:nvPr/>
                </p:nvSpPr>
                <p:spPr bwMode="auto">
                  <a:xfrm>
                    <a:off x="7448551" y="555307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51" name="Line 51">
                    <a:extLst>
                      <a:ext uri="{FF2B5EF4-FFF2-40B4-BE49-F238E27FC236}">
                        <a16:creationId xmlns:a16="http://schemas.microsoft.com/office/drawing/2014/main" id="{3E187F38-AFCC-4DD9-803D-8DF9DB326182}"/>
                      </a:ext>
                    </a:extLst>
                  </p:cNvPr>
                  <p:cNvSpPr>
                    <a:spLocks noChangeShapeType="1"/>
                  </p:cNvSpPr>
                  <p:nvPr/>
                </p:nvSpPr>
                <p:spPr bwMode="auto">
                  <a:xfrm>
                    <a:off x="8069263" y="5343525"/>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52" name="Rectangle 52">
                    <a:extLst>
                      <a:ext uri="{FF2B5EF4-FFF2-40B4-BE49-F238E27FC236}">
                        <a16:creationId xmlns:a16="http://schemas.microsoft.com/office/drawing/2014/main" id="{8863C66F-755D-42A8-A627-2E68D9370302}"/>
                      </a:ext>
                    </a:extLst>
                  </p:cNvPr>
                  <p:cNvSpPr>
                    <a:spLocks noChangeArrowheads="1"/>
                  </p:cNvSpPr>
                  <p:nvPr/>
                </p:nvSpPr>
                <p:spPr bwMode="auto">
                  <a:xfrm>
                    <a:off x="8069263" y="5343525"/>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53" name="Line 53">
                    <a:extLst>
                      <a:ext uri="{FF2B5EF4-FFF2-40B4-BE49-F238E27FC236}">
                        <a16:creationId xmlns:a16="http://schemas.microsoft.com/office/drawing/2014/main" id="{EFF66D2F-91F5-48CE-9FA0-79831A759BF8}"/>
                      </a:ext>
                    </a:extLst>
                  </p:cNvPr>
                  <p:cNvSpPr>
                    <a:spLocks noChangeShapeType="1"/>
                  </p:cNvSpPr>
                  <p:nvPr/>
                </p:nvSpPr>
                <p:spPr bwMode="auto">
                  <a:xfrm>
                    <a:off x="8069263" y="5543550"/>
                    <a:ext cx="1588" cy="1588"/>
                  </a:xfrm>
                  <a:prstGeom prst="line">
                    <a:avLst/>
                  </a:prstGeom>
                  <a:noFill/>
                  <a:ln w="0">
                    <a:solidFill>
                      <a:schemeClr val="bg1">
                        <a:lumMod val="9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54" name="Rectangle 54">
                    <a:extLst>
                      <a:ext uri="{FF2B5EF4-FFF2-40B4-BE49-F238E27FC236}">
                        <a16:creationId xmlns:a16="http://schemas.microsoft.com/office/drawing/2014/main" id="{E4F85A8D-4CB9-423B-B154-26DCFEAB43AA}"/>
                      </a:ext>
                    </a:extLst>
                  </p:cNvPr>
                  <p:cNvSpPr>
                    <a:spLocks noChangeArrowheads="1"/>
                  </p:cNvSpPr>
                  <p:nvPr/>
                </p:nvSpPr>
                <p:spPr bwMode="auto">
                  <a:xfrm>
                    <a:off x="8069263" y="5543550"/>
                    <a:ext cx="9525" cy="9525"/>
                  </a:xfrm>
                  <a:prstGeom prst="rect">
                    <a:avLst/>
                  </a:prstGeom>
                  <a:solidFill>
                    <a:srgbClr val="D4D4D4"/>
                  </a:solidFill>
                  <a:ln w="0">
                    <a:solidFill>
                      <a:schemeClr val="bg1">
                        <a:lumMod val="95000"/>
                      </a:schemeClr>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sp>
              <p:nvSpPr>
                <p:cNvPr id="232" name="Rectangle 12">
                  <a:extLst>
                    <a:ext uri="{FF2B5EF4-FFF2-40B4-BE49-F238E27FC236}">
                      <a16:creationId xmlns:a16="http://schemas.microsoft.com/office/drawing/2014/main" id="{266E1138-4749-455D-BBC7-A9E1662C0799}"/>
                    </a:ext>
                  </a:extLst>
                </p:cNvPr>
                <p:cNvSpPr>
                  <a:spLocks noChangeArrowheads="1"/>
                </p:cNvSpPr>
                <p:nvPr/>
              </p:nvSpPr>
              <p:spPr bwMode="auto">
                <a:xfrm>
                  <a:off x="4592501" y="4576763"/>
                  <a:ext cx="6572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latin typeface="Calibri" panose="020F0502020204030204" pitchFamily="34" charset="0"/>
                    </a:rPr>
                    <a:t>0</a:t>
                  </a:r>
                  <a:endParaRPr kumimoji="0" lang="en-US" altLang="en-US" sz="1000" b="0" i="0" u="none" strike="noStrike" cap="none" normalizeH="0" baseline="0" dirty="0">
                    <a:ln>
                      <a:noFill/>
                    </a:ln>
                    <a:solidFill>
                      <a:schemeClr val="tx1"/>
                    </a:solidFill>
                    <a:effectLst/>
                  </a:endParaRPr>
                </a:p>
              </p:txBody>
            </p:sp>
            <p:sp>
              <p:nvSpPr>
                <p:cNvPr id="233" name="Rectangle 14">
                  <a:extLst>
                    <a:ext uri="{FF2B5EF4-FFF2-40B4-BE49-F238E27FC236}">
                      <a16:creationId xmlns:a16="http://schemas.microsoft.com/office/drawing/2014/main" id="{5866FDF0-713B-4F0D-A140-388003454D1E}"/>
                    </a:ext>
                  </a:extLst>
                </p:cNvPr>
                <p:cNvSpPr>
                  <a:spLocks noChangeArrowheads="1"/>
                </p:cNvSpPr>
                <p:nvPr/>
              </p:nvSpPr>
              <p:spPr bwMode="auto">
                <a:xfrm>
                  <a:off x="5330920" y="4564857"/>
                  <a:ext cx="6572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000" dirty="0">
                      <a:solidFill>
                        <a:srgbClr val="000000"/>
                      </a:solidFill>
                      <a:latin typeface="Calibri" panose="020F0502020204030204" pitchFamily="34" charset="0"/>
                    </a:rPr>
                    <a:t>5</a:t>
                  </a:r>
                  <a:endParaRPr kumimoji="0" lang="en-US" altLang="en-US" sz="1000" b="0" i="0" u="none" strike="noStrike" cap="none" normalizeH="0" baseline="0" dirty="0">
                    <a:ln>
                      <a:noFill/>
                    </a:ln>
                    <a:solidFill>
                      <a:schemeClr val="tx1"/>
                    </a:solidFill>
                    <a:effectLst/>
                  </a:endParaRPr>
                </a:p>
              </p:txBody>
            </p:sp>
            <p:sp>
              <p:nvSpPr>
                <p:cNvPr id="234" name="Rectangle 14">
                  <a:extLst>
                    <a:ext uri="{FF2B5EF4-FFF2-40B4-BE49-F238E27FC236}">
                      <a16:creationId xmlns:a16="http://schemas.microsoft.com/office/drawing/2014/main" id="{21095107-B21F-476D-9E0C-B86FFF4BD42A}"/>
                    </a:ext>
                  </a:extLst>
                </p:cNvPr>
                <p:cNvSpPr>
                  <a:spLocks noChangeArrowheads="1"/>
                </p:cNvSpPr>
                <p:nvPr/>
              </p:nvSpPr>
              <p:spPr bwMode="auto">
                <a:xfrm>
                  <a:off x="3812337" y="4567246"/>
                  <a:ext cx="10419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latin typeface="Calibri" panose="020F0502020204030204" pitchFamily="34" charset="0"/>
                    </a:rPr>
                    <a:t>-5</a:t>
                  </a:r>
                  <a:endParaRPr kumimoji="0" lang="en-US" altLang="en-US" sz="1000" b="0" i="0" u="none" strike="noStrike" cap="none" normalizeH="0" baseline="0" dirty="0">
                    <a:ln>
                      <a:noFill/>
                    </a:ln>
                    <a:solidFill>
                      <a:schemeClr val="tx1"/>
                    </a:solidFill>
                    <a:effectLst/>
                  </a:endParaRPr>
                </a:p>
              </p:txBody>
            </p:sp>
          </p:grpSp>
          <p:grpSp>
            <p:nvGrpSpPr>
              <p:cNvPr id="341" name="Group 340">
                <a:extLst>
                  <a:ext uri="{FF2B5EF4-FFF2-40B4-BE49-F238E27FC236}">
                    <a16:creationId xmlns:a16="http://schemas.microsoft.com/office/drawing/2014/main" id="{1B0242D6-D979-41B9-83C8-5ED753189872}"/>
                  </a:ext>
                </a:extLst>
              </p:cNvPr>
              <p:cNvGrpSpPr/>
              <p:nvPr/>
            </p:nvGrpSpPr>
            <p:grpSpPr>
              <a:xfrm>
                <a:off x="2910276" y="717466"/>
                <a:ext cx="766112" cy="3863343"/>
                <a:chOff x="3273691" y="1680643"/>
                <a:chExt cx="766112" cy="3863343"/>
              </a:xfrm>
            </p:grpSpPr>
            <p:sp>
              <p:nvSpPr>
                <p:cNvPr id="8" name="Rectangle 178">
                  <a:extLst>
                    <a:ext uri="{FF2B5EF4-FFF2-40B4-BE49-F238E27FC236}">
                      <a16:creationId xmlns:a16="http://schemas.microsoft.com/office/drawing/2014/main" id="{24B4A969-A938-46CF-982E-BB1B8BFECB91}"/>
                    </a:ext>
                  </a:extLst>
                </p:cNvPr>
                <p:cNvSpPr>
                  <a:spLocks noChangeArrowheads="1"/>
                </p:cNvSpPr>
                <p:nvPr/>
              </p:nvSpPr>
              <p:spPr bwMode="auto">
                <a:xfrm>
                  <a:off x="3363073" y="1680643"/>
                  <a:ext cx="59247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200" b="1" dirty="0">
                      <a:solidFill>
                        <a:srgbClr val="000000"/>
                      </a:solidFill>
                      <a:latin typeface=" Calibri "/>
                    </a:rPr>
                    <a:t>Identifier</a:t>
                  </a:r>
                  <a:endParaRPr kumimoji="0" lang="en-US" altLang="en-US" sz="1200" b="1" i="0" u="none" strike="noStrike" cap="none" normalizeH="0" baseline="0" dirty="0">
                    <a:ln>
                      <a:noFill/>
                    </a:ln>
                    <a:solidFill>
                      <a:schemeClr val="tx1"/>
                    </a:solidFill>
                    <a:effectLst/>
                    <a:latin typeface=" Calibri "/>
                  </a:endParaRPr>
                </a:p>
              </p:txBody>
            </p:sp>
            <p:sp>
              <p:nvSpPr>
                <p:cNvPr id="25" name="Rectangle 5">
                  <a:extLst>
                    <a:ext uri="{FF2B5EF4-FFF2-40B4-BE49-F238E27FC236}">
                      <a16:creationId xmlns:a16="http://schemas.microsoft.com/office/drawing/2014/main" id="{53FDE51C-A1A1-48B2-B488-8EC8BA1673B6}"/>
                    </a:ext>
                  </a:extLst>
                </p:cNvPr>
                <p:cNvSpPr>
                  <a:spLocks noChangeArrowheads="1"/>
                </p:cNvSpPr>
                <p:nvPr/>
              </p:nvSpPr>
              <p:spPr bwMode="auto">
                <a:xfrm>
                  <a:off x="3273691" y="1941890"/>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4G17140</a:t>
                  </a:r>
                  <a:endParaRPr kumimoji="0" lang="en-US" altLang="en-US" sz="1200" b="0" i="0" u="none" strike="noStrike" cap="none" normalizeH="0" baseline="0" dirty="0">
                    <a:ln>
                      <a:noFill/>
                    </a:ln>
                    <a:solidFill>
                      <a:schemeClr val="tx1"/>
                    </a:solidFill>
                    <a:effectLst/>
                  </a:endParaRPr>
                </a:p>
              </p:txBody>
            </p:sp>
            <p:sp>
              <p:nvSpPr>
                <p:cNvPr id="27" name="Rectangle 7">
                  <a:extLst>
                    <a:ext uri="{FF2B5EF4-FFF2-40B4-BE49-F238E27FC236}">
                      <a16:creationId xmlns:a16="http://schemas.microsoft.com/office/drawing/2014/main" id="{639DA128-CD4B-4C43-8988-C4B3259A0FC9}"/>
                    </a:ext>
                  </a:extLst>
                </p:cNvPr>
                <p:cNvSpPr>
                  <a:spLocks noChangeArrowheads="1"/>
                </p:cNvSpPr>
                <p:nvPr/>
              </p:nvSpPr>
              <p:spPr bwMode="auto">
                <a:xfrm>
                  <a:off x="3273691" y="2153028"/>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5G65110</a:t>
                  </a:r>
                  <a:endParaRPr kumimoji="0" lang="en-US" altLang="en-US" sz="1200" b="0" i="0" u="none" strike="noStrike" cap="none" normalizeH="0" baseline="0" dirty="0">
                    <a:ln>
                      <a:noFill/>
                    </a:ln>
                    <a:solidFill>
                      <a:schemeClr val="tx1"/>
                    </a:solidFill>
                    <a:effectLst/>
                  </a:endParaRPr>
                </a:p>
              </p:txBody>
            </p:sp>
            <p:sp>
              <p:nvSpPr>
                <p:cNvPr id="29" name="Rectangle 9">
                  <a:extLst>
                    <a:ext uri="{FF2B5EF4-FFF2-40B4-BE49-F238E27FC236}">
                      <a16:creationId xmlns:a16="http://schemas.microsoft.com/office/drawing/2014/main" id="{49417560-CAB5-4DC0-9EAD-DA52BF8D20F3}"/>
                    </a:ext>
                  </a:extLst>
                </p:cNvPr>
                <p:cNvSpPr>
                  <a:spLocks noChangeArrowheads="1"/>
                </p:cNvSpPr>
                <p:nvPr/>
              </p:nvSpPr>
              <p:spPr bwMode="auto">
                <a:xfrm>
                  <a:off x="3273691" y="2372896"/>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1G36160</a:t>
                  </a:r>
                  <a:endParaRPr kumimoji="0" lang="en-US" altLang="en-US" sz="1200" b="0" i="0" u="none" strike="noStrike" cap="none" normalizeH="0" baseline="0" dirty="0">
                    <a:ln>
                      <a:noFill/>
                    </a:ln>
                    <a:solidFill>
                      <a:schemeClr val="tx1"/>
                    </a:solidFill>
                    <a:effectLst/>
                  </a:endParaRPr>
                </a:p>
              </p:txBody>
            </p:sp>
            <p:sp>
              <p:nvSpPr>
                <p:cNvPr id="31" name="Rectangle 11">
                  <a:extLst>
                    <a:ext uri="{FF2B5EF4-FFF2-40B4-BE49-F238E27FC236}">
                      <a16:creationId xmlns:a16="http://schemas.microsoft.com/office/drawing/2014/main" id="{8EA641A4-FA1E-4D79-9217-0AF24F441EE5}"/>
                    </a:ext>
                  </a:extLst>
                </p:cNvPr>
                <p:cNvSpPr>
                  <a:spLocks noChangeArrowheads="1"/>
                </p:cNvSpPr>
                <p:nvPr/>
              </p:nvSpPr>
              <p:spPr bwMode="auto">
                <a:xfrm>
                  <a:off x="3273691" y="2587208"/>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2G34790</a:t>
                  </a:r>
                  <a:endParaRPr kumimoji="0" lang="en-US" altLang="en-US" sz="1200" b="0" i="0" u="none" strike="noStrike" cap="none" normalizeH="0" baseline="0" dirty="0">
                    <a:ln>
                      <a:noFill/>
                    </a:ln>
                    <a:solidFill>
                      <a:schemeClr val="tx1"/>
                    </a:solidFill>
                    <a:effectLst/>
                  </a:endParaRPr>
                </a:p>
              </p:txBody>
            </p:sp>
            <p:sp>
              <p:nvSpPr>
                <p:cNvPr id="33" name="Rectangle 13">
                  <a:extLst>
                    <a:ext uri="{FF2B5EF4-FFF2-40B4-BE49-F238E27FC236}">
                      <a16:creationId xmlns:a16="http://schemas.microsoft.com/office/drawing/2014/main" id="{B1860DAB-9420-4159-88A4-E36E535F15BB}"/>
                    </a:ext>
                  </a:extLst>
                </p:cNvPr>
                <p:cNvSpPr>
                  <a:spLocks noChangeArrowheads="1"/>
                </p:cNvSpPr>
                <p:nvPr/>
              </p:nvSpPr>
              <p:spPr bwMode="auto">
                <a:xfrm>
                  <a:off x="3273691" y="2795171"/>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5G16390</a:t>
                  </a:r>
                  <a:endParaRPr kumimoji="0" lang="en-US" altLang="en-US" sz="1200" b="0" i="0" u="none" strike="noStrike" cap="none" normalizeH="0" baseline="0" dirty="0">
                    <a:ln>
                      <a:noFill/>
                    </a:ln>
                    <a:solidFill>
                      <a:schemeClr val="tx1"/>
                    </a:solidFill>
                    <a:effectLst/>
                  </a:endParaRPr>
                </a:p>
              </p:txBody>
            </p:sp>
            <p:sp>
              <p:nvSpPr>
                <p:cNvPr id="35" name="Rectangle 15">
                  <a:extLst>
                    <a:ext uri="{FF2B5EF4-FFF2-40B4-BE49-F238E27FC236}">
                      <a16:creationId xmlns:a16="http://schemas.microsoft.com/office/drawing/2014/main" id="{5E0DDEAC-4AD6-4474-B747-AE57949A7E6C}"/>
                    </a:ext>
                  </a:extLst>
                </p:cNvPr>
                <p:cNvSpPr>
                  <a:spLocks noChangeArrowheads="1"/>
                </p:cNvSpPr>
                <p:nvPr/>
              </p:nvSpPr>
              <p:spPr bwMode="auto">
                <a:xfrm>
                  <a:off x="3273691" y="3003134"/>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3G16370</a:t>
                  </a:r>
                  <a:endParaRPr kumimoji="0" lang="en-US" altLang="en-US" sz="1200" b="0" i="0" u="none" strike="noStrike" cap="none" normalizeH="0" baseline="0" dirty="0">
                    <a:ln>
                      <a:noFill/>
                    </a:ln>
                    <a:solidFill>
                      <a:schemeClr val="tx1"/>
                    </a:solidFill>
                    <a:effectLst/>
                  </a:endParaRPr>
                </a:p>
              </p:txBody>
            </p:sp>
            <p:sp>
              <p:nvSpPr>
                <p:cNvPr id="37" name="Rectangle 17">
                  <a:extLst>
                    <a:ext uri="{FF2B5EF4-FFF2-40B4-BE49-F238E27FC236}">
                      <a16:creationId xmlns:a16="http://schemas.microsoft.com/office/drawing/2014/main" id="{5B29110E-8E07-42EF-9771-6BD830F09D87}"/>
                    </a:ext>
                  </a:extLst>
                </p:cNvPr>
                <p:cNvSpPr>
                  <a:spLocks noChangeArrowheads="1"/>
                </p:cNvSpPr>
                <p:nvPr/>
              </p:nvSpPr>
              <p:spPr bwMode="auto">
                <a:xfrm>
                  <a:off x="3273691" y="3223796"/>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5G47980</a:t>
                  </a:r>
                  <a:endParaRPr kumimoji="0" lang="en-US" altLang="en-US" sz="1200" b="0" i="0" u="none" strike="noStrike" cap="none" normalizeH="0" baseline="0" dirty="0">
                    <a:ln>
                      <a:noFill/>
                    </a:ln>
                    <a:solidFill>
                      <a:schemeClr val="tx1"/>
                    </a:solidFill>
                    <a:effectLst/>
                  </a:endParaRPr>
                </a:p>
              </p:txBody>
            </p:sp>
            <p:sp>
              <p:nvSpPr>
                <p:cNvPr id="39" name="Rectangle 19">
                  <a:extLst>
                    <a:ext uri="{FF2B5EF4-FFF2-40B4-BE49-F238E27FC236}">
                      <a16:creationId xmlns:a16="http://schemas.microsoft.com/office/drawing/2014/main" id="{194C2BC8-19EC-48D2-8CC2-86C64C422FF6}"/>
                    </a:ext>
                  </a:extLst>
                </p:cNvPr>
                <p:cNvSpPr>
                  <a:spLocks noChangeArrowheads="1"/>
                </p:cNvSpPr>
                <p:nvPr/>
              </p:nvSpPr>
              <p:spPr bwMode="auto">
                <a:xfrm>
                  <a:off x="3273691" y="3437315"/>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2G22230</a:t>
                  </a:r>
                  <a:endParaRPr kumimoji="0" lang="en-US" altLang="en-US" sz="1200" b="0" i="0" u="none" strike="noStrike" cap="none" normalizeH="0" baseline="0" dirty="0">
                    <a:ln>
                      <a:noFill/>
                    </a:ln>
                    <a:solidFill>
                      <a:schemeClr val="tx1"/>
                    </a:solidFill>
                    <a:effectLst/>
                  </a:endParaRPr>
                </a:p>
              </p:txBody>
            </p:sp>
            <p:sp>
              <p:nvSpPr>
                <p:cNvPr id="41" name="Rectangle 21">
                  <a:extLst>
                    <a:ext uri="{FF2B5EF4-FFF2-40B4-BE49-F238E27FC236}">
                      <a16:creationId xmlns:a16="http://schemas.microsoft.com/office/drawing/2014/main" id="{C5270026-91B4-41A7-9A2C-5867F750FF14}"/>
                    </a:ext>
                  </a:extLst>
                </p:cNvPr>
                <p:cNvSpPr>
                  <a:spLocks noChangeArrowheads="1"/>
                </p:cNvSpPr>
                <p:nvPr/>
              </p:nvSpPr>
              <p:spPr bwMode="auto">
                <a:xfrm>
                  <a:off x="3273691" y="3650040"/>
                  <a:ext cx="7573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4G30670</a:t>
                  </a:r>
                  <a:endParaRPr kumimoji="0" lang="en-US" altLang="en-US" sz="1200" b="0" i="0" u="none" strike="noStrike" cap="none" normalizeH="0" baseline="0" dirty="0">
                    <a:ln>
                      <a:noFill/>
                    </a:ln>
                    <a:solidFill>
                      <a:schemeClr val="tx1"/>
                    </a:solidFill>
                    <a:effectLst/>
                  </a:endParaRPr>
                </a:p>
              </p:txBody>
            </p:sp>
            <p:sp>
              <p:nvSpPr>
                <p:cNvPr id="43" name="Rectangle 23">
                  <a:extLst>
                    <a:ext uri="{FF2B5EF4-FFF2-40B4-BE49-F238E27FC236}">
                      <a16:creationId xmlns:a16="http://schemas.microsoft.com/office/drawing/2014/main" id="{6656284E-726E-4750-8B74-3131089F4CAE}"/>
                    </a:ext>
                  </a:extLst>
                </p:cNvPr>
                <p:cNvSpPr>
                  <a:spLocks noChangeArrowheads="1"/>
                </p:cNvSpPr>
                <p:nvPr/>
              </p:nvSpPr>
              <p:spPr bwMode="auto">
                <a:xfrm>
                  <a:off x="3312278" y="3865940"/>
                  <a:ext cx="72212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AT4G20870</a:t>
                  </a:r>
                  <a:endParaRPr kumimoji="0" lang="en-US" altLang="en-US" sz="1200" b="0" i="0" u="none" strike="noStrike" cap="none" normalizeH="0" baseline="0" dirty="0">
                    <a:ln>
                      <a:noFill/>
                    </a:ln>
                    <a:solidFill>
                      <a:schemeClr val="tx1"/>
                    </a:solidFill>
                    <a:effectLst/>
                  </a:endParaRPr>
                </a:p>
              </p:txBody>
            </p:sp>
            <p:sp>
              <p:nvSpPr>
                <p:cNvPr id="303" name="Rectangle 74">
                  <a:extLst>
                    <a:ext uri="{FF2B5EF4-FFF2-40B4-BE49-F238E27FC236}">
                      <a16:creationId xmlns:a16="http://schemas.microsoft.com/office/drawing/2014/main" id="{11AF54DC-F598-4288-9419-0A7454B21D98}"/>
                    </a:ext>
                  </a:extLst>
                </p:cNvPr>
                <p:cNvSpPr>
                  <a:spLocks noChangeArrowheads="1"/>
                </p:cNvSpPr>
                <p:nvPr/>
              </p:nvSpPr>
              <p:spPr bwMode="auto">
                <a:xfrm>
                  <a:off x="3282416" y="4079783"/>
                  <a:ext cx="7573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4G39170</a:t>
                  </a:r>
                  <a:endParaRPr kumimoji="0" lang="en-US" altLang="en-US" sz="1200" b="0" i="0" u="none" strike="noStrike" cap="none" normalizeH="0" baseline="0" dirty="0">
                    <a:ln>
                      <a:noFill/>
                    </a:ln>
                    <a:solidFill>
                      <a:schemeClr val="tx1"/>
                    </a:solidFill>
                    <a:effectLst/>
                  </a:endParaRPr>
                </a:p>
              </p:txBody>
            </p:sp>
            <p:sp>
              <p:nvSpPr>
                <p:cNvPr id="305" name="Rectangle 76">
                  <a:extLst>
                    <a:ext uri="{FF2B5EF4-FFF2-40B4-BE49-F238E27FC236}">
                      <a16:creationId xmlns:a16="http://schemas.microsoft.com/office/drawing/2014/main" id="{751600EB-1272-48F8-938A-2DECB24AFDBA}"/>
                    </a:ext>
                  </a:extLst>
                </p:cNvPr>
                <p:cNvSpPr>
                  <a:spLocks noChangeArrowheads="1"/>
                </p:cNvSpPr>
                <p:nvPr/>
              </p:nvSpPr>
              <p:spPr bwMode="auto">
                <a:xfrm>
                  <a:off x="3282416" y="4290922"/>
                  <a:ext cx="7573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3G55940</a:t>
                  </a:r>
                  <a:endParaRPr kumimoji="0" lang="en-US" altLang="en-US" sz="1200" b="0" i="0" u="none" strike="noStrike" cap="none" normalizeH="0" baseline="0" dirty="0">
                    <a:ln>
                      <a:noFill/>
                    </a:ln>
                    <a:solidFill>
                      <a:schemeClr val="tx1"/>
                    </a:solidFill>
                    <a:effectLst/>
                  </a:endParaRPr>
                </a:p>
              </p:txBody>
            </p:sp>
            <p:sp>
              <p:nvSpPr>
                <p:cNvPr id="307" name="Rectangle 78">
                  <a:extLst>
                    <a:ext uri="{FF2B5EF4-FFF2-40B4-BE49-F238E27FC236}">
                      <a16:creationId xmlns:a16="http://schemas.microsoft.com/office/drawing/2014/main" id="{D8DDB1A0-88AE-4B67-BAD0-A7BF2D23BF42}"/>
                    </a:ext>
                  </a:extLst>
                </p:cNvPr>
                <p:cNvSpPr>
                  <a:spLocks noChangeArrowheads="1"/>
                </p:cNvSpPr>
                <p:nvPr/>
              </p:nvSpPr>
              <p:spPr bwMode="auto">
                <a:xfrm>
                  <a:off x="3282416" y="4504443"/>
                  <a:ext cx="7573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5G04510</a:t>
                  </a:r>
                  <a:endParaRPr kumimoji="0" lang="en-US" altLang="en-US" sz="1200" b="0" i="0" u="none" strike="noStrike" cap="none" normalizeH="0" baseline="0" dirty="0">
                    <a:ln>
                      <a:noFill/>
                    </a:ln>
                    <a:solidFill>
                      <a:schemeClr val="tx1"/>
                    </a:solidFill>
                    <a:effectLst/>
                  </a:endParaRPr>
                </a:p>
              </p:txBody>
            </p:sp>
            <p:sp>
              <p:nvSpPr>
                <p:cNvPr id="309" name="Rectangle 80">
                  <a:extLst>
                    <a:ext uri="{FF2B5EF4-FFF2-40B4-BE49-F238E27FC236}">
                      <a16:creationId xmlns:a16="http://schemas.microsoft.com/office/drawing/2014/main" id="{38F276F2-B15D-4786-9F4B-7BED8F2CD0E4}"/>
                    </a:ext>
                  </a:extLst>
                </p:cNvPr>
                <p:cNvSpPr>
                  <a:spLocks noChangeArrowheads="1"/>
                </p:cNvSpPr>
                <p:nvPr/>
              </p:nvSpPr>
              <p:spPr bwMode="auto">
                <a:xfrm>
                  <a:off x="3282416" y="4717963"/>
                  <a:ext cx="7573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3G07960</a:t>
                  </a:r>
                  <a:endParaRPr kumimoji="0" lang="en-US" altLang="en-US" sz="1200" b="0" i="0" u="none" strike="noStrike" cap="none" normalizeH="0" baseline="0" dirty="0">
                    <a:ln>
                      <a:noFill/>
                    </a:ln>
                    <a:solidFill>
                      <a:schemeClr val="tx1"/>
                    </a:solidFill>
                    <a:effectLst/>
                  </a:endParaRPr>
                </a:p>
              </p:txBody>
            </p:sp>
            <p:sp>
              <p:nvSpPr>
                <p:cNvPr id="311" name="Rectangle 82">
                  <a:extLst>
                    <a:ext uri="{FF2B5EF4-FFF2-40B4-BE49-F238E27FC236}">
                      <a16:creationId xmlns:a16="http://schemas.microsoft.com/office/drawing/2014/main" id="{46E6B046-B102-4415-9C94-B8CE9BE3DED2}"/>
                    </a:ext>
                  </a:extLst>
                </p:cNvPr>
                <p:cNvSpPr>
                  <a:spLocks noChangeArrowheads="1"/>
                </p:cNvSpPr>
                <p:nvPr/>
              </p:nvSpPr>
              <p:spPr bwMode="auto">
                <a:xfrm>
                  <a:off x="3282416" y="4927517"/>
                  <a:ext cx="7573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3G47220</a:t>
                  </a:r>
                  <a:endParaRPr kumimoji="0" lang="en-US" altLang="en-US" sz="1200" b="0" i="0" u="none" strike="noStrike" cap="none" normalizeH="0" baseline="0" dirty="0">
                    <a:ln>
                      <a:noFill/>
                    </a:ln>
                    <a:solidFill>
                      <a:schemeClr val="tx1"/>
                    </a:solidFill>
                    <a:effectLst/>
                  </a:endParaRPr>
                </a:p>
              </p:txBody>
            </p:sp>
            <p:sp>
              <p:nvSpPr>
                <p:cNvPr id="313" name="Rectangle 84">
                  <a:extLst>
                    <a:ext uri="{FF2B5EF4-FFF2-40B4-BE49-F238E27FC236}">
                      <a16:creationId xmlns:a16="http://schemas.microsoft.com/office/drawing/2014/main" id="{6E50D59E-4B40-40AC-A580-67176C4E4B26}"/>
                    </a:ext>
                  </a:extLst>
                </p:cNvPr>
                <p:cNvSpPr>
                  <a:spLocks noChangeArrowheads="1"/>
                </p:cNvSpPr>
                <p:nvPr/>
              </p:nvSpPr>
              <p:spPr bwMode="auto">
                <a:xfrm>
                  <a:off x="3282416" y="5148180"/>
                  <a:ext cx="7573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5G58670</a:t>
                  </a:r>
                  <a:endParaRPr kumimoji="0" lang="en-US" altLang="en-US" sz="1200" b="0" i="0" u="none" strike="noStrike" cap="none" normalizeH="0" baseline="0" dirty="0">
                    <a:ln>
                      <a:noFill/>
                    </a:ln>
                    <a:solidFill>
                      <a:schemeClr val="tx1"/>
                    </a:solidFill>
                    <a:effectLst/>
                  </a:endParaRPr>
                </a:p>
              </p:txBody>
            </p:sp>
            <p:sp>
              <p:nvSpPr>
                <p:cNvPr id="315" name="Rectangle 86">
                  <a:extLst>
                    <a:ext uri="{FF2B5EF4-FFF2-40B4-BE49-F238E27FC236}">
                      <a16:creationId xmlns:a16="http://schemas.microsoft.com/office/drawing/2014/main" id="{8CA6B247-95A8-4E9E-8319-2E5926E47BAA}"/>
                    </a:ext>
                  </a:extLst>
                </p:cNvPr>
                <p:cNvSpPr>
                  <a:spLocks noChangeArrowheads="1"/>
                </p:cNvSpPr>
                <p:nvPr/>
              </p:nvSpPr>
              <p:spPr bwMode="auto">
                <a:xfrm>
                  <a:off x="3282416" y="5359320"/>
                  <a:ext cx="7573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rPr>
                    <a:t> AT1G05470</a:t>
                  </a:r>
                  <a:endParaRPr kumimoji="0" lang="en-US" altLang="en-US" sz="1200" b="0" i="0" u="none" strike="noStrike" cap="none" normalizeH="0" baseline="0" dirty="0">
                    <a:ln>
                      <a:noFill/>
                    </a:ln>
                    <a:solidFill>
                      <a:schemeClr val="tx1"/>
                    </a:solidFill>
                    <a:effectLst/>
                  </a:endParaRPr>
                </a:p>
              </p:txBody>
            </p:sp>
          </p:grpSp>
          <p:grpSp>
            <p:nvGrpSpPr>
              <p:cNvPr id="343" name="Group 342">
                <a:extLst>
                  <a:ext uri="{FF2B5EF4-FFF2-40B4-BE49-F238E27FC236}">
                    <a16:creationId xmlns:a16="http://schemas.microsoft.com/office/drawing/2014/main" id="{9C9B559B-0701-478D-AB45-0BE6513BBE67}"/>
                  </a:ext>
                </a:extLst>
              </p:cNvPr>
              <p:cNvGrpSpPr/>
              <p:nvPr/>
            </p:nvGrpSpPr>
            <p:grpSpPr>
              <a:xfrm>
                <a:off x="3767573" y="715944"/>
                <a:ext cx="568056" cy="3863286"/>
                <a:chOff x="4130988" y="1679121"/>
                <a:chExt cx="568056" cy="3863286"/>
              </a:xfrm>
            </p:grpSpPr>
            <p:sp>
              <p:nvSpPr>
                <p:cNvPr id="7" name="Rectangle 178">
                  <a:extLst>
                    <a:ext uri="{FF2B5EF4-FFF2-40B4-BE49-F238E27FC236}">
                      <a16:creationId xmlns:a16="http://schemas.microsoft.com/office/drawing/2014/main" id="{96C85427-1D6E-4387-948D-55591E1E8325}"/>
                    </a:ext>
                  </a:extLst>
                </p:cNvPr>
                <p:cNvSpPr>
                  <a:spLocks noChangeArrowheads="1"/>
                </p:cNvSpPr>
                <p:nvPr/>
              </p:nvSpPr>
              <p:spPr bwMode="auto">
                <a:xfrm>
                  <a:off x="4136175" y="1679121"/>
                  <a:ext cx="33470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200" b="1" dirty="0">
                      <a:solidFill>
                        <a:srgbClr val="000000"/>
                      </a:solidFill>
                      <a:latin typeface=" Calibri "/>
                    </a:rPr>
                    <a:t>Gene</a:t>
                  </a:r>
                  <a:endParaRPr kumimoji="0" lang="en-US" altLang="en-US" sz="1200" b="1" i="0" u="none" strike="noStrike" cap="none" normalizeH="0" baseline="0" dirty="0">
                    <a:ln>
                      <a:noFill/>
                    </a:ln>
                    <a:solidFill>
                      <a:schemeClr val="tx1"/>
                    </a:solidFill>
                    <a:effectLst/>
                    <a:latin typeface=" Calibri "/>
                  </a:endParaRPr>
                </a:p>
              </p:txBody>
            </p:sp>
            <p:sp>
              <p:nvSpPr>
                <p:cNvPr id="26" name="Rectangle 6">
                  <a:extLst>
                    <a:ext uri="{FF2B5EF4-FFF2-40B4-BE49-F238E27FC236}">
                      <a16:creationId xmlns:a16="http://schemas.microsoft.com/office/drawing/2014/main" id="{A2DCAE6E-ADB5-45E7-8FC0-AD2618C15CEC}"/>
                    </a:ext>
                  </a:extLst>
                </p:cNvPr>
                <p:cNvSpPr>
                  <a:spLocks noChangeArrowheads="1"/>
                </p:cNvSpPr>
                <p:nvPr/>
              </p:nvSpPr>
              <p:spPr bwMode="auto">
                <a:xfrm>
                  <a:off x="4136698" y="1942684"/>
                  <a:ext cx="3366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PHdp</a:t>
                  </a:r>
                  <a:endParaRPr kumimoji="0" lang="en-US" altLang="en-US" sz="1200" b="0" i="1" u="none" strike="noStrike" cap="none" normalizeH="0" baseline="0" dirty="0">
                    <a:ln>
                      <a:noFill/>
                    </a:ln>
                    <a:solidFill>
                      <a:schemeClr val="tx1"/>
                    </a:solidFill>
                    <a:effectLst/>
                  </a:endParaRPr>
                </a:p>
              </p:txBody>
            </p:sp>
            <p:sp>
              <p:nvSpPr>
                <p:cNvPr id="28" name="Rectangle 8">
                  <a:extLst>
                    <a:ext uri="{FF2B5EF4-FFF2-40B4-BE49-F238E27FC236}">
                      <a16:creationId xmlns:a16="http://schemas.microsoft.com/office/drawing/2014/main" id="{E081905C-B129-41D3-8EE2-5DFCEA946BD2}"/>
                    </a:ext>
                  </a:extLst>
                </p:cNvPr>
                <p:cNvSpPr>
                  <a:spLocks noChangeArrowheads="1"/>
                </p:cNvSpPr>
                <p:nvPr/>
              </p:nvSpPr>
              <p:spPr bwMode="auto">
                <a:xfrm>
                  <a:off x="4146655" y="2158743"/>
                  <a:ext cx="3643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ACX2 </a:t>
                  </a:r>
                  <a:endParaRPr kumimoji="0" lang="en-US" altLang="en-US" sz="1200" b="0" i="1" u="none" strike="noStrike" cap="none" normalizeH="0" baseline="0" dirty="0">
                    <a:ln>
                      <a:noFill/>
                    </a:ln>
                    <a:solidFill>
                      <a:schemeClr val="tx1"/>
                    </a:solidFill>
                    <a:effectLst/>
                  </a:endParaRPr>
                </a:p>
              </p:txBody>
            </p:sp>
            <p:sp>
              <p:nvSpPr>
                <p:cNvPr id="30" name="Rectangle 10">
                  <a:extLst>
                    <a:ext uri="{FF2B5EF4-FFF2-40B4-BE49-F238E27FC236}">
                      <a16:creationId xmlns:a16="http://schemas.microsoft.com/office/drawing/2014/main" id="{0116732A-877A-464C-8BD4-386573FD4615}"/>
                    </a:ext>
                  </a:extLst>
                </p:cNvPr>
                <p:cNvSpPr>
                  <a:spLocks noChangeArrowheads="1"/>
                </p:cNvSpPr>
                <p:nvPr/>
              </p:nvSpPr>
              <p:spPr bwMode="auto">
                <a:xfrm>
                  <a:off x="4148237" y="2376548"/>
                  <a:ext cx="3659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ACC1 </a:t>
                  </a:r>
                  <a:endParaRPr kumimoji="0" lang="en-US" altLang="en-US" sz="1200" b="0" i="1" u="none" strike="noStrike" cap="none" normalizeH="0" baseline="0" dirty="0">
                    <a:ln>
                      <a:noFill/>
                    </a:ln>
                    <a:solidFill>
                      <a:schemeClr val="tx1"/>
                    </a:solidFill>
                    <a:effectLst/>
                  </a:endParaRPr>
                </a:p>
              </p:txBody>
            </p:sp>
            <p:sp>
              <p:nvSpPr>
                <p:cNvPr id="32" name="Rectangle 12">
                  <a:extLst>
                    <a:ext uri="{FF2B5EF4-FFF2-40B4-BE49-F238E27FC236}">
                      <a16:creationId xmlns:a16="http://schemas.microsoft.com/office/drawing/2014/main" id="{59A2F765-779B-467C-B8DE-4C6224A50788}"/>
                    </a:ext>
                  </a:extLst>
                </p:cNvPr>
                <p:cNvSpPr>
                  <a:spLocks noChangeArrowheads="1"/>
                </p:cNvSpPr>
                <p:nvPr/>
              </p:nvSpPr>
              <p:spPr bwMode="auto">
                <a:xfrm>
                  <a:off x="4136819" y="2585145"/>
                  <a:ext cx="47448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MEE23 </a:t>
                  </a:r>
                  <a:endParaRPr kumimoji="0" lang="en-US" altLang="en-US" sz="1200" b="0" i="1" u="none" strike="noStrike" cap="none" normalizeH="0" baseline="0" dirty="0">
                    <a:ln>
                      <a:noFill/>
                    </a:ln>
                    <a:solidFill>
                      <a:schemeClr val="tx1"/>
                    </a:solidFill>
                    <a:effectLst/>
                  </a:endParaRPr>
                </a:p>
              </p:txBody>
            </p:sp>
            <p:sp>
              <p:nvSpPr>
                <p:cNvPr id="34" name="Rectangle 14">
                  <a:extLst>
                    <a:ext uri="{FF2B5EF4-FFF2-40B4-BE49-F238E27FC236}">
                      <a16:creationId xmlns:a16="http://schemas.microsoft.com/office/drawing/2014/main" id="{257E49AF-240F-4C76-8E58-6088EAD7C52F}"/>
                    </a:ext>
                  </a:extLst>
                </p:cNvPr>
                <p:cNvSpPr>
                  <a:spLocks noChangeArrowheads="1"/>
                </p:cNvSpPr>
                <p:nvPr/>
              </p:nvSpPr>
              <p:spPr bwMode="auto">
                <a:xfrm>
                  <a:off x="4133948" y="2798505"/>
                  <a:ext cx="3659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CAC1 </a:t>
                  </a:r>
                  <a:endParaRPr kumimoji="0" lang="en-US" altLang="en-US" sz="1200" b="0" i="1" u="none" strike="noStrike" cap="none" normalizeH="0" baseline="0" dirty="0">
                    <a:ln>
                      <a:noFill/>
                    </a:ln>
                    <a:solidFill>
                      <a:schemeClr val="tx1"/>
                    </a:solidFill>
                    <a:effectLst/>
                  </a:endParaRPr>
                </a:p>
              </p:txBody>
            </p:sp>
            <p:sp>
              <p:nvSpPr>
                <p:cNvPr id="36" name="Rectangle 16">
                  <a:extLst>
                    <a:ext uri="{FF2B5EF4-FFF2-40B4-BE49-F238E27FC236}">
                      <a16:creationId xmlns:a16="http://schemas.microsoft.com/office/drawing/2014/main" id="{8F07116D-EB94-4813-96FE-7E5AEA594EFD}"/>
                    </a:ext>
                  </a:extLst>
                </p:cNvPr>
                <p:cNvSpPr>
                  <a:spLocks noChangeArrowheads="1"/>
                </p:cNvSpPr>
                <p:nvPr/>
              </p:nvSpPr>
              <p:spPr bwMode="auto">
                <a:xfrm>
                  <a:off x="4130988" y="3009008"/>
                  <a:ext cx="53059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GDSLmp</a:t>
                  </a:r>
                  <a:endParaRPr kumimoji="0" lang="en-US" altLang="en-US" sz="1200" b="0" i="1" u="none" strike="noStrike" cap="none" normalizeH="0" baseline="0" dirty="0">
                    <a:ln>
                      <a:noFill/>
                    </a:ln>
                    <a:solidFill>
                      <a:schemeClr val="tx1"/>
                    </a:solidFill>
                    <a:effectLst/>
                  </a:endParaRPr>
                </a:p>
              </p:txBody>
            </p:sp>
            <p:sp>
              <p:nvSpPr>
                <p:cNvPr id="38" name="Rectangle 18">
                  <a:extLst>
                    <a:ext uri="{FF2B5EF4-FFF2-40B4-BE49-F238E27FC236}">
                      <a16:creationId xmlns:a16="http://schemas.microsoft.com/office/drawing/2014/main" id="{80F42AE3-F09C-4FC7-8270-EE3E632F75BB}"/>
                    </a:ext>
                  </a:extLst>
                </p:cNvPr>
                <p:cNvSpPr>
                  <a:spLocks noChangeArrowheads="1"/>
                </p:cNvSpPr>
                <p:nvPr/>
              </p:nvSpPr>
              <p:spPr bwMode="auto">
                <a:xfrm>
                  <a:off x="4136389" y="3225860"/>
                  <a:ext cx="56265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HXXXDtp</a:t>
                  </a:r>
                  <a:endParaRPr kumimoji="0" lang="en-US" altLang="en-US" sz="1200" b="0" i="1" u="none" strike="noStrike" cap="none" normalizeH="0" baseline="0" dirty="0">
                    <a:ln>
                      <a:noFill/>
                    </a:ln>
                    <a:solidFill>
                      <a:schemeClr val="tx1"/>
                    </a:solidFill>
                    <a:effectLst/>
                  </a:endParaRPr>
                </a:p>
              </p:txBody>
            </p:sp>
            <p:sp>
              <p:nvSpPr>
                <p:cNvPr id="40" name="Rectangle 20">
                  <a:extLst>
                    <a:ext uri="{FF2B5EF4-FFF2-40B4-BE49-F238E27FC236}">
                      <a16:creationId xmlns:a16="http://schemas.microsoft.com/office/drawing/2014/main" id="{4BBC34B1-56FE-44F9-9CEE-99CE7F4F1AAE}"/>
                    </a:ext>
                  </a:extLst>
                </p:cNvPr>
                <p:cNvSpPr>
                  <a:spLocks noChangeArrowheads="1"/>
                </p:cNvSpPr>
                <p:nvPr/>
              </p:nvSpPr>
              <p:spPr bwMode="auto">
                <a:xfrm>
                  <a:off x="4136175" y="3439220"/>
                  <a:ext cx="39767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SHESt </a:t>
                  </a:r>
                  <a:endParaRPr kumimoji="0" lang="en-US" altLang="en-US" sz="1200" b="0" i="1" u="none" strike="noStrike" cap="none" normalizeH="0" baseline="0" dirty="0">
                    <a:ln>
                      <a:noFill/>
                    </a:ln>
                    <a:solidFill>
                      <a:schemeClr val="tx1"/>
                    </a:solidFill>
                    <a:effectLst/>
                  </a:endParaRPr>
                </a:p>
              </p:txBody>
            </p:sp>
            <p:sp>
              <p:nvSpPr>
                <p:cNvPr id="42" name="Rectangle 22">
                  <a:extLst>
                    <a:ext uri="{FF2B5EF4-FFF2-40B4-BE49-F238E27FC236}">
                      <a16:creationId xmlns:a16="http://schemas.microsoft.com/office/drawing/2014/main" id="{6D7B2159-95C5-4497-A8CD-471E7927E9BE}"/>
                    </a:ext>
                  </a:extLst>
                </p:cNvPr>
                <p:cNvSpPr>
                  <a:spLocks noChangeArrowheads="1"/>
                </p:cNvSpPr>
                <p:nvPr/>
              </p:nvSpPr>
              <p:spPr bwMode="auto">
                <a:xfrm>
                  <a:off x="4138984" y="3656708"/>
                  <a:ext cx="35586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pMLP</a:t>
                  </a:r>
                  <a:endParaRPr kumimoji="0" lang="en-US" altLang="en-US" sz="1200" b="0" i="1" u="none" strike="noStrike" cap="none" normalizeH="0" baseline="0" dirty="0">
                    <a:ln>
                      <a:noFill/>
                    </a:ln>
                    <a:solidFill>
                      <a:schemeClr val="tx1"/>
                    </a:solidFill>
                    <a:effectLst/>
                  </a:endParaRPr>
                </a:p>
              </p:txBody>
            </p:sp>
            <p:sp>
              <p:nvSpPr>
                <p:cNvPr id="44" name="Rectangle 24">
                  <a:extLst>
                    <a:ext uri="{FF2B5EF4-FFF2-40B4-BE49-F238E27FC236}">
                      <a16:creationId xmlns:a16="http://schemas.microsoft.com/office/drawing/2014/main" id="{F61C8E59-E92A-424A-AF47-974754FE714A}"/>
                    </a:ext>
                  </a:extLst>
                </p:cNvPr>
                <p:cNvSpPr>
                  <a:spLocks noChangeArrowheads="1"/>
                </p:cNvSpPr>
                <p:nvPr/>
              </p:nvSpPr>
              <p:spPr bwMode="auto">
                <a:xfrm>
                  <a:off x="4138478" y="3864035"/>
                  <a:ext cx="36163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FAH2 </a:t>
                  </a:r>
                  <a:endParaRPr kumimoji="0" lang="en-US" altLang="en-US" sz="1200" b="0" i="1" u="none" strike="noStrike" cap="none" normalizeH="0" baseline="0" dirty="0">
                    <a:ln>
                      <a:noFill/>
                    </a:ln>
                    <a:solidFill>
                      <a:schemeClr val="tx1"/>
                    </a:solidFill>
                    <a:effectLst/>
                  </a:endParaRPr>
                </a:p>
              </p:txBody>
            </p:sp>
            <p:sp>
              <p:nvSpPr>
                <p:cNvPr id="304" name="Rectangle 75">
                  <a:extLst>
                    <a:ext uri="{FF2B5EF4-FFF2-40B4-BE49-F238E27FC236}">
                      <a16:creationId xmlns:a16="http://schemas.microsoft.com/office/drawing/2014/main" id="{02B5066A-5077-4DC1-A59B-E6733214B7A2}"/>
                    </a:ext>
                  </a:extLst>
                </p:cNvPr>
                <p:cNvSpPr>
                  <a:spLocks noChangeArrowheads="1"/>
                </p:cNvSpPr>
                <p:nvPr/>
              </p:nvSpPr>
              <p:spPr bwMode="auto">
                <a:xfrm>
                  <a:off x="4140596" y="4070278"/>
                  <a:ext cx="51456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Sec14pL</a:t>
                  </a:r>
                  <a:endParaRPr kumimoji="0" lang="en-US" altLang="en-US" sz="1200" b="0" i="1" u="none" strike="noStrike" cap="none" normalizeH="0" baseline="0" dirty="0">
                    <a:ln>
                      <a:noFill/>
                    </a:ln>
                    <a:solidFill>
                      <a:schemeClr val="tx1"/>
                    </a:solidFill>
                    <a:effectLst/>
                  </a:endParaRPr>
                </a:p>
              </p:txBody>
            </p:sp>
            <p:sp>
              <p:nvSpPr>
                <p:cNvPr id="306" name="Rectangle 77">
                  <a:extLst>
                    <a:ext uri="{FF2B5EF4-FFF2-40B4-BE49-F238E27FC236}">
                      <a16:creationId xmlns:a16="http://schemas.microsoft.com/office/drawing/2014/main" id="{2403E2F3-65F7-466C-87F1-D9CBAA0B5DAD}"/>
                    </a:ext>
                  </a:extLst>
                </p:cNvPr>
                <p:cNvSpPr>
                  <a:spLocks noChangeArrowheads="1"/>
                </p:cNvSpPr>
                <p:nvPr/>
              </p:nvSpPr>
              <p:spPr bwMode="auto">
                <a:xfrm>
                  <a:off x="4142494" y="4294116"/>
                  <a:ext cx="33816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PLC7 </a:t>
                  </a:r>
                  <a:endParaRPr kumimoji="0" lang="en-US" altLang="en-US" sz="1200" b="0" i="1" u="none" strike="noStrike" cap="none" normalizeH="0" baseline="0" dirty="0">
                    <a:ln>
                      <a:noFill/>
                    </a:ln>
                    <a:solidFill>
                      <a:schemeClr val="tx1"/>
                    </a:solidFill>
                    <a:effectLst/>
                  </a:endParaRPr>
                </a:p>
              </p:txBody>
            </p:sp>
            <p:sp>
              <p:nvSpPr>
                <p:cNvPr id="308" name="Rectangle 79">
                  <a:extLst>
                    <a:ext uri="{FF2B5EF4-FFF2-40B4-BE49-F238E27FC236}">
                      <a16:creationId xmlns:a16="http://schemas.microsoft.com/office/drawing/2014/main" id="{51D70088-3069-4EF7-8E3D-355374C0B948}"/>
                    </a:ext>
                  </a:extLst>
                </p:cNvPr>
                <p:cNvSpPr>
                  <a:spLocks noChangeArrowheads="1"/>
                </p:cNvSpPr>
                <p:nvPr/>
              </p:nvSpPr>
              <p:spPr bwMode="auto">
                <a:xfrm>
                  <a:off x="4147258" y="4508428"/>
                  <a:ext cx="36869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PDK1 </a:t>
                  </a:r>
                  <a:endParaRPr kumimoji="0" lang="en-US" altLang="en-US" sz="1200" b="0" i="1" u="none" strike="noStrike" cap="none" normalizeH="0" baseline="0" dirty="0">
                    <a:ln>
                      <a:noFill/>
                    </a:ln>
                    <a:solidFill>
                      <a:schemeClr val="tx1"/>
                    </a:solidFill>
                    <a:effectLst/>
                  </a:endParaRPr>
                </a:p>
              </p:txBody>
            </p:sp>
            <p:sp>
              <p:nvSpPr>
                <p:cNvPr id="310" name="Rectangle 81">
                  <a:extLst>
                    <a:ext uri="{FF2B5EF4-FFF2-40B4-BE49-F238E27FC236}">
                      <a16:creationId xmlns:a16="http://schemas.microsoft.com/office/drawing/2014/main" id="{465BBB42-9771-45CB-B8B6-3BAE436AAE3B}"/>
                    </a:ext>
                  </a:extLst>
                </p:cNvPr>
                <p:cNvSpPr>
                  <a:spLocks noChangeArrowheads="1"/>
                </p:cNvSpPr>
                <p:nvPr/>
              </p:nvSpPr>
              <p:spPr bwMode="auto">
                <a:xfrm>
                  <a:off x="4147262" y="4722741"/>
                  <a:ext cx="43601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PIP5K6</a:t>
                  </a:r>
                  <a:endParaRPr kumimoji="0" lang="en-US" altLang="en-US" sz="1200" b="0" i="1" u="none" strike="noStrike" cap="none" normalizeH="0" baseline="0" dirty="0">
                    <a:ln>
                      <a:noFill/>
                    </a:ln>
                    <a:solidFill>
                      <a:schemeClr val="tx1"/>
                    </a:solidFill>
                    <a:effectLst/>
                  </a:endParaRPr>
                </a:p>
              </p:txBody>
            </p:sp>
            <p:sp>
              <p:nvSpPr>
                <p:cNvPr id="312" name="Rectangle 83">
                  <a:extLst>
                    <a:ext uri="{FF2B5EF4-FFF2-40B4-BE49-F238E27FC236}">
                      <a16:creationId xmlns:a16="http://schemas.microsoft.com/office/drawing/2014/main" id="{AE48F6BF-5FA2-4B52-A9D1-D6DDC687B319}"/>
                    </a:ext>
                  </a:extLst>
                </p:cNvPr>
                <p:cNvSpPr>
                  <a:spLocks noChangeArrowheads="1"/>
                </p:cNvSpPr>
                <p:nvPr/>
              </p:nvSpPr>
              <p:spPr bwMode="auto">
                <a:xfrm>
                  <a:off x="4156783" y="4932291"/>
                  <a:ext cx="33816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PLC9 </a:t>
                  </a:r>
                  <a:endParaRPr kumimoji="0" lang="en-US" altLang="en-US" sz="1200" b="0" i="1" u="none" strike="noStrike" cap="none" normalizeH="0" baseline="0" dirty="0">
                    <a:ln>
                      <a:noFill/>
                    </a:ln>
                    <a:solidFill>
                      <a:schemeClr val="tx1"/>
                    </a:solidFill>
                    <a:effectLst/>
                  </a:endParaRPr>
                </a:p>
              </p:txBody>
            </p:sp>
            <p:sp>
              <p:nvSpPr>
                <p:cNvPr id="314" name="Rectangle 85">
                  <a:extLst>
                    <a:ext uri="{FF2B5EF4-FFF2-40B4-BE49-F238E27FC236}">
                      <a16:creationId xmlns:a16="http://schemas.microsoft.com/office/drawing/2014/main" id="{85B57068-148E-46AC-BC29-7B1820A2C4F6}"/>
                    </a:ext>
                  </a:extLst>
                </p:cNvPr>
                <p:cNvSpPr>
                  <a:spLocks noChangeArrowheads="1"/>
                </p:cNvSpPr>
                <p:nvPr/>
              </p:nvSpPr>
              <p:spPr bwMode="auto">
                <a:xfrm>
                  <a:off x="4161546" y="5146603"/>
                  <a:ext cx="33816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PLC1 </a:t>
                  </a:r>
                  <a:endParaRPr kumimoji="0" lang="en-US" altLang="en-US" sz="1200" b="0" i="1" u="none" strike="noStrike" cap="none" normalizeH="0" baseline="0" dirty="0">
                    <a:ln>
                      <a:noFill/>
                    </a:ln>
                    <a:solidFill>
                      <a:schemeClr val="tx1"/>
                    </a:solidFill>
                    <a:effectLst/>
                  </a:endParaRPr>
                </a:p>
              </p:txBody>
            </p:sp>
            <p:sp>
              <p:nvSpPr>
                <p:cNvPr id="316" name="Rectangle 87">
                  <a:extLst>
                    <a:ext uri="{FF2B5EF4-FFF2-40B4-BE49-F238E27FC236}">
                      <a16:creationId xmlns:a16="http://schemas.microsoft.com/office/drawing/2014/main" id="{4E5327BD-9A8E-4E48-9993-EB358349ECCC}"/>
                    </a:ext>
                  </a:extLst>
                </p:cNvPr>
                <p:cNvSpPr>
                  <a:spLocks noChangeArrowheads="1"/>
                </p:cNvSpPr>
                <p:nvPr/>
              </p:nvSpPr>
              <p:spPr bwMode="auto">
                <a:xfrm>
                  <a:off x="4161547" y="5357741"/>
                  <a:ext cx="362279"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rPr>
                    <a:t>CVP2 </a:t>
                  </a:r>
                  <a:endParaRPr kumimoji="0" lang="en-US" altLang="en-US" sz="1200" b="0" i="1" u="none" strike="noStrike" cap="none" normalizeH="0" baseline="0" dirty="0">
                    <a:ln>
                      <a:noFill/>
                    </a:ln>
                    <a:solidFill>
                      <a:schemeClr val="tx1"/>
                    </a:solidFill>
                    <a:effectLst/>
                  </a:endParaRPr>
                </a:p>
              </p:txBody>
            </p:sp>
          </p:grpSp>
          <p:grpSp>
            <p:nvGrpSpPr>
              <p:cNvPr id="359" name="Group 358">
                <a:extLst>
                  <a:ext uri="{FF2B5EF4-FFF2-40B4-BE49-F238E27FC236}">
                    <a16:creationId xmlns:a16="http://schemas.microsoft.com/office/drawing/2014/main" id="{272C2C14-7D9A-4DC6-A554-B4041D3E7151}"/>
                  </a:ext>
                </a:extLst>
              </p:cNvPr>
              <p:cNvGrpSpPr/>
              <p:nvPr/>
            </p:nvGrpSpPr>
            <p:grpSpPr>
              <a:xfrm>
                <a:off x="4453868" y="759719"/>
                <a:ext cx="1483471" cy="3820346"/>
                <a:chOff x="4453868" y="759719"/>
                <a:chExt cx="1483471" cy="3820346"/>
              </a:xfrm>
            </p:grpSpPr>
            <p:grpSp>
              <p:nvGrpSpPr>
                <p:cNvPr id="357" name="Group 356">
                  <a:extLst>
                    <a:ext uri="{FF2B5EF4-FFF2-40B4-BE49-F238E27FC236}">
                      <a16:creationId xmlns:a16="http://schemas.microsoft.com/office/drawing/2014/main" id="{0C7E8DCF-2EE0-42EE-BFF0-2B75E154BBD9}"/>
                    </a:ext>
                  </a:extLst>
                </p:cNvPr>
                <p:cNvGrpSpPr/>
                <p:nvPr/>
              </p:nvGrpSpPr>
              <p:grpSpPr>
                <a:xfrm>
                  <a:off x="4456080" y="3124507"/>
                  <a:ext cx="1286710" cy="180000"/>
                  <a:chOff x="3808062" y="3112602"/>
                  <a:chExt cx="1286710" cy="180000"/>
                </a:xfrm>
              </p:grpSpPr>
              <p:sp>
                <p:nvSpPr>
                  <p:cNvPr id="13" name="Rectangle 5">
                    <a:extLst>
                      <a:ext uri="{FF2B5EF4-FFF2-40B4-BE49-F238E27FC236}">
                        <a16:creationId xmlns:a16="http://schemas.microsoft.com/office/drawing/2014/main" id="{4A72DA99-DF2D-4CE1-9AC7-C7DB6B9F62D6}"/>
                      </a:ext>
                    </a:extLst>
                  </p:cNvPr>
                  <p:cNvSpPr>
                    <a:spLocks noChangeArrowheads="1"/>
                  </p:cNvSpPr>
                  <p:nvPr/>
                </p:nvSpPr>
                <p:spPr bwMode="auto">
                  <a:xfrm>
                    <a:off x="3808062" y="3112602"/>
                    <a:ext cx="432000" cy="180000"/>
                  </a:xfrm>
                  <a:prstGeom prst="rect">
                    <a:avLst/>
                  </a:prstGeom>
                  <a:solidFill>
                    <a:srgbClr val="F9E9DE"/>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14" name="Rectangle 6">
                    <a:extLst>
                      <a:ext uri="{FF2B5EF4-FFF2-40B4-BE49-F238E27FC236}">
                        <a16:creationId xmlns:a16="http://schemas.microsoft.com/office/drawing/2014/main" id="{C45326E0-9259-4363-B75A-24F785468293}"/>
                      </a:ext>
                    </a:extLst>
                  </p:cNvPr>
                  <p:cNvSpPr>
                    <a:spLocks noChangeArrowheads="1"/>
                  </p:cNvSpPr>
                  <p:nvPr/>
                </p:nvSpPr>
                <p:spPr bwMode="auto">
                  <a:xfrm>
                    <a:off x="4235417" y="3112602"/>
                    <a:ext cx="432000" cy="180000"/>
                  </a:xfrm>
                  <a:prstGeom prst="rect">
                    <a:avLst/>
                  </a:prstGeom>
                  <a:solidFill>
                    <a:srgbClr val="F1CBB2"/>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5" name="Rectangle 7">
                    <a:extLst>
                      <a:ext uri="{FF2B5EF4-FFF2-40B4-BE49-F238E27FC236}">
                        <a16:creationId xmlns:a16="http://schemas.microsoft.com/office/drawing/2014/main" id="{9B3562D6-3FA2-4D38-BCFD-16E99DA62FB5}"/>
                      </a:ext>
                    </a:extLst>
                  </p:cNvPr>
                  <p:cNvSpPr>
                    <a:spLocks noChangeArrowheads="1"/>
                  </p:cNvSpPr>
                  <p:nvPr/>
                </p:nvSpPr>
                <p:spPr bwMode="auto">
                  <a:xfrm>
                    <a:off x="4662772" y="3112602"/>
                    <a:ext cx="432000" cy="180000"/>
                  </a:xfrm>
                  <a:prstGeom prst="rect">
                    <a:avLst/>
                  </a:prstGeom>
                  <a:solidFill>
                    <a:srgbClr val="F6DCC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grpSp>
            <p:grpSp>
              <p:nvGrpSpPr>
                <p:cNvPr id="351" name="Group 350">
                  <a:extLst>
                    <a:ext uri="{FF2B5EF4-FFF2-40B4-BE49-F238E27FC236}">
                      <a16:creationId xmlns:a16="http://schemas.microsoft.com/office/drawing/2014/main" id="{80EE3C93-28AA-4B59-9D73-B00DACC7D960}"/>
                    </a:ext>
                  </a:extLst>
                </p:cNvPr>
                <p:cNvGrpSpPr/>
                <p:nvPr/>
              </p:nvGrpSpPr>
              <p:grpSpPr>
                <a:xfrm>
                  <a:off x="4456080" y="3334852"/>
                  <a:ext cx="1286710" cy="180000"/>
                  <a:chOff x="3808062" y="3317390"/>
                  <a:chExt cx="1286710" cy="180000"/>
                </a:xfrm>
              </p:grpSpPr>
              <p:sp>
                <p:nvSpPr>
                  <p:cNvPr id="16" name="Rectangle 8">
                    <a:extLst>
                      <a:ext uri="{FF2B5EF4-FFF2-40B4-BE49-F238E27FC236}">
                        <a16:creationId xmlns:a16="http://schemas.microsoft.com/office/drawing/2014/main" id="{F39D7A16-20F5-494A-9640-4B2BD6002982}"/>
                      </a:ext>
                    </a:extLst>
                  </p:cNvPr>
                  <p:cNvSpPr>
                    <a:spLocks noChangeArrowheads="1"/>
                  </p:cNvSpPr>
                  <p:nvPr/>
                </p:nvSpPr>
                <p:spPr bwMode="auto">
                  <a:xfrm>
                    <a:off x="3808062" y="3317390"/>
                    <a:ext cx="432000" cy="180000"/>
                  </a:xfrm>
                  <a:prstGeom prst="rect">
                    <a:avLst/>
                  </a:prstGeom>
                  <a:solidFill>
                    <a:srgbClr val="C2E4CD"/>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7" name="Rectangle 9">
                    <a:extLst>
                      <a:ext uri="{FF2B5EF4-FFF2-40B4-BE49-F238E27FC236}">
                        <a16:creationId xmlns:a16="http://schemas.microsoft.com/office/drawing/2014/main" id="{EE1162E0-B8A9-4637-B7E2-275453EAB249}"/>
                      </a:ext>
                    </a:extLst>
                  </p:cNvPr>
                  <p:cNvSpPr>
                    <a:spLocks noChangeArrowheads="1"/>
                  </p:cNvSpPr>
                  <p:nvPr/>
                </p:nvSpPr>
                <p:spPr bwMode="auto">
                  <a:xfrm>
                    <a:off x="4235417" y="3317390"/>
                    <a:ext cx="432000" cy="180000"/>
                  </a:xfrm>
                  <a:prstGeom prst="rect">
                    <a:avLst/>
                  </a:prstGeom>
                  <a:solidFill>
                    <a:srgbClr val="F1C8AE"/>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8" name="Rectangle 10">
                    <a:extLst>
                      <a:ext uri="{FF2B5EF4-FFF2-40B4-BE49-F238E27FC236}">
                        <a16:creationId xmlns:a16="http://schemas.microsoft.com/office/drawing/2014/main" id="{2C01F0E4-9CAD-42CB-A55F-9055BC265AE7}"/>
                      </a:ext>
                    </a:extLst>
                  </p:cNvPr>
                  <p:cNvSpPr>
                    <a:spLocks noChangeArrowheads="1"/>
                  </p:cNvSpPr>
                  <p:nvPr/>
                </p:nvSpPr>
                <p:spPr bwMode="auto">
                  <a:xfrm>
                    <a:off x="4662772" y="3317390"/>
                    <a:ext cx="432000" cy="180000"/>
                  </a:xfrm>
                  <a:prstGeom prst="rect">
                    <a:avLst/>
                  </a:prstGeom>
                  <a:solidFill>
                    <a:srgbClr val="F6DBCA"/>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352" name="Group 351">
                  <a:extLst>
                    <a:ext uri="{FF2B5EF4-FFF2-40B4-BE49-F238E27FC236}">
                      <a16:creationId xmlns:a16="http://schemas.microsoft.com/office/drawing/2014/main" id="{22A838DB-3A77-47D6-97DE-B002C753C71B}"/>
                    </a:ext>
                  </a:extLst>
                </p:cNvPr>
                <p:cNvGrpSpPr/>
                <p:nvPr/>
              </p:nvGrpSpPr>
              <p:grpSpPr>
                <a:xfrm>
                  <a:off x="4454492" y="3552339"/>
                  <a:ext cx="1291949" cy="180000"/>
                  <a:chOff x="3802823" y="3534877"/>
                  <a:chExt cx="1291949" cy="180000"/>
                </a:xfrm>
              </p:grpSpPr>
              <p:sp>
                <p:nvSpPr>
                  <p:cNvPr id="19" name="Rectangle 11">
                    <a:extLst>
                      <a:ext uri="{FF2B5EF4-FFF2-40B4-BE49-F238E27FC236}">
                        <a16:creationId xmlns:a16="http://schemas.microsoft.com/office/drawing/2014/main" id="{D11D5E71-4D03-49FC-93C6-F3F018DEFEDD}"/>
                      </a:ext>
                    </a:extLst>
                  </p:cNvPr>
                  <p:cNvSpPr>
                    <a:spLocks noChangeArrowheads="1"/>
                  </p:cNvSpPr>
                  <p:nvPr/>
                </p:nvSpPr>
                <p:spPr bwMode="auto">
                  <a:xfrm>
                    <a:off x="3802823" y="3534877"/>
                    <a:ext cx="432000" cy="180000"/>
                  </a:xfrm>
                  <a:prstGeom prst="rect">
                    <a:avLst/>
                  </a:prstGeom>
                  <a:solidFill>
                    <a:srgbClr val="F6DBCA"/>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20" name="Rectangle 12">
                    <a:extLst>
                      <a:ext uri="{FF2B5EF4-FFF2-40B4-BE49-F238E27FC236}">
                        <a16:creationId xmlns:a16="http://schemas.microsoft.com/office/drawing/2014/main" id="{23E92A54-23B0-41C3-976D-952DC2BAF634}"/>
                      </a:ext>
                    </a:extLst>
                  </p:cNvPr>
                  <p:cNvSpPr>
                    <a:spLocks noChangeArrowheads="1"/>
                  </p:cNvSpPr>
                  <p:nvPr/>
                </p:nvSpPr>
                <p:spPr bwMode="auto">
                  <a:xfrm>
                    <a:off x="4235417" y="3534877"/>
                    <a:ext cx="432000" cy="180000"/>
                  </a:xfrm>
                  <a:prstGeom prst="rect">
                    <a:avLst/>
                  </a:prstGeom>
                  <a:solidFill>
                    <a:srgbClr val="F4D4BF"/>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22" name="Rectangle 13">
                    <a:extLst>
                      <a:ext uri="{FF2B5EF4-FFF2-40B4-BE49-F238E27FC236}">
                        <a16:creationId xmlns:a16="http://schemas.microsoft.com/office/drawing/2014/main" id="{5CDEE8CE-43DC-46D0-AB2B-0F0461F89B72}"/>
                      </a:ext>
                    </a:extLst>
                  </p:cNvPr>
                  <p:cNvSpPr>
                    <a:spLocks noChangeArrowheads="1"/>
                  </p:cNvSpPr>
                  <p:nvPr/>
                </p:nvSpPr>
                <p:spPr bwMode="auto">
                  <a:xfrm>
                    <a:off x="4662772" y="3534877"/>
                    <a:ext cx="432000" cy="180000"/>
                  </a:xfrm>
                  <a:prstGeom prst="rect">
                    <a:avLst/>
                  </a:prstGeom>
                  <a:solidFill>
                    <a:srgbClr val="F4D6C3"/>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353" name="Group 352">
                  <a:extLst>
                    <a:ext uri="{FF2B5EF4-FFF2-40B4-BE49-F238E27FC236}">
                      <a16:creationId xmlns:a16="http://schemas.microsoft.com/office/drawing/2014/main" id="{B96B1AD0-4913-4C91-8232-46D18FD2B8B5}"/>
                    </a:ext>
                  </a:extLst>
                </p:cNvPr>
                <p:cNvGrpSpPr/>
                <p:nvPr/>
              </p:nvGrpSpPr>
              <p:grpSpPr>
                <a:xfrm>
                  <a:off x="4457667" y="3763477"/>
                  <a:ext cx="1291949" cy="180000"/>
                  <a:chOff x="3802823" y="3739665"/>
                  <a:chExt cx="1291949" cy="180000"/>
                </a:xfrm>
              </p:grpSpPr>
              <p:sp>
                <p:nvSpPr>
                  <p:cNvPr id="252" name="Rectangle 14">
                    <a:extLst>
                      <a:ext uri="{FF2B5EF4-FFF2-40B4-BE49-F238E27FC236}">
                        <a16:creationId xmlns:a16="http://schemas.microsoft.com/office/drawing/2014/main" id="{23B01161-9F5A-4F66-B392-3E32D1B03E5A}"/>
                      </a:ext>
                    </a:extLst>
                  </p:cNvPr>
                  <p:cNvSpPr>
                    <a:spLocks noChangeArrowheads="1"/>
                  </p:cNvSpPr>
                  <p:nvPr/>
                </p:nvSpPr>
                <p:spPr bwMode="auto">
                  <a:xfrm>
                    <a:off x="3802823" y="3739665"/>
                    <a:ext cx="432000" cy="180000"/>
                  </a:xfrm>
                  <a:prstGeom prst="rect">
                    <a:avLst/>
                  </a:prstGeom>
                  <a:solidFill>
                    <a:srgbClr val="D5EDDD"/>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253" name="Rectangle 15">
                    <a:extLst>
                      <a:ext uri="{FF2B5EF4-FFF2-40B4-BE49-F238E27FC236}">
                        <a16:creationId xmlns:a16="http://schemas.microsoft.com/office/drawing/2014/main" id="{546C9F8C-8741-4C1A-95AC-45FDE888DEDD}"/>
                      </a:ext>
                    </a:extLst>
                  </p:cNvPr>
                  <p:cNvSpPr>
                    <a:spLocks noChangeArrowheads="1"/>
                  </p:cNvSpPr>
                  <p:nvPr/>
                </p:nvSpPr>
                <p:spPr bwMode="auto">
                  <a:xfrm>
                    <a:off x="4235417" y="3739665"/>
                    <a:ext cx="432000" cy="180000"/>
                  </a:xfrm>
                  <a:prstGeom prst="rect">
                    <a:avLst/>
                  </a:prstGeom>
                  <a:solidFill>
                    <a:srgbClr val="F7E1D2"/>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254" name="Rectangle 16">
                    <a:extLst>
                      <a:ext uri="{FF2B5EF4-FFF2-40B4-BE49-F238E27FC236}">
                        <a16:creationId xmlns:a16="http://schemas.microsoft.com/office/drawing/2014/main" id="{8BA69BF4-BDD7-4F2D-B716-C28E04C8972D}"/>
                      </a:ext>
                    </a:extLst>
                  </p:cNvPr>
                  <p:cNvSpPr>
                    <a:spLocks noChangeArrowheads="1"/>
                  </p:cNvSpPr>
                  <p:nvPr/>
                </p:nvSpPr>
                <p:spPr bwMode="auto">
                  <a:xfrm>
                    <a:off x="4662772" y="3739665"/>
                    <a:ext cx="432000" cy="180000"/>
                  </a:xfrm>
                  <a:prstGeom prst="rect">
                    <a:avLst/>
                  </a:prstGeom>
                  <a:solidFill>
                    <a:srgbClr val="F3D1B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354" name="Group 353">
                  <a:extLst>
                    <a:ext uri="{FF2B5EF4-FFF2-40B4-BE49-F238E27FC236}">
                      <a16:creationId xmlns:a16="http://schemas.microsoft.com/office/drawing/2014/main" id="{143C6C7C-AADB-46C9-8050-16C843A15859}"/>
                    </a:ext>
                  </a:extLst>
                </p:cNvPr>
                <p:cNvGrpSpPr/>
                <p:nvPr/>
              </p:nvGrpSpPr>
              <p:grpSpPr>
                <a:xfrm>
                  <a:off x="4457140" y="3978356"/>
                  <a:ext cx="1291949" cy="180000"/>
                  <a:chOff x="3802823" y="3955565"/>
                  <a:chExt cx="1291949" cy="180000"/>
                </a:xfrm>
              </p:grpSpPr>
              <p:sp>
                <p:nvSpPr>
                  <p:cNvPr id="255" name="Rectangle 17">
                    <a:extLst>
                      <a:ext uri="{FF2B5EF4-FFF2-40B4-BE49-F238E27FC236}">
                        <a16:creationId xmlns:a16="http://schemas.microsoft.com/office/drawing/2014/main" id="{03E79502-2324-464A-B3FD-EC49AA645C5E}"/>
                      </a:ext>
                    </a:extLst>
                  </p:cNvPr>
                  <p:cNvSpPr>
                    <a:spLocks noChangeArrowheads="1"/>
                  </p:cNvSpPr>
                  <p:nvPr/>
                </p:nvSpPr>
                <p:spPr bwMode="auto">
                  <a:xfrm>
                    <a:off x="3802823" y="3955565"/>
                    <a:ext cx="432000" cy="180000"/>
                  </a:xfrm>
                  <a:prstGeom prst="rect">
                    <a:avLst/>
                  </a:prstGeom>
                  <a:solidFill>
                    <a:srgbClr val="F5D9C6"/>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54" name="Rectangle 18">
                    <a:extLst>
                      <a:ext uri="{FF2B5EF4-FFF2-40B4-BE49-F238E27FC236}">
                        <a16:creationId xmlns:a16="http://schemas.microsoft.com/office/drawing/2014/main" id="{E9AC5400-41C4-4D21-9596-EF963F0D87D8}"/>
                      </a:ext>
                    </a:extLst>
                  </p:cNvPr>
                  <p:cNvSpPr>
                    <a:spLocks noChangeArrowheads="1"/>
                  </p:cNvSpPr>
                  <p:nvPr/>
                </p:nvSpPr>
                <p:spPr bwMode="auto">
                  <a:xfrm>
                    <a:off x="4235417" y="3955565"/>
                    <a:ext cx="432000" cy="180000"/>
                  </a:xfrm>
                  <a:prstGeom prst="rect">
                    <a:avLst/>
                  </a:prstGeom>
                  <a:solidFill>
                    <a:srgbClr val="F6DBCA"/>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55" name="Rectangle 19">
                    <a:extLst>
                      <a:ext uri="{FF2B5EF4-FFF2-40B4-BE49-F238E27FC236}">
                        <a16:creationId xmlns:a16="http://schemas.microsoft.com/office/drawing/2014/main" id="{0BE4E1C1-5EC6-4512-B103-44B4B9C9E8C1}"/>
                      </a:ext>
                    </a:extLst>
                  </p:cNvPr>
                  <p:cNvSpPr>
                    <a:spLocks noChangeArrowheads="1"/>
                  </p:cNvSpPr>
                  <p:nvPr/>
                </p:nvSpPr>
                <p:spPr bwMode="auto">
                  <a:xfrm>
                    <a:off x="4662772" y="3955565"/>
                    <a:ext cx="432000" cy="180000"/>
                  </a:xfrm>
                  <a:prstGeom prst="rect">
                    <a:avLst/>
                  </a:prstGeom>
                  <a:solidFill>
                    <a:srgbClr val="F3D0BA"/>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355" name="Group 354">
                  <a:extLst>
                    <a:ext uri="{FF2B5EF4-FFF2-40B4-BE49-F238E27FC236}">
                      <a16:creationId xmlns:a16="http://schemas.microsoft.com/office/drawing/2014/main" id="{8E60AB69-1971-493C-B8E4-512F28D8D4F5}"/>
                    </a:ext>
                  </a:extLst>
                </p:cNvPr>
                <p:cNvGrpSpPr/>
                <p:nvPr/>
              </p:nvGrpSpPr>
              <p:grpSpPr>
                <a:xfrm>
                  <a:off x="4457667" y="4188926"/>
                  <a:ext cx="1291949" cy="180000"/>
                  <a:chOff x="3802823" y="4166702"/>
                  <a:chExt cx="1291949" cy="180000"/>
                </a:xfrm>
              </p:grpSpPr>
              <p:sp>
                <p:nvSpPr>
                  <p:cNvPr id="56" name="Rectangle 20">
                    <a:extLst>
                      <a:ext uri="{FF2B5EF4-FFF2-40B4-BE49-F238E27FC236}">
                        <a16:creationId xmlns:a16="http://schemas.microsoft.com/office/drawing/2014/main" id="{1EBD79B3-6884-48A3-9FF3-32023CF68D74}"/>
                      </a:ext>
                    </a:extLst>
                  </p:cNvPr>
                  <p:cNvSpPr>
                    <a:spLocks noChangeArrowheads="1"/>
                  </p:cNvSpPr>
                  <p:nvPr/>
                </p:nvSpPr>
                <p:spPr bwMode="auto">
                  <a:xfrm>
                    <a:off x="3802823" y="4166702"/>
                    <a:ext cx="432000" cy="180000"/>
                  </a:xfrm>
                  <a:prstGeom prst="rect">
                    <a:avLst/>
                  </a:prstGeom>
                  <a:solidFill>
                    <a:srgbClr val="F9E8DD"/>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57" name="Rectangle 21">
                    <a:extLst>
                      <a:ext uri="{FF2B5EF4-FFF2-40B4-BE49-F238E27FC236}">
                        <a16:creationId xmlns:a16="http://schemas.microsoft.com/office/drawing/2014/main" id="{3B564B32-8352-4A7E-BCAA-D198D619D137}"/>
                      </a:ext>
                    </a:extLst>
                  </p:cNvPr>
                  <p:cNvSpPr>
                    <a:spLocks noChangeArrowheads="1"/>
                  </p:cNvSpPr>
                  <p:nvPr/>
                </p:nvSpPr>
                <p:spPr bwMode="auto">
                  <a:xfrm>
                    <a:off x="4235417" y="4166702"/>
                    <a:ext cx="432000" cy="180000"/>
                  </a:xfrm>
                  <a:prstGeom prst="rect">
                    <a:avLst/>
                  </a:prstGeom>
                  <a:solidFill>
                    <a:srgbClr val="F5DAC9"/>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58" name="Rectangle 22">
                    <a:extLst>
                      <a:ext uri="{FF2B5EF4-FFF2-40B4-BE49-F238E27FC236}">
                        <a16:creationId xmlns:a16="http://schemas.microsoft.com/office/drawing/2014/main" id="{A53B80C2-C3BB-482A-81BD-0A3376632A7F}"/>
                      </a:ext>
                    </a:extLst>
                  </p:cNvPr>
                  <p:cNvSpPr>
                    <a:spLocks noChangeArrowheads="1"/>
                  </p:cNvSpPr>
                  <p:nvPr/>
                </p:nvSpPr>
                <p:spPr bwMode="auto">
                  <a:xfrm>
                    <a:off x="4662772" y="4166702"/>
                    <a:ext cx="432000" cy="180000"/>
                  </a:xfrm>
                  <a:prstGeom prst="rect">
                    <a:avLst/>
                  </a:prstGeom>
                  <a:solidFill>
                    <a:srgbClr val="F2CCB4"/>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356" name="Group 355">
                  <a:extLst>
                    <a:ext uri="{FF2B5EF4-FFF2-40B4-BE49-F238E27FC236}">
                      <a16:creationId xmlns:a16="http://schemas.microsoft.com/office/drawing/2014/main" id="{5EBF5DFF-500D-4EEA-9BFD-DAF4A2935E81}"/>
                    </a:ext>
                  </a:extLst>
                </p:cNvPr>
                <p:cNvGrpSpPr/>
                <p:nvPr/>
              </p:nvGrpSpPr>
              <p:grpSpPr>
                <a:xfrm>
                  <a:off x="4457667" y="4400065"/>
                  <a:ext cx="1291949" cy="180000"/>
                  <a:chOff x="3802823" y="4381015"/>
                  <a:chExt cx="1291949" cy="180000"/>
                </a:xfrm>
              </p:grpSpPr>
              <p:sp>
                <p:nvSpPr>
                  <p:cNvPr id="59" name="Rectangle 23">
                    <a:extLst>
                      <a:ext uri="{FF2B5EF4-FFF2-40B4-BE49-F238E27FC236}">
                        <a16:creationId xmlns:a16="http://schemas.microsoft.com/office/drawing/2014/main" id="{CA391BEC-8E5F-4837-91A0-6370D21E24B3}"/>
                      </a:ext>
                    </a:extLst>
                  </p:cNvPr>
                  <p:cNvSpPr>
                    <a:spLocks noChangeArrowheads="1"/>
                  </p:cNvSpPr>
                  <p:nvPr/>
                </p:nvSpPr>
                <p:spPr bwMode="auto">
                  <a:xfrm>
                    <a:off x="3802823" y="4381015"/>
                    <a:ext cx="432000" cy="180000"/>
                  </a:xfrm>
                  <a:prstGeom prst="rect">
                    <a:avLst/>
                  </a:prstGeom>
                  <a:solidFill>
                    <a:srgbClr val="F0C6A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60" name="Rectangle 24">
                    <a:extLst>
                      <a:ext uri="{FF2B5EF4-FFF2-40B4-BE49-F238E27FC236}">
                        <a16:creationId xmlns:a16="http://schemas.microsoft.com/office/drawing/2014/main" id="{E07ADA72-22C8-4152-9565-A2ABABF2F537}"/>
                      </a:ext>
                    </a:extLst>
                  </p:cNvPr>
                  <p:cNvSpPr>
                    <a:spLocks noChangeArrowheads="1"/>
                  </p:cNvSpPr>
                  <p:nvPr/>
                </p:nvSpPr>
                <p:spPr bwMode="auto">
                  <a:xfrm>
                    <a:off x="4235417" y="4381015"/>
                    <a:ext cx="432000" cy="180000"/>
                  </a:xfrm>
                  <a:prstGeom prst="rect">
                    <a:avLst/>
                  </a:prstGeom>
                  <a:solidFill>
                    <a:srgbClr val="EFBFA1"/>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1" name="Rectangle 25">
                    <a:extLst>
                      <a:ext uri="{FF2B5EF4-FFF2-40B4-BE49-F238E27FC236}">
                        <a16:creationId xmlns:a16="http://schemas.microsoft.com/office/drawing/2014/main" id="{009E9140-959E-43F1-9BC4-E0AFED31D2F2}"/>
                      </a:ext>
                    </a:extLst>
                  </p:cNvPr>
                  <p:cNvSpPr>
                    <a:spLocks noChangeArrowheads="1"/>
                  </p:cNvSpPr>
                  <p:nvPr/>
                </p:nvSpPr>
                <p:spPr bwMode="auto">
                  <a:xfrm>
                    <a:off x="4662772" y="4381015"/>
                    <a:ext cx="432000" cy="180000"/>
                  </a:xfrm>
                  <a:prstGeom prst="rect">
                    <a:avLst/>
                  </a:prstGeom>
                  <a:solidFill>
                    <a:srgbClr val="E69F70"/>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sp>
              <p:nvSpPr>
                <p:cNvPr id="4" name="Rectangle 178">
                  <a:extLst>
                    <a:ext uri="{FF2B5EF4-FFF2-40B4-BE49-F238E27FC236}">
                      <a16:creationId xmlns:a16="http://schemas.microsoft.com/office/drawing/2014/main" id="{98DABFBC-4288-455C-997C-745E4C29565D}"/>
                    </a:ext>
                  </a:extLst>
                </p:cNvPr>
                <p:cNvSpPr>
                  <a:spLocks noChangeArrowheads="1"/>
                </p:cNvSpPr>
                <p:nvPr/>
              </p:nvSpPr>
              <p:spPr bwMode="auto">
                <a:xfrm>
                  <a:off x="4616131" y="767968"/>
                  <a:ext cx="128241"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000" b="1" dirty="0">
                      <a:solidFill>
                        <a:srgbClr val="000000"/>
                      </a:solidFill>
                      <a:latin typeface=" Calibri "/>
                    </a:rPr>
                    <a:t>As</a:t>
                  </a:r>
                  <a:endParaRPr kumimoji="0" lang="en-US" altLang="en-US" sz="1000" b="1" i="0" u="none" strike="noStrike" cap="none" normalizeH="0" baseline="0" dirty="0">
                    <a:ln>
                      <a:noFill/>
                    </a:ln>
                    <a:solidFill>
                      <a:schemeClr val="tx1"/>
                    </a:solidFill>
                    <a:effectLst/>
                    <a:latin typeface=" Calibri "/>
                  </a:endParaRPr>
                </a:p>
              </p:txBody>
            </p:sp>
            <p:sp>
              <p:nvSpPr>
                <p:cNvPr id="5" name="Rectangle 178">
                  <a:extLst>
                    <a:ext uri="{FF2B5EF4-FFF2-40B4-BE49-F238E27FC236}">
                      <a16:creationId xmlns:a16="http://schemas.microsoft.com/office/drawing/2014/main" id="{A2626088-79A1-40BB-8A76-FB28653D0FF2}"/>
                    </a:ext>
                  </a:extLst>
                </p:cNvPr>
                <p:cNvSpPr>
                  <a:spLocks noChangeArrowheads="1"/>
                </p:cNvSpPr>
                <p:nvPr/>
              </p:nvSpPr>
              <p:spPr bwMode="auto">
                <a:xfrm>
                  <a:off x="4971894" y="760566"/>
                  <a:ext cx="25299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chemeClr val="tx1"/>
                      </a:solidFill>
                      <a:effectLst/>
                      <a:latin typeface=" Calibri "/>
                    </a:rPr>
                    <a:t>Hpx</a:t>
                  </a:r>
                </a:p>
              </p:txBody>
            </p:sp>
            <p:sp>
              <p:nvSpPr>
                <p:cNvPr id="6" name="Rectangle 178">
                  <a:extLst>
                    <a:ext uri="{FF2B5EF4-FFF2-40B4-BE49-F238E27FC236}">
                      <a16:creationId xmlns:a16="http://schemas.microsoft.com/office/drawing/2014/main" id="{B867B508-1497-48D9-9A99-EBD6B7BD8B3F}"/>
                    </a:ext>
                  </a:extLst>
                </p:cNvPr>
                <p:cNvSpPr>
                  <a:spLocks noChangeArrowheads="1"/>
                </p:cNvSpPr>
                <p:nvPr/>
              </p:nvSpPr>
              <p:spPr bwMode="auto">
                <a:xfrm>
                  <a:off x="5333734" y="759719"/>
                  <a:ext cx="396932"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chemeClr val="tx1"/>
                      </a:solidFill>
                      <a:effectLst/>
                      <a:latin typeface=" Calibri "/>
                    </a:rPr>
                    <a:t>HpxAs</a:t>
                  </a:r>
                </a:p>
              </p:txBody>
            </p:sp>
            <p:grpSp>
              <p:nvGrpSpPr>
                <p:cNvPr id="290" name="Group 289">
                  <a:extLst>
                    <a:ext uri="{FF2B5EF4-FFF2-40B4-BE49-F238E27FC236}">
                      <a16:creationId xmlns:a16="http://schemas.microsoft.com/office/drawing/2014/main" id="{63ACF65D-A7DC-45D4-9544-0BA347D6D2B8}"/>
                    </a:ext>
                  </a:extLst>
                </p:cNvPr>
                <p:cNvGrpSpPr/>
                <p:nvPr/>
              </p:nvGrpSpPr>
              <p:grpSpPr>
                <a:xfrm>
                  <a:off x="4453868" y="985608"/>
                  <a:ext cx="1294800" cy="180000"/>
                  <a:chOff x="4817283" y="1946222"/>
                  <a:chExt cx="1294800" cy="180000"/>
                </a:xfrm>
              </p:grpSpPr>
              <p:sp>
                <p:nvSpPr>
                  <p:cNvPr id="80" name="Rectangle 57">
                    <a:extLst>
                      <a:ext uri="{FF2B5EF4-FFF2-40B4-BE49-F238E27FC236}">
                        <a16:creationId xmlns:a16="http://schemas.microsoft.com/office/drawing/2014/main" id="{4CB78A01-A12C-4BB4-AB12-B2B2DA5ED600}"/>
                      </a:ext>
                    </a:extLst>
                  </p:cNvPr>
                  <p:cNvSpPr>
                    <a:spLocks noChangeArrowheads="1"/>
                  </p:cNvSpPr>
                  <p:nvPr/>
                </p:nvSpPr>
                <p:spPr bwMode="auto">
                  <a:xfrm>
                    <a:off x="4817283" y="1946222"/>
                    <a:ext cx="432000" cy="180000"/>
                  </a:xfrm>
                  <a:prstGeom prst="rect">
                    <a:avLst/>
                  </a:prstGeom>
                  <a:solidFill>
                    <a:srgbClr val="94D0A7"/>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81" name="Rectangle 58">
                    <a:extLst>
                      <a:ext uri="{FF2B5EF4-FFF2-40B4-BE49-F238E27FC236}">
                        <a16:creationId xmlns:a16="http://schemas.microsoft.com/office/drawing/2014/main" id="{2E204374-5A6F-460C-8BC7-F4D54F53BDD6}"/>
                      </a:ext>
                    </a:extLst>
                  </p:cNvPr>
                  <p:cNvSpPr>
                    <a:spLocks noChangeArrowheads="1"/>
                  </p:cNvSpPr>
                  <p:nvPr/>
                </p:nvSpPr>
                <p:spPr bwMode="auto">
                  <a:xfrm>
                    <a:off x="5248298" y="1946222"/>
                    <a:ext cx="432000" cy="180000"/>
                  </a:xfrm>
                  <a:prstGeom prst="rect">
                    <a:avLst/>
                  </a:prstGeom>
                  <a:solidFill>
                    <a:srgbClr val="D2EBDA"/>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82" name="Rectangle 59">
                    <a:extLst>
                      <a:ext uri="{FF2B5EF4-FFF2-40B4-BE49-F238E27FC236}">
                        <a16:creationId xmlns:a16="http://schemas.microsoft.com/office/drawing/2014/main" id="{37512341-307C-4045-900C-7498F4EA2F2E}"/>
                      </a:ext>
                    </a:extLst>
                  </p:cNvPr>
                  <p:cNvSpPr>
                    <a:spLocks noChangeArrowheads="1"/>
                  </p:cNvSpPr>
                  <p:nvPr/>
                </p:nvSpPr>
                <p:spPr bwMode="auto">
                  <a:xfrm>
                    <a:off x="5680083" y="1946222"/>
                    <a:ext cx="432000" cy="180000"/>
                  </a:xfrm>
                  <a:prstGeom prst="rect">
                    <a:avLst/>
                  </a:prstGeom>
                  <a:solidFill>
                    <a:srgbClr val="98D1AA"/>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1" name="Group 290">
                  <a:extLst>
                    <a:ext uri="{FF2B5EF4-FFF2-40B4-BE49-F238E27FC236}">
                      <a16:creationId xmlns:a16="http://schemas.microsoft.com/office/drawing/2014/main" id="{2E8A2F14-48B0-4228-941C-5E03330F66EF}"/>
                    </a:ext>
                  </a:extLst>
                </p:cNvPr>
                <p:cNvGrpSpPr/>
                <p:nvPr/>
              </p:nvGrpSpPr>
              <p:grpSpPr>
                <a:xfrm>
                  <a:off x="4453868" y="1201511"/>
                  <a:ext cx="1294800" cy="180000"/>
                  <a:chOff x="4817283" y="2162125"/>
                  <a:chExt cx="1294800" cy="180000"/>
                </a:xfrm>
              </p:grpSpPr>
              <p:sp>
                <p:nvSpPr>
                  <p:cNvPr id="83" name="Rectangle 60">
                    <a:extLst>
                      <a:ext uri="{FF2B5EF4-FFF2-40B4-BE49-F238E27FC236}">
                        <a16:creationId xmlns:a16="http://schemas.microsoft.com/office/drawing/2014/main" id="{C4965C8A-3608-46F0-B91E-278A69FDACB2}"/>
                      </a:ext>
                    </a:extLst>
                  </p:cNvPr>
                  <p:cNvSpPr>
                    <a:spLocks noChangeArrowheads="1"/>
                  </p:cNvSpPr>
                  <p:nvPr/>
                </p:nvSpPr>
                <p:spPr bwMode="auto">
                  <a:xfrm>
                    <a:off x="4817283" y="2162125"/>
                    <a:ext cx="432000" cy="180000"/>
                  </a:xfrm>
                  <a:prstGeom prst="rect">
                    <a:avLst/>
                  </a:prstGeom>
                  <a:solidFill>
                    <a:srgbClr val="A9D9B7"/>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84" name="Rectangle 61">
                    <a:extLst>
                      <a:ext uri="{FF2B5EF4-FFF2-40B4-BE49-F238E27FC236}">
                        <a16:creationId xmlns:a16="http://schemas.microsoft.com/office/drawing/2014/main" id="{ADAA67C6-A22F-4545-A6E2-BE51E59ED468}"/>
                      </a:ext>
                    </a:extLst>
                  </p:cNvPr>
                  <p:cNvSpPr>
                    <a:spLocks noChangeArrowheads="1"/>
                  </p:cNvSpPr>
                  <p:nvPr/>
                </p:nvSpPr>
                <p:spPr bwMode="auto">
                  <a:xfrm>
                    <a:off x="5248298" y="2162125"/>
                    <a:ext cx="432000" cy="180000"/>
                  </a:xfrm>
                  <a:prstGeom prst="rect">
                    <a:avLst/>
                  </a:prstGeom>
                  <a:solidFill>
                    <a:srgbClr val="F9E9DF"/>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85" name="Rectangle 62">
                    <a:extLst>
                      <a:ext uri="{FF2B5EF4-FFF2-40B4-BE49-F238E27FC236}">
                        <a16:creationId xmlns:a16="http://schemas.microsoft.com/office/drawing/2014/main" id="{B7BAE8C5-82FF-4889-B82C-956BD5F76B47}"/>
                      </a:ext>
                    </a:extLst>
                  </p:cNvPr>
                  <p:cNvSpPr>
                    <a:spLocks noChangeArrowheads="1"/>
                  </p:cNvSpPr>
                  <p:nvPr/>
                </p:nvSpPr>
                <p:spPr bwMode="auto">
                  <a:xfrm>
                    <a:off x="5680083" y="2162125"/>
                    <a:ext cx="432000" cy="180000"/>
                  </a:xfrm>
                  <a:prstGeom prst="rect">
                    <a:avLst/>
                  </a:prstGeom>
                  <a:solidFill>
                    <a:srgbClr val="CFEAD7"/>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2" name="Group 291">
                  <a:extLst>
                    <a:ext uri="{FF2B5EF4-FFF2-40B4-BE49-F238E27FC236}">
                      <a16:creationId xmlns:a16="http://schemas.microsoft.com/office/drawing/2014/main" id="{5AE4B1A7-0BEE-4567-B7F9-E3110C521700}"/>
                    </a:ext>
                  </a:extLst>
                </p:cNvPr>
                <p:cNvGrpSpPr/>
                <p:nvPr/>
              </p:nvGrpSpPr>
              <p:grpSpPr>
                <a:xfrm>
                  <a:off x="4453868" y="1411064"/>
                  <a:ext cx="1294800" cy="180000"/>
                  <a:chOff x="4817283" y="2376440"/>
                  <a:chExt cx="1294800" cy="180000"/>
                </a:xfrm>
              </p:grpSpPr>
              <p:sp>
                <p:nvSpPr>
                  <p:cNvPr id="86" name="Rectangle 63">
                    <a:extLst>
                      <a:ext uri="{FF2B5EF4-FFF2-40B4-BE49-F238E27FC236}">
                        <a16:creationId xmlns:a16="http://schemas.microsoft.com/office/drawing/2014/main" id="{532A9927-8114-4796-B3B3-79E181E2DC23}"/>
                      </a:ext>
                    </a:extLst>
                  </p:cNvPr>
                  <p:cNvSpPr>
                    <a:spLocks noChangeArrowheads="1"/>
                  </p:cNvSpPr>
                  <p:nvPr/>
                </p:nvSpPr>
                <p:spPr bwMode="auto">
                  <a:xfrm>
                    <a:off x="4817283" y="2376440"/>
                    <a:ext cx="432000" cy="180000"/>
                  </a:xfrm>
                  <a:prstGeom prst="rect">
                    <a:avLst/>
                  </a:prstGeom>
                  <a:solidFill>
                    <a:srgbClr val="AAD9B8"/>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87" name="Rectangle 64">
                    <a:extLst>
                      <a:ext uri="{FF2B5EF4-FFF2-40B4-BE49-F238E27FC236}">
                        <a16:creationId xmlns:a16="http://schemas.microsoft.com/office/drawing/2014/main" id="{35FC934C-4077-4723-9DFE-860DB7DDF67C}"/>
                      </a:ext>
                    </a:extLst>
                  </p:cNvPr>
                  <p:cNvSpPr>
                    <a:spLocks noChangeArrowheads="1"/>
                  </p:cNvSpPr>
                  <p:nvPr/>
                </p:nvSpPr>
                <p:spPr bwMode="auto">
                  <a:xfrm>
                    <a:off x="5248298" y="2376440"/>
                    <a:ext cx="432000" cy="180000"/>
                  </a:xfrm>
                  <a:prstGeom prst="rect">
                    <a:avLst/>
                  </a:prstGeom>
                  <a:solidFill>
                    <a:srgbClr val="F6DECE"/>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88" name="Rectangle 65">
                    <a:extLst>
                      <a:ext uri="{FF2B5EF4-FFF2-40B4-BE49-F238E27FC236}">
                        <a16:creationId xmlns:a16="http://schemas.microsoft.com/office/drawing/2014/main" id="{64DF4373-AFAA-4FF1-8B48-5ED495D0AC54}"/>
                      </a:ext>
                    </a:extLst>
                  </p:cNvPr>
                  <p:cNvSpPr>
                    <a:spLocks noChangeArrowheads="1"/>
                  </p:cNvSpPr>
                  <p:nvPr/>
                </p:nvSpPr>
                <p:spPr bwMode="auto">
                  <a:xfrm>
                    <a:off x="5680083" y="2376440"/>
                    <a:ext cx="432000" cy="180000"/>
                  </a:xfrm>
                  <a:prstGeom prst="rect">
                    <a:avLst/>
                  </a:prstGeom>
                  <a:solidFill>
                    <a:srgbClr val="D0EAD8"/>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3" name="Group 292">
                  <a:extLst>
                    <a:ext uri="{FF2B5EF4-FFF2-40B4-BE49-F238E27FC236}">
                      <a16:creationId xmlns:a16="http://schemas.microsoft.com/office/drawing/2014/main" id="{F07B7DE1-3FB3-4CB3-8114-10E133D69434}"/>
                    </a:ext>
                  </a:extLst>
                </p:cNvPr>
                <p:cNvGrpSpPr/>
                <p:nvPr/>
              </p:nvGrpSpPr>
              <p:grpSpPr>
                <a:xfrm>
                  <a:off x="4453868" y="1622199"/>
                  <a:ext cx="1294800" cy="180000"/>
                  <a:chOff x="4817283" y="2587575"/>
                  <a:chExt cx="1294800" cy="180000"/>
                </a:xfrm>
              </p:grpSpPr>
              <p:sp>
                <p:nvSpPr>
                  <p:cNvPr id="89" name="Rectangle 66">
                    <a:extLst>
                      <a:ext uri="{FF2B5EF4-FFF2-40B4-BE49-F238E27FC236}">
                        <a16:creationId xmlns:a16="http://schemas.microsoft.com/office/drawing/2014/main" id="{DFDCB209-6D6E-4470-9A32-05C9C6EB0BE2}"/>
                      </a:ext>
                    </a:extLst>
                  </p:cNvPr>
                  <p:cNvSpPr>
                    <a:spLocks noChangeArrowheads="1"/>
                  </p:cNvSpPr>
                  <p:nvPr/>
                </p:nvSpPr>
                <p:spPr bwMode="auto">
                  <a:xfrm>
                    <a:off x="4817283" y="2587575"/>
                    <a:ext cx="432000" cy="180000"/>
                  </a:xfrm>
                  <a:prstGeom prst="rect">
                    <a:avLst/>
                  </a:prstGeom>
                  <a:solidFill>
                    <a:srgbClr val="F7E0D1"/>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0" name="Rectangle 67">
                    <a:extLst>
                      <a:ext uri="{FF2B5EF4-FFF2-40B4-BE49-F238E27FC236}">
                        <a16:creationId xmlns:a16="http://schemas.microsoft.com/office/drawing/2014/main" id="{C4E6585D-64A8-498C-899B-97EEFA7066EB}"/>
                      </a:ext>
                    </a:extLst>
                  </p:cNvPr>
                  <p:cNvSpPr>
                    <a:spLocks noChangeArrowheads="1"/>
                  </p:cNvSpPr>
                  <p:nvPr/>
                </p:nvSpPr>
                <p:spPr bwMode="auto">
                  <a:xfrm>
                    <a:off x="5248298" y="2587575"/>
                    <a:ext cx="432000" cy="180000"/>
                  </a:xfrm>
                  <a:prstGeom prst="rect">
                    <a:avLst/>
                  </a:prstGeom>
                  <a:solidFill>
                    <a:srgbClr val="F7E1D3"/>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1" name="Rectangle 68">
                    <a:extLst>
                      <a:ext uri="{FF2B5EF4-FFF2-40B4-BE49-F238E27FC236}">
                        <a16:creationId xmlns:a16="http://schemas.microsoft.com/office/drawing/2014/main" id="{514DE3DA-31C9-431E-9D42-36212199883F}"/>
                      </a:ext>
                    </a:extLst>
                  </p:cNvPr>
                  <p:cNvSpPr>
                    <a:spLocks noChangeArrowheads="1"/>
                  </p:cNvSpPr>
                  <p:nvPr/>
                </p:nvSpPr>
                <p:spPr bwMode="auto">
                  <a:xfrm>
                    <a:off x="5680083" y="2587575"/>
                    <a:ext cx="432000" cy="180000"/>
                  </a:xfrm>
                  <a:prstGeom prst="rect">
                    <a:avLst/>
                  </a:prstGeom>
                  <a:solidFill>
                    <a:srgbClr val="F0C6AA"/>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4" name="Group 293">
                  <a:extLst>
                    <a:ext uri="{FF2B5EF4-FFF2-40B4-BE49-F238E27FC236}">
                      <a16:creationId xmlns:a16="http://schemas.microsoft.com/office/drawing/2014/main" id="{B9741E57-3CB2-4C71-A3F4-F04E15DC8FB9}"/>
                    </a:ext>
                  </a:extLst>
                </p:cNvPr>
                <p:cNvGrpSpPr/>
                <p:nvPr/>
              </p:nvGrpSpPr>
              <p:grpSpPr>
                <a:xfrm>
                  <a:off x="4453868" y="1838899"/>
                  <a:ext cx="1294800" cy="180000"/>
                  <a:chOff x="4817283" y="2801894"/>
                  <a:chExt cx="1294800" cy="180000"/>
                </a:xfrm>
              </p:grpSpPr>
              <p:sp>
                <p:nvSpPr>
                  <p:cNvPr id="92" name="Rectangle 69">
                    <a:extLst>
                      <a:ext uri="{FF2B5EF4-FFF2-40B4-BE49-F238E27FC236}">
                        <a16:creationId xmlns:a16="http://schemas.microsoft.com/office/drawing/2014/main" id="{B82C4594-CC9A-42B4-95FB-8A2F24AF721C}"/>
                      </a:ext>
                    </a:extLst>
                  </p:cNvPr>
                  <p:cNvSpPr>
                    <a:spLocks noChangeArrowheads="1"/>
                  </p:cNvSpPr>
                  <p:nvPr/>
                </p:nvSpPr>
                <p:spPr bwMode="auto">
                  <a:xfrm>
                    <a:off x="4817283" y="2801894"/>
                    <a:ext cx="432000" cy="180000"/>
                  </a:xfrm>
                  <a:prstGeom prst="rect">
                    <a:avLst/>
                  </a:prstGeom>
                  <a:solidFill>
                    <a:srgbClr val="F6DDCC"/>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3" name="Rectangle 70">
                    <a:extLst>
                      <a:ext uri="{FF2B5EF4-FFF2-40B4-BE49-F238E27FC236}">
                        <a16:creationId xmlns:a16="http://schemas.microsoft.com/office/drawing/2014/main" id="{02F4BD7A-F141-41C4-9617-5DB6D562FBBE}"/>
                      </a:ext>
                    </a:extLst>
                  </p:cNvPr>
                  <p:cNvSpPr>
                    <a:spLocks noChangeArrowheads="1"/>
                  </p:cNvSpPr>
                  <p:nvPr/>
                </p:nvSpPr>
                <p:spPr bwMode="auto">
                  <a:xfrm>
                    <a:off x="5248298" y="2801894"/>
                    <a:ext cx="432000" cy="180000"/>
                  </a:xfrm>
                  <a:prstGeom prst="rect">
                    <a:avLst/>
                  </a:prstGeom>
                  <a:solidFill>
                    <a:srgbClr val="F0C4A8"/>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4" name="Rectangle 71">
                    <a:extLst>
                      <a:ext uri="{FF2B5EF4-FFF2-40B4-BE49-F238E27FC236}">
                        <a16:creationId xmlns:a16="http://schemas.microsoft.com/office/drawing/2014/main" id="{51B3F090-31B7-4B3E-9EEF-7E023501E9A2}"/>
                      </a:ext>
                    </a:extLst>
                  </p:cNvPr>
                  <p:cNvSpPr>
                    <a:spLocks noChangeArrowheads="1"/>
                  </p:cNvSpPr>
                  <p:nvPr/>
                </p:nvSpPr>
                <p:spPr bwMode="auto">
                  <a:xfrm>
                    <a:off x="5680083" y="2801894"/>
                    <a:ext cx="432000" cy="180000"/>
                  </a:xfrm>
                  <a:prstGeom prst="rect">
                    <a:avLst/>
                  </a:prstGeom>
                  <a:solidFill>
                    <a:srgbClr val="EFC0A1"/>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5" name="Group 294">
                  <a:extLst>
                    <a:ext uri="{FF2B5EF4-FFF2-40B4-BE49-F238E27FC236}">
                      <a16:creationId xmlns:a16="http://schemas.microsoft.com/office/drawing/2014/main" id="{A5E15E00-4E81-4F38-A39F-1A41D8A3F805}"/>
                    </a:ext>
                  </a:extLst>
                </p:cNvPr>
                <p:cNvGrpSpPr/>
                <p:nvPr/>
              </p:nvGrpSpPr>
              <p:grpSpPr>
                <a:xfrm>
                  <a:off x="4453868" y="2054793"/>
                  <a:ext cx="1294800" cy="180000"/>
                  <a:chOff x="4817283" y="3013026"/>
                  <a:chExt cx="1294800" cy="180000"/>
                </a:xfrm>
              </p:grpSpPr>
              <p:sp>
                <p:nvSpPr>
                  <p:cNvPr id="95" name="Rectangle 72">
                    <a:extLst>
                      <a:ext uri="{FF2B5EF4-FFF2-40B4-BE49-F238E27FC236}">
                        <a16:creationId xmlns:a16="http://schemas.microsoft.com/office/drawing/2014/main" id="{3C42B359-86E8-4520-8189-3CB109074EBA}"/>
                      </a:ext>
                    </a:extLst>
                  </p:cNvPr>
                  <p:cNvSpPr>
                    <a:spLocks noChangeArrowheads="1"/>
                  </p:cNvSpPr>
                  <p:nvPr/>
                </p:nvSpPr>
                <p:spPr bwMode="auto">
                  <a:xfrm>
                    <a:off x="4817283" y="3013026"/>
                    <a:ext cx="432000" cy="180000"/>
                  </a:xfrm>
                  <a:prstGeom prst="rect">
                    <a:avLst/>
                  </a:prstGeom>
                  <a:solidFill>
                    <a:srgbClr val="F6DECE"/>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6" name="Rectangle 73">
                    <a:extLst>
                      <a:ext uri="{FF2B5EF4-FFF2-40B4-BE49-F238E27FC236}">
                        <a16:creationId xmlns:a16="http://schemas.microsoft.com/office/drawing/2014/main" id="{7815D7B7-5B0A-4DF9-B217-A4AE25EE139E}"/>
                      </a:ext>
                    </a:extLst>
                  </p:cNvPr>
                  <p:cNvSpPr>
                    <a:spLocks noChangeArrowheads="1"/>
                  </p:cNvSpPr>
                  <p:nvPr/>
                </p:nvSpPr>
                <p:spPr bwMode="auto">
                  <a:xfrm>
                    <a:off x="5248298" y="3013026"/>
                    <a:ext cx="432000" cy="180000"/>
                  </a:xfrm>
                  <a:prstGeom prst="rect">
                    <a:avLst/>
                  </a:prstGeom>
                  <a:solidFill>
                    <a:srgbClr val="F3D1B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7" name="Rectangle 74">
                    <a:extLst>
                      <a:ext uri="{FF2B5EF4-FFF2-40B4-BE49-F238E27FC236}">
                        <a16:creationId xmlns:a16="http://schemas.microsoft.com/office/drawing/2014/main" id="{6BAE63E1-EE3E-427C-BEDA-FA40B8AAA2A1}"/>
                      </a:ext>
                    </a:extLst>
                  </p:cNvPr>
                  <p:cNvSpPr>
                    <a:spLocks noChangeArrowheads="1"/>
                  </p:cNvSpPr>
                  <p:nvPr/>
                </p:nvSpPr>
                <p:spPr bwMode="auto">
                  <a:xfrm>
                    <a:off x="5680083" y="3013026"/>
                    <a:ext cx="432000" cy="180000"/>
                  </a:xfrm>
                  <a:prstGeom prst="rect">
                    <a:avLst/>
                  </a:prstGeom>
                  <a:solidFill>
                    <a:srgbClr val="ECB38F"/>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6" name="Group 295">
                  <a:extLst>
                    <a:ext uri="{FF2B5EF4-FFF2-40B4-BE49-F238E27FC236}">
                      <a16:creationId xmlns:a16="http://schemas.microsoft.com/office/drawing/2014/main" id="{414F40D4-8C1C-406F-8048-12B491877337}"/>
                    </a:ext>
                  </a:extLst>
                </p:cNvPr>
                <p:cNvGrpSpPr/>
                <p:nvPr/>
              </p:nvGrpSpPr>
              <p:grpSpPr>
                <a:xfrm>
                  <a:off x="4453868" y="2263555"/>
                  <a:ext cx="1294800" cy="180000"/>
                  <a:chOff x="4817283" y="3228931"/>
                  <a:chExt cx="1294800" cy="180000"/>
                </a:xfrm>
              </p:grpSpPr>
              <p:sp>
                <p:nvSpPr>
                  <p:cNvPr id="98" name="Rectangle 75">
                    <a:extLst>
                      <a:ext uri="{FF2B5EF4-FFF2-40B4-BE49-F238E27FC236}">
                        <a16:creationId xmlns:a16="http://schemas.microsoft.com/office/drawing/2014/main" id="{3AA475A9-AD57-4A6F-90A7-184AE3871343}"/>
                      </a:ext>
                    </a:extLst>
                  </p:cNvPr>
                  <p:cNvSpPr>
                    <a:spLocks noChangeArrowheads="1"/>
                  </p:cNvSpPr>
                  <p:nvPr/>
                </p:nvSpPr>
                <p:spPr bwMode="auto">
                  <a:xfrm>
                    <a:off x="4817283" y="3228931"/>
                    <a:ext cx="432000" cy="180000"/>
                  </a:xfrm>
                  <a:prstGeom prst="rect">
                    <a:avLst/>
                  </a:prstGeom>
                  <a:solidFill>
                    <a:srgbClr val="E69E6F"/>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9" name="Rectangle 76">
                    <a:extLst>
                      <a:ext uri="{FF2B5EF4-FFF2-40B4-BE49-F238E27FC236}">
                        <a16:creationId xmlns:a16="http://schemas.microsoft.com/office/drawing/2014/main" id="{E87D04C7-2CC7-4DA3-82E7-B8592973709C}"/>
                      </a:ext>
                    </a:extLst>
                  </p:cNvPr>
                  <p:cNvSpPr>
                    <a:spLocks noChangeArrowheads="1"/>
                  </p:cNvSpPr>
                  <p:nvPr/>
                </p:nvSpPr>
                <p:spPr bwMode="auto">
                  <a:xfrm>
                    <a:off x="5248298" y="3228931"/>
                    <a:ext cx="432000" cy="180000"/>
                  </a:xfrm>
                  <a:prstGeom prst="rect">
                    <a:avLst/>
                  </a:prstGeom>
                  <a:solidFill>
                    <a:srgbClr val="F4D4BF"/>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00" name="Rectangle 77">
                    <a:extLst>
                      <a:ext uri="{FF2B5EF4-FFF2-40B4-BE49-F238E27FC236}">
                        <a16:creationId xmlns:a16="http://schemas.microsoft.com/office/drawing/2014/main" id="{B90388B2-E5EC-405B-B1AB-FA56F314DAB1}"/>
                      </a:ext>
                    </a:extLst>
                  </p:cNvPr>
                  <p:cNvSpPr>
                    <a:spLocks noChangeArrowheads="1"/>
                  </p:cNvSpPr>
                  <p:nvPr/>
                </p:nvSpPr>
                <p:spPr bwMode="auto">
                  <a:xfrm>
                    <a:off x="5680083" y="3228931"/>
                    <a:ext cx="432000" cy="180000"/>
                  </a:xfrm>
                  <a:prstGeom prst="rect">
                    <a:avLst/>
                  </a:prstGeom>
                  <a:solidFill>
                    <a:srgbClr val="EAAF88"/>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7" name="Group 296">
                  <a:extLst>
                    <a:ext uri="{FF2B5EF4-FFF2-40B4-BE49-F238E27FC236}">
                      <a16:creationId xmlns:a16="http://schemas.microsoft.com/office/drawing/2014/main" id="{8569BF38-3788-430A-B086-89763C13A37F}"/>
                    </a:ext>
                  </a:extLst>
                </p:cNvPr>
                <p:cNvGrpSpPr/>
                <p:nvPr/>
              </p:nvGrpSpPr>
              <p:grpSpPr>
                <a:xfrm>
                  <a:off x="4453868" y="2477869"/>
                  <a:ext cx="1294800" cy="180000"/>
                  <a:chOff x="4817283" y="3443245"/>
                  <a:chExt cx="1294800" cy="180000"/>
                </a:xfrm>
              </p:grpSpPr>
              <p:sp>
                <p:nvSpPr>
                  <p:cNvPr id="101" name="Rectangle 78">
                    <a:extLst>
                      <a:ext uri="{FF2B5EF4-FFF2-40B4-BE49-F238E27FC236}">
                        <a16:creationId xmlns:a16="http://schemas.microsoft.com/office/drawing/2014/main" id="{04BB6191-6A1D-4211-92F5-060CC03825B8}"/>
                      </a:ext>
                    </a:extLst>
                  </p:cNvPr>
                  <p:cNvSpPr>
                    <a:spLocks noChangeArrowheads="1"/>
                  </p:cNvSpPr>
                  <p:nvPr/>
                </p:nvSpPr>
                <p:spPr bwMode="auto">
                  <a:xfrm>
                    <a:off x="4817283" y="3443245"/>
                    <a:ext cx="432000" cy="180000"/>
                  </a:xfrm>
                  <a:prstGeom prst="rect">
                    <a:avLst/>
                  </a:prstGeom>
                  <a:solidFill>
                    <a:srgbClr val="F6DECE"/>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02" name="Rectangle 79">
                    <a:extLst>
                      <a:ext uri="{FF2B5EF4-FFF2-40B4-BE49-F238E27FC236}">
                        <a16:creationId xmlns:a16="http://schemas.microsoft.com/office/drawing/2014/main" id="{5FA74492-573C-407E-8B27-EB42E78DFC57}"/>
                      </a:ext>
                    </a:extLst>
                  </p:cNvPr>
                  <p:cNvSpPr>
                    <a:spLocks noChangeArrowheads="1"/>
                  </p:cNvSpPr>
                  <p:nvPr/>
                </p:nvSpPr>
                <p:spPr bwMode="auto">
                  <a:xfrm>
                    <a:off x="5248298" y="3443245"/>
                    <a:ext cx="432000" cy="180000"/>
                  </a:xfrm>
                  <a:prstGeom prst="rect">
                    <a:avLst/>
                  </a:prstGeom>
                  <a:solidFill>
                    <a:srgbClr val="EDB896"/>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03" name="Rectangle 80">
                    <a:extLst>
                      <a:ext uri="{FF2B5EF4-FFF2-40B4-BE49-F238E27FC236}">
                        <a16:creationId xmlns:a16="http://schemas.microsoft.com/office/drawing/2014/main" id="{374E11B3-A06A-4CE9-9972-E80585ACE190}"/>
                      </a:ext>
                    </a:extLst>
                  </p:cNvPr>
                  <p:cNvSpPr>
                    <a:spLocks noChangeArrowheads="1"/>
                  </p:cNvSpPr>
                  <p:nvPr/>
                </p:nvSpPr>
                <p:spPr bwMode="auto">
                  <a:xfrm>
                    <a:off x="5680083" y="3443245"/>
                    <a:ext cx="432000" cy="180000"/>
                  </a:xfrm>
                  <a:prstGeom prst="rect">
                    <a:avLst/>
                  </a:prstGeom>
                  <a:solidFill>
                    <a:srgbClr val="EAAE86"/>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8" name="Group 297">
                  <a:extLst>
                    <a:ext uri="{FF2B5EF4-FFF2-40B4-BE49-F238E27FC236}">
                      <a16:creationId xmlns:a16="http://schemas.microsoft.com/office/drawing/2014/main" id="{5988C251-B87D-43E2-8B97-51B349059B05}"/>
                    </a:ext>
                  </a:extLst>
                </p:cNvPr>
                <p:cNvGrpSpPr/>
                <p:nvPr/>
              </p:nvGrpSpPr>
              <p:grpSpPr>
                <a:xfrm>
                  <a:off x="4453868" y="2693761"/>
                  <a:ext cx="1294800" cy="180000"/>
                  <a:chOff x="4817283" y="3654375"/>
                  <a:chExt cx="1294800" cy="180000"/>
                </a:xfrm>
              </p:grpSpPr>
              <p:sp>
                <p:nvSpPr>
                  <p:cNvPr id="104" name="Rectangle 81">
                    <a:extLst>
                      <a:ext uri="{FF2B5EF4-FFF2-40B4-BE49-F238E27FC236}">
                        <a16:creationId xmlns:a16="http://schemas.microsoft.com/office/drawing/2014/main" id="{F70C0688-7EDF-45D1-90FC-AC8DB8DDBBE6}"/>
                      </a:ext>
                    </a:extLst>
                  </p:cNvPr>
                  <p:cNvSpPr>
                    <a:spLocks noChangeArrowheads="1"/>
                  </p:cNvSpPr>
                  <p:nvPr/>
                </p:nvSpPr>
                <p:spPr bwMode="auto">
                  <a:xfrm>
                    <a:off x="4817283" y="3654375"/>
                    <a:ext cx="432000" cy="180000"/>
                  </a:xfrm>
                  <a:prstGeom prst="rect">
                    <a:avLst/>
                  </a:prstGeom>
                  <a:solidFill>
                    <a:srgbClr val="F1C8AE"/>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05" name="Rectangle 82">
                    <a:extLst>
                      <a:ext uri="{FF2B5EF4-FFF2-40B4-BE49-F238E27FC236}">
                        <a16:creationId xmlns:a16="http://schemas.microsoft.com/office/drawing/2014/main" id="{38A8EF3F-88FF-4BE1-9C2C-2181AE86BBCD}"/>
                      </a:ext>
                    </a:extLst>
                  </p:cNvPr>
                  <p:cNvSpPr>
                    <a:spLocks noChangeArrowheads="1"/>
                  </p:cNvSpPr>
                  <p:nvPr/>
                </p:nvSpPr>
                <p:spPr bwMode="auto">
                  <a:xfrm>
                    <a:off x="5248298" y="3654375"/>
                    <a:ext cx="432000" cy="180000"/>
                  </a:xfrm>
                  <a:prstGeom prst="rect">
                    <a:avLst/>
                  </a:prstGeom>
                  <a:solidFill>
                    <a:srgbClr val="F8E7D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06" name="Rectangle 83">
                    <a:extLst>
                      <a:ext uri="{FF2B5EF4-FFF2-40B4-BE49-F238E27FC236}">
                        <a16:creationId xmlns:a16="http://schemas.microsoft.com/office/drawing/2014/main" id="{4BEA7905-41B5-4A78-B589-32E1E2E99957}"/>
                      </a:ext>
                    </a:extLst>
                  </p:cNvPr>
                  <p:cNvSpPr>
                    <a:spLocks noChangeArrowheads="1"/>
                  </p:cNvSpPr>
                  <p:nvPr/>
                </p:nvSpPr>
                <p:spPr bwMode="auto">
                  <a:xfrm>
                    <a:off x="5680083" y="3654375"/>
                    <a:ext cx="432000" cy="180000"/>
                  </a:xfrm>
                  <a:prstGeom prst="rect">
                    <a:avLst/>
                  </a:prstGeom>
                  <a:solidFill>
                    <a:srgbClr val="F2CEB6"/>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grpSp>
              <p:nvGrpSpPr>
                <p:cNvPr id="299" name="Group 298">
                  <a:extLst>
                    <a:ext uri="{FF2B5EF4-FFF2-40B4-BE49-F238E27FC236}">
                      <a16:creationId xmlns:a16="http://schemas.microsoft.com/office/drawing/2014/main" id="{CB2F80FD-F7F8-4227-9FAB-00AB610071C9}"/>
                    </a:ext>
                  </a:extLst>
                </p:cNvPr>
                <p:cNvGrpSpPr/>
                <p:nvPr/>
              </p:nvGrpSpPr>
              <p:grpSpPr>
                <a:xfrm>
                  <a:off x="4453868" y="2905706"/>
                  <a:ext cx="1294800" cy="180000"/>
                  <a:chOff x="4817283" y="3868701"/>
                  <a:chExt cx="1294800" cy="180000"/>
                </a:xfrm>
              </p:grpSpPr>
              <p:sp>
                <p:nvSpPr>
                  <p:cNvPr id="107" name="Rectangle 84">
                    <a:extLst>
                      <a:ext uri="{FF2B5EF4-FFF2-40B4-BE49-F238E27FC236}">
                        <a16:creationId xmlns:a16="http://schemas.microsoft.com/office/drawing/2014/main" id="{2CD5F4FE-F6FC-485A-9855-1FCCE81ECA49}"/>
                      </a:ext>
                    </a:extLst>
                  </p:cNvPr>
                  <p:cNvSpPr>
                    <a:spLocks noChangeArrowheads="1"/>
                  </p:cNvSpPr>
                  <p:nvPr/>
                </p:nvSpPr>
                <p:spPr bwMode="auto">
                  <a:xfrm>
                    <a:off x="4817283" y="3868701"/>
                    <a:ext cx="432000" cy="180000"/>
                  </a:xfrm>
                  <a:prstGeom prst="rect">
                    <a:avLst/>
                  </a:prstGeom>
                  <a:solidFill>
                    <a:srgbClr val="F8E6DA"/>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08" name="Rectangle 85">
                    <a:extLst>
                      <a:ext uri="{FF2B5EF4-FFF2-40B4-BE49-F238E27FC236}">
                        <a16:creationId xmlns:a16="http://schemas.microsoft.com/office/drawing/2014/main" id="{1DB24888-8E6D-4EF8-9A15-245172B69011}"/>
                      </a:ext>
                    </a:extLst>
                  </p:cNvPr>
                  <p:cNvSpPr>
                    <a:spLocks noChangeArrowheads="1"/>
                  </p:cNvSpPr>
                  <p:nvPr/>
                </p:nvSpPr>
                <p:spPr bwMode="auto">
                  <a:xfrm>
                    <a:off x="5248298" y="3868701"/>
                    <a:ext cx="432000" cy="180000"/>
                  </a:xfrm>
                  <a:prstGeom prst="rect">
                    <a:avLst/>
                  </a:prstGeom>
                  <a:solidFill>
                    <a:srgbClr val="F4D3BF"/>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09" name="Rectangle 86">
                    <a:extLst>
                      <a:ext uri="{FF2B5EF4-FFF2-40B4-BE49-F238E27FC236}">
                        <a16:creationId xmlns:a16="http://schemas.microsoft.com/office/drawing/2014/main" id="{0816D424-B4F8-4988-BD58-1E4E10F28B56}"/>
                      </a:ext>
                    </a:extLst>
                  </p:cNvPr>
                  <p:cNvSpPr>
                    <a:spLocks noChangeArrowheads="1"/>
                  </p:cNvSpPr>
                  <p:nvPr/>
                </p:nvSpPr>
                <p:spPr bwMode="auto">
                  <a:xfrm>
                    <a:off x="5680083" y="3868701"/>
                    <a:ext cx="432000" cy="180000"/>
                  </a:xfrm>
                  <a:prstGeom prst="rect">
                    <a:avLst/>
                  </a:prstGeom>
                  <a:solidFill>
                    <a:srgbClr val="F7E0D2"/>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grpSp>
            <p:sp>
              <p:nvSpPr>
                <p:cNvPr id="197" name="TextBox 196">
                  <a:extLst>
                    <a:ext uri="{FF2B5EF4-FFF2-40B4-BE49-F238E27FC236}">
                      <a16:creationId xmlns:a16="http://schemas.microsoft.com/office/drawing/2014/main" id="{D887ECD8-290D-4AF4-BBE5-8A240995A38A}"/>
                    </a:ext>
                  </a:extLst>
                </p:cNvPr>
                <p:cNvSpPr txBox="1"/>
                <p:nvPr/>
              </p:nvSpPr>
              <p:spPr>
                <a:xfrm>
                  <a:off x="5760520" y="1581989"/>
                  <a:ext cx="176819" cy="307777"/>
                </a:xfrm>
                <a:prstGeom prst="rect">
                  <a:avLst/>
                </a:prstGeom>
                <a:noFill/>
              </p:spPr>
              <p:txBody>
                <a:bodyPr wrap="square" rtlCol="0">
                  <a:spAutoFit/>
                </a:bodyPr>
                <a:lstStyle/>
                <a:p>
                  <a:pPr algn="ctr"/>
                  <a:r>
                    <a:rPr lang="en-IN" sz="1400" dirty="0">
                      <a:solidFill>
                        <a:srgbClr val="31A354"/>
                      </a:solidFill>
                      <a:latin typeface="Calibri "/>
                    </a:rPr>
                    <a:t>*</a:t>
                  </a:r>
                </a:p>
              </p:txBody>
            </p:sp>
            <p:sp>
              <p:nvSpPr>
                <p:cNvPr id="344" name="TextBox 343">
                  <a:extLst>
                    <a:ext uri="{FF2B5EF4-FFF2-40B4-BE49-F238E27FC236}">
                      <a16:creationId xmlns:a16="http://schemas.microsoft.com/office/drawing/2014/main" id="{8F0B2DCC-517F-485E-A8F5-4B03AD9078F7}"/>
                    </a:ext>
                  </a:extLst>
                </p:cNvPr>
                <p:cNvSpPr txBox="1"/>
                <p:nvPr/>
              </p:nvSpPr>
              <p:spPr>
                <a:xfrm>
                  <a:off x="5760520" y="4165353"/>
                  <a:ext cx="176819" cy="307777"/>
                </a:xfrm>
                <a:prstGeom prst="rect">
                  <a:avLst/>
                </a:prstGeom>
                <a:noFill/>
              </p:spPr>
              <p:txBody>
                <a:bodyPr wrap="square" rtlCol="0">
                  <a:spAutoFit/>
                </a:bodyPr>
                <a:lstStyle/>
                <a:p>
                  <a:pPr algn="ctr"/>
                  <a:r>
                    <a:rPr lang="en-IN" sz="1400" dirty="0">
                      <a:solidFill>
                        <a:srgbClr val="31A354"/>
                      </a:solidFill>
                      <a:latin typeface="Calibri "/>
                    </a:rPr>
                    <a:t>*</a:t>
                  </a:r>
                </a:p>
              </p:txBody>
            </p:sp>
            <p:sp>
              <p:nvSpPr>
                <p:cNvPr id="345" name="TextBox 344">
                  <a:extLst>
                    <a:ext uri="{FF2B5EF4-FFF2-40B4-BE49-F238E27FC236}">
                      <a16:creationId xmlns:a16="http://schemas.microsoft.com/office/drawing/2014/main" id="{B485BF07-F847-47C1-B6EF-CD7933146518}"/>
                    </a:ext>
                  </a:extLst>
                </p:cNvPr>
                <p:cNvSpPr txBox="1"/>
                <p:nvPr/>
              </p:nvSpPr>
              <p:spPr>
                <a:xfrm>
                  <a:off x="5760520" y="3952551"/>
                  <a:ext cx="176819" cy="307777"/>
                </a:xfrm>
                <a:prstGeom prst="rect">
                  <a:avLst/>
                </a:prstGeom>
                <a:noFill/>
              </p:spPr>
              <p:txBody>
                <a:bodyPr wrap="square" rtlCol="0">
                  <a:spAutoFit/>
                </a:bodyPr>
                <a:lstStyle/>
                <a:p>
                  <a:pPr algn="ctr"/>
                  <a:r>
                    <a:rPr lang="en-IN" sz="1400" dirty="0">
                      <a:solidFill>
                        <a:srgbClr val="31A354"/>
                      </a:solidFill>
                      <a:latin typeface="Calibri "/>
                    </a:rPr>
                    <a:t>*</a:t>
                  </a:r>
                </a:p>
              </p:txBody>
            </p:sp>
            <p:sp>
              <p:nvSpPr>
                <p:cNvPr id="346" name="TextBox 345">
                  <a:extLst>
                    <a:ext uri="{FF2B5EF4-FFF2-40B4-BE49-F238E27FC236}">
                      <a16:creationId xmlns:a16="http://schemas.microsoft.com/office/drawing/2014/main" id="{492370CB-CBEB-4538-91F5-A367157B223A}"/>
                    </a:ext>
                  </a:extLst>
                </p:cNvPr>
                <p:cNvSpPr txBox="1"/>
                <p:nvPr/>
              </p:nvSpPr>
              <p:spPr>
                <a:xfrm>
                  <a:off x="5760520" y="3720483"/>
                  <a:ext cx="176819" cy="307777"/>
                </a:xfrm>
                <a:prstGeom prst="rect">
                  <a:avLst/>
                </a:prstGeom>
                <a:noFill/>
              </p:spPr>
              <p:txBody>
                <a:bodyPr wrap="square" rtlCol="0">
                  <a:spAutoFit/>
                </a:bodyPr>
                <a:lstStyle/>
                <a:p>
                  <a:pPr algn="ctr"/>
                  <a:r>
                    <a:rPr lang="en-IN" sz="1400" dirty="0">
                      <a:solidFill>
                        <a:srgbClr val="31A354"/>
                      </a:solidFill>
                      <a:latin typeface="Calibri "/>
                    </a:rPr>
                    <a:t>*</a:t>
                  </a:r>
                </a:p>
              </p:txBody>
            </p:sp>
          </p:grpSp>
        </p:grpSp>
      </p:grpSp>
      <p:sp>
        <p:nvSpPr>
          <p:cNvPr id="350" name="Rechteck 1375">
            <a:extLst>
              <a:ext uri="{FF2B5EF4-FFF2-40B4-BE49-F238E27FC236}">
                <a16:creationId xmlns:a16="http://schemas.microsoft.com/office/drawing/2014/main" id="{143B535A-B940-49FF-8B52-8D618FA8E9DA}"/>
              </a:ext>
            </a:extLst>
          </p:cNvPr>
          <p:cNvSpPr/>
          <p:nvPr/>
        </p:nvSpPr>
        <p:spPr>
          <a:xfrm>
            <a:off x="864328" y="5172119"/>
            <a:ext cx="7415344" cy="1569660"/>
          </a:xfrm>
          <a:prstGeom prst="rect">
            <a:avLst/>
          </a:prstGeom>
        </p:spPr>
        <p:txBody>
          <a:bodyPr wrap="square">
            <a:spAutoFit/>
          </a:bodyPr>
          <a:lstStyle/>
          <a:p>
            <a:pPr marL="1079500" indent="-1079500" algn="just" defTabSz="179388"/>
            <a:r>
              <a:rPr lang="en-US" sz="1200" b="1" dirty="0">
                <a:latin typeface="Times New Roman" panose="02020603050405020304" pitchFamily="18" charset="0"/>
                <a:cs typeface="Times New Roman" panose="02020603050405020304" pitchFamily="18" charset="0"/>
              </a:rPr>
              <a:t>Suppl. Figure 1:	Expression analysis of lipid signalling and </a:t>
            </a:r>
            <a:r>
              <a:rPr lang="en-US" sz="1200" b="1" dirty="0" err="1">
                <a:latin typeface="Times New Roman" panose="02020603050405020304" pitchFamily="18" charset="0"/>
                <a:cs typeface="Times New Roman" panose="02020603050405020304" pitchFamily="18" charset="0"/>
              </a:rPr>
              <a:t>phosphatidyl</a:t>
            </a:r>
            <a:r>
              <a:rPr lang="en-US" sz="1200" b="1" dirty="0">
                <a:latin typeface="Times New Roman" panose="02020603050405020304" pitchFamily="18" charset="0"/>
                <a:cs typeface="Times New Roman" panose="02020603050405020304" pitchFamily="18" charset="0"/>
              </a:rPr>
              <a:t> inositol metabolism-related genes. </a:t>
            </a:r>
            <a:r>
              <a:rPr lang="en-US" sz="1200" dirty="0">
                <a:latin typeface="Times New Roman" panose="02020603050405020304" pitchFamily="18" charset="0"/>
                <a:cs typeface="Times New Roman" panose="02020603050405020304" pitchFamily="18" charset="0"/>
              </a:rPr>
              <a:t>Several lipid and phosphatidylinositol metabolism-related transcripts were identified to be directly involved in root development and regulation and are presented in the main text. The heat map here presents the rest of the genes in this category which showed significant expression change (linear fold change≥2, ≤-2, FDR p≤0.05) and were identified in initial root development regulatory gene network. The genes presented here are either not directly involved in root and root hair growth or are not characterized for their function. The genes marked with asterisks show significant and unique response to HpxAs. </a:t>
            </a:r>
            <a:endParaRPr lang="de-DE" sz="1200" dirty="0">
              <a:latin typeface="Times New Roman" panose="02020603050405020304" pitchFamily="18" charset="0"/>
              <a:cs typeface="Times New Roman" panose="02020603050405020304" pitchFamily="18" charset="0"/>
            </a:endParaRPr>
          </a:p>
        </p:txBody>
      </p:sp>
      <p:sp>
        <p:nvSpPr>
          <p:cNvPr id="2" name="Textfeld 1"/>
          <p:cNvSpPr txBox="1"/>
          <p:nvPr/>
        </p:nvSpPr>
        <p:spPr>
          <a:xfrm>
            <a:off x="0" y="-25766"/>
            <a:ext cx="4106765" cy="369332"/>
          </a:xfrm>
          <a:prstGeom prst="rect">
            <a:avLst/>
          </a:prstGeom>
          <a:noFill/>
        </p:spPr>
        <p:txBody>
          <a:bodyPr wrap="none" rtlCol="0">
            <a:spAutoFit/>
          </a:bodyPr>
          <a:lstStyle/>
          <a:p>
            <a:r>
              <a:rPr lang="de-DE" dirty="0" err="1"/>
              <a:t>Supplementary</a:t>
            </a:r>
            <a:r>
              <a:rPr lang="de-DE" dirty="0"/>
              <a:t> Materials </a:t>
            </a:r>
            <a:r>
              <a:rPr lang="de-DE" dirty="0" err="1"/>
              <a:t>for</a:t>
            </a:r>
            <a:r>
              <a:rPr lang="de-DE" dirty="0"/>
              <a:t> Kumar et al. </a:t>
            </a:r>
          </a:p>
        </p:txBody>
      </p:sp>
    </p:spTree>
    <p:extLst>
      <p:ext uri="{BB962C8B-B14F-4D97-AF65-F5344CB8AC3E}">
        <p14:creationId xmlns:p14="http://schemas.microsoft.com/office/powerpoint/2010/main" val="28635355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6" name="Rechteck 1375"/>
          <p:cNvSpPr/>
          <p:nvPr/>
        </p:nvSpPr>
        <p:spPr>
          <a:xfrm>
            <a:off x="556152" y="5078281"/>
            <a:ext cx="8131573" cy="1200329"/>
          </a:xfrm>
          <a:prstGeom prst="rect">
            <a:avLst/>
          </a:prstGeom>
        </p:spPr>
        <p:txBody>
          <a:bodyPr wrap="square">
            <a:spAutoFit/>
          </a:bodyPr>
          <a:lstStyle/>
          <a:p>
            <a:pPr marL="1079500" indent="-1079500" algn="just"/>
            <a:r>
              <a:rPr lang="en-US" sz="1200" b="1" dirty="0">
                <a:latin typeface="Times New Roman" panose="02020603050405020304" pitchFamily="18" charset="0"/>
                <a:cs typeface="Times New Roman" panose="02020603050405020304" pitchFamily="18" charset="0"/>
              </a:rPr>
              <a:t>Suppl. Figure 2:	Expression analysis of hypoxia marker gene transcripts.</a:t>
            </a:r>
            <a:r>
              <a:rPr lang="en-US" sz="1200" dirty="0">
                <a:latin typeface="Times New Roman" panose="02020603050405020304" pitchFamily="18" charset="0"/>
                <a:cs typeface="Times New Roman" panose="02020603050405020304" pitchFamily="18" charset="0"/>
              </a:rPr>
              <a:t> (A) The expression pattern for additional hypoxia marker genes from microarray analysis after 7d of treatment. (B) Transcript amounts of the same genes after 7d of treatment and subsequently after 4h of reaeration as analyzed in roots of </a:t>
            </a:r>
            <a:r>
              <a:rPr lang="en-US" sz="1200" i="1" dirty="0">
                <a:latin typeface="Times New Roman" panose="02020603050405020304" pitchFamily="18" charset="0"/>
                <a:cs typeface="Times New Roman" panose="02020603050405020304" pitchFamily="18" charset="0"/>
              </a:rPr>
              <a:t>A. thaliana </a:t>
            </a:r>
            <a:r>
              <a:rPr lang="en-US" sz="1200" dirty="0">
                <a:latin typeface="Times New Roman" panose="02020603050405020304" pitchFamily="18" charset="0"/>
                <a:cs typeface="Times New Roman" panose="02020603050405020304" pitchFamily="18" charset="0"/>
              </a:rPr>
              <a:t>(Col-0) by qRT-PCR. Green bars (also marked with *) are from reaerated samples. Relative change for each treatment is calculated by comparing expression in control plants before reaeration (means±SE, n=6; three experiments; Tukey’s test, p&lt;0.05). Different letters represent significantly different means. </a:t>
            </a:r>
            <a:endParaRPr lang="de-DE" sz="1200" dirty="0">
              <a:latin typeface="Times New Roman" panose="02020603050405020304" pitchFamily="18" charset="0"/>
              <a:cs typeface="Times New Roman" panose="02020603050405020304" pitchFamily="18" charset="0"/>
            </a:endParaRPr>
          </a:p>
        </p:txBody>
      </p:sp>
      <p:grpSp>
        <p:nvGrpSpPr>
          <p:cNvPr id="4" name="Group 3">
            <a:extLst>
              <a:ext uri="{FF2B5EF4-FFF2-40B4-BE49-F238E27FC236}">
                <a16:creationId xmlns:a16="http://schemas.microsoft.com/office/drawing/2014/main" id="{32DC1154-811E-4B54-8582-E84FFE7DFDF1}"/>
              </a:ext>
            </a:extLst>
          </p:cNvPr>
          <p:cNvGrpSpPr/>
          <p:nvPr/>
        </p:nvGrpSpPr>
        <p:grpSpPr>
          <a:xfrm>
            <a:off x="3866931" y="504078"/>
            <a:ext cx="4820794" cy="4391675"/>
            <a:chOff x="556845" y="457186"/>
            <a:chExt cx="4820794" cy="4391675"/>
          </a:xfrm>
        </p:grpSpPr>
        <p:grpSp>
          <p:nvGrpSpPr>
            <p:cNvPr id="3" name="Group 2">
              <a:extLst>
                <a:ext uri="{FF2B5EF4-FFF2-40B4-BE49-F238E27FC236}">
                  <a16:creationId xmlns:a16="http://schemas.microsoft.com/office/drawing/2014/main" id="{9941CA08-5927-4D83-8A42-2CE40CA37532}"/>
                </a:ext>
              </a:extLst>
            </p:cNvPr>
            <p:cNvGrpSpPr/>
            <p:nvPr/>
          </p:nvGrpSpPr>
          <p:grpSpPr>
            <a:xfrm>
              <a:off x="556845" y="457186"/>
              <a:ext cx="4820794" cy="4343398"/>
              <a:chOff x="556845" y="457186"/>
              <a:chExt cx="4820794" cy="4343398"/>
            </a:xfrm>
          </p:grpSpPr>
          <p:grpSp>
            <p:nvGrpSpPr>
              <p:cNvPr id="8" name="Group 7">
                <a:extLst>
                  <a:ext uri="{FF2B5EF4-FFF2-40B4-BE49-F238E27FC236}">
                    <a16:creationId xmlns:a16="http://schemas.microsoft.com/office/drawing/2014/main" id="{01CCE78F-9115-472C-AAA8-75D5D2294768}"/>
                  </a:ext>
                </a:extLst>
              </p:cNvPr>
              <p:cNvGrpSpPr/>
              <p:nvPr/>
            </p:nvGrpSpPr>
            <p:grpSpPr>
              <a:xfrm>
                <a:off x="556845" y="709506"/>
                <a:ext cx="2253006" cy="3810000"/>
                <a:chOff x="67729" y="1689100"/>
                <a:chExt cx="2253006" cy="3810000"/>
              </a:xfrm>
            </p:grpSpPr>
            <p:grpSp>
              <p:nvGrpSpPr>
                <p:cNvPr id="7" name="Group 6">
                  <a:extLst>
                    <a:ext uri="{FF2B5EF4-FFF2-40B4-BE49-F238E27FC236}">
                      <a16:creationId xmlns:a16="http://schemas.microsoft.com/office/drawing/2014/main" id="{CFDE8DE9-EB1F-400F-83D0-5C61691B6EEB}"/>
                    </a:ext>
                  </a:extLst>
                </p:cNvPr>
                <p:cNvGrpSpPr/>
                <p:nvPr/>
              </p:nvGrpSpPr>
              <p:grpSpPr>
                <a:xfrm>
                  <a:off x="457200" y="1689100"/>
                  <a:ext cx="1863535" cy="3810000"/>
                  <a:chOff x="648731" y="609600"/>
                  <a:chExt cx="1863535" cy="3810000"/>
                </a:xfrm>
              </p:grpSpPr>
              <p:grpSp>
                <p:nvGrpSpPr>
                  <p:cNvPr id="246" name="Group 245"/>
                  <p:cNvGrpSpPr/>
                  <p:nvPr/>
                </p:nvGrpSpPr>
                <p:grpSpPr>
                  <a:xfrm>
                    <a:off x="659381" y="609600"/>
                    <a:ext cx="1845260" cy="1250662"/>
                    <a:chOff x="1567568" y="1107961"/>
                    <a:chExt cx="1845260" cy="1250662"/>
                  </a:xfrm>
                </p:grpSpPr>
                <p:sp>
                  <p:nvSpPr>
                    <p:cNvPr id="545" name="Freeform 40"/>
                    <p:cNvSpPr>
                      <a:spLocks noEditPoints="1"/>
                    </p:cNvSpPr>
                    <p:nvPr/>
                  </p:nvSpPr>
                  <p:spPr bwMode="auto">
                    <a:xfrm>
                      <a:off x="1761785" y="1342644"/>
                      <a:ext cx="25461" cy="869563"/>
                    </a:xfrm>
                    <a:custGeom>
                      <a:avLst/>
                      <a:gdLst/>
                      <a:ahLst/>
                      <a:cxnLst>
                        <a:cxn ang="0">
                          <a:pos x="0" y="1044"/>
                        </a:cxn>
                        <a:cxn ang="0">
                          <a:pos x="30" y="1044"/>
                        </a:cxn>
                        <a:cxn ang="0">
                          <a:pos x="30" y="1050"/>
                        </a:cxn>
                        <a:cxn ang="0">
                          <a:pos x="0" y="1050"/>
                        </a:cxn>
                        <a:cxn ang="0">
                          <a:pos x="0" y="1044"/>
                        </a:cxn>
                        <a:cxn ang="0">
                          <a:pos x="0" y="522"/>
                        </a:cxn>
                        <a:cxn ang="0">
                          <a:pos x="30" y="522"/>
                        </a:cxn>
                        <a:cxn ang="0">
                          <a:pos x="30" y="528"/>
                        </a:cxn>
                        <a:cxn ang="0">
                          <a:pos x="0" y="528"/>
                        </a:cxn>
                        <a:cxn ang="0">
                          <a:pos x="0" y="522"/>
                        </a:cxn>
                        <a:cxn ang="0">
                          <a:pos x="0" y="0"/>
                        </a:cxn>
                        <a:cxn ang="0">
                          <a:pos x="30" y="0"/>
                        </a:cxn>
                        <a:cxn ang="0">
                          <a:pos x="30" y="6"/>
                        </a:cxn>
                        <a:cxn ang="0">
                          <a:pos x="0" y="6"/>
                        </a:cxn>
                        <a:cxn ang="0">
                          <a:pos x="0" y="0"/>
                        </a:cxn>
                      </a:cxnLst>
                      <a:rect l="0" t="0" r="r" b="b"/>
                      <a:pathLst>
                        <a:path w="30" h="1050">
                          <a:moveTo>
                            <a:pt x="0" y="1044"/>
                          </a:moveTo>
                          <a:lnTo>
                            <a:pt x="30" y="1044"/>
                          </a:lnTo>
                          <a:lnTo>
                            <a:pt x="30" y="1050"/>
                          </a:lnTo>
                          <a:lnTo>
                            <a:pt x="0" y="1050"/>
                          </a:lnTo>
                          <a:lnTo>
                            <a:pt x="0" y="1044"/>
                          </a:lnTo>
                          <a:close/>
                          <a:moveTo>
                            <a:pt x="0" y="522"/>
                          </a:moveTo>
                          <a:lnTo>
                            <a:pt x="30" y="522"/>
                          </a:lnTo>
                          <a:lnTo>
                            <a:pt x="30" y="528"/>
                          </a:lnTo>
                          <a:lnTo>
                            <a:pt x="0" y="528"/>
                          </a:lnTo>
                          <a:lnTo>
                            <a:pt x="0" y="522"/>
                          </a:lnTo>
                          <a:close/>
                          <a:moveTo>
                            <a:pt x="0" y="0"/>
                          </a:moveTo>
                          <a:lnTo>
                            <a:pt x="30" y="0"/>
                          </a:lnTo>
                          <a:lnTo>
                            <a:pt x="30" y="6"/>
                          </a:lnTo>
                          <a:lnTo>
                            <a:pt x="0" y="6"/>
                          </a:lnTo>
                          <a:lnTo>
                            <a:pt x="0" y="0"/>
                          </a:lnTo>
                          <a:close/>
                        </a:path>
                      </a:pathLst>
                    </a:custGeom>
                    <a:solidFill>
                      <a:schemeClr val="tx1"/>
                    </a:solidFill>
                    <a:ln w="635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sz="800">
                        <a:latin typeface="Calibri "/>
                      </a:endParaRPr>
                    </a:p>
                  </p:txBody>
                </p:sp>
                <p:sp>
                  <p:nvSpPr>
                    <p:cNvPr id="546" name="Rectangle 43"/>
                    <p:cNvSpPr>
                      <a:spLocks noChangeArrowheads="1"/>
                    </p:cNvSpPr>
                    <p:nvPr/>
                  </p:nvSpPr>
                  <p:spPr bwMode="auto">
                    <a:xfrm>
                      <a:off x="1687532" y="2171542"/>
                      <a:ext cx="58910"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0</a:t>
                      </a:r>
                      <a:endParaRPr lang="en-US" sz="800">
                        <a:latin typeface="Calibri "/>
                        <a:cs typeface="Arial" pitchFamily="34" charset="0"/>
                      </a:endParaRPr>
                    </a:p>
                  </p:txBody>
                </p:sp>
                <p:sp>
                  <p:nvSpPr>
                    <p:cNvPr id="547" name="Rectangle 44"/>
                    <p:cNvSpPr>
                      <a:spLocks noChangeArrowheads="1"/>
                    </p:cNvSpPr>
                    <p:nvPr/>
                  </p:nvSpPr>
                  <p:spPr bwMode="auto">
                    <a:xfrm>
                      <a:off x="1624023" y="1716459"/>
                      <a:ext cx="117818"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80</a:t>
                      </a:r>
                      <a:endParaRPr lang="en-US" sz="800">
                        <a:latin typeface="Calibri "/>
                        <a:cs typeface="Arial" pitchFamily="34" charset="0"/>
                      </a:endParaRPr>
                    </a:p>
                  </p:txBody>
                </p:sp>
                <p:sp>
                  <p:nvSpPr>
                    <p:cNvPr id="548" name="Rectangle 45"/>
                    <p:cNvSpPr>
                      <a:spLocks noChangeArrowheads="1"/>
                    </p:cNvSpPr>
                    <p:nvPr/>
                  </p:nvSpPr>
                  <p:spPr bwMode="auto">
                    <a:xfrm>
                      <a:off x="1567568" y="1282379"/>
                      <a:ext cx="176729"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160</a:t>
                      </a:r>
                      <a:endParaRPr lang="en-US" sz="800">
                        <a:latin typeface="Calibri "/>
                        <a:cs typeface="Arial" pitchFamily="34" charset="0"/>
                      </a:endParaRPr>
                    </a:p>
                  </p:txBody>
                </p:sp>
                <p:sp>
                  <p:nvSpPr>
                    <p:cNvPr id="549" name="Rectangle 62"/>
                    <p:cNvSpPr>
                      <a:spLocks noChangeArrowheads="1"/>
                    </p:cNvSpPr>
                    <p:nvPr/>
                  </p:nvSpPr>
                  <p:spPr bwMode="auto">
                    <a:xfrm>
                      <a:off x="1916792" y="1296498"/>
                      <a:ext cx="212796"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b="1" i="1" dirty="0">
                          <a:solidFill>
                            <a:srgbClr val="000000"/>
                          </a:solidFill>
                          <a:latin typeface="Calibri "/>
                          <a:cs typeface="Arial" pitchFamily="34" charset="0"/>
                        </a:rPr>
                        <a:t>HB1</a:t>
                      </a:r>
                      <a:endParaRPr lang="en-US" sz="800" b="1" i="1" dirty="0">
                        <a:latin typeface="Calibri "/>
                        <a:cs typeface="Arial" pitchFamily="34" charset="0"/>
                      </a:endParaRPr>
                    </a:p>
                  </p:txBody>
                </p:sp>
                <p:cxnSp>
                  <p:nvCxnSpPr>
                    <p:cNvPr id="558" name="Straight Connector 557"/>
                    <p:cNvCxnSpPr/>
                    <p:nvPr/>
                  </p:nvCxnSpPr>
                  <p:spPr>
                    <a:xfrm>
                      <a:off x="1790454" y="2209126"/>
                      <a:ext cx="162237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9" name="Straight Connector 558"/>
                    <p:cNvCxnSpPr/>
                    <p:nvPr/>
                  </p:nvCxnSpPr>
                  <p:spPr>
                    <a:xfrm>
                      <a:off x="1791440" y="1297036"/>
                      <a:ext cx="0" cy="91317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60" name="Rectangle 46"/>
                    <p:cNvSpPr>
                      <a:spLocks noChangeArrowheads="1"/>
                    </p:cNvSpPr>
                    <p:nvPr/>
                  </p:nvSpPr>
                  <p:spPr bwMode="auto">
                    <a:xfrm>
                      <a:off x="2037048" y="2231955"/>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561" name="Rectangle 46"/>
                    <p:cNvSpPr>
                      <a:spLocks noChangeArrowheads="1"/>
                    </p:cNvSpPr>
                    <p:nvPr/>
                  </p:nvSpPr>
                  <p:spPr bwMode="auto">
                    <a:xfrm>
                      <a:off x="2422362" y="2231955"/>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562" name="Rectangle 46"/>
                    <p:cNvSpPr>
                      <a:spLocks noChangeArrowheads="1"/>
                    </p:cNvSpPr>
                    <p:nvPr/>
                  </p:nvSpPr>
                  <p:spPr bwMode="auto">
                    <a:xfrm>
                      <a:off x="2814437" y="2231955"/>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563" name="Rectangle 46"/>
                    <p:cNvSpPr>
                      <a:spLocks noChangeArrowheads="1"/>
                    </p:cNvSpPr>
                    <p:nvPr/>
                  </p:nvSpPr>
                  <p:spPr bwMode="auto">
                    <a:xfrm>
                      <a:off x="3206511" y="2231955"/>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133" name="Rectangle 76"/>
                    <p:cNvSpPr>
                      <a:spLocks noChangeArrowheads="1"/>
                    </p:cNvSpPr>
                    <p:nvPr/>
                  </p:nvSpPr>
                  <p:spPr bwMode="auto">
                    <a:xfrm>
                      <a:off x="1862550" y="2198122"/>
                      <a:ext cx="125867" cy="9818"/>
                    </a:xfrm>
                    <a:prstGeom prst="rect">
                      <a:avLst/>
                    </a:prstGeom>
                    <a:solidFill>
                      <a:srgbClr val="FDEAD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35" name="Rectangle 78"/>
                    <p:cNvSpPr>
                      <a:spLocks noChangeArrowheads="1"/>
                    </p:cNvSpPr>
                    <p:nvPr/>
                  </p:nvSpPr>
                  <p:spPr bwMode="auto">
                    <a:xfrm>
                      <a:off x="2053149" y="2193376"/>
                      <a:ext cx="125867" cy="9818"/>
                    </a:xfrm>
                    <a:prstGeom prst="rect">
                      <a:avLst/>
                    </a:prstGeom>
                    <a:solidFill>
                      <a:srgbClr val="EBF1DE"/>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37" name="Rectangle 80"/>
                    <p:cNvSpPr>
                      <a:spLocks noChangeArrowheads="1"/>
                    </p:cNvSpPr>
                    <p:nvPr/>
                  </p:nvSpPr>
                  <p:spPr bwMode="auto">
                    <a:xfrm>
                      <a:off x="2233305" y="2184978"/>
                      <a:ext cx="125867" cy="24545"/>
                    </a:xfrm>
                    <a:prstGeom prst="rect">
                      <a:avLst/>
                    </a:prstGeom>
                    <a:solidFill>
                      <a:srgbClr val="FCD5B5"/>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39" name="Rectangle 82"/>
                    <p:cNvSpPr>
                      <a:spLocks noChangeArrowheads="1"/>
                    </p:cNvSpPr>
                    <p:nvPr/>
                  </p:nvSpPr>
                  <p:spPr bwMode="auto">
                    <a:xfrm>
                      <a:off x="2433419" y="2181022"/>
                      <a:ext cx="125867" cy="24545"/>
                    </a:xfrm>
                    <a:prstGeom prst="rect">
                      <a:avLst/>
                    </a:prstGeom>
                    <a:solidFill>
                      <a:srgbClr val="D7E4BD"/>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1" name="Rectangle 84"/>
                    <p:cNvSpPr>
                      <a:spLocks noChangeArrowheads="1"/>
                    </p:cNvSpPr>
                    <p:nvPr/>
                  </p:nvSpPr>
                  <p:spPr bwMode="auto">
                    <a:xfrm>
                      <a:off x="2635852" y="1403834"/>
                      <a:ext cx="125867" cy="800175"/>
                    </a:xfrm>
                    <a:prstGeom prst="rect">
                      <a:avLst/>
                    </a:prstGeom>
                    <a:solidFill>
                      <a:srgbClr val="FAC090"/>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3" name="Rectangle 86"/>
                    <p:cNvSpPr>
                      <a:spLocks noChangeArrowheads="1"/>
                    </p:cNvSpPr>
                    <p:nvPr/>
                  </p:nvSpPr>
                  <p:spPr bwMode="auto">
                    <a:xfrm>
                      <a:off x="2835161" y="2181046"/>
                      <a:ext cx="125867" cy="24545"/>
                    </a:xfrm>
                    <a:prstGeom prst="rect">
                      <a:avLst/>
                    </a:prstGeom>
                    <a:solidFill>
                      <a:srgbClr val="C3D69B"/>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5" name="Rectangle 88"/>
                    <p:cNvSpPr>
                      <a:spLocks noChangeArrowheads="1"/>
                    </p:cNvSpPr>
                    <p:nvPr/>
                  </p:nvSpPr>
                  <p:spPr bwMode="auto">
                    <a:xfrm>
                      <a:off x="3031297" y="1982940"/>
                      <a:ext cx="125867" cy="225816"/>
                    </a:xfrm>
                    <a:prstGeom prst="rect">
                      <a:avLst/>
                    </a:prstGeom>
                    <a:solidFill>
                      <a:srgbClr val="E46C0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7" name="Rectangle 90"/>
                    <p:cNvSpPr>
                      <a:spLocks noChangeArrowheads="1"/>
                    </p:cNvSpPr>
                    <p:nvPr/>
                  </p:nvSpPr>
                  <p:spPr bwMode="auto">
                    <a:xfrm>
                      <a:off x="3225372" y="2166318"/>
                      <a:ext cx="125867" cy="39272"/>
                    </a:xfrm>
                    <a:prstGeom prst="rect">
                      <a:avLst/>
                    </a:prstGeom>
                    <a:solidFill>
                      <a:srgbClr val="77933C"/>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49" name="Freeform 92"/>
                    <p:cNvSpPr>
                      <a:spLocks noEditPoints="1"/>
                    </p:cNvSpPr>
                    <p:nvPr/>
                  </p:nvSpPr>
                  <p:spPr bwMode="auto">
                    <a:xfrm>
                      <a:off x="1908054" y="2203032"/>
                      <a:ext cx="34127" cy="818"/>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64" name="Freeform 93"/>
                    <p:cNvSpPr>
                      <a:spLocks noEditPoints="1"/>
                    </p:cNvSpPr>
                    <p:nvPr/>
                  </p:nvSpPr>
                  <p:spPr bwMode="auto">
                    <a:xfrm>
                      <a:off x="2098653" y="2198285"/>
                      <a:ext cx="34127" cy="818"/>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65" name="Freeform 94"/>
                    <p:cNvSpPr>
                      <a:spLocks noEditPoints="1"/>
                    </p:cNvSpPr>
                    <p:nvPr/>
                  </p:nvSpPr>
                  <p:spPr bwMode="auto">
                    <a:xfrm>
                      <a:off x="2284495" y="2184978"/>
                      <a:ext cx="34127" cy="4909"/>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166" name="Freeform 95"/>
                    <p:cNvSpPr>
                      <a:spLocks noEditPoints="1"/>
                    </p:cNvSpPr>
                    <p:nvPr/>
                  </p:nvSpPr>
                  <p:spPr bwMode="auto">
                    <a:xfrm>
                      <a:off x="2279738" y="2176986"/>
                      <a:ext cx="34127" cy="9818"/>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67" name="Freeform 96"/>
                    <p:cNvSpPr>
                      <a:spLocks noEditPoints="1"/>
                    </p:cNvSpPr>
                    <p:nvPr/>
                  </p:nvSpPr>
                  <p:spPr bwMode="auto">
                    <a:xfrm>
                      <a:off x="2484609" y="2181022"/>
                      <a:ext cx="34127" cy="4909"/>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168" name="Freeform 97"/>
                    <p:cNvSpPr>
                      <a:spLocks noEditPoints="1"/>
                    </p:cNvSpPr>
                    <p:nvPr/>
                  </p:nvSpPr>
                  <p:spPr bwMode="auto">
                    <a:xfrm>
                      <a:off x="2479852" y="2176194"/>
                      <a:ext cx="34127" cy="9818"/>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69" name="Freeform 98"/>
                    <p:cNvSpPr>
                      <a:spLocks noEditPoints="1"/>
                    </p:cNvSpPr>
                    <p:nvPr/>
                  </p:nvSpPr>
                  <p:spPr bwMode="auto">
                    <a:xfrm>
                      <a:off x="2681355" y="1236926"/>
                      <a:ext cx="34127" cy="338725"/>
                    </a:xfrm>
                    <a:custGeom>
                      <a:avLst/>
                      <a:gdLst/>
                      <a:ahLst/>
                      <a:cxnLst>
                        <a:cxn ang="0">
                          <a:pos x="18" y="414"/>
                        </a:cxn>
                        <a:cxn ang="0">
                          <a:pos x="18" y="207"/>
                        </a:cxn>
                        <a:cxn ang="0">
                          <a:pos x="18" y="0"/>
                        </a:cxn>
                        <a:cxn ang="0">
                          <a:pos x="18" y="414"/>
                        </a:cxn>
                        <a:cxn ang="0">
                          <a:pos x="0" y="414"/>
                        </a:cxn>
                        <a:cxn ang="0">
                          <a:pos x="36" y="414"/>
                        </a:cxn>
                        <a:cxn ang="0">
                          <a:pos x="0" y="414"/>
                        </a:cxn>
                        <a:cxn ang="0">
                          <a:pos x="0" y="0"/>
                        </a:cxn>
                        <a:cxn ang="0">
                          <a:pos x="36" y="0"/>
                        </a:cxn>
                        <a:cxn ang="0">
                          <a:pos x="0" y="0"/>
                        </a:cxn>
                      </a:cxnLst>
                      <a:rect l="0" t="0" r="r" b="b"/>
                      <a:pathLst>
                        <a:path w="36" h="414">
                          <a:moveTo>
                            <a:pt x="18" y="414"/>
                          </a:moveTo>
                          <a:lnTo>
                            <a:pt x="18" y="207"/>
                          </a:lnTo>
                          <a:lnTo>
                            <a:pt x="18" y="0"/>
                          </a:lnTo>
                          <a:lnTo>
                            <a:pt x="18" y="414"/>
                          </a:lnTo>
                          <a:close/>
                          <a:moveTo>
                            <a:pt x="0" y="414"/>
                          </a:moveTo>
                          <a:lnTo>
                            <a:pt x="36" y="414"/>
                          </a:lnTo>
                          <a:lnTo>
                            <a:pt x="0" y="414"/>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170" name="Freeform 99"/>
                    <p:cNvSpPr>
                      <a:spLocks noEditPoints="1"/>
                    </p:cNvSpPr>
                    <p:nvPr/>
                  </p:nvSpPr>
                  <p:spPr bwMode="auto">
                    <a:xfrm>
                      <a:off x="2681355" y="1234472"/>
                      <a:ext cx="34127" cy="343634"/>
                    </a:xfrm>
                    <a:custGeom>
                      <a:avLst/>
                      <a:gdLst/>
                      <a:ahLst/>
                      <a:cxnLst>
                        <a:cxn ang="0">
                          <a:pos x="15" y="417"/>
                        </a:cxn>
                        <a:cxn ang="0">
                          <a:pos x="15" y="210"/>
                        </a:cxn>
                        <a:cxn ang="0">
                          <a:pos x="15" y="3"/>
                        </a:cxn>
                        <a:cxn ang="0">
                          <a:pos x="21" y="3"/>
                        </a:cxn>
                        <a:cxn ang="0">
                          <a:pos x="21" y="210"/>
                        </a:cxn>
                        <a:cxn ang="0">
                          <a:pos x="21" y="417"/>
                        </a:cxn>
                        <a:cxn ang="0">
                          <a:pos x="15" y="417"/>
                        </a:cxn>
                        <a:cxn ang="0">
                          <a:pos x="0" y="414"/>
                        </a:cxn>
                        <a:cxn ang="0">
                          <a:pos x="36" y="414"/>
                        </a:cxn>
                        <a:cxn ang="0">
                          <a:pos x="36" y="420"/>
                        </a:cxn>
                        <a:cxn ang="0">
                          <a:pos x="0" y="420"/>
                        </a:cxn>
                        <a:cxn ang="0">
                          <a:pos x="0" y="414"/>
                        </a:cxn>
                        <a:cxn ang="0">
                          <a:pos x="0" y="0"/>
                        </a:cxn>
                        <a:cxn ang="0">
                          <a:pos x="36" y="0"/>
                        </a:cxn>
                        <a:cxn ang="0">
                          <a:pos x="36" y="6"/>
                        </a:cxn>
                        <a:cxn ang="0">
                          <a:pos x="0" y="6"/>
                        </a:cxn>
                        <a:cxn ang="0">
                          <a:pos x="0" y="0"/>
                        </a:cxn>
                      </a:cxnLst>
                      <a:rect l="0" t="0" r="r" b="b"/>
                      <a:pathLst>
                        <a:path w="36" h="420">
                          <a:moveTo>
                            <a:pt x="15" y="417"/>
                          </a:moveTo>
                          <a:lnTo>
                            <a:pt x="15" y="210"/>
                          </a:lnTo>
                          <a:lnTo>
                            <a:pt x="15" y="3"/>
                          </a:lnTo>
                          <a:lnTo>
                            <a:pt x="21" y="3"/>
                          </a:lnTo>
                          <a:lnTo>
                            <a:pt x="21" y="210"/>
                          </a:lnTo>
                          <a:lnTo>
                            <a:pt x="21" y="417"/>
                          </a:lnTo>
                          <a:lnTo>
                            <a:pt x="15" y="417"/>
                          </a:lnTo>
                          <a:close/>
                          <a:moveTo>
                            <a:pt x="0" y="414"/>
                          </a:moveTo>
                          <a:lnTo>
                            <a:pt x="36" y="414"/>
                          </a:lnTo>
                          <a:lnTo>
                            <a:pt x="36" y="420"/>
                          </a:lnTo>
                          <a:lnTo>
                            <a:pt x="0" y="420"/>
                          </a:lnTo>
                          <a:lnTo>
                            <a:pt x="0" y="414"/>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71" name="Freeform 100"/>
                    <p:cNvSpPr>
                      <a:spLocks noEditPoints="1"/>
                    </p:cNvSpPr>
                    <p:nvPr/>
                  </p:nvSpPr>
                  <p:spPr bwMode="auto">
                    <a:xfrm>
                      <a:off x="2880664" y="2181046"/>
                      <a:ext cx="34127" cy="4909"/>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172" name="Freeform 101"/>
                    <p:cNvSpPr>
                      <a:spLocks noEditPoints="1"/>
                    </p:cNvSpPr>
                    <p:nvPr/>
                  </p:nvSpPr>
                  <p:spPr bwMode="auto">
                    <a:xfrm>
                      <a:off x="2880664" y="2176218"/>
                      <a:ext cx="34127" cy="9818"/>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73" name="Freeform 102"/>
                    <p:cNvSpPr>
                      <a:spLocks noEditPoints="1"/>
                    </p:cNvSpPr>
                    <p:nvPr/>
                  </p:nvSpPr>
                  <p:spPr bwMode="auto">
                    <a:xfrm>
                      <a:off x="3076801" y="1948575"/>
                      <a:ext cx="34127" cy="78544"/>
                    </a:xfrm>
                    <a:custGeom>
                      <a:avLst/>
                      <a:gdLst/>
                      <a:ahLst/>
                      <a:cxnLst>
                        <a:cxn ang="0">
                          <a:pos x="18" y="96"/>
                        </a:cxn>
                        <a:cxn ang="0">
                          <a:pos x="18" y="48"/>
                        </a:cxn>
                        <a:cxn ang="0">
                          <a:pos x="18" y="0"/>
                        </a:cxn>
                        <a:cxn ang="0">
                          <a:pos x="18" y="96"/>
                        </a:cxn>
                        <a:cxn ang="0">
                          <a:pos x="0" y="96"/>
                        </a:cxn>
                        <a:cxn ang="0">
                          <a:pos x="36" y="96"/>
                        </a:cxn>
                        <a:cxn ang="0">
                          <a:pos x="0" y="96"/>
                        </a:cxn>
                        <a:cxn ang="0">
                          <a:pos x="0" y="0"/>
                        </a:cxn>
                        <a:cxn ang="0">
                          <a:pos x="36" y="0"/>
                        </a:cxn>
                        <a:cxn ang="0">
                          <a:pos x="0" y="0"/>
                        </a:cxn>
                      </a:cxnLst>
                      <a:rect l="0" t="0" r="r" b="b"/>
                      <a:pathLst>
                        <a:path w="36" h="96">
                          <a:moveTo>
                            <a:pt x="18" y="96"/>
                          </a:moveTo>
                          <a:lnTo>
                            <a:pt x="18" y="48"/>
                          </a:lnTo>
                          <a:lnTo>
                            <a:pt x="18" y="0"/>
                          </a:lnTo>
                          <a:lnTo>
                            <a:pt x="18" y="96"/>
                          </a:lnTo>
                          <a:close/>
                          <a:moveTo>
                            <a:pt x="0" y="96"/>
                          </a:moveTo>
                          <a:lnTo>
                            <a:pt x="36" y="96"/>
                          </a:lnTo>
                          <a:lnTo>
                            <a:pt x="0" y="9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174" name="Freeform 103"/>
                    <p:cNvSpPr>
                      <a:spLocks noEditPoints="1"/>
                    </p:cNvSpPr>
                    <p:nvPr/>
                  </p:nvSpPr>
                  <p:spPr bwMode="auto">
                    <a:xfrm>
                      <a:off x="3076801" y="1942957"/>
                      <a:ext cx="34127" cy="83454"/>
                    </a:xfrm>
                    <a:custGeom>
                      <a:avLst/>
                      <a:gdLst/>
                      <a:ahLst/>
                      <a:cxnLst>
                        <a:cxn ang="0">
                          <a:pos x="15" y="99"/>
                        </a:cxn>
                        <a:cxn ang="0">
                          <a:pos x="15" y="51"/>
                        </a:cxn>
                        <a:cxn ang="0">
                          <a:pos x="15" y="3"/>
                        </a:cxn>
                        <a:cxn ang="0">
                          <a:pos x="21" y="3"/>
                        </a:cxn>
                        <a:cxn ang="0">
                          <a:pos x="21" y="51"/>
                        </a:cxn>
                        <a:cxn ang="0">
                          <a:pos x="21" y="99"/>
                        </a:cxn>
                        <a:cxn ang="0">
                          <a:pos x="15" y="99"/>
                        </a:cxn>
                        <a:cxn ang="0">
                          <a:pos x="0" y="96"/>
                        </a:cxn>
                        <a:cxn ang="0">
                          <a:pos x="36" y="96"/>
                        </a:cxn>
                        <a:cxn ang="0">
                          <a:pos x="36" y="102"/>
                        </a:cxn>
                        <a:cxn ang="0">
                          <a:pos x="0" y="102"/>
                        </a:cxn>
                        <a:cxn ang="0">
                          <a:pos x="0" y="96"/>
                        </a:cxn>
                        <a:cxn ang="0">
                          <a:pos x="0" y="0"/>
                        </a:cxn>
                        <a:cxn ang="0">
                          <a:pos x="36" y="0"/>
                        </a:cxn>
                        <a:cxn ang="0">
                          <a:pos x="36" y="6"/>
                        </a:cxn>
                        <a:cxn ang="0">
                          <a:pos x="0" y="6"/>
                        </a:cxn>
                        <a:cxn ang="0">
                          <a:pos x="0" y="0"/>
                        </a:cxn>
                      </a:cxnLst>
                      <a:rect l="0" t="0" r="r" b="b"/>
                      <a:pathLst>
                        <a:path w="36" h="102">
                          <a:moveTo>
                            <a:pt x="15" y="99"/>
                          </a:moveTo>
                          <a:lnTo>
                            <a:pt x="15" y="51"/>
                          </a:lnTo>
                          <a:lnTo>
                            <a:pt x="15" y="3"/>
                          </a:lnTo>
                          <a:lnTo>
                            <a:pt x="21" y="3"/>
                          </a:lnTo>
                          <a:lnTo>
                            <a:pt x="21" y="51"/>
                          </a:lnTo>
                          <a:lnTo>
                            <a:pt x="21" y="99"/>
                          </a:lnTo>
                          <a:lnTo>
                            <a:pt x="15" y="99"/>
                          </a:lnTo>
                          <a:close/>
                          <a:moveTo>
                            <a:pt x="0" y="96"/>
                          </a:moveTo>
                          <a:lnTo>
                            <a:pt x="36" y="96"/>
                          </a:lnTo>
                          <a:lnTo>
                            <a:pt x="36" y="102"/>
                          </a:lnTo>
                          <a:lnTo>
                            <a:pt x="0" y="102"/>
                          </a:lnTo>
                          <a:lnTo>
                            <a:pt x="0" y="9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75" name="Freeform 104"/>
                    <p:cNvSpPr>
                      <a:spLocks noEditPoints="1"/>
                    </p:cNvSpPr>
                    <p:nvPr/>
                  </p:nvSpPr>
                  <p:spPr bwMode="auto">
                    <a:xfrm>
                      <a:off x="3270875" y="2166318"/>
                      <a:ext cx="34127" cy="9818"/>
                    </a:xfrm>
                    <a:custGeom>
                      <a:avLst/>
                      <a:gdLst/>
                      <a:ahLst/>
                      <a:cxnLst>
                        <a:cxn ang="0">
                          <a:pos x="18" y="12"/>
                        </a:cxn>
                        <a:cxn ang="0">
                          <a:pos x="18" y="6"/>
                        </a:cxn>
                        <a:cxn ang="0">
                          <a:pos x="18" y="0"/>
                        </a:cxn>
                        <a:cxn ang="0">
                          <a:pos x="18" y="12"/>
                        </a:cxn>
                        <a:cxn ang="0">
                          <a:pos x="0" y="12"/>
                        </a:cxn>
                        <a:cxn ang="0">
                          <a:pos x="36" y="12"/>
                        </a:cxn>
                        <a:cxn ang="0">
                          <a:pos x="0" y="12"/>
                        </a:cxn>
                        <a:cxn ang="0">
                          <a:pos x="0" y="0"/>
                        </a:cxn>
                        <a:cxn ang="0">
                          <a:pos x="36" y="0"/>
                        </a:cxn>
                        <a:cxn ang="0">
                          <a:pos x="0" y="0"/>
                        </a:cxn>
                      </a:cxnLst>
                      <a:rect l="0" t="0" r="r" b="b"/>
                      <a:pathLst>
                        <a:path w="36" h="12">
                          <a:moveTo>
                            <a:pt x="18" y="12"/>
                          </a:moveTo>
                          <a:lnTo>
                            <a:pt x="18" y="6"/>
                          </a:lnTo>
                          <a:lnTo>
                            <a:pt x="18" y="0"/>
                          </a:lnTo>
                          <a:lnTo>
                            <a:pt x="18" y="12"/>
                          </a:lnTo>
                          <a:close/>
                          <a:moveTo>
                            <a:pt x="0" y="12"/>
                          </a:moveTo>
                          <a:lnTo>
                            <a:pt x="36" y="12"/>
                          </a:lnTo>
                          <a:lnTo>
                            <a:pt x="0" y="12"/>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176" name="Freeform 105"/>
                    <p:cNvSpPr>
                      <a:spLocks noEditPoints="1"/>
                    </p:cNvSpPr>
                    <p:nvPr/>
                  </p:nvSpPr>
                  <p:spPr bwMode="auto">
                    <a:xfrm>
                      <a:off x="3270875" y="2155954"/>
                      <a:ext cx="34127" cy="14727"/>
                    </a:xfrm>
                    <a:custGeom>
                      <a:avLst/>
                      <a:gdLst/>
                      <a:ahLst/>
                      <a:cxnLst>
                        <a:cxn ang="0">
                          <a:pos x="15" y="15"/>
                        </a:cxn>
                        <a:cxn ang="0">
                          <a:pos x="15" y="9"/>
                        </a:cxn>
                        <a:cxn ang="0">
                          <a:pos x="15" y="3"/>
                        </a:cxn>
                        <a:cxn ang="0">
                          <a:pos x="21" y="3"/>
                        </a:cxn>
                        <a:cxn ang="0">
                          <a:pos x="21" y="9"/>
                        </a:cxn>
                        <a:cxn ang="0">
                          <a:pos x="21" y="15"/>
                        </a:cxn>
                        <a:cxn ang="0">
                          <a:pos x="15" y="15"/>
                        </a:cxn>
                        <a:cxn ang="0">
                          <a:pos x="0" y="12"/>
                        </a:cxn>
                        <a:cxn ang="0">
                          <a:pos x="36" y="12"/>
                        </a:cxn>
                        <a:cxn ang="0">
                          <a:pos x="36" y="18"/>
                        </a:cxn>
                        <a:cxn ang="0">
                          <a:pos x="0" y="18"/>
                        </a:cxn>
                        <a:cxn ang="0">
                          <a:pos x="0" y="12"/>
                        </a:cxn>
                        <a:cxn ang="0">
                          <a:pos x="0" y="0"/>
                        </a:cxn>
                        <a:cxn ang="0">
                          <a:pos x="36" y="0"/>
                        </a:cxn>
                        <a:cxn ang="0">
                          <a:pos x="36" y="6"/>
                        </a:cxn>
                        <a:cxn ang="0">
                          <a:pos x="0" y="6"/>
                        </a:cxn>
                        <a:cxn ang="0">
                          <a:pos x="0" y="0"/>
                        </a:cxn>
                      </a:cxnLst>
                      <a:rect l="0" t="0" r="r" b="b"/>
                      <a:pathLst>
                        <a:path w="36" h="18">
                          <a:moveTo>
                            <a:pt x="15" y="15"/>
                          </a:moveTo>
                          <a:lnTo>
                            <a:pt x="15" y="9"/>
                          </a:lnTo>
                          <a:lnTo>
                            <a:pt x="15" y="3"/>
                          </a:lnTo>
                          <a:lnTo>
                            <a:pt x="21" y="3"/>
                          </a:lnTo>
                          <a:lnTo>
                            <a:pt x="21" y="9"/>
                          </a:lnTo>
                          <a:lnTo>
                            <a:pt x="21" y="15"/>
                          </a:lnTo>
                          <a:lnTo>
                            <a:pt x="15" y="15"/>
                          </a:lnTo>
                          <a:close/>
                          <a:moveTo>
                            <a:pt x="0" y="12"/>
                          </a:moveTo>
                          <a:lnTo>
                            <a:pt x="36" y="12"/>
                          </a:lnTo>
                          <a:lnTo>
                            <a:pt x="36" y="18"/>
                          </a:lnTo>
                          <a:lnTo>
                            <a:pt x="0" y="18"/>
                          </a:lnTo>
                          <a:lnTo>
                            <a:pt x="0" y="12"/>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201" name="Rectangle 130"/>
                    <p:cNvSpPr>
                      <a:spLocks noChangeArrowheads="1"/>
                    </p:cNvSpPr>
                    <p:nvPr/>
                  </p:nvSpPr>
                  <p:spPr bwMode="auto">
                    <a:xfrm>
                      <a:off x="1848416" y="2076674"/>
                      <a:ext cx="152239"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e</a:t>
                      </a:r>
                      <a:endParaRPr lang="en-US" sz="800">
                        <a:latin typeface="Arial" pitchFamily="34" charset="0"/>
                        <a:cs typeface="Arial" pitchFamily="34" charset="0"/>
                      </a:endParaRPr>
                    </a:p>
                  </p:txBody>
                </p:sp>
                <p:sp>
                  <p:nvSpPr>
                    <p:cNvPr id="1202" name="Rectangle 131"/>
                    <p:cNvSpPr>
                      <a:spLocks noChangeArrowheads="1"/>
                    </p:cNvSpPr>
                    <p:nvPr/>
                  </p:nvSpPr>
                  <p:spPr bwMode="auto">
                    <a:xfrm>
                      <a:off x="2035068" y="2076288"/>
                      <a:ext cx="156099"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e</a:t>
                      </a:r>
                      <a:endParaRPr lang="en-US" sz="800">
                        <a:latin typeface="Arial" pitchFamily="34" charset="0"/>
                        <a:cs typeface="Arial" pitchFamily="34" charset="0"/>
                      </a:endParaRPr>
                    </a:p>
                  </p:txBody>
                </p:sp>
                <p:sp>
                  <p:nvSpPr>
                    <p:cNvPr id="1203" name="Rectangle 132"/>
                    <p:cNvSpPr>
                      <a:spLocks noChangeArrowheads="1"/>
                    </p:cNvSpPr>
                    <p:nvPr/>
                  </p:nvSpPr>
                  <p:spPr bwMode="auto">
                    <a:xfrm>
                      <a:off x="2221562" y="2050532"/>
                      <a:ext cx="152239"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d</a:t>
                      </a:r>
                      <a:endParaRPr lang="en-US" sz="800">
                        <a:latin typeface="Arial" pitchFamily="34" charset="0"/>
                        <a:cs typeface="Arial" pitchFamily="34" charset="0"/>
                      </a:endParaRPr>
                    </a:p>
                  </p:txBody>
                </p:sp>
                <p:sp>
                  <p:nvSpPr>
                    <p:cNvPr id="1204" name="Rectangle 133"/>
                    <p:cNvSpPr>
                      <a:spLocks noChangeArrowheads="1"/>
                    </p:cNvSpPr>
                    <p:nvPr/>
                  </p:nvSpPr>
                  <p:spPr bwMode="auto">
                    <a:xfrm>
                      <a:off x="2437976" y="2062999"/>
                      <a:ext cx="124536"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d</a:t>
                      </a:r>
                      <a:endParaRPr lang="en-US" sz="800">
                        <a:latin typeface="Arial" pitchFamily="34" charset="0"/>
                        <a:cs typeface="Arial" pitchFamily="34" charset="0"/>
                      </a:endParaRPr>
                    </a:p>
                  </p:txBody>
                </p:sp>
                <p:sp>
                  <p:nvSpPr>
                    <p:cNvPr id="1205" name="Rectangle 134"/>
                    <p:cNvSpPr>
                      <a:spLocks noChangeArrowheads="1"/>
                    </p:cNvSpPr>
                    <p:nvPr/>
                  </p:nvSpPr>
                  <p:spPr bwMode="auto">
                    <a:xfrm>
                      <a:off x="2676965" y="1107961"/>
                      <a:ext cx="50494"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a</a:t>
                      </a:r>
                      <a:endParaRPr lang="en-US" sz="800">
                        <a:latin typeface="Arial" pitchFamily="34" charset="0"/>
                        <a:cs typeface="Arial" pitchFamily="34" charset="0"/>
                      </a:endParaRPr>
                    </a:p>
                  </p:txBody>
                </p:sp>
                <p:sp>
                  <p:nvSpPr>
                    <p:cNvPr id="1206" name="Rectangle 135"/>
                    <p:cNvSpPr>
                      <a:spLocks noChangeArrowheads="1"/>
                    </p:cNvSpPr>
                    <p:nvPr/>
                  </p:nvSpPr>
                  <p:spPr bwMode="auto">
                    <a:xfrm>
                      <a:off x="2818617" y="2060591"/>
                      <a:ext cx="15811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d</a:t>
                      </a:r>
                      <a:endParaRPr lang="en-US" sz="800">
                        <a:latin typeface="Arial" pitchFamily="34" charset="0"/>
                        <a:cs typeface="Arial" pitchFamily="34" charset="0"/>
                      </a:endParaRPr>
                    </a:p>
                  </p:txBody>
                </p:sp>
                <p:sp>
                  <p:nvSpPr>
                    <p:cNvPr id="1207" name="Rectangle 136"/>
                    <p:cNvSpPr>
                      <a:spLocks noChangeArrowheads="1"/>
                    </p:cNvSpPr>
                    <p:nvPr/>
                  </p:nvSpPr>
                  <p:spPr bwMode="auto">
                    <a:xfrm>
                      <a:off x="3020791" y="1822468"/>
                      <a:ext cx="151469"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b</a:t>
                      </a:r>
                      <a:endParaRPr lang="en-US" sz="800">
                        <a:latin typeface="Arial" pitchFamily="34" charset="0"/>
                        <a:cs typeface="Arial" pitchFamily="34" charset="0"/>
                      </a:endParaRPr>
                    </a:p>
                  </p:txBody>
                </p:sp>
                <p:sp>
                  <p:nvSpPr>
                    <p:cNvPr id="1208" name="Rectangle 137"/>
                    <p:cNvSpPr>
                      <a:spLocks noChangeArrowheads="1"/>
                    </p:cNvSpPr>
                    <p:nvPr/>
                  </p:nvSpPr>
                  <p:spPr bwMode="auto">
                    <a:xfrm>
                      <a:off x="3211114" y="2037171"/>
                      <a:ext cx="152239"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c</a:t>
                      </a:r>
                      <a:endParaRPr lang="en-US" sz="800">
                        <a:latin typeface="Arial" pitchFamily="34" charset="0"/>
                        <a:cs typeface="Arial" pitchFamily="34" charset="0"/>
                      </a:endParaRPr>
                    </a:p>
                  </p:txBody>
                </p:sp>
                <p:sp>
                  <p:nvSpPr>
                    <p:cNvPr id="1330" name="Rectangle 206"/>
                    <p:cNvSpPr>
                      <a:spLocks noChangeArrowheads="1"/>
                    </p:cNvSpPr>
                    <p:nvPr/>
                  </p:nvSpPr>
                  <p:spPr bwMode="auto">
                    <a:xfrm>
                      <a:off x="2643388" y="2182054"/>
                      <a:ext cx="143884"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a</a:t>
                      </a:r>
                      <a:endParaRPr lang="en-US" sz="800">
                        <a:latin typeface="Arial" pitchFamily="34" charset="0"/>
                        <a:cs typeface="Arial" pitchFamily="34" charset="0"/>
                      </a:endParaRPr>
                    </a:p>
                  </p:txBody>
                </p:sp>
              </p:grpSp>
              <p:grpSp>
                <p:nvGrpSpPr>
                  <p:cNvPr id="248" name="Group 247"/>
                  <p:cNvGrpSpPr/>
                  <p:nvPr/>
                </p:nvGrpSpPr>
                <p:grpSpPr>
                  <a:xfrm>
                    <a:off x="689961" y="1879600"/>
                    <a:ext cx="1822305" cy="1209950"/>
                    <a:chOff x="1585448" y="4375791"/>
                    <a:chExt cx="1822305" cy="1209950"/>
                  </a:xfrm>
                </p:grpSpPr>
                <p:sp>
                  <p:nvSpPr>
                    <p:cNvPr id="699" name="Rectangle 43"/>
                    <p:cNvSpPr>
                      <a:spLocks noChangeArrowheads="1"/>
                    </p:cNvSpPr>
                    <p:nvPr/>
                  </p:nvSpPr>
                  <p:spPr bwMode="auto">
                    <a:xfrm>
                      <a:off x="1682457" y="5402467"/>
                      <a:ext cx="58910"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0</a:t>
                      </a:r>
                      <a:endParaRPr lang="en-US" sz="800">
                        <a:latin typeface="Calibri "/>
                        <a:cs typeface="Arial" pitchFamily="34" charset="0"/>
                      </a:endParaRPr>
                    </a:p>
                  </p:txBody>
                </p:sp>
                <p:sp>
                  <p:nvSpPr>
                    <p:cNvPr id="698" name="Freeform 40"/>
                    <p:cNvSpPr>
                      <a:spLocks noEditPoints="1"/>
                    </p:cNvSpPr>
                    <p:nvPr/>
                  </p:nvSpPr>
                  <p:spPr bwMode="auto">
                    <a:xfrm>
                      <a:off x="1756710" y="4569762"/>
                      <a:ext cx="25461" cy="869563"/>
                    </a:xfrm>
                    <a:custGeom>
                      <a:avLst/>
                      <a:gdLst/>
                      <a:ahLst/>
                      <a:cxnLst>
                        <a:cxn ang="0">
                          <a:pos x="0" y="1044"/>
                        </a:cxn>
                        <a:cxn ang="0">
                          <a:pos x="30" y="1044"/>
                        </a:cxn>
                        <a:cxn ang="0">
                          <a:pos x="30" y="1050"/>
                        </a:cxn>
                        <a:cxn ang="0">
                          <a:pos x="0" y="1050"/>
                        </a:cxn>
                        <a:cxn ang="0">
                          <a:pos x="0" y="1044"/>
                        </a:cxn>
                        <a:cxn ang="0">
                          <a:pos x="0" y="522"/>
                        </a:cxn>
                        <a:cxn ang="0">
                          <a:pos x="30" y="522"/>
                        </a:cxn>
                        <a:cxn ang="0">
                          <a:pos x="30" y="528"/>
                        </a:cxn>
                        <a:cxn ang="0">
                          <a:pos x="0" y="528"/>
                        </a:cxn>
                        <a:cxn ang="0">
                          <a:pos x="0" y="522"/>
                        </a:cxn>
                        <a:cxn ang="0">
                          <a:pos x="0" y="0"/>
                        </a:cxn>
                        <a:cxn ang="0">
                          <a:pos x="30" y="0"/>
                        </a:cxn>
                        <a:cxn ang="0">
                          <a:pos x="30" y="6"/>
                        </a:cxn>
                        <a:cxn ang="0">
                          <a:pos x="0" y="6"/>
                        </a:cxn>
                        <a:cxn ang="0">
                          <a:pos x="0" y="0"/>
                        </a:cxn>
                      </a:cxnLst>
                      <a:rect l="0" t="0" r="r" b="b"/>
                      <a:pathLst>
                        <a:path w="30" h="1050">
                          <a:moveTo>
                            <a:pt x="0" y="1044"/>
                          </a:moveTo>
                          <a:lnTo>
                            <a:pt x="30" y="1044"/>
                          </a:lnTo>
                          <a:lnTo>
                            <a:pt x="30" y="1050"/>
                          </a:lnTo>
                          <a:lnTo>
                            <a:pt x="0" y="1050"/>
                          </a:lnTo>
                          <a:lnTo>
                            <a:pt x="0" y="1044"/>
                          </a:lnTo>
                          <a:close/>
                          <a:moveTo>
                            <a:pt x="0" y="522"/>
                          </a:moveTo>
                          <a:lnTo>
                            <a:pt x="30" y="522"/>
                          </a:lnTo>
                          <a:lnTo>
                            <a:pt x="30" y="528"/>
                          </a:lnTo>
                          <a:lnTo>
                            <a:pt x="0" y="528"/>
                          </a:lnTo>
                          <a:lnTo>
                            <a:pt x="0" y="522"/>
                          </a:lnTo>
                          <a:close/>
                          <a:moveTo>
                            <a:pt x="0" y="0"/>
                          </a:moveTo>
                          <a:lnTo>
                            <a:pt x="30" y="0"/>
                          </a:lnTo>
                          <a:lnTo>
                            <a:pt x="30" y="6"/>
                          </a:lnTo>
                          <a:lnTo>
                            <a:pt x="0" y="6"/>
                          </a:lnTo>
                          <a:lnTo>
                            <a:pt x="0" y="0"/>
                          </a:lnTo>
                          <a:close/>
                        </a:path>
                      </a:pathLst>
                    </a:custGeom>
                    <a:solidFill>
                      <a:schemeClr val="tx1"/>
                    </a:solidFill>
                    <a:ln w="635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sz="800">
                        <a:latin typeface="Calibri "/>
                      </a:endParaRPr>
                    </a:p>
                  </p:txBody>
                </p:sp>
                <p:sp>
                  <p:nvSpPr>
                    <p:cNvPr id="700" name="Rectangle 44"/>
                    <p:cNvSpPr>
                      <a:spLocks noChangeArrowheads="1"/>
                    </p:cNvSpPr>
                    <p:nvPr/>
                  </p:nvSpPr>
                  <p:spPr bwMode="auto">
                    <a:xfrm>
                      <a:off x="1588620" y="4972518"/>
                      <a:ext cx="117818"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40</a:t>
                      </a:r>
                      <a:endParaRPr lang="en-US" sz="800">
                        <a:latin typeface="Calibri "/>
                        <a:cs typeface="Arial" pitchFamily="34" charset="0"/>
                      </a:endParaRPr>
                    </a:p>
                  </p:txBody>
                </p:sp>
                <p:sp>
                  <p:nvSpPr>
                    <p:cNvPr id="701" name="Rectangle 45"/>
                    <p:cNvSpPr>
                      <a:spLocks noChangeArrowheads="1"/>
                    </p:cNvSpPr>
                    <p:nvPr/>
                  </p:nvSpPr>
                  <p:spPr bwMode="auto">
                    <a:xfrm>
                      <a:off x="1585448" y="4540389"/>
                      <a:ext cx="117818"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80</a:t>
                      </a:r>
                      <a:endParaRPr lang="en-US" sz="800">
                        <a:latin typeface="Calibri "/>
                        <a:cs typeface="Arial" pitchFamily="34" charset="0"/>
                      </a:endParaRPr>
                    </a:p>
                  </p:txBody>
                </p:sp>
                <p:sp>
                  <p:nvSpPr>
                    <p:cNvPr id="702" name="Rectangle 62"/>
                    <p:cNvSpPr>
                      <a:spLocks noChangeArrowheads="1"/>
                    </p:cNvSpPr>
                    <p:nvPr/>
                  </p:nvSpPr>
                  <p:spPr bwMode="auto">
                    <a:xfrm>
                      <a:off x="1896493" y="4523616"/>
                      <a:ext cx="288536"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b="1" i="1">
                          <a:solidFill>
                            <a:srgbClr val="000000"/>
                          </a:solidFill>
                          <a:latin typeface="Calibri "/>
                          <a:cs typeface="Arial" pitchFamily="34" charset="0"/>
                        </a:rPr>
                        <a:t>PCO1</a:t>
                      </a:r>
                      <a:endParaRPr lang="en-US" sz="800" b="1" i="1">
                        <a:latin typeface="Calibri "/>
                        <a:cs typeface="Arial" pitchFamily="34" charset="0"/>
                      </a:endParaRPr>
                    </a:p>
                  </p:txBody>
                </p:sp>
                <p:cxnSp>
                  <p:nvCxnSpPr>
                    <p:cNvPr id="711" name="Straight Connector 710"/>
                    <p:cNvCxnSpPr/>
                    <p:nvPr/>
                  </p:nvCxnSpPr>
                  <p:spPr>
                    <a:xfrm>
                      <a:off x="1785379" y="5436244"/>
                      <a:ext cx="162237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2" name="Straight Connector 711"/>
                    <p:cNvCxnSpPr/>
                    <p:nvPr/>
                  </p:nvCxnSpPr>
                  <p:spPr>
                    <a:xfrm>
                      <a:off x="1786365" y="4524154"/>
                      <a:ext cx="0" cy="91317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13" name="Rectangle 46"/>
                    <p:cNvSpPr>
                      <a:spLocks noChangeArrowheads="1"/>
                    </p:cNvSpPr>
                    <p:nvPr/>
                  </p:nvSpPr>
                  <p:spPr bwMode="auto">
                    <a:xfrm>
                      <a:off x="2031974" y="5459073"/>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14" name="Rectangle 46"/>
                    <p:cNvSpPr>
                      <a:spLocks noChangeArrowheads="1"/>
                    </p:cNvSpPr>
                    <p:nvPr/>
                  </p:nvSpPr>
                  <p:spPr bwMode="auto">
                    <a:xfrm>
                      <a:off x="2417288" y="5459073"/>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15" name="Rectangle 46"/>
                    <p:cNvSpPr>
                      <a:spLocks noChangeArrowheads="1"/>
                    </p:cNvSpPr>
                    <p:nvPr/>
                  </p:nvSpPr>
                  <p:spPr bwMode="auto">
                    <a:xfrm>
                      <a:off x="2809362" y="5459073"/>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16" name="Rectangle 46"/>
                    <p:cNvSpPr>
                      <a:spLocks noChangeArrowheads="1"/>
                    </p:cNvSpPr>
                    <p:nvPr/>
                  </p:nvSpPr>
                  <p:spPr bwMode="auto">
                    <a:xfrm>
                      <a:off x="3201436" y="5459073"/>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1097" name="Rectangle 73"/>
                    <p:cNvSpPr>
                      <a:spLocks noChangeArrowheads="1"/>
                    </p:cNvSpPr>
                    <p:nvPr/>
                  </p:nvSpPr>
                  <p:spPr bwMode="auto">
                    <a:xfrm>
                      <a:off x="1870186" y="5414046"/>
                      <a:ext cx="122270" cy="14975"/>
                    </a:xfrm>
                    <a:prstGeom prst="rect">
                      <a:avLst/>
                    </a:prstGeom>
                    <a:solidFill>
                      <a:srgbClr val="FDEAD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099" name="Rectangle 75"/>
                    <p:cNvSpPr>
                      <a:spLocks noChangeArrowheads="1"/>
                    </p:cNvSpPr>
                    <p:nvPr/>
                  </p:nvSpPr>
                  <p:spPr bwMode="auto">
                    <a:xfrm>
                      <a:off x="2072746" y="5414046"/>
                      <a:ext cx="122270" cy="14975"/>
                    </a:xfrm>
                    <a:prstGeom prst="rect">
                      <a:avLst/>
                    </a:prstGeom>
                    <a:solidFill>
                      <a:srgbClr val="EBF1DE"/>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01" name="Rectangle 77"/>
                    <p:cNvSpPr>
                      <a:spLocks noChangeArrowheads="1"/>
                    </p:cNvSpPr>
                    <p:nvPr/>
                  </p:nvSpPr>
                  <p:spPr bwMode="auto">
                    <a:xfrm>
                      <a:off x="2257630" y="5234344"/>
                      <a:ext cx="122270" cy="194676"/>
                    </a:xfrm>
                    <a:prstGeom prst="rect">
                      <a:avLst/>
                    </a:prstGeom>
                    <a:solidFill>
                      <a:srgbClr val="FCD5B5"/>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03" name="Rectangle 79"/>
                    <p:cNvSpPr>
                      <a:spLocks noChangeArrowheads="1"/>
                    </p:cNvSpPr>
                    <p:nvPr/>
                  </p:nvSpPr>
                  <p:spPr bwMode="auto">
                    <a:xfrm>
                      <a:off x="2444966" y="5279270"/>
                      <a:ext cx="122270" cy="149750"/>
                    </a:xfrm>
                    <a:prstGeom prst="rect">
                      <a:avLst/>
                    </a:prstGeom>
                    <a:solidFill>
                      <a:srgbClr val="D7E4BD"/>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05" name="Rectangle 81"/>
                    <p:cNvSpPr>
                      <a:spLocks noChangeArrowheads="1"/>
                    </p:cNvSpPr>
                    <p:nvPr/>
                  </p:nvSpPr>
                  <p:spPr bwMode="auto">
                    <a:xfrm>
                      <a:off x="2647526" y="4600401"/>
                      <a:ext cx="122270" cy="828619"/>
                    </a:xfrm>
                    <a:prstGeom prst="rect">
                      <a:avLst/>
                    </a:prstGeom>
                    <a:solidFill>
                      <a:srgbClr val="FAC090"/>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07" name="Rectangle 83"/>
                    <p:cNvSpPr>
                      <a:spLocks noChangeArrowheads="1"/>
                    </p:cNvSpPr>
                    <p:nvPr/>
                  </p:nvSpPr>
                  <p:spPr bwMode="auto">
                    <a:xfrm>
                      <a:off x="2834862" y="5409054"/>
                      <a:ext cx="122270" cy="19967"/>
                    </a:xfrm>
                    <a:prstGeom prst="rect">
                      <a:avLst/>
                    </a:prstGeom>
                    <a:solidFill>
                      <a:srgbClr val="C3D69B"/>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09" name="Rectangle 85"/>
                    <p:cNvSpPr>
                      <a:spLocks noChangeArrowheads="1"/>
                    </p:cNvSpPr>
                    <p:nvPr/>
                  </p:nvSpPr>
                  <p:spPr bwMode="auto">
                    <a:xfrm>
                      <a:off x="3037424" y="4620368"/>
                      <a:ext cx="122270" cy="808653"/>
                    </a:xfrm>
                    <a:prstGeom prst="rect">
                      <a:avLst/>
                    </a:prstGeom>
                    <a:solidFill>
                      <a:srgbClr val="E46C0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1" name="Rectangle 87"/>
                    <p:cNvSpPr>
                      <a:spLocks noChangeArrowheads="1"/>
                    </p:cNvSpPr>
                    <p:nvPr/>
                  </p:nvSpPr>
                  <p:spPr bwMode="auto">
                    <a:xfrm>
                      <a:off x="3217146" y="5184428"/>
                      <a:ext cx="122270" cy="244592"/>
                    </a:xfrm>
                    <a:prstGeom prst="rect">
                      <a:avLst/>
                    </a:prstGeom>
                    <a:solidFill>
                      <a:srgbClr val="77933C"/>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93" name="Freeform 89"/>
                    <p:cNvSpPr>
                      <a:spLocks noEditPoints="1"/>
                    </p:cNvSpPr>
                    <p:nvPr/>
                  </p:nvSpPr>
                  <p:spPr bwMode="auto">
                    <a:xfrm>
                      <a:off x="1916632" y="5411672"/>
                      <a:ext cx="30964" cy="832"/>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94" name="Freeform 90"/>
                    <p:cNvSpPr>
                      <a:spLocks noEditPoints="1"/>
                    </p:cNvSpPr>
                    <p:nvPr/>
                  </p:nvSpPr>
                  <p:spPr bwMode="auto">
                    <a:xfrm>
                      <a:off x="2119191" y="5416665"/>
                      <a:ext cx="30964" cy="832"/>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95" name="Freeform 91"/>
                    <p:cNvSpPr>
                      <a:spLocks noEditPoints="1"/>
                    </p:cNvSpPr>
                    <p:nvPr/>
                  </p:nvSpPr>
                  <p:spPr bwMode="auto">
                    <a:xfrm>
                      <a:off x="2298917" y="5207013"/>
                      <a:ext cx="30964" cy="49917"/>
                    </a:xfrm>
                    <a:custGeom>
                      <a:avLst/>
                      <a:gdLst/>
                      <a:ahLst/>
                      <a:cxnLst>
                        <a:cxn ang="0">
                          <a:pos x="18" y="60"/>
                        </a:cxn>
                        <a:cxn ang="0">
                          <a:pos x="18" y="30"/>
                        </a:cxn>
                        <a:cxn ang="0">
                          <a:pos x="18" y="0"/>
                        </a:cxn>
                        <a:cxn ang="0">
                          <a:pos x="18" y="60"/>
                        </a:cxn>
                        <a:cxn ang="0">
                          <a:pos x="0" y="60"/>
                        </a:cxn>
                        <a:cxn ang="0">
                          <a:pos x="36" y="60"/>
                        </a:cxn>
                        <a:cxn ang="0">
                          <a:pos x="0" y="60"/>
                        </a:cxn>
                        <a:cxn ang="0">
                          <a:pos x="0" y="0"/>
                        </a:cxn>
                        <a:cxn ang="0">
                          <a:pos x="36" y="0"/>
                        </a:cxn>
                        <a:cxn ang="0">
                          <a:pos x="0" y="0"/>
                        </a:cxn>
                      </a:cxnLst>
                      <a:rect l="0" t="0" r="r" b="b"/>
                      <a:pathLst>
                        <a:path w="36" h="60">
                          <a:moveTo>
                            <a:pt x="18" y="60"/>
                          </a:moveTo>
                          <a:lnTo>
                            <a:pt x="18" y="30"/>
                          </a:lnTo>
                          <a:lnTo>
                            <a:pt x="18" y="0"/>
                          </a:lnTo>
                          <a:lnTo>
                            <a:pt x="18" y="60"/>
                          </a:lnTo>
                          <a:close/>
                          <a:moveTo>
                            <a:pt x="0" y="60"/>
                          </a:moveTo>
                          <a:lnTo>
                            <a:pt x="36" y="60"/>
                          </a:lnTo>
                          <a:lnTo>
                            <a:pt x="0" y="60"/>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28" name="Freeform 92"/>
                    <p:cNvSpPr>
                      <a:spLocks noEditPoints="1"/>
                    </p:cNvSpPr>
                    <p:nvPr/>
                  </p:nvSpPr>
                  <p:spPr bwMode="auto">
                    <a:xfrm>
                      <a:off x="2298917" y="5204518"/>
                      <a:ext cx="30964" cy="54908"/>
                    </a:xfrm>
                    <a:custGeom>
                      <a:avLst/>
                      <a:gdLst/>
                      <a:ahLst/>
                      <a:cxnLst>
                        <a:cxn ang="0">
                          <a:pos x="15" y="63"/>
                        </a:cxn>
                        <a:cxn ang="0">
                          <a:pos x="15" y="33"/>
                        </a:cxn>
                        <a:cxn ang="0">
                          <a:pos x="15" y="3"/>
                        </a:cxn>
                        <a:cxn ang="0">
                          <a:pos x="21" y="3"/>
                        </a:cxn>
                        <a:cxn ang="0">
                          <a:pos x="21" y="33"/>
                        </a:cxn>
                        <a:cxn ang="0">
                          <a:pos x="21" y="63"/>
                        </a:cxn>
                        <a:cxn ang="0">
                          <a:pos x="15" y="63"/>
                        </a:cxn>
                        <a:cxn ang="0">
                          <a:pos x="0" y="60"/>
                        </a:cxn>
                        <a:cxn ang="0">
                          <a:pos x="36" y="60"/>
                        </a:cxn>
                        <a:cxn ang="0">
                          <a:pos x="36" y="66"/>
                        </a:cxn>
                        <a:cxn ang="0">
                          <a:pos x="0" y="66"/>
                        </a:cxn>
                        <a:cxn ang="0">
                          <a:pos x="0" y="60"/>
                        </a:cxn>
                        <a:cxn ang="0">
                          <a:pos x="0" y="0"/>
                        </a:cxn>
                        <a:cxn ang="0">
                          <a:pos x="36" y="0"/>
                        </a:cxn>
                        <a:cxn ang="0">
                          <a:pos x="36" y="6"/>
                        </a:cxn>
                        <a:cxn ang="0">
                          <a:pos x="0" y="6"/>
                        </a:cxn>
                        <a:cxn ang="0">
                          <a:pos x="0" y="0"/>
                        </a:cxn>
                      </a:cxnLst>
                      <a:rect l="0" t="0" r="r" b="b"/>
                      <a:pathLst>
                        <a:path w="36" h="66">
                          <a:moveTo>
                            <a:pt x="15" y="63"/>
                          </a:moveTo>
                          <a:lnTo>
                            <a:pt x="15" y="33"/>
                          </a:lnTo>
                          <a:lnTo>
                            <a:pt x="15" y="3"/>
                          </a:lnTo>
                          <a:lnTo>
                            <a:pt x="21" y="3"/>
                          </a:lnTo>
                          <a:lnTo>
                            <a:pt x="21" y="33"/>
                          </a:lnTo>
                          <a:lnTo>
                            <a:pt x="21" y="63"/>
                          </a:lnTo>
                          <a:lnTo>
                            <a:pt x="15" y="63"/>
                          </a:lnTo>
                          <a:close/>
                          <a:moveTo>
                            <a:pt x="0" y="60"/>
                          </a:moveTo>
                          <a:lnTo>
                            <a:pt x="36" y="60"/>
                          </a:lnTo>
                          <a:lnTo>
                            <a:pt x="36" y="66"/>
                          </a:lnTo>
                          <a:lnTo>
                            <a:pt x="0" y="66"/>
                          </a:lnTo>
                          <a:lnTo>
                            <a:pt x="0" y="60"/>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29" name="Freeform 93"/>
                    <p:cNvSpPr>
                      <a:spLocks noEditPoints="1"/>
                    </p:cNvSpPr>
                    <p:nvPr/>
                  </p:nvSpPr>
                  <p:spPr bwMode="auto">
                    <a:xfrm>
                      <a:off x="2486253" y="5251938"/>
                      <a:ext cx="30964" cy="54908"/>
                    </a:xfrm>
                    <a:custGeom>
                      <a:avLst/>
                      <a:gdLst/>
                      <a:ahLst/>
                      <a:cxnLst>
                        <a:cxn ang="0">
                          <a:pos x="18" y="66"/>
                        </a:cxn>
                        <a:cxn ang="0">
                          <a:pos x="18" y="33"/>
                        </a:cxn>
                        <a:cxn ang="0">
                          <a:pos x="18" y="0"/>
                        </a:cxn>
                        <a:cxn ang="0">
                          <a:pos x="18" y="66"/>
                        </a:cxn>
                        <a:cxn ang="0">
                          <a:pos x="0" y="66"/>
                        </a:cxn>
                        <a:cxn ang="0">
                          <a:pos x="36" y="66"/>
                        </a:cxn>
                        <a:cxn ang="0">
                          <a:pos x="0" y="66"/>
                        </a:cxn>
                        <a:cxn ang="0">
                          <a:pos x="0" y="0"/>
                        </a:cxn>
                        <a:cxn ang="0">
                          <a:pos x="36" y="0"/>
                        </a:cxn>
                        <a:cxn ang="0">
                          <a:pos x="0" y="0"/>
                        </a:cxn>
                      </a:cxnLst>
                      <a:rect l="0" t="0" r="r" b="b"/>
                      <a:pathLst>
                        <a:path w="36" h="66">
                          <a:moveTo>
                            <a:pt x="18" y="66"/>
                          </a:moveTo>
                          <a:lnTo>
                            <a:pt x="18" y="33"/>
                          </a:lnTo>
                          <a:lnTo>
                            <a:pt x="18" y="0"/>
                          </a:lnTo>
                          <a:lnTo>
                            <a:pt x="18" y="66"/>
                          </a:lnTo>
                          <a:close/>
                          <a:moveTo>
                            <a:pt x="0" y="66"/>
                          </a:moveTo>
                          <a:lnTo>
                            <a:pt x="36" y="66"/>
                          </a:lnTo>
                          <a:lnTo>
                            <a:pt x="0" y="6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30" name="Freeform 94"/>
                    <p:cNvSpPr>
                      <a:spLocks noEditPoints="1"/>
                    </p:cNvSpPr>
                    <p:nvPr/>
                  </p:nvSpPr>
                  <p:spPr bwMode="auto">
                    <a:xfrm>
                      <a:off x="2486253" y="5249443"/>
                      <a:ext cx="30964" cy="59901"/>
                    </a:xfrm>
                    <a:custGeom>
                      <a:avLst/>
                      <a:gdLst/>
                      <a:ahLst/>
                      <a:cxnLst>
                        <a:cxn ang="0">
                          <a:pos x="15" y="69"/>
                        </a:cxn>
                        <a:cxn ang="0">
                          <a:pos x="15" y="36"/>
                        </a:cxn>
                        <a:cxn ang="0">
                          <a:pos x="15" y="3"/>
                        </a:cxn>
                        <a:cxn ang="0">
                          <a:pos x="21" y="3"/>
                        </a:cxn>
                        <a:cxn ang="0">
                          <a:pos x="21" y="36"/>
                        </a:cxn>
                        <a:cxn ang="0">
                          <a:pos x="21" y="69"/>
                        </a:cxn>
                        <a:cxn ang="0">
                          <a:pos x="15" y="69"/>
                        </a:cxn>
                        <a:cxn ang="0">
                          <a:pos x="0" y="66"/>
                        </a:cxn>
                        <a:cxn ang="0">
                          <a:pos x="36" y="66"/>
                        </a:cxn>
                        <a:cxn ang="0">
                          <a:pos x="36" y="72"/>
                        </a:cxn>
                        <a:cxn ang="0">
                          <a:pos x="0" y="72"/>
                        </a:cxn>
                        <a:cxn ang="0">
                          <a:pos x="0" y="66"/>
                        </a:cxn>
                        <a:cxn ang="0">
                          <a:pos x="0" y="0"/>
                        </a:cxn>
                        <a:cxn ang="0">
                          <a:pos x="36" y="0"/>
                        </a:cxn>
                        <a:cxn ang="0">
                          <a:pos x="36" y="6"/>
                        </a:cxn>
                        <a:cxn ang="0">
                          <a:pos x="0" y="6"/>
                        </a:cxn>
                        <a:cxn ang="0">
                          <a:pos x="0" y="0"/>
                        </a:cxn>
                      </a:cxnLst>
                      <a:rect l="0" t="0" r="r" b="b"/>
                      <a:pathLst>
                        <a:path w="36" h="72">
                          <a:moveTo>
                            <a:pt x="15" y="69"/>
                          </a:moveTo>
                          <a:lnTo>
                            <a:pt x="15" y="36"/>
                          </a:lnTo>
                          <a:lnTo>
                            <a:pt x="15" y="3"/>
                          </a:lnTo>
                          <a:lnTo>
                            <a:pt x="21" y="3"/>
                          </a:lnTo>
                          <a:lnTo>
                            <a:pt x="21" y="36"/>
                          </a:lnTo>
                          <a:lnTo>
                            <a:pt x="21" y="69"/>
                          </a:lnTo>
                          <a:lnTo>
                            <a:pt x="15" y="69"/>
                          </a:lnTo>
                          <a:close/>
                          <a:moveTo>
                            <a:pt x="0" y="66"/>
                          </a:moveTo>
                          <a:lnTo>
                            <a:pt x="36" y="66"/>
                          </a:lnTo>
                          <a:lnTo>
                            <a:pt x="36" y="72"/>
                          </a:lnTo>
                          <a:lnTo>
                            <a:pt x="0" y="72"/>
                          </a:lnTo>
                          <a:lnTo>
                            <a:pt x="0" y="6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31" name="Freeform 95"/>
                    <p:cNvSpPr>
                      <a:spLocks noEditPoints="1"/>
                    </p:cNvSpPr>
                    <p:nvPr/>
                  </p:nvSpPr>
                  <p:spPr bwMode="auto">
                    <a:xfrm>
                      <a:off x="2688813" y="4518161"/>
                      <a:ext cx="30964" cy="169717"/>
                    </a:xfrm>
                    <a:custGeom>
                      <a:avLst/>
                      <a:gdLst/>
                      <a:ahLst/>
                      <a:cxnLst>
                        <a:cxn ang="0">
                          <a:pos x="18" y="204"/>
                        </a:cxn>
                        <a:cxn ang="0">
                          <a:pos x="18" y="102"/>
                        </a:cxn>
                        <a:cxn ang="0">
                          <a:pos x="18" y="0"/>
                        </a:cxn>
                        <a:cxn ang="0">
                          <a:pos x="18" y="204"/>
                        </a:cxn>
                        <a:cxn ang="0">
                          <a:pos x="0" y="204"/>
                        </a:cxn>
                        <a:cxn ang="0">
                          <a:pos x="36" y="204"/>
                        </a:cxn>
                        <a:cxn ang="0">
                          <a:pos x="0" y="204"/>
                        </a:cxn>
                        <a:cxn ang="0">
                          <a:pos x="0" y="0"/>
                        </a:cxn>
                        <a:cxn ang="0">
                          <a:pos x="36" y="0"/>
                        </a:cxn>
                        <a:cxn ang="0">
                          <a:pos x="0" y="0"/>
                        </a:cxn>
                      </a:cxnLst>
                      <a:rect l="0" t="0" r="r" b="b"/>
                      <a:pathLst>
                        <a:path w="36" h="204">
                          <a:moveTo>
                            <a:pt x="18" y="204"/>
                          </a:moveTo>
                          <a:lnTo>
                            <a:pt x="18" y="102"/>
                          </a:lnTo>
                          <a:lnTo>
                            <a:pt x="18" y="0"/>
                          </a:lnTo>
                          <a:lnTo>
                            <a:pt x="18" y="204"/>
                          </a:lnTo>
                          <a:close/>
                          <a:moveTo>
                            <a:pt x="0" y="204"/>
                          </a:moveTo>
                          <a:lnTo>
                            <a:pt x="36" y="204"/>
                          </a:lnTo>
                          <a:lnTo>
                            <a:pt x="0" y="204"/>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32" name="Freeform 96"/>
                    <p:cNvSpPr>
                      <a:spLocks noEditPoints="1"/>
                    </p:cNvSpPr>
                    <p:nvPr/>
                  </p:nvSpPr>
                  <p:spPr bwMode="auto">
                    <a:xfrm>
                      <a:off x="2688813" y="4515665"/>
                      <a:ext cx="30964" cy="174709"/>
                    </a:xfrm>
                    <a:custGeom>
                      <a:avLst/>
                      <a:gdLst/>
                      <a:ahLst/>
                      <a:cxnLst>
                        <a:cxn ang="0">
                          <a:pos x="15" y="207"/>
                        </a:cxn>
                        <a:cxn ang="0">
                          <a:pos x="15" y="105"/>
                        </a:cxn>
                        <a:cxn ang="0">
                          <a:pos x="15" y="3"/>
                        </a:cxn>
                        <a:cxn ang="0">
                          <a:pos x="21" y="3"/>
                        </a:cxn>
                        <a:cxn ang="0">
                          <a:pos x="21" y="105"/>
                        </a:cxn>
                        <a:cxn ang="0">
                          <a:pos x="21" y="207"/>
                        </a:cxn>
                        <a:cxn ang="0">
                          <a:pos x="15" y="207"/>
                        </a:cxn>
                        <a:cxn ang="0">
                          <a:pos x="0" y="204"/>
                        </a:cxn>
                        <a:cxn ang="0">
                          <a:pos x="36" y="204"/>
                        </a:cxn>
                        <a:cxn ang="0">
                          <a:pos x="36" y="210"/>
                        </a:cxn>
                        <a:cxn ang="0">
                          <a:pos x="0" y="210"/>
                        </a:cxn>
                        <a:cxn ang="0">
                          <a:pos x="0" y="204"/>
                        </a:cxn>
                        <a:cxn ang="0">
                          <a:pos x="0" y="0"/>
                        </a:cxn>
                        <a:cxn ang="0">
                          <a:pos x="36" y="0"/>
                        </a:cxn>
                        <a:cxn ang="0">
                          <a:pos x="36" y="6"/>
                        </a:cxn>
                        <a:cxn ang="0">
                          <a:pos x="0" y="6"/>
                        </a:cxn>
                        <a:cxn ang="0">
                          <a:pos x="0" y="0"/>
                        </a:cxn>
                      </a:cxnLst>
                      <a:rect l="0" t="0" r="r" b="b"/>
                      <a:pathLst>
                        <a:path w="36" h="210">
                          <a:moveTo>
                            <a:pt x="15" y="207"/>
                          </a:moveTo>
                          <a:lnTo>
                            <a:pt x="15" y="105"/>
                          </a:lnTo>
                          <a:lnTo>
                            <a:pt x="15" y="3"/>
                          </a:lnTo>
                          <a:lnTo>
                            <a:pt x="21" y="3"/>
                          </a:lnTo>
                          <a:lnTo>
                            <a:pt x="21" y="105"/>
                          </a:lnTo>
                          <a:lnTo>
                            <a:pt x="21" y="207"/>
                          </a:lnTo>
                          <a:lnTo>
                            <a:pt x="15" y="207"/>
                          </a:lnTo>
                          <a:close/>
                          <a:moveTo>
                            <a:pt x="0" y="204"/>
                          </a:moveTo>
                          <a:lnTo>
                            <a:pt x="36" y="204"/>
                          </a:lnTo>
                          <a:lnTo>
                            <a:pt x="36" y="210"/>
                          </a:lnTo>
                          <a:lnTo>
                            <a:pt x="0" y="210"/>
                          </a:lnTo>
                          <a:lnTo>
                            <a:pt x="0" y="204"/>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50" name="Freeform 97"/>
                    <p:cNvSpPr>
                      <a:spLocks noEditPoints="1"/>
                    </p:cNvSpPr>
                    <p:nvPr/>
                  </p:nvSpPr>
                  <p:spPr bwMode="auto">
                    <a:xfrm>
                      <a:off x="2876149" y="5406680"/>
                      <a:ext cx="30964" cy="4991"/>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51" name="Freeform 98"/>
                    <p:cNvSpPr>
                      <a:spLocks noEditPoints="1"/>
                    </p:cNvSpPr>
                    <p:nvPr/>
                  </p:nvSpPr>
                  <p:spPr bwMode="auto">
                    <a:xfrm>
                      <a:off x="2876149" y="5404185"/>
                      <a:ext cx="30964" cy="9984"/>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52" name="Freeform 99"/>
                    <p:cNvSpPr>
                      <a:spLocks noEditPoints="1"/>
                    </p:cNvSpPr>
                    <p:nvPr/>
                  </p:nvSpPr>
                  <p:spPr bwMode="auto">
                    <a:xfrm>
                      <a:off x="3083869" y="4488212"/>
                      <a:ext cx="30964" cy="269551"/>
                    </a:xfrm>
                    <a:custGeom>
                      <a:avLst/>
                      <a:gdLst/>
                      <a:ahLst/>
                      <a:cxnLst>
                        <a:cxn ang="0">
                          <a:pos x="18" y="324"/>
                        </a:cxn>
                        <a:cxn ang="0">
                          <a:pos x="18" y="162"/>
                        </a:cxn>
                        <a:cxn ang="0">
                          <a:pos x="18" y="0"/>
                        </a:cxn>
                        <a:cxn ang="0">
                          <a:pos x="18" y="324"/>
                        </a:cxn>
                        <a:cxn ang="0">
                          <a:pos x="0" y="324"/>
                        </a:cxn>
                        <a:cxn ang="0">
                          <a:pos x="36" y="324"/>
                        </a:cxn>
                        <a:cxn ang="0">
                          <a:pos x="0" y="324"/>
                        </a:cxn>
                        <a:cxn ang="0">
                          <a:pos x="0" y="0"/>
                        </a:cxn>
                        <a:cxn ang="0">
                          <a:pos x="36" y="0"/>
                        </a:cxn>
                        <a:cxn ang="0">
                          <a:pos x="0" y="0"/>
                        </a:cxn>
                      </a:cxnLst>
                      <a:rect l="0" t="0" r="r" b="b"/>
                      <a:pathLst>
                        <a:path w="36" h="324">
                          <a:moveTo>
                            <a:pt x="18" y="324"/>
                          </a:moveTo>
                          <a:lnTo>
                            <a:pt x="18" y="162"/>
                          </a:lnTo>
                          <a:lnTo>
                            <a:pt x="18" y="0"/>
                          </a:lnTo>
                          <a:lnTo>
                            <a:pt x="18" y="324"/>
                          </a:lnTo>
                          <a:close/>
                          <a:moveTo>
                            <a:pt x="0" y="324"/>
                          </a:moveTo>
                          <a:lnTo>
                            <a:pt x="36" y="324"/>
                          </a:lnTo>
                          <a:lnTo>
                            <a:pt x="0" y="324"/>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53" name="Freeform 100"/>
                    <p:cNvSpPr>
                      <a:spLocks noEditPoints="1"/>
                    </p:cNvSpPr>
                    <p:nvPr/>
                  </p:nvSpPr>
                  <p:spPr bwMode="auto">
                    <a:xfrm>
                      <a:off x="3083869" y="4485716"/>
                      <a:ext cx="30964" cy="274543"/>
                    </a:xfrm>
                    <a:custGeom>
                      <a:avLst/>
                      <a:gdLst/>
                      <a:ahLst/>
                      <a:cxnLst>
                        <a:cxn ang="0">
                          <a:pos x="15" y="327"/>
                        </a:cxn>
                        <a:cxn ang="0">
                          <a:pos x="15" y="165"/>
                        </a:cxn>
                        <a:cxn ang="0">
                          <a:pos x="15" y="3"/>
                        </a:cxn>
                        <a:cxn ang="0">
                          <a:pos x="21" y="3"/>
                        </a:cxn>
                        <a:cxn ang="0">
                          <a:pos x="21" y="165"/>
                        </a:cxn>
                        <a:cxn ang="0">
                          <a:pos x="21" y="327"/>
                        </a:cxn>
                        <a:cxn ang="0">
                          <a:pos x="15" y="327"/>
                        </a:cxn>
                        <a:cxn ang="0">
                          <a:pos x="0" y="324"/>
                        </a:cxn>
                        <a:cxn ang="0">
                          <a:pos x="36" y="324"/>
                        </a:cxn>
                        <a:cxn ang="0">
                          <a:pos x="36" y="330"/>
                        </a:cxn>
                        <a:cxn ang="0">
                          <a:pos x="0" y="330"/>
                        </a:cxn>
                        <a:cxn ang="0">
                          <a:pos x="0" y="324"/>
                        </a:cxn>
                        <a:cxn ang="0">
                          <a:pos x="0" y="0"/>
                        </a:cxn>
                        <a:cxn ang="0">
                          <a:pos x="36" y="0"/>
                        </a:cxn>
                        <a:cxn ang="0">
                          <a:pos x="36" y="6"/>
                        </a:cxn>
                        <a:cxn ang="0">
                          <a:pos x="0" y="6"/>
                        </a:cxn>
                        <a:cxn ang="0">
                          <a:pos x="0" y="0"/>
                        </a:cxn>
                      </a:cxnLst>
                      <a:rect l="0" t="0" r="r" b="b"/>
                      <a:pathLst>
                        <a:path w="36" h="330">
                          <a:moveTo>
                            <a:pt x="15" y="327"/>
                          </a:moveTo>
                          <a:lnTo>
                            <a:pt x="15" y="165"/>
                          </a:lnTo>
                          <a:lnTo>
                            <a:pt x="15" y="3"/>
                          </a:lnTo>
                          <a:lnTo>
                            <a:pt x="21" y="3"/>
                          </a:lnTo>
                          <a:lnTo>
                            <a:pt x="21" y="165"/>
                          </a:lnTo>
                          <a:lnTo>
                            <a:pt x="21" y="327"/>
                          </a:lnTo>
                          <a:lnTo>
                            <a:pt x="15" y="327"/>
                          </a:lnTo>
                          <a:close/>
                          <a:moveTo>
                            <a:pt x="0" y="324"/>
                          </a:moveTo>
                          <a:lnTo>
                            <a:pt x="36" y="324"/>
                          </a:lnTo>
                          <a:lnTo>
                            <a:pt x="36" y="330"/>
                          </a:lnTo>
                          <a:lnTo>
                            <a:pt x="0" y="330"/>
                          </a:lnTo>
                          <a:lnTo>
                            <a:pt x="0" y="324"/>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54" name="Freeform 101"/>
                    <p:cNvSpPr>
                      <a:spLocks noEditPoints="1"/>
                    </p:cNvSpPr>
                    <p:nvPr/>
                  </p:nvSpPr>
                  <p:spPr bwMode="auto">
                    <a:xfrm>
                      <a:off x="3263593" y="5142122"/>
                      <a:ext cx="30964" cy="89851"/>
                    </a:xfrm>
                    <a:custGeom>
                      <a:avLst/>
                      <a:gdLst/>
                      <a:ahLst/>
                      <a:cxnLst>
                        <a:cxn ang="0">
                          <a:pos x="18" y="108"/>
                        </a:cxn>
                        <a:cxn ang="0">
                          <a:pos x="18" y="54"/>
                        </a:cxn>
                        <a:cxn ang="0">
                          <a:pos x="18" y="0"/>
                        </a:cxn>
                        <a:cxn ang="0">
                          <a:pos x="18" y="108"/>
                        </a:cxn>
                        <a:cxn ang="0">
                          <a:pos x="0" y="108"/>
                        </a:cxn>
                        <a:cxn ang="0">
                          <a:pos x="36" y="108"/>
                        </a:cxn>
                        <a:cxn ang="0">
                          <a:pos x="0" y="108"/>
                        </a:cxn>
                        <a:cxn ang="0">
                          <a:pos x="0" y="0"/>
                        </a:cxn>
                        <a:cxn ang="0">
                          <a:pos x="36" y="0"/>
                        </a:cxn>
                        <a:cxn ang="0">
                          <a:pos x="0" y="0"/>
                        </a:cxn>
                      </a:cxnLst>
                      <a:rect l="0" t="0" r="r" b="b"/>
                      <a:pathLst>
                        <a:path w="36" h="108">
                          <a:moveTo>
                            <a:pt x="18" y="108"/>
                          </a:moveTo>
                          <a:lnTo>
                            <a:pt x="18" y="54"/>
                          </a:lnTo>
                          <a:lnTo>
                            <a:pt x="18" y="0"/>
                          </a:lnTo>
                          <a:lnTo>
                            <a:pt x="18" y="108"/>
                          </a:lnTo>
                          <a:close/>
                          <a:moveTo>
                            <a:pt x="0" y="108"/>
                          </a:moveTo>
                          <a:lnTo>
                            <a:pt x="36" y="108"/>
                          </a:lnTo>
                          <a:lnTo>
                            <a:pt x="0" y="108"/>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55" name="Freeform 102"/>
                    <p:cNvSpPr>
                      <a:spLocks noEditPoints="1"/>
                    </p:cNvSpPr>
                    <p:nvPr/>
                  </p:nvSpPr>
                  <p:spPr bwMode="auto">
                    <a:xfrm>
                      <a:off x="3263593" y="5139626"/>
                      <a:ext cx="30964" cy="94842"/>
                    </a:xfrm>
                    <a:custGeom>
                      <a:avLst/>
                      <a:gdLst/>
                      <a:ahLst/>
                      <a:cxnLst>
                        <a:cxn ang="0">
                          <a:pos x="15" y="111"/>
                        </a:cxn>
                        <a:cxn ang="0">
                          <a:pos x="15" y="57"/>
                        </a:cxn>
                        <a:cxn ang="0">
                          <a:pos x="15" y="3"/>
                        </a:cxn>
                        <a:cxn ang="0">
                          <a:pos x="21" y="3"/>
                        </a:cxn>
                        <a:cxn ang="0">
                          <a:pos x="21" y="57"/>
                        </a:cxn>
                        <a:cxn ang="0">
                          <a:pos x="21" y="111"/>
                        </a:cxn>
                        <a:cxn ang="0">
                          <a:pos x="15" y="111"/>
                        </a:cxn>
                        <a:cxn ang="0">
                          <a:pos x="0" y="108"/>
                        </a:cxn>
                        <a:cxn ang="0">
                          <a:pos x="36" y="108"/>
                        </a:cxn>
                        <a:cxn ang="0">
                          <a:pos x="36" y="114"/>
                        </a:cxn>
                        <a:cxn ang="0">
                          <a:pos x="0" y="114"/>
                        </a:cxn>
                        <a:cxn ang="0">
                          <a:pos x="0" y="108"/>
                        </a:cxn>
                        <a:cxn ang="0">
                          <a:pos x="0" y="0"/>
                        </a:cxn>
                        <a:cxn ang="0">
                          <a:pos x="36" y="0"/>
                        </a:cxn>
                        <a:cxn ang="0">
                          <a:pos x="36" y="6"/>
                        </a:cxn>
                        <a:cxn ang="0">
                          <a:pos x="0" y="6"/>
                        </a:cxn>
                        <a:cxn ang="0">
                          <a:pos x="0" y="0"/>
                        </a:cxn>
                      </a:cxnLst>
                      <a:rect l="0" t="0" r="r" b="b"/>
                      <a:pathLst>
                        <a:path w="36" h="114">
                          <a:moveTo>
                            <a:pt x="15" y="111"/>
                          </a:moveTo>
                          <a:lnTo>
                            <a:pt x="15" y="57"/>
                          </a:lnTo>
                          <a:lnTo>
                            <a:pt x="15" y="3"/>
                          </a:lnTo>
                          <a:lnTo>
                            <a:pt x="21" y="3"/>
                          </a:lnTo>
                          <a:lnTo>
                            <a:pt x="21" y="57"/>
                          </a:lnTo>
                          <a:lnTo>
                            <a:pt x="21" y="111"/>
                          </a:lnTo>
                          <a:lnTo>
                            <a:pt x="15" y="111"/>
                          </a:lnTo>
                          <a:close/>
                          <a:moveTo>
                            <a:pt x="0" y="108"/>
                          </a:moveTo>
                          <a:lnTo>
                            <a:pt x="36" y="108"/>
                          </a:lnTo>
                          <a:lnTo>
                            <a:pt x="36" y="114"/>
                          </a:lnTo>
                          <a:lnTo>
                            <a:pt x="0" y="114"/>
                          </a:lnTo>
                          <a:lnTo>
                            <a:pt x="0" y="108"/>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80" name="Rectangle 127"/>
                    <p:cNvSpPr>
                      <a:spLocks noChangeArrowheads="1"/>
                    </p:cNvSpPr>
                    <p:nvPr/>
                  </p:nvSpPr>
                  <p:spPr bwMode="auto">
                    <a:xfrm>
                      <a:off x="3240609" y="5012722"/>
                      <a:ext cx="78435"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b</a:t>
                      </a:r>
                      <a:endParaRPr lang="en-US" sz="800">
                        <a:latin typeface="Arial" pitchFamily="34" charset="0"/>
                        <a:cs typeface="Arial" pitchFamily="34" charset="0"/>
                      </a:endParaRPr>
                    </a:p>
                  </p:txBody>
                </p:sp>
                <p:sp>
                  <p:nvSpPr>
                    <p:cNvPr id="181" name="Rectangle 128"/>
                    <p:cNvSpPr>
                      <a:spLocks noChangeArrowheads="1"/>
                    </p:cNvSpPr>
                    <p:nvPr/>
                  </p:nvSpPr>
                  <p:spPr bwMode="auto">
                    <a:xfrm>
                      <a:off x="1884731" y="5288224"/>
                      <a:ext cx="92263"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c</a:t>
                      </a:r>
                      <a:endParaRPr lang="en-US" sz="800">
                        <a:latin typeface="Arial" pitchFamily="34" charset="0"/>
                        <a:cs typeface="Arial" pitchFamily="34" charset="0"/>
                      </a:endParaRPr>
                    </a:p>
                  </p:txBody>
                </p:sp>
                <p:sp>
                  <p:nvSpPr>
                    <p:cNvPr id="182" name="Rectangle 129"/>
                    <p:cNvSpPr>
                      <a:spLocks noChangeArrowheads="1"/>
                    </p:cNvSpPr>
                    <p:nvPr/>
                  </p:nvSpPr>
                  <p:spPr bwMode="auto">
                    <a:xfrm>
                      <a:off x="2057423" y="5283282"/>
                      <a:ext cx="151057"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c</a:t>
                      </a:r>
                      <a:endParaRPr lang="en-US" sz="800">
                        <a:latin typeface="Arial" pitchFamily="34" charset="0"/>
                        <a:cs typeface="Arial" pitchFamily="34" charset="0"/>
                      </a:endParaRPr>
                    </a:p>
                  </p:txBody>
                </p:sp>
                <p:sp>
                  <p:nvSpPr>
                    <p:cNvPr id="184" name="Rectangle 130"/>
                    <p:cNvSpPr>
                      <a:spLocks noChangeArrowheads="1"/>
                    </p:cNvSpPr>
                    <p:nvPr/>
                  </p:nvSpPr>
                  <p:spPr bwMode="auto">
                    <a:xfrm>
                      <a:off x="2258669" y="5071583"/>
                      <a:ext cx="113631" cy="125913"/>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b</a:t>
                      </a:r>
                      <a:endParaRPr lang="en-US" sz="800">
                        <a:latin typeface="Arial" pitchFamily="34" charset="0"/>
                        <a:cs typeface="Arial" pitchFamily="34" charset="0"/>
                      </a:endParaRPr>
                    </a:p>
                  </p:txBody>
                </p:sp>
                <p:sp>
                  <p:nvSpPr>
                    <p:cNvPr id="185" name="Rectangle 131"/>
                    <p:cNvSpPr>
                      <a:spLocks noChangeArrowheads="1"/>
                    </p:cNvSpPr>
                    <p:nvPr/>
                  </p:nvSpPr>
                  <p:spPr bwMode="auto">
                    <a:xfrm>
                      <a:off x="2428510" y="5119523"/>
                      <a:ext cx="148729"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b</a:t>
                      </a:r>
                      <a:endParaRPr lang="en-US" sz="800">
                        <a:latin typeface="Arial" pitchFamily="34" charset="0"/>
                        <a:cs typeface="Arial" pitchFamily="34" charset="0"/>
                      </a:endParaRPr>
                    </a:p>
                  </p:txBody>
                </p:sp>
                <p:sp>
                  <p:nvSpPr>
                    <p:cNvPr id="186" name="Rectangle 132"/>
                    <p:cNvSpPr>
                      <a:spLocks noChangeArrowheads="1"/>
                    </p:cNvSpPr>
                    <p:nvPr/>
                  </p:nvSpPr>
                  <p:spPr bwMode="auto">
                    <a:xfrm>
                      <a:off x="2678065" y="4406139"/>
                      <a:ext cx="50494"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a</a:t>
                      </a:r>
                      <a:endParaRPr lang="en-US" sz="800">
                        <a:latin typeface="Arial" pitchFamily="34" charset="0"/>
                        <a:cs typeface="Arial" pitchFamily="34" charset="0"/>
                      </a:endParaRPr>
                    </a:p>
                  </p:txBody>
                </p:sp>
                <p:sp>
                  <p:nvSpPr>
                    <p:cNvPr id="187" name="Rectangle 133"/>
                    <p:cNvSpPr>
                      <a:spLocks noChangeArrowheads="1"/>
                    </p:cNvSpPr>
                    <p:nvPr/>
                  </p:nvSpPr>
                  <p:spPr bwMode="auto">
                    <a:xfrm>
                      <a:off x="2855255" y="5277585"/>
                      <a:ext cx="71560"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c</a:t>
                      </a:r>
                      <a:endParaRPr lang="en-US" sz="800">
                        <a:latin typeface="Arial" pitchFamily="34" charset="0"/>
                        <a:cs typeface="Arial" pitchFamily="34" charset="0"/>
                      </a:endParaRPr>
                    </a:p>
                  </p:txBody>
                </p:sp>
                <p:sp>
                  <p:nvSpPr>
                    <p:cNvPr id="188" name="Rectangle 134"/>
                    <p:cNvSpPr>
                      <a:spLocks noChangeArrowheads="1"/>
                    </p:cNvSpPr>
                    <p:nvPr/>
                  </p:nvSpPr>
                  <p:spPr bwMode="auto">
                    <a:xfrm>
                      <a:off x="3039843" y="4375791"/>
                      <a:ext cx="130006"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a</a:t>
                      </a:r>
                      <a:endParaRPr lang="en-US" sz="800">
                        <a:latin typeface="Arial" pitchFamily="34" charset="0"/>
                        <a:cs typeface="Arial" pitchFamily="34" charset="0"/>
                      </a:endParaRPr>
                    </a:p>
                  </p:txBody>
                </p:sp>
              </p:grpSp>
              <p:grpSp>
                <p:nvGrpSpPr>
                  <p:cNvPr id="250" name="Group 249"/>
                  <p:cNvGrpSpPr/>
                  <p:nvPr/>
                </p:nvGrpSpPr>
                <p:grpSpPr>
                  <a:xfrm>
                    <a:off x="648731" y="3203349"/>
                    <a:ext cx="1863535" cy="1216251"/>
                    <a:chOff x="1544218" y="5470894"/>
                    <a:chExt cx="1863535" cy="1216251"/>
                  </a:xfrm>
                </p:grpSpPr>
                <p:grpSp>
                  <p:nvGrpSpPr>
                    <p:cNvPr id="13" name="Group 2286"/>
                    <p:cNvGrpSpPr/>
                    <p:nvPr/>
                  </p:nvGrpSpPr>
                  <p:grpSpPr>
                    <a:xfrm>
                      <a:off x="1939883" y="6560016"/>
                      <a:ext cx="1418616" cy="127129"/>
                      <a:chOff x="1451575" y="6577363"/>
                      <a:chExt cx="1420119" cy="127552"/>
                    </a:xfrm>
                  </p:grpSpPr>
                  <p:sp>
                    <p:nvSpPr>
                      <p:cNvPr id="79" name="Rectangle 46"/>
                      <p:cNvSpPr>
                        <a:spLocks noChangeArrowheads="1"/>
                      </p:cNvSpPr>
                      <p:nvPr/>
                    </p:nvSpPr>
                    <p:spPr bwMode="auto">
                      <a:xfrm>
                        <a:off x="1451575" y="6577825"/>
                        <a:ext cx="167493" cy="127090"/>
                      </a:xfrm>
                      <a:prstGeom prst="rect">
                        <a:avLst/>
                      </a:prstGeom>
                      <a:noFill/>
                      <a:ln w="9525">
                        <a:noFill/>
                        <a:miter lim="800000"/>
                        <a:headEnd/>
                        <a:tailEnd/>
                      </a:ln>
                    </p:spPr>
                    <p:txBody>
                      <a:bodyPr vert="horz" wrap="square" lIns="0" tIns="0" rIns="0" bIns="0" numCol="1" anchor="ctr" anchorCtr="0" compatLnSpc="1">
                        <a:prstTxWarp prst="textNoShape">
                          <a:avLst/>
                        </a:prstTxWarp>
                        <a:spAutoFit/>
                      </a:bodyPr>
                      <a:lstStyle/>
                      <a:p>
                        <a:pPr algn="ctr" fontAlgn="base">
                          <a:spcBef>
                            <a:spcPct val="0"/>
                          </a:spcBef>
                          <a:spcAft>
                            <a:spcPct val="0"/>
                          </a:spcAft>
                        </a:pPr>
                        <a:r>
                          <a:rPr lang="en-US" sz="800" b="1">
                            <a:solidFill>
                              <a:srgbClr val="000000"/>
                            </a:solidFill>
                            <a:latin typeface="Calibri "/>
                            <a:cs typeface="Arial" pitchFamily="34" charset="0"/>
                          </a:rPr>
                          <a:t>C</a:t>
                        </a:r>
                        <a:endParaRPr lang="en-US" sz="800" b="1">
                          <a:latin typeface="Calibri "/>
                          <a:cs typeface="Arial" pitchFamily="34" charset="0"/>
                        </a:endParaRPr>
                      </a:p>
                    </p:txBody>
                  </p:sp>
                  <p:sp>
                    <p:nvSpPr>
                      <p:cNvPr id="80" name="Rectangle 50"/>
                      <p:cNvSpPr>
                        <a:spLocks noChangeArrowheads="1"/>
                      </p:cNvSpPr>
                      <p:nvPr/>
                    </p:nvSpPr>
                    <p:spPr bwMode="auto">
                      <a:xfrm>
                        <a:off x="1807913" y="6577363"/>
                        <a:ext cx="220725" cy="127090"/>
                      </a:xfrm>
                      <a:prstGeom prst="rect">
                        <a:avLst/>
                      </a:prstGeom>
                      <a:noFill/>
                      <a:ln w="9525">
                        <a:noFill/>
                        <a:miter lim="800000"/>
                        <a:headEnd/>
                        <a:tailEnd/>
                      </a:ln>
                    </p:spPr>
                    <p:txBody>
                      <a:bodyPr vert="horz" wrap="square" lIns="0" tIns="0" rIns="0" bIns="0" numCol="1" anchor="ctr" anchorCtr="0" compatLnSpc="1">
                        <a:prstTxWarp prst="textNoShape">
                          <a:avLst/>
                        </a:prstTxWarp>
                        <a:spAutoFit/>
                      </a:bodyPr>
                      <a:lstStyle/>
                      <a:p>
                        <a:pPr algn="ctr" fontAlgn="base">
                          <a:spcBef>
                            <a:spcPct val="0"/>
                          </a:spcBef>
                          <a:spcAft>
                            <a:spcPct val="0"/>
                          </a:spcAft>
                        </a:pPr>
                        <a:r>
                          <a:rPr lang="en-US" sz="800" b="1">
                            <a:solidFill>
                              <a:srgbClr val="000000"/>
                            </a:solidFill>
                            <a:latin typeface="Calibri "/>
                            <a:cs typeface="Arial" pitchFamily="34" charset="0"/>
                          </a:rPr>
                          <a:t>As</a:t>
                        </a:r>
                        <a:endParaRPr lang="en-US" sz="800" b="1">
                          <a:latin typeface="Calibri "/>
                          <a:cs typeface="Arial" pitchFamily="34" charset="0"/>
                        </a:endParaRPr>
                      </a:p>
                    </p:txBody>
                  </p:sp>
                  <p:sp>
                    <p:nvSpPr>
                      <p:cNvPr id="81" name="Rectangle 54"/>
                      <p:cNvSpPr>
                        <a:spLocks noChangeArrowheads="1"/>
                      </p:cNvSpPr>
                      <p:nvPr/>
                    </p:nvSpPr>
                    <p:spPr bwMode="auto">
                      <a:xfrm>
                        <a:off x="2209800" y="6577739"/>
                        <a:ext cx="200986" cy="127090"/>
                      </a:xfrm>
                      <a:prstGeom prst="rect">
                        <a:avLst/>
                      </a:prstGeom>
                      <a:noFill/>
                      <a:ln w="9525">
                        <a:noFill/>
                        <a:miter lim="800000"/>
                        <a:headEnd/>
                        <a:tailEnd/>
                      </a:ln>
                    </p:spPr>
                    <p:txBody>
                      <a:bodyPr vert="horz" wrap="none" lIns="0" tIns="0" rIns="0" bIns="0" numCol="1" anchor="ctr" anchorCtr="0" compatLnSpc="1">
                        <a:prstTxWarp prst="textNoShape">
                          <a:avLst/>
                        </a:prstTxWarp>
                        <a:spAutoFit/>
                      </a:bodyPr>
                      <a:lstStyle/>
                      <a:p>
                        <a:pPr fontAlgn="base">
                          <a:spcBef>
                            <a:spcPct val="0"/>
                          </a:spcBef>
                          <a:spcAft>
                            <a:spcPct val="0"/>
                          </a:spcAft>
                        </a:pPr>
                        <a:r>
                          <a:rPr lang="en-US" sz="800" b="1">
                            <a:solidFill>
                              <a:srgbClr val="000000"/>
                            </a:solidFill>
                            <a:latin typeface="Calibri "/>
                            <a:cs typeface="Arial" pitchFamily="34" charset="0"/>
                          </a:rPr>
                          <a:t>Hpx</a:t>
                        </a:r>
                        <a:endParaRPr lang="en-US" sz="800" b="1">
                          <a:latin typeface="Calibri "/>
                          <a:cs typeface="Arial" pitchFamily="34" charset="0"/>
                        </a:endParaRPr>
                      </a:p>
                    </p:txBody>
                  </p:sp>
                  <p:sp>
                    <p:nvSpPr>
                      <p:cNvPr id="82" name="Rectangle 58"/>
                      <p:cNvSpPr>
                        <a:spLocks noChangeArrowheads="1"/>
                      </p:cNvSpPr>
                      <p:nvPr/>
                    </p:nvSpPr>
                    <p:spPr bwMode="auto">
                      <a:xfrm>
                        <a:off x="2534712" y="6577739"/>
                        <a:ext cx="336982" cy="127090"/>
                      </a:xfrm>
                      <a:prstGeom prst="rect">
                        <a:avLst/>
                      </a:prstGeom>
                      <a:noFill/>
                      <a:ln w="9525">
                        <a:noFill/>
                        <a:miter lim="800000"/>
                        <a:headEnd/>
                        <a:tailEnd/>
                      </a:ln>
                    </p:spPr>
                    <p:txBody>
                      <a:bodyPr vert="horz" wrap="none" lIns="0" tIns="0" rIns="0" bIns="0" numCol="1" anchor="ctr" anchorCtr="0" compatLnSpc="1">
                        <a:prstTxWarp prst="textNoShape">
                          <a:avLst/>
                        </a:prstTxWarp>
                        <a:spAutoFit/>
                      </a:bodyPr>
                      <a:lstStyle/>
                      <a:p>
                        <a:pPr fontAlgn="base">
                          <a:spcBef>
                            <a:spcPct val="0"/>
                          </a:spcBef>
                          <a:spcAft>
                            <a:spcPct val="0"/>
                          </a:spcAft>
                        </a:pPr>
                        <a:r>
                          <a:rPr lang="en-US" sz="800" b="1">
                            <a:solidFill>
                              <a:srgbClr val="000000"/>
                            </a:solidFill>
                            <a:latin typeface="Calibri "/>
                            <a:cs typeface="Arial" pitchFamily="34" charset="0"/>
                          </a:rPr>
                          <a:t>HpxAs</a:t>
                        </a:r>
                        <a:endParaRPr lang="en-US" sz="800" b="1">
                          <a:latin typeface="Calibri "/>
                          <a:cs typeface="Arial" pitchFamily="34" charset="0"/>
                        </a:endParaRPr>
                      </a:p>
                    </p:txBody>
                  </p:sp>
                </p:grpSp>
                <p:sp>
                  <p:nvSpPr>
                    <p:cNvPr id="749" name="Freeform 40"/>
                    <p:cNvSpPr>
                      <a:spLocks noEditPoints="1"/>
                    </p:cNvSpPr>
                    <p:nvPr/>
                  </p:nvSpPr>
                  <p:spPr bwMode="auto">
                    <a:xfrm>
                      <a:off x="1756710" y="5617832"/>
                      <a:ext cx="25461" cy="869563"/>
                    </a:xfrm>
                    <a:custGeom>
                      <a:avLst/>
                      <a:gdLst/>
                      <a:ahLst/>
                      <a:cxnLst>
                        <a:cxn ang="0">
                          <a:pos x="0" y="1044"/>
                        </a:cxn>
                        <a:cxn ang="0">
                          <a:pos x="30" y="1044"/>
                        </a:cxn>
                        <a:cxn ang="0">
                          <a:pos x="30" y="1050"/>
                        </a:cxn>
                        <a:cxn ang="0">
                          <a:pos x="0" y="1050"/>
                        </a:cxn>
                        <a:cxn ang="0">
                          <a:pos x="0" y="1044"/>
                        </a:cxn>
                        <a:cxn ang="0">
                          <a:pos x="0" y="522"/>
                        </a:cxn>
                        <a:cxn ang="0">
                          <a:pos x="30" y="522"/>
                        </a:cxn>
                        <a:cxn ang="0">
                          <a:pos x="30" y="528"/>
                        </a:cxn>
                        <a:cxn ang="0">
                          <a:pos x="0" y="528"/>
                        </a:cxn>
                        <a:cxn ang="0">
                          <a:pos x="0" y="522"/>
                        </a:cxn>
                        <a:cxn ang="0">
                          <a:pos x="0" y="0"/>
                        </a:cxn>
                        <a:cxn ang="0">
                          <a:pos x="30" y="0"/>
                        </a:cxn>
                        <a:cxn ang="0">
                          <a:pos x="30" y="6"/>
                        </a:cxn>
                        <a:cxn ang="0">
                          <a:pos x="0" y="6"/>
                        </a:cxn>
                        <a:cxn ang="0">
                          <a:pos x="0" y="0"/>
                        </a:cxn>
                      </a:cxnLst>
                      <a:rect l="0" t="0" r="r" b="b"/>
                      <a:pathLst>
                        <a:path w="30" h="1050">
                          <a:moveTo>
                            <a:pt x="0" y="1044"/>
                          </a:moveTo>
                          <a:lnTo>
                            <a:pt x="30" y="1044"/>
                          </a:lnTo>
                          <a:lnTo>
                            <a:pt x="30" y="1050"/>
                          </a:lnTo>
                          <a:lnTo>
                            <a:pt x="0" y="1050"/>
                          </a:lnTo>
                          <a:lnTo>
                            <a:pt x="0" y="1044"/>
                          </a:lnTo>
                          <a:close/>
                          <a:moveTo>
                            <a:pt x="0" y="522"/>
                          </a:moveTo>
                          <a:lnTo>
                            <a:pt x="30" y="522"/>
                          </a:lnTo>
                          <a:lnTo>
                            <a:pt x="30" y="528"/>
                          </a:lnTo>
                          <a:lnTo>
                            <a:pt x="0" y="528"/>
                          </a:lnTo>
                          <a:lnTo>
                            <a:pt x="0" y="522"/>
                          </a:lnTo>
                          <a:close/>
                          <a:moveTo>
                            <a:pt x="0" y="0"/>
                          </a:moveTo>
                          <a:lnTo>
                            <a:pt x="30" y="0"/>
                          </a:lnTo>
                          <a:lnTo>
                            <a:pt x="30" y="6"/>
                          </a:lnTo>
                          <a:lnTo>
                            <a:pt x="0" y="6"/>
                          </a:lnTo>
                          <a:lnTo>
                            <a:pt x="0" y="0"/>
                          </a:lnTo>
                          <a:close/>
                        </a:path>
                      </a:pathLst>
                    </a:custGeom>
                    <a:solidFill>
                      <a:schemeClr val="tx1"/>
                    </a:solidFill>
                    <a:ln w="635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sz="800">
                        <a:latin typeface="Calibri "/>
                      </a:endParaRPr>
                    </a:p>
                  </p:txBody>
                </p:sp>
                <p:sp>
                  <p:nvSpPr>
                    <p:cNvPr id="750" name="Rectangle 43"/>
                    <p:cNvSpPr>
                      <a:spLocks noChangeArrowheads="1"/>
                    </p:cNvSpPr>
                    <p:nvPr/>
                  </p:nvSpPr>
                  <p:spPr bwMode="auto">
                    <a:xfrm>
                      <a:off x="1651494" y="6446730"/>
                      <a:ext cx="58910"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0</a:t>
                      </a:r>
                      <a:endParaRPr lang="en-US" sz="800">
                        <a:latin typeface="Calibri "/>
                        <a:cs typeface="Arial" pitchFamily="34" charset="0"/>
                      </a:endParaRPr>
                    </a:p>
                  </p:txBody>
                </p:sp>
                <p:sp>
                  <p:nvSpPr>
                    <p:cNvPr id="751" name="Rectangle 44"/>
                    <p:cNvSpPr>
                      <a:spLocks noChangeArrowheads="1"/>
                    </p:cNvSpPr>
                    <p:nvPr/>
                  </p:nvSpPr>
                  <p:spPr bwMode="auto">
                    <a:xfrm>
                      <a:off x="1544218" y="5992069"/>
                      <a:ext cx="176729"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200</a:t>
                      </a:r>
                      <a:endParaRPr lang="en-US" sz="800">
                        <a:latin typeface="Calibri "/>
                        <a:cs typeface="Arial" pitchFamily="34" charset="0"/>
                      </a:endParaRPr>
                    </a:p>
                  </p:txBody>
                </p:sp>
                <p:sp>
                  <p:nvSpPr>
                    <p:cNvPr id="752" name="Rectangle 45"/>
                    <p:cNvSpPr>
                      <a:spLocks noChangeArrowheads="1"/>
                    </p:cNvSpPr>
                    <p:nvPr/>
                  </p:nvSpPr>
                  <p:spPr bwMode="auto">
                    <a:xfrm>
                      <a:off x="1544218" y="5561522"/>
                      <a:ext cx="176729"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400</a:t>
                      </a:r>
                      <a:endParaRPr lang="en-US" sz="800">
                        <a:latin typeface="Calibri "/>
                        <a:cs typeface="Arial" pitchFamily="34" charset="0"/>
                      </a:endParaRPr>
                    </a:p>
                  </p:txBody>
                </p:sp>
                <p:sp>
                  <p:nvSpPr>
                    <p:cNvPr id="753" name="Rectangle 62"/>
                    <p:cNvSpPr>
                      <a:spLocks noChangeArrowheads="1"/>
                    </p:cNvSpPr>
                    <p:nvPr/>
                  </p:nvSpPr>
                  <p:spPr bwMode="auto">
                    <a:xfrm>
                      <a:off x="1896493" y="5571686"/>
                      <a:ext cx="283727" cy="12666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b="1" i="1">
                          <a:solidFill>
                            <a:srgbClr val="000000"/>
                          </a:solidFill>
                          <a:latin typeface="Calibri "/>
                          <a:cs typeface="Arial" pitchFamily="34" charset="0"/>
                        </a:rPr>
                        <a:t>PDC1</a:t>
                      </a:r>
                      <a:endParaRPr lang="en-US" sz="800" b="1" i="1">
                        <a:latin typeface="Calibri "/>
                        <a:cs typeface="Arial" pitchFamily="34" charset="0"/>
                      </a:endParaRPr>
                    </a:p>
                  </p:txBody>
                </p:sp>
                <p:cxnSp>
                  <p:nvCxnSpPr>
                    <p:cNvPr id="762" name="Straight Connector 761"/>
                    <p:cNvCxnSpPr/>
                    <p:nvPr/>
                  </p:nvCxnSpPr>
                  <p:spPr>
                    <a:xfrm>
                      <a:off x="1785379" y="6484313"/>
                      <a:ext cx="162237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3" name="Straight Connector 762"/>
                    <p:cNvCxnSpPr/>
                    <p:nvPr/>
                  </p:nvCxnSpPr>
                  <p:spPr>
                    <a:xfrm>
                      <a:off x="1786365" y="5572224"/>
                      <a:ext cx="0" cy="91317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64" name="Rectangle 46"/>
                    <p:cNvSpPr>
                      <a:spLocks noChangeArrowheads="1"/>
                    </p:cNvSpPr>
                    <p:nvPr/>
                  </p:nvSpPr>
                  <p:spPr bwMode="auto">
                    <a:xfrm>
                      <a:off x="2031974" y="6507141"/>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65" name="Rectangle 46"/>
                    <p:cNvSpPr>
                      <a:spLocks noChangeArrowheads="1"/>
                    </p:cNvSpPr>
                    <p:nvPr/>
                  </p:nvSpPr>
                  <p:spPr bwMode="auto">
                    <a:xfrm>
                      <a:off x="2417288" y="6507141"/>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66" name="Rectangle 46"/>
                    <p:cNvSpPr>
                      <a:spLocks noChangeArrowheads="1"/>
                    </p:cNvSpPr>
                    <p:nvPr/>
                  </p:nvSpPr>
                  <p:spPr bwMode="auto">
                    <a:xfrm>
                      <a:off x="2809362" y="6507141"/>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67" name="Rectangle 46"/>
                    <p:cNvSpPr>
                      <a:spLocks noChangeArrowheads="1"/>
                    </p:cNvSpPr>
                    <p:nvPr/>
                  </p:nvSpPr>
                  <p:spPr bwMode="auto">
                    <a:xfrm>
                      <a:off x="3201436" y="6507142"/>
                      <a:ext cx="1485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1181" name="Rectangle 141"/>
                    <p:cNvSpPr>
                      <a:spLocks noChangeArrowheads="1"/>
                    </p:cNvSpPr>
                    <p:nvPr/>
                  </p:nvSpPr>
                  <p:spPr bwMode="auto">
                    <a:xfrm>
                      <a:off x="1863735" y="6466333"/>
                      <a:ext cx="122270" cy="10857"/>
                    </a:xfrm>
                    <a:prstGeom prst="rect">
                      <a:avLst/>
                    </a:prstGeom>
                    <a:solidFill>
                      <a:srgbClr val="FDEAD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83" name="Rectangle 143"/>
                    <p:cNvSpPr>
                      <a:spLocks noChangeArrowheads="1"/>
                    </p:cNvSpPr>
                    <p:nvPr/>
                  </p:nvSpPr>
                  <p:spPr bwMode="auto">
                    <a:xfrm>
                      <a:off x="2063872" y="6467916"/>
                      <a:ext cx="122270" cy="10857"/>
                    </a:xfrm>
                    <a:prstGeom prst="rect">
                      <a:avLst/>
                    </a:prstGeom>
                    <a:solidFill>
                      <a:srgbClr val="EBF1DE"/>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85" name="Rectangle 145"/>
                    <p:cNvSpPr>
                      <a:spLocks noChangeArrowheads="1"/>
                    </p:cNvSpPr>
                    <p:nvPr/>
                  </p:nvSpPr>
                  <p:spPr bwMode="auto">
                    <a:xfrm>
                      <a:off x="2249734" y="6439191"/>
                      <a:ext cx="122270" cy="37999"/>
                    </a:xfrm>
                    <a:prstGeom prst="rect">
                      <a:avLst/>
                    </a:prstGeom>
                    <a:solidFill>
                      <a:srgbClr val="FCD5B5"/>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87" name="Rectangle 147"/>
                    <p:cNvSpPr>
                      <a:spLocks noChangeArrowheads="1"/>
                    </p:cNvSpPr>
                    <p:nvPr/>
                  </p:nvSpPr>
                  <p:spPr bwMode="auto">
                    <a:xfrm>
                      <a:off x="2440355" y="6438400"/>
                      <a:ext cx="122270" cy="37999"/>
                    </a:xfrm>
                    <a:prstGeom prst="rect">
                      <a:avLst/>
                    </a:prstGeom>
                    <a:solidFill>
                      <a:srgbClr val="D7E4BD"/>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89" name="Rectangle 149"/>
                    <p:cNvSpPr>
                      <a:spLocks noChangeArrowheads="1"/>
                    </p:cNvSpPr>
                    <p:nvPr/>
                  </p:nvSpPr>
                  <p:spPr bwMode="auto">
                    <a:xfrm>
                      <a:off x="2645748" y="5645839"/>
                      <a:ext cx="122270" cy="830561"/>
                    </a:xfrm>
                    <a:prstGeom prst="rect">
                      <a:avLst/>
                    </a:prstGeom>
                    <a:solidFill>
                      <a:srgbClr val="FAC090"/>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91" name="Rectangle 151"/>
                    <p:cNvSpPr>
                      <a:spLocks noChangeArrowheads="1"/>
                    </p:cNvSpPr>
                    <p:nvPr/>
                  </p:nvSpPr>
                  <p:spPr bwMode="auto">
                    <a:xfrm>
                      <a:off x="2831612" y="6467916"/>
                      <a:ext cx="122270" cy="10857"/>
                    </a:xfrm>
                    <a:prstGeom prst="rect">
                      <a:avLst/>
                    </a:prstGeom>
                    <a:solidFill>
                      <a:srgbClr val="C3D69B"/>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93" name="Rectangle 153"/>
                    <p:cNvSpPr>
                      <a:spLocks noChangeArrowheads="1"/>
                    </p:cNvSpPr>
                    <p:nvPr/>
                  </p:nvSpPr>
                  <p:spPr bwMode="auto">
                    <a:xfrm>
                      <a:off x="3031749" y="5960692"/>
                      <a:ext cx="122270" cy="515707"/>
                    </a:xfrm>
                    <a:prstGeom prst="rect">
                      <a:avLst/>
                    </a:prstGeom>
                    <a:solidFill>
                      <a:srgbClr val="E46C0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95" name="Rectangle 155"/>
                    <p:cNvSpPr>
                      <a:spLocks noChangeArrowheads="1"/>
                    </p:cNvSpPr>
                    <p:nvPr/>
                  </p:nvSpPr>
                  <p:spPr bwMode="auto">
                    <a:xfrm>
                      <a:off x="3222369" y="6464860"/>
                      <a:ext cx="122270" cy="16286"/>
                    </a:xfrm>
                    <a:prstGeom prst="rect">
                      <a:avLst/>
                    </a:prstGeom>
                    <a:solidFill>
                      <a:srgbClr val="77933C"/>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197" name="Freeform 157"/>
                    <p:cNvSpPr>
                      <a:spLocks noEditPoints="1"/>
                    </p:cNvSpPr>
                    <p:nvPr/>
                  </p:nvSpPr>
                  <p:spPr bwMode="auto">
                    <a:xfrm>
                      <a:off x="1911033" y="6471761"/>
                      <a:ext cx="31533" cy="905"/>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98" name="Freeform 158"/>
                    <p:cNvSpPr>
                      <a:spLocks noEditPoints="1"/>
                    </p:cNvSpPr>
                    <p:nvPr/>
                  </p:nvSpPr>
                  <p:spPr bwMode="auto">
                    <a:xfrm>
                      <a:off x="2111167" y="6466220"/>
                      <a:ext cx="31533" cy="905"/>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199" name="Freeform 159"/>
                    <p:cNvSpPr>
                      <a:spLocks noEditPoints="1"/>
                    </p:cNvSpPr>
                    <p:nvPr/>
                  </p:nvSpPr>
                  <p:spPr bwMode="auto">
                    <a:xfrm>
                      <a:off x="2297034" y="6439191"/>
                      <a:ext cx="31533" cy="10857"/>
                    </a:xfrm>
                    <a:custGeom>
                      <a:avLst/>
                      <a:gdLst/>
                      <a:ahLst/>
                      <a:cxnLst>
                        <a:cxn ang="0">
                          <a:pos x="18" y="12"/>
                        </a:cxn>
                        <a:cxn ang="0">
                          <a:pos x="18" y="6"/>
                        </a:cxn>
                        <a:cxn ang="0">
                          <a:pos x="18" y="0"/>
                        </a:cxn>
                        <a:cxn ang="0">
                          <a:pos x="18" y="12"/>
                        </a:cxn>
                        <a:cxn ang="0">
                          <a:pos x="0" y="12"/>
                        </a:cxn>
                        <a:cxn ang="0">
                          <a:pos x="36" y="12"/>
                        </a:cxn>
                        <a:cxn ang="0">
                          <a:pos x="0" y="12"/>
                        </a:cxn>
                        <a:cxn ang="0">
                          <a:pos x="0" y="0"/>
                        </a:cxn>
                        <a:cxn ang="0">
                          <a:pos x="36" y="0"/>
                        </a:cxn>
                        <a:cxn ang="0">
                          <a:pos x="0" y="0"/>
                        </a:cxn>
                      </a:cxnLst>
                      <a:rect l="0" t="0" r="r" b="b"/>
                      <a:pathLst>
                        <a:path w="36" h="12">
                          <a:moveTo>
                            <a:pt x="18" y="12"/>
                          </a:moveTo>
                          <a:lnTo>
                            <a:pt x="18" y="6"/>
                          </a:lnTo>
                          <a:lnTo>
                            <a:pt x="18" y="0"/>
                          </a:lnTo>
                          <a:lnTo>
                            <a:pt x="18" y="12"/>
                          </a:lnTo>
                          <a:close/>
                          <a:moveTo>
                            <a:pt x="0" y="12"/>
                          </a:moveTo>
                          <a:lnTo>
                            <a:pt x="36" y="12"/>
                          </a:lnTo>
                          <a:lnTo>
                            <a:pt x="0" y="12"/>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200" name="Freeform 160"/>
                    <p:cNvSpPr>
                      <a:spLocks noEditPoints="1"/>
                    </p:cNvSpPr>
                    <p:nvPr/>
                  </p:nvSpPr>
                  <p:spPr bwMode="auto">
                    <a:xfrm>
                      <a:off x="2297034" y="6436477"/>
                      <a:ext cx="31533" cy="16286"/>
                    </a:xfrm>
                    <a:custGeom>
                      <a:avLst/>
                      <a:gdLst/>
                      <a:ahLst/>
                      <a:cxnLst>
                        <a:cxn ang="0">
                          <a:pos x="15" y="15"/>
                        </a:cxn>
                        <a:cxn ang="0">
                          <a:pos x="15" y="9"/>
                        </a:cxn>
                        <a:cxn ang="0">
                          <a:pos x="15" y="3"/>
                        </a:cxn>
                        <a:cxn ang="0">
                          <a:pos x="21" y="3"/>
                        </a:cxn>
                        <a:cxn ang="0">
                          <a:pos x="21" y="9"/>
                        </a:cxn>
                        <a:cxn ang="0">
                          <a:pos x="21" y="15"/>
                        </a:cxn>
                        <a:cxn ang="0">
                          <a:pos x="15" y="15"/>
                        </a:cxn>
                        <a:cxn ang="0">
                          <a:pos x="0" y="12"/>
                        </a:cxn>
                        <a:cxn ang="0">
                          <a:pos x="36" y="12"/>
                        </a:cxn>
                        <a:cxn ang="0">
                          <a:pos x="36" y="18"/>
                        </a:cxn>
                        <a:cxn ang="0">
                          <a:pos x="0" y="18"/>
                        </a:cxn>
                        <a:cxn ang="0">
                          <a:pos x="0" y="12"/>
                        </a:cxn>
                        <a:cxn ang="0">
                          <a:pos x="0" y="0"/>
                        </a:cxn>
                        <a:cxn ang="0">
                          <a:pos x="36" y="0"/>
                        </a:cxn>
                        <a:cxn ang="0">
                          <a:pos x="36" y="6"/>
                        </a:cxn>
                        <a:cxn ang="0">
                          <a:pos x="0" y="6"/>
                        </a:cxn>
                        <a:cxn ang="0">
                          <a:pos x="0" y="0"/>
                        </a:cxn>
                      </a:cxnLst>
                      <a:rect l="0" t="0" r="r" b="b"/>
                      <a:pathLst>
                        <a:path w="36" h="18">
                          <a:moveTo>
                            <a:pt x="15" y="15"/>
                          </a:moveTo>
                          <a:lnTo>
                            <a:pt x="15" y="9"/>
                          </a:lnTo>
                          <a:lnTo>
                            <a:pt x="15" y="3"/>
                          </a:lnTo>
                          <a:lnTo>
                            <a:pt x="21" y="3"/>
                          </a:lnTo>
                          <a:lnTo>
                            <a:pt x="21" y="9"/>
                          </a:lnTo>
                          <a:lnTo>
                            <a:pt x="21" y="15"/>
                          </a:lnTo>
                          <a:lnTo>
                            <a:pt x="15" y="15"/>
                          </a:lnTo>
                          <a:close/>
                          <a:moveTo>
                            <a:pt x="0" y="12"/>
                          </a:moveTo>
                          <a:lnTo>
                            <a:pt x="36" y="12"/>
                          </a:lnTo>
                          <a:lnTo>
                            <a:pt x="36" y="18"/>
                          </a:lnTo>
                          <a:lnTo>
                            <a:pt x="0" y="18"/>
                          </a:lnTo>
                          <a:lnTo>
                            <a:pt x="0" y="12"/>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209" name="Freeform 161"/>
                    <p:cNvSpPr>
                      <a:spLocks noEditPoints="1"/>
                    </p:cNvSpPr>
                    <p:nvPr/>
                  </p:nvSpPr>
                  <p:spPr bwMode="auto">
                    <a:xfrm>
                      <a:off x="2492910" y="6432972"/>
                      <a:ext cx="31533" cy="16286"/>
                    </a:xfrm>
                    <a:custGeom>
                      <a:avLst/>
                      <a:gdLst/>
                      <a:ahLst/>
                      <a:cxnLst>
                        <a:cxn ang="0">
                          <a:pos x="18" y="18"/>
                        </a:cxn>
                        <a:cxn ang="0">
                          <a:pos x="18" y="9"/>
                        </a:cxn>
                        <a:cxn ang="0">
                          <a:pos x="18" y="0"/>
                        </a:cxn>
                        <a:cxn ang="0">
                          <a:pos x="18" y="18"/>
                        </a:cxn>
                        <a:cxn ang="0">
                          <a:pos x="0" y="18"/>
                        </a:cxn>
                        <a:cxn ang="0">
                          <a:pos x="36" y="18"/>
                        </a:cxn>
                        <a:cxn ang="0">
                          <a:pos x="0" y="18"/>
                        </a:cxn>
                        <a:cxn ang="0">
                          <a:pos x="0" y="0"/>
                        </a:cxn>
                        <a:cxn ang="0">
                          <a:pos x="36" y="0"/>
                        </a:cxn>
                        <a:cxn ang="0">
                          <a:pos x="0" y="0"/>
                        </a:cxn>
                      </a:cxnLst>
                      <a:rect l="0" t="0" r="r" b="b"/>
                      <a:pathLst>
                        <a:path w="36" h="18">
                          <a:moveTo>
                            <a:pt x="18" y="18"/>
                          </a:moveTo>
                          <a:lnTo>
                            <a:pt x="18" y="9"/>
                          </a:lnTo>
                          <a:lnTo>
                            <a:pt x="18" y="0"/>
                          </a:lnTo>
                          <a:lnTo>
                            <a:pt x="18" y="18"/>
                          </a:lnTo>
                          <a:close/>
                          <a:moveTo>
                            <a:pt x="0" y="18"/>
                          </a:moveTo>
                          <a:lnTo>
                            <a:pt x="36" y="18"/>
                          </a:lnTo>
                          <a:lnTo>
                            <a:pt x="0" y="18"/>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261" name="Freeform 162"/>
                    <p:cNvSpPr>
                      <a:spLocks noEditPoints="1"/>
                    </p:cNvSpPr>
                    <p:nvPr/>
                  </p:nvSpPr>
                  <p:spPr bwMode="auto">
                    <a:xfrm>
                      <a:off x="2488152" y="6430257"/>
                      <a:ext cx="31533" cy="21714"/>
                    </a:xfrm>
                    <a:custGeom>
                      <a:avLst/>
                      <a:gdLst/>
                      <a:ahLst/>
                      <a:cxnLst>
                        <a:cxn ang="0">
                          <a:pos x="15" y="21"/>
                        </a:cxn>
                        <a:cxn ang="0">
                          <a:pos x="15" y="12"/>
                        </a:cxn>
                        <a:cxn ang="0">
                          <a:pos x="15" y="3"/>
                        </a:cxn>
                        <a:cxn ang="0">
                          <a:pos x="21" y="3"/>
                        </a:cxn>
                        <a:cxn ang="0">
                          <a:pos x="21" y="12"/>
                        </a:cxn>
                        <a:cxn ang="0">
                          <a:pos x="21" y="21"/>
                        </a:cxn>
                        <a:cxn ang="0">
                          <a:pos x="15" y="21"/>
                        </a:cxn>
                        <a:cxn ang="0">
                          <a:pos x="0" y="18"/>
                        </a:cxn>
                        <a:cxn ang="0">
                          <a:pos x="36" y="18"/>
                        </a:cxn>
                        <a:cxn ang="0">
                          <a:pos x="36" y="24"/>
                        </a:cxn>
                        <a:cxn ang="0">
                          <a:pos x="0" y="24"/>
                        </a:cxn>
                        <a:cxn ang="0">
                          <a:pos x="0" y="18"/>
                        </a:cxn>
                        <a:cxn ang="0">
                          <a:pos x="0" y="0"/>
                        </a:cxn>
                        <a:cxn ang="0">
                          <a:pos x="36" y="0"/>
                        </a:cxn>
                        <a:cxn ang="0">
                          <a:pos x="36" y="6"/>
                        </a:cxn>
                        <a:cxn ang="0">
                          <a:pos x="0" y="6"/>
                        </a:cxn>
                        <a:cxn ang="0">
                          <a:pos x="0" y="0"/>
                        </a:cxn>
                      </a:cxnLst>
                      <a:rect l="0" t="0" r="r" b="b"/>
                      <a:pathLst>
                        <a:path w="36" h="24">
                          <a:moveTo>
                            <a:pt x="15" y="21"/>
                          </a:moveTo>
                          <a:lnTo>
                            <a:pt x="15" y="12"/>
                          </a:lnTo>
                          <a:lnTo>
                            <a:pt x="15" y="3"/>
                          </a:lnTo>
                          <a:lnTo>
                            <a:pt x="21" y="3"/>
                          </a:lnTo>
                          <a:lnTo>
                            <a:pt x="21" y="12"/>
                          </a:lnTo>
                          <a:lnTo>
                            <a:pt x="21" y="21"/>
                          </a:lnTo>
                          <a:lnTo>
                            <a:pt x="15" y="21"/>
                          </a:lnTo>
                          <a:close/>
                          <a:moveTo>
                            <a:pt x="0" y="18"/>
                          </a:moveTo>
                          <a:lnTo>
                            <a:pt x="36" y="18"/>
                          </a:lnTo>
                          <a:lnTo>
                            <a:pt x="36" y="24"/>
                          </a:lnTo>
                          <a:lnTo>
                            <a:pt x="0" y="24"/>
                          </a:lnTo>
                          <a:lnTo>
                            <a:pt x="0" y="18"/>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263" name="Freeform 163"/>
                    <p:cNvSpPr>
                      <a:spLocks noEditPoints="1"/>
                    </p:cNvSpPr>
                    <p:nvPr/>
                  </p:nvSpPr>
                  <p:spPr bwMode="auto">
                    <a:xfrm>
                      <a:off x="2693047" y="5596981"/>
                      <a:ext cx="31533" cy="108570"/>
                    </a:xfrm>
                    <a:custGeom>
                      <a:avLst/>
                      <a:gdLst/>
                      <a:ahLst/>
                      <a:cxnLst>
                        <a:cxn ang="0">
                          <a:pos x="18" y="120"/>
                        </a:cxn>
                        <a:cxn ang="0">
                          <a:pos x="18" y="60"/>
                        </a:cxn>
                        <a:cxn ang="0">
                          <a:pos x="18" y="0"/>
                        </a:cxn>
                        <a:cxn ang="0">
                          <a:pos x="18" y="120"/>
                        </a:cxn>
                        <a:cxn ang="0">
                          <a:pos x="0" y="120"/>
                        </a:cxn>
                        <a:cxn ang="0">
                          <a:pos x="36" y="120"/>
                        </a:cxn>
                        <a:cxn ang="0">
                          <a:pos x="0" y="120"/>
                        </a:cxn>
                        <a:cxn ang="0">
                          <a:pos x="0" y="0"/>
                        </a:cxn>
                        <a:cxn ang="0">
                          <a:pos x="36" y="0"/>
                        </a:cxn>
                        <a:cxn ang="0">
                          <a:pos x="0" y="0"/>
                        </a:cxn>
                      </a:cxnLst>
                      <a:rect l="0" t="0" r="r" b="b"/>
                      <a:pathLst>
                        <a:path w="36" h="120">
                          <a:moveTo>
                            <a:pt x="18" y="120"/>
                          </a:moveTo>
                          <a:lnTo>
                            <a:pt x="18" y="60"/>
                          </a:lnTo>
                          <a:lnTo>
                            <a:pt x="18" y="0"/>
                          </a:lnTo>
                          <a:lnTo>
                            <a:pt x="18" y="120"/>
                          </a:lnTo>
                          <a:close/>
                          <a:moveTo>
                            <a:pt x="0" y="120"/>
                          </a:moveTo>
                          <a:lnTo>
                            <a:pt x="36" y="120"/>
                          </a:lnTo>
                          <a:lnTo>
                            <a:pt x="0" y="120"/>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264" name="Freeform 164"/>
                    <p:cNvSpPr>
                      <a:spLocks noEditPoints="1"/>
                    </p:cNvSpPr>
                    <p:nvPr/>
                  </p:nvSpPr>
                  <p:spPr bwMode="auto">
                    <a:xfrm>
                      <a:off x="2693047" y="5594267"/>
                      <a:ext cx="31533" cy="113998"/>
                    </a:xfrm>
                    <a:custGeom>
                      <a:avLst/>
                      <a:gdLst/>
                      <a:ahLst/>
                      <a:cxnLst>
                        <a:cxn ang="0">
                          <a:pos x="15" y="123"/>
                        </a:cxn>
                        <a:cxn ang="0">
                          <a:pos x="15" y="63"/>
                        </a:cxn>
                        <a:cxn ang="0">
                          <a:pos x="15" y="3"/>
                        </a:cxn>
                        <a:cxn ang="0">
                          <a:pos x="21" y="3"/>
                        </a:cxn>
                        <a:cxn ang="0">
                          <a:pos x="21" y="63"/>
                        </a:cxn>
                        <a:cxn ang="0">
                          <a:pos x="21" y="123"/>
                        </a:cxn>
                        <a:cxn ang="0">
                          <a:pos x="15" y="123"/>
                        </a:cxn>
                        <a:cxn ang="0">
                          <a:pos x="0" y="120"/>
                        </a:cxn>
                        <a:cxn ang="0">
                          <a:pos x="36" y="120"/>
                        </a:cxn>
                        <a:cxn ang="0">
                          <a:pos x="36" y="126"/>
                        </a:cxn>
                        <a:cxn ang="0">
                          <a:pos x="0" y="126"/>
                        </a:cxn>
                        <a:cxn ang="0">
                          <a:pos x="0" y="120"/>
                        </a:cxn>
                        <a:cxn ang="0">
                          <a:pos x="0" y="0"/>
                        </a:cxn>
                        <a:cxn ang="0">
                          <a:pos x="36" y="0"/>
                        </a:cxn>
                        <a:cxn ang="0">
                          <a:pos x="36" y="6"/>
                        </a:cxn>
                        <a:cxn ang="0">
                          <a:pos x="0" y="6"/>
                        </a:cxn>
                        <a:cxn ang="0">
                          <a:pos x="0" y="0"/>
                        </a:cxn>
                      </a:cxnLst>
                      <a:rect l="0" t="0" r="r" b="b"/>
                      <a:pathLst>
                        <a:path w="36" h="126">
                          <a:moveTo>
                            <a:pt x="15" y="123"/>
                          </a:moveTo>
                          <a:lnTo>
                            <a:pt x="15" y="63"/>
                          </a:lnTo>
                          <a:lnTo>
                            <a:pt x="15" y="3"/>
                          </a:lnTo>
                          <a:lnTo>
                            <a:pt x="21" y="3"/>
                          </a:lnTo>
                          <a:lnTo>
                            <a:pt x="21" y="63"/>
                          </a:lnTo>
                          <a:lnTo>
                            <a:pt x="21" y="123"/>
                          </a:lnTo>
                          <a:lnTo>
                            <a:pt x="15" y="123"/>
                          </a:lnTo>
                          <a:close/>
                          <a:moveTo>
                            <a:pt x="0" y="120"/>
                          </a:moveTo>
                          <a:lnTo>
                            <a:pt x="36" y="120"/>
                          </a:lnTo>
                          <a:lnTo>
                            <a:pt x="36" y="126"/>
                          </a:lnTo>
                          <a:lnTo>
                            <a:pt x="0" y="126"/>
                          </a:lnTo>
                          <a:lnTo>
                            <a:pt x="0" y="120"/>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265" name="Freeform 165"/>
                    <p:cNvSpPr>
                      <a:spLocks noEditPoints="1"/>
                    </p:cNvSpPr>
                    <p:nvPr/>
                  </p:nvSpPr>
                  <p:spPr bwMode="auto">
                    <a:xfrm>
                      <a:off x="2878909" y="6467916"/>
                      <a:ext cx="31533" cy="5429"/>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266" name="Freeform 166"/>
                    <p:cNvSpPr>
                      <a:spLocks noEditPoints="1"/>
                    </p:cNvSpPr>
                    <p:nvPr/>
                  </p:nvSpPr>
                  <p:spPr bwMode="auto">
                    <a:xfrm>
                      <a:off x="2878909" y="6465202"/>
                      <a:ext cx="31533" cy="10857"/>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267" name="Freeform 167"/>
                    <p:cNvSpPr>
                      <a:spLocks noEditPoints="1"/>
                    </p:cNvSpPr>
                    <p:nvPr/>
                  </p:nvSpPr>
                  <p:spPr bwMode="auto">
                    <a:xfrm>
                      <a:off x="3079047" y="5900978"/>
                      <a:ext cx="31533" cy="130284"/>
                    </a:xfrm>
                    <a:custGeom>
                      <a:avLst/>
                      <a:gdLst/>
                      <a:ahLst/>
                      <a:cxnLst>
                        <a:cxn ang="0">
                          <a:pos x="18" y="144"/>
                        </a:cxn>
                        <a:cxn ang="0">
                          <a:pos x="18" y="72"/>
                        </a:cxn>
                        <a:cxn ang="0">
                          <a:pos x="18" y="0"/>
                        </a:cxn>
                        <a:cxn ang="0">
                          <a:pos x="18" y="144"/>
                        </a:cxn>
                        <a:cxn ang="0">
                          <a:pos x="0" y="144"/>
                        </a:cxn>
                        <a:cxn ang="0">
                          <a:pos x="36" y="144"/>
                        </a:cxn>
                        <a:cxn ang="0">
                          <a:pos x="0" y="144"/>
                        </a:cxn>
                        <a:cxn ang="0">
                          <a:pos x="0" y="0"/>
                        </a:cxn>
                        <a:cxn ang="0">
                          <a:pos x="36" y="0"/>
                        </a:cxn>
                        <a:cxn ang="0">
                          <a:pos x="0" y="0"/>
                        </a:cxn>
                      </a:cxnLst>
                      <a:rect l="0" t="0" r="r" b="b"/>
                      <a:pathLst>
                        <a:path w="36" h="144">
                          <a:moveTo>
                            <a:pt x="18" y="144"/>
                          </a:moveTo>
                          <a:lnTo>
                            <a:pt x="18" y="72"/>
                          </a:lnTo>
                          <a:lnTo>
                            <a:pt x="18" y="0"/>
                          </a:lnTo>
                          <a:lnTo>
                            <a:pt x="18" y="144"/>
                          </a:lnTo>
                          <a:close/>
                          <a:moveTo>
                            <a:pt x="0" y="144"/>
                          </a:moveTo>
                          <a:lnTo>
                            <a:pt x="36" y="144"/>
                          </a:lnTo>
                          <a:lnTo>
                            <a:pt x="0" y="144"/>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300" name="Freeform 168"/>
                    <p:cNvSpPr>
                      <a:spLocks noEditPoints="1"/>
                    </p:cNvSpPr>
                    <p:nvPr/>
                  </p:nvSpPr>
                  <p:spPr bwMode="auto">
                    <a:xfrm>
                      <a:off x="3079047" y="5898264"/>
                      <a:ext cx="31533" cy="135713"/>
                    </a:xfrm>
                    <a:custGeom>
                      <a:avLst/>
                      <a:gdLst/>
                      <a:ahLst/>
                      <a:cxnLst>
                        <a:cxn ang="0">
                          <a:pos x="15" y="147"/>
                        </a:cxn>
                        <a:cxn ang="0">
                          <a:pos x="15" y="75"/>
                        </a:cxn>
                        <a:cxn ang="0">
                          <a:pos x="15" y="3"/>
                        </a:cxn>
                        <a:cxn ang="0">
                          <a:pos x="21" y="3"/>
                        </a:cxn>
                        <a:cxn ang="0">
                          <a:pos x="21" y="75"/>
                        </a:cxn>
                        <a:cxn ang="0">
                          <a:pos x="21" y="147"/>
                        </a:cxn>
                        <a:cxn ang="0">
                          <a:pos x="15" y="147"/>
                        </a:cxn>
                        <a:cxn ang="0">
                          <a:pos x="0" y="144"/>
                        </a:cxn>
                        <a:cxn ang="0">
                          <a:pos x="36" y="144"/>
                        </a:cxn>
                        <a:cxn ang="0">
                          <a:pos x="36" y="150"/>
                        </a:cxn>
                        <a:cxn ang="0">
                          <a:pos x="0" y="150"/>
                        </a:cxn>
                        <a:cxn ang="0">
                          <a:pos x="0" y="144"/>
                        </a:cxn>
                        <a:cxn ang="0">
                          <a:pos x="0" y="0"/>
                        </a:cxn>
                        <a:cxn ang="0">
                          <a:pos x="36" y="0"/>
                        </a:cxn>
                        <a:cxn ang="0">
                          <a:pos x="36" y="6"/>
                        </a:cxn>
                        <a:cxn ang="0">
                          <a:pos x="0" y="6"/>
                        </a:cxn>
                        <a:cxn ang="0">
                          <a:pos x="0" y="0"/>
                        </a:cxn>
                      </a:cxnLst>
                      <a:rect l="0" t="0" r="r" b="b"/>
                      <a:pathLst>
                        <a:path w="36" h="150">
                          <a:moveTo>
                            <a:pt x="15" y="147"/>
                          </a:moveTo>
                          <a:lnTo>
                            <a:pt x="15" y="75"/>
                          </a:lnTo>
                          <a:lnTo>
                            <a:pt x="15" y="3"/>
                          </a:lnTo>
                          <a:lnTo>
                            <a:pt x="21" y="3"/>
                          </a:lnTo>
                          <a:lnTo>
                            <a:pt x="21" y="75"/>
                          </a:lnTo>
                          <a:lnTo>
                            <a:pt x="21" y="147"/>
                          </a:lnTo>
                          <a:lnTo>
                            <a:pt x="15" y="147"/>
                          </a:lnTo>
                          <a:close/>
                          <a:moveTo>
                            <a:pt x="0" y="144"/>
                          </a:moveTo>
                          <a:lnTo>
                            <a:pt x="36" y="144"/>
                          </a:lnTo>
                          <a:lnTo>
                            <a:pt x="36" y="150"/>
                          </a:lnTo>
                          <a:lnTo>
                            <a:pt x="0" y="150"/>
                          </a:lnTo>
                          <a:lnTo>
                            <a:pt x="0" y="144"/>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1301" name="Freeform 169"/>
                    <p:cNvSpPr>
                      <a:spLocks noEditPoints="1"/>
                    </p:cNvSpPr>
                    <p:nvPr/>
                  </p:nvSpPr>
                  <p:spPr bwMode="auto">
                    <a:xfrm>
                      <a:off x="3274922" y="6464860"/>
                      <a:ext cx="31533" cy="5429"/>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1302" name="Freeform 170"/>
                    <p:cNvSpPr>
                      <a:spLocks noEditPoints="1"/>
                    </p:cNvSpPr>
                    <p:nvPr/>
                  </p:nvSpPr>
                  <p:spPr bwMode="auto">
                    <a:xfrm>
                      <a:off x="3270165" y="6462145"/>
                      <a:ext cx="31533" cy="10857"/>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570" name="Rectangle 195"/>
                    <p:cNvSpPr>
                      <a:spLocks noChangeArrowheads="1"/>
                    </p:cNvSpPr>
                    <p:nvPr/>
                  </p:nvSpPr>
                  <p:spPr bwMode="auto">
                    <a:xfrm>
                      <a:off x="3032705" y="5777371"/>
                      <a:ext cx="127825"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b</a:t>
                      </a:r>
                      <a:endParaRPr lang="en-US" sz="800">
                        <a:latin typeface="Arial" pitchFamily="34" charset="0"/>
                        <a:cs typeface="Arial" pitchFamily="34" charset="0"/>
                      </a:endParaRPr>
                    </a:p>
                  </p:txBody>
                </p:sp>
                <p:sp>
                  <p:nvSpPr>
                    <p:cNvPr id="571" name="Rectangle 196"/>
                    <p:cNvSpPr>
                      <a:spLocks noChangeArrowheads="1"/>
                    </p:cNvSpPr>
                    <p:nvPr/>
                  </p:nvSpPr>
                  <p:spPr bwMode="auto">
                    <a:xfrm>
                      <a:off x="1867470" y="6333912"/>
                      <a:ext cx="118597"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d</a:t>
                      </a:r>
                      <a:endParaRPr lang="en-US" sz="800">
                        <a:latin typeface="Arial" pitchFamily="34" charset="0"/>
                        <a:cs typeface="Arial" pitchFamily="34" charset="0"/>
                      </a:endParaRPr>
                    </a:p>
                  </p:txBody>
                </p:sp>
                <p:sp>
                  <p:nvSpPr>
                    <p:cNvPr id="572" name="Rectangle 197"/>
                    <p:cNvSpPr>
                      <a:spLocks noChangeArrowheads="1"/>
                    </p:cNvSpPr>
                    <p:nvPr/>
                  </p:nvSpPr>
                  <p:spPr bwMode="auto">
                    <a:xfrm>
                      <a:off x="2055337" y="6331537"/>
                      <a:ext cx="147197"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d</a:t>
                      </a:r>
                      <a:endParaRPr lang="en-US" sz="800">
                        <a:latin typeface="Arial" pitchFamily="34" charset="0"/>
                        <a:cs typeface="Arial" pitchFamily="34" charset="0"/>
                      </a:endParaRPr>
                    </a:p>
                  </p:txBody>
                </p:sp>
                <p:sp>
                  <p:nvSpPr>
                    <p:cNvPr id="573" name="Rectangle 198"/>
                    <p:cNvSpPr>
                      <a:spLocks noChangeArrowheads="1"/>
                    </p:cNvSpPr>
                    <p:nvPr/>
                  </p:nvSpPr>
                  <p:spPr bwMode="auto">
                    <a:xfrm>
                      <a:off x="2258099" y="6307677"/>
                      <a:ext cx="106188"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c</a:t>
                      </a:r>
                      <a:endParaRPr lang="en-US" sz="800">
                        <a:latin typeface="Arial" pitchFamily="34" charset="0"/>
                        <a:cs typeface="Arial" pitchFamily="34" charset="0"/>
                      </a:endParaRPr>
                    </a:p>
                  </p:txBody>
                </p:sp>
                <p:sp>
                  <p:nvSpPr>
                    <p:cNvPr id="574" name="Rectangle 199"/>
                    <p:cNvSpPr>
                      <a:spLocks noChangeArrowheads="1"/>
                    </p:cNvSpPr>
                    <p:nvPr/>
                  </p:nvSpPr>
                  <p:spPr bwMode="auto">
                    <a:xfrm>
                      <a:off x="2438020" y="6305300"/>
                      <a:ext cx="132049"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c</a:t>
                      </a:r>
                      <a:endParaRPr lang="en-US" sz="800">
                        <a:latin typeface="Arial" pitchFamily="34" charset="0"/>
                        <a:cs typeface="Arial" pitchFamily="34" charset="0"/>
                      </a:endParaRPr>
                    </a:p>
                  </p:txBody>
                </p:sp>
                <p:sp>
                  <p:nvSpPr>
                    <p:cNvPr id="575" name="Rectangle 200"/>
                    <p:cNvSpPr>
                      <a:spLocks noChangeArrowheads="1"/>
                    </p:cNvSpPr>
                    <p:nvPr/>
                  </p:nvSpPr>
                  <p:spPr bwMode="auto">
                    <a:xfrm>
                      <a:off x="2652108" y="5470894"/>
                      <a:ext cx="114115"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a</a:t>
                      </a:r>
                      <a:endParaRPr lang="en-US" sz="800">
                        <a:latin typeface="Arial" pitchFamily="34" charset="0"/>
                        <a:cs typeface="Arial" pitchFamily="34" charset="0"/>
                      </a:endParaRPr>
                    </a:p>
                  </p:txBody>
                </p:sp>
                <p:sp>
                  <p:nvSpPr>
                    <p:cNvPr id="576" name="Rectangle 201"/>
                    <p:cNvSpPr>
                      <a:spLocks noChangeArrowheads="1"/>
                    </p:cNvSpPr>
                    <p:nvPr/>
                  </p:nvSpPr>
                  <p:spPr bwMode="auto">
                    <a:xfrm>
                      <a:off x="2849546" y="6338657"/>
                      <a:ext cx="84185"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d</a:t>
                      </a:r>
                      <a:endParaRPr lang="en-US" sz="800">
                        <a:latin typeface="Arial" pitchFamily="34" charset="0"/>
                        <a:cs typeface="Arial" pitchFamily="34" charset="0"/>
                      </a:endParaRPr>
                    </a:p>
                  </p:txBody>
                </p:sp>
                <p:sp>
                  <p:nvSpPr>
                    <p:cNvPr id="577" name="Rectangle 202"/>
                    <p:cNvSpPr>
                      <a:spLocks noChangeArrowheads="1"/>
                    </p:cNvSpPr>
                    <p:nvPr/>
                  </p:nvSpPr>
                  <p:spPr bwMode="auto">
                    <a:xfrm>
                      <a:off x="3244412" y="6328377"/>
                      <a:ext cx="81329" cy="12666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pitchFamily="34" charset="0"/>
                          <a:cs typeface="Arial" pitchFamily="34" charset="0"/>
                        </a:rPr>
                        <a:t>d</a:t>
                      </a:r>
                      <a:endParaRPr lang="en-US" sz="800">
                        <a:latin typeface="Arial" pitchFamily="34" charset="0"/>
                        <a:cs typeface="Arial" pitchFamily="34" charset="0"/>
                      </a:endParaRPr>
                    </a:p>
                  </p:txBody>
                </p:sp>
              </p:grpSp>
            </p:grpSp>
            <p:sp>
              <p:nvSpPr>
                <p:cNvPr id="667" name="TextBox 666"/>
                <p:cNvSpPr txBox="1"/>
                <p:nvPr/>
              </p:nvSpPr>
              <p:spPr>
                <a:xfrm rot="16200000">
                  <a:off x="-1228415" y="3337076"/>
                  <a:ext cx="2880320" cy="288032"/>
                </a:xfrm>
                <a:prstGeom prst="rect">
                  <a:avLst/>
                </a:prstGeom>
                <a:noFill/>
              </p:spPr>
              <p:txBody>
                <a:bodyPr wrap="square" rtlCol="0">
                  <a:spAutoFit/>
                </a:bodyPr>
                <a:lstStyle/>
                <a:p>
                  <a:pPr algn="ctr"/>
                  <a:r>
                    <a:rPr lang="en-IN" sz="1200" dirty="0">
                      <a:latin typeface="Calibri "/>
                    </a:rPr>
                    <a:t>Root transcript amounts (r. u.)</a:t>
                  </a:r>
                </a:p>
              </p:txBody>
            </p:sp>
          </p:grpSp>
          <p:grpSp>
            <p:nvGrpSpPr>
              <p:cNvPr id="12" name="Group 11">
                <a:extLst>
                  <a:ext uri="{FF2B5EF4-FFF2-40B4-BE49-F238E27FC236}">
                    <a16:creationId xmlns:a16="http://schemas.microsoft.com/office/drawing/2014/main" id="{CE09A932-7F0B-493A-884E-E6D61A4A5749}"/>
                  </a:ext>
                </a:extLst>
              </p:cNvPr>
              <p:cNvGrpSpPr/>
              <p:nvPr/>
            </p:nvGrpSpPr>
            <p:grpSpPr>
              <a:xfrm>
                <a:off x="3142440" y="457186"/>
                <a:ext cx="2235199" cy="4343398"/>
                <a:chOff x="2794000" y="1436780"/>
                <a:chExt cx="2235199" cy="4343398"/>
              </a:xfrm>
            </p:grpSpPr>
            <p:sp>
              <p:nvSpPr>
                <p:cNvPr id="457" name="TextBox 456"/>
                <p:cNvSpPr txBox="1"/>
                <p:nvPr/>
              </p:nvSpPr>
              <p:spPr>
                <a:xfrm rot="16200000">
                  <a:off x="760801" y="3469979"/>
                  <a:ext cx="4343398" cy="276999"/>
                </a:xfrm>
                <a:prstGeom prst="rect">
                  <a:avLst/>
                </a:prstGeom>
                <a:noFill/>
              </p:spPr>
              <p:txBody>
                <a:bodyPr wrap="square" rtlCol="0">
                  <a:spAutoFit/>
                </a:bodyPr>
                <a:lstStyle/>
                <a:p>
                  <a:pPr algn="ctr"/>
                  <a:r>
                    <a:rPr lang="en-IN" sz="1200">
                      <a:latin typeface="Calibri "/>
                    </a:rPr>
                    <a:t>Transcript expression (r. u.)</a:t>
                  </a:r>
                </a:p>
              </p:txBody>
            </p:sp>
            <p:grpSp>
              <p:nvGrpSpPr>
                <p:cNvPr id="6" name="Group 5">
                  <a:extLst>
                    <a:ext uri="{FF2B5EF4-FFF2-40B4-BE49-F238E27FC236}">
                      <a16:creationId xmlns:a16="http://schemas.microsoft.com/office/drawing/2014/main" id="{46EC89F1-DC55-4330-8349-AEDEC3DC8C9A}"/>
                    </a:ext>
                  </a:extLst>
                </p:cNvPr>
                <p:cNvGrpSpPr/>
                <p:nvPr/>
              </p:nvGrpSpPr>
              <p:grpSpPr>
                <a:xfrm>
                  <a:off x="3103240" y="4168635"/>
                  <a:ext cx="1908374" cy="1265011"/>
                  <a:chOff x="3135342" y="585309"/>
                  <a:chExt cx="1908374" cy="1265011"/>
                </a:xfrm>
              </p:grpSpPr>
              <p:sp>
                <p:nvSpPr>
                  <p:cNvPr id="466" name="Rectangle 46"/>
                  <p:cNvSpPr>
                    <a:spLocks noChangeArrowheads="1"/>
                  </p:cNvSpPr>
                  <p:nvPr/>
                </p:nvSpPr>
                <p:spPr bwMode="auto">
                  <a:xfrm>
                    <a:off x="3666478" y="1727209"/>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467" name="Rectangle 46"/>
                  <p:cNvSpPr>
                    <a:spLocks noChangeArrowheads="1"/>
                  </p:cNvSpPr>
                  <p:nvPr/>
                </p:nvSpPr>
                <p:spPr bwMode="auto">
                  <a:xfrm>
                    <a:off x="4052200" y="1727209"/>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468" name="Rectangle 46"/>
                  <p:cNvSpPr>
                    <a:spLocks noChangeArrowheads="1"/>
                  </p:cNvSpPr>
                  <p:nvPr/>
                </p:nvSpPr>
                <p:spPr bwMode="auto">
                  <a:xfrm>
                    <a:off x="4444691" y="1727209"/>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469" name="Rectangle 46"/>
                  <p:cNvSpPr>
                    <a:spLocks noChangeArrowheads="1"/>
                  </p:cNvSpPr>
                  <p:nvPr/>
                </p:nvSpPr>
                <p:spPr bwMode="auto">
                  <a:xfrm>
                    <a:off x="4837180" y="1727209"/>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grpSp>
                <p:nvGrpSpPr>
                  <p:cNvPr id="5" name="Group 4">
                    <a:extLst>
                      <a:ext uri="{FF2B5EF4-FFF2-40B4-BE49-F238E27FC236}">
                        <a16:creationId xmlns:a16="http://schemas.microsoft.com/office/drawing/2014/main" id="{1DA79131-20C4-4CAC-BFD0-2B0C60F850E6}"/>
                      </a:ext>
                    </a:extLst>
                  </p:cNvPr>
                  <p:cNvGrpSpPr/>
                  <p:nvPr/>
                </p:nvGrpSpPr>
                <p:grpSpPr>
                  <a:xfrm>
                    <a:off x="3135342" y="585309"/>
                    <a:ext cx="1908374" cy="1204396"/>
                    <a:chOff x="3135342" y="585309"/>
                    <a:chExt cx="1908374" cy="1204396"/>
                  </a:xfrm>
                </p:grpSpPr>
                <p:sp>
                  <p:nvSpPr>
                    <p:cNvPr id="459" name="Freeform 40"/>
                    <p:cNvSpPr>
                      <a:spLocks noEditPoints="1"/>
                    </p:cNvSpPr>
                    <p:nvPr/>
                  </p:nvSpPr>
                  <p:spPr bwMode="auto">
                    <a:xfrm>
                      <a:off x="3390923" y="840493"/>
                      <a:ext cx="25488" cy="872459"/>
                    </a:xfrm>
                    <a:custGeom>
                      <a:avLst/>
                      <a:gdLst/>
                      <a:ahLst/>
                      <a:cxnLst>
                        <a:cxn ang="0">
                          <a:pos x="0" y="1044"/>
                        </a:cxn>
                        <a:cxn ang="0">
                          <a:pos x="30" y="1044"/>
                        </a:cxn>
                        <a:cxn ang="0">
                          <a:pos x="30" y="1050"/>
                        </a:cxn>
                        <a:cxn ang="0">
                          <a:pos x="0" y="1050"/>
                        </a:cxn>
                        <a:cxn ang="0">
                          <a:pos x="0" y="1044"/>
                        </a:cxn>
                        <a:cxn ang="0">
                          <a:pos x="0" y="522"/>
                        </a:cxn>
                        <a:cxn ang="0">
                          <a:pos x="30" y="522"/>
                        </a:cxn>
                        <a:cxn ang="0">
                          <a:pos x="30" y="528"/>
                        </a:cxn>
                        <a:cxn ang="0">
                          <a:pos x="0" y="528"/>
                        </a:cxn>
                        <a:cxn ang="0">
                          <a:pos x="0" y="522"/>
                        </a:cxn>
                        <a:cxn ang="0">
                          <a:pos x="0" y="0"/>
                        </a:cxn>
                        <a:cxn ang="0">
                          <a:pos x="30" y="0"/>
                        </a:cxn>
                        <a:cxn ang="0">
                          <a:pos x="30" y="6"/>
                        </a:cxn>
                        <a:cxn ang="0">
                          <a:pos x="0" y="6"/>
                        </a:cxn>
                        <a:cxn ang="0">
                          <a:pos x="0" y="0"/>
                        </a:cxn>
                      </a:cxnLst>
                      <a:rect l="0" t="0" r="r" b="b"/>
                      <a:pathLst>
                        <a:path w="30" h="1050">
                          <a:moveTo>
                            <a:pt x="0" y="1044"/>
                          </a:moveTo>
                          <a:lnTo>
                            <a:pt x="30" y="1044"/>
                          </a:lnTo>
                          <a:lnTo>
                            <a:pt x="30" y="1050"/>
                          </a:lnTo>
                          <a:lnTo>
                            <a:pt x="0" y="1050"/>
                          </a:lnTo>
                          <a:lnTo>
                            <a:pt x="0" y="1044"/>
                          </a:lnTo>
                          <a:close/>
                          <a:moveTo>
                            <a:pt x="0" y="522"/>
                          </a:moveTo>
                          <a:lnTo>
                            <a:pt x="30" y="522"/>
                          </a:lnTo>
                          <a:lnTo>
                            <a:pt x="30" y="528"/>
                          </a:lnTo>
                          <a:lnTo>
                            <a:pt x="0" y="528"/>
                          </a:lnTo>
                          <a:lnTo>
                            <a:pt x="0" y="522"/>
                          </a:lnTo>
                          <a:close/>
                          <a:moveTo>
                            <a:pt x="0" y="0"/>
                          </a:moveTo>
                          <a:lnTo>
                            <a:pt x="30" y="0"/>
                          </a:lnTo>
                          <a:lnTo>
                            <a:pt x="30" y="6"/>
                          </a:lnTo>
                          <a:lnTo>
                            <a:pt x="0" y="6"/>
                          </a:lnTo>
                          <a:lnTo>
                            <a:pt x="0" y="0"/>
                          </a:lnTo>
                          <a:close/>
                        </a:path>
                      </a:pathLst>
                    </a:custGeom>
                    <a:solidFill>
                      <a:schemeClr val="tx1"/>
                    </a:solidFill>
                    <a:ln w="635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sz="800">
                        <a:latin typeface="Calibri "/>
                      </a:endParaRPr>
                    </a:p>
                  </p:txBody>
                </p:sp>
                <p:sp>
                  <p:nvSpPr>
                    <p:cNvPr id="460" name="Rectangle 43"/>
                    <p:cNvSpPr>
                      <a:spLocks noChangeArrowheads="1"/>
                    </p:cNvSpPr>
                    <p:nvPr/>
                  </p:nvSpPr>
                  <p:spPr bwMode="auto">
                    <a:xfrm>
                      <a:off x="3285595" y="1666594"/>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0</a:t>
                      </a:r>
                      <a:endParaRPr lang="en-US" sz="800">
                        <a:latin typeface="Calibri "/>
                        <a:cs typeface="Arial" pitchFamily="34" charset="0"/>
                      </a:endParaRPr>
                    </a:p>
                  </p:txBody>
                </p:sp>
                <p:sp>
                  <p:nvSpPr>
                    <p:cNvPr id="461" name="Rectangle 44"/>
                    <p:cNvSpPr>
                      <a:spLocks noChangeArrowheads="1"/>
                    </p:cNvSpPr>
                    <p:nvPr/>
                  </p:nvSpPr>
                  <p:spPr bwMode="auto">
                    <a:xfrm>
                      <a:off x="3135342" y="1214389"/>
                      <a:ext cx="230832"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1000</a:t>
                      </a:r>
                      <a:endParaRPr lang="en-US" sz="800">
                        <a:latin typeface="Calibri "/>
                        <a:cs typeface="Arial" pitchFamily="34" charset="0"/>
                      </a:endParaRPr>
                    </a:p>
                  </p:txBody>
                </p:sp>
                <p:sp>
                  <p:nvSpPr>
                    <p:cNvPr id="462" name="Rectangle 45"/>
                    <p:cNvSpPr>
                      <a:spLocks noChangeArrowheads="1"/>
                    </p:cNvSpPr>
                    <p:nvPr/>
                  </p:nvSpPr>
                  <p:spPr bwMode="auto">
                    <a:xfrm>
                      <a:off x="3136135" y="787171"/>
                      <a:ext cx="230832"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2000</a:t>
                      </a:r>
                      <a:endParaRPr lang="en-US" sz="800">
                        <a:latin typeface="Calibri "/>
                        <a:cs typeface="Arial" pitchFamily="34" charset="0"/>
                      </a:endParaRPr>
                    </a:p>
                  </p:txBody>
                </p:sp>
                <p:sp>
                  <p:nvSpPr>
                    <p:cNvPr id="463" name="Rectangle 62"/>
                    <p:cNvSpPr>
                      <a:spLocks noChangeArrowheads="1"/>
                    </p:cNvSpPr>
                    <p:nvPr/>
                  </p:nvSpPr>
                  <p:spPr bwMode="auto">
                    <a:xfrm>
                      <a:off x="3530854" y="788636"/>
                      <a:ext cx="274114"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b="1" i="1">
                          <a:solidFill>
                            <a:srgbClr val="000000"/>
                          </a:solidFill>
                          <a:latin typeface="Calibri "/>
                          <a:cs typeface="Arial" pitchFamily="34" charset="0"/>
                        </a:rPr>
                        <a:t>HUP7</a:t>
                      </a:r>
                      <a:endParaRPr lang="en-US" sz="800" b="1" i="1">
                        <a:latin typeface="Calibri "/>
                        <a:cs typeface="Arial" pitchFamily="34" charset="0"/>
                      </a:endParaRPr>
                    </a:p>
                  </p:txBody>
                </p:sp>
                <p:cxnSp>
                  <p:nvCxnSpPr>
                    <p:cNvPr id="464" name="Straight Connector 463"/>
                    <p:cNvCxnSpPr/>
                    <p:nvPr/>
                  </p:nvCxnSpPr>
                  <p:spPr>
                    <a:xfrm>
                      <a:off x="3419622" y="1710067"/>
                      <a:ext cx="162409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5" name="Straight Connector 464"/>
                    <p:cNvCxnSpPr/>
                    <p:nvPr/>
                  </p:nvCxnSpPr>
                  <p:spPr>
                    <a:xfrm>
                      <a:off x="3420609" y="789177"/>
                      <a:ext cx="0" cy="91621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70" name="Rectangle 8"/>
                    <p:cNvSpPr>
                      <a:spLocks noChangeArrowheads="1"/>
                    </p:cNvSpPr>
                    <p:nvPr/>
                  </p:nvSpPr>
                  <p:spPr bwMode="auto">
                    <a:xfrm>
                      <a:off x="3491071" y="1692806"/>
                      <a:ext cx="126000" cy="9707"/>
                    </a:xfrm>
                    <a:prstGeom prst="rect">
                      <a:avLst/>
                    </a:prstGeom>
                    <a:solidFill>
                      <a:srgbClr val="FDEAD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1" name="Rectangle 10"/>
                    <p:cNvSpPr>
                      <a:spLocks noChangeArrowheads="1"/>
                    </p:cNvSpPr>
                    <p:nvPr/>
                  </p:nvSpPr>
                  <p:spPr bwMode="auto">
                    <a:xfrm>
                      <a:off x="3674855" y="1689952"/>
                      <a:ext cx="126000" cy="9707"/>
                    </a:xfrm>
                    <a:prstGeom prst="rect">
                      <a:avLst/>
                    </a:prstGeom>
                    <a:solidFill>
                      <a:srgbClr val="EBF1DE"/>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2" name="Rectangle 12"/>
                    <p:cNvSpPr>
                      <a:spLocks noChangeArrowheads="1"/>
                    </p:cNvSpPr>
                    <p:nvPr/>
                  </p:nvSpPr>
                  <p:spPr bwMode="auto">
                    <a:xfrm>
                      <a:off x="3864440" y="1691765"/>
                      <a:ext cx="126000" cy="14561"/>
                    </a:xfrm>
                    <a:prstGeom prst="rect">
                      <a:avLst/>
                    </a:prstGeom>
                    <a:solidFill>
                      <a:srgbClr val="FCD5B5"/>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3" name="Rectangle 14"/>
                    <p:cNvSpPr>
                      <a:spLocks noChangeArrowheads="1"/>
                    </p:cNvSpPr>
                    <p:nvPr/>
                  </p:nvSpPr>
                  <p:spPr bwMode="auto">
                    <a:xfrm>
                      <a:off x="4057115" y="1678245"/>
                      <a:ext cx="126000" cy="24268"/>
                    </a:xfrm>
                    <a:prstGeom prst="rect">
                      <a:avLst/>
                    </a:prstGeom>
                    <a:solidFill>
                      <a:srgbClr val="D7E4BD"/>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4" name="Rectangle 16"/>
                    <p:cNvSpPr>
                      <a:spLocks noChangeArrowheads="1"/>
                    </p:cNvSpPr>
                    <p:nvPr/>
                  </p:nvSpPr>
                  <p:spPr bwMode="auto">
                    <a:xfrm>
                      <a:off x="4263211" y="888999"/>
                      <a:ext cx="126000" cy="815421"/>
                    </a:xfrm>
                    <a:prstGeom prst="rect">
                      <a:avLst/>
                    </a:prstGeom>
                    <a:solidFill>
                      <a:srgbClr val="FAC090"/>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5" name="Rectangle 18"/>
                    <p:cNvSpPr>
                      <a:spLocks noChangeArrowheads="1"/>
                    </p:cNvSpPr>
                    <p:nvPr/>
                  </p:nvSpPr>
                  <p:spPr bwMode="auto">
                    <a:xfrm>
                      <a:off x="4454614" y="1687002"/>
                      <a:ext cx="126000" cy="14561"/>
                    </a:xfrm>
                    <a:prstGeom prst="rect">
                      <a:avLst/>
                    </a:prstGeom>
                    <a:solidFill>
                      <a:srgbClr val="C3D69B"/>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6" name="Rectangle 20"/>
                    <p:cNvSpPr>
                      <a:spLocks noChangeArrowheads="1"/>
                    </p:cNvSpPr>
                    <p:nvPr/>
                  </p:nvSpPr>
                  <p:spPr bwMode="auto">
                    <a:xfrm>
                      <a:off x="4653638" y="1296709"/>
                      <a:ext cx="126000" cy="407710"/>
                    </a:xfrm>
                    <a:prstGeom prst="rect">
                      <a:avLst/>
                    </a:prstGeom>
                    <a:solidFill>
                      <a:srgbClr val="E46C0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7" name="Rectangle 22"/>
                    <p:cNvSpPr>
                      <a:spLocks noChangeArrowheads="1"/>
                    </p:cNvSpPr>
                    <p:nvPr/>
                  </p:nvSpPr>
                  <p:spPr bwMode="auto">
                    <a:xfrm>
                      <a:off x="4844494" y="1660737"/>
                      <a:ext cx="126000" cy="43683"/>
                    </a:xfrm>
                    <a:prstGeom prst="rect">
                      <a:avLst/>
                    </a:prstGeom>
                    <a:solidFill>
                      <a:srgbClr val="77933C"/>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478" name="Freeform 24"/>
                    <p:cNvSpPr>
                      <a:spLocks noEditPoints="1"/>
                    </p:cNvSpPr>
                    <p:nvPr/>
                  </p:nvSpPr>
                  <p:spPr bwMode="auto">
                    <a:xfrm>
                      <a:off x="3547649" y="1697660"/>
                      <a:ext cx="42434" cy="809"/>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479" name="Freeform 25"/>
                    <p:cNvSpPr>
                      <a:spLocks noEditPoints="1"/>
                    </p:cNvSpPr>
                    <p:nvPr/>
                  </p:nvSpPr>
                  <p:spPr bwMode="auto">
                    <a:xfrm>
                      <a:off x="3738505" y="1694806"/>
                      <a:ext cx="42434" cy="809"/>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480" name="Freeform 26"/>
                    <p:cNvSpPr>
                      <a:spLocks noEditPoints="1"/>
                    </p:cNvSpPr>
                    <p:nvPr/>
                  </p:nvSpPr>
                  <p:spPr bwMode="auto">
                    <a:xfrm>
                      <a:off x="3921020" y="1696618"/>
                      <a:ext cx="42434" cy="809"/>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481" name="Freeform 27"/>
                    <p:cNvSpPr>
                      <a:spLocks noEditPoints="1"/>
                    </p:cNvSpPr>
                    <p:nvPr/>
                  </p:nvSpPr>
                  <p:spPr bwMode="auto">
                    <a:xfrm>
                      <a:off x="4113693" y="1678245"/>
                      <a:ext cx="42434" cy="9707"/>
                    </a:xfrm>
                    <a:custGeom>
                      <a:avLst/>
                      <a:gdLst/>
                      <a:ahLst/>
                      <a:cxnLst>
                        <a:cxn ang="0">
                          <a:pos x="18" y="12"/>
                        </a:cxn>
                        <a:cxn ang="0">
                          <a:pos x="18" y="6"/>
                        </a:cxn>
                        <a:cxn ang="0">
                          <a:pos x="18" y="0"/>
                        </a:cxn>
                        <a:cxn ang="0">
                          <a:pos x="18" y="12"/>
                        </a:cxn>
                        <a:cxn ang="0">
                          <a:pos x="0" y="12"/>
                        </a:cxn>
                        <a:cxn ang="0">
                          <a:pos x="36" y="12"/>
                        </a:cxn>
                        <a:cxn ang="0">
                          <a:pos x="0" y="12"/>
                        </a:cxn>
                        <a:cxn ang="0">
                          <a:pos x="0" y="0"/>
                        </a:cxn>
                        <a:cxn ang="0">
                          <a:pos x="36" y="0"/>
                        </a:cxn>
                        <a:cxn ang="0">
                          <a:pos x="0" y="0"/>
                        </a:cxn>
                      </a:cxnLst>
                      <a:rect l="0" t="0" r="r" b="b"/>
                      <a:pathLst>
                        <a:path w="36" h="12">
                          <a:moveTo>
                            <a:pt x="18" y="12"/>
                          </a:moveTo>
                          <a:lnTo>
                            <a:pt x="18" y="6"/>
                          </a:lnTo>
                          <a:lnTo>
                            <a:pt x="18" y="0"/>
                          </a:lnTo>
                          <a:lnTo>
                            <a:pt x="18" y="12"/>
                          </a:lnTo>
                          <a:close/>
                          <a:moveTo>
                            <a:pt x="0" y="12"/>
                          </a:moveTo>
                          <a:lnTo>
                            <a:pt x="36" y="12"/>
                          </a:lnTo>
                          <a:lnTo>
                            <a:pt x="0" y="12"/>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482" name="Freeform 28"/>
                    <p:cNvSpPr>
                      <a:spLocks noEditPoints="1"/>
                    </p:cNvSpPr>
                    <p:nvPr/>
                  </p:nvSpPr>
                  <p:spPr bwMode="auto">
                    <a:xfrm>
                      <a:off x="4094643" y="1669469"/>
                      <a:ext cx="42434" cy="14561"/>
                    </a:xfrm>
                    <a:custGeom>
                      <a:avLst/>
                      <a:gdLst/>
                      <a:ahLst/>
                      <a:cxnLst>
                        <a:cxn ang="0">
                          <a:pos x="15" y="15"/>
                        </a:cxn>
                        <a:cxn ang="0">
                          <a:pos x="15" y="9"/>
                        </a:cxn>
                        <a:cxn ang="0">
                          <a:pos x="15" y="3"/>
                        </a:cxn>
                        <a:cxn ang="0">
                          <a:pos x="21" y="3"/>
                        </a:cxn>
                        <a:cxn ang="0">
                          <a:pos x="21" y="9"/>
                        </a:cxn>
                        <a:cxn ang="0">
                          <a:pos x="21" y="15"/>
                        </a:cxn>
                        <a:cxn ang="0">
                          <a:pos x="15" y="15"/>
                        </a:cxn>
                        <a:cxn ang="0">
                          <a:pos x="0" y="12"/>
                        </a:cxn>
                        <a:cxn ang="0">
                          <a:pos x="36" y="12"/>
                        </a:cxn>
                        <a:cxn ang="0">
                          <a:pos x="36" y="18"/>
                        </a:cxn>
                        <a:cxn ang="0">
                          <a:pos x="0" y="18"/>
                        </a:cxn>
                        <a:cxn ang="0">
                          <a:pos x="0" y="12"/>
                        </a:cxn>
                        <a:cxn ang="0">
                          <a:pos x="0" y="0"/>
                        </a:cxn>
                        <a:cxn ang="0">
                          <a:pos x="36" y="0"/>
                        </a:cxn>
                        <a:cxn ang="0">
                          <a:pos x="36" y="6"/>
                        </a:cxn>
                        <a:cxn ang="0">
                          <a:pos x="0" y="6"/>
                        </a:cxn>
                        <a:cxn ang="0">
                          <a:pos x="0" y="0"/>
                        </a:cxn>
                      </a:cxnLst>
                      <a:rect l="0" t="0" r="r" b="b"/>
                      <a:pathLst>
                        <a:path w="36" h="18">
                          <a:moveTo>
                            <a:pt x="15" y="15"/>
                          </a:moveTo>
                          <a:lnTo>
                            <a:pt x="15" y="9"/>
                          </a:lnTo>
                          <a:lnTo>
                            <a:pt x="15" y="3"/>
                          </a:lnTo>
                          <a:lnTo>
                            <a:pt x="21" y="3"/>
                          </a:lnTo>
                          <a:lnTo>
                            <a:pt x="21" y="9"/>
                          </a:lnTo>
                          <a:lnTo>
                            <a:pt x="21" y="15"/>
                          </a:lnTo>
                          <a:lnTo>
                            <a:pt x="15" y="15"/>
                          </a:lnTo>
                          <a:close/>
                          <a:moveTo>
                            <a:pt x="0" y="12"/>
                          </a:moveTo>
                          <a:lnTo>
                            <a:pt x="36" y="12"/>
                          </a:lnTo>
                          <a:lnTo>
                            <a:pt x="36" y="18"/>
                          </a:lnTo>
                          <a:lnTo>
                            <a:pt x="0" y="18"/>
                          </a:lnTo>
                          <a:lnTo>
                            <a:pt x="0" y="12"/>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483" name="Freeform 29"/>
                    <p:cNvSpPr>
                      <a:spLocks noEditPoints="1"/>
                    </p:cNvSpPr>
                    <p:nvPr/>
                  </p:nvSpPr>
                  <p:spPr bwMode="auto">
                    <a:xfrm>
                      <a:off x="4319789" y="743388"/>
                      <a:ext cx="42434" cy="300929"/>
                    </a:xfrm>
                    <a:custGeom>
                      <a:avLst/>
                      <a:gdLst/>
                      <a:ahLst/>
                      <a:cxnLst>
                        <a:cxn ang="0">
                          <a:pos x="18" y="372"/>
                        </a:cxn>
                        <a:cxn ang="0">
                          <a:pos x="18" y="186"/>
                        </a:cxn>
                        <a:cxn ang="0">
                          <a:pos x="18" y="0"/>
                        </a:cxn>
                        <a:cxn ang="0">
                          <a:pos x="18" y="372"/>
                        </a:cxn>
                        <a:cxn ang="0">
                          <a:pos x="0" y="372"/>
                        </a:cxn>
                        <a:cxn ang="0">
                          <a:pos x="36" y="372"/>
                        </a:cxn>
                        <a:cxn ang="0">
                          <a:pos x="0" y="372"/>
                        </a:cxn>
                        <a:cxn ang="0">
                          <a:pos x="0" y="0"/>
                        </a:cxn>
                        <a:cxn ang="0">
                          <a:pos x="36" y="0"/>
                        </a:cxn>
                        <a:cxn ang="0">
                          <a:pos x="0" y="0"/>
                        </a:cxn>
                      </a:cxnLst>
                      <a:rect l="0" t="0" r="r" b="b"/>
                      <a:pathLst>
                        <a:path w="36" h="372">
                          <a:moveTo>
                            <a:pt x="18" y="372"/>
                          </a:moveTo>
                          <a:lnTo>
                            <a:pt x="18" y="186"/>
                          </a:lnTo>
                          <a:lnTo>
                            <a:pt x="18" y="0"/>
                          </a:lnTo>
                          <a:lnTo>
                            <a:pt x="18" y="372"/>
                          </a:lnTo>
                          <a:close/>
                          <a:moveTo>
                            <a:pt x="0" y="372"/>
                          </a:moveTo>
                          <a:lnTo>
                            <a:pt x="36" y="372"/>
                          </a:lnTo>
                          <a:lnTo>
                            <a:pt x="0" y="372"/>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484" name="Freeform 30"/>
                    <p:cNvSpPr>
                      <a:spLocks noEditPoints="1"/>
                    </p:cNvSpPr>
                    <p:nvPr/>
                  </p:nvSpPr>
                  <p:spPr bwMode="auto">
                    <a:xfrm>
                      <a:off x="4300739" y="734612"/>
                      <a:ext cx="42434" cy="305783"/>
                    </a:xfrm>
                    <a:custGeom>
                      <a:avLst/>
                      <a:gdLst/>
                      <a:ahLst/>
                      <a:cxnLst>
                        <a:cxn ang="0">
                          <a:pos x="15" y="375"/>
                        </a:cxn>
                        <a:cxn ang="0">
                          <a:pos x="15" y="189"/>
                        </a:cxn>
                        <a:cxn ang="0">
                          <a:pos x="15" y="3"/>
                        </a:cxn>
                        <a:cxn ang="0">
                          <a:pos x="21" y="3"/>
                        </a:cxn>
                        <a:cxn ang="0">
                          <a:pos x="21" y="189"/>
                        </a:cxn>
                        <a:cxn ang="0">
                          <a:pos x="21" y="375"/>
                        </a:cxn>
                        <a:cxn ang="0">
                          <a:pos x="15" y="375"/>
                        </a:cxn>
                        <a:cxn ang="0">
                          <a:pos x="0" y="372"/>
                        </a:cxn>
                        <a:cxn ang="0">
                          <a:pos x="36" y="372"/>
                        </a:cxn>
                        <a:cxn ang="0">
                          <a:pos x="36" y="378"/>
                        </a:cxn>
                        <a:cxn ang="0">
                          <a:pos x="0" y="378"/>
                        </a:cxn>
                        <a:cxn ang="0">
                          <a:pos x="0" y="372"/>
                        </a:cxn>
                        <a:cxn ang="0">
                          <a:pos x="0" y="0"/>
                        </a:cxn>
                        <a:cxn ang="0">
                          <a:pos x="36" y="0"/>
                        </a:cxn>
                        <a:cxn ang="0">
                          <a:pos x="36" y="6"/>
                        </a:cxn>
                        <a:cxn ang="0">
                          <a:pos x="0" y="6"/>
                        </a:cxn>
                        <a:cxn ang="0">
                          <a:pos x="0" y="0"/>
                        </a:cxn>
                      </a:cxnLst>
                      <a:rect l="0" t="0" r="r" b="b"/>
                      <a:pathLst>
                        <a:path w="36" h="378">
                          <a:moveTo>
                            <a:pt x="15" y="375"/>
                          </a:moveTo>
                          <a:lnTo>
                            <a:pt x="15" y="189"/>
                          </a:lnTo>
                          <a:lnTo>
                            <a:pt x="15" y="3"/>
                          </a:lnTo>
                          <a:lnTo>
                            <a:pt x="21" y="3"/>
                          </a:lnTo>
                          <a:lnTo>
                            <a:pt x="21" y="189"/>
                          </a:lnTo>
                          <a:lnTo>
                            <a:pt x="21" y="375"/>
                          </a:lnTo>
                          <a:lnTo>
                            <a:pt x="15" y="375"/>
                          </a:lnTo>
                          <a:close/>
                          <a:moveTo>
                            <a:pt x="0" y="372"/>
                          </a:moveTo>
                          <a:lnTo>
                            <a:pt x="36" y="372"/>
                          </a:lnTo>
                          <a:lnTo>
                            <a:pt x="36" y="378"/>
                          </a:lnTo>
                          <a:lnTo>
                            <a:pt x="0" y="378"/>
                          </a:lnTo>
                          <a:lnTo>
                            <a:pt x="0" y="372"/>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485" name="Freeform 31"/>
                    <p:cNvSpPr>
                      <a:spLocks noEditPoints="1"/>
                    </p:cNvSpPr>
                    <p:nvPr/>
                  </p:nvSpPr>
                  <p:spPr bwMode="auto">
                    <a:xfrm>
                      <a:off x="4511192" y="1687002"/>
                      <a:ext cx="42434" cy="4854"/>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486" name="Freeform 32"/>
                    <p:cNvSpPr>
                      <a:spLocks noEditPoints="1"/>
                    </p:cNvSpPr>
                    <p:nvPr/>
                  </p:nvSpPr>
                  <p:spPr bwMode="auto">
                    <a:xfrm>
                      <a:off x="4492142" y="1678225"/>
                      <a:ext cx="42434" cy="9707"/>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487" name="Freeform 33"/>
                    <p:cNvSpPr>
                      <a:spLocks noEditPoints="1"/>
                    </p:cNvSpPr>
                    <p:nvPr/>
                  </p:nvSpPr>
                  <p:spPr bwMode="auto">
                    <a:xfrm>
                      <a:off x="4717288" y="1175367"/>
                      <a:ext cx="42434" cy="247538"/>
                    </a:xfrm>
                    <a:custGeom>
                      <a:avLst/>
                      <a:gdLst/>
                      <a:ahLst/>
                      <a:cxnLst>
                        <a:cxn ang="0">
                          <a:pos x="18" y="306"/>
                        </a:cxn>
                        <a:cxn ang="0">
                          <a:pos x="18" y="153"/>
                        </a:cxn>
                        <a:cxn ang="0">
                          <a:pos x="18" y="0"/>
                        </a:cxn>
                        <a:cxn ang="0">
                          <a:pos x="18" y="306"/>
                        </a:cxn>
                        <a:cxn ang="0">
                          <a:pos x="0" y="306"/>
                        </a:cxn>
                        <a:cxn ang="0">
                          <a:pos x="36" y="306"/>
                        </a:cxn>
                        <a:cxn ang="0">
                          <a:pos x="0" y="306"/>
                        </a:cxn>
                        <a:cxn ang="0">
                          <a:pos x="0" y="0"/>
                        </a:cxn>
                        <a:cxn ang="0">
                          <a:pos x="36" y="0"/>
                        </a:cxn>
                        <a:cxn ang="0">
                          <a:pos x="0" y="0"/>
                        </a:cxn>
                      </a:cxnLst>
                      <a:rect l="0" t="0" r="r" b="b"/>
                      <a:pathLst>
                        <a:path w="36" h="306">
                          <a:moveTo>
                            <a:pt x="18" y="306"/>
                          </a:moveTo>
                          <a:lnTo>
                            <a:pt x="18" y="153"/>
                          </a:lnTo>
                          <a:lnTo>
                            <a:pt x="18" y="0"/>
                          </a:lnTo>
                          <a:lnTo>
                            <a:pt x="18" y="306"/>
                          </a:lnTo>
                          <a:close/>
                          <a:moveTo>
                            <a:pt x="0" y="306"/>
                          </a:moveTo>
                          <a:lnTo>
                            <a:pt x="36" y="306"/>
                          </a:lnTo>
                          <a:lnTo>
                            <a:pt x="0" y="30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488" name="Freeform 34"/>
                    <p:cNvSpPr>
                      <a:spLocks noEditPoints="1"/>
                    </p:cNvSpPr>
                    <p:nvPr/>
                  </p:nvSpPr>
                  <p:spPr bwMode="auto">
                    <a:xfrm>
                      <a:off x="4698238" y="1166590"/>
                      <a:ext cx="42434" cy="252392"/>
                    </a:xfrm>
                    <a:custGeom>
                      <a:avLst/>
                      <a:gdLst/>
                      <a:ahLst/>
                      <a:cxnLst>
                        <a:cxn ang="0">
                          <a:pos x="15" y="309"/>
                        </a:cxn>
                        <a:cxn ang="0">
                          <a:pos x="15" y="156"/>
                        </a:cxn>
                        <a:cxn ang="0">
                          <a:pos x="15" y="3"/>
                        </a:cxn>
                        <a:cxn ang="0">
                          <a:pos x="21" y="3"/>
                        </a:cxn>
                        <a:cxn ang="0">
                          <a:pos x="21" y="156"/>
                        </a:cxn>
                        <a:cxn ang="0">
                          <a:pos x="21" y="309"/>
                        </a:cxn>
                        <a:cxn ang="0">
                          <a:pos x="15" y="309"/>
                        </a:cxn>
                        <a:cxn ang="0">
                          <a:pos x="0" y="306"/>
                        </a:cxn>
                        <a:cxn ang="0">
                          <a:pos x="36" y="306"/>
                        </a:cxn>
                        <a:cxn ang="0">
                          <a:pos x="36" y="312"/>
                        </a:cxn>
                        <a:cxn ang="0">
                          <a:pos x="0" y="312"/>
                        </a:cxn>
                        <a:cxn ang="0">
                          <a:pos x="0" y="306"/>
                        </a:cxn>
                        <a:cxn ang="0">
                          <a:pos x="0" y="0"/>
                        </a:cxn>
                        <a:cxn ang="0">
                          <a:pos x="36" y="0"/>
                        </a:cxn>
                        <a:cxn ang="0">
                          <a:pos x="36" y="6"/>
                        </a:cxn>
                        <a:cxn ang="0">
                          <a:pos x="0" y="6"/>
                        </a:cxn>
                        <a:cxn ang="0">
                          <a:pos x="0" y="0"/>
                        </a:cxn>
                      </a:cxnLst>
                      <a:rect l="0" t="0" r="r" b="b"/>
                      <a:pathLst>
                        <a:path w="36" h="312">
                          <a:moveTo>
                            <a:pt x="15" y="309"/>
                          </a:moveTo>
                          <a:lnTo>
                            <a:pt x="15" y="156"/>
                          </a:lnTo>
                          <a:lnTo>
                            <a:pt x="15" y="3"/>
                          </a:lnTo>
                          <a:lnTo>
                            <a:pt x="21" y="3"/>
                          </a:lnTo>
                          <a:lnTo>
                            <a:pt x="21" y="156"/>
                          </a:lnTo>
                          <a:lnTo>
                            <a:pt x="21" y="309"/>
                          </a:lnTo>
                          <a:lnTo>
                            <a:pt x="15" y="309"/>
                          </a:lnTo>
                          <a:close/>
                          <a:moveTo>
                            <a:pt x="0" y="306"/>
                          </a:moveTo>
                          <a:lnTo>
                            <a:pt x="36" y="306"/>
                          </a:lnTo>
                          <a:lnTo>
                            <a:pt x="36" y="312"/>
                          </a:lnTo>
                          <a:lnTo>
                            <a:pt x="0" y="312"/>
                          </a:lnTo>
                          <a:lnTo>
                            <a:pt x="0" y="30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489" name="Freeform 35"/>
                    <p:cNvSpPr>
                      <a:spLocks noEditPoints="1"/>
                    </p:cNvSpPr>
                    <p:nvPr/>
                  </p:nvSpPr>
                  <p:spPr bwMode="auto">
                    <a:xfrm>
                      <a:off x="4901072" y="1651029"/>
                      <a:ext cx="42434" cy="29122"/>
                    </a:xfrm>
                    <a:custGeom>
                      <a:avLst/>
                      <a:gdLst/>
                      <a:ahLst/>
                      <a:cxnLst>
                        <a:cxn ang="0">
                          <a:pos x="18" y="36"/>
                        </a:cxn>
                        <a:cxn ang="0">
                          <a:pos x="18" y="18"/>
                        </a:cxn>
                        <a:cxn ang="0">
                          <a:pos x="18" y="0"/>
                        </a:cxn>
                        <a:cxn ang="0">
                          <a:pos x="18" y="36"/>
                        </a:cxn>
                        <a:cxn ang="0">
                          <a:pos x="0" y="36"/>
                        </a:cxn>
                        <a:cxn ang="0">
                          <a:pos x="36" y="36"/>
                        </a:cxn>
                        <a:cxn ang="0">
                          <a:pos x="0" y="36"/>
                        </a:cxn>
                        <a:cxn ang="0">
                          <a:pos x="0" y="0"/>
                        </a:cxn>
                        <a:cxn ang="0">
                          <a:pos x="36" y="0"/>
                        </a:cxn>
                        <a:cxn ang="0">
                          <a:pos x="0" y="0"/>
                        </a:cxn>
                      </a:cxnLst>
                      <a:rect l="0" t="0" r="r" b="b"/>
                      <a:pathLst>
                        <a:path w="36" h="36">
                          <a:moveTo>
                            <a:pt x="18" y="36"/>
                          </a:moveTo>
                          <a:lnTo>
                            <a:pt x="18" y="18"/>
                          </a:lnTo>
                          <a:lnTo>
                            <a:pt x="18" y="0"/>
                          </a:lnTo>
                          <a:lnTo>
                            <a:pt x="18" y="36"/>
                          </a:lnTo>
                          <a:close/>
                          <a:moveTo>
                            <a:pt x="0" y="36"/>
                          </a:moveTo>
                          <a:lnTo>
                            <a:pt x="36" y="36"/>
                          </a:lnTo>
                          <a:lnTo>
                            <a:pt x="0" y="3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490" name="Freeform 36"/>
                    <p:cNvSpPr>
                      <a:spLocks noEditPoints="1"/>
                    </p:cNvSpPr>
                    <p:nvPr/>
                  </p:nvSpPr>
                  <p:spPr bwMode="auto">
                    <a:xfrm>
                      <a:off x="4882022" y="1642253"/>
                      <a:ext cx="42434" cy="33976"/>
                    </a:xfrm>
                    <a:custGeom>
                      <a:avLst/>
                      <a:gdLst/>
                      <a:ahLst/>
                      <a:cxnLst>
                        <a:cxn ang="0">
                          <a:pos x="15" y="39"/>
                        </a:cxn>
                        <a:cxn ang="0">
                          <a:pos x="15" y="21"/>
                        </a:cxn>
                        <a:cxn ang="0">
                          <a:pos x="15" y="3"/>
                        </a:cxn>
                        <a:cxn ang="0">
                          <a:pos x="21" y="3"/>
                        </a:cxn>
                        <a:cxn ang="0">
                          <a:pos x="21" y="21"/>
                        </a:cxn>
                        <a:cxn ang="0">
                          <a:pos x="21" y="39"/>
                        </a:cxn>
                        <a:cxn ang="0">
                          <a:pos x="15" y="39"/>
                        </a:cxn>
                        <a:cxn ang="0">
                          <a:pos x="0" y="36"/>
                        </a:cxn>
                        <a:cxn ang="0">
                          <a:pos x="36" y="36"/>
                        </a:cxn>
                        <a:cxn ang="0">
                          <a:pos x="36" y="42"/>
                        </a:cxn>
                        <a:cxn ang="0">
                          <a:pos x="0" y="42"/>
                        </a:cxn>
                        <a:cxn ang="0">
                          <a:pos x="0" y="36"/>
                        </a:cxn>
                        <a:cxn ang="0">
                          <a:pos x="0" y="0"/>
                        </a:cxn>
                        <a:cxn ang="0">
                          <a:pos x="36" y="0"/>
                        </a:cxn>
                        <a:cxn ang="0">
                          <a:pos x="36" y="6"/>
                        </a:cxn>
                        <a:cxn ang="0">
                          <a:pos x="0" y="6"/>
                        </a:cxn>
                        <a:cxn ang="0">
                          <a:pos x="0" y="0"/>
                        </a:cxn>
                      </a:cxnLst>
                      <a:rect l="0" t="0" r="r" b="b"/>
                      <a:pathLst>
                        <a:path w="36" h="42">
                          <a:moveTo>
                            <a:pt x="15" y="39"/>
                          </a:moveTo>
                          <a:lnTo>
                            <a:pt x="15" y="21"/>
                          </a:lnTo>
                          <a:lnTo>
                            <a:pt x="15" y="3"/>
                          </a:lnTo>
                          <a:lnTo>
                            <a:pt x="21" y="3"/>
                          </a:lnTo>
                          <a:lnTo>
                            <a:pt x="21" y="21"/>
                          </a:lnTo>
                          <a:lnTo>
                            <a:pt x="21" y="39"/>
                          </a:lnTo>
                          <a:lnTo>
                            <a:pt x="15" y="39"/>
                          </a:lnTo>
                          <a:close/>
                          <a:moveTo>
                            <a:pt x="0" y="36"/>
                          </a:moveTo>
                          <a:lnTo>
                            <a:pt x="36" y="36"/>
                          </a:lnTo>
                          <a:lnTo>
                            <a:pt x="36" y="42"/>
                          </a:lnTo>
                          <a:lnTo>
                            <a:pt x="0" y="42"/>
                          </a:lnTo>
                          <a:lnTo>
                            <a:pt x="0" y="3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491" name="Rectangle 61"/>
                    <p:cNvSpPr>
                      <a:spLocks noChangeArrowheads="1"/>
                    </p:cNvSpPr>
                    <p:nvPr/>
                  </p:nvSpPr>
                  <p:spPr bwMode="auto">
                    <a:xfrm>
                      <a:off x="3523926" y="1536853"/>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chemeClr val="tx1"/>
                          </a:solidFill>
                          <a:effectLst/>
                          <a:latin typeface="Calibri "/>
                          <a:cs typeface="Arial" pitchFamily="34" charset="0"/>
                        </a:rPr>
                        <a:t>e</a:t>
                      </a:r>
                    </a:p>
                  </p:txBody>
                </p:sp>
                <p:sp>
                  <p:nvSpPr>
                    <p:cNvPr id="492" name="Rectangle 62"/>
                    <p:cNvSpPr>
                      <a:spLocks noChangeArrowheads="1"/>
                    </p:cNvSpPr>
                    <p:nvPr/>
                  </p:nvSpPr>
                  <p:spPr bwMode="auto">
                    <a:xfrm>
                      <a:off x="3705659" y="1533999"/>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chemeClr val="tx1"/>
                          </a:solidFill>
                          <a:effectLst/>
                          <a:latin typeface="Calibri "/>
                          <a:cs typeface="Arial" pitchFamily="34" charset="0"/>
                        </a:rPr>
                        <a:t>e</a:t>
                      </a:r>
                    </a:p>
                  </p:txBody>
                </p:sp>
                <p:sp>
                  <p:nvSpPr>
                    <p:cNvPr id="493" name="Rectangle 63"/>
                    <p:cNvSpPr>
                      <a:spLocks noChangeArrowheads="1"/>
                    </p:cNvSpPr>
                    <p:nvPr/>
                  </p:nvSpPr>
                  <p:spPr bwMode="auto">
                    <a:xfrm>
                      <a:off x="3859146" y="1540665"/>
                      <a:ext cx="14106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de</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494" name="Rectangle 64"/>
                    <p:cNvSpPr>
                      <a:spLocks noChangeArrowheads="1"/>
                    </p:cNvSpPr>
                    <p:nvPr/>
                  </p:nvSpPr>
                  <p:spPr bwMode="auto">
                    <a:xfrm>
                      <a:off x="4082363" y="1503616"/>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d</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495" name="Rectangle 65"/>
                    <p:cNvSpPr>
                      <a:spLocks noChangeArrowheads="1"/>
                    </p:cNvSpPr>
                    <p:nvPr/>
                  </p:nvSpPr>
                  <p:spPr bwMode="auto">
                    <a:xfrm>
                      <a:off x="4288744" y="585309"/>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a</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496" name="Rectangle 66"/>
                    <p:cNvSpPr>
                      <a:spLocks noChangeArrowheads="1"/>
                    </p:cNvSpPr>
                    <p:nvPr/>
                  </p:nvSpPr>
                  <p:spPr bwMode="auto">
                    <a:xfrm>
                      <a:off x="4447355" y="1510280"/>
                      <a:ext cx="14106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de</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497" name="Rectangle 67"/>
                    <p:cNvSpPr>
                      <a:spLocks noChangeArrowheads="1"/>
                    </p:cNvSpPr>
                    <p:nvPr/>
                  </p:nvSpPr>
                  <p:spPr bwMode="auto">
                    <a:xfrm>
                      <a:off x="4685975" y="1003620"/>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b</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498" name="Rectangle 68"/>
                    <p:cNvSpPr>
                      <a:spLocks noChangeArrowheads="1"/>
                    </p:cNvSpPr>
                    <p:nvPr/>
                  </p:nvSpPr>
                  <p:spPr bwMode="auto">
                    <a:xfrm>
                      <a:off x="4874408" y="1481682"/>
                      <a:ext cx="64120"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c</a:t>
                      </a:r>
                      <a:endParaRPr kumimoji="0" lang="en-US" sz="1000" b="0" i="0" u="none" strike="noStrike" cap="none" normalizeH="0" baseline="0">
                        <a:ln>
                          <a:noFill/>
                        </a:ln>
                        <a:solidFill>
                          <a:schemeClr val="tx1"/>
                        </a:solidFill>
                        <a:effectLst/>
                        <a:latin typeface="Calibri "/>
                        <a:cs typeface="Arial" pitchFamily="34" charset="0"/>
                      </a:endParaRPr>
                    </a:p>
                  </p:txBody>
                </p:sp>
              </p:grpSp>
            </p:grpSp>
            <p:grpSp>
              <p:nvGrpSpPr>
                <p:cNvPr id="499" name="Group 573"/>
                <p:cNvGrpSpPr/>
                <p:nvPr/>
              </p:nvGrpSpPr>
              <p:grpSpPr>
                <a:xfrm>
                  <a:off x="3229608" y="1752600"/>
                  <a:ext cx="1799591" cy="1178805"/>
                  <a:chOff x="2206694" y="1726419"/>
                  <a:chExt cx="1799590" cy="1178805"/>
                </a:xfrm>
              </p:grpSpPr>
              <p:sp>
                <p:nvSpPr>
                  <p:cNvPr id="652" name="Rectangle 46"/>
                  <p:cNvSpPr>
                    <a:spLocks noChangeArrowheads="1"/>
                  </p:cNvSpPr>
                  <p:nvPr/>
                </p:nvSpPr>
                <p:spPr bwMode="auto">
                  <a:xfrm>
                    <a:off x="2629047" y="2782113"/>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653" name="Rectangle 46"/>
                  <p:cNvSpPr>
                    <a:spLocks noChangeArrowheads="1"/>
                  </p:cNvSpPr>
                  <p:nvPr/>
                </p:nvSpPr>
                <p:spPr bwMode="auto">
                  <a:xfrm>
                    <a:off x="3014768" y="2782113"/>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654" name="Rectangle 46"/>
                  <p:cNvSpPr>
                    <a:spLocks noChangeArrowheads="1"/>
                  </p:cNvSpPr>
                  <p:nvPr/>
                </p:nvSpPr>
                <p:spPr bwMode="auto">
                  <a:xfrm>
                    <a:off x="3407259" y="2782113"/>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655" name="Rectangle 46"/>
                  <p:cNvSpPr>
                    <a:spLocks noChangeArrowheads="1"/>
                  </p:cNvSpPr>
                  <p:nvPr/>
                </p:nvSpPr>
                <p:spPr bwMode="auto">
                  <a:xfrm>
                    <a:off x="3799748" y="2782113"/>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656" name="Freeform 40"/>
                  <p:cNvSpPr>
                    <a:spLocks noEditPoints="1"/>
                  </p:cNvSpPr>
                  <p:nvPr/>
                </p:nvSpPr>
                <p:spPr bwMode="auto">
                  <a:xfrm>
                    <a:off x="2353492" y="1889841"/>
                    <a:ext cx="25488" cy="872459"/>
                  </a:xfrm>
                  <a:custGeom>
                    <a:avLst/>
                    <a:gdLst/>
                    <a:ahLst/>
                    <a:cxnLst>
                      <a:cxn ang="0">
                        <a:pos x="0" y="1044"/>
                      </a:cxn>
                      <a:cxn ang="0">
                        <a:pos x="30" y="1044"/>
                      </a:cxn>
                      <a:cxn ang="0">
                        <a:pos x="30" y="1050"/>
                      </a:cxn>
                      <a:cxn ang="0">
                        <a:pos x="0" y="1050"/>
                      </a:cxn>
                      <a:cxn ang="0">
                        <a:pos x="0" y="1044"/>
                      </a:cxn>
                      <a:cxn ang="0">
                        <a:pos x="0" y="522"/>
                      </a:cxn>
                      <a:cxn ang="0">
                        <a:pos x="30" y="522"/>
                      </a:cxn>
                      <a:cxn ang="0">
                        <a:pos x="30" y="528"/>
                      </a:cxn>
                      <a:cxn ang="0">
                        <a:pos x="0" y="528"/>
                      </a:cxn>
                      <a:cxn ang="0">
                        <a:pos x="0" y="522"/>
                      </a:cxn>
                      <a:cxn ang="0">
                        <a:pos x="0" y="0"/>
                      </a:cxn>
                      <a:cxn ang="0">
                        <a:pos x="30" y="0"/>
                      </a:cxn>
                      <a:cxn ang="0">
                        <a:pos x="30" y="6"/>
                      </a:cxn>
                      <a:cxn ang="0">
                        <a:pos x="0" y="6"/>
                      </a:cxn>
                      <a:cxn ang="0">
                        <a:pos x="0" y="0"/>
                      </a:cxn>
                    </a:cxnLst>
                    <a:rect l="0" t="0" r="r" b="b"/>
                    <a:pathLst>
                      <a:path w="30" h="1050">
                        <a:moveTo>
                          <a:pt x="0" y="1044"/>
                        </a:moveTo>
                        <a:lnTo>
                          <a:pt x="30" y="1044"/>
                        </a:lnTo>
                        <a:lnTo>
                          <a:pt x="30" y="1050"/>
                        </a:lnTo>
                        <a:lnTo>
                          <a:pt x="0" y="1050"/>
                        </a:lnTo>
                        <a:lnTo>
                          <a:pt x="0" y="1044"/>
                        </a:lnTo>
                        <a:close/>
                        <a:moveTo>
                          <a:pt x="0" y="522"/>
                        </a:moveTo>
                        <a:lnTo>
                          <a:pt x="30" y="522"/>
                        </a:lnTo>
                        <a:lnTo>
                          <a:pt x="30" y="528"/>
                        </a:lnTo>
                        <a:lnTo>
                          <a:pt x="0" y="528"/>
                        </a:lnTo>
                        <a:lnTo>
                          <a:pt x="0" y="522"/>
                        </a:lnTo>
                        <a:close/>
                        <a:moveTo>
                          <a:pt x="0" y="0"/>
                        </a:moveTo>
                        <a:lnTo>
                          <a:pt x="30" y="0"/>
                        </a:lnTo>
                        <a:lnTo>
                          <a:pt x="30" y="6"/>
                        </a:lnTo>
                        <a:lnTo>
                          <a:pt x="0" y="6"/>
                        </a:lnTo>
                        <a:lnTo>
                          <a:pt x="0" y="0"/>
                        </a:lnTo>
                        <a:close/>
                      </a:path>
                    </a:pathLst>
                  </a:custGeom>
                  <a:solidFill>
                    <a:schemeClr val="tx1"/>
                  </a:solidFill>
                  <a:ln w="635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sz="800">
                      <a:latin typeface="Calibri "/>
                    </a:endParaRPr>
                  </a:p>
                </p:txBody>
              </p:sp>
              <p:sp>
                <p:nvSpPr>
                  <p:cNvPr id="657" name="Rectangle 43"/>
                  <p:cNvSpPr>
                    <a:spLocks noChangeArrowheads="1"/>
                  </p:cNvSpPr>
                  <p:nvPr/>
                </p:nvSpPr>
                <p:spPr bwMode="auto">
                  <a:xfrm>
                    <a:off x="2279161" y="2696098"/>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0</a:t>
                    </a:r>
                    <a:endParaRPr lang="en-US" sz="800">
                      <a:latin typeface="Calibri "/>
                      <a:cs typeface="Arial" pitchFamily="34" charset="0"/>
                    </a:endParaRPr>
                  </a:p>
                </p:txBody>
              </p:sp>
              <p:sp>
                <p:nvSpPr>
                  <p:cNvPr id="658" name="Rectangle 44"/>
                  <p:cNvSpPr>
                    <a:spLocks noChangeArrowheads="1"/>
                  </p:cNvSpPr>
                  <p:nvPr/>
                </p:nvSpPr>
                <p:spPr bwMode="auto">
                  <a:xfrm>
                    <a:off x="2215585" y="2264901"/>
                    <a:ext cx="115416"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40</a:t>
                    </a:r>
                    <a:endParaRPr lang="en-US" sz="800">
                      <a:latin typeface="Calibri "/>
                      <a:cs typeface="Arial" pitchFamily="34" charset="0"/>
                    </a:endParaRPr>
                  </a:p>
                </p:txBody>
              </p:sp>
              <p:sp>
                <p:nvSpPr>
                  <p:cNvPr id="659" name="Rectangle 45"/>
                  <p:cNvSpPr>
                    <a:spLocks noChangeArrowheads="1"/>
                  </p:cNvSpPr>
                  <p:nvPr/>
                </p:nvSpPr>
                <p:spPr bwMode="auto">
                  <a:xfrm>
                    <a:off x="2206694" y="1829374"/>
                    <a:ext cx="115416"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80</a:t>
                    </a:r>
                    <a:endParaRPr lang="en-US" sz="800">
                      <a:latin typeface="Calibri "/>
                      <a:cs typeface="Arial" pitchFamily="34" charset="0"/>
                    </a:endParaRPr>
                  </a:p>
                </p:txBody>
              </p:sp>
              <p:sp>
                <p:nvSpPr>
                  <p:cNvPr id="660" name="Rectangle 62"/>
                  <p:cNvSpPr>
                    <a:spLocks noChangeArrowheads="1"/>
                  </p:cNvSpPr>
                  <p:nvPr/>
                </p:nvSpPr>
                <p:spPr bwMode="auto">
                  <a:xfrm>
                    <a:off x="2508663" y="1843541"/>
                    <a:ext cx="32541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b="1" i="1">
                        <a:solidFill>
                          <a:srgbClr val="000000"/>
                        </a:solidFill>
                        <a:latin typeface="Calibri "/>
                        <a:cs typeface="Arial" pitchFamily="34" charset="0"/>
                      </a:rPr>
                      <a:t>LBD41</a:t>
                    </a:r>
                    <a:endParaRPr lang="en-US" sz="800" b="1" i="1">
                      <a:latin typeface="Calibri "/>
                      <a:cs typeface="Arial" pitchFamily="34" charset="0"/>
                    </a:endParaRPr>
                  </a:p>
                </p:txBody>
              </p:sp>
              <p:cxnSp>
                <p:nvCxnSpPr>
                  <p:cNvPr id="661" name="Straight Connector 660"/>
                  <p:cNvCxnSpPr/>
                  <p:nvPr/>
                </p:nvCxnSpPr>
                <p:spPr>
                  <a:xfrm>
                    <a:off x="2382191" y="2759208"/>
                    <a:ext cx="162409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2" name="Straight Connector 661"/>
                  <p:cNvCxnSpPr/>
                  <p:nvPr/>
                </p:nvCxnSpPr>
                <p:spPr>
                  <a:xfrm>
                    <a:off x="2383178" y="1844081"/>
                    <a:ext cx="0" cy="91621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63" name="Rectangle 8"/>
                  <p:cNvSpPr>
                    <a:spLocks noChangeArrowheads="1"/>
                  </p:cNvSpPr>
                  <p:nvPr/>
                </p:nvSpPr>
                <p:spPr bwMode="auto">
                  <a:xfrm>
                    <a:off x="2466970" y="2734657"/>
                    <a:ext cx="126000" cy="15015"/>
                  </a:xfrm>
                  <a:prstGeom prst="rect">
                    <a:avLst/>
                  </a:prstGeom>
                  <a:solidFill>
                    <a:srgbClr val="FDEAD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64" name="Rectangle 10"/>
                  <p:cNvSpPr>
                    <a:spLocks noChangeArrowheads="1"/>
                  </p:cNvSpPr>
                  <p:nvPr/>
                </p:nvSpPr>
                <p:spPr bwMode="auto">
                  <a:xfrm>
                    <a:off x="2646961" y="2724647"/>
                    <a:ext cx="126000" cy="25025"/>
                  </a:xfrm>
                  <a:prstGeom prst="rect">
                    <a:avLst/>
                  </a:prstGeom>
                  <a:solidFill>
                    <a:srgbClr val="EBF1DE"/>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65" name="Rectangle 12"/>
                  <p:cNvSpPr>
                    <a:spLocks noChangeArrowheads="1"/>
                  </p:cNvSpPr>
                  <p:nvPr/>
                </p:nvSpPr>
                <p:spPr bwMode="auto">
                  <a:xfrm>
                    <a:off x="2830991" y="2674596"/>
                    <a:ext cx="126000" cy="75076"/>
                  </a:xfrm>
                  <a:prstGeom prst="rect">
                    <a:avLst/>
                  </a:prstGeom>
                  <a:solidFill>
                    <a:srgbClr val="FCD5B5"/>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66" name="Rectangle 14"/>
                  <p:cNvSpPr>
                    <a:spLocks noChangeArrowheads="1"/>
                  </p:cNvSpPr>
                  <p:nvPr/>
                </p:nvSpPr>
                <p:spPr bwMode="auto">
                  <a:xfrm>
                    <a:off x="3030035" y="2554473"/>
                    <a:ext cx="126000" cy="195199"/>
                  </a:xfrm>
                  <a:prstGeom prst="rect">
                    <a:avLst/>
                  </a:prstGeom>
                  <a:solidFill>
                    <a:srgbClr val="D7E4BD"/>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69" name="Rectangle 16"/>
                  <p:cNvSpPr>
                    <a:spLocks noChangeArrowheads="1"/>
                  </p:cNvSpPr>
                  <p:nvPr/>
                </p:nvSpPr>
                <p:spPr bwMode="auto">
                  <a:xfrm>
                    <a:off x="3233841" y="2073984"/>
                    <a:ext cx="126000" cy="675688"/>
                  </a:xfrm>
                  <a:prstGeom prst="rect">
                    <a:avLst/>
                  </a:prstGeom>
                  <a:solidFill>
                    <a:srgbClr val="FAC090"/>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70" name="Rectangle 18"/>
                  <p:cNvSpPr>
                    <a:spLocks noChangeArrowheads="1"/>
                  </p:cNvSpPr>
                  <p:nvPr/>
                </p:nvSpPr>
                <p:spPr bwMode="auto">
                  <a:xfrm>
                    <a:off x="3427397" y="2729652"/>
                    <a:ext cx="126000" cy="20020"/>
                  </a:xfrm>
                  <a:prstGeom prst="rect">
                    <a:avLst/>
                  </a:prstGeom>
                  <a:solidFill>
                    <a:srgbClr val="C3D69B"/>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71" name="Rectangle 20"/>
                  <p:cNvSpPr>
                    <a:spLocks noChangeArrowheads="1"/>
                  </p:cNvSpPr>
                  <p:nvPr/>
                </p:nvSpPr>
                <p:spPr bwMode="auto">
                  <a:xfrm>
                    <a:off x="3621677" y="2294208"/>
                    <a:ext cx="126000" cy="455464"/>
                  </a:xfrm>
                  <a:prstGeom prst="rect">
                    <a:avLst/>
                  </a:prstGeom>
                  <a:solidFill>
                    <a:srgbClr val="E46C0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72" name="Rectangle 22"/>
                  <p:cNvSpPr>
                    <a:spLocks noChangeArrowheads="1"/>
                  </p:cNvSpPr>
                  <p:nvPr/>
                </p:nvSpPr>
                <p:spPr bwMode="auto">
                  <a:xfrm>
                    <a:off x="3815233" y="2649570"/>
                    <a:ext cx="126000" cy="100102"/>
                  </a:xfrm>
                  <a:prstGeom prst="rect">
                    <a:avLst/>
                  </a:prstGeom>
                  <a:solidFill>
                    <a:srgbClr val="77933C"/>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73" name="Freeform 24"/>
                  <p:cNvSpPr>
                    <a:spLocks noEditPoints="1"/>
                  </p:cNvSpPr>
                  <p:nvPr/>
                </p:nvSpPr>
                <p:spPr bwMode="auto">
                  <a:xfrm>
                    <a:off x="2537385" y="2734657"/>
                    <a:ext cx="52811" cy="834"/>
                  </a:xfrm>
                  <a:custGeom>
                    <a:avLst/>
                    <a:gdLst/>
                    <a:ahLst/>
                    <a:cxnLst>
                      <a:cxn ang="0">
                        <a:pos x="18" y="0"/>
                      </a:cxn>
                      <a:cxn ang="0">
                        <a:pos x="18" y="0"/>
                      </a:cxn>
                      <a:cxn ang="0">
                        <a:pos x="18" y="0"/>
                      </a:cxn>
                      <a:cxn ang="0">
                        <a:pos x="0" y="0"/>
                      </a:cxn>
                      <a:cxn ang="0">
                        <a:pos x="36" y="0"/>
                      </a:cxn>
                      <a:cxn ang="0">
                        <a:pos x="0" y="0"/>
                      </a:cxn>
                      <a:cxn ang="0">
                        <a:pos x="36" y="0"/>
                      </a:cxn>
                    </a:cxnLst>
                    <a:rect l="0" t="0" r="r" b="b"/>
                    <a:pathLst>
                      <a:path w="36">
                        <a:moveTo>
                          <a:pt x="18" y="0"/>
                        </a:moveTo>
                        <a:lnTo>
                          <a:pt x="18" y="0"/>
                        </a:lnTo>
                        <a:lnTo>
                          <a:pt x="18" y="0"/>
                        </a:lnTo>
                        <a:moveTo>
                          <a:pt x="0" y="0"/>
                        </a:moveTo>
                        <a:lnTo>
                          <a:pt x="36" y="0"/>
                        </a:lnTo>
                        <a:moveTo>
                          <a:pt x="0" y="0"/>
                        </a:moveTo>
                        <a:lnTo>
                          <a:pt x="36" y="0"/>
                        </a:lnTo>
                      </a:path>
                    </a:pathLst>
                  </a:custGeom>
                  <a:noFill/>
                  <a:ln w="9525"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674" name="Freeform 25"/>
                  <p:cNvSpPr>
                    <a:spLocks noEditPoints="1"/>
                  </p:cNvSpPr>
                  <p:nvPr/>
                </p:nvSpPr>
                <p:spPr bwMode="auto">
                  <a:xfrm>
                    <a:off x="2726178" y="2719641"/>
                    <a:ext cx="52811" cy="15015"/>
                  </a:xfrm>
                  <a:custGeom>
                    <a:avLst/>
                    <a:gdLst/>
                    <a:ahLst/>
                    <a:cxnLst>
                      <a:cxn ang="0">
                        <a:pos x="18" y="18"/>
                      </a:cxn>
                      <a:cxn ang="0">
                        <a:pos x="18" y="9"/>
                      </a:cxn>
                      <a:cxn ang="0">
                        <a:pos x="18" y="0"/>
                      </a:cxn>
                      <a:cxn ang="0">
                        <a:pos x="18" y="18"/>
                      </a:cxn>
                      <a:cxn ang="0">
                        <a:pos x="0" y="18"/>
                      </a:cxn>
                      <a:cxn ang="0">
                        <a:pos x="36" y="18"/>
                      </a:cxn>
                      <a:cxn ang="0">
                        <a:pos x="0" y="18"/>
                      </a:cxn>
                      <a:cxn ang="0">
                        <a:pos x="0" y="0"/>
                      </a:cxn>
                      <a:cxn ang="0">
                        <a:pos x="36" y="0"/>
                      </a:cxn>
                      <a:cxn ang="0">
                        <a:pos x="0" y="0"/>
                      </a:cxn>
                    </a:cxnLst>
                    <a:rect l="0" t="0" r="r" b="b"/>
                    <a:pathLst>
                      <a:path w="36" h="18">
                        <a:moveTo>
                          <a:pt x="18" y="18"/>
                        </a:moveTo>
                        <a:lnTo>
                          <a:pt x="18" y="9"/>
                        </a:lnTo>
                        <a:lnTo>
                          <a:pt x="18" y="0"/>
                        </a:lnTo>
                        <a:lnTo>
                          <a:pt x="18" y="18"/>
                        </a:lnTo>
                        <a:close/>
                        <a:moveTo>
                          <a:pt x="0" y="18"/>
                        </a:moveTo>
                        <a:lnTo>
                          <a:pt x="36" y="18"/>
                        </a:lnTo>
                        <a:lnTo>
                          <a:pt x="0" y="18"/>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675" name="Freeform 26"/>
                  <p:cNvSpPr>
                    <a:spLocks noEditPoints="1"/>
                  </p:cNvSpPr>
                  <p:nvPr/>
                </p:nvSpPr>
                <p:spPr bwMode="auto">
                  <a:xfrm>
                    <a:off x="2681724" y="2710789"/>
                    <a:ext cx="52811" cy="20020"/>
                  </a:xfrm>
                  <a:custGeom>
                    <a:avLst/>
                    <a:gdLst/>
                    <a:ahLst/>
                    <a:cxnLst>
                      <a:cxn ang="0">
                        <a:pos x="15" y="21"/>
                      </a:cxn>
                      <a:cxn ang="0">
                        <a:pos x="15" y="12"/>
                      </a:cxn>
                      <a:cxn ang="0">
                        <a:pos x="15" y="3"/>
                      </a:cxn>
                      <a:cxn ang="0">
                        <a:pos x="21" y="3"/>
                      </a:cxn>
                      <a:cxn ang="0">
                        <a:pos x="21" y="12"/>
                      </a:cxn>
                      <a:cxn ang="0">
                        <a:pos x="21" y="21"/>
                      </a:cxn>
                      <a:cxn ang="0">
                        <a:pos x="15" y="21"/>
                      </a:cxn>
                      <a:cxn ang="0">
                        <a:pos x="0" y="18"/>
                      </a:cxn>
                      <a:cxn ang="0">
                        <a:pos x="36" y="18"/>
                      </a:cxn>
                      <a:cxn ang="0">
                        <a:pos x="36" y="24"/>
                      </a:cxn>
                      <a:cxn ang="0">
                        <a:pos x="0" y="24"/>
                      </a:cxn>
                      <a:cxn ang="0">
                        <a:pos x="0" y="18"/>
                      </a:cxn>
                      <a:cxn ang="0">
                        <a:pos x="0" y="0"/>
                      </a:cxn>
                      <a:cxn ang="0">
                        <a:pos x="36" y="0"/>
                      </a:cxn>
                      <a:cxn ang="0">
                        <a:pos x="36" y="6"/>
                      </a:cxn>
                      <a:cxn ang="0">
                        <a:pos x="0" y="6"/>
                      </a:cxn>
                      <a:cxn ang="0">
                        <a:pos x="0" y="0"/>
                      </a:cxn>
                    </a:cxnLst>
                    <a:rect l="0" t="0" r="r" b="b"/>
                    <a:pathLst>
                      <a:path w="36" h="24">
                        <a:moveTo>
                          <a:pt x="15" y="21"/>
                        </a:moveTo>
                        <a:lnTo>
                          <a:pt x="15" y="12"/>
                        </a:lnTo>
                        <a:lnTo>
                          <a:pt x="15" y="3"/>
                        </a:lnTo>
                        <a:lnTo>
                          <a:pt x="21" y="3"/>
                        </a:lnTo>
                        <a:lnTo>
                          <a:pt x="21" y="12"/>
                        </a:lnTo>
                        <a:lnTo>
                          <a:pt x="21" y="21"/>
                        </a:lnTo>
                        <a:lnTo>
                          <a:pt x="15" y="21"/>
                        </a:lnTo>
                        <a:close/>
                        <a:moveTo>
                          <a:pt x="0" y="18"/>
                        </a:moveTo>
                        <a:lnTo>
                          <a:pt x="36" y="18"/>
                        </a:lnTo>
                        <a:lnTo>
                          <a:pt x="36" y="24"/>
                        </a:lnTo>
                        <a:lnTo>
                          <a:pt x="0" y="24"/>
                        </a:lnTo>
                        <a:lnTo>
                          <a:pt x="0" y="18"/>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676" name="Freeform 27"/>
                  <p:cNvSpPr>
                    <a:spLocks noEditPoints="1"/>
                  </p:cNvSpPr>
                  <p:nvPr/>
                </p:nvSpPr>
                <p:spPr bwMode="auto">
                  <a:xfrm>
                    <a:off x="2901406" y="2669591"/>
                    <a:ext cx="52811" cy="15015"/>
                  </a:xfrm>
                  <a:custGeom>
                    <a:avLst/>
                    <a:gdLst/>
                    <a:ahLst/>
                    <a:cxnLst>
                      <a:cxn ang="0">
                        <a:pos x="18" y="18"/>
                      </a:cxn>
                      <a:cxn ang="0">
                        <a:pos x="18" y="9"/>
                      </a:cxn>
                      <a:cxn ang="0">
                        <a:pos x="18" y="0"/>
                      </a:cxn>
                      <a:cxn ang="0">
                        <a:pos x="18" y="18"/>
                      </a:cxn>
                      <a:cxn ang="0">
                        <a:pos x="0" y="18"/>
                      </a:cxn>
                      <a:cxn ang="0">
                        <a:pos x="36" y="18"/>
                      </a:cxn>
                      <a:cxn ang="0">
                        <a:pos x="0" y="18"/>
                      </a:cxn>
                      <a:cxn ang="0">
                        <a:pos x="0" y="0"/>
                      </a:cxn>
                      <a:cxn ang="0">
                        <a:pos x="36" y="0"/>
                      </a:cxn>
                      <a:cxn ang="0">
                        <a:pos x="0" y="0"/>
                      </a:cxn>
                    </a:cxnLst>
                    <a:rect l="0" t="0" r="r" b="b"/>
                    <a:pathLst>
                      <a:path w="36" h="18">
                        <a:moveTo>
                          <a:pt x="18" y="18"/>
                        </a:moveTo>
                        <a:lnTo>
                          <a:pt x="18" y="9"/>
                        </a:lnTo>
                        <a:lnTo>
                          <a:pt x="18" y="0"/>
                        </a:lnTo>
                        <a:lnTo>
                          <a:pt x="18" y="18"/>
                        </a:lnTo>
                        <a:close/>
                        <a:moveTo>
                          <a:pt x="0" y="18"/>
                        </a:moveTo>
                        <a:lnTo>
                          <a:pt x="36" y="18"/>
                        </a:lnTo>
                        <a:lnTo>
                          <a:pt x="0" y="18"/>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677" name="Freeform 28"/>
                  <p:cNvSpPr>
                    <a:spLocks noEditPoints="1"/>
                  </p:cNvSpPr>
                  <p:nvPr/>
                </p:nvSpPr>
                <p:spPr bwMode="auto">
                  <a:xfrm>
                    <a:off x="2869652" y="2660738"/>
                    <a:ext cx="52811" cy="20020"/>
                  </a:xfrm>
                  <a:custGeom>
                    <a:avLst/>
                    <a:gdLst/>
                    <a:ahLst/>
                    <a:cxnLst>
                      <a:cxn ang="0">
                        <a:pos x="15" y="21"/>
                      </a:cxn>
                      <a:cxn ang="0">
                        <a:pos x="15" y="12"/>
                      </a:cxn>
                      <a:cxn ang="0">
                        <a:pos x="15" y="3"/>
                      </a:cxn>
                      <a:cxn ang="0">
                        <a:pos x="21" y="3"/>
                      </a:cxn>
                      <a:cxn ang="0">
                        <a:pos x="21" y="12"/>
                      </a:cxn>
                      <a:cxn ang="0">
                        <a:pos x="21" y="21"/>
                      </a:cxn>
                      <a:cxn ang="0">
                        <a:pos x="15" y="21"/>
                      </a:cxn>
                      <a:cxn ang="0">
                        <a:pos x="0" y="18"/>
                      </a:cxn>
                      <a:cxn ang="0">
                        <a:pos x="36" y="18"/>
                      </a:cxn>
                      <a:cxn ang="0">
                        <a:pos x="36" y="24"/>
                      </a:cxn>
                      <a:cxn ang="0">
                        <a:pos x="0" y="24"/>
                      </a:cxn>
                      <a:cxn ang="0">
                        <a:pos x="0" y="18"/>
                      </a:cxn>
                      <a:cxn ang="0">
                        <a:pos x="0" y="0"/>
                      </a:cxn>
                      <a:cxn ang="0">
                        <a:pos x="36" y="0"/>
                      </a:cxn>
                      <a:cxn ang="0">
                        <a:pos x="36" y="6"/>
                      </a:cxn>
                      <a:cxn ang="0">
                        <a:pos x="0" y="6"/>
                      </a:cxn>
                      <a:cxn ang="0">
                        <a:pos x="0" y="0"/>
                      </a:cxn>
                    </a:cxnLst>
                    <a:rect l="0" t="0" r="r" b="b"/>
                    <a:pathLst>
                      <a:path w="36" h="24">
                        <a:moveTo>
                          <a:pt x="15" y="21"/>
                        </a:moveTo>
                        <a:lnTo>
                          <a:pt x="15" y="12"/>
                        </a:lnTo>
                        <a:lnTo>
                          <a:pt x="15" y="3"/>
                        </a:lnTo>
                        <a:lnTo>
                          <a:pt x="21" y="3"/>
                        </a:lnTo>
                        <a:lnTo>
                          <a:pt x="21" y="12"/>
                        </a:lnTo>
                        <a:lnTo>
                          <a:pt x="21" y="21"/>
                        </a:lnTo>
                        <a:lnTo>
                          <a:pt x="15" y="21"/>
                        </a:lnTo>
                        <a:close/>
                        <a:moveTo>
                          <a:pt x="0" y="18"/>
                        </a:moveTo>
                        <a:lnTo>
                          <a:pt x="36" y="18"/>
                        </a:lnTo>
                        <a:lnTo>
                          <a:pt x="36" y="24"/>
                        </a:lnTo>
                        <a:lnTo>
                          <a:pt x="0" y="24"/>
                        </a:lnTo>
                        <a:lnTo>
                          <a:pt x="0" y="18"/>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678" name="Freeform 29"/>
                  <p:cNvSpPr>
                    <a:spLocks noEditPoints="1"/>
                  </p:cNvSpPr>
                  <p:nvPr/>
                </p:nvSpPr>
                <p:spPr bwMode="auto">
                  <a:xfrm>
                    <a:off x="3100449" y="2504422"/>
                    <a:ext cx="52811" cy="100102"/>
                  </a:xfrm>
                  <a:custGeom>
                    <a:avLst/>
                    <a:gdLst/>
                    <a:ahLst/>
                    <a:cxnLst>
                      <a:cxn ang="0">
                        <a:pos x="18" y="120"/>
                      </a:cxn>
                      <a:cxn ang="0">
                        <a:pos x="18" y="60"/>
                      </a:cxn>
                      <a:cxn ang="0">
                        <a:pos x="18" y="0"/>
                      </a:cxn>
                      <a:cxn ang="0">
                        <a:pos x="18" y="120"/>
                      </a:cxn>
                      <a:cxn ang="0">
                        <a:pos x="0" y="120"/>
                      </a:cxn>
                      <a:cxn ang="0">
                        <a:pos x="36" y="120"/>
                      </a:cxn>
                      <a:cxn ang="0">
                        <a:pos x="0" y="120"/>
                      </a:cxn>
                      <a:cxn ang="0">
                        <a:pos x="0" y="0"/>
                      </a:cxn>
                      <a:cxn ang="0">
                        <a:pos x="36" y="0"/>
                      </a:cxn>
                      <a:cxn ang="0">
                        <a:pos x="0" y="0"/>
                      </a:cxn>
                    </a:cxnLst>
                    <a:rect l="0" t="0" r="r" b="b"/>
                    <a:pathLst>
                      <a:path w="36" h="120">
                        <a:moveTo>
                          <a:pt x="18" y="120"/>
                        </a:moveTo>
                        <a:lnTo>
                          <a:pt x="18" y="60"/>
                        </a:lnTo>
                        <a:lnTo>
                          <a:pt x="18" y="0"/>
                        </a:lnTo>
                        <a:lnTo>
                          <a:pt x="18" y="120"/>
                        </a:lnTo>
                        <a:close/>
                        <a:moveTo>
                          <a:pt x="0" y="120"/>
                        </a:moveTo>
                        <a:lnTo>
                          <a:pt x="36" y="120"/>
                        </a:lnTo>
                        <a:lnTo>
                          <a:pt x="0" y="120"/>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679" name="Freeform 30"/>
                  <p:cNvSpPr>
                    <a:spLocks noEditPoints="1"/>
                  </p:cNvSpPr>
                  <p:nvPr/>
                </p:nvSpPr>
                <p:spPr bwMode="auto">
                  <a:xfrm>
                    <a:off x="3068695" y="2501920"/>
                    <a:ext cx="52811" cy="105107"/>
                  </a:xfrm>
                  <a:custGeom>
                    <a:avLst/>
                    <a:gdLst/>
                    <a:ahLst/>
                    <a:cxnLst>
                      <a:cxn ang="0">
                        <a:pos x="15" y="123"/>
                      </a:cxn>
                      <a:cxn ang="0">
                        <a:pos x="15" y="63"/>
                      </a:cxn>
                      <a:cxn ang="0">
                        <a:pos x="15" y="3"/>
                      </a:cxn>
                      <a:cxn ang="0">
                        <a:pos x="21" y="3"/>
                      </a:cxn>
                      <a:cxn ang="0">
                        <a:pos x="21" y="63"/>
                      </a:cxn>
                      <a:cxn ang="0">
                        <a:pos x="21" y="123"/>
                      </a:cxn>
                      <a:cxn ang="0">
                        <a:pos x="15" y="123"/>
                      </a:cxn>
                      <a:cxn ang="0">
                        <a:pos x="0" y="120"/>
                      </a:cxn>
                      <a:cxn ang="0">
                        <a:pos x="36" y="120"/>
                      </a:cxn>
                      <a:cxn ang="0">
                        <a:pos x="36" y="126"/>
                      </a:cxn>
                      <a:cxn ang="0">
                        <a:pos x="0" y="126"/>
                      </a:cxn>
                      <a:cxn ang="0">
                        <a:pos x="0" y="120"/>
                      </a:cxn>
                      <a:cxn ang="0">
                        <a:pos x="0" y="0"/>
                      </a:cxn>
                      <a:cxn ang="0">
                        <a:pos x="36" y="0"/>
                      </a:cxn>
                      <a:cxn ang="0">
                        <a:pos x="36" y="6"/>
                      </a:cxn>
                      <a:cxn ang="0">
                        <a:pos x="0" y="6"/>
                      </a:cxn>
                      <a:cxn ang="0">
                        <a:pos x="0" y="0"/>
                      </a:cxn>
                    </a:cxnLst>
                    <a:rect l="0" t="0" r="r" b="b"/>
                    <a:pathLst>
                      <a:path w="36" h="126">
                        <a:moveTo>
                          <a:pt x="15" y="123"/>
                        </a:moveTo>
                        <a:lnTo>
                          <a:pt x="15" y="63"/>
                        </a:lnTo>
                        <a:lnTo>
                          <a:pt x="15" y="3"/>
                        </a:lnTo>
                        <a:lnTo>
                          <a:pt x="21" y="3"/>
                        </a:lnTo>
                        <a:lnTo>
                          <a:pt x="21" y="63"/>
                        </a:lnTo>
                        <a:lnTo>
                          <a:pt x="21" y="123"/>
                        </a:lnTo>
                        <a:lnTo>
                          <a:pt x="15" y="123"/>
                        </a:lnTo>
                        <a:close/>
                        <a:moveTo>
                          <a:pt x="0" y="120"/>
                        </a:moveTo>
                        <a:lnTo>
                          <a:pt x="36" y="120"/>
                        </a:lnTo>
                        <a:lnTo>
                          <a:pt x="36" y="126"/>
                        </a:lnTo>
                        <a:lnTo>
                          <a:pt x="0" y="126"/>
                        </a:lnTo>
                        <a:lnTo>
                          <a:pt x="0" y="120"/>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680" name="Freeform 31"/>
                  <p:cNvSpPr>
                    <a:spLocks noEditPoints="1"/>
                  </p:cNvSpPr>
                  <p:nvPr/>
                </p:nvSpPr>
                <p:spPr bwMode="auto">
                  <a:xfrm>
                    <a:off x="3313057" y="1908816"/>
                    <a:ext cx="52811" cy="335341"/>
                  </a:xfrm>
                  <a:custGeom>
                    <a:avLst/>
                    <a:gdLst/>
                    <a:ahLst/>
                    <a:cxnLst>
                      <a:cxn ang="0">
                        <a:pos x="18" y="402"/>
                      </a:cxn>
                      <a:cxn ang="0">
                        <a:pos x="18" y="201"/>
                      </a:cxn>
                      <a:cxn ang="0">
                        <a:pos x="18" y="0"/>
                      </a:cxn>
                      <a:cxn ang="0">
                        <a:pos x="18" y="402"/>
                      </a:cxn>
                      <a:cxn ang="0">
                        <a:pos x="0" y="402"/>
                      </a:cxn>
                      <a:cxn ang="0">
                        <a:pos x="36" y="402"/>
                      </a:cxn>
                      <a:cxn ang="0">
                        <a:pos x="0" y="402"/>
                      </a:cxn>
                      <a:cxn ang="0">
                        <a:pos x="0" y="0"/>
                      </a:cxn>
                      <a:cxn ang="0">
                        <a:pos x="36" y="0"/>
                      </a:cxn>
                      <a:cxn ang="0">
                        <a:pos x="0" y="0"/>
                      </a:cxn>
                    </a:cxnLst>
                    <a:rect l="0" t="0" r="r" b="b"/>
                    <a:pathLst>
                      <a:path w="36" h="402">
                        <a:moveTo>
                          <a:pt x="18" y="402"/>
                        </a:moveTo>
                        <a:lnTo>
                          <a:pt x="18" y="201"/>
                        </a:lnTo>
                        <a:lnTo>
                          <a:pt x="18" y="0"/>
                        </a:lnTo>
                        <a:lnTo>
                          <a:pt x="18" y="402"/>
                        </a:lnTo>
                        <a:close/>
                        <a:moveTo>
                          <a:pt x="0" y="402"/>
                        </a:moveTo>
                        <a:lnTo>
                          <a:pt x="36" y="402"/>
                        </a:lnTo>
                        <a:lnTo>
                          <a:pt x="0" y="402"/>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681" name="Freeform 32"/>
                  <p:cNvSpPr>
                    <a:spLocks noEditPoints="1"/>
                  </p:cNvSpPr>
                  <p:nvPr/>
                </p:nvSpPr>
                <p:spPr bwMode="auto">
                  <a:xfrm>
                    <a:off x="3268603" y="1906314"/>
                    <a:ext cx="52811" cy="340347"/>
                  </a:xfrm>
                  <a:custGeom>
                    <a:avLst/>
                    <a:gdLst/>
                    <a:ahLst/>
                    <a:cxnLst>
                      <a:cxn ang="0">
                        <a:pos x="15" y="405"/>
                      </a:cxn>
                      <a:cxn ang="0">
                        <a:pos x="15" y="204"/>
                      </a:cxn>
                      <a:cxn ang="0">
                        <a:pos x="15" y="3"/>
                      </a:cxn>
                      <a:cxn ang="0">
                        <a:pos x="21" y="3"/>
                      </a:cxn>
                      <a:cxn ang="0">
                        <a:pos x="21" y="204"/>
                      </a:cxn>
                      <a:cxn ang="0">
                        <a:pos x="21" y="405"/>
                      </a:cxn>
                      <a:cxn ang="0">
                        <a:pos x="15" y="405"/>
                      </a:cxn>
                      <a:cxn ang="0">
                        <a:pos x="0" y="402"/>
                      </a:cxn>
                      <a:cxn ang="0">
                        <a:pos x="36" y="402"/>
                      </a:cxn>
                      <a:cxn ang="0">
                        <a:pos x="36" y="408"/>
                      </a:cxn>
                      <a:cxn ang="0">
                        <a:pos x="0" y="408"/>
                      </a:cxn>
                      <a:cxn ang="0">
                        <a:pos x="0" y="402"/>
                      </a:cxn>
                      <a:cxn ang="0">
                        <a:pos x="0" y="0"/>
                      </a:cxn>
                      <a:cxn ang="0">
                        <a:pos x="36" y="0"/>
                      </a:cxn>
                      <a:cxn ang="0">
                        <a:pos x="36" y="6"/>
                      </a:cxn>
                      <a:cxn ang="0">
                        <a:pos x="0" y="6"/>
                      </a:cxn>
                      <a:cxn ang="0">
                        <a:pos x="0" y="0"/>
                      </a:cxn>
                    </a:cxnLst>
                    <a:rect l="0" t="0" r="r" b="b"/>
                    <a:pathLst>
                      <a:path w="36" h="408">
                        <a:moveTo>
                          <a:pt x="15" y="405"/>
                        </a:moveTo>
                        <a:lnTo>
                          <a:pt x="15" y="204"/>
                        </a:lnTo>
                        <a:lnTo>
                          <a:pt x="15" y="3"/>
                        </a:lnTo>
                        <a:lnTo>
                          <a:pt x="21" y="3"/>
                        </a:lnTo>
                        <a:lnTo>
                          <a:pt x="21" y="204"/>
                        </a:lnTo>
                        <a:lnTo>
                          <a:pt x="21" y="405"/>
                        </a:lnTo>
                        <a:lnTo>
                          <a:pt x="15" y="405"/>
                        </a:lnTo>
                        <a:close/>
                        <a:moveTo>
                          <a:pt x="0" y="402"/>
                        </a:moveTo>
                        <a:lnTo>
                          <a:pt x="36" y="402"/>
                        </a:lnTo>
                        <a:lnTo>
                          <a:pt x="36" y="408"/>
                        </a:lnTo>
                        <a:lnTo>
                          <a:pt x="0" y="408"/>
                        </a:lnTo>
                        <a:lnTo>
                          <a:pt x="0" y="402"/>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682" name="Freeform 33"/>
                  <p:cNvSpPr>
                    <a:spLocks noEditPoints="1"/>
                  </p:cNvSpPr>
                  <p:nvPr/>
                </p:nvSpPr>
                <p:spPr bwMode="auto">
                  <a:xfrm>
                    <a:off x="3497811" y="2729652"/>
                    <a:ext cx="52811" cy="5005"/>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683" name="Freeform 34"/>
                  <p:cNvSpPr>
                    <a:spLocks noEditPoints="1"/>
                  </p:cNvSpPr>
                  <p:nvPr/>
                </p:nvSpPr>
                <p:spPr bwMode="auto">
                  <a:xfrm>
                    <a:off x="3462882" y="2723974"/>
                    <a:ext cx="52811" cy="10010"/>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684" name="Freeform 35"/>
                  <p:cNvSpPr>
                    <a:spLocks noEditPoints="1"/>
                  </p:cNvSpPr>
                  <p:nvPr/>
                </p:nvSpPr>
                <p:spPr bwMode="auto">
                  <a:xfrm>
                    <a:off x="3700893" y="2189101"/>
                    <a:ext cx="52811" cy="215219"/>
                  </a:xfrm>
                  <a:custGeom>
                    <a:avLst/>
                    <a:gdLst/>
                    <a:ahLst/>
                    <a:cxnLst>
                      <a:cxn ang="0">
                        <a:pos x="18" y="258"/>
                      </a:cxn>
                      <a:cxn ang="0">
                        <a:pos x="18" y="129"/>
                      </a:cxn>
                      <a:cxn ang="0">
                        <a:pos x="18" y="0"/>
                      </a:cxn>
                      <a:cxn ang="0">
                        <a:pos x="18" y="258"/>
                      </a:cxn>
                      <a:cxn ang="0">
                        <a:pos x="0" y="258"/>
                      </a:cxn>
                      <a:cxn ang="0">
                        <a:pos x="36" y="258"/>
                      </a:cxn>
                      <a:cxn ang="0">
                        <a:pos x="0" y="258"/>
                      </a:cxn>
                      <a:cxn ang="0">
                        <a:pos x="0" y="0"/>
                      </a:cxn>
                      <a:cxn ang="0">
                        <a:pos x="36" y="0"/>
                      </a:cxn>
                      <a:cxn ang="0">
                        <a:pos x="0" y="0"/>
                      </a:cxn>
                    </a:cxnLst>
                    <a:rect l="0" t="0" r="r" b="b"/>
                    <a:pathLst>
                      <a:path w="36" h="258">
                        <a:moveTo>
                          <a:pt x="18" y="258"/>
                        </a:moveTo>
                        <a:lnTo>
                          <a:pt x="18" y="129"/>
                        </a:lnTo>
                        <a:lnTo>
                          <a:pt x="18" y="0"/>
                        </a:lnTo>
                        <a:lnTo>
                          <a:pt x="18" y="258"/>
                        </a:lnTo>
                        <a:close/>
                        <a:moveTo>
                          <a:pt x="0" y="258"/>
                        </a:moveTo>
                        <a:lnTo>
                          <a:pt x="36" y="258"/>
                        </a:lnTo>
                        <a:lnTo>
                          <a:pt x="0" y="258"/>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685" name="Freeform 36"/>
                  <p:cNvSpPr>
                    <a:spLocks noEditPoints="1"/>
                  </p:cNvSpPr>
                  <p:nvPr/>
                </p:nvSpPr>
                <p:spPr bwMode="auto">
                  <a:xfrm>
                    <a:off x="3656439" y="2186599"/>
                    <a:ext cx="52811" cy="220224"/>
                  </a:xfrm>
                  <a:custGeom>
                    <a:avLst/>
                    <a:gdLst/>
                    <a:ahLst/>
                    <a:cxnLst>
                      <a:cxn ang="0">
                        <a:pos x="15" y="261"/>
                      </a:cxn>
                      <a:cxn ang="0">
                        <a:pos x="15" y="132"/>
                      </a:cxn>
                      <a:cxn ang="0">
                        <a:pos x="15" y="3"/>
                      </a:cxn>
                      <a:cxn ang="0">
                        <a:pos x="21" y="3"/>
                      </a:cxn>
                      <a:cxn ang="0">
                        <a:pos x="21" y="132"/>
                      </a:cxn>
                      <a:cxn ang="0">
                        <a:pos x="21" y="261"/>
                      </a:cxn>
                      <a:cxn ang="0">
                        <a:pos x="15" y="261"/>
                      </a:cxn>
                      <a:cxn ang="0">
                        <a:pos x="0" y="258"/>
                      </a:cxn>
                      <a:cxn ang="0">
                        <a:pos x="36" y="258"/>
                      </a:cxn>
                      <a:cxn ang="0">
                        <a:pos x="36" y="264"/>
                      </a:cxn>
                      <a:cxn ang="0">
                        <a:pos x="0" y="264"/>
                      </a:cxn>
                      <a:cxn ang="0">
                        <a:pos x="0" y="258"/>
                      </a:cxn>
                      <a:cxn ang="0">
                        <a:pos x="0" y="0"/>
                      </a:cxn>
                      <a:cxn ang="0">
                        <a:pos x="36" y="0"/>
                      </a:cxn>
                      <a:cxn ang="0">
                        <a:pos x="36" y="6"/>
                      </a:cxn>
                      <a:cxn ang="0">
                        <a:pos x="0" y="6"/>
                      </a:cxn>
                      <a:cxn ang="0">
                        <a:pos x="0" y="0"/>
                      </a:cxn>
                    </a:cxnLst>
                    <a:rect l="0" t="0" r="r" b="b"/>
                    <a:pathLst>
                      <a:path w="36" h="264">
                        <a:moveTo>
                          <a:pt x="15" y="261"/>
                        </a:moveTo>
                        <a:lnTo>
                          <a:pt x="15" y="132"/>
                        </a:lnTo>
                        <a:lnTo>
                          <a:pt x="15" y="3"/>
                        </a:lnTo>
                        <a:lnTo>
                          <a:pt x="21" y="3"/>
                        </a:lnTo>
                        <a:lnTo>
                          <a:pt x="21" y="132"/>
                        </a:lnTo>
                        <a:lnTo>
                          <a:pt x="21" y="261"/>
                        </a:lnTo>
                        <a:lnTo>
                          <a:pt x="15" y="261"/>
                        </a:lnTo>
                        <a:close/>
                        <a:moveTo>
                          <a:pt x="0" y="258"/>
                        </a:moveTo>
                        <a:lnTo>
                          <a:pt x="36" y="258"/>
                        </a:lnTo>
                        <a:lnTo>
                          <a:pt x="36" y="264"/>
                        </a:lnTo>
                        <a:lnTo>
                          <a:pt x="0" y="264"/>
                        </a:lnTo>
                        <a:lnTo>
                          <a:pt x="0" y="258"/>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686" name="Freeform 37"/>
                  <p:cNvSpPr>
                    <a:spLocks noEditPoints="1"/>
                  </p:cNvSpPr>
                  <p:nvPr/>
                </p:nvSpPr>
                <p:spPr bwMode="auto">
                  <a:xfrm>
                    <a:off x="3885647" y="2634555"/>
                    <a:ext cx="52811" cy="40041"/>
                  </a:xfrm>
                  <a:custGeom>
                    <a:avLst/>
                    <a:gdLst/>
                    <a:ahLst/>
                    <a:cxnLst>
                      <a:cxn ang="0">
                        <a:pos x="18" y="48"/>
                      </a:cxn>
                      <a:cxn ang="0">
                        <a:pos x="18" y="24"/>
                      </a:cxn>
                      <a:cxn ang="0">
                        <a:pos x="18" y="0"/>
                      </a:cxn>
                      <a:cxn ang="0">
                        <a:pos x="18" y="48"/>
                      </a:cxn>
                      <a:cxn ang="0">
                        <a:pos x="0" y="48"/>
                      </a:cxn>
                      <a:cxn ang="0">
                        <a:pos x="36" y="48"/>
                      </a:cxn>
                      <a:cxn ang="0">
                        <a:pos x="0" y="48"/>
                      </a:cxn>
                      <a:cxn ang="0">
                        <a:pos x="0" y="0"/>
                      </a:cxn>
                      <a:cxn ang="0">
                        <a:pos x="36" y="0"/>
                      </a:cxn>
                      <a:cxn ang="0">
                        <a:pos x="0" y="0"/>
                      </a:cxn>
                    </a:cxnLst>
                    <a:rect l="0" t="0" r="r" b="b"/>
                    <a:pathLst>
                      <a:path w="36" h="48">
                        <a:moveTo>
                          <a:pt x="18" y="48"/>
                        </a:moveTo>
                        <a:lnTo>
                          <a:pt x="18" y="24"/>
                        </a:lnTo>
                        <a:lnTo>
                          <a:pt x="18" y="0"/>
                        </a:lnTo>
                        <a:lnTo>
                          <a:pt x="18" y="48"/>
                        </a:lnTo>
                        <a:close/>
                        <a:moveTo>
                          <a:pt x="0" y="48"/>
                        </a:moveTo>
                        <a:lnTo>
                          <a:pt x="36" y="48"/>
                        </a:lnTo>
                        <a:lnTo>
                          <a:pt x="0" y="48"/>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687" name="Freeform 38"/>
                  <p:cNvSpPr>
                    <a:spLocks noEditPoints="1"/>
                  </p:cNvSpPr>
                  <p:nvPr/>
                </p:nvSpPr>
                <p:spPr bwMode="auto">
                  <a:xfrm>
                    <a:off x="3847543" y="2628878"/>
                    <a:ext cx="52811" cy="45046"/>
                  </a:xfrm>
                  <a:custGeom>
                    <a:avLst/>
                    <a:gdLst/>
                    <a:ahLst/>
                    <a:cxnLst>
                      <a:cxn ang="0">
                        <a:pos x="15" y="51"/>
                      </a:cxn>
                      <a:cxn ang="0">
                        <a:pos x="15" y="27"/>
                      </a:cxn>
                      <a:cxn ang="0">
                        <a:pos x="15" y="3"/>
                      </a:cxn>
                      <a:cxn ang="0">
                        <a:pos x="21" y="3"/>
                      </a:cxn>
                      <a:cxn ang="0">
                        <a:pos x="21" y="27"/>
                      </a:cxn>
                      <a:cxn ang="0">
                        <a:pos x="21" y="51"/>
                      </a:cxn>
                      <a:cxn ang="0">
                        <a:pos x="15" y="51"/>
                      </a:cxn>
                      <a:cxn ang="0">
                        <a:pos x="0" y="48"/>
                      </a:cxn>
                      <a:cxn ang="0">
                        <a:pos x="36" y="48"/>
                      </a:cxn>
                      <a:cxn ang="0">
                        <a:pos x="36" y="54"/>
                      </a:cxn>
                      <a:cxn ang="0">
                        <a:pos x="0" y="54"/>
                      </a:cxn>
                      <a:cxn ang="0">
                        <a:pos x="0" y="48"/>
                      </a:cxn>
                      <a:cxn ang="0">
                        <a:pos x="0" y="0"/>
                      </a:cxn>
                      <a:cxn ang="0">
                        <a:pos x="36" y="0"/>
                      </a:cxn>
                      <a:cxn ang="0">
                        <a:pos x="36" y="6"/>
                      </a:cxn>
                      <a:cxn ang="0">
                        <a:pos x="0" y="6"/>
                      </a:cxn>
                      <a:cxn ang="0">
                        <a:pos x="0" y="0"/>
                      </a:cxn>
                    </a:cxnLst>
                    <a:rect l="0" t="0" r="r" b="b"/>
                    <a:pathLst>
                      <a:path w="36" h="54">
                        <a:moveTo>
                          <a:pt x="15" y="51"/>
                        </a:moveTo>
                        <a:lnTo>
                          <a:pt x="15" y="27"/>
                        </a:lnTo>
                        <a:lnTo>
                          <a:pt x="15" y="3"/>
                        </a:lnTo>
                        <a:lnTo>
                          <a:pt x="21" y="3"/>
                        </a:lnTo>
                        <a:lnTo>
                          <a:pt x="21" y="27"/>
                        </a:lnTo>
                        <a:lnTo>
                          <a:pt x="21" y="51"/>
                        </a:lnTo>
                        <a:lnTo>
                          <a:pt x="15" y="51"/>
                        </a:lnTo>
                        <a:close/>
                        <a:moveTo>
                          <a:pt x="0" y="48"/>
                        </a:moveTo>
                        <a:lnTo>
                          <a:pt x="36" y="48"/>
                        </a:lnTo>
                        <a:lnTo>
                          <a:pt x="36" y="54"/>
                        </a:lnTo>
                        <a:lnTo>
                          <a:pt x="0" y="54"/>
                        </a:lnTo>
                        <a:lnTo>
                          <a:pt x="0" y="48"/>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688" name="Rectangle 63"/>
                  <p:cNvSpPr>
                    <a:spLocks noChangeArrowheads="1"/>
                  </p:cNvSpPr>
                  <p:nvPr/>
                </p:nvSpPr>
                <p:spPr bwMode="auto">
                  <a:xfrm>
                    <a:off x="2498262" y="2569891"/>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chemeClr val="tx1"/>
                        </a:solidFill>
                        <a:effectLst/>
                        <a:latin typeface="Arial" pitchFamily="34" charset="0"/>
                        <a:cs typeface="Arial" pitchFamily="34" charset="0"/>
                      </a:rPr>
                      <a:t>d</a:t>
                    </a:r>
                  </a:p>
                </p:txBody>
              </p:sp>
              <p:sp>
                <p:nvSpPr>
                  <p:cNvPr id="689" name="Rectangle 64"/>
                  <p:cNvSpPr>
                    <a:spLocks noChangeArrowheads="1"/>
                  </p:cNvSpPr>
                  <p:nvPr/>
                </p:nvSpPr>
                <p:spPr bwMode="auto">
                  <a:xfrm>
                    <a:off x="2683773" y="2547082"/>
                    <a:ext cx="67327"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000">
                        <a:solidFill>
                          <a:srgbClr val="000000"/>
                        </a:solidFill>
                        <a:latin typeface="Calibri" pitchFamily="34" charset="0"/>
                        <a:cs typeface="Arial" pitchFamily="34" charset="0"/>
                      </a:rPr>
                      <a:t>d</a:t>
                    </a:r>
                    <a:endParaRPr kumimoji="0" lang="en-US" sz="1000" b="0" i="0" u="none" strike="noStrike" cap="none" normalizeH="0" baseline="0">
                      <a:ln>
                        <a:noFill/>
                      </a:ln>
                      <a:solidFill>
                        <a:schemeClr val="tx1"/>
                      </a:solidFill>
                      <a:effectLst/>
                      <a:latin typeface="Arial" pitchFamily="34" charset="0"/>
                      <a:cs typeface="Arial" pitchFamily="34" charset="0"/>
                    </a:endParaRPr>
                  </a:p>
                </p:txBody>
              </p:sp>
              <p:sp>
                <p:nvSpPr>
                  <p:cNvPr id="690" name="Rectangle 65"/>
                  <p:cNvSpPr>
                    <a:spLocks noChangeArrowheads="1"/>
                  </p:cNvSpPr>
                  <p:nvPr/>
                </p:nvSpPr>
                <p:spPr bwMode="auto">
                  <a:xfrm>
                    <a:off x="2868328" y="2494707"/>
                    <a:ext cx="54503"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000">
                        <a:solidFill>
                          <a:srgbClr val="000000"/>
                        </a:solidFill>
                        <a:latin typeface="Calibri" pitchFamily="34" charset="0"/>
                        <a:cs typeface="Arial" pitchFamily="34" charset="0"/>
                      </a:rPr>
                      <a:t>c</a:t>
                    </a:r>
                    <a:endParaRPr kumimoji="0" lang="en-US" sz="1000" b="0" i="0" u="none" strike="noStrike" cap="none" normalizeH="0" baseline="0">
                      <a:ln>
                        <a:noFill/>
                      </a:ln>
                      <a:solidFill>
                        <a:schemeClr val="tx1"/>
                      </a:solidFill>
                      <a:effectLst/>
                      <a:latin typeface="Arial" pitchFamily="34" charset="0"/>
                      <a:cs typeface="Arial" pitchFamily="34" charset="0"/>
                    </a:endParaRPr>
                  </a:p>
                </p:txBody>
              </p:sp>
              <p:sp>
                <p:nvSpPr>
                  <p:cNvPr id="691" name="Rectangle 66"/>
                  <p:cNvSpPr>
                    <a:spLocks noChangeArrowheads="1"/>
                  </p:cNvSpPr>
                  <p:nvPr/>
                </p:nvSpPr>
                <p:spPr bwMode="auto">
                  <a:xfrm>
                    <a:off x="3029830" y="2340700"/>
                    <a:ext cx="121829"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000">
                        <a:solidFill>
                          <a:srgbClr val="000000"/>
                        </a:solidFill>
                        <a:latin typeface="Calibri" pitchFamily="34" charset="0"/>
                        <a:cs typeface="Arial" pitchFamily="34" charset="0"/>
                      </a:rPr>
                      <a:t>bc</a:t>
                    </a:r>
                    <a:endParaRPr kumimoji="0" lang="en-US" sz="1000" b="0" i="0" u="none" strike="noStrike" cap="none" normalizeH="0" baseline="0">
                      <a:ln>
                        <a:noFill/>
                      </a:ln>
                      <a:solidFill>
                        <a:schemeClr val="tx1"/>
                      </a:solidFill>
                      <a:effectLst/>
                      <a:latin typeface="Arial" pitchFamily="34" charset="0"/>
                      <a:cs typeface="Arial" pitchFamily="34" charset="0"/>
                    </a:endParaRPr>
                  </a:p>
                </p:txBody>
              </p:sp>
              <p:sp>
                <p:nvSpPr>
                  <p:cNvPr id="692" name="Rectangle 67"/>
                  <p:cNvSpPr>
                    <a:spLocks noChangeArrowheads="1"/>
                  </p:cNvSpPr>
                  <p:nvPr/>
                </p:nvSpPr>
                <p:spPr bwMode="auto">
                  <a:xfrm>
                    <a:off x="3259715" y="1726419"/>
                    <a:ext cx="6091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pitchFamily="34" charset="0"/>
                        <a:cs typeface="Arial" pitchFamily="34" charset="0"/>
                      </a:rPr>
                      <a:t>a</a:t>
                    </a:r>
                    <a:endParaRPr kumimoji="0" lang="en-US" sz="1000" b="0" i="0" u="none" strike="noStrike" cap="none" normalizeH="0" baseline="0">
                      <a:ln>
                        <a:noFill/>
                      </a:ln>
                      <a:solidFill>
                        <a:schemeClr val="tx1"/>
                      </a:solidFill>
                      <a:effectLst/>
                      <a:latin typeface="Arial" pitchFamily="34" charset="0"/>
                      <a:cs typeface="Arial" pitchFamily="34" charset="0"/>
                    </a:endParaRPr>
                  </a:p>
                </p:txBody>
              </p:sp>
              <p:sp>
                <p:nvSpPr>
                  <p:cNvPr id="693" name="Rectangle 68"/>
                  <p:cNvSpPr>
                    <a:spLocks noChangeArrowheads="1"/>
                  </p:cNvSpPr>
                  <p:nvPr/>
                </p:nvSpPr>
                <p:spPr bwMode="auto">
                  <a:xfrm>
                    <a:off x="3464692" y="2562951"/>
                    <a:ext cx="67326"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pitchFamily="34" charset="0"/>
                        <a:cs typeface="Arial" pitchFamily="34" charset="0"/>
                      </a:rPr>
                      <a:t>d</a:t>
                    </a:r>
                    <a:endParaRPr kumimoji="0" lang="en-US" sz="1000" b="0" i="0" u="none" strike="noStrike" cap="none" normalizeH="0" baseline="0">
                      <a:ln>
                        <a:noFill/>
                      </a:ln>
                      <a:solidFill>
                        <a:schemeClr val="tx1"/>
                      </a:solidFill>
                      <a:effectLst/>
                      <a:latin typeface="Arial" pitchFamily="34" charset="0"/>
                      <a:cs typeface="Arial" pitchFamily="34" charset="0"/>
                    </a:endParaRPr>
                  </a:p>
                </p:txBody>
              </p:sp>
              <p:sp>
                <p:nvSpPr>
                  <p:cNvPr id="694" name="Rectangle 69"/>
                  <p:cNvSpPr>
                    <a:spLocks noChangeArrowheads="1"/>
                  </p:cNvSpPr>
                  <p:nvPr/>
                </p:nvSpPr>
                <p:spPr bwMode="auto">
                  <a:xfrm>
                    <a:off x="3628032" y="2016851"/>
                    <a:ext cx="128241"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pitchFamily="34" charset="0"/>
                        <a:cs typeface="Arial" pitchFamily="34" charset="0"/>
                      </a:rPr>
                      <a:t>ab</a:t>
                    </a:r>
                    <a:endParaRPr kumimoji="0" lang="en-US" sz="1000" b="0" i="0" u="none" strike="noStrike" cap="none" normalizeH="0" baseline="0">
                      <a:ln>
                        <a:noFill/>
                      </a:ln>
                      <a:solidFill>
                        <a:schemeClr val="tx1"/>
                      </a:solidFill>
                      <a:effectLst/>
                      <a:latin typeface="Arial" pitchFamily="34" charset="0"/>
                      <a:cs typeface="Arial" pitchFamily="34" charset="0"/>
                    </a:endParaRPr>
                  </a:p>
                </p:txBody>
              </p:sp>
              <p:sp>
                <p:nvSpPr>
                  <p:cNvPr id="695" name="Rectangle 70"/>
                  <p:cNvSpPr>
                    <a:spLocks noChangeArrowheads="1"/>
                  </p:cNvSpPr>
                  <p:nvPr/>
                </p:nvSpPr>
                <p:spPr bwMode="auto">
                  <a:xfrm>
                    <a:off x="3820787" y="2449003"/>
                    <a:ext cx="121829"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pitchFamily="34" charset="0"/>
                        <a:cs typeface="Arial" pitchFamily="34" charset="0"/>
                      </a:rPr>
                      <a:t>bc</a:t>
                    </a:r>
                    <a:endParaRPr kumimoji="0" lang="en-US" sz="1000" b="0" i="0" u="none" strike="noStrike" cap="none" normalizeH="0" baseline="0">
                      <a:ln>
                        <a:noFill/>
                      </a:ln>
                      <a:solidFill>
                        <a:schemeClr val="tx1"/>
                      </a:solidFill>
                      <a:effectLst/>
                      <a:latin typeface="Arial" pitchFamily="34" charset="0"/>
                      <a:cs typeface="Arial" pitchFamily="34" charset="0"/>
                    </a:endParaRPr>
                  </a:p>
                </p:txBody>
              </p:sp>
            </p:grpSp>
            <p:grpSp>
              <p:nvGrpSpPr>
                <p:cNvPr id="697" name="Group 696">
                  <a:extLst>
                    <a:ext uri="{FF2B5EF4-FFF2-40B4-BE49-F238E27FC236}">
                      <a16:creationId xmlns:a16="http://schemas.microsoft.com/office/drawing/2014/main" id="{1E42AFDC-7C72-47E5-B651-B835CAB81805}"/>
                    </a:ext>
                  </a:extLst>
                </p:cNvPr>
                <p:cNvGrpSpPr/>
                <p:nvPr/>
              </p:nvGrpSpPr>
              <p:grpSpPr>
                <a:xfrm>
                  <a:off x="3227417" y="2959930"/>
                  <a:ext cx="1790899" cy="1195900"/>
                  <a:chOff x="3227417" y="1371600"/>
                  <a:chExt cx="1790899" cy="1195900"/>
                </a:xfrm>
              </p:grpSpPr>
              <p:grpSp>
                <p:nvGrpSpPr>
                  <p:cNvPr id="703" name="Group 644">
                    <a:extLst>
                      <a:ext uri="{FF2B5EF4-FFF2-40B4-BE49-F238E27FC236}">
                        <a16:creationId xmlns:a16="http://schemas.microsoft.com/office/drawing/2014/main" id="{D6316C4D-0B2D-4203-BBE1-21FE28D630C3}"/>
                      </a:ext>
                    </a:extLst>
                  </p:cNvPr>
                  <p:cNvGrpSpPr/>
                  <p:nvPr/>
                </p:nvGrpSpPr>
                <p:grpSpPr>
                  <a:xfrm>
                    <a:off x="3227417" y="1371600"/>
                    <a:ext cx="1790899" cy="1195900"/>
                    <a:chOff x="2210306" y="3877849"/>
                    <a:chExt cx="1790898" cy="1195900"/>
                  </a:xfrm>
                </p:grpSpPr>
                <p:sp>
                  <p:nvSpPr>
                    <p:cNvPr id="706" name="Freeform 40">
                      <a:extLst>
                        <a:ext uri="{FF2B5EF4-FFF2-40B4-BE49-F238E27FC236}">
                          <a16:creationId xmlns:a16="http://schemas.microsoft.com/office/drawing/2014/main" id="{A6A9367A-B25C-487A-9820-5588A0ED9957}"/>
                        </a:ext>
                      </a:extLst>
                    </p:cNvPr>
                    <p:cNvSpPr>
                      <a:spLocks noEditPoints="1"/>
                    </p:cNvSpPr>
                    <p:nvPr/>
                  </p:nvSpPr>
                  <p:spPr bwMode="auto">
                    <a:xfrm>
                      <a:off x="2348412" y="4058366"/>
                      <a:ext cx="25488" cy="872459"/>
                    </a:xfrm>
                    <a:custGeom>
                      <a:avLst/>
                      <a:gdLst/>
                      <a:ahLst/>
                      <a:cxnLst>
                        <a:cxn ang="0">
                          <a:pos x="0" y="1044"/>
                        </a:cxn>
                        <a:cxn ang="0">
                          <a:pos x="30" y="1044"/>
                        </a:cxn>
                        <a:cxn ang="0">
                          <a:pos x="30" y="1050"/>
                        </a:cxn>
                        <a:cxn ang="0">
                          <a:pos x="0" y="1050"/>
                        </a:cxn>
                        <a:cxn ang="0">
                          <a:pos x="0" y="1044"/>
                        </a:cxn>
                        <a:cxn ang="0">
                          <a:pos x="0" y="522"/>
                        </a:cxn>
                        <a:cxn ang="0">
                          <a:pos x="30" y="522"/>
                        </a:cxn>
                        <a:cxn ang="0">
                          <a:pos x="30" y="528"/>
                        </a:cxn>
                        <a:cxn ang="0">
                          <a:pos x="0" y="528"/>
                        </a:cxn>
                        <a:cxn ang="0">
                          <a:pos x="0" y="522"/>
                        </a:cxn>
                        <a:cxn ang="0">
                          <a:pos x="0" y="0"/>
                        </a:cxn>
                        <a:cxn ang="0">
                          <a:pos x="30" y="0"/>
                        </a:cxn>
                        <a:cxn ang="0">
                          <a:pos x="30" y="6"/>
                        </a:cxn>
                        <a:cxn ang="0">
                          <a:pos x="0" y="6"/>
                        </a:cxn>
                        <a:cxn ang="0">
                          <a:pos x="0" y="0"/>
                        </a:cxn>
                      </a:cxnLst>
                      <a:rect l="0" t="0" r="r" b="b"/>
                      <a:pathLst>
                        <a:path w="30" h="1050">
                          <a:moveTo>
                            <a:pt x="0" y="1044"/>
                          </a:moveTo>
                          <a:lnTo>
                            <a:pt x="30" y="1044"/>
                          </a:lnTo>
                          <a:lnTo>
                            <a:pt x="30" y="1050"/>
                          </a:lnTo>
                          <a:lnTo>
                            <a:pt x="0" y="1050"/>
                          </a:lnTo>
                          <a:lnTo>
                            <a:pt x="0" y="1044"/>
                          </a:lnTo>
                          <a:close/>
                          <a:moveTo>
                            <a:pt x="0" y="522"/>
                          </a:moveTo>
                          <a:lnTo>
                            <a:pt x="30" y="522"/>
                          </a:lnTo>
                          <a:lnTo>
                            <a:pt x="30" y="528"/>
                          </a:lnTo>
                          <a:lnTo>
                            <a:pt x="0" y="528"/>
                          </a:lnTo>
                          <a:lnTo>
                            <a:pt x="0" y="522"/>
                          </a:lnTo>
                          <a:close/>
                          <a:moveTo>
                            <a:pt x="0" y="0"/>
                          </a:moveTo>
                          <a:lnTo>
                            <a:pt x="30" y="0"/>
                          </a:lnTo>
                          <a:lnTo>
                            <a:pt x="30" y="6"/>
                          </a:lnTo>
                          <a:lnTo>
                            <a:pt x="0" y="6"/>
                          </a:lnTo>
                          <a:lnTo>
                            <a:pt x="0" y="0"/>
                          </a:lnTo>
                          <a:close/>
                        </a:path>
                      </a:pathLst>
                    </a:custGeom>
                    <a:solidFill>
                      <a:schemeClr val="tx1"/>
                    </a:solidFill>
                    <a:ln w="635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sz="800">
                        <a:latin typeface="Calibri "/>
                      </a:endParaRPr>
                    </a:p>
                  </p:txBody>
                </p:sp>
                <p:sp>
                  <p:nvSpPr>
                    <p:cNvPr id="707" name="Rectangle 43">
                      <a:extLst>
                        <a:ext uri="{FF2B5EF4-FFF2-40B4-BE49-F238E27FC236}">
                          <a16:creationId xmlns:a16="http://schemas.microsoft.com/office/drawing/2014/main" id="{9373ED9B-1557-47A5-861B-B28F95E065D6}"/>
                        </a:ext>
                      </a:extLst>
                    </p:cNvPr>
                    <p:cNvSpPr>
                      <a:spLocks noChangeArrowheads="1"/>
                    </p:cNvSpPr>
                    <p:nvPr/>
                  </p:nvSpPr>
                  <p:spPr bwMode="auto">
                    <a:xfrm>
                      <a:off x="2252610" y="4856683"/>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0</a:t>
                      </a:r>
                      <a:endParaRPr lang="en-US" sz="800">
                        <a:latin typeface="Calibri "/>
                        <a:cs typeface="Arial" pitchFamily="34" charset="0"/>
                      </a:endParaRPr>
                    </a:p>
                  </p:txBody>
                </p:sp>
                <p:sp>
                  <p:nvSpPr>
                    <p:cNvPr id="708" name="Rectangle 44">
                      <a:extLst>
                        <a:ext uri="{FF2B5EF4-FFF2-40B4-BE49-F238E27FC236}">
                          <a16:creationId xmlns:a16="http://schemas.microsoft.com/office/drawing/2014/main" id="{408BECCB-C811-4ED9-B64B-B4D37DE2CD2A}"/>
                        </a:ext>
                      </a:extLst>
                    </p:cNvPr>
                    <p:cNvSpPr>
                      <a:spLocks noChangeArrowheads="1"/>
                    </p:cNvSpPr>
                    <p:nvPr/>
                  </p:nvSpPr>
                  <p:spPr bwMode="auto">
                    <a:xfrm>
                      <a:off x="2210306" y="4429879"/>
                      <a:ext cx="115416"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20</a:t>
                      </a:r>
                      <a:endParaRPr lang="en-US" sz="800">
                        <a:latin typeface="Calibri "/>
                        <a:cs typeface="Arial" pitchFamily="34" charset="0"/>
                      </a:endParaRPr>
                    </a:p>
                  </p:txBody>
                </p:sp>
                <p:sp>
                  <p:nvSpPr>
                    <p:cNvPr id="709" name="Rectangle 45">
                      <a:extLst>
                        <a:ext uri="{FF2B5EF4-FFF2-40B4-BE49-F238E27FC236}">
                          <a16:creationId xmlns:a16="http://schemas.microsoft.com/office/drawing/2014/main" id="{D5AC94F6-EBB3-448F-8B6B-14AF9C9BDBDE}"/>
                        </a:ext>
                      </a:extLst>
                    </p:cNvPr>
                    <p:cNvSpPr>
                      <a:spLocks noChangeArrowheads="1"/>
                    </p:cNvSpPr>
                    <p:nvPr/>
                  </p:nvSpPr>
                  <p:spPr bwMode="auto">
                    <a:xfrm>
                      <a:off x="2210306" y="3996311"/>
                      <a:ext cx="115416"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a:solidFill>
                            <a:srgbClr val="000000"/>
                          </a:solidFill>
                          <a:latin typeface="Calibri "/>
                          <a:cs typeface="Arial" pitchFamily="34" charset="0"/>
                        </a:rPr>
                        <a:t>40</a:t>
                      </a:r>
                      <a:endParaRPr lang="en-US" sz="800">
                        <a:latin typeface="Calibri "/>
                        <a:cs typeface="Arial" pitchFamily="34" charset="0"/>
                      </a:endParaRPr>
                    </a:p>
                  </p:txBody>
                </p:sp>
                <p:sp>
                  <p:nvSpPr>
                    <p:cNvPr id="710" name="Rectangle 62">
                      <a:extLst>
                        <a:ext uri="{FF2B5EF4-FFF2-40B4-BE49-F238E27FC236}">
                          <a16:creationId xmlns:a16="http://schemas.microsoft.com/office/drawing/2014/main" id="{1E073D69-B700-4CF1-A44C-8649F08FACDF}"/>
                        </a:ext>
                      </a:extLst>
                    </p:cNvPr>
                    <p:cNvSpPr>
                      <a:spLocks noChangeArrowheads="1"/>
                    </p:cNvSpPr>
                    <p:nvPr/>
                  </p:nvSpPr>
                  <p:spPr bwMode="auto">
                    <a:xfrm>
                      <a:off x="2488343" y="4012066"/>
                      <a:ext cx="269304"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800" b="1" i="1">
                          <a:solidFill>
                            <a:srgbClr val="000000"/>
                          </a:solidFill>
                          <a:latin typeface="Calibri "/>
                          <a:cs typeface="Arial" pitchFamily="34" charset="0"/>
                        </a:rPr>
                        <a:t>SUS1</a:t>
                      </a:r>
                      <a:endParaRPr lang="en-US" sz="800" b="1" i="1">
                        <a:latin typeface="Calibri "/>
                        <a:cs typeface="Arial" pitchFamily="34" charset="0"/>
                      </a:endParaRPr>
                    </a:p>
                  </p:txBody>
                </p:sp>
                <p:cxnSp>
                  <p:nvCxnSpPr>
                    <p:cNvPr id="717" name="Straight Connector 716">
                      <a:extLst>
                        <a:ext uri="{FF2B5EF4-FFF2-40B4-BE49-F238E27FC236}">
                          <a16:creationId xmlns:a16="http://schemas.microsoft.com/office/drawing/2014/main" id="{D532B94F-B155-41D1-BCE3-AE6E97678E63}"/>
                        </a:ext>
                      </a:extLst>
                    </p:cNvPr>
                    <p:cNvCxnSpPr/>
                    <p:nvPr/>
                  </p:nvCxnSpPr>
                  <p:spPr>
                    <a:xfrm>
                      <a:off x="2377111" y="4927733"/>
                      <a:ext cx="162409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8" name="Straight Connector 717">
                      <a:extLst>
                        <a:ext uri="{FF2B5EF4-FFF2-40B4-BE49-F238E27FC236}">
                          <a16:creationId xmlns:a16="http://schemas.microsoft.com/office/drawing/2014/main" id="{CCEF1179-F166-42F5-A3F1-24BC40DA2967}"/>
                        </a:ext>
                      </a:extLst>
                    </p:cNvPr>
                    <p:cNvCxnSpPr/>
                    <p:nvPr/>
                  </p:nvCxnSpPr>
                  <p:spPr>
                    <a:xfrm>
                      <a:off x="2378098" y="4012606"/>
                      <a:ext cx="0" cy="91621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19" name="Rectangle 46">
                      <a:extLst>
                        <a:ext uri="{FF2B5EF4-FFF2-40B4-BE49-F238E27FC236}">
                          <a16:creationId xmlns:a16="http://schemas.microsoft.com/office/drawing/2014/main" id="{2AA19C5B-49EB-492B-A13B-51DAF72E46F6}"/>
                        </a:ext>
                      </a:extLst>
                    </p:cNvPr>
                    <p:cNvSpPr>
                      <a:spLocks noChangeArrowheads="1"/>
                    </p:cNvSpPr>
                    <p:nvPr/>
                  </p:nvSpPr>
                  <p:spPr bwMode="auto">
                    <a:xfrm>
                      <a:off x="2623967" y="4950638"/>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20" name="Rectangle 46">
                      <a:extLst>
                        <a:ext uri="{FF2B5EF4-FFF2-40B4-BE49-F238E27FC236}">
                          <a16:creationId xmlns:a16="http://schemas.microsoft.com/office/drawing/2014/main" id="{63A8359A-E884-4C9E-8B4A-CCBE19710B87}"/>
                        </a:ext>
                      </a:extLst>
                    </p:cNvPr>
                    <p:cNvSpPr>
                      <a:spLocks noChangeArrowheads="1"/>
                    </p:cNvSpPr>
                    <p:nvPr/>
                  </p:nvSpPr>
                  <p:spPr bwMode="auto">
                    <a:xfrm>
                      <a:off x="3009688" y="4950638"/>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21" name="Rectangle 46">
                      <a:extLst>
                        <a:ext uri="{FF2B5EF4-FFF2-40B4-BE49-F238E27FC236}">
                          <a16:creationId xmlns:a16="http://schemas.microsoft.com/office/drawing/2014/main" id="{63DE3E78-8715-4D8E-A46F-57B16412D6D5}"/>
                        </a:ext>
                      </a:extLst>
                    </p:cNvPr>
                    <p:cNvSpPr>
                      <a:spLocks noChangeArrowheads="1"/>
                    </p:cNvSpPr>
                    <p:nvPr/>
                  </p:nvSpPr>
                  <p:spPr bwMode="auto">
                    <a:xfrm>
                      <a:off x="3402179" y="4950638"/>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22" name="Rectangle 46">
                      <a:extLst>
                        <a:ext uri="{FF2B5EF4-FFF2-40B4-BE49-F238E27FC236}">
                          <a16:creationId xmlns:a16="http://schemas.microsoft.com/office/drawing/2014/main" id="{4E6E4E6E-8E7E-4AB2-B52A-C426D5B4E4EC}"/>
                        </a:ext>
                      </a:extLst>
                    </p:cNvPr>
                    <p:cNvSpPr>
                      <a:spLocks noChangeArrowheads="1"/>
                    </p:cNvSpPr>
                    <p:nvPr/>
                  </p:nvSpPr>
                  <p:spPr bwMode="auto">
                    <a:xfrm>
                      <a:off x="3794668" y="4950638"/>
                      <a:ext cx="148745" cy="123111"/>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800">
                          <a:solidFill>
                            <a:srgbClr val="000000"/>
                          </a:solidFill>
                          <a:latin typeface="Calibri "/>
                          <a:cs typeface="Arial" pitchFamily="34" charset="0"/>
                        </a:rPr>
                        <a:t>*</a:t>
                      </a:r>
                      <a:endParaRPr lang="en-US" sz="800">
                        <a:latin typeface="Calibri "/>
                        <a:cs typeface="Arial" pitchFamily="34" charset="0"/>
                      </a:endParaRPr>
                    </a:p>
                  </p:txBody>
                </p:sp>
                <p:sp>
                  <p:nvSpPr>
                    <p:cNvPr id="723" name="Rectangle 147">
                      <a:extLst>
                        <a:ext uri="{FF2B5EF4-FFF2-40B4-BE49-F238E27FC236}">
                          <a16:creationId xmlns:a16="http://schemas.microsoft.com/office/drawing/2014/main" id="{EA3E13EA-0A63-42A6-87CD-5AA3751BF891}"/>
                        </a:ext>
                      </a:extLst>
                    </p:cNvPr>
                    <p:cNvSpPr>
                      <a:spLocks noChangeArrowheads="1"/>
                    </p:cNvSpPr>
                    <p:nvPr/>
                  </p:nvSpPr>
                  <p:spPr bwMode="auto">
                    <a:xfrm>
                      <a:off x="2452686" y="4893037"/>
                      <a:ext cx="126000" cy="25832"/>
                    </a:xfrm>
                    <a:prstGeom prst="rect">
                      <a:avLst/>
                    </a:prstGeom>
                    <a:solidFill>
                      <a:srgbClr val="FDEAD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24" name="Rectangle 149">
                      <a:extLst>
                        <a:ext uri="{FF2B5EF4-FFF2-40B4-BE49-F238E27FC236}">
                          <a16:creationId xmlns:a16="http://schemas.microsoft.com/office/drawing/2014/main" id="{6E9466A3-068C-4E7F-9EDD-D46E117739F6}"/>
                        </a:ext>
                      </a:extLst>
                    </p:cNvPr>
                    <p:cNvSpPr>
                      <a:spLocks noChangeArrowheads="1"/>
                    </p:cNvSpPr>
                    <p:nvPr/>
                  </p:nvSpPr>
                  <p:spPr bwMode="auto">
                    <a:xfrm>
                      <a:off x="2637323" y="4836207"/>
                      <a:ext cx="126000" cy="82662"/>
                    </a:xfrm>
                    <a:prstGeom prst="rect">
                      <a:avLst/>
                    </a:prstGeom>
                    <a:solidFill>
                      <a:srgbClr val="EBF1DE"/>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25" name="Rectangle 151">
                      <a:extLst>
                        <a:ext uri="{FF2B5EF4-FFF2-40B4-BE49-F238E27FC236}">
                          <a16:creationId xmlns:a16="http://schemas.microsoft.com/office/drawing/2014/main" id="{13C523D4-AD3D-4035-A636-CC8D798E4237}"/>
                        </a:ext>
                      </a:extLst>
                    </p:cNvPr>
                    <p:cNvSpPr>
                      <a:spLocks noChangeArrowheads="1"/>
                    </p:cNvSpPr>
                    <p:nvPr/>
                  </p:nvSpPr>
                  <p:spPr bwMode="auto">
                    <a:xfrm>
                      <a:off x="2814816" y="4815542"/>
                      <a:ext cx="126000" cy="103327"/>
                    </a:xfrm>
                    <a:prstGeom prst="rect">
                      <a:avLst/>
                    </a:prstGeom>
                    <a:solidFill>
                      <a:srgbClr val="FCD5B5"/>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26" name="Rectangle 153">
                      <a:extLst>
                        <a:ext uri="{FF2B5EF4-FFF2-40B4-BE49-F238E27FC236}">
                          <a16:creationId xmlns:a16="http://schemas.microsoft.com/office/drawing/2014/main" id="{84FE3804-7FDB-47C3-8569-1D91DE27D89C}"/>
                        </a:ext>
                      </a:extLst>
                    </p:cNvPr>
                    <p:cNvSpPr>
                      <a:spLocks noChangeArrowheads="1"/>
                    </p:cNvSpPr>
                    <p:nvPr/>
                  </p:nvSpPr>
                  <p:spPr bwMode="auto">
                    <a:xfrm>
                      <a:off x="3016529" y="4779377"/>
                      <a:ext cx="126000" cy="139491"/>
                    </a:xfrm>
                    <a:prstGeom prst="rect">
                      <a:avLst/>
                    </a:prstGeom>
                    <a:solidFill>
                      <a:srgbClr val="D7E4BD"/>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27" name="Rectangle 155">
                      <a:extLst>
                        <a:ext uri="{FF2B5EF4-FFF2-40B4-BE49-F238E27FC236}">
                          <a16:creationId xmlns:a16="http://schemas.microsoft.com/office/drawing/2014/main" id="{4AAE80C5-CE81-4C52-AF63-4C8B5C7FA0BD}"/>
                        </a:ext>
                      </a:extLst>
                    </p:cNvPr>
                    <p:cNvSpPr>
                      <a:spLocks noChangeArrowheads="1"/>
                    </p:cNvSpPr>
                    <p:nvPr/>
                  </p:nvSpPr>
                  <p:spPr bwMode="auto">
                    <a:xfrm>
                      <a:off x="3217833" y="4025090"/>
                      <a:ext cx="126000" cy="893779"/>
                    </a:xfrm>
                    <a:prstGeom prst="rect">
                      <a:avLst/>
                    </a:prstGeom>
                    <a:solidFill>
                      <a:srgbClr val="FAC090"/>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28" name="Rectangle 157">
                      <a:extLst>
                        <a:ext uri="{FF2B5EF4-FFF2-40B4-BE49-F238E27FC236}">
                          <a16:creationId xmlns:a16="http://schemas.microsoft.com/office/drawing/2014/main" id="{8CC09F49-4644-4C21-BB7F-C08A6988AFAB}"/>
                        </a:ext>
                      </a:extLst>
                    </p:cNvPr>
                    <p:cNvSpPr>
                      <a:spLocks noChangeArrowheads="1"/>
                    </p:cNvSpPr>
                    <p:nvPr/>
                  </p:nvSpPr>
                  <p:spPr bwMode="auto">
                    <a:xfrm>
                      <a:off x="3419137" y="4836207"/>
                      <a:ext cx="126000" cy="82662"/>
                    </a:xfrm>
                    <a:prstGeom prst="rect">
                      <a:avLst/>
                    </a:prstGeom>
                    <a:solidFill>
                      <a:srgbClr val="C3D69B"/>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29" name="Rectangle 159">
                      <a:extLst>
                        <a:ext uri="{FF2B5EF4-FFF2-40B4-BE49-F238E27FC236}">
                          <a16:creationId xmlns:a16="http://schemas.microsoft.com/office/drawing/2014/main" id="{6A85ADD7-EC08-4265-9AAB-047924E54DB0}"/>
                        </a:ext>
                      </a:extLst>
                    </p:cNvPr>
                    <p:cNvSpPr>
                      <a:spLocks noChangeArrowheads="1"/>
                    </p:cNvSpPr>
                    <p:nvPr/>
                  </p:nvSpPr>
                  <p:spPr bwMode="auto">
                    <a:xfrm>
                      <a:off x="3608945" y="4071587"/>
                      <a:ext cx="126000" cy="847281"/>
                    </a:xfrm>
                    <a:prstGeom prst="rect">
                      <a:avLst/>
                    </a:prstGeom>
                    <a:solidFill>
                      <a:srgbClr val="E46C0A"/>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30" name="Rectangle 161">
                      <a:extLst>
                        <a:ext uri="{FF2B5EF4-FFF2-40B4-BE49-F238E27FC236}">
                          <a16:creationId xmlns:a16="http://schemas.microsoft.com/office/drawing/2014/main" id="{300819B9-D52B-45D4-B24D-7CB808485AA2}"/>
                        </a:ext>
                      </a:extLst>
                    </p:cNvPr>
                    <p:cNvSpPr>
                      <a:spLocks noChangeArrowheads="1"/>
                    </p:cNvSpPr>
                    <p:nvPr/>
                  </p:nvSpPr>
                  <p:spPr bwMode="auto">
                    <a:xfrm>
                      <a:off x="3800724" y="4758712"/>
                      <a:ext cx="126000" cy="160157"/>
                    </a:xfrm>
                    <a:prstGeom prst="rect">
                      <a:avLst/>
                    </a:prstGeom>
                    <a:solidFill>
                      <a:srgbClr val="77933C"/>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31" name="Freeform 163">
                      <a:extLst>
                        <a:ext uri="{FF2B5EF4-FFF2-40B4-BE49-F238E27FC236}">
                          <a16:creationId xmlns:a16="http://schemas.microsoft.com/office/drawing/2014/main" id="{8BBAB53F-995B-46C6-B830-108FF94364EE}"/>
                        </a:ext>
                      </a:extLst>
                    </p:cNvPr>
                    <p:cNvSpPr>
                      <a:spLocks noEditPoints="1"/>
                    </p:cNvSpPr>
                    <p:nvPr/>
                  </p:nvSpPr>
                  <p:spPr bwMode="auto">
                    <a:xfrm>
                      <a:off x="2496619" y="4893037"/>
                      <a:ext cx="54688" cy="5166"/>
                    </a:xfrm>
                    <a:custGeom>
                      <a:avLst/>
                      <a:gdLst/>
                      <a:ahLst/>
                      <a:cxnLst>
                        <a:cxn ang="0">
                          <a:pos x="18" y="6"/>
                        </a:cxn>
                        <a:cxn ang="0">
                          <a:pos x="18" y="3"/>
                        </a:cxn>
                        <a:cxn ang="0">
                          <a:pos x="18" y="0"/>
                        </a:cxn>
                        <a:cxn ang="0">
                          <a:pos x="18" y="6"/>
                        </a:cxn>
                        <a:cxn ang="0">
                          <a:pos x="0" y="6"/>
                        </a:cxn>
                        <a:cxn ang="0">
                          <a:pos x="36" y="6"/>
                        </a:cxn>
                        <a:cxn ang="0">
                          <a:pos x="0" y="6"/>
                        </a:cxn>
                        <a:cxn ang="0">
                          <a:pos x="0" y="0"/>
                        </a:cxn>
                        <a:cxn ang="0">
                          <a:pos x="36" y="0"/>
                        </a:cxn>
                        <a:cxn ang="0">
                          <a:pos x="0" y="0"/>
                        </a:cxn>
                      </a:cxnLst>
                      <a:rect l="0" t="0" r="r" b="b"/>
                      <a:pathLst>
                        <a:path w="36" h="6">
                          <a:moveTo>
                            <a:pt x="18" y="6"/>
                          </a:moveTo>
                          <a:lnTo>
                            <a:pt x="18" y="3"/>
                          </a:lnTo>
                          <a:lnTo>
                            <a:pt x="18" y="0"/>
                          </a:lnTo>
                          <a:lnTo>
                            <a:pt x="18" y="6"/>
                          </a:lnTo>
                          <a:close/>
                          <a:moveTo>
                            <a:pt x="0" y="6"/>
                          </a:moveTo>
                          <a:lnTo>
                            <a:pt x="36" y="6"/>
                          </a:lnTo>
                          <a:lnTo>
                            <a:pt x="0" y="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732" name="Freeform 164">
                      <a:extLst>
                        <a:ext uri="{FF2B5EF4-FFF2-40B4-BE49-F238E27FC236}">
                          <a16:creationId xmlns:a16="http://schemas.microsoft.com/office/drawing/2014/main" id="{B25A5E5A-2367-41AD-9ACC-05F069520219}"/>
                        </a:ext>
                      </a:extLst>
                    </p:cNvPr>
                    <p:cNvSpPr>
                      <a:spLocks noEditPoints="1"/>
                    </p:cNvSpPr>
                    <p:nvPr/>
                  </p:nvSpPr>
                  <p:spPr bwMode="auto">
                    <a:xfrm>
                      <a:off x="2496619" y="4890454"/>
                      <a:ext cx="54688" cy="10333"/>
                    </a:xfrm>
                    <a:custGeom>
                      <a:avLst/>
                      <a:gdLst/>
                      <a:ahLst/>
                      <a:cxnLst>
                        <a:cxn ang="0">
                          <a:pos x="15" y="9"/>
                        </a:cxn>
                        <a:cxn ang="0">
                          <a:pos x="15" y="6"/>
                        </a:cxn>
                        <a:cxn ang="0">
                          <a:pos x="15" y="3"/>
                        </a:cxn>
                        <a:cxn ang="0">
                          <a:pos x="21" y="3"/>
                        </a:cxn>
                        <a:cxn ang="0">
                          <a:pos x="21" y="6"/>
                        </a:cxn>
                        <a:cxn ang="0">
                          <a:pos x="21" y="9"/>
                        </a:cxn>
                        <a:cxn ang="0">
                          <a:pos x="15" y="9"/>
                        </a:cxn>
                        <a:cxn ang="0">
                          <a:pos x="0" y="6"/>
                        </a:cxn>
                        <a:cxn ang="0">
                          <a:pos x="36" y="6"/>
                        </a:cxn>
                        <a:cxn ang="0">
                          <a:pos x="36" y="12"/>
                        </a:cxn>
                        <a:cxn ang="0">
                          <a:pos x="0" y="12"/>
                        </a:cxn>
                        <a:cxn ang="0">
                          <a:pos x="0" y="6"/>
                        </a:cxn>
                        <a:cxn ang="0">
                          <a:pos x="0" y="0"/>
                        </a:cxn>
                        <a:cxn ang="0">
                          <a:pos x="36" y="0"/>
                        </a:cxn>
                        <a:cxn ang="0">
                          <a:pos x="36" y="6"/>
                        </a:cxn>
                        <a:cxn ang="0">
                          <a:pos x="0" y="6"/>
                        </a:cxn>
                        <a:cxn ang="0">
                          <a:pos x="0" y="0"/>
                        </a:cxn>
                      </a:cxnLst>
                      <a:rect l="0" t="0" r="r" b="b"/>
                      <a:pathLst>
                        <a:path w="36" h="12">
                          <a:moveTo>
                            <a:pt x="15" y="9"/>
                          </a:moveTo>
                          <a:lnTo>
                            <a:pt x="15" y="6"/>
                          </a:lnTo>
                          <a:lnTo>
                            <a:pt x="15" y="3"/>
                          </a:lnTo>
                          <a:lnTo>
                            <a:pt x="21" y="3"/>
                          </a:lnTo>
                          <a:lnTo>
                            <a:pt x="21" y="6"/>
                          </a:lnTo>
                          <a:lnTo>
                            <a:pt x="21" y="9"/>
                          </a:lnTo>
                          <a:lnTo>
                            <a:pt x="15" y="9"/>
                          </a:lnTo>
                          <a:close/>
                          <a:moveTo>
                            <a:pt x="0" y="6"/>
                          </a:moveTo>
                          <a:lnTo>
                            <a:pt x="36" y="6"/>
                          </a:lnTo>
                          <a:lnTo>
                            <a:pt x="36" y="12"/>
                          </a:lnTo>
                          <a:lnTo>
                            <a:pt x="0" y="12"/>
                          </a:lnTo>
                          <a:lnTo>
                            <a:pt x="0" y="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733" name="Freeform 165">
                      <a:extLst>
                        <a:ext uri="{FF2B5EF4-FFF2-40B4-BE49-F238E27FC236}">
                          <a16:creationId xmlns:a16="http://schemas.microsoft.com/office/drawing/2014/main" id="{1D9BAA60-FE74-441C-99AD-2AEBF17A4951}"/>
                        </a:ext>
                      </a:extLst>
                    </p:cNvPr>
                    <p:cNvSpPr>
                      <a:spLocks noEditPoints="1"/>
                    </p:cNvSpPr>
                    <p:nvPr/>
                  </p:nvSpPr>
                  <p:spPr bwMode="auto">
                    <a:xfrm>
                      <a:off x="2672141" y="4815542"/>
                      <a:ext cx="54688" cy="51664"/>
                    </a:xfrm>
                    <a:custGeom>
                      <a:avLst/>
                      <a:gdLst/>
                      <a:ahLst/>
                      <a:cxnLst>
                        <a:cxn ang="0">
                          <a:pos x="18" y="60"/>
                        </a:cxn>
                        <a:cxn ang="0">
                          <a:pos x="18" y="30"/>
                        </a:cxn>
                        <a:cxn ang="0">
                          <a:pos x="18" y="0"/>
                        </a:cxn>
                        <a:cxn ang="0">
                          <a:pos x="18" y="60"/>
                        </a:cxn>
                        <a:cxn ang="0">
                          <a:pos x="0" y="60"/>
                        </a:cxn>
                        <a:cxn ang="0">
                          <a:pos x="36" y="60"/>
                        </a:cxn>
                        <a:cxn ang="0">
                          <a:pos x="0" y="60"/>
                        </a:cxn>
                        <a:cxn ang="0">
                          <a:pos x="0" y="0"/>
                        </a:cxn>
                        <a:cxn ang="0">
                          <a:pos x="36" y="0"/>
                        </a:cxn>
                        <a:cxn ang="0">
                          <a:pos x="0" y="0"/>
                        </a:cxn>
                      </a:cxnLst>
                      <a:rect l="0" t="0" r="r" b="b"/>
                      <a:pathLst>
                        <a:path w="36" h="60">
                          <a:moveTo>
                            <a:pt x="18" y="60"/>
                          </a:moveTo>
                          <a:lnTo>
                            <a:pt x="18" y="30"/>
                          </a:lnTo>
                          <a:lnTo>
                            <a:pt x="18" y="0"/>
                          </a:lnTo>
                          <a:lnTo>
                            <a:pt x="18" y="60"/>
                          </a:lnTo>
                          <a:close/>
                          <a:moveTo>
                            <a:pt x="0" y="60"/>
                          </a:moveTo>
                          <a:lnTo>
                            <a:pt x="36" y="60"/>
                          </a:lnTo>
                          <a:lnTo>
                            <a:pt x="0" y="60"/>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734" name="Freeform 166">
                      <a:extLst>
                        <a:ext uri="{FF2B5EF4-FFF2-40B4-BE49-F238E27FC236}">
                          <a16:creationId xmlns:a16="http://schemas.microsoft.com/office/drawing/2014/main" id="{29AA8F2C-C26E-47CD-929D-451FF1EC7053}"/>
                        </a:ext>
                      </a:extLst>
                    </p:cNvPr>
                    <p:cNvSpPr>
                      <a:spLocks noEditPoints="1"/>
                    </p:cNvSpPr>
                    <p:nvPr/>
                  </p:nvSpPr>
                  <p:spPr bwMode="auto">
                    <a:xfrm>
                      <a:off x="2672141" y="4803434"/>
                      <a:ext cx="54688" cy="56830"/>
                    </a:xfrm>
                    <a:custGeom>
                      <a:avLst/>
                      <a:gdLst/>
                      <a:ahLst/>
                      <a:cxnLst>
                        <a:cxn ang="0">
                          <a:pos x="15" y="63"/>
                        </a:cxn>
                        <a:cxn ang="0">
                          <a:pos x="15" y="33"/>
                        </a:cxn>
                        <a:cxn ang="0">
                          <a:pos x="15" y="3"/>
                        </a:cxn>
                        <a:cxn ang="0">
                          <a:pos x="21" y="3"/>
                        </a:cxn>
                        <a:cxn ang="0">
                          <a:pos x="21" y="33"/>
                        </a:cxn>
                        <a:cxn ang="0">
                          <a:pos x="21" y="63"/>
                        </a:cxn>
                        <a:cxn ang="0">
                          <a:pos x="15" y="63"/>
                        </a:cxn>
                        <a:cxn ang="0">
                          <a:pos x="0" y="60"/>
                        </a:cxn>
                        <a:cxn ang="0">
                          <a:pos x="36" y="60"/>
                        </a:cxn>
                        <a:cxn ang="0">
                          <a:pos x="36" y="66"/>
                        </a:cxn>
                        <a:cxn ang="0">
                          <a:pos x="0" y="66"/>
                        </a:cxn>
                        <a:cxn ang="0">
                          <a:pos x="0" y="60"/>
                        </a:cxn>
                        <a:cxn ang="0">
                          <a:pos x="0" y="0"/>
                        </a:cxn>
                        <a:cxn ang="0">
                          <a:pos x="36" y="0"/>
                        </a:cxn>
                        <a:cxn ang="0">
                          <a:pos x="36" y="6"/>
                        </a:cxn>
                        <a:cxn ang="0">
                          <a:pos x="0" y="6"/>
                        </a:cxn>
                        <a:cxn ang="0">
                          <a:pos x="0" y="0"/>
                        </a:cxn>
                      </a:cxnLst>
                      <a:rect l="0" t="0" r="r" b="b"/>
                      <a:pathLst>
                        <a:path w="36" h="66">
                          <a:moveTo>
                            <a:pt x="15" y="63"/>
                          </a:moveTo>
                          <a:lnTo>
                            <a:pt x="15" y="33"/>
                          </a:lnTo>
                          <a:lnTo>
                            <a:pt x="15" y="3"/>
                          </a:lnTo>
                          <a:lnTo>
                            <a:pt x="21" y="3"/>
                          </a:lnTo>
                          <a:lnTo>
                            <a:pt x="21" y="33"/>
                          </a:lnTo>
                          <a:lnTo>
                            <a:pt x="21" y="63"/>
                          </a:lnTo>
                          <a:lnTo>
                            <a:pt x="15" y="63"/>
                          </a:lnTo>
                          <a:close/>
                          <a:moveTo>
                            <a:pt x="0" y="60"/>
                          </a:moveTo>
                          <a:lnTo>
                            <a:pt x="36" y="60"/>
                          </a:lnTo>
                          <a:lnTo>
                            <a:pt x="36" y="66"/>
                          </a:lnTo>
                          <a:lnTo>
                            <a:pt x="0" y="66"/>
                          </a:lnTo>
                          <a:lnTo>
                            <a:pt x="0" y="60"/>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735" name="Freeform 167">
                      <a:extLst>
                        <a:ext uri="{FF2B5EF4-FFF2-40B4-BE49-F238E27FC236}">
                          <a16:creationId xmlns:a16="http://schemas.microsoft.com/office/drawing/2014/main" id="{2B40006F-6041-4059-81B5-50C8C4D17CFC}"/>
                        </a:ext>
                      </a:extLst>
                    </p:cNvPr>
                    <p:cNvSpPr>
                      <a:spLocks noEditPoints="1"/>
                    </p:cNvSpPr>
                    <p:nvPr/>
                  </p:nvSpPr>
                  <p:spPr bwMode="auto">
                    <a:xfrm>
                      <a:off x="2849634" y="4805209"/>
                      <a:ext cx="54688" cy="25832"/>
                    </a:xfrm>
                    <a:custGeom>
                      <a:avLst/>
                      <a:gdLst/>
                      <a:ahLst/>
                      <a:cxnLst>
                        <a:cxn ang="0">
                          <a:pos x="18" y="30"/>
                        </a:cxn>
                        <a:cxn ang="0">
                          <a:pos x="18" y="15"/>
                        </a:cxn>
                        <a:cxn ang="0">
                          <a:pos x="18" y="0"/>
                        </a:cxn>
                        <a:cxn ang="0">
                          <a:pos x="18" y="30"/>
                        </a:cxn>
                        <a:cxn ang="0">
                          <a:pos x="0" y="30"/>
                        </a:cxn>
                        <a:cxn ang="0">
                          <a:pos x="36" y="30"/>
                        </a:cxn>
                        <a:cxn ang="0">
                          <a:pos x="0" y="30"/>
                        </a:cxn>
                        <a:cxn ang="0">
                          <a:pos x="0" y="0"/>
                        </a:cxn>
                        <a:cxn ang="0">
                          <a:pos x="36" y="0"/>
                        </a:cxn>
                        <a:cxn ang="0">
                          <a:pos x="0" y="0"/>
                        </a:cxn>
                      </a:cxnLst>
                      <a:rect l="0" t="0" r="r" b="b"/>
                      <a:pathLst>
                        <a:path w="36" h="30">
                          <a:moveTo>
                            <a:pt x="18" y="30"/>
                          </a:moveTo>
                          <a:lnTo>
                            <a:pt x="18" y="15"/>
                          </a:lnTo>
                          <a:lnTo>
                            <a:pt x="18" y="0"/>
                          </a:lnTo>
                          <a:lnTo>
                            <a:pt x="18" y="30"/>
                          </a:lnTo>
                          <a:close/>
                          <a:moveTo>
                            <a:pt x="0" y="30"/>
                          </a:moveTo>
                          <a:lnTo>
                            <a:pt x="36" y="30"/>
                          </a:lnTo>
                          <a:lnTo>
                            <a:pt x="0" y="30"/>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736" name="Freeform 168">
                      <a:extLst>
                        <a:ext uri="{FF2B5EF4-FFF2-40B4-BE49-F238E27FC236}">
                          <a16:creationId xmlns:a16="http://schemas.microsoft.com/office/drawing/2014/main" id="{8267952F-851A-4F3C-A3C9-51C221399255}"/>
                        </a:ext>
                      </a:extLst>
                    </p:cNvPr>
                    <p:cNvSpPr>
                      <a:spLocks noEditPoints="1"/>
                    </p:cNvSpPr>
                    <p:nvPr/>
                  </p:nvSpPr>
                  <p:spPr bwMode="auto">
                    <a:xfrm>
                      <a:off x="2846459" y="4799451"/>
                      <a:ext cx="54688" cy="30998"/>
                    </a:xfrm>
                    <a:custGeom>
                      <a:avLst/>
                      <a:gdLst/>
                      <a:ahLst/>
                      <a:cxnLst>
                        <a:cxn ang="0">
                          <a:pos x="15" y="33"/>
                        </a:cxn>
                        <a:cxn ang="0">
                          <a:pos x="15" y="18"/>
                        </a:cxn>
                        <a:cxn ang="0">
                          <a:pos x="15" y="3"/>
                        </a:cxn>
                        <a:cxn ang="0">
                          <a:pos x="21" y="3"/>
                        </a:cxn>
                        <a:cxn ang="0">
                          <a:pos x="21" y="18"/>
                        </a:cxn>
                        <a:cxn ang="0">
                          <a:pos x="21" y="33"/>
                        </a:cxn>
                        <a:cxn ang="0">
                          <a:pos x="15" y="33"/>
                        </a:cxn>
                        <a:cxn ang="0">
                          <a:pos x="0" y="30"/>
                        </a:cxn>
                        <a:cxn ang="0">
                          <a:pos x="36" y="30"/>
                        </a:cxn>
                        <a:cxn ang="0">
                          <a:pos x="36" y="36"/>
                        </a:cxn>
                        <a:cxn ang="0">
                          <a:pos x="0" y="36"/>
                        </a:cxn>
                        <a:cxn ang="0">
                          <a:pos x="0" y="30"/>
                        </a:cxn>
                        <a:cxn ang="0">
                          <a:pos x="0" y="0"/>
                        </a:cxn>
                        <a:cxn ang="0">
                          <a:pos x="36" y="0"/>
                        </a:cxn>
                        <a:cxn ang="0">
                          <a:pos x="36" y="6"/>
                        </a:cxn>
                        <a:cxn ang="0">
                          <a:pos x="0" y="6"/>
                        </a:cxn>
                        <a:cxn ang="0">
                          <a:pos x="0" y="0"/>
                        </a:cxn>
                      </a:cxnLst>
                      <a:rect l="0" t="0" r="r" b="b"/>
                      <a:pathLst>
                        <a:path w="36" h="36">
                          <a:moveTo>
                            <a:pt x="15" y="33"/>
                          </a:moveTo>
                          <a:lnTo>
                            <a:pt x="15" y="18"/>
                          </a:lnTo>
                          <a:lnTo>
                            <a:pt x="15" y="3"/>
                          </a:lnTo>
                          <a:lnTo>
                            <a:pt x="21" y="3"/>
                          </a:lnTo>
                          <a:lnTo>
                            <a:pt x="21" y="18"/>
                          </a:lnTo>
                          <a:lnTo>
                            <a:pt x="21" y="33"/>
                          </a:lnTo>
                          <a:lnTo>
                            <a:pt x="15" y="33"/>
                          </a:lnTo>
                          <a:close/>
                          <a:moveTo>
                            <a:pt x="0" y="30"/>
                          </a:moveTo>
                          <a:lnTo>
                            <a:pt x="36" y="30"/>
                          </a:lnTo>
                          <a:lnTo>
                            <a:pt x="36" y="36"/>
                          </a:lnTo>
                          <a:lnTo>
                            <a:pt x="0" y="36"/>
                          </a:lnTo>
                          <a:lnTo>
                            <a:pt x="0" y="30"/>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737" name="Freeform 169">
                      <a:extLst>
                        <a:ext uri="{FF2B5EF4-FFF2-40B4-BE49-F238E27FC236}">
                          <a16:creationId xmlns:a16="http://schemas.microsoft.com/office/drawing/2014/main" id="{E369E53B-5202-410E-B22A-831944E408AF}"/>
                        </a:ext>
                      </a:extLst>
                    </p:cNvPr>
                    <p:cNvSpPr>
                      <a:spLocks noEditPoints="1"/>
                    </p:cNvSpPr>
                    <p:nvPr/>
                  </p:nvSpPr>
                  <p:spPr bwMode="auto">
                    <a:xfrm>
                      <a:off x="3060462" y="4774211"/>
                      <a:ext cx="54688" cy="15499"/>
                    </a:xfrm>
                    <a:custGeom>
                      <a:avLst/>
                      <a:gdLst/>
                      <a:ahLst/>
                      <a:cxnLst>
                        <a:cxn ang="0">
                          <a:pos x="18" y="18"/>
                        </a:cxn>
                        <a:cxn ang="0">
                          <a:pos x="18" y="9"/>
                        </a:cxn>
                        <a:cxn ang="0">
                          <a:pos x="18" y="0"/>
                        </a:cxn>
                        <a:cxn ang="0">
                          <a:pos x="18" y="18"/>
                        </a:cxn>
                        <a:cxn ang="0">
                          <a:pos x="0" y="18"/>
                        </a:cxn>
                        <a:cxn ang="0">
                          <a:pos x="36" y="18"/>
                        </a:cxn>
                        <a:cxn ang="0">
                          <a:pos x="0" y="18"/>
                        </a:cxn>
                        <a:cxn ang="0">
                          <a:pos x="0" y="0"/>
                        </a:cxn>
                        <a:cxn ang="0">
                          <a:pos x="36" y="0"/>
                        </a:cxn>
                        <a:cxn ang="0">
                          <a:pos x="0" y="0"/>
                        </a:cxn>
                      </a:cxnLst>
                      <a:rect l="0" t="0" r="r" b="b"/>
                      <a:pathLst>
                        <a:path w="36" h="18">
                          <a:moveTo>
                            <a:pt x="18" y="18"/>
                          </a:moveTo>
                          <a:lnTo>
                            <a:pt x="18" y="9"/>
                          </a:lnTo>
                          <a:lnTo>
                            <a:pt x="18" y="0"/>
                          </a:lnTo>
                          <a:lnTo>
                            <a:pt x="18" y="18"/>
                          </a:lnTo>
                          <a:close/>
                          <a:moveTo>
                            <a:pt x="0" y="18"/>
                          </a:moveTo>
                          <a:lnTo>
                            <a:pt x="36" y="18"/>
                          </a:lnTo>
                          <a:lnTo>
                            <a:pt x="0" y="18"/>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738" name="Freeform 170">
                      <a:extLst>
                        <a:ext uri="{FF2B5EF4-FFF2-40B4-BE49-F238E27FC236}">
                          <a16:creationId xmlns:a16="http://schemas.microsoft.com/office/drawing/2014/main" id="{C67F56C0-8C53-4519-ABDD-A785E6D93B72}"/>
                        </a:ext>
                      </a:extLst>
                    </p:cNvPr>
                    <p:cNvSpPr>
                      <a:spLocks noEditPoints="1"/>
                    </p:cNvSpPr>
                    <p:nvPr/>
                  </p:nvSpPr>
                  <p:spPr bwMode="auto">
                    <a:xfrm>
                      <a:off x="3050937" y="4765278"/>
                      <a:ext cx="54688" cy="20665"/>
                    </a:xfrm>
                    <a:custGeom>
                      <a:avLst/>
                      <a:gdLst/>
                      <a:ahLst/>
                      <a:cxnLst>
                        <a:cxn ang="0">
                          <a:pos x="15" y="21"/>
                        </a:cxn>
                        <a:cxn ang="0">
                          <a:pos x="15" y="12"/>
                        </a:cxn>
                        <a:cxn ang="0">
                          <a:pos x="15" y="3"/>
                        </a:cxn>
                        <a:cxn ang="0">
                          <a:pos x="21" y="3"/>
                        </a:cxn>
                        <a:cxn ang="0">
                          <a:pos x="21" y="12"/>
                        </a:cxn>
                        <a:cxn ang="0">
                          <a:pos x="21" y="21"/>
                        </a:cxn>
                        <a:cxn ang="0">
                          <a:pos x="15" y="21"/>
                        </a:cxn>
                        <a:cxn ang="0">
                          <a:pos x="0" y="18"/>
                        </a:cxn>
                        <a:cxn ang="0">
                          <a:pos x="36" y="18"/>
                        </a:cxn>
                        <a:cxn ang="0">
                          <a:pos x="36" y="24"/>
                        </a:cxn>
                        <a:cxn ang="0">
                          <a:pos x="0" y="24"/>
                        </a:cxn>
                        <a:cxn ang="0">
                          <a:pos x="0" y="18"/>
                        </a:cxn>
                        <a:cxn ang="0">
                          <a:pos x="0" y="0"/>
                        </a:cxn>
                        <a:cxn ang="0">
                          <a:pos x="36" y="0"/>
                        </a:cxn>
                        <a:cxn ang="0">
                          <a:pos x="36" y="6"/>
                        </a:cxn>
                        <a:cxn ang="0">
                          <a:pos x="0" y="6"/>
                        </a:cxn>
                        <a:cxn ang="0">
                          <a:pos x="0" y="0"/>
                        </a:cxn>
                      </a:cxnLst>
                      <a:rect l="0" t="0" r="r" b="b"/>
                      <a:pathLst>
                        <a:path w="36" h="24">
                          <a:moveTo>
                            <a:pt x="15" y="21"/>
                          </a:moveTo>
                          <a:lnTo>
                            <a:pt x="15" y="12"/>
                          </a:lnTo>
                          <a:lnTo>
                            <a:pt x="15" y="3"/>
                          </a:lnTo>
                          <a:lnTo>
                            <a:pt x="21" y="3"/>
                          </a:lnTo>
                          <a:lnTo>
                            <a:pt x="21" y="12"/>
                          </a:lnTo>
                          <a:lnTo>
                            <a:pt x="21" y="21"/>
                          </a:lnTo>
                          <a:lnTo>
                            <a:pt x="15" y="21"/>
                          </a:lnTo>
                          <a:close/>
                          <a:moveTo>
                            <a:pt x="0" y="18"/>
                          </a:moveTo>
                          <a:lnTo>
                            <a:pt x="36" y="18"/>
                          </a:lnTo>
                          <a:lnTo>
                            <a:pt x="36" y="24"/>
                          </a:lnTo>
                          <a:lnTo>
                            <a:pt x="0" y="24"/>
                          </a:lnTo>
                          <a:lnTo>
                            <a:pt x="0" y="18"/>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739" name="Freeform 171">
                      <a:extLst>
                        <a:ext uri="{FF2B5EF4-FFF2-40B4-BE49-F238E27FC236}">
                          <a16:creationId xmlns:a16="http://schemas.microsoft.com/office/drawing/2014/main" id="{20BF9C3F-98C1-425A-9D88-67A4E0784E65}"/>
                        </a:ext>
                      </a:extLst>
                    </p:cNvPr>
                    <p:cNvSpPr>
                      <a:spLocks noEditPoints="1"/>
                    </p:cNvSpPr>
                    <p:nvPr/>
                  </p:nvSpPr>
                  <p:spPr bwMode="auto">
                    <a:xfrm>
                      <a:off x="3252651" y="3880432"/>
                      <a:ext cx="54688" cy="289316"/>
                    </a:xfrm>
                    <a:custGeom>
                      <a:avLst/>
                      <a:gdLst/>
                      <a:ahLst/>
                      <a:cxnLst>
                        <a:cxn ang="0">
                          <a:pos x="18" y="336"/>
                        </a:cxn>
                        <a:cxn ang="0">
                          <a:pos x="18" y="168"/>
                        </a:cxn>
                        <a:cxn ang="0">
                          <a:pos x="18" y="0"/>
                        </a:cxn>
                        <a:cxn ang="0">
                          <a:pos x="18" y="336"/>
                        </a:cxn>
                        <a:cxn ang="0">
                          <a:pos x="0" y="336"/>
                        </a:cxn>
                        <a:cxn ang="0">
                          <a:pos x="36" y="336"/>
                        </a:cxn>
                        <a:cxn ang="0">
                          <a:pos x="0" y="336"/>
                        </a:cxn>
                        <a:cxn ang="0">
                          <a:pos x="0" y="0"/>
                        </a:cxn>
                        <a:cxn ang="0">
                          <a:pos x="36" y="0"/>
                        </a:cxn>
                        <a:cxn ang="0">
                          <a:pos x="0" y="0"/>
                        </a:cxn>
                      </a:cxnLst>
                      <a:rect l="0" t="0" r="r" b="b"/>
                      <a:pathLst>
                        <a:path w="36" h="336">
                          <a:moveTo>
                            <a:pt x="18" y="336"/>
                          </a:moveTo>
                          <a:lnTo>
                            <a:pt x="18" y="168"/>
                          </a:lnTo>
                          <a:lnTo>
                            <a:pt x="18" y="0"/>
                          </a:lnTo>
                          <a:lnTo>
                            <a:pt x="18" y="336"/>
                          </a:lnTo>
                          <a:close/>
                          <a:moveTo>
                            <a:pt x="0" y="336"/>
                          </a:moveTo>
                          <a:lnTo>
                            <a:pt x="36" y="336"/>
                          </a:lnTo>
                          <a:lnTo>
                            <a:pt x="0" y="336"/>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740" name="Freeform 172">
                      <a:extLst>
                        <a:ext uri="{FF2B5EF4-FFF2-40B4-BE49-F238E27FC236}">
                          <a16:creationId xmlns:a16="http://schemas.microsoft.com/office/drawing/2014/main" id="{C0DD135D-6EED-4E44-81A3-640F3AC3BAA1}"/>
                        </a:ext>
                      </a:extLst>
                    </p:cNvPr>
                    <p:cNvSpPr>
                      <a:spLocks noEditPoints="1"/>
                    </p:cNvSpPr>
                    <p:nvPr/>
                  </p:nvSpPr>
                  <p:spPr bwMode="auto">
                    <a:xfrm>
                      <a:off x="3252651" y="3877849"/>
                      <a:ext cx="54688" cy="294482"/>
                    </a:xfrm>
                    <a:custGeom>
                      <a:avLst/>
                      <a:gdLst/>
                      <a:ahLst/>
                      <a:cxnLst>
                        <a:cxn ang="0">
                          <a:pos x="15" y="339"/>
                        </a:cxn>
                        <a:cxn ang="0">
                          <a:pos x="15" y="171"/>
                        </a:cxn>
                        <a:cxn ang="0">
                          <a:pos x="15" y="3"/>
                        </a:cxn>
                        <a:cxn ang="0">
                          <a:pos x="21" y="3"/>
                        </a:cxn>
                        <a:cxn ang="0">
                          <a:pos x="21" y="171"/>
                        </a:cxn>
                        <a:cxn ang="0">
                          <a:pos x="21" y="339"/>
                        </a:cxn>
                        <a:cxn ang="0">
                          <a:pos x="15" y="339"/>
                        </a:cxn>
                        <a:cxn ang="0">
                          <a:pos x="0" y="336"/>
                        </a:cxn>
                        <a:cxn ang="0">
                          <a:pos x="36" y="336"/>
                        </a:cxn>
                        <a:cxn ang="0">
                          <a:pos x="36" y="342"/>
                        </a:cxn>
                        <a:cxn ang="0">
                          <a:pos x="0" y="342"/>
                        </a:cxn>
                        <a:cxn ang="0">
                          <a:pos x="0" y="336"/>
                        </a:cxn>
                        <a:cxn ang="0">
                          <a:pos x="0" y="0"/>
                        </a:cxn>
                        <a:cxn ang="0">
                          <a:pos x="36" y="0"/>
                        </a:cxn>
                        <a:cxn ang="0">
                          <a:pos x="36" y="6"/>
                        </a:cxn>
                        <a:cxn ang="0">
                          <a:pos x="0" y="6"/>
                        </a:cxn>
                        <a:cxn ang="0">
                          <a:pos x="0" y="0"/>
                        </a:cxn>
                      </a:cxnLst>
                      <a:rect l="0" t="0" r="r" b="b"/>
                      <a:pathLst>
                        <a:path w="36" h="342">
                          <a:moveTo>
                            <a:pt x="15" y="339"/>
                          </a:moveTo>
                          <a:lnTo>
                            <a:pt x="15" y="171"/>
                          </a:lnTo>
                          <a:lnTo>
                            <a:pt x="15" y="3"/>
                          </a:lnTo>
                          <a:lnTo>
                            <a:pt x="21" y="3"/>
                          </a:lnTo>
                          <a:lnTo>
                            <a:pt x="21" y="171"/>
                          </a:lnTo>
                          <a:lnTo>
                            <a:pt x="21" y="339"/>
                          </a:lnTo>
                          <a:lnTo>
                            <a:pt x="15" y="339"/>
                          </a:lnTo>
                          <a:close/>
                          <a:moveTo>
                            <a:pt x="0" y="336"/>
                          </a:moveTo>
                          <a:lnTo>
                            <a:pt x="36" y="336"/>
                          </a:lnTo>
                          <a:lnTo>
                            <a:pt x="36" y="342"/>
                          </a:lnTo>
                          <a:lnTo>
                            <a:pt x="0" y="342"/>
                          </a:lnTo>
                          <a:lnTo>
                            <a:pt x="0" y="336"/>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741" name="Freeform 173">
                      <a:extLst>
                        <a:ext uri="{FF2B5EF4-FFF2-40B4-BE49-F238E27FC236}">
                          <a16:creationId xmlns:a16="http://schemas.microsoft.com/office/drawing/2014/main" id="{C5445937-19B7-4F52-9A3A-7126EA12BCEF}"/>
                        </a:ext>
                      </a:extLst>
                    </p:cNvPr>
                    <p:cNvSpPr>
                      <a:spLocks noEditPoints="1"/>
                    </p:cNvSpPr>
                    <p:nvPr/>
                  </p:nvSpPr>
                  <p:spPr bwMode="auto">
                    <a:xfrm>
                      <a:off x="3453955" y="4836207"/>
                      <a:ext cx="54688" cy="10333"/>
                    </a:xfrm>
                    <a:custGeom>
                      <a:avLst/>
                      <a:gdLst/>
                      <a:ahLst/>
                      <a:cxnLst>
                        <a:cxn ang="0">
                          <a:pos x="18" y="12"/>
                        </a:cxn>
                        <a:cxn ang="0">
                          <a:pos x="18" y="6"/>
                        </a:cxn>
                        <a:cxn ang="0">
                          <a:pos x="18" y="0"/>
                        </a:cxn>
                        <a:cxn ang="0">
                          <a:pos x="18" y="12"/>
                        </a:cxn>
                        <a:cxn ang="0">
                          <a:pos x="0" y="12"/>
                        </a:cxn>
                        <a:cxn ang="0">
                          <a:pos x="36" y="12"/>
                        </a:cxn>
                        <a:cxn ang="0">
                          <a:pos x="0" y="12"/>
                        </a:cxn>
                        <a:cxn ang="0">
                          <a:pos x="0" y="0"/>
                        </a:cxn>
                        <a:cxn ang="0">
                          <a:pos x="36" y="0"/>
                        </a:cxn>
                        <a:cxn ang="0">
                          <a:pos x="0" y="0"/>
                        </a:cxn>
                      </a:cxnLst>
                      <a:rect l="0" t="0" r="r" b="b"/>
                      <a:pathLst>
                        <a:path w="36" h="12">
                          <a:moveTo>
                            <a:pt x="18" y="12"/>
                          </a:moveTo>
                          <a:lnTo>
                            <a:pt x="18" y="6"/>
                          </a:lnTo>
                          <a:lnTo>
                            <a:pt x="18" y="0"/>
                          </a:lnTo>
                          <a:lnTo>
                            <a:pt x="18" y="12"/>
                          </a:lnTo>
                          <a:close/>
                          <a:moveTo>
                            <a:pt x="0" y="12"/>
                          </a:moveTo>
                          <a:lnTo>
                            <a:pt x="36" y="12"/>
                          </a:lnTo>
                          <a:lnTo>
                            <a:pt x="0" y="12"/>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742" name="Freeform 174">
                      <a:extLst>
                        <a:ext uri="{FF2B5EF4-FFF2-40B4-BE49-F238E27FC236}">
                          <a16:creationId xmlns:a16="http://schemas.microsoft.com/office/drawing/2014/main" id="{69E74B5E-E85C-44DC-B1B8-0C636A7BE969}"/>
                        </a:ext>
                      </a:extLst>
                    </p:cNvPr>
                    <p:cNvSpPr>
                      <a:spLocks noEditPoints="1"/>
                    </p:cNvSpPr>
                    <p:nvPr/>
                  </p:nvSpPr>
                  <p:spPr bwMode="auto">
                    <a:xfrm>
                      <a:off x="3450780" y="4827274"/>
                      <a:ext cx="54688" cy="15499"/>
                    </a:xfrm>
                    <a:custGeom>
                      <a:avLst/>
                      <a:gdLst/>
                      <a:ahLst/>
                      <a:cxnLst>
                        <a:cxn ang="0">
                          <a:pos x="15" y="15"/>
                        </a:cxn>
                        <a:cxn ang="0">
                          <a:pos x="15" y="9"/>
                        </a:cxn>
                        <a:cxn ang="0">
                          <a:pos x="15" y="3"/>
                        </a:cxn>
                        <a:cxn ang="0">
                          <a:pos x="21" y="3"/>
                        </a:cxn>
                        <a:cxn ang="0">
                          <a:pos x="21" y="9"/>
                        </a:cxn>
                        <a:cxn ang="0">
                          <a:pos x="21" y="15"/>
                        </a:cxn>
                        <a:cxn ang="0">
                          <a:pos x="15" y="15"/>
                        </a:cxn>
                        <a:cxn ang="0">
                          <a:pos x="0" y="12"/>
                        </a:cxn>
                        <a:cxn ang="0">
                          <a:pos x="36" y="12"/>
                        </a:cxn>
                        <a:cxn ang="0">
                          <a:pos x="36" y="18"/>
                        </a:cxn>
                        <a:cxn ang="0">
                          <a:pos x="0" y="18"/>
                        </a:cxn>
                        <a:cxn ang="0">
                          <a:pos x="0" y="12"/>
                        </a:cxn>
                        <a:cxn ang="0">
                          <a:pos x="0" y="0"/>
                        </a:cxn>
                        <a:cxn ang="0">
                          <a:pos x="36" y="0"/>
                        </a:cxn>
                        <a:cxn ang="0">
                          <a:pos x="36" y="6"/>
                        </a:cxn>
                        <a:cxn ang="0">
                          <a:pos x="0" y="6"/>
                        </a:cxn>
                        <a:cxn ang="0">
                          <a:pos x="0" y="0"/>
                        </a:cxn>
                      </a:cxnLst>
                      <a:rect l="0" t="0" r="r" b="b"/>
                      <a:pathLst>
                        <a:path w="36" h="18">
                          <a:moveTo>
                            <a:pt x="15" y="15"/>
                          </a:moveTo>
                          <a:lnTo>
                            <a:pt x="15" y="9"/>
                          </a:lnTo>
                          <a:lnTo>
                            <a:pt x="15" y="3"/>
                          </a:lnTo>
                          <a:lnTo>
                            <a:pt x="21" y="3"/>
                          </a:lnTo>
                          <a:lnTo>
                            <a:pt x="21" y="9"/>
                          </a:lnTo>
                          <a:lnTo>
                            <a:pt x="21" y="15"/>
                          </a:lnTo>
                          <a:lnTo>
                            <a:pt x="15" y="15"/>
                          </a:lnTo>
                          <a:close/>
                          <a:moveTo>
                            <a:pt x="0" y="12"/>
                          </a:moveTo>
                          <a:lnTo>
                            <a:pt x="36" y="12"/>
                          </a:lnTo>
                          <a:lnTo>
                            <a:pt x="36" y="18"/>
                          </a:lnTo>
                          <a:lnTo>
                            <a:pt x="0" y="18"/>
                          </a:lnTo>
                          <a:lnTo>
                            <a:pt x="0" y="12"/>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743" name="Freeform 175">
                      <a:extLst>
                        <a:ext uri="{FF2B5EF4-FFF2-40B4-BE49-F238E27FC236}">
                          <a16:creationId xmlns:a16="http://schemas.microsoft.com/office/drawing/2014/main" id="{C703E59B-1D9D-47E7-8B14-A9DAB90EE966}"/>
                        </a:ext>
                      </a:extLst>
                    </p:cNvPr>
                    <p:cNvSpPr>
                      <a:spLocks noEditPoints="1"/>
                    </p:cNvSpPr>
                    <p:nvPr/>
                  </p:nvSpPr>
                  <p:spPr bwMode="auto">
                    <a:xfrm>
                      <a:off x="3652877" y="3895931"/>
                      <a:ext cx="54688" cy="356478"/>
                    </a:xfrm>
                    <a:custGeom>
                      <a:avLst/>
                      <a:gdLst/>
                      <a:ahLst/>
                      <a:cxnLst>
                        <a:cxn ang="0">
                          <a:pos x="18" y="414"/>
                        </a:cxn>
                        <a:cxn ang="0">
                          <a:pos x="18" y="207"/>
                        </a:cxn>
                        <a:cxn ang="0">
                          <a:pos x="18" y="0"/>
                        </a:cxn>
                        <a:cxn ang="0">
                          <a:pos x="18" y="414"/>
                        </a:cxn>
                        <a:cxn ang="0">
                          <a:pos x="0" y="414"/>
                        </a:cxn>
                        <a:cxn ang="0">
                          <a:pos x="36" y="414"/>
                        </a:cxn>
                        <a:cxn ang="0">
                          <a:pos x="0" y="414"/>
                        </a:cxn>
                        <a:cxn ang="0">
                          <a:pos x="0" y="0"/>
                        </a:cxn>
                        <a:cxn ang="0">
                          <a:pos x="36" y="0"/>
                        </a:cxn>
                        <a:cxn ang="0">
                          <a:pos x="0" y="0"/>
                        </a:cxn>
                      </a:cxnLst>
                      <a:rect l="0" t="0" r="r" b="b"/>
                      <a:pathLst>
                        <a:path w="36" h="414">
                          <a:moveTo>
                            <a:pt x="18" y="414"/>
                          </a:moveTo>
                          <a:lnTo>
                            <a:pt x="18" y="207"/>
                          </a:lnTo>
                          <a:lnTo>
                            <a:pt x="18" y="0"/>
                          </a:lnTo>
                          <a:lnTo>
                            <a:pt x="18" y="414"/>
                          </a:lnTo>
                          <a:close/>
                          <a:moveTo>
                            <a:pt x="0" y="414"/>
                          </a:moveTo>
                          <a:lnTo>
                            <a:pt x="36" y="414"/>
                          </a:lnTo>
                          <a:lnTo>
                            <a:pt x="0" y="414"/>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744" name="Freeform 176">
                      <a:extLst>
                        <a:ext uri="{FF2B5EF4-FFF2-40B4-BE49-F238E27FC236}">
                          <a16:creationId xmlns:a16="http://schemas.microsoft.com/office/drawing/2014/main" id="{445B637F-F768-461E-9DCE-E681737DA13B}"/>
                        </a:ext>
                      </a:extLst>
                    </p:cNvPr>
                    <p:cNvSpPr>
                      <a:spLocks noEditPoints="1"/>
                    </p:cNvSpPr>
                    <p:nvPr/>
                  </p:nvSpPr>
                  <p:spPr bwMode="auto">
                    <a:xfrm>
                      <a:off x="3643352" y="3893348"/>
                      <a:ext cx="54688" cy="361645"/>
                    </a:xfrm>
                    <a:custGeom>
                      <a:avLst/>
                      <a:gdLst/>
                      <a:ahLst/>
                      <a:cxnLst>
                        <a:cxn ang="0">
                          <a:pos x="15" y="417"/>
                        </a:cxn>
                        <a:cxn ang="0">
                          <a:pos x="15" y="210"/>
                        </a:cxn>
                        <a:cxn ang="0">
                          <a:pos x="15" y="3"/>
                        </a:cxn>
                        <a:cxn ang="0">
                          <a:pos x="21" y="3"/>
                        </a:cxn>
                        <a:cxn ang="0">
                          <a:pos x="21" y="210"/>
                        </a:cxn>
                        <a:cxn ang="0">
                          <a:pos x="21" y="417"/>
                        </a:cxn>
                        <a:cxn ang="0">
                          <a:pos x="15" y="417"/>
                        </a:cxn>
                        <a:cxn ang="0">
                          <a:pos x="0" y="414"/>
                        </a:cxn>
                        <a:cxn ang="0">
                          <a:pos x="36" y="414"/>
                        </a:cxn>
                        <a:cxn ang="0">
                          <a:pos x="36" y="420"/>
                        </a:cxn>
                        <a:cxn ang="0">
                          <a:pos x="0" y="420"/>
                        </a:cxn>
                        <a:cxn ang="0">
                          <a:pos x="0" y="414"/>
                        </a:cxn>
                        <a:cxn ang="0">
                          <a:pos x="0" y="0"/>
                        </a:cxn>
                        <a:cxn ang="0">
                          <a:pos x="36" y="0"/>
                        </a:cxn>
                        <a:cxn ang="0">
                          <a:pos x="36" y="6"/>
                        </a:cxn>
                        <a:cxn ang="0">
                          <a:pos x="0" y="6"/>
                        </a:cxn>
                        <a:cxn ang="0">
                          <a:pos x="0" y="0"/>
                        </a:cxn>
                      </a:cxnLst>
                      <a:rect l="0" t="0" r="r" b="b"/>
                      <a:pathLst>
                        <a:path w="36" h="420">
                          <a:moveTo>
                            <a:pt x="15" y="417"/>
                          </a:moveTo>
                          <a:lnTo>
                            <a:pt x="15" y="210"/>
                          </a:lnTo>
                          <a:lnTo>
                            <a:pt x="15" y="3"/>
                          </a:lnTo>
                          <a:lnTo>
                            <a:pt x="21" y="3"/>
                          </a:lnTo>
                          <a:lnTo>
                            <a:pt x="21" y="210"/>
                          </a:lnTo>
                          <a:lnTo>
                            <a:pt x="21" y="417"/>
                          </a:lnTo>
                          <a:lnTo>
                            <a:pt x="15" y="417"/>
                          </a:lnTo>
                          <a:close/>
                          <a:moveTo>
                            <a:pt x="0" y="414"/>
                          </a:moveTo>
                          <a:lnTo>
                            <a:pt x="36" y="414"/>
                          </a:lnTo>
                          <a:lnTo>
                            <a:pt x="36" y="420"/>
                          </a:lnTo>
                          <a:lnTo>
                            <a:pt x="0" y="420"/>
                          </a:lnTo>
                          <a:lnTo>
                            <a:pt x="0" y="414"/>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745" name="Freeform 177">
                      <a:extLst>
                        <a:ext uri="{FF2B5EF4-FFF2-40B4-BE49-F238E27FC236}">
                          <a16:creationId xmlns:a16="http://schemas.microsoft.com/office/drawing/2014/main" id="{DCA54C6F-26C7-49E5-8D96-2E79C0D04D94}"/>
                        </a:ext>
                      </a:extLst>
                    </p:cNvPr>
                    <p:cNvSpPr>
                      <a:spLocks noEditPoints="1"/>
                    </p:cNvSpPr>
                    <p:nvPr/>
                  </p:nvSpPr>
                  <p:spPr bwMode="auto">
                    <a:xfrm>
                      <a:off x="3835542" y="4738046"/>
                      <a:ext cx="54688" cy="46497"/>
                    </a:xfrm>
                    <a:custGeom>
                      <a:avLst/>
                      <a:gdLst/>
                      <a:ahLst/>
                      <a:cxnLst>
                        <a:cxn ang="0">
                          <a:pos x="18" y="54"/>
                        </a:cxn>
                        <a:cxn ang="0">
                          <a:pos x="18" y="27"/>
                        </a:cxn>
                        <a:cxn ang="0">
                          <a:pos x="18" y="0"/>
                        </a:cxn>
                        <a:cxn ang="0">
                          <a:pos x="18" y="54"/>
                        </a:cxn>
                        <a:cxn ang="0">
                          <a:pos x="0" y="54"/>
                        </a:cxn>
                        <a:cxn ang="0">
                          <a:pos x="36" y="54"/>
                        </a:cxn>
                        <a:cxn ang="0">
                          <a:pos x="0" y="54"/>
                        </a:cxn>
                        <a:cxn ang="0">
                          <a:pos x="0" y="0"/>
                        </a:cxn>
                        <a:cxn ang="0">
                          <a:pos x="36" y="0"/>
                        </a:cxn>
                        <a:cxn ang="0">
                          <a:pos x="0" y="0"/>
                        </a:cxn>
                      </a:cxnLst>
                      <a:rect l="0" t="0" r="r" b="b"/>
                      <a:pathLst>
                        <a:path w="36" h="54">
                          <a:moveTo>
                            <a:pt x="18" y="54"/>
                          </a:moveTo>
                          <a:lnTo>
                            <a:pt x="18" y="27"/>
                          </a:lnTo>
                          <a:lnTo>
                            <a:pt x="18" y="0"/>
                          </a:lnTo>
                          <a:lnTo>
                            <a:pt x="18" y="54"/>
                          </a:lnTo>
                          <a:close/>
                          <a:moveTo>
                            <a:pt x="0" y="54"/>
                          </a:moveTo>
                          <a:lnTo>
                            <a:pt x="36" y="54"/>
                          </a:lnTo>
                          <a:lnTo>
                            <a:pt x="0" y="54"/>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IN"/>
                    </a:p>
                  </p:txBody>
                </p:sp>
                <p:sp>
                  <p:nvSpPr>
                    <p:cNvPr id="746" name="Freeform 178">
                      <a:extLst>
                        <a:ext uri="{FF2B5EF4-FFF2-40B4-BE49-F238E27FC236}">
                          <a16:creationId xmlns:a16="http://schemas.microsoft.com/office/drawing/2014/main" id="{97640F31-17CD-466E-B005-4AE5999B8A78}"/>
                        </a:ext>
                      </a:extLst>
                    </p:cNvPr>
                    <p:cNvSpPr>
                      <a:spLocks noEditPoints="1"/>
                    </p:cNvSpPr>
                    <p:nvPr/>
                  </p:nvSpPr>
                  <p:spPr bwMode="auto">
                    <a:xfrm>
                      <a:off x="3835542" y="4735464"/>
                      <a:ext cx="54688" cy="51664"/>
                    </a:xfrm>
                    <a:custGeom>
                      <a:avLst/>
                      <a:gdLst/>
                      <a:ahLst/>
                      <a:cxnLst>
                        <a:cxn ang="0">
                          <a:pos x="15" y="57"/>
                        </a:cxn>
                        <a:cxn ang="0">
                          <a:pos x="15" y="30"/>
                        </a:cxn>
                        <a:cxn ang="0">
                          <a:pos x="15" y="3"/>
                        </a:cxn>
                        <a:cxn ang="0">
                          <a:pos x="21" y="3"/>
                        </a:cxn>
                        <a:cxn ang="0">
                          <a:pos x="21" y="30"/>
                        </a:cxn>
                        <a:cxn ang="0">
                          <a:pos x="21" y="57"/>
                        </a:cxn>
                        <a:cxn ang="0">
                          <a:pos x="15" y="57"/>
                        </a:cxn>
                        <a:cxn ang="0">
                          <a:pos x="0" y="54"/>
                        </a:cxn>
                        <a:cxn ang="0">
                          <a:pos x="36" y="54"/>
                        </a:cxn>
                        <a:cxn ang="0">
                          <a:pos x="36" y="60"/>
                        </a:cxn>
                        <a:cxn ang="0">
                          <a:pos x="0" y="60"/>
                        </a:cxn>
                        <a:cxn ang="0">
                          <a:pos x="0" y="54"/>
                        </a:cxn>
                        <a:cxn ang="0">
                          <a:pos x="0" y="0"/>
                        </a:cxn>
                        <a:cxn ang="0">
                          <a:pos x="36" y="0"/>
                        </a:cxn>
                        <a:cxn ang="0">
                          <a:pos x="36" y="6"/>
                        </a:cxn>
                        <a:cxn ang="0">
                          <a:pos x="0" y="6"/>
                        </a:cxn>
                        <a:cxn ang="0">
                          <a:pos x="0" y="0"/>
                        </a:cxn>
                      </a:cxnLst>
                      <a:rect l="0" t="0" r="r" b="b"/>
                      <a:pathLst>
                        <a:path w="36" h="60">
                          <a:moveTo>
                            <a:pt x="15" y="57"/>
                          </a:moveTo>
                          <a:lnTo>
                            <a:pt x="15" y="30"/>
                          </a:lnTo>
                          <a:lnTo>
                            <a:pt x="15" y="3"/>
                          </a:lnTo>
                          <a:lnTo>
                            <a:pt x="21" y="3"/>
                          </a:lnTo>
                          <a:lnTo>
                            <a:pt x="21" y="30"/>
                          </a:lnTo>
                          <a:lnTo>
                            <a:pt x="21" y="57"/>
                          </a:lnTo>
                          <a:lnTo>
                            <a:pt x="15" y="57"/>
                          </a:lnTo>
                          <a:close/>
                          <a:moveTo>
                            <a:pt x="0" y="54"/>
                          </a:moveTo>
                          <a:lnTo>
                            <a:pt x="36" y="54"/>
                          </a:lnTo>
                          <a:lnTo>
                            <a:pt x="36" y="60"/>
                          </a:lnTo>
                          <a:lnTo>
                            <a:pt x="0" y="60"/>
                          </a:lnTo>
                          <a:lnTo>
                            <a:pt x="0" y="54"/>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IN"/>
                    </a:p>
                  </p:txBody>
                </p:sp>
                <p:sp>
                  <p:nvSpPr>
                    <p:cNvPr id="747" name="Rectangle 203">
                      <a:extLst>
                        <a:ext uri="{FF2B5EF4-FFF2-40B4-BE49-F238E27FC236}">
                          <a16:creationId xmlns:a16="http://schemas.microsoft.com/office/drawing/2014/main" id="{6932E3E5-ADA5-4AF4-8895-6D3D401586BF}"/>
                        </a:ext>
                      </a:extLst>
                    </p:cNvPr>
                    <p:cNvSpPr>
                      <a:spLocks noChangeArrowheads="1"/>
                    </p:cNvSpPr>
                    <p:nvPr/>
                  </p:nvSpPr>
                  <p:spPr bwMode="auto">
                    <a:xfrm>
                      <a:off x="2479050" y="4711365"/>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000">
                          <a:solidFill>
                            <a:srgbClr val="000000"/>
                          </a:solidFill>
                          <a:latin typeface="Calibri "/>
                          <a:cs typeface="Arial" pitchFamily="34" charset="0"/>
                        </a:rPr>
                        <a:t>d</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748" name="Rectangle 204">
                      <a:extLst>
                        <a:ext uri="{FF2B5EF4-FFF2-40B4-BE49-F238E27FC236}">
                          <a16:creationId xmlns:a16="http://schemas.microsoft.com/office/drawing/2014/main" id="{3A4B2C0D-11DB-4000-B241-B5906BC76E08}"/>
                        </a:ext>
                      </a:extLst>
                    </p:cNvPr>
                    <p:cNvSpPr>
                      <a:spLocks noChangeArrowheads="1"/>
                    </p:cNvSpPr>
                    <p:nvPr/>
                  </p:nvSpPr>
                  <p:spPr bwMode="auto">
                    <a:xfrm>
                      <a:off x="2634664" y="4635165"/>
                      <a:ext cx="13465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000">
                          <a:solidFill>
                            <a:srgbClr val="000000"/>
                          </a:solidFill>
                          <a:latin typeface="Calibri "/>
                          <a:cs typeface="Arial" pitchFamily="34" charset="0"/>
                        </a:rPr>
                        <a:t>cd</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754" name="Rectangle 205">
                      <a:extLst>
                        <a:ext uri="{FF2B5EF4-FFF2-40B4-BE49-F238E27FC236}">
                          <a16:creationId xmlns:a16="http://schemas.microsoft.com/office/drawing/2014/main" id="{0928D6A9-8892-4E72-8D93-3C21097C4E19}"/>
                        </a:ext>
                      </a:extLst>
                    </p:cNvPr>
                    <p:cNvSpPr>
                      <a:spLocks noChangeArrowheads="1"/>
                    </p:cNvSpPr>
                    <p:nvPr/>
                  </p:nvSpPr>
                  <p:spPr bwMode="auto">
                    <a:xfrm>
                      <a:off x="2800553" y="4647865"/>
                      <a:ext cx="13465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bc</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755" name="Rectangle 206">
                      <a:extLst>
                        <a:ext uri="{FF2B5EF4-FFF2-40B4-BE49-F238E27FC236}">
                          <a16:creationId xmlns:a16="http://schemas.microsoft.com/office/drawing/2014/main" id="{5E246370-2EEA-400E-9EC1-58FD30EDB94E}"/>
                        </a:ext>
                      </a:extLst>
                    </p:cNvPr>
                    <p:cNvSpPr>
                      <a:spLocks noChangeArrowheads="1"/>
                    </p:cNvSpPr>
                    <p:nvPr/>
                  </p:nvSpPr>
                  <p:spPr bwMode="auto">
                    <a:xfrm>
                      <a:off x="3012354" y="4558965"/>
                      <a:ext cx="13465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bc</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756" name="Rectangle 208">
                      <a:extLst>
                        <a:ext uri="{FF2B5EF4-FFF2-40B4-BE49-F238E27FC236}">
                          <a16:creationId xmlns:a16="http://schemas.microsoft.com/office/drawing/2014/main" id="{A612D652-1C60-4D23-99C6-15E6BD8BCCB5}"/>
                        </a:ext>
                      </a:extLst>
                    </p:cNvPr>
                    <p:cNvSpPr>
                      <a:spLocks noChangeArrowheads="1"/>
                    </p:cNvSpPr>
                    <p:nvPr/>
                  </p:nvSpPr>
                  <p:spPr bwMode="auto">
                    <a:xfrm>
                      <a:off x="3419993" y="4648943"/>
                      <a:ext cx="13465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000">
                          <a:solidFill>
                            <a:srgbClr val="000000"/>
                          </a:solidFill>
                          <a:latin typeface="Calibri "/>
                          <a:cs typeface="Arial" pitchFamily="34" charset="0"/>
                        </a:rPr>
                        <a:t>cd</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757" name="Rectangle 210">
                      <a:extLst>
                        <a:ext uri="{FF2B5EF4-FFF2-40B4-BE49-F238E27FC236}">
                          <a16:creationId xmlns:a16="http://schemas.microsoft.com/office/drawing/2014/main" id="{8819A096-C25B-4FEA-AB01-79989B6B5958}"/>
                        </a:ext>
                      </a:extLst>
                    </p:cNvPr>
                    <p:cNvSpPr>
                      <a:spLocks noChangeArrowheads="1"/>
                    </p:cNvSpPr>
                    <p:nvPr/>
                  </p:nvSpPr>
                  <p:spPr bwMode="auto">
                    <a:xfrm>
                      <a:off x="3825571" y="4533565"/>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b</a:t>
                      </a:r>
                      <a:endParaRPr kumimoji="0" lang="en-US" sz="1000" b="0" i="0" u="none" strike="noStrike" cap="none" normalizeH="0" baseline="0">
                        <a:ln>
                          <a:noFill/>
                        </a:ln>
                        <a:solidFill>
                          <a:schemeClr val="tx1"/>
                        </a:solidFill>
                        <a:effectLst/>
                        <a:latin typeface="Calibri "/>
                        <a:cs typeface="Arial" pitchFamily="34" charset="0"/>
                      </a:endParaRPr>
                    </a:p>
                  </p:txBody>
                </p:sp>
              </p:grpSp>
              <p:sp>
                <p:nvSpPr>
                  <p:cNvPr id="704" name="Rectangle 209">
                    <a:extLst>
                      <a:ext uri="{FF2B5EF4-FFF2-40B4-BE49-F238E27FC236}">
                        <a16:creationId xmlns:a16="http://schemas.microsoft.com/office/drawing/2014/main" id="{C61F3B77-98E9-42DE-83DF-3A0E572002FE}"/>
                      </a:ext>
                    </a:extLst>
                  </p:cNvPr>
                  <p:cNvSpPr>
                    <a:spLocks noChangeArrowheads="1"/>
                  </p:cNvSpPr>
                  <p:nvPr/>
                </p:nvSpPr>
                <p:spPr bwMode="auto">
                  <a:xfrm>
                    <a:off x="4261268" y="1752600"/>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a</a:t>
                    </a:r>
                    <a:endParaRPr kumimoji="0" lang="en-US" sz="1000" b="0" i="0" u="none" strike="noStrike" cap="none" normalizeH="0" baseline="0">
                      <a:ln>
                        <a:noFill/>
                      </a:ln>
                      <a:solidFill>
                        <a:schemeClr val="tx1"/>
                      </a:solidFill>
                      <a:effectLst/>
                      <a:latin typeface="Calibri "/>
                      <a:cs typeface="Arial" pitchFamily="34" charset="0"/>
                    </a:endParaRPr>
                  </a:p>
                </p:txBody>
              </p:sp>
              <p:sp>
                <p:nvSpPr>
                  <p:cNvPr id="705" name="Rectangle 209">
                    <a:extLst>
                      <a:ext uri="{FF2B5EF4-FFF2-40B4-BE49-F238E27FC236}">
                        <a16:creationId xmlns:a16="http://schemas.microsoft.com/office/drawing/2014/main" id="{F5F572E3-D5A4-400D-9794-DFE8387E5775}"/>
                      </a:ext>
                    </a:extLst>
                  </p:cNvPr>
                  <p:cNvSpPr>
                    <a:spLocks noChangeArrowheads="1"/>
                  </p:cNvSpPr>
                  <p:nvPr/>
                </p:nvSpPr>
                <p:spPr bwMode="auto">
                  <a:xfrm>
                    <a:off x="4642280" y="1797384"/>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Calibri "/>
                        <a:cs typeface="Arial" pitchFamily="34" charset="0"/>
                      </a:rPr>
                      <a:t>a</a:t>
                    </a:r>
                    <a:endParaRPr kumimoji="0" lang="en-US" sz="1000" b="0" i="0" u="none" strike="noStrike" cap="none" normalizeH="0" baseline="0">
                      <a:ln>
                        <a:noFill/>
                      </a:ln>
                      <a:solidFill>
                        <a:schemeClr val="tx1"/>
                      </a:solidFill>
                      <a:effectLst/>
                      <a:latin typeface="Calibri "/>
                      <a:cs typeface="Arial" pitchFamily="34" charset="0"/>
                    </a:endParaRPr>
                  </a:p>
                </p:txBody>
              </p:sp>
            </p:grpSp>
          </p:grpSp>
        </p:grpSp>
        <p:sp>
          <p:nvSpPr>
            <p:cNvPr id="335" name="TextBox 334">
              <a:extLst>
                <a:ext uri="{FF2B5EF4-FFF2-40B4-BE49-F238E27FC236}">
                  <a16:creationId xmlns:a16="http://schemas.microsoft.com/office/drawing/2014/main" id="{A5CA1251-033C-4760-BA3A-DA46C7AB85AF}"/>
                </a:ext>
              </a:extLst>
            </p:cNvPr>
            <p:cNvSpPr txBox="1"/>
            <p:nvPr/>
          </p:nvSpPr>
          <p:spPr>
            <a:xfrm>
              <a:off x="1678497" y="4571862"/>
              <a:ext cx="3129983" cy="276999"/>
            </a:xfrm>
            <a:prstGeom prst="rect">
              <a:avLst/>
            </a:prstGeom>
            <a:noFill/>
          </p:spPr>
          <p:txBody>
            <a:bodyPr wrap="square" rtlCol="0">
              <a:spAutoFit/>
            </a:bodyPr>
            <a:lstStyle/>
            <a:p>
              <a:pPr algn="ctr"/>
              <a:r>
                <a:rPr lang="en-IN" sz="1200" dirty="0">
                  <a:latin typeface="Calibri "/>
                </a:rPr>
                <a:t>n = 6 (3 independent experiments), p&lt;0.05</a:t>
              </a:r>
            </a:p>
          </p:txBody>
        </p:sp>
      </p:grpSp>
      <p:sp>
        <p:nvSpPr>
          <p:cNvPr id="320" name="TextBox 319">
            <a:extLst>
              <a:ext uri="{FF2B5EF4-FFF2-40B4-BE49-F238E27FC236}">
                <a16:creationId xmlns:a16="http://schemas.microsoft.com/office/drawing/2014/main" id="{9998EE37-B268-47C6-A768-7894B3C0E8C8}"/>
              </a:ext>
            </a:extLst>
          </p:cNvPr>
          <p:cNvSpPr txBox="1"/>
          <p:nvPr/>
        </p:nvSpPr>
        <p:spPr>
          <a:xfrm>
            <a:off x="4238103" y="359921"/>
            <a:ext cx="466560" cy="307777"/>
          </a:xfrm>
          <a:prstGeom prst="rect">
            <a:avLst/>
          </a:prstGeom>
          <a:noFill/>
        </p:spPr>
        <p:txBody>
          <a:bodyPr wrap="square" rtlCol="0">
            <a:spAutoFit/>
          </a:bodyPr>
          <a:lstStyle/>
          <a:p>
            <a:pPr algn="ctr"/>
            <a:r>
              <a:rPr lang="en-IN" sz="1400" b="1" dirty="0">
                <a:latin typeface=" Calibri "/>
              </a:rPr>
              <a:t>(B)</a:t>
            </a:r>
          </a:p>
        </p:txBody>
      </p:sp>
      <p:sp>
        <p:nvSpPr>
          <p:cNvPr id="321" name="TextBox 320">
            <a:extLst>
              <a:ext uri="{FF2B5EF4-FFF2-40B4-BE49-F238E27FC236}">
                <a16:creationId xmlns:a16="http://schemas.microsoft.com/office/drawing/2014/main" id="{D7805A35-D426-4431-8A69-C4772F2B58F6}"/>
              </a:ext>
            </a:extLst>
          </p:cNvPr>
          <p:cNvSpPr txBox="1"/>
          <p:nvPr/>
        </p:nvSpPr>
        <p:spPr>
          <a:xfrm>
            <a:off x="579678" y="394631"/>
            <a:ext cx="466560" cy="307777"/>
          </a:xfrm>
          <a:prstGeom prst="rect">
            <a:avLst/>
          </a:prstGeom>
          <a:noFill/>
        </p:spPr>
        <p:txBody>
          <a:bodyPr wrap="square" rtlCol="0">
            <a:spAutoFit/>
          </a:bodyPr>
          <a:lstStyle/>
          <a:p>
            <a:pPr algn="ctr"/>
            <a:r>
              <a:rPr lang="en-IN" sz="1400" b="1" dirty="0">
                <a:latin typeface=" Calibri "/>
              </a:rPr>
              <a:t>(A)</a:t>
            </a:r>
          </a:p>
        </p:txBody>
      </p:sp>
      <p:grpSp>
        <p:nvGrpSpPr>
          <p:cNvPr id="11" name="Group 10">
            <a:extLst>
              <a:ext uri="{FF2B5EF4-FFF2-40B4-BE49-F238E27FC236}">
                <a16:creationId xmlns:a16="http://schemas.microsoft.com/office/drawing/2014/main" id="{FC8A20FC-E6B1-4C15-9097-2AB9459561E6}"/>
              </a:ext>
            </a:extLst>
          </p:cNvPr>
          <p:cNvGrpSpPr/>
          <p:nvPr/>
        </p:nvGrpSpPr>
        <p:grpSpPr>
          <a:xfrm>
            <a:off x="678367" y="977430"/>
            <a:ext cx="3261097" cy="3594067"/>
            <a:chOff x="678367" y="977430"/>
            <a:chExt cx="3261097" cy="3594067"/>
          </a:xfrm>
        </p:grpSpPr>
        <p:grpSp>
          <p:nvGrpSpPr>
            <p:cNvPr id="10" name="Group 9">
              <a:extLst>
                <a:ext uri="{FF2B5EF4-FFF2-40B4-BE49-F238E27FC236}">
                  <a16:creationId xmlns:a16="http://schemas.microsoft.com/office/drawing/2014/main" id="{24901B3A-A639-4077-96B6-0BAE79489A94}"/>
                </a:ext>
              </a:extLst>
            </p:cNvPr>
            <p:cNvGrpSpPr/>
            <p:nvPr/>
          </p:nvGrpSpPr>
          <p:grpSpPr>
            <a:xfrm>
              <a:off x="809481" y="1197426"/>
              <a:ext cx="3129983" cy="3374071"/>
              <a:chOff x="305392" y="1197426"/>
              <a:chExt cx="3129983" cy="3374071"/>
            </a:xfrm>
          </p:grpSpPr>
          <p:grpSp>
            <p:nvGrpSpPr>
              <p:cNvPr id="2" name="Group 1">
                <a:extLst>
                  <a:ext uri="{FF2B5EF4-FFF2-40B4-BE49-F238E27FC236}">
                    <a16:creationId xmlns:a16="http://schemas.microsoft.com/office/drawing/2014/main" id="{03F665BC-36B0-4F15-BBC6-9A33B14644EE}"/>
                  </a:ext>
                </a:extLst>
              </p:cNvPr>
              <p:cNvGrpSpPr/>
              <p:nvPr/>
            </p:nvGrpSpPr>
            <p:grpSpPr>
              <a:xfrm>
                <a:off x="563160" y="1197426"/>
                <a:ext cx="2440364" cy="2982403"/>
                <a:chOff x="5734050" y="1255727"/>
                <a:chExt cx="2440364" cy="2982403"/>
              </a:xfrm>
            </p:grpSpPr>
            <p:grpSp>
              <p:nvGrpSpPr>
                <p:cNvPr id="272" name="Group 271">
                  <a:extLst>
                    <a:ext uri="{FF2B5EF4-FFF2-40B4-BE49-F238E27FC236}">
                      <a16:creationId xmlns:a16="http://schemas.microsoft.com/office/drawing/2014/main" id="{475B80A0-9EF9-4970-8680-51923DE1967D}"/>
                    </a:ext>
                  </a:extLst>
                </p:cNvPr>
                <p:cNvGrpSpPr/>
                <p:nvPr/>
              </p:nvGrpSpPr>
              <p:grpSpPr>
                <a:xfrm>
                  <a:off x="6512010" y="1255727"/>
                  <a:ext cx="875385" cy="718316"/>
                  <a:chOff x="2958353" y="1329109"/>
                  <a:chExt cx="875385" cy="718316"/>
                </a:xfrm>
              </p:grpSpPr>
              <p:sp>
                <p:nvSpPr>
                  <p:cNvPr id="273" name="Rectangle 272">
                    <a:extLst>
                      <a:ext uri="{FF2B5EF4-FFF2-40B4-BE49-F238E27FC236}">
                        <a16:creationId xmlns:a16="http://schemas.microsoft.com/office/drawing/2014/main" id="{D71AD09F-B64E-4FDC-B161-5AC618B7090C}"/>
                      </a:ext>
                    </a:extLst>
                  </p:cNvPr>
                  <p:cNvSpPr>
                    <a:spLocks noChangeArrowheads="1"/>
                  </p:cNvSpPr>
                  <p:nvPr/>
                </p:nvSpPr>
                <p:spPr bwMode="auto">
                  <a:xfrm>
                    <a:off x="2958353" y="1436679"/>
                    <a:ext cx="208044" cy="610746"/>
                  </a:xfrm>
                  <a:prstGeom prst="rect">
                    <a:avLst/>
                  </a:prstGeom>
                  <a:solidFill>
                    <a:srgbClr val="F2DCD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274" name="Rectangle 273">
                    <a:extLst>
                      <a:ext uri="{FF2B5EF4-FFF2-40B4-BE49-F238E27FC236}">
                        <a16:creationId xmlns:a16="http://schemas.microsoft.com/office/drawing/2014/main" id="{E85DA654-DAC0-4F93-B25E-DB58C01A0F86}"/>
                      </a:ext>
                    </a:extLst>
                  </p:cNvPr>
                  <p:cNvSpPr>
                    <a:spLocks noChangeArrowheads="1"/>
                  </p:cNvSpPr>
                  <p:nvPr/>
                </p:nvSpPr>
                <p:spPr bwMode="auto">
                  <a:xfrm>
                    <a:off x="2988488" y="1574800"/>
                    <a:ext cx="151305" cy="471725"/>
                  </a:xfrm>
                  <a:prstGeom prst="rect">
                    <a:avLst/>
                  </a:prstGeom>
                  <a:solidFill>
                    <a:schemeClr val="accent3">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275" name="Rectangle 274">
                    <a:extLst>
                      <a:ext uri="{FF2B5EF4-FFF2-40B4-BE49-F238E27FC236}">
                        <a16:creationId xmlns:a16="http://schemas.microsoft.com/office/drawing/2014/main" id="{398FE25E-286E-42E7-A5A2-B39F29C67D07}"/>
                      </a:ext>
                    </a:extLst>
                  </p:cNvPr>
                  <p:cNvSpPr>
                    <a:spLocks noChangeArrowheads="1"/>
                  </p:cNvSpPr>
                  <p:nvPr/>
                </p:nvSpPr>
                <p:spPr bwMode="auto">
                  <a:xfrm>
                    <a:off x="3017655" y="1778000"/>
                    <a:ext cx="94566" cy="266162"/>
                  </a:xfrm>
                  <a:prstGeom prst="rect">
                    <a:avLst/>
                  </a:prstGeom>
                  <a:solidFill>
                    <a:schemeClr val="tx2">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cxnSp>
                <p:nvCxnSpPr>
                  <p:cNvPr id="276" name="Straight Connector 275">
                    <a:extLst>
                      <a:ext uri="{FF2B5EF4-FFF2-40B4-BE49-F238E27FC236}">
                        <a16:creationId xmlns:a16="http://schemas.microsoft.com/office/drawing/2014/main" id="{4FF62159-0D3E-4CFE-9A33-5627050EC1E7}"/>
                      </a:ext>
                    </a:extLst>
                  </p:cNvPr>
                  <p:cNvCxnSpPr/>
                  <p:nvPr/>
                </p:nvCxnSpPr>
                <p:spPr>
                  <a:xfrm>
                    <a:off x="3088096" y="1867683"/>
                    <a:ext cx="18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77" name="TextBox 276">
                    <a:extLst>
                      <a:ext uri="{FF2B5EF4-FFF2-40B4-BE49-F238E27FC236}">
                        <a16:creationId xmlns:a16="http://schemas.microsoft.com/office/drawing/2014/main" id="{826DA361-D41D-446D-B4FA-188F465B1E34}"/>
                      </a:ext>
                    </a:extLst>
                  </p:cNvPr>
                  <p:cNvSpPr txBox="1"/>
                  <p:nvPr/>
                </p:nvSpPr>
                <p:spPr>
                  <a:xfrm>
                    <a:off x="3153320" y="1714973"/>
                    <a:ext cx="458357" cy="276999"/>
                  </a:xfrm>
                  <a:prstGeom prst="rect">
                    <a:avLst/>
                  </a:prstGeom>
                  <a:noFill/>
                </p:spPr>
                <p:txBody>
                  <a:bodyPr wrap="square" rtlCol="0">
                    <a:spAutoFit/>
                  </a:bodyPr>
                  <a:lstStyle/>
                  <a:p>
                    <a:pPr algn="ctr"/>
                    <a:r>
                      <a:rPr lang="en-IN" sz="1200">
                        <a:latin typeface="Calibri" panose="020F0502020204030204" pitchFamily="34" charset="0"/>
                        <a:cs typeface="Calibri" panose="020F0502020204030204" pitchFamily="34" charset="0"/>
                      </a:rPr>
                      <a:t>As</a:t>
                    </a:r>
                    <a:endParaRPr lang="en-IN" sz="1200" baseline="30000">
                      <a:latin typeface="Calibri" panose="020F0502020204030204" pitchFamily="34" charset="0"/>
                      <a:cs typeface="Calibri" panose="020F0502020204030204" pitchFamily="34" charset="0"/>
                    </a:endParaRPr>
                  </a:p>
                </p:txBody>
              </p:sp>
              <p:cxnSp>
                <p:nvCxnSpPr>
                  <p:cNvPr id="278" name="Straight Connector 277">
                    <a:extLst>
                      <a:ext uri="{FF2B5EF4-FFF2-40B4-BE49-F238E27FC236}">
                        <a16:creationId xmlns:a16="http://schemas.microsoft.com/office/drawing/2014/main" id="{404E5293-79D3-43D4-A217-EB89C4BA90D7}"/>
                      </a:ext>
                    </a:extLst>
                  </p:cNvPr>
                  <p:cNvCxnSpPr/>
                  <p:nvPr/>
                </p:nvCxnSpPr>
                <p:spPr>
                  <a:xfrm>
                    <a:off x="3088481" y="1683535"/>
                    <a:ext cx="18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9" name="Straight Connector 278">
                    <a:extLst>
                      <a:ext uri="{FF2B5EF4-FFF2-40B4-BE49-F238E27FC236}">
                        <a16:creationId xmlns:a16="http://schemas.microsoft.com/office/drawing/2014/main" id="{7781288E-2E3C-4DC0-8CB2-E4751107F5F1}"/>
                      </a:ext>
                    </a:extLst>
                  </p:cNvPr>
                  <p:cNvCxnSpPr/>
                  <p:nvPr/>
                </p:nvCxnSpPr>
                <p:spPr>
                  <a:xfrm>
                    <a:off x="3088479" y="1481141"/>
                    <a:ext cx="18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80" name="TextBox 279">
                    <a:extLst>
                      <a:ext uri="{FF2B5EF4-FFF2-40B4-BE49-F238E27FC236}">
                        <a16:creationId xmlns:a16="http://schemas.microsoft.com/office/drawing/2014/main" id="{4EC808F6-D0C8-4A33-8968-F28BD0923D9F}"/>
                      </a:ext>
                    </a:extLst>
                  </p:cNvPr>
                  <p:cNvSpPr txBox="1"/>
                  <p:nvPr/>
                </p:nvSpPr>
                <p:spPr>
                  <a:xfrm>
                    <a:off x="3187454" y="1329109"/>
                    <a:ext cx="458357" cy="276999"/>
                  </a:xfrm>
                  <a:prstGeom prst="rect">
                    <a:avLst/>
                  </a:prstGeom>
                  <a:noFill/>
                </p:spPr>
                <p:txBody>
                  <a:bodyPr wrap="square" rtlCol="0">
                    <a:spAutoFit/>
                  </a:bodyPr>
                  <a:lstStyle/>
                  <a:p>
                    <a:pPr algn="ctr"/>
                    <a:r>
                      <a:rPr lang="en-IN" sz="1200">
                        <a:latin typeface="Calibri" panose="020F0502020204030204" pitchFamily="34" charset="0"/>
                        <a:cs typeface="Calibri" panose="020F0502020204030204" pitchFamily="34" charset="0"/>
                      </a:rPr>
                      <a:t>Hpx</a:t>
                    </a:r>
                    <a:endParaRPr lang="en-IN" sz="1200" baseline="30000">
                      <a:latin typeface="Calibri" panose="020F0502020204030204" pitchFamily="34" charset="0"/>
                      <a:cs typeface="Calibri" panose="020F0502020204030204" pitchFamily="34" charset="0"/>
                    </a:endParaRPr>
                  </a:p>
                </p:txBody>
              </p:sp>
              <p:sp>
                <p:nvSpPr>
                  <p:cNvPr id="281" name="TextBox 280">
                    <a:extLst>
                      <a:ext uri="{FF2B5EF4-FFF2-40B4-BE49-F238E27FC236}">
                        <a16:creationId xmlns:a16="http://schemas.microsoft.com/office/drawing/2014/main" id="{C6817E45-4E2C-4EAE-B958-CF8AB63EEB5A}"/>
                      </a:ext>
                    </a:extLst>
                  </p:cNvPr>
                  <p:cNvSpPr txBox="1"/>
                  <p:nvPr/>
                </p:nvSpPr>
                <p:spPr>
                  <a:xfrm>
                    <a:off x="3147060" y="1528941"/>
                    <a:ext cx="686678" cy="276999"/>
                  </a:xfrm>
                  <a:prstGeom prst="rect">
                    <a:avLst/>
                  </a:prstGeom>
                  <a:noFill/>
                </p:spPr>
                <p:txBody>
                  <a:bodyPr wrap="square" rtlCol="0">
                    <a:spAutoFit/>
                  </a:bodyPr>
                  <a:lstStyle/>
                  <a:p>
                    <a:pPr algn="ctr"/>
                    <a:r>
                      <a:rPr lang="en-IN" sz="1200">
                        <a:latin typeface="Calibri" panose="020F0502020204030204" pitchFamily="34" charset="0"/>
                        <a:cs typeface="Calibri" panose="020F0502020204030204" pitchFamily="34" charset="0"/>
                      </a:rPr>
                      <a:t>HpxAs</a:t>
                    </a:r>
                    <a:endParaRPr lang="en-IN" sz="1200" baseline="30000">
                      <a:latin typeface="Calibri" panose="020F0502020204030204" pitchFamily="34" charset="0"/>
                      <a:cs typeface="Calibri" panose="020F0502020204030204" pitchFamily="34" charset="0"/>
                    </a:endParaRPr>
                  </a:p>
                </p:txBody>
              </p:sp>
            </p:grpSp>
            <p:cxnSp>
              <p:nvCxnSpPr>
                <p:cNvPr id="293" name="Straight Connector 292">
                  <a:extLst>
                    <a:ext uri="{FF2B5EF4-FFF2-40B4-BE49-F238E27FC236}">
                      <a16:creationId xmlns:a16="http://schemas.microsoft.com/office/drawing/2014/main" id="{26717664-DC73-44AD-A509-77A1ABF443A6}"/>
                    </a:ext>
                  </a:extLst>
                </p:cNvPr>
                <p:cNvCxnSpPr/>
                <p:nvPr/>
              </p:nvCxnSpPr>
              <p:spPr>
                <a:xfrm>
                  <a:off x="5945911" y="3565747"/>
                  <a:ext cx="2124000" cy="0"/>
                </a:xfrm>
                <a:prstGeom prst="line">
                  <a:avLst/>
                </a:prstGeom>
                <a:ln w="3175" cmpd="sng">
                  <a:solidFill>
                    <a:srgbClr val="FF0000"/>
                  </a:solidFill>
                  <a:prstDash val="sysDash"/>
                </a:ln>
              </p:spPr>
              <p:style>
                <a:lnRef idx="1">
                  <a:schemeClr val="accent1"/>
                </a:lnRef>
                <a:fillRef idx="0">
                  <a:schemeClr val="accent1"/>
                </a:fillRef>
                <a:effectRef idx="0">
                  <a:schemeClr val="accent1"/>
                </a:effectRef>
                <a:fontRef idx="minor">
                  <a:schemeClr val="tx1"/>
                </a:fontRef>
              </p:style>
            </p:cxnSp>
            <p:sp>
              <p:nvSpPr>
                <p:cNvPr id="296" name="Rectangle 295">
                  <a:extLst>
                    <a:ext uri="{FF2B5EF4-FFF2-40B4-BE49-F238E27FC236}">
                      <a16:creationId xmlns:a16="http://schemas.microsoft.com/office/drawing/2014/main" id="{B687F8AD-0967-4D41-8899-D9271C2A806A}"/>
                    </a:ext>
                  </a:extLst>
                </p:cNvPr>
                <p:cNvSpPr>
                  <a:spLocks noChangeArrowheads="1"/>
                </p:cNvSpPr>
                <p:nvPr/>
              </p:nvSpPr>
              <p:spPr bwMode="auto">
                <a:xfrm>
                  <a:off x="6128401" y="2288903"/>
                  <a:ext cx="143648" cy="1317600"/>
                </a:xfrm>
                <a:prstGeom prst="rect">
                  <a:avLst/>
                </a:prstGeom>
                <a:solidFill>
                  <a:srgbClr val="F2DCD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299" name="Rectangle 298">
                  <a:extLst>
                    <a:ext uri="{FF2B5EF4-FFF2-40B4-BE49-F238E27FC236}">
                      <a16:creationId xmlns:a16="http://schemas.microsoft.com/office/drawing/2014/main" id="{676A35F6-0D95-4346-BD18-B74828258556}"/>
                    </a:ext>
                  </a:extLst>
                </p:cNvPr>
                <p:cNvSpPr>
                  <a:spLocks noChangeArrowheads="1"/>
                </p:cNvSpPr>
                <p:nvPr/>
              </p:nvSpPr>
              <p:spPr bwMode="auto">
                <a:xfrm>
                  <a:off x="6437378" y="3016103"/>
                  <a:ext cx="143648" cy="590400"/>
                </a:xfrm>
                <a:prstGeom prst="rect">
                  <a:avLst/>
                </a:prstGeom>
                <a:solidFill>
                  <a:srgbClr val="F2DCD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00" name="Rectangle 299">
                  <a:extLst>
                    <a:ext uri="{FF2B5EF4-FFF2-40B4-BE49-F238E27FC236}">
                      <a16:creationId xmlns:a16="http://schemas.microsoft.com/office/drawing/2014/main" id="{A161D342-EDDD-429F-AEBB-268D13E7260A}"/>
                    </a:ext>
                  </a:extLst>
                </p:cNvPr>
                <p:cNvSpPr>
                  <a:spLocks noChangeArrowheads="1"/>
                </p:cNvSpPr>
                <p:nvPr/>
              </p:nvSpPr>
              <p:spPr bwMode="auto">
                <a:xfrm>
                  <a:off x="6751322" y="3119284"/>
                  <a:ext cx="143648" cy="489600"/>
                </a:xfrm>
                <a:prstGeom prst="rect">
                  <a:avLst/>
                </a:prstGeom>
                <a:solidFill>
                  <a:srgbClr val="F2DCD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01" name="Rectangle 300">
                  <a:extLst>
                    <a:ext uri="{FF2B5EF4-FFF2-40B4-BE49-F238E27FC236}">
                      <a16:creationId xmlns:a16="http://schemas.microsoft.com/office/drawing/2014/main" id="{1B4CAF15-C7D2-49E0-8A7C-BF320BE04EF6}"/>
                    </a:ext>
                  </a:extLst>
                </p:cNvPr>
                <p:cNvSpPr>
                  <a:spLocks noChangeArrowheads="1"/>
                </p:cNvSpPr>
                <p:nvPr/>
              </p:nvSpPr>
              <p:spPr bwMode="auto">
                <a:xfrm>
                  <a:off x="7096764" y="3257303"/>
                  <a:ext cx="143648" cy="349200"/>
                </a:xfrm>
                <a:prstGeom prst="rect">
                  <a:avLst/>
                </a:prstGeom>
                <a:solidFill>
                  <a:srgbClr val="F2DCD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02" name="Rectangle 301">
                  <a:extLst>
                    <a:ext uri="{FF2B5EF4-FFF2-40B4-BE49-F238E27FC236}">
                      <a16:creationId xmlns:a16="http://schemas.microsoft.com/office/drawing/2014/main" id="{3EB470DD-4274-46D4-A4CA-0889AA118852}"/>
                    </a:ext>
                  </a:extLst>
                </p:cNvPr>
                <p:cNvSpPr>
                  <a:spLocks noChangeArrowheads="1"/>
                </p:cNvSpPr>
                <p:nvPr/>
              </p:nvSpPr>
              <p:spPr bwMode="auto">
                <a:xfrm>
                  <a:off x="7454714" y="3245284"/>
                  <a:ext cx="143648" cy="363600"/>
                </a:xfrm>
                <a:prstGeom prst="rect">
                  <a:avLst/>
                </a:prstGeom>
                <a:solidFill>
                  <a:srgbClr val="F2DCD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03" name="Rectangle 302">
                  <a:extLst>
                    <a:ext uri="{FF2B5EF4-FFF2-40B4-BE49-F238E27FC236}">
                      <a16:creationId xmlns:a16="http://schemas.microsoft.com/office/drawing/2014/main" id="{FA822960-05CB-4738-9E36-A9A3DED6AD89}"/>
                    </a:ext>
                  </a:extLst>
                </p:cNvPr>
                <p:cNvSpPr>
                  <a:spLocks noChangeArrowheads="1"/>
                </p:cNvSpPr>
                <p:nvPr/>
              </p:nvSpPr>
              <p:spPr bwMode="auto">
                <a:xfrm>
                  <a:off x="7794502" y="1513684"/>
                  <a:ext cx="143648" cy="2095200"/>
                </a:xfrm>
                <a:prstGeom prst="rect">
                  <a:avLst/>
                </a:prstGeom>
                <a:solidFill>
                  <a:srgbClr val="F2DCDB"/>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11" name="Rectangle 310">
                  <a:extLst>
                    <a:ext uri="{FF2B5EF4-FFF2-40B4-BE49-F238E27FC236}">
                      <a16:creationId xmlns:a16="http://schemas.microsoft.com/office/drawing/2014/main" id="{D7410B51-9DF0-4522-B186-8AFB544C0676}"/>
                    </a:ext>
                  </a:extLst>
                </p:cNvPr>
                <p:cNvSpPr>
                  <a:spLocks noChangeArrowheads="1"/>
                </p:cNvSpPr>
                <p:nvPr/>
              </p:nvSpPr>
              <p:spPr bwMode="auto">
                <a:xfrm>
                  <a:off x="6148268" y="2465885"/>
                  <a:ext cx="104472" cy="1141200"/>
                </a:xfrm>
                <a:prstGeom prst="rect">
                  <a:avLst/>
                </a:prstGeom>
                <a:solidFill>
                  <a:schemeClr val="accent3">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14" name="Rectangle 313">
                  <a:extLst>
                    <a:ext uri="{FF2B5EF4-FFF2-40B4-BE49-F238E27FC236}">
                      <a16:creationId xmlns:a16="http://schemas.microsoft.com/office/drawing/2014/main" id="{446B9A85-DAEC-4538-A134-91FC14E77BC2}"/>
                    </a:ext>
                  </a:extLst>
                </p:cNvPr>
                <p:cNvSpPr>
                  <a:spLocks noChangeArrowheads="1"/>
                </p:cNvSpPr>
                <p:nvPr/>
              </p:nvSpPr>
              <p:spPr bwMode="auto">
                <a:xfrm>
                  <a:off x="6456998" y="3264503"/>
                  <a:ext cx="104472" cy="342000"/>
                </a:xfrm>
                <a:prstGeom prst="rect">
                  <a:avLst/>
                </a:prstGeom>
                <a:solidFill>
                  <a:schemeClr val="accent3">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15" name="Rectangle 314">
                  <a:extLst>
                    <a:ext uri="{FF2B5EF4-FFF2-40B4-BE49-F238E27FC236}">
                      <a16:creationId xmlns:a16="http://schemas.microsoft.com/office/drawing/2014/main" id="{E06A8FA7-2514-4699-A9EB-ABC3C80764DD}"/>
                    </a:ext>
                  </a:extLst>
                </p:cNvPr>
                <p:cNvSpPr>
                  <a:spLocks noChangeArrowheads="1"/>
                </p:cNvSpPr>
                <p:nvPr/>
              </p:nvSpPr>
              <p:spPr bwMode="auto">
                <a:xfrm>
                  <a:off x="6771456" y="3155284"/>
                  <a:ext cx="104472" cy="453600"/>
                </a:xfrm>
                <a:prstGeom prst="rect">
                  <a:avLst/>
                </a:prstGeom>
                <a:solidFill>
                  <a:schemeClr val="accent3">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16" name="Rectangle 315">
                  <a:extLst>
                    <a:ext uri="{FF2B5EF4-FFF2-40B4-BE49-F238E27FC236}">
                      <a16:creationId xmlns:a16="http://schemas.microsoft.com/office/drawing/2014/main" id="{9796FCDB-9058-480B-8EDD-D0BA5D45DDB5}"/>
                    </a:ext>
                  </a:extLst>
                </p:cNvPr>
                <p:cNvSpPr>
                  <a:spLocks noChangeArrowheads="1"/>
                </p:cNvSpPr>
                <p:nvPr/>
              </p:nvSpPr>
              <p:spPr bwMode="auto">
                <a:xfrm>
                  <a:off x="7116680" y="3364076"/>
                  <a:ext cx="104472" cy="244800"/>
                </a:xfrm>
                <a:prstGeom prst="rect">
                  <a:avLst/>
                </a:prstGeom>
                <a:solidFill>
                  <a:schemeClr val="accent3">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17" name="Rectangle 316">
                  <a:extLst>
                    <a:ext uri="{FF2B5EF4-FFF2-40B4-BE49-F238E27FC236}">
                      <a16:creationId xmlns:a16="http://schemas.microsoft.com/office/drawing/2014/main" id="{261ADAD6-D9E3-44E0-BFFA-987ACE13A36C}"/>
                    </a:ext>
                  </a:extLst>
                </p:cNvPr>
                <p:cNvSpPr>
                  <a:spLocks noChangeArrowheads="1"/>
                </p:cNvSpPr>
                <p:nvPr/>
              </p:nvSpPr>
              <p:spPr bwMode="auto">
                <a:xfrm>
                  <a:off x="7475243" y="3328084"/>
                  <a:ext cx="104472" cy="280800"/>
                </a:xfrm>
                <a:prstGeom prst="rect">
                  <a:avLst/>
                </a:prstGeom>
                <a:solidFill>
                  <a:schemeClr val="accent3">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18" name="Rectangle 317">
                  <a:extLst>
                    <a:ext uri="{FF2B5EF4-FFF2-40B4-BE49-F238E27FC236}">
                      <a16:creationId xmlns:a16="http://schemas.microsoft.com/office/drawing/2014/main" id="{61D18DD5-C53D-474A-A078-6ADC3C0D0388}"/>
                    </a:ext>
                  </a:extLst>
                </p:cNvPr>
                <p:cNvSpPr>
                  <a:spLocks noChangeArrowheads="1"/>
                </p:cNvSpPr>
                <p:nvPr/>
              </p:nvSpPr>
              <p:spPr bwMode="auto">
                <a:xfrm>
                  <a:off x="7813663" y="1865329"/>
                  <a:ext cx="104472" cy="1738800"/>
                </a:xfrm>
                <a:prstGeom prst="rect">
                  <a:avLst/>
                </a:prstGeom>
                <a:solidFill>
                  <a:schemeClr val="accent3">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25" name="Line 104">
                  <a:extLst>
                    <a:ext uri="{FF2B5EF4-FFF2-40B4-BE49-F238E27FC236}">
                      <a16:creationId xmlns:a16="http://schemas.microsoft.com/office/drawing/2014/main" id="{18F802C6-366A-4C1D-BEC1-0CD4949F3F0F}"/>
                    </a:ext>
                  </a:extLst>
                </p:cNvPr>
                <p:cNvSpPr>
                  <a:spLocks noChangeShapeType="1"/>
                </p:cNvSpPr>
                <p:nvPr/>
              </p:nvSpPr>
              <p:spPr bwMode="auto">
                <a:xfrm>
                  <a:off x="5951702" y="3608697"/>
                  <a:ext cx="2124000" cy="0"/>
                </a:xfrm>
                <a:prstGeom prst="line">
                  <a:avLst/>
                </a:prstGeom>
                <a:noFill/>
                <a:ln w="1270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327" name="Rectangle 326">
                  <a:extLst>
                    <a:ext uri="{FF2B5EF4-FFF2-40B4-BE49-F238E27FC236}">
                      <a16:creationId xmlns:a16="http://schemas.microsoft.com/office/drawing/2014/main" id="{115EF5AE-4A05-4E6D-9DC2-BF22C3E3BB8E}"/>
                    </a:ext>
                  </a:extLst>
                </p:cNvPr>
                <p:cNvSpPr>
                  <a:spLocks noChangeArrowheads="1"/>
                </p:cNvSpPr>
                <p:nvPr/>
              </p:nvSpPr>
              <p:spPr bwMode="auto">
                <a:xfrm>
                  <a:off x="6169326" y="3416922"/>
                  <a:ext cx="65295" cy="187200"/>
                </a:xfrm>
                <a:prstGeom prst="rect">
                  <a:avLst/>
                </a:prstGeom>
                <a:solidFill>
                  <a:schemeClr val="tx2">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30" name="Rectangle 329">
                  <a:extLst>
                    <a:ext uri="{FF2B5EF4-FFF2-40B4-BE49-F238E27FC236}">
                      <a16:creationId xmlns:a16="http://schemas.microsoft.com/office/drawing/2014/main" id="{4CF57E8C-AB4F-43EC-B248-EF9DE454DDC5}"/>
                    </a:ext>
                  </a:extLst>
                </p:cNvPr>
                <p:cNvSpPr>
                  <a:spLocks noChangeArrowheads="1"/>
                </p:cNvSpPr>
                <p:nvPr/>
              </p:nvSpPr>
              <p:spPr bwMode="auto">
                <a:xfrm>
                  <a:off x="6477973" y="3562141"/>
                  <a:ext cx="65295" cy="39600"/>
                </a:xfrm>
                <a:prstGeom prst="rect">
                  <a:avLst/>
                </a:prstGeom>
                <a:solidFill>
                  <a:schemeClr val="tx2">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31" name="Rectangle 330">
                  <a:extLst>
                    <a:ext uri="{FF2B5EF4-FFF2-40B4-BE49-F238E27FC236}">
                      <a16:creationId xmlns:a16="http://schemas.microsoft.com/office/drawing/2014/main" id="{08F6A189-40E8-49CE-9D4B-BBA2B5D3C34C}"/>
                    </a:ext>
                  </a:extLst>
                </p:cNvPr>
                <p:cNvSpPr>
                  <a:spLocks noChangeArrowheads="1"/>
                </p:cNvSpPr>
                <p:nvPr/>
              </p:nvSpPr>
              <p:spPr bwMode="auto">
                <a:xfrm>
                  <a:off x="6792278" y="3500941"/>
                  <a:ext cx="65295" cy="100800"/>
                </a:xfrm>
                <a:prstGeom prst="rect">
                  <a:avLst/>
                </a:prstGeom>
                <a:solidFill>
                  <a:schemeClr val="tx2">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32" name="Rectangle 331">
                  <a:extLst>
                    <a:ext uri="{FF2B5EF4-FFF2-40B4-BE49-F238E27FC236}">
                      <a16:creationId xmlns:a16="http://schemas.microsoft.com/office/drawing/2014/main" id="{87D50BDC-CF77-41AA-A1F6-F52C3A9EA02B}"/>
                    </a:ext>
                  </a:extLst>
                </p:cNvPr>
                <p:cNvSpPr>
                  <a:spLocks noChangeArrowheads="1"/>
                </p:cNvSpPr>
                <p:nvPr/>
              </p:nvSpPr>
              <p:spPr bwMode="auto">
                <a:xfrm>
                  <a:off x="7137142" y="3554941"/>
                  <a:ext cx="65295" cy="46800"/>
                </a:xfrm>
                <a:prstGeom prst="rect">
                  <a:avLst/>
                </a:prstGeom>
                <a:solidFill>
                  <a:schemeClr val="tx2">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33" name="Rectangle 332">
                  <a:extLst>
                    <a:ext uri="{FF2B5EF4-FFF2-40B4-BE49-F238E27FC236}">
                      <a16:creationId xmlns:a16="http://schemas.microsoft.com/office/drawing/2014/main" id="{1A94954C-29F8-44A6-9223-B223E193757C}"/>
                    </a:ext>
                  </a:extLst>
                </p:cNvPr>
                <p:cNvSpPr>
                  <a:spLocks noChangeArrowheads="1"/>
                </p:cNvSpPr>
                <p:nvPr/>
              </p:nvSpPr>
              <p:spPr bwMode="auto">
                <a:xfrm>
                  <a:off x="7495275" y="3568122"/>
                  <a:ext cx="65295" cy="36000"/>
                </a:xfrm>
                <a:prstGeom prst="rect">
                  <a:avLst/>
                </a:prstGeom>
                <a:solidFill>
                  <a:schemeClr val="tx2">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34" name="Rectangle 333">
                  <a:extLst>
                    <a:ext uri="{FF2B5EF4-FFF2-40B4-BE49-F238E27FC236}">
                      <a16:creationId xmlns:a16="http://schemas.microsoft.com/office/drawing/2014/main" id="{3704401E-669E-4E20-9540-FA2BC2E828EC}"/>
                    </a:ext>
                  </a:extLst>
                </p:cNvPr>
                <p:cNvSpPr>
                  <a:spLocks noChangeArrowheads="1"/>
                </p:cNvSpPr>
                <p:nvPr/>
              </p:nvSpPr>
              <p:spPr bwMode="auto">
                <a:xfrm>
                  <a:off x="7832893" y="3540541"/>
                  <a:ext cx="65295" cy="61200"/>
                </a:xfrm>
                <a:prstGeom prst="rect">
                  <a:avLst/>
                </a:prstGeom>
                <a:solidFill>
                  <a:schemeClr val="tx2">
                    <a:lumMod val="20000"/>
                    <a:lumOff val="80000"/>
                  </a:schemeClr>
                </a:solidFill>
                <a:ln w="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344" name="Rectangle 109">
                  <a:extLst>
                    <a:ext uri="{FF2B5EF4-FFF2-40B4-BE49-F238E27FC236}">
                      <a16:creationId xmlns:a16="http://schemas.microsoft.com/office/drawing/2014/main" id="{14C6140C-5182-4616-9065-B123124F8BD2}"/>
                    </a:ext>
                  </a:extLst>
                </p:cNvPr>
                <p:cNvSpPr>
                  <a:spLocks noChangeArrowheads="1"/>
                </p:cNvSpPr>
                <p:nvPr/>
              </p:nvSpPr>
              <p:spPr bwMode="auto">
                <a:xfrm>
                  <a:off x="5886973" y="3499618"/>
                  <a:ext cx="4488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FF0000"/>
                      </a:solidFill>
                      <a:effectLst/>
                      <a:latin typeface="Calibri" panose="020F0502020204030204" pitchFamily="34" charset="0"/>
                    </a:rPr>
                    <a:t>2</a:t>
                  </a:r>
                  <a:endParaRPr kumimoji="0" lang="en-US" altLang="en-US" sz="700" b="0" i="0" u="none" strike="noStrike" cap="none" normalizeH="0" baseline="0">
                    <a:ln>
                      <a:noFill/>
                    </a:ln>
                    <a:solidFill>
                      <a:srgbClr val="FF0000"/>
                    </a:solidFill>
                    <a:effectLst/>
                  </a:endParaRPr>
                </a:p>
              </p:txBody>
            </p:sp>
            <p:sp>
              <p:nvSpPr>
                <p:cNvPr id="346" name="TextBox 345">
                  <a:extLst>
                    <a:ext uri="{FF2B5EF4-FFF2-40B4-BE49-F238E27FC236}">
                      <a16:creationId xmlns:a16="http://schemas.microsoft.com/office/drawing/2014/main" id="{053BAD05-E541-4E2F-8910-074F983D3ADC}"/>
                    </a:ext>
                  </a:extLst>
                </p:cNvPr>
                <p:cNvSpPr txBox="1"/>
                <p:nvPr/>
              </p:nvSpPr>
              <p:spPr>
                <a:xfrm>
                  <a:off x="5843052" y="3930353"/>
                  <a:ext cx="2331362" cy="307777"/>
                </a:xfrm>
                <a:prstGeom prst="rect">
                  <a:avLst/>
                </a:prstGeom>
                <a:noFill/>
              </p:spPr>
              <p:txBody>
                <a:bodyPr wrap="square" rtlCol="0">
                  <a:spAutoFit/>
                </a:bodyPr>
                <a:lstStyle/>
                <a:p>
                  <a:pPr algn="ctr"/>
                  <a:r>
                    <a:rPr lang="en-IN" sz="1400">
                      <a:latin typeface="Calibri "/>
                    </a:rPr>
                    <a:t>Hypoxia marker transcripts</a:t>
                  </a:r>
                </a:p>
              </p:txBody>
            </p:sp>
            <p:grpSp>
              <p:nvGrpSpPr>
                <p:cNvPr id="92" name="Group 91">
                  <a:extLst>
                    <a:ext uri="{FF2B5EF4-FFF2-40B4-BE49-F238E27FC236}">
                      <a16:creationId xmlns:a16="http://schemas.microsoft.com/office/drawing/2014/main" id="{07D4C826-8AFE-46EC-AF00-0A9D3AFF5D13}"/>
                    </a:ext>
                  </a:extLst>
                </p:cNvPr>
                <p:cNvGrpSpPr/>
                <p:nvPr/>
              </p:nvGrpSpPr>
              <p:grpSpPr>
                <a:xfrm>
                  <a:off x="5734050" y="1295400"/>
                  <a:ext cx="249798" cy="2434030"/>
                  <a:chOff x="6392622" y="2967740"/>
                  <a:chExt cx="249798" cy="2434030"/>
                </a:xfrm>
              </p:grpSpPr>
              <p:sp>
                <p:nvSpPr>
                  <p:cNvPr id="16" name="Line 9">
                    <a:extLst>
                      <a:ext uri="{FF2B5EF4-FFF2-40B4-BE49-F238E27FC236}">
                        <a16:creationId xmlns:a16="http://schemas.microsoft.com/office/drawing/2014/main" id="{D855CE17-BFF0-48C4-8230-65C652E09FA0}"/>
                      </a:ext>
                    </a:extLst>
                  </p:cNvPr>
                  <p:cNvSpPr>
                    <a:spLocks noChangeShapeType="1"/>
                  </p:cNvSpPr>
                  <p:nvPr/>
                </p:nvSpPr>
                <p:spPr bwMode="auto">
                  <a:xfrm flipV="1">
                    <a:off x="6613284" y="2967740"/>
                    <a:ext cx="0" cy="2309813"/>
                  </a:xfrm>
                  <a:prstGeom prst="line">
                    <a:avLst/>
                  </a:prstGeom>
                  <a:noFill/>
                  <a:ln w="1270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7" name="Freeform 10">
                    <a:extLst>
                      <a:ext uri="{FF2B5EF4-FFF2-40B4-BE49-F238E27FC236}">
                        <a16:creationId xmlns:a16="http://schemas.microsoft.com/office/drawing/2014/main" id="{87E99EBF-942B-435A-AAB3-A1D7E9C22A4D}"/>
                      </a:ext>
                    </a:extLst>
                  </p:cNvPr>
                  <p:cNvSpPr>
                    <a:spLocks noEditPoints="1"/>
                  </p:cNvSpPr>
                  <p:nvPr/>
                </p:nvSpPr>
                <p:spPr bwMode="auto">
                  <a:xfrm>
                    <a:off x="6578359" y="3429702"/>
                    <a:ext cx="34925" cy="1847850"/>
                  </a:xfrm>
                  <a:custGeom>
                    <a:avLst/>
                    <a:gdLst>
                      <a:gd name="T0" fmla="*/ 0 w 22"/>
                      <a:gd name="T1" fmla="*/ 1164 h 1164"/>
                      <a:gd name="T2" fmla="*/ 22 w 22"/>
                      <a:gd name="T3" fmla="*/ 1164 h 1164"/>
                      <a:gd name="T4" fmla="*/ 0 w 22"/>
                      <a:gd name="T5" fmla="*/ 582 h 1164"/>
                      <a:gd name="T6" fmla="*/ 22 w 22"/>
                      <a:gd name="T7" fmla="*/ 582 h 1164"/>
                      <a:gd name="T8" fmla="*/ 0 w 22"/>
                      <a:gd name="T9" fmla="*/ 0 h 1164"/>
                      <a:gd name="T10" fmla="*/ 22 w 22"/>
                      <a:gd name="T11" fmla="*/ 0 h 1164"/>
                    </a:gdLst>
                    <a:ahLst/>
                    <a:cxnLst>
                      <a:cxn ang="0">
                        <a:pos x="T0" y="T1"/>
                      </a:cxn>
                      <a:cxn ang="0">
                        <a:pos x="T2" y="T3"/>
                      </a:cxn>
                      <a:cxn ang="0">
                        <a:pos x="T4" y="T5"/>
                      </a:cxn>
                      <a:cxn ang="0">
                        <a:pos x="T6" y="T7"/>
                      </a:cxn>
                      <a:cxn ang="0">
                        <a:pos x="T8" y="T9"/>
                      </a:cxn>
                      <a:cxn ang="0">
                        <a:pos x="T10" y="T11"/>
                      </a:cxn>
                    </a:cxnLst>
                    <a:rect l="0" t="0" r="r" b="b"/>
                    <a:pathLst>
                      <a:path w="22" h="1164">
                        <a:moveTo>
                          <a:pt x="0" y="1164"/>
                        </a:moveTo>
                        <a:lnTo>
                          <a:pt x="22" y="1164"/>
                        </a:lnTo>
                        <a:moveTo>
                          <a:pt x="0" y="582"/>
                        </a:moveTo>
                        <a:lnTo>
                          <a:pt x="22" y="582"/>
                        </a:lnTo>
                        <a:moveTo>
                          <a:pt x="0" y="0"/>
                        </a:moveTo>
                        <a:lnTo>
                          <a:pt x="22" y="0"/>
                        </a:lnTo>
                      </a:path>
                    </a:pathLst>
                  </a:custGeom>
                  <a:noFill/>
                  <a:ln w="1270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sp>
                <p:nvSpPr>
                  <p:cNvPr id="19" name="Rectangle 12">
                    <a:extLst>
                      <a:ext uri="{FF2B5EF4-FFF2-40B4-BE49-F238E27FC236}">
                        <a16:creationId xmlns:a16="http://schemas.microsoft.com/office/drawing/2014/main" id="{81E804B0-69D0-4A0F-A479-520E91EF5908}"/>
                      </a:ext>
                    </a:extLst>
                  </p:cNvPr>
                  <p:cNvSpPr>
                    <a:spLocks noChangeArrowheads="1"/>
                  </p:cNvSpPr>
                  <p:nvPr/>
                </p:nvSpPr>
                <p:spPr bwMode="auto">
                  <a:xfrm>
                    <a:off x="6584712" y="5263271"/>
                    <a:ext cx="5770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latin typeface="Calibri" panose="020F0502020204030204" pitchFamily="34" charset="0"/>
                      </a:rPr>
                      <a:t>0</a:t>
                    </a:r>
                    <a:endParaRPr kumimoji="0" lang="en-US" altLang="en-US" sz="1800" b="0" i="0" u="none" strike="noStrike" cap="none" normalizeH="0" baseline="0">
                      <a:ln>
                        <a:noFill/>
                      </a:ln>
                      <a:effectLst/>
                    </a:endParaRPr>
                  </a:p>
                </p:txBody>
              </p:sp>
              <p:sp>
                <p:nvSpPr>
                  <p:cNvPr id="20" name="Rectangle 13">
                    <a:extLst>
                      <a:ext uri="{FF2B5EF4-FFF2-40B4-BE49-F238E27FC236}">
                        <a16:creationId xmlns:a16="http://schemas.microsoft.com/office/drawing/2014/main" id="{440A4A00-DE76-4960-9F4F-B945A9CDBE12}"/>
                      </a:ext>
                    </a:extLst>
                  </p:cNvPr>
                  <p:cNvSpPr>
                    <a:spLocks noChangeArrowheads="1"/>
                  </p:cNvSpPr>
                  <p:nvPr/>
                </p:nvSpPr>
                <p:spPr bwMode="auto">
                  <a:xfrm>
                    <a:off x="6392622" y="4277427"/>
                    <a:ext cx="11541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latin typeface="Calibri" panose="020F0502020204030204" pitchFamily="34" charset="0"/>
                      </a:rPr>
                      <a:t>40</a:t>
                    </a:r>
                    <a:endParaRPr kumimoji="0" lang="en-US" altLang="en-US" sz="1800" b="0" i="0" u="none" strike="noStrike" cap="none" normalizeH="0" baseline="0">
                      <a:ln>
                        <a:noFill/>
                      </a:ln>
                      <a:effectLst/>
                    </a:endParaRPr>
                  </a:p>
                </p:txBody>
              </p:sp>
              <p:sp>
                <p:nvSpPr>
                  <p:cNvPr id="21" name="Rectangle 14">
                    <a:extLst>
                      <a:ext uri="{FF2B5EF4-FFF2-40B4-BE49-F238E27FC236}">
                        <a16:creationId xmlns:a16="http://schemas.microsoft.com/office/drawing/2014/main" id="{6705BC7F-FF39-48F0-A2C0-F0A336E1FCBB}"/>
                      </a:ext>
                    </a:extLst>
                  </p:cNvPr>
                  <p:cNvSpPr>
                    <a:spLocks noChangeArrowheads="1"/>
                  </p:cNvSpPr>
                  <p:nvPr/>
                </p:nvSpPr>
                <p:spPr bwMode="auto">
                  <a:xfrm>
                    <a:off x="6392622" y="3353502"/>
                    <a:ext cx="177800" cy="169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595959"/>
                        </a:solidFill>
                        <a:effectLst/>
                        <a:latin typeface="Calibri" panose="020F0502020204030204" pitchFamily="34" charset="0"/>
                      </a:rPr>
                      <a:t>8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grpSp>
            <p:sp>
              <p:nvSpPr>
                <p:cNvPr id="23" name="Rectangle 16">
                  <a:extLst>
                    <a:ext uri="{FF2B5EF4-FFF2-40B4-BE49-F238E27FC236}">
                      <a16:creationId xmlns:a16="http://schemas.microsoft.com/office/drawing/2014/main" id="{68347386-7277-4975-B7A0-2C5FB4FCDC0B}"/>
                    </a:ext>
                  </a:extLst>
                </p:cNvPr>
                <p:cNvSpPr>
                  <a:spLocks noChangeArrowheads="1"/>
                </p:cNvSpPr>
                <p:nvPr/>
              </p:nvSpPr>
              <p:spPr bwMode="auto">
                <a:xfrm>
                  <a:off x="6099457" y="3736043"/>
                  <a:ext cx="24846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latin typeface="Calibri" panose="020F0502020204030204" pitchFamily="34" charset="0"/>
                    </a:rPr>
                    <a:t>PDC1</a:t>
                  </a:r>
                  <a:endParaRPr kumimoji="0" lang="en-US" altLang="en-US" sz="1800" b="0" i="0" u="none" strike="noStrike" cap="none" normalizeH="0" baseline="0">
                    <a:ln>
                      <a:noFill/>
                    </a:ln>
                    <a:effectLst/>
                  </a:endParaRPr>
                </a:p>
              </p:txBody>
            </p:sp>
            <p:sp>
              <p:nvSpPr>
                <p:cNvPr id="25" name="Rectangle 18">
                  <a:extLst>
                    <a:ext uri="{FF2B5EF4-FFF2-40B4-BE49-F238E27FC236}">
                      <a16:creationId xmlns:a16="http://schemas.microsoft.com/office/drawing/2014/main" id="{7CCA44C5-39F5-40AB-8747-1C6BE71DE67B}"/>
                    </a:ext>
                  </a:extLst>
                </p:cNvPr>
                <p:cNvSpPr>
                  <a:spLocks noChangeArrowheads="1"/>
                </p:cNvSpPr>
                <p:nvPr/>
              </p:nvSpPr>
              <p:spPr bwMode="auto">
                <a:xfrm>
                  <a:off x="6419480" y="3736043"/>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latin typeface="Calibri" panose="020F0502020204030204" pitchFamily="34" charset="0"/>
                    </a:rPr>
                    <a:t>HB1</a:t>
                  </a:r>
                  <a:endParaRPr kumimoji="0" lang="en-US" altLang="en-US" sz="1800" b="0" i="0" u="none" strike="noStrike" cap="none" normalizeH="0" baseline="0">
                    <a:ln>
                      <a:noFill/>
                    </a:ln>
                    <a:effectLst/>
                  </a:endParaRPr>
                </a:p>
              </p:txBody>
            </p:sp>
            <p:sp>
              <p:nvSpPr>
                <p:cNvPr id="26" name="Rectangle 19">
                  <a:extLst>
                    <a:ext uri="{FF2B5EF4-FFF2-40B4-BE49-F238E27FC236}">
                      <a16:creationId xmlns:a16="http://schemas.microsoft.com/office/drawing/2014/main" id="{C238F8BC-0061-41D6-B178-1AAC3CAB348E}"/>
                    </a:ext>
                  </a:extLst>
                </p:cNvPr>
                <p:cNvSpPr>
                  <a:spLocks noChangeArrowheads="1"/>
                </p:cNvSpPr>
                <p:nvPr/>
              </p:nvSpPr>
              <p:spPr bwMode="auto">
                <a:xfrm>
                  <a:off x="6700721" y="3736043"/>
                  <a:ext cx="25487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latin typeface="Calibri" panose="020F0502020204030204" pitchFamily="34" charset="0"/>
                    </a:rPr>
                    <a:t>PCO1</a:t>
                  </a:r>
                  <a:endParaRPr kumimoji="0" lang="en-US" altLang="en-US" sz="1800" b="0" i="0" u="none" strike="noStrike" cap="none" normalizeH="0" baseline="0">
                    <a:ln>
                      <a:noFill/>
                    </a:ln>
                    <a:effectLst/>
                  </a:endParaRPr>
                </a:p>
              </p:txBody>
            </p:sp>
            <p:sp>
              <p:nvSpPr>
                <p:cNvPr id="27" name="Rectangle 20">
                  <a:extLst>
                    <a:ext uri="{FF2B5EF4-FFF2-40B4-BE49-F238E27FC236}">
                      <a16:creationId xmlns:a16="http://schemas.microsoft.com/office/drawing/2014/main" id="{684CB4F6-02C6-45BA-B6D3-BAF74C2AD871}"/>
                    </a:ext>
                  </a:extLst>
                </p:cNvPr>
                <p:cNvSpPr>
                  <a:spLocks noChangeArrowheads="1"/>
                </p:cNvSpPr>
                <p:nvPr/>
              </p:nvSpPr>
              <p:spPr bwMode="auto">
                <a:xfrm>
                  <a:off x="7041274" y="3736043"/>
                  <a:ext cx="29655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latin typeface="Calibri" panose="020F0502020204030204" pitchFamily="34" charset="0"/>
                    </a:rPr>
                    <a:t>LBD41</a:t>
                  </a:r>
                  <a:endParaRPr kumimoji="0" lang="en-US" altLang="en-US" sz="1800" b="0" i="0" u="none" strike="noStrike" cap="none" normalizeH="0" baseline="0">
                    <a:ln>
                      <a:noFill/>
                    </a:ln>
                    <a:effectLst/>
                  </a:endParaRPr>
                </a:p>
              </p:txBody>
            </p:sp>
            <p:sp>
              <p:nvSpPr>
                <p:cNvPr id="28" name="Rectangle 21">
                  <a:extLst>
                    <a:ext uri="{FF2B5EF4-FFF2-40B4-BE49-F238E27FC236}">
                      <a16:creationId xmlns:a16="http://schemas.microsoft.com/office/drawing/2014/main" id="{882F2E7F-646C-4B1B-90AA-EA66DACF86E7}"/>
                    </a:ext>
                  </a:extLst>
                </p:cNvPr>
                <p:cNvSpPr>
                  <a:spLocks noChangeArrowheads="1"/>
                </p:cNvSpPr>
                <p:nvPr/>
              </p:nvSpPr>
              <p:spPr bwMode="auto">
                <a:xfrm>
                  <a:off x="7414654" y="3736043"/>
                  <a:ext cx="237244"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latin typeface="Calibri" panose="020F0502020204030204" pitchFamily="34" charset="0"/>
                    </a:rPr>
                    <a:t>SUS1</a:t>
                  </a:r>
                  <a:endParaRPr kumimoji="0" lang="en-US" altLang="en-US" sz="1800" b="0" i="0" u="none" strike="noStrike" cap="none" normalizeH="0" baseline="0">
                    <a:ln>
                      <a:noFill/>
                    </a:ln>
                    <a:effectLst/>
                  </a:endParaRPr>
                </a:p>
              </p:txBody>
            </p:sp>
            <p:sp>
              <p:nvSpPr>
                <p:cNvPr id="29" name="Rectangle 22">
                  <a:extLst>
                    <a:ext uri="{FF2B5EF4-FFF2-40B4-BE49-F238E27FC236}">
                      <a16:creationId xmlns:a16="http://schemas.microsoft.com/office/drawing/2014/main" id="{E6EFF97D-DF10-4F02-9723-C442807DAABA}"/>
                    </a:ext>
                  </a:extLst>
                </p:cNvPr>
                <p:cNvSpPr>
                  <a:spLocks noChangeArrowheads="1"/>
                </p:cNvSpPr>
                <p:nvPr/>
              </p:nvSpPr>
              <p:spPr bwMode="auto">
                <a:xfrm>
                  <a:off x="7727074" y="3729693"/>
                  <a:ext cx="26289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latin typeface="Calibri" panose="020F0502020204030204" pitchFamily="34" charset="0"/>
                    </a:rPr>
                    <a:t>HUP7</a:t>
                  </a:r>
                  <a:endParaRPr kumimoji="0" lang="en-US" altLang="en-US" sz="1800" b="0" i="0" u="none" strike="noStrike" cap="none" normalizeH="0" baseline="0">
                    <a:ln>
                      <a:noFill/>
                    </a:ln>
                    <a:effectLst/>
                  </a:endParaRPr>
                </a:p>
              </p:txBody>
            </p:sp>
          </p:grpSp>
          <p:sp>
            <p:nvSpPr>
              <p:cNvPr id="328" name="TextBox 327">
                <a:extLst>
                  <a:ext uri="{FF2B5EF4-FFF2-40B4-BE49-F238E27FC236}">
                    <a16:creationId xmlns:a16="http://schemas.microsoft.com/office/drawing/2014/main" id="{0E54D013-1413-4FE5-91A4-171678E2AE17}"/>
                  </a:ext>
                </a:extLst>
              </p:cNvPr>
              <p:cNvSpPr txBox="1"/>
              <p:nvPr/>
            </p:nvSpPr>
            <p:spPr>
              <a:xfrm>
                <a:off x="305392" y="4294498"/>
                <a:ext cx="3129983" cy="276999"/>
              </a:xfrm>
              <a:prstGeom prst="rect">
                <a:avLst/>
              </a:prstGeom>
              <a:noFill/>
            </p:spPr>
            <p:txBody>
              <a:bodyPr wrap="square" rtlCol="0">
                <a:spAutoFit/>
              </a:bodyPr>
              <a:lstStyle/>
              <a:p>
                <a:pPr algn="ctr"/>
                <a:r>
                  <a:rPr lang="en-IN" sz="1200" dirty="0">
                    <a:latin typeface="Calibri "/>
                  </a:rPr>
                  <a:t>n = 3 (3 independent experiments), p&lt;0.05</a:t>
                </a:r>
              </a:p>
            </p:txBody>
          </p:sp>
        </p:grpSp>
        <p:sp>
          <p:nvSpPr>
            <p:cNvPr id="324" name="TextBox 323">
              <a:extLst>
                <a:ext uri="{FF2B5EF4-FFF2-40B4-BE49-F238E27FC236}">
                  <a16:creationId xmlns:a16="http://schemas.microsoft.com/office/drawing/2014/main" id="{42052856-F850-4E82-822C-2603FFE1DA65}"/>
                </a:ext>
              </a:extLst>
            </p:cNvPr>
            <p:cNvSpPr txBox="1"/>
            <p:nvPr/>
          </p:nvSpPr>
          <p:spPr>
            <a:xfrm rot="16200000">
              <a:off x="-617777" y="2273574"/>
              <a:ext cx="2880320" cy="288032"/>
            </a:xfrm>
            <a:prstGeom prst="rect">
              <a:avLst/>
            </a:prstGeom>
            <a:noFill/>
          </p:spPr>
          <p:txBody>
            <a:bodyPr wrap="square" rtlCol="0">
              <a:spAutoFit/>
            </a:bodyPr>
            <a:lstStyle/>
            <a:p>
              <a:pPr algn="ctr"/>
              <a:r>
                <a:rPr lang="en-IN" sz="1200" dirty="0">
                  <a:latin typeface="Calibri "/>
                </a:rPr>
                <a:t>Root transcript amounts (r. u.)</a:t>
              </a:r>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66C105B6-59EA-4750-A838-914E25E80CD8}"/>
              </a:ext>
            </a:extLst>
          </p:cNvPr>
          <p:cNvGrpSpPr/>
          <p:nvPr/>
        </p:nvGrpSpPr>
        <p:grpSpPr>
          <a:xfrm>
            <a:off x="2797123" y="903601"/>
            <a:ext cx="3083275" cy="3080639"/>
            <a:chOff x="5681000" y="726778"/>
            <a:chExt cx="3083275" cy="3080639"/>
          </a:xfrm>
        </p:grpSpPr>
        <p:sp>
          <p:nvSpPr>
            <p:cNvPr id="4" name="Freeform 65">
              <a:extLst>
                <a:ext uri="{FF2B5EF4-FFF2-40B4-BE49-F238E27FC236}">
                  <a16:creationId xmlns:a16="http://schemas.microsoft.com/office/drawing/2014/main" id="{417F6BA1-5F78-4410-9D50-3E549EC34D26}"/>
                </a:ext>
              </a:extLst>
            </p:cNvPr>
            <p:cNvSpPr>
              <a:spLocks noEditPoints="1"/>
            </p:cNvSpPr>
            <p:nvPr/>
          </p:nvSpPr>
          <p:spPr bwMode="auto">
            <a:xfrm>
              <a:off x="6929136" y="3084174"/>
              <a:ext cx="57150" cy="87313"/>
            </a:xfrm>
            <a:custGeom>
              <a:avLst/>
              <a:gdLst>
                <a:gd name="T0" fmla="*/ 18 w 36"/>
                <a:gd name="T1" fmla="*/ 30 h 55"/>
                <a:gd name="T2" fmla="*/ 18 w 36"/>
                <a:gd name="T3" fmla="*/ 55 h 55"/>
                <a:gd name="T4" fmla="*/ 18 w 36"/>
                <a:gd name="T5" fmla="*/ 30 h 55"/>
                <a:gd name="T6" fmla="*/ 18 w 36"/>
                <a:gd name="T7" fmla="*/ 30 h 55"/>
                <a:gd name="T8" fmla="*/ 18 w 36"/>
                <a:gd name="T9" fmla="*/ 0 h 55"/>
                <a:gd name="T10" fmla="*/ 18 w 36"/>
                <a:gd name="T11" fmla="*/ 30 h 55"/>
                <a:gd name="T12" fmla="*/ 0 w 36"/>
                <a:gd name="T13" fmla="*/ 55 h 55"/>
                <a:gd name="T14" fmla="*/ 36 w 36"/>
                <a:gd name="T15" fmla="*/ 55 h 55"/>
                <a:gd name="T16" fmla="*/ 0 w 36"/>
                <a:gd name="T17" fmla="*/ 55 h 55"/>
                <a:gd name="T18" fmla="*/ 0 w 36"/>
                <a:gd name="T19" fmla="*/ 0 h 55"/>
                <a:gd name="T20" fmla="*/ 36 w 36"/>
                <a:gd name="T21" fmla="*/ 0 h 55"/>
                <a:gd name="T22" fmla="*/ 0 w 36"/>
                <a:gd name="T23" fmla="*/ 0 h 5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6" h="55">
                  <a:moveTo>
                    <a:pt x="18" y="30"/>
                  </a:moveTo>
                  <a:lnTo>
                    <a:pt x="18" y="55"/>
                  </a:lnTo>
                  <a:lnTo>
                    <a:pt x="18" y="30"/>
                  </a:lnTo>
                  <a:close/>
                  <a:moveTo>
                    <a:pt x="18" y="30"/>
                  </a:moveTo>
                  <a:lnTo>
                    <a:pt x="18" y="0"/>
                  </a:lnTo>
                  <a:lnTo>
                    <a:pt x="18" y="30"/>
                  </a:lnTo>
                  <a:close/>
                  <a:moveTo>
                    <a:pt x="0" y="55"/>
                  </a:moveTo>
                  <a:lnTo>
                    <a:pt x="36" y="55"/>
                  </a:lnTo>
                  <a:lnTo>
                    <a:pt x="0" y="55"/>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IN"/>
            </a:p>
          </p:txBody>
        </p:sp>
        <p:sp>
          <p:nvSpPr>
            <p:cNvPr id="5" name="Freeform 67">
              <a:extLst>
                <a:ext uri="{FF2B5EF4-FFF2-40B4-BE49-F238E27FC236}">
                  <a16:creationId xmlns:a16="http://schemas.microsoft.com/office/drawing/2014/main" id="{7D8863F6-B651-4D67-95C4-9FC39805E147}"/>
                </a:ext>
              </a:extLst>
            </p:cNvPr>
            <p:cNvSpPr>
              <a:spLocks noEditPoints="1"/>
            </p:cNvSpPr>
            <p:nvPr/>
          </p:nvSpPr>
          <p:spPr bwMode="auto">
            <a:xfrm>
              <a:off x="7373571" y="2787606"/>
              <a:ext cx="57150" cy="76200"/>
            </a:xfrm>
            <a:custGeom>
              <a:avLst/>
              <a:gdLst>
                <a:gd name="T0" fmla="*/ 18 w 36"/>
                <a:gd name="T1" fmla="*/ 24 h 48"/>
                <a:gd name="T2" fmla="*/ 18 w 36"/>
                <a:gd name="T3" fmla="*/ 48 h 48"/>
                <a:gd name="T4" fmla="*/ 18 w 36"/>
                <a:gd name="T5" fmla="*/ 24 h 48"/>
                <a:gd name="T6" fmla="*/ 18 w 36"/>
                <a:gd name="T7" fmla="*/ 24 h 48"/>
                <a:gd name="T8" fmla="*/ 18 w 36"/>
                <a:gd name="T9" fmla="*/ 0 h 48"/>
                <a:gd name="T10" fmla="*/ 18 w 36"/>
                <a:gd name="T11" fmla="*/ 24 h 48"/>
                <a:gd name="T12" fmla="*/ 0 w 36"/>
                <a:gd name="T13" fmla="*/ 48 h 48"/>
                <a:gd name="T14" fmla="*/ 36 w 36"/>
                <a:gd name="T15" fmla="*/ 48 h 48"/>
                <a:gd name="T16" fmla="*/ 0 w 36"/>
                <a:gd name="T17" fmla="*/ 48 h 48"/>
                <a:gd name="T18" fmla="*/ 0 w 36"/>
                <a:gd name="T19" fmla="*/ 0 h 48"/>
                <a:gd name="T20" fmla="*/ 36 w 36"/>
                <a:gd name="T21" fmla="*/ 0 h 48"/>
                <a:gd name="T22" fmla="*/ 0 w 36"/>
                <a:gd name="T23" fmla="*/ 0 h 4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6" h="48">
                  <a:moveTo>
                    <a:pt x="18" y="24"/>
                  </a:moveTo>
                  <a:lnTo>
                    <a:pt x="18" y="48"/>
                  </a:lnTo>
                  <a:lnTo>
                    <a:pt x="18" y="24"/>
                  </a:lnTo>
                  <a:close/>
                  <a:moveTo>
                    <a:pt x="18" y="24"/>
                  </a:moveTo>
                  <a:lnTo>
                    <a:pt x="18" y="0"/>
                  </a:lnTo>
                  <a:lnTo>
                    <a:pt x="18" y="24"/>
                  </a:lnTo>
                  <a:close/>
                  <a:moveTo>
                    <a:pt x="0" y="48"/>
                  </a:moveTo>
                  <a:lnTo>
                    <a:pt x="36" y="48"/>
                  </a:lnTo>
                  <a:lnTo>
                    <a:pt x="0" y="48"/>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IN"/>
            </a:p>
          </p:txBody>
        </p:sp>
        <p:sp>
          <p:nvSpPr>
            <p:cNvPr id="6" name="Freeform 69">
              <a:extLst>
                <a:ext uri="{FF2B5EF4-FFF2-40B4-BE49-F238E27FC236}">
                  <a16:creationId xmlns:a16="http://schemas.microsoft.com/office/drawing/2014/main" id="{0ECD6783-10DE-4293-B951-D53C0B58D3F9}"/>
                </a:ext>
              </a:extLst>
            </p:cNvPr>
            <p:cNvSpPr>
              <a:spLocks noEditPoints="1"/>
            </p:cNvSpPr>
            <p:nvPr/>
          </p:nvSpPr>
          <p:spPr bwMode="auto">
            <a:xfrm>
              <a:off x="7808264" y="1824080"/>
              <a:ext cx="57150" cy="411163"/>
            </a:xfrm>
            <a:custGeom>
              <a:avLst/>
              <a:gdLst>
                <a:gd name="T0" fmla="*/ 18 w 36"/>
                <a:gd name="T1" fmla="*/ 126 h 259"/>
                <a:gd name="T2" fmla="*/ 18 w 36"/>
                <a:gd name="T3" fmla="*/ 259 h 259"/>
                <a:gd name="T4" fmla="*/ 18 w 36"/>
                <a:gd name="T5" fmla="*/ 126 h 259"/>
                <a:gd name="T6" fmla="*/ 18 w 36"/>
                <a:gd name="T7" fmla="*/ 126 h 259"/>
                <a:gd name="T8" fmla="*/ 18 w 36"/>
                <a:gd name="T9" fmla="*/ 0 h 259"/>
                <a:gd name="T10" fmla="*/ 18 w 36"/>
                <a:gd name="T11" fmla="*/ 126 h 259"/>
                <a:gd name="T12" fmla="*/ 0 w 36"/>
                <a:gd name="T13" fmla="*/ 259 h 259"/>
                <a:gd name="T14" fmla="*/ 36 w 36"/>
                <a:gd name="T15" fmla="*/ 259 h 259"/>
                <a:gd name="T16" fmla="*/ 0 w 36"/>
                <a:gd name="T17" fmla="*/ 259 h 259"/>
                <a:gd name="T18" fmla="*/ 0 w 36"/>
                <a:gd name="T19" fmla="*/ 0 h 259"/>
                <a:gd name="T20" fmla="*/ 36 w 36"/>
                <a:gd name="T21" fmla="*/ 0 h 259"/>
                <a:gd name="T22" fmla="*/ 0 w 36"/>
                <a:gd name="T23" fmla="*/ 0 h 25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6" h="259">
                  <a:moveTo>
                    <a:pt x="18" y="126"/>
                  </a:moveTo>
                  <a:lnTo>
                    <a:pt x="18" y="259"/>
                  </a:lnTo>
                  <a:lnTo>
                    <a:pt x="18" y="126"/>
                  </a:lnTo>
                  <a:close/>
                  <a:moveTo>
                    <a:pt x="18" y="126"/>
                  </a:moveTo>
                  <a:lnTo>
                    <a:pt x="18" y="0"/>
                  </a:lnTo>
                  <a:lnTo>
                    <a:pt x="18" y="126"/>
                  </a:lnTo>
                  <a:close/>
                  <a:moveTo>
                    <a:pt x="0" y="259"/>
                  </a:moveTo>
                  <a:lnTo>
                    <a:pt x="36" y="259"/>
                  </a:lnTo>
                  <a:lnTo>
                    <a:pt x="0" y="259"/>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IN"/>
            </a:p>
          </p:txBody>
        </p:sp>
        <p:sp>
          <p:nvSpPr>
            <p:cNvPr id="7" name="TextBox 6">
              <a:extLst>
                <a:ext uri="{FF2B5EF4-FFF2-40B4-BE49-F238E27FC236}">
                  <a16:creationId xmlns:a16="http://schemas.microsoft.com/office/drawing/2014/main" id="{0571DFE8-A6AA-420B-9083-2A0560CB4282}"/>
                </a:ext>
              </a:extLst>
            </p:cNvPr>
            <p:cNvSpPr txBox="1"/>
            <p:nvPr/>
          </p:nvSpPr>
          <p:spPr>
            <a:xfrm>
              <a:off x="5847794" y="726778"/>
              <a:ext cx="2916481" cy="492443"/>
            </a:xfrm>
            <a:prstGeom prst="rect">
              <a:avLst/>
            </a:prstGeom>
            <a:noFill/>
          </p:spPr>
          <p:txBody>
            <a:bodyPr wrap="square" rtlCol="0">
              <a:spAutoFit/>
            </a:bodyPr>
            <a:lstStyle/>
            <a:p>
              <a:pPr algn="ctr"/>
              <a:r>
                <a:rPr lang="en-IN" sz="1300" dirty="0">
                  <a:latin typeface=" Calibri "/>
                </a:rPr>
                <a:t>NADPH dependent XTT reductase</a:t>
              </a:r>
            </a:p>
            <a:p>
              <a:pPr algn="ctr"/>
              <a:r>
                <a:rPr lang="en-IN" sz="1300" dirty="0">
                  <a:latin typeface=" Calibri "/>
                </a:rPr>
                <a:t>(soluble fraction)</a:t>
              </a:r>
            </a:p>
          </p:txBody>
        </p:sp>
        <p:sp>
          <p:nvSpPr>
            <p:cNvPr id="8" name="Rectangle 28">
              <a:extLst>
                <a:ext uri="{FF2B5EF4-FFF2-40B4-BE49-F238E27FC236}">
                  <a16:creationId xmlns:a16="http://schemas.microsoft.com/office/drawing/2014/main" id="{562D31B4-3703-4463-BF78-1C751670D6EF}"/>
                </a:ext>
              </a:extLst>
            </p:cNvPr>
            <p:cNvSpPr>
              <a:spLocks noChangeArrowheads="1"/>
            </p:cNvSpPr>
            <p:nvPr/>
          </p:nvSpPr>
          <p:spPr bwMode="auto">
            <a:xfrm>
              <a:off x="6457900" y="3395463"/>
              <a:ext cx="84479" cy="18312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r>
                <a:rPr lang="en-US" sz="1400" dirty="0">
                  <a:solidFill>
                    <a:srgbClr val="000000"/>
                  </a:solidFill>
                  <a:latin typeface="Calibri "/>
                  <a:cs typeface="Arial" pitchFamily="34" charset="0"/>
                </a:rPr>
                <a:t>0</a:t>
              </a:r>
              <a:endParaRPr lang="en-US" sz="1400" dirty="0">
                <a:latin typeface="Calibri "/>
                <a:cs typeface="Arial" pitchFamily="34" charset="0"/>
              </a:endParaRPr>
            </a:p>
          </p:txBody>
        </p:sp>
        <p:sp>
          <p:nvSpPr>
            <p:cNvPr id="9" name="Rectangle 33">
              <a:extLst>
                <a:ext uri="{FF2B5EF4-FFF2-40B4-BE49-F238E27FC236}">
                  <a16:creationId xmlns:a16="http://schemas.microsoft.com/office/drawing/2014/main" id="{275DD676-6752-4365-BFF8-D7C342BD683E}"/>
                </a:ext>
              </a:extLst>
            </p:cNvPr>
            <p:cNvSpPr>
              <a:spLocks noChangeArrowheads="1"/>
            </p:cNvSpPr>
            <p:nvPr/>
          </p:nvSpPr>
          <p:spPr bwMode="auto">
            <a:xfrm>
              <a:off x="6899056" y="3553553"/>
              <a:ext cx="94017" cy="1569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b="1" dirty="0">
                  <a:solidFill>
                    <a:srgbClr val="000000"/>
                  </a:solidFill>
                  <a:latin typeface="Calibri "/>
                  <a:cs typeface="Arial" pitchFamily="34" charset="0"/>
                </a:rPr>
                <a:t>C</a:t>
              </a:r>
              <a:endParaRPr lang="en-US" sz="1200" b="1" dirty="0">
                <a:latin typeface="Calibri "/>
                <a:cs typeface="Arial" pitchFamily="34" charset="0"/>
              </a:endParaRPr>
            </a:p>
          </p:txBody>
        </p:sp>
        <p:sp>
          <p:nvSpPr>
            <p:cNvPr id="10" name="Rectangle 34">
              <a:extLst>
                <a:ext uri="{FF2B5EF4-FFF2-40B4-BE49-F238E27FC236}">
                  <a16:creationId xmlns:a16="http://schemas.microsoft.com/office/drawing/2014/main" id="{4AD4CB43-0557-4A8B-9783-6CFEE3D87359}"/>
                </a:ext>
              </a:extLst>
            </p:cNvPr>
            <p:cNvSpPr>
              <a:spLocks noChangeArrowheads="1"/>
            </p:cNvSpPr>
            <p:nvPr/>
          </p:nvSpPr>
          <p:spPr bwMode="auto">
            <a:xfrm>
              <a:off x="7314427" y="3553553"/>
              <a:ext cx="166231" cy="1569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b="1" dirty="0">
                  <a:solidFill>
                    <a:srgbClr val="000000"/>
                  </a:solidFill>
                  <a:latin typeface="Calibri "/>
                  <a:cs typeface="Arial" pitchFamily="34" charset="0"/>
                </a:rPr>
                <a:t>As</a:t>
              </a:r>
              <a:endParaRPr lang="en-US" sz="1200" b="1" dirty="0">
                <a:latin typeface="Calibri "/>
                <a:cs typeface="Arial" pitchFamily="34" charset="0"/>
              </a:endParaRPr>
            </a:p>
          </p:txBody>
        </p:sp>
        <p:sp>
          <p:nvSpPr>
            <p:cNvPr id="11" name="Rectangle 35">
              <a:extLst>
                <a:ext uri="{FF2B5EF4-FFF2-40B4-BE49-F238E27FC236}">
                  <a16:creationId xmlns:a16="http://schemas.microsoft.com/office/drawing/2014/main" id="{595B4E3A-900B-4D8C-9442-D21C80E1C684}"/>
                </a:ext>
              </a:extLst>
            </p:cNvPr>
            <p:cNvSpPr>
              <a:spLocks noChangeArrowheads="1"/>
            </p:cNvSpPr>
            <p:nvPr/>
          </p:nvSpPr>
          <p:spPr bwMode="auto">
            <a:xfrm>
              <a:off x="7746770" y="3548790"/>
              <a:ext cx="246622" cy="1569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b="1" dirty="0">
                  <a:solidFill>
                    <a:srgbClr val="000000"/>
                  </a:solidFill>
                  <a:latin typeface="Calibri "/>
                  <a:cs typeface="Arial" pitchFamily="34" charset="0"/>
                </a:rPr>
                <a:t>Hpx</a:t>
              </a:r>
              <a:endParaRPr lang="en-US" sz="1200" b="1" dirty="0">
                <a:latin typeface="Calibri "/>
                <a:cs typeface="Arial" pitchFamily="34" charset="0"/>
              </a:endParaRPr>
            </a:p>
          </p:txBody>
        </p:sp>
        <p:sp>
          <p:nvSpPr>
            <p:cNvPr id="12" name="Rectangle 36">
              <a:extLst>
                <a:ext uri="{FF2B5EF4-FFF2-40B4-BE49-F238E27FC236}">
                  <a16:creationId xmlns:a16="http://schemas.microsoft.com/office/drawing/2014/main" id="{73970FE6-2D79-42FC-B897-8848177A639E}"/>
                </a:ext>
              </a:extLst>
            </p:cNvPr>
            <p:cNvSpPr>
              <a:spLocks noChangeArrowheads="1"/>
            </p:cNvSpPr>
            <p:nvPr/>
          </p:nvSpPr>
          <p:spPr bwMode="auto">
            <a:xfrm>
              <a:off x="8127843" y="3553553"/>
              <a:ext cx="412853" cy="1569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b="1" dirty="0">
                  <a:solidFill>
                    <a:srgbClr val="000000"/>
                  </a:solidFill>
                  <a:latin typeface="Calibri "/>
                  <a:cs typeface="Arial" pitchFamily="34" charset="0"/>
                </a:rPr>
                <a:t>HpxAs</a:t>
              </a:r>
              <a:endParaRPr lang="en-US" sz="1200" b="1" dirty="0">
                <a:latin typeface="Calibri "/>
                <a:cs typeface="Arial" pitchFamily="34" charset="0"/>
              </a:endParaRPr>
            </a:p>
          </p:txBody>
        </p:sp>
        <p:sp>
          <p:nvSpPr>
            <p:cNvPr id="13" name="TextBox 12">
              <a:extLst>
                <a:ext uri="{FF2B5EF4-FFF2-40B4-BE49-F238E27FC236}">
                  <a16:creationId xmlns:a16="http://schemas.microsoft.com/office/drawing/2014/main" id="{0428E957-ED3D-48D8-A7E3-488BB8185CF5}"/>
                </a:ext>
              </a:extLst>
            </p:cNvPr>
            <p:cNvSpPr txBox="1"/>
            <p:nvPr/>
          </p:nvSpPr>
          <p:spPr>
            <a:xfrm rot="16200000">
              <a:off x="4500448" y="2165199"/>
              <a:ext cx="2822770" cy="461665"/>
            </a:xfrm>
            <a:prstGeom prst="rect">
              <a:avLst/>
            </a:prstGeom>
            <a:noFill/>
          </p:spPr>
          <p:txBody>
            <a:bodyPr wrap="square" rtlCol="0">
              <a:spAutoFit/>
            </a:bodyPr>
            <a:lstStyle/>
            <a:p>
              <a:pPr algn="ctr"/>
              <a:r>
                <a:rPr lang="en-IN" sz="1200" b="1" dirty="0">
                  <a:latin typeface="Calibri "/>
                </a:rPr>
                <a:t>XTT reductase activity </a:t>
              </a:r>
            </a:p>
            <a:p>
              <a:pPr algn="ctr"/>
              <a:r>
                <a:rPr lang="en-IN" sz="1200" b="1" dirty="0">
                  <a:latin typeface="Calibri "/>
                </a:rPr>
                <a:t>(nmoles min</a:t>
              </a:r>
              <a:r>
                <a:rPr lang="en-IN" sz="1200" b="1" baseline="30000" dirty="0">
                  <a:latin typeface="Calibri "/>
                </a:rPr>
                <a:t>-1</a:t>
              </a:r>
              <a:r>
                <a:rPr lang="en-IN" sz="1200" b="1" dirty="0">
                  <a:latin typeface="Calibri "/>
                </a:rPr>
                <a:t> mg</a:t>
              </a:r>
              <a:r>
                <a:rPr lang="en-IN" sz="1200" b="1" baseline="30000" dirty="0">
                  <a:latin typeface="Calibri "/>
                </a:rPr>
                <a:t>-1</a:t>
              </a:r>
              <a:r>
                <a:rPr lang="en-IN" sz="1200" b="1" dirty="0">
                  <a:latin typeface="Calibri "/>
                </a:rPr>
                <a:t> protein)</a:t>
              </a:r>
            </a:p>
          </p:txBody>
        </p:sp>
        <p:cxnSp>
          <p:nvCxnSpPr>
            <p:cNvPr id="14" name="Gerade Verbindung mit Pfeil 2">
              <a:extLst>
                <a:ext uri="{FF2B5EF4-FFF2-40B4-BE49-F238E27FC236}">
                  <a16:creationId xmlns:a16="http://schemas.microsoft.com/office/drawing/2014/main" id="{E248DCA2-D50F-4F67-8976-38259941E2ED}"/>
                </a:ext>
              </a:extLst>
            </p:cNvPr>
            <p:cNvCxnSpPr/>
            <p:nvPr/>
          </p:nvCxnSpPr>
          <p:spPr>
            <a:xfrm>
              <a:off x="6633378" y="3492615"/>
              <a:ext cx="1986208" cy="0"/>
            </a:xfrm>
            <a:prstGeom prst="straightConnector1">
              <a:avLst/>
            </a:prstGeom>
            <a:ln w="127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5" name="Rectangle 24">
              <a:extLst>
                <a:ext uri="{FF2B5EF4-FFF2-40B4-BE49-F238E27FC236}">
                  <a16:creationId xmlns:a16="http://schemas.microsoft.com/office/drawing/2014/main" id="{D4AC9025-B379-4AFB-ADC3-5C1F52ACDCEF}"/>
                </a:ext>
              </a:extLst>
            </p:cNvPr>
            <p:cNvSpPr>
              <a:spLocks noChangeArrowheads="1"/>
            </p:cNvSpPr>
            <p:nvPr/>
          </p:nvSpPr>
          <p:spPr bwMode="auto">
            <a:xfrm>
              <a:off x="6634490" y="1316418"/>
              <a:ext cx="0" cy="2166480"/>
            </a:xfrm>
            <a:prstGeom prst="rect">
              <a:avLst/>
            </a:prstGeom>
            <a:solidFill>
              <a:srgbClr val="868686"/>
            </a:solidFill>
            <a:ln w="635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dirty="0"/>
            </a:p>
          </p:txBody>
        </p:sp>
        <p:sp>
          <p:nvSpPr>
            <p:cNvPr id="16" name="Freeform 25">
              <a:extLst>
                <a:ext uri="{FF2B5EF4-FFF2-40B4-BE49-F238E27FC236}">
                  <a16:creationId xmlns:a16="http://schemas.microsoft.com/office/drawing/2014/main" id="{87360A50-659D-4805-98C7-5858E4AC40C4}"/>
                </a:ext>
              </a:extLst>
            </p:cNvPr>
            <p:cNvSpPr>
              <a:spLocks noEditPoints="1"/>
            </p:cNvSpPr>
            <p:nvPr/>
          </p:nvSpPr>
          <p:spPr bwMode="auto">
            <a:xfrm>
              <a:off x="6586069" y="1570043"/>
              <a:ext cx="48495" cy="1926672"/>
            </a:xfrm>
            <a:custGeom>
              <a:avLst/>
              <a:gdLst/>
              <a:ahLst/>
              <a:cxnLst>
                <a:cxn ang="0">
                  <a:pos x="0" y="1152"/>
                </a:cxn>
                <a:cxn ang="0">
                  <a:pos x="30" y="1152"/>
                </a:cxn>
                <a:cxn ang="0">
                  <a:pos x="30" y="1158"/>
                </a:cxn>
                <a:cxn ang="0">
                  <a:pos x="0" y="1158"/>
                </a:cxn>
                <a:cxn ang="0">
                  <a:pos x="0" y="1152"/>
                </a:cxn>
                <a:cxn ang="0">
                  <a:pos x="0" y="576"/>
                </a:cxn>
                <a:cxn ang="0">
                  <a:pos x="30" y="576"/>
                </a:cxn>
                <a:cxn ang="0">
                  <a:pos x="30" y="582"/>
                </a:cxn>
                <a:cxn ang="0">
                  <a:pos x="0" y="582"/>
                </a:cxn>
                <a:cxn ang="0">
                  <a:pos x="0" y="576"/>
                </a:cxn>
                <a:cxn ang="0">
                  <a:pos x="0" y="0"/>
                </a:cxn>
                <a:cxn ang="0">
                  <a:pos x="30" y="0"/>
                </a:cxn>
                <a:cxn ang="0">
                  <a:pos x="30" y="6"/>
                </a:cxn>
                <a:cxn ang="0">
                  <a:pos x="0" y="6"/>
                </a:cxn>
                <a:cxn ang="0">
                  <a:pos x="0" y="0"/>
                </a:cxn>
              </a:cxnLst>
              <a:rect l="0" t="0" r="r" b="b"/>
              <a:pathLst>
                <a:path w="30" h="1158">
                  <a:moveTo>
                    <a:pt x="0" y="1152"/>
                  </a:moveTo>
                  <a:lnTo>
                    <a:pt x="30" y="1152"/>
                  </a:lnTo>
                  <a:lnTo>
                    <a:pt x="30" y="1158"/>
                  </a:lnTo>
                  <a:lnTo>
                    <a:pt x="0" y="1158"/>
                  </a:lnTo>
                  <a:lnTo>
                    <a:pt x="0" y="1152"/>
                  </a:lnTo>
                  <a:close/>
                  <a:moveTo>
                    <a:pt x="0" y="576"/>
                  </a:moveTo>
                  <a:lnTo>
                    <a:pt x="30" y="576"/>
                  </a:lnTo>
                  <a:lnTo>
                    <a:pt x="30" y="582"/>
                  </a:lnTo>
                  <a:lnTo>
                    <a:pt x="0" y="582"/>
                  </a:lnTo>
                  <a:lnTo>
                    <a:pt x="0" y="576"/>
                  </a:lnTo>
                  <a:close/>
                  <a:moveTo>
                    <a:pt x="0" y="0"/>
                  </a:moveTo>
                  <a:lnTo>
                    <a:pt x="30" y="0"/>
                  </a:lnTo>
                  <a:lnTo>
                    <a:pt x="30" y="6"/>
                  </a:lnTo>
                  <a:lnTo>
                    <a:pt x="0" y="6"/>
                  </a:lnTo>
                  <a:lnTo>
                    <a:pt x="0" y="0"/>
                  </a:lnTo>
                  <a:close/>
                </a:path>
              </a:pathLst>
            </a:custGeom>
            <a:solidFill>
              <a:schemeClr val="tx1"/>
            </a:solidFill>
            <a:ln w="635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dirty="0"/>
            </a:p>
          </p:txBody>
        </p:sp>
        <p:sp>
          <p:nvSpPr>
            <p:cNvPr id="17" name="Rectangle 16">
              <a:extLst>
                <a:ext uri="{FF2B5EF4-FFF2-40B4-BE49-F238E27FC236}">
                  <a16:creationId xmlns:a16="http://schemas.microsoft.com/office/drawing/2014/main" id="{E737399B-8799-4C23-B351-D2AF1E115BAF}"/>
                </a:ext>
              </a:extLst>
            </p:cNvPr>
            <p:cNvSpPr>
              <a:spLocks noChangeArrowheads="1"/>
            </p:cNvSpPr>
            <p:nvPr/>
          </p:nvSpPr>
          <p:spPr bwMode="auto">
            <a:xfrm>
              <a:off x="6331538" y="2451921"/>
              <a:ext cx="235641" cy="1846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Calibri "/>
                  <a:cs typeface="Arial" pitchFamily="34" charset="0"/>
                </a:rPr>
                <a:t>200</a:t>
              </a:r>
              <a:endParaRPr kumimoji="0" lang="en-US" sz="1200" b="0" i="0" u="none" strike="noStrike" cap="none" normalizeH="0" baseline="0" dirty="0">
                <a:ln>
                  <a:noFill/>
                </a:ln>
                <a:solidFill>
                  <a:schemeClr val="tx1"/>
                </a:solidFill>
                <a:effectLst/>
                <a:latin typeface="Calibri "/>
                <a:cs typeface="Arial" pitchFamily="34" charset="0"/>
              </a:endParaRPr>
            </a:p>
          </p:txBody>
        </p:sp>
        <p:sp>
          <p:nvSpPr>
            <p:cNvPr id="18" name="Rectangle 17">
              <a:extLst>
                <a:ext uri="{FF2B5EF4-FFF2-40B4-BE49-F238E27FC236}">
                  <a16:creationId xmlns:a16="http://schemas.microsoft.com/office/drawing/2014/main" id="{DB7440D5-0EDB-4934-AFC9-FCBAEAB40B6A}"/>
                </a:ext>
              </a:extLst>
            </p:cNvPr>
            <p:cNvSpPr>
              <a:spLocks noChangeArrowheads="1"/>
            </p:cNvSpPr>
            <p:nvPr/>
          </p:nvSpPr>
          <p:spPr bwMode="auto">
            <a:xfrm>
              <a:off x="6316297" y="1493185"/>
              <a:ext cx="235642" cy="1846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200" b="0" i="0" u="none" strike="noStrike" cap="none" normalizeH="0" baseline="0" dirty="0">
                  <a:ln>
                    <a:noFill/>
                  </a:ln>
                  <a:solidFill>
                    <a:srgbClr val="000000"/>
                  </a:solidFill>
                  <a:effectLst/>
                  <a:latin typeface="Calibri "/>
                  <a:cs typeface="Arial" pitchFamily="34" charset="0"/>
                </a:rPr>
                <a:t>400</a:t>
              </a:r>
              <a:endParaRPr kumimoji="0" lang="en-US" sz="1200" b="0" i="0" u="none" strike="noStrike" cap="none" normalizeH="0" baseline="0" dirty="0">
                <a:ln>
                  <a:noFill/>
                </a:ln>
                <a:solidFill>
                  <a:schemeClr val="tx1"/>
                </a:solidFill>
                <a:effectLst/>
                <a:latin typeface="Calibri "/>
                <a:cs typeface="Arial" pitchFamily="34" charset="0"/>
              </a:endParaRPr>
            </a:p>
          </p:txBody>
        </p:sp>
        <p:grpSp>
          <p:nvGrpSpPr>
            <p:cNvPr id="19" name="Group 18">
              <a:extLst>
                <a:ext uri="{FF2B5EF4-FFF2-40B4-BE49-F238E27FC236}">
                  <a16:creationId xmlns:a16="http://schemas.microsoft.com/office/drawing/2014/main" id="{3D11511F-095C-4ADC-8DD1-2D566108EA3A}"/>
                </a:ext>
              </a:extLst>
            </p:cNvPr>
            <p:cNvGrpSpPr/>
            <p:nvPr/>
          </p:nvGrpSpPr>
          <p:grpSpPr>
            <a:xfrm>
              <a:off x="6800888" y="2113151"/>
              <a:ext cx="290970" cy="1373828"/>
              <a:chOff x="9709847" y="4283075"/>
              <a:chExt cx="290970" cy="1373828"/>
            </a:xfrm>
          </p:grpSpPr>
          <p:sp>
            <p:nvSpPr>
              <p:cNvPr id="29" name="Rectangle 28">
                <a:extLst>
                  <a:ext uri="{FF2B5EF4-FFF2-40B4-BE49-F238E27FC236}">
                    <a16:creationId xmlns:a16="http://schemas.microsoft.com/office/drawing/2014/main" id="{9C8FD83D-0D93-4AD4-9E76-82364E521067}"/>
                  </a:ext>
                </a:extLst>
              </p:cNvPr>
              <p:cNvSpPr>
                <a:spLocks noChangeArrowheads="1"/>
              </p:cNvSpPr>
              <p:nvPr/>
            </p:nvSpPr>
            <p:spPr bwMode="auto">
              <a:xfrm>
                <a:off x="9709847" y="4461703"/>
                <a:ext cx="290970" cy="1195200"/>
              </a:xfrm>
              <a:prstGeom prst="rect">
                <a:avLst/>
              </a:prstGeom>
              <a:solidFill>
                <a:srgbClr val="F5F5F5"/>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30" name="Freeform 122">
                <a:extLst>
                  <a:ext uri="{FF2B5EF4-FFF2-40B4-BE49-F238E27FC236}">
                    <a16:creationId xmlns:a16="http://schemas.microsoft.com/office/drawing/2014/main" id="{CD76B286-78DD-4FA0-9084-8D4FD5B2E46E}"/>
                  </a:ext>
                </a:extLst>
              </p:cNvPr>
              <p:cNvSpPr>
                <a:spLocks noEditPoints="1"/>
              </p:cNvSpPr>
              <p:nvPr/>
            </p:nvSpPr>
            <p:spPr bwMode="auto">
              <a:xfrm>
                <a:off x="9826625" y="4283075"/>
                <a:ext cx="57150" cy="344488"/>
              </a:xfrm>
              <a:custGeom>
                <a:avLst/>
                <a:gdLst>
                  <a:gd name="T0" fmla="*/ 18 w 36"/>
                  <a:gd name="T1" fmla="*/ 109 h 217"/>
                  <a:gd name="T2" fmla="*/ 18 w 36"/>
                  <a:gd name="T3" fmla="*/ 217 h 217"/>
                  <a:gd name="T4" fmla="*/ 18 w 36"/>
                  <a:gd name="T5" fmla="*/ 109 h 217"/>
                  <a:gd name="T6" fmla="*/ 18 w 36"/>
                  <a:gd name="T7" fmla="*/ 0 h 217"/>
                  <a:gd name="T8" fmla="*/ 0 w 36"/>
                  <a:gd name="T9" fmla="*/ 217 h 217"/>
                  <a:gd name="T10" fmla="*/ 36 w 36"/>
                  <a:gd name="T11" fmla="*/ 217 h 217"/>
                  <a:gd name="T12" fmla="*/ 0 w 36"/>
                  <a:gd name="T13" fmla="*/ 0 h 217"/>
                  <a:gd name="T14" fmla="*/ 36 w 36"/>
                  <a:gd name="T15" fmla="*/ 0 h 217"/>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217">
                    <a:moveTo>
                      <a:pt x="18" y="109"/>
                    </a:moveTo>
                    <a:lnTo>
                      <a:pt x="18" y="217"/>
                    </a:lnTo>
                    <a:moveTo>
                      <a:pt x="18" y="109"/>
                    </a:moveTo>
                    <a:lnTo>
                      <a:pt x="18" y="0"/>
                    </a:lnTo>
                    <a:moveTo>
                      <a:pt x="0" y="217"/>
                    </a:moveTo>
                    <a:lnTo>
                      <a:pt x="36" y="217"/>
                    </a:lnTo>
                    <a:moveTo>
                      <a:pt x="0" y="0"/>
                    </a:moveTo>
                    <a:lnTo>
                      <a:pt x="36" y="0"/>
                    </a:lnTo>
                  </a:path>
                </a:pathLst>
              </a:custGeom>
              <a:noFill/>
              <a:ln w="9525"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nvGrpSpPr>
            <p:cNvPr id="20" name="Group 19">
              <a:extLst>
                <a:ext uri="{FF2B5EF4-FFF2-40B4-BE49-F238E27FC236}">
                  <a16:creationId xmlns:a16="http://schemas.microsoft.com/office/drawing/2014/main" id="{C732BD53-9D94-4734-BC4D-E1D59E5BF513}"/>
                </a:ext>
              </a:extLst>
            </p:cNvPr>
            <p:cNvGrpSpPr/>
            <p:nvPr/>
          </p:nvGrpSpPr>
          <p:grpSpPr>
            <a:xfrm>
              <a:off x="7244934" y="2592976"/>
              <a:ext cx="310369" cy="897181"/>
              <a:chOff x="10709665" y="4750588"/>
              <a:chExt cx="310369" cy="897181"/>
            </a:xfrm>
          </p:grpSpPr>
          <p:sp>
            <p:nvSpPr>
              <p:cNvPr id="27" name="Rectangle 8">
                <a:extLst>
                  <a:ext uri="{FF2B5EF4-FFF2-40B4-BE49-F238E27FC236}">
                    <a16:creationId xmlns:a16="http://schemas.microsoft.com/office/drawing/2014/main" id="{DBDB33CE-103D-47DE-B452-DF7EF684E1C9}"/>
                  </a:ext>
                </a:extLst>
              </p:cNvPr>
              <p:cNvSpPr>
                <a:spLocks noChangeArrowheads="1"/>
              </p:cNvSpPr>
              <p:nvPr/>
            </p:nvSpPr>
            <p:spPr bwMode="auto">
              <a:xfrm>
                <a:off x="10709665" y="4794569"/>
                <a:ext cx="310369" cy="853200"/>
              </a:xfrm>
              <a:prstGeom prst="rect">
                <a:avLst/>
              </a:prstGeom>
              <a:solidFill>
                <a:srgbClr val="E5F5E0"/>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28" name="Freeform 124">
                <a:extLst>
                  <a:ext uri="{FF2B5EF4-FFF2-40B4-BE49-F238E27FC236}">
                    <a16:creationId xmlns:a16="http://schemas.microsoft.com/office/drawing/2014/main" id="{3312A2C5-A6C5-4358-A6C7-769CF6C6A1B4}"/>
                  </a:ext>
                </a:extLst>
              </p:cNvPr>
              <p:cNvSpPr>
                <a:spLocks noEditPoints="1"/>
              </p:cNvSpPr>
              <p:nvPr/>
            </p:nvSpPr>
            <p:spPr bwMode="auto">
              <a:xfrm>
                <a:off x="10832302" y="4750588"/>
                <a:ext cx="57150" cy="85725"/>
              </a:xfrm>
              <a:custGeom>
                <a:avLst/>
                <a:gdLst>
                  <a:gd name="T0" fmla="*/ 18 w 36"/>
                  <a:gd name="T1" fmla="*/ 24 h 54"/>
                  <a:gd name="T2" fmla="*/ 18 w 36"/>
                  <a:gd name="T3" fmla="*/ 54 h 54"/>
                  <a:gd name="T4" fmla="*/ 18 w 36"/>
                  <a:gd name="T5" fmla="*/ 24 h 54"/>
                  <a:gd name="T6" fmla="*/ 18 w 36"/>
                  <a:gd name="T7" fmla="*/ 0 h 54"/>
                  <a:gd name="T8" fmla="*/ 0 w 36"/>
                  <a:gd name="T9" fmla="*/ 54 h 54"/>
                  <a:gd name="T10" fmla="*/ 36 w 36"/>
                  <a:gd name="T11" fmla="*/ 54 h 54"/>
                  <a:gd name="T12" fmla="*/ 0 w 36"/>
                  <a:gd name="T13" fmla="*/ 0 h 54"/>
                  <a:gd name="T14" fmla="*/ 36 w 36"/>
                  <a:gd name="T15" fmla="*/ 0 h 54"/>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54">
                    <a:moveTo>
                      <a:pt x="18" y="24"/>
                    </a:moveTo>
                    <a:lnTo>
                      <a:pt x="18" y="54"/>
                    </a:lnTo>
                    <a:moveTo>
                      <a:pt x="18" y="24"/>
                    </a:moveTo>
                    <a:lnTo>
                      <a:pt x="18" y="0"/>
                    </a:lnTo>
                    <a:moveTo>
                      <a:pt x="0" y="54"/>
                    </a:moveTo>
                    <a:lnTo>
                      <a:pt x="36" y="54"/>
                    </a:lnTo>
                    <a:moveTo>
                      <a:pt x="0" y="0"/>
                    </a:moveTo>
                    <a:lnTo>
                      <a:pt x="36" y="0"/>
                    </a:lnTo>
                  </a:path>
                </a:pathLst>
              </a:custGeom>
              <a:noFill/>
              <a:ln w="9525"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nvGrpSpPr>
            <p:cNvPr id="21" name="Group 20">
              <a:extLst>
                <a:ext uri="{FF2B5EF4-FFF2-40B4-BE49-F238E27FC236}">
                  <a16:creationId xmlns:a16="http://schemas.microsoft.com/office/drawing/2014/main" id="{207875A5-CFDB-4369-B301-3199FE4238EE}"/>
                </a:ext>
              </a:extLst>
            </p:cNvPr>
            <p:cNvGrpSpPr/>
            <p:nvPr/>
          </p:nvGrpSpPr>
          <p:grpSpPr>
            <a:xfrm>
              <a:off x="7721217" y="1491367"/>
              <a:ext cx="300669" cy="1996108"/>
              <a:chOff x="11736072" y="3659188"/>
              <a:chExt cx="300669" cy="1996108"/>
            </a:xfrm>
          </p:grpSpPr>
          <p:sp>
            <p:nvSpPr>
              <p:cNvPr id="25" name="Rectangle 24">
                <a:extLst>
                  <a:ext uri="{FF2B5EF4-FFF2-40B4-BE49-F238E27FC236}">
                    <a16:creationId xmlns:a16="http://schemas.microsoft.com/office/drawing/2014/main" id="{37E64C27-4A90-43B0-B335-67135206CA21}"/>
                  </a:ext>
                </a:extLst>
              </p:cNvPr>
              <p:cNvSpPr>
                <a:spLocks noChangeArrowheads="1"/>
              </p:cNvSpPr>
              <p:nvPr/>
            </p:nvSpPr>
            <p:spPr bwMode="auto">
              <a:xfrm>
                <a:off x="11736072" y="3966896"/>
                <a:ext cx="300669" cy="1688400"/>
              </a:xfrm>
              <a:prstGeom prst="rect">
                <a:avLst/>
              </a:prstGeom>
              <a:solidFill>
                <a:srgbClr val="A1D99B"/>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dirty="0"/>
              </a:p>
            </p:txBody>
          </p:sp>
          <p:sp>
            <p:nvSpPr>
              <p:cNvPr id="26" name="Freeform 126">
                <a:extLst>
                  <a:ext uri="{FF2B5EF4-FFF2-40B4-BE49-F238E27FC236}">
                    <a16:creationId xmlns:a16="http://schemas.microsoft.com/office/drawing/2014/main" id="{F924839B-6619-4241-BA27-51F8CCF5735E}"/>
                  </a:ext>
                </a:extLst>
              </p:cNvPr>
              <p:cNvSpPr>
                <a:spLocks noEditPoints="1"/>
              </p:cNvSpPr>
              <p:nvPr/>
            </p:nvSpPr>
            <p:spPr bwMode="auto">
              <a:xfrm>
                <a:off x="11857037" y="3659188"/>
                <a:ext cx="58738" cy="620713"/>
              </a:xfrm>
              <a:custGeom>
                <a:avLst/>
                <a:gdLst>
                  <a:gd name="T0" fmla="*/ 19 w 37"/>
                  <a:gd name="T1" fmla="*/ 193 h 391"/>
                  <a:gd name="T2" fmla="*/ 19 w 37"/>
                  <a:gd name="T3" fmla="*/ 391 h 391"/>
                  <a:gd name="T4" fmla="*/ 19 w 37"/>
                  <a:gd name="T5" fmla="*/ 193 h 391"/>
                  <a:gd name="T6" fmla="*/ 19 w 37"/>
                  <a:gd name="T7" fmla="*/ 0 h 391"/>
                  <a:gd name="T8" fmla="*/ 0 w 37"/>
                  <a:gd name="T9" fmla="*/ 391 h 391"/>
                  <a:gd name="T10" fmla="*/ 37 w 37"/>
                  <a:gd name="T11" fmla="*/ 391 h 391"/>
                  <a:gd name="T12" fmla="*/ 0 w 37"/>
                  <a:gd name="T13" fmla="*/ 0 h 391"/>
                  <a:gd name="T14" fmla="*/ 37 w 37"/>
                  <a:gd name="T15" fmla="*/ 0 h 391"/>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7" h="391">
                    <a:moveTo>
                      <a:pt x="19" y="193"/>
                    </a:moveTo>
                    <a:lnTo>
                      <a:pt x="19" y="391"/>
                    </a:lnTo>
                    <a:moveTo>
                      <a:pt x="19" y="193"/>
                    </a:moveTo>
                    <a:lnTo>
                      <a:pt x="19" y="0"/>
                    </a:lnTo>
                    <a:moveTo>
                      <a:pt x="0" y="391"/>
                    </a:moveTo>
                    <a:lnTo>
                      <a:pt x="37" y="391"/>
                    </a:lnTo>
                    <a:moveTo>
                      <a:pt x="0" y="0"/>
                    </a:moveTo>
                    <a:lnTo>
                      <a:pt x="37" y="0"/>
                    </a:lnTo>
                  </a:path>
                </a:pathLst>
              </a:custGeom>
              <a:noFill/>
              <a:ln w="9525"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dirty="0"/>
              </a:p>
            </p:txBody>
          </p:sp>
        </p:grpSp>
        <p:grpSp>
          <p:nvGrpSpPr>
            <p:cNvPr id="22" name="Group 21">
              <a:extLst>
                <a:ext uri="{FF2B5EF4-FFF2-40B4-BE49-F238E27FC236}">
                  <a16:creationId xmlns:a16="http://schemas.microsoft.com/office/drawing/2014/main" id="{169C9C83-700A-4622-B749-5827CC93C813}"/>
                </a:ext>
              </a:extLst>
            </p:cNvPr>
            <p:cNvGrpSpPr/>
            <p:nvPr/>
          </p:nvGrpSpPr>
          <p:grpSpPr>
            <a:xfrm>
              <a:off x="8182077" y="1924347"/>
              <a:ext cx="300669" cy="1562891"/>
              <a:chOff x="12750484" y="4086821"/>
              <a:chExt cx="300669" cy="1562891"/>
            </a:xfrm>
          </p:grpSpPr>
          <p:sp>
            <p:nvSpPr>
              <p:cNvPr id="23" name="Rectangle 22">
                <a:extLst>
                  <a:ext uri="{FF2B5EF4-FFF2-40B4-BE49-F238E27FC236}">
                    <a16:creationId xmlns:a16="http://schemas.microsoft.com/office/drawing/2014/main" id="{0B467A37-1B84-42C4-8E47-71ACEABBF355}"/>
                  </a:ext>
                </a:extLst>
              </p:cNvPr>
              <p:cNvSpPr>
                <a:spLocks noChangeArrowheads="1"/>
              </p:cNvSpPr>
              <p:nvPr/>
            </p:nvSpPr>
            <p:spPr bwMode="auto">
              <a:xfrm>
                <a:off x="12750484" y="4339312"/>
                <a:ext cx="300669" cy="1310400"/>
              </a:xfrm>
              <a:prstGeom prst="rect">
                <a:avLst/>
              </a:prstGeom>
              <a:solidFill>
                <a:srgbClr val="31A354"/>
              </a:solidFill>
              <a:ln w="63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b="1" dirty="0"/>
              </a:p>
            </p:txBody>
          </p:sp>
          <p:sp>
            <p:nvSpPr>
              <p:cNvPr id="24" name="Freeform 128">
                <a:extLst>
                  <a:ext uri="{FF2B5EF4-FFF2-40B4-BE49-F238E27FC236}">
                    <a16:creationId xmlns:a16="http://schemas.microsoft.com/office/drawing/2014/main" id="{349B936A-DF5D-4435-AB46-8BCA03EACC7E}"/>
                  </a:ext>
                </a:extLst>
              </p:cNvPr>
              <p:cNvSpPr>
                <a:spLocks noEditPoints="1"/>
              </p:cNvSpPr>
              <p:nvPr/>
            </p:nvSpPr>
            <p:spPr bwMode="auto">
              <a:xfrm>
                <a:off x="12873832" y="4086821"/>
                <a:ext cx="57150" cy="496888"/>
              </a:xfrm>
              <a:custGeom>
                <a:avLst/>
                <a:gdLst>
                  <a:gd name="T0" fmla="*/ 18 w 36"/>
                  <a:gd name="T1" fmla="*/ 156 h 313"/>
                  <a:gd name="T2" fmla="*/ 18 w 36"/>
                  <a:gd name="T3" fmla="*/ 313 h 313"/>
                  <a:gd name="T4" fmla="*/ 18 w 36"/>
                  <a:gd name="T5" fmla="*/ 156 h 313"/>
                  <a:gd name="T6" fmla="*/ 18 w 36"/>
                  <a:gd name="T7" fmla="*/ 0 h 313"/>
                  <a:gd name="T8" fmla="*/ 0 w 36"/>
                  <a:gd name="T9" fmla="*/ 313 h 313"/>
                  <a:gd name="T10" fmla="*/ 36 w 36"/>
                  <a:gd name="T11" fmla="*/ 313 h 313"/>
                  <a:gd name="T12" fmla="*/ 0 w 36"/>
                  <a:gd name="T13" fmla="*/ 0 h 313"/>
                  <a:gd name="T14" fmla="*/ 36 w 36"/>
                  <a:gd name="T15" fmla="*/ 0 h 313"/>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313">
                    <a:moveTo>
                      <a:pt x="18" y="156"/>
                    </a:moveTo>
                    <a:lnTo>
                      <a:pt x="18" y="313"/>
                    </a:lnTo>
                    <a:moveTo>
                      <a:pt x="18" y="156"/>
                    </a:moveTo>
                    <a:lnTo>
                      <a:pt x="18" y="0"/>
                    </a:lnTo>
                    <a:moveTo>
                      <a:pt x="0" y="313"/>
                    </a:moveTo>
                    <a:lnTo>
                      <a:pt x="36" y="313"/>
                    </a:lnTo>
                    <a:moveTo>
                      <a:pt x="0" y="0"/>
                    </a:moveTo>
                    <a:lnTo>
                      <a:pt x="36" y="0"/>
                    </a:lnTo>
                  </a:path>
                </a:pathLst>
              </a:custGeom>
              <a:noFill/>
              <a:ln w="9525"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dirty="0"/>
              </a:p>
            </p:txBody>
          </p:sp>
        </p:grpSp>
      </p:grpSp>
      <p:sp>
        <p:nvSpPr>
          <p:cNvPr id="32" name="Rechteck 1375">
            <a:extLst>
              <a:ext uri="{FF2B5EF4-FFF2-40B4-BE49-F238E27FC236}">
                <a16:creationId xmlns:a16="http://schemas.microsoft.com/office/drawing/2014/main" id="{130A4858-F547-4D8C-A2FF-082E5E9C6F7E}"/>
              </a:ext>
            </a:extLst>
          </p:cNvPr>
          <p:cNvSpPr/>
          <p:nvPr/>
        </p:nvSpPr>
        <p:spPr>
          <a:xfrm>
            <a:off x="1354202" y="4357006"/>
            <a:ext cx="6013710" cy="1384995"/>
          </a:xfrm>
          <a:prstGeom prst="rect">
            <a:avLst/>
          </a:prstGeom>
        </p:spPr>
        <p:txBody>
          <a:bodyPr wrap="square">
            <a:spAutoFit/>
          </a:bodyPr>
          <a:lstStyle/>
          <a:p>
            <a:pPr marL="1079500" indent="-1079500" algn="just"/>
            <a:r>
              <a:rPr lang="en-US" sz="1200" b="1" dirty="0">
                <a:latin typeface="Times New Roman" panose="02020603050405020304" pitchFamily="18" charset="0"/>
                <a:cs typeface="Times New Roman" panose="02020603050405020304" pitchFamily="18" charset="0"/>
              </a:rPr>
              <a:t>Suppl. Figure 3:	XTT reductase activity as a confirmatory test for contamination of membrane crude fraction. </a:t>
            </a:r>
            <a:r>
              <a:rPr lang="en-US" sz="1200" dirty="0">
                <a:latin typeface="Times New Roman" panose="02020603050405020304" pitchFamily="18" charset="0"/>
                <a:ea typeface="Calibri" panose="020F0502020204030204" pitchFamily="34" charset="0"/>
                <a:cs typeface="Times New Roman" panose="02020603050405020304" pitchFamily="18" charset="0"/>
              </a:rPr>
              <a:t>NADPH dependent XTT reductase activity was measured in crude membrane extracts to analyze stress effects on NADPH oxidases (Fig. 7). In parallel, soluble plant proteins from the same extraction were utilized to again measure XTT reductase activity in order to ascertain potential contamination of the crude membrane extract by soluble proteins. Data are means±SE, n=6 (3 independent experiments; Tukey’s test, p&lt;0.05). </a:t>
            </a:r>
            <a:r>
              <a:rPr lang="en-US" sz="1200" dirty="0">
                <a:latin typeface="Times New Roman" panose="02020603050405020304" pitchFamily="18" charset="0"/>
                <a:cs typeface="Times New Roman" panose="02020603050405020304" pitchFamily="18" charset="0"/>
              </a:rPr>
              <a:t> </a:t>
            </a:r>
            <a:endParaRPr lang="de-D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004453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F6744776-F5AF-4DD2-985B-26AAFB44076B}"/>
              </a:ext>
            </a:extLst>
          </p:cNvPr>
          <p:cNvSpPr txBox="1"/>
          <p:nvPr/>
        </p:nvSpPr>
        <p:spPr>
          <a:xfrm>
            <a:off x="624670" y="5092948"/>
            <a:ext cx="7964997" cy="1569660"/>
          </a:xfrm>
          <a:prstGeom prst="rect">
            <a:avLst/>
          </a:prstGeom>
          <a:noFill/>
        </p:spPr>
        <p:txBody>
          <a:bodyPr wrap="square" rtlCol="0">
            <a:spAutoFit/>
          </a:bodyPr>
          <a:lstStyle/>
          <a:p>
            <a:pPr marL="1077913" indent="-1077913" algn="just" defTabSz="1617663"/>
            <a:r>
              <a:rPr lang="en-IN" sz="1200" b="1" dirty="0">
                <a:latin typeface="Times New Roman" panose="02020603050405020304" pitchFamily="18" charset="0"/>
                <a:cs typeface="Times New Roman" panose="02020603050405020304" pitchFamily="18" charset="0"/>
              </a:rPr>
              <a:t>Supp. Figure 4:	Fluorescence based analysis for ROS generation and accumulation in different cell layers in root hair zone of differentially treated Arabidopsis roots. </a:t>
            </a:r>
            <a:r>
              <a:rPr lang="en-IN" sz="1200" dirty="0">
                <a:latin typeface="Times New Roman" panose="02020603050405020304" pitchFamily="18" charset="0"/>
                <a:cs typeface="Times New Roman" panose="02020603050405020304" pitchFamily="18" charset="0"/>
              </a:rPr>
              <a:t>Redox signalling and associated ROX generating and sequestering pathways play a crucial role in root development especially in growth of root hairs.</a:t>
            </a:r>
            <a:r>
              <a:rPr lang="en-IN" sz="1200" b="1" dirty="0">
                <a:latin typeface="Times New Roman" panose="02020603050405020304" pitchFamily="18" charset="0"/>
                <a:cs typeface="Times New Roman" panose="02020603050405020304" pitchFamily="18" charset="0"/>
              </a:rPr>
              <a:t> </a:t>
            </a:r>
            <a:r>
              <a:rPr lang="en-IN" sz="1200" dirty="0">
                <a:latin typeface="Times New Roman" panose="02020603050405020304" pitchFamily="18" charset="0"/>
                <a:cs typeface="Times New Roman" panose="02020603050405020304" pitchFamily="18" charset="0"/>
              </a:rPr>
              <a:t>Representative micrographs (n=25-35, 1 experiment) show different cell layers with differential accumulation of ROS under As, Hpx and HpxAs-treatment. Intact plant roots were incubated in DCFDA solution (5 µM) and thoroughly rinsed. Thereafter the roots were observed under CLSM (LSM780, Zeiss) in the root hair zone. The dye was excited under argon laser (488 nm) and emission recorded in the range 500-550nm (max. 517-527 nm).  </a:t>
            </a:r>
            <a:endParaRPr lang="en-IN" sz="1200" b="1" dirty="0">
              <a:latin typeface="Times New Roman" panose="02020603050405020304" pitchFamily="18" charset="0"/>
              <a:cs typeface="Times New Roman" panose="02020603050405020304" pitchFamily="18" charset="0"/>
            </a:endParaRPr>
          </a:p>
        </p:txBody>
      </p:sp>
      <p:grpSp>
        <p:nvGrpSpPr>
          <p:cNvPr id="11" name="Group 10">
            <a:extLst>
              <a:ext uri="{FF2B5EF4-FFF2-40B4-BE49-F238E27FC236}">
                <a16:creationId xmlns:a16="http://schemas.microsoft.com/office/drawing/2014/main" id="{8A2BA454-BFC7-4FA5-AC72-E660C8A1DD85}"/>
              </a:ext>
            </a:extLst>
          </p:cNvPr>
          <p:cNvGrpSpPr/>
          <p:nvPr/>
        </p:nvGrpSpPr>
        <p:grpSpPr>
          <a:xfrm>
            <a:off x="541379" y="75127"/>
            <a:ext cx="8152565" cy="4929349"/>
            <a:chOff x="541379" y="75127"/>
            <a:chExt cx="8152565" cy="4929349"/>
          </a:xfrm>
        </p:grpSpPr>
        <p:grpSp>
          <p:nvGrpSpPr>
            <p:cNvPr id="3" name="Group 2">
              <a:extLst>
                <a:ext uri="{FF2B5EF4-FFF2-40B4-BE49-F238E27FC236}">
                  <a16:creationId xmlns:a16="http://schemas.microsoft.com/office/drawing/2014/main" id="{84392485-1A4B-4CCE-B2D0-A0F67F143354}"/>
                </a:ext>
              </a:extLst>
            </p:cNvPr>
            <p:cNvGrpSpPr/>
            <p:nvPr/>
          </p:nvGrpSpPr>
          <p:grpSpPr>
            <a:xfrm>
              <a:off x="541379" y="75127"/>
              <a:ext cx="8152565" cy="4929349"/>
              <a:chOff x="534235" y="633251"/>
              <a:chExt cx="8152565" cy="4929349"/>
            </a:xfrm>
          </p:grpSpPr>
          <p:pic>
            <p:nvPicPr>
              <p:cNvPr id="24" name="Picture 23" descr="A picture containing worm, black, white, monitor&#10;&#10;Description automatically generated">
                <a:extLst>
                  <a:ext uri="{FF2B5EF4-FFF2-40B4-BE49-F238E27FC236}">
                    <a16:creationId xmlns:a16="http://schemas.microsoft.com/office/drawing/2014/main" id="{99BD8C92-7E31-474E-AA7E-43DC35F8AC8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484955" y="1100510"/>
                <a:ext cx="1950720" cy="1950720"/>
              </a:xfrm>
              <a:prstGeom prst="rect">
                <a:avLst/>
              </a:prstGeom>
            </p:spPr>
          </p:pic>
          <p:pic>
            <p:nvPicPr>
              <p:cNvPr id="28" name="Picture 27" descr="A picture containing photo, building, sitting, snow&#10;&#10;Description automatically generated">
                <a:extLst>
                  <a:ext uri="{FF2B5EF4-FFF2-40B4-BE49-F238E27FC236}">
                    <a16:creationId xmlns:a16="http://schemas.microsoft.com/office/drawing/2014/main" id="{B96FCC6E-0FBA-4B26-B4A1-5B8DCE7F8303}"/>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785360" y="1100510"/>
                <a:ext cx="1950720" cy="1950720"/>
              </a:xfrm>
              <a:prstGeom prst="rect">
                <a:avLst/>
              </a:prstGeom>
            </p:spPr>
          </p:pic>
          <p:pic>
            <p:nvPicPr>
              <p:cNvPr id="37" name="Picture 36" descr="A picture containing black, red, night, fire&#10;&#10;Description automatically generated">
                <a:extLst>
                  <a:ext uri="{FF2B5EF4-FFF2-40B4-BE49-F238E27FC236}">
                    <a16:creationId xmlns:a16="http://schemas.microsoft.com/office/drawing/2014/main" id="{AE9EEBCD-831A-41FA-8D53-D90BB245AAAF}"/>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736080" y="1100510"/>
                <a:ext cx="1950720" cy="1950720"/>
              </a:xfrm>
              <a:prstGeom prst="rect">
                <a:avLst/>
              </a:prstGeom>
            </p:spPr>
          </p:pic>
          <p:pic>
            <p:nvPicPr>
              <p:cNvPr id="39" name="Picture 38" descr="A picture containing old, photo, white, boat&#10;&#10;Description automatically generated">
                <a:extLst>
                  <a:ext uri="{FF2B5EF4-FFF2-40B4-BE49-F238E27FC236}">
                    <a16:creationId xmlns:a16="http://schemas.microsoft.com/office/drawing/2014/main" id="{E2814623-E8EB-4B35-AAC9-4E5A0C0B797D}"/>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34235" y="3611880"/>
                <a:ext cx="1950720" cy="1950720"/>
              </a:xfrm>
              <a:prstGeom prst="rect">
                <a:avLst/>
              </a:prstGeom>
            </p:spPr>
          </p:pic>
          <p:pic>
            <p:nvPicPr>
              <p:cNvPr id="41" name="Picture 40" descr="A picture containing worm, animal&#10;&#10;Description automatically generated">
                <a:extLst>
                  <a:ext uri="{FF2B5EF4-FFF2-40B4-BE49-F238E27FC236}">
                    <a16:creationId xmlns:a16="http://schemas.microsoft.com/office/drawing/2014/main" id="{70D9E0A2-4236-4B96-A219-57CCC8B0E08E}"/>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484955" y="3611880"/>
                <a:ext cx="1950720" cy="1950720"/>
              </a:xfrm>
              <a:prstGeom prst="rect">
                <a:avLst/>
              </a:prstGeom>
            </p:spPr>
          </p:pic>
          <p:pic>
            <p:nvPicPr>
              <p:cNvPr id="43" name="Picture 42" descr="A picture containing sitting, old, water, small&#10;&#10;Description automatically generated">
                <a:extLst>
                  <a:ext uri="{FF2B5EF4-FFF2-40B4-BE49-F238E27FC236}">
                    <a16:creationId xmlns:a16="http://schemas.microsoft.com/office/drawing/2014/main" id="{C6F68931-ADFE-4ACA-B0EA-67AE81048A64}"/>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785360" y="3611880"/>
                <a:ext cx="1950720" cy="1950720"/>
              </a:xfrm>
              <a:prstGeom prst="rect">
                <a:avLst/>
              </a:prstGeom>
            </p:spPr>
          </p:pic>
          <p:pic>
            <p:nvPicPr>
              <p:cNvPr id="45" name="Picture 44" descr="A close up of a red light&#10;&#10;Description automatically generated">
                <a:extLst>
                  <a:ext uri="{FF2B5EF4-FFF2-40B4-BE49-F238E27FC236}">
                    <a16:creationId xmlns:a16="http://schemas.microsoft.com/office/drawing/2014/main" id="{668666E5-3079-419A-A5FD-633962227803}"/>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736080" y="3611880"/>
                <a:ext cx="1950720" cy="1950720"/>
              </a:xfrm>
              <a:prstGeom prst="rect">
                <a:avLst/>
              </a:prstGeom>
            </p:spPr>
          </p:pic>
          <p:sp>
            <p:nvSpPr>
              <p:cNvPr id="46" name="TextBox 45">
                <a:extLst>
                  <a:ext uri="{FF2B5EF4-FFF2-40B4-BE49-F238E27FC236}">
                    <a16:creationId xmlns:a16="http://schemas.microsoft.com/office/drawing/2014/main" id="{5910E60E-BE15-414E-BC51-89BF1FF9C26E}"/>
                  </a:ext>
                </a:extLst>
              </p:cNvPr>
              <p:cNvSpPr txBox="1"/>
              <p:nvPr/>
            </p:nvSpPr>
            <p:spPr>
              <a:xfrm>
                <a:off x="2373072" y="645950"/>
                <a:ext cx="234662" cy="307777"/>
              </a:xfrm>
              <a:prstGeom prst="rect">
                <a:avLst/>
              </a:prstGeom>
              <a:noFill/>
            </p:spPr>
            <p:txBody>
              <a:bodyPr wrap="square" rtlCol="0">
                <a:spAutoFit/>
              </a:bodyPr>
              <a:lstStyle/>
              <a:p>
                <a:pPr algn="ctr"/>
                <a:r>
                  <a:rPr lang="en-IN" sz="1400">
                    <a:latin typeface=" Calibri "/>
                  </a:rPr>
                  <a:t>C</a:t>
                </a:r>
              </a:p>
            </p:txBody>
          </p:sp>
          <p:sp>
            <p:nvSpPr>
              <p:cNvPr id="47" name="TextBox 46">
                <a:extLst>
                  <a:ext uri="{FF2B5EF4-FFF2-40B4-BE49-F238E27FC236}">
                    <a16:creationId xmlns:a16="http://schemas.microsoft.com/office/drawing/2014/main" id="{4B93E268-9FF1-4FDB-BA47-CB814DA631DF}"/>
                  </a:ext>
                </a:extLst>
              </p:cNvPr>
              <p:cNvSpPr txBox="1"/>
              <p:nvPr/>
            </p:nvSpPr>
            <p:spPr>
              <a:xfrm>
                <a:off x="6499388" y="633251"/>
                <a:ext cx="466561" cy="307777"/>
              </a:xfrm>
              <a:prstGeom prst="rect">
                <a:avLst/>
              </a:prstGeom>
              <a:noFill/>
            </p:spPr>
            <p:txBody>
              <a:bodyPr wrap="square" rtlCol="0">
                <a:spAutoFit/>
              </a:bodyPr>
              <a:lstStyle/>
              <a:p>
                <a:pPr algn="ctr"/>
                <a:r>
                  <a:rPr lang="en-IN" sz="1400">
                    <a:latin typeface=" Calibri "/>
                  </a:rPr>
                  <a:t>As</a:t>
                </a:r>
              </a:p>
            </p:txBody>
          </p:sp>
          <p:sp>
            <p:nvSpPr>
              <p:cNvPr id="48" name="TextBox 47">
                <a:extLst>
                  <a:ext uri="{FF2B5EF4-FFF2-40B4-BE49-F238E27FC236}">
                    <a16:creationId xmlns:a16="http://schemas.microsoft.com/office/drawing/2014/main" id="{89F1290E-9056-4BF3-BB6F-D7EDB3E7AD8F}"/>
                  </a:ext>
                </a:extLst>
              </p:cNvPr>
              <p:cNvSpPr txBox="1"/>
              <p:nvPr/>
            </p:nvSpPr>
            <p:spPr>
              <a:xfrm>
                <a:off x="2082132" y="3228975"/>
                <a:ext cx="864906" cy="307777"/>
              </a:xfrm>
              <a:prstGeom prst="rect">
                <a:avLst/>
              </a:prstGeom>
              <a:noFill/>
            </p:spPr>
            <p:txBody>
              <a:bodyPr wrap="square" rtlCol="0">
                <a:spAutoFit/>
              </a:bodyPr>
              <a:lstStyle/>
              <a:p>
                <a:pPr algn="ctr"/>
                <a:r>
                  <a:rPr lang="en-IN" sz="1400">
                    <a:latin typeface=" Calibri "/>
                  </a:rPr>
                  <a:t>Hpx</a:t>
                </a:r>
              </a:p>
            </p:txBody>
          </p:sp>
          <p:sp>
            <p:nvSpPr>
              <p:cNvPr id="49" name="TextBox 48">
                <a:extLst>
                  <a:ext uri="{FF2B5EF4-FFF2-40B4-BE49-F238E27FC236}">
                    <a16:creationId xmlns:a16="http://schemas.microsoft.com/office/drawing/2014/main" id="{055BE9AF-382A-4443-9ADF-2462E2DA1344}"/>
                  </a:ext>
                </a:extLst>
              </p:cNvPr>
              <p:cNvSpPr txBox="1"/>
              <p:nvPr/>
            </p:nvSpPr>
            <p:spPr>
              <a:xfrm>
                <a:off x="6192136" y="3234497"/>
                <a:ext cx="1084964" cy="307777"/>
              </a:xfrm>
              <a:prstGeom prst="rect">
                <a:avLst/>
              </a:prstGeom>
              <a:noFill/>
            </p:spPr>
            <p:txBody>
              <a:bodyPr wrap="square" rtlCol="0">
                <a:spAutoFit/>
              </a:bodyPr>
              <a:lstStyle/>
              <a:p>
                <a:pPr algn="ctr"/>
                <a:r>
                  <a:rPr lang="en-IN" sz="1400">
                    <a:latin typeface=" Calibri "/>
                  </a:rPr>
                  <a:t>HpxAs</a:t>
                </a:r>
              </a:p>
            </p:txBody>
          </p:sp>
          <p:pic>
            <p:nvPicPr>
              <p:cNvPr id="53" name="Picture 52" descr="A picture containing old, photo, sitting, white&#10;&#10;Description automatically generated">
                <a:extLst>
                  <a:ext uri="{FF2B5EF4-FFF2-40B4-BE49-F238E27FC236}">
                    <a16:creationId xmlns:a16="http://schemas.microsoft.com/office/drawing/2014/main" id="{2A0D09E6-B994-4935-AFD6-680B006E8655}"/>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36575" y="1097915"/>
                <a:ext cx="1950720" cy="1950720"/>
              </a:xfrm>
              <a:prstGeom prst="rect">
                <a:avLst/>
              </a:prstGeom>
            </p:spPr>
          </p:pic>
        </p:grpSp>
        <p:sp>
          <p:nvSpPr>
            <p:cNvPr id="2" name="Oval 1">
              <a:extLst>
                <a:ext uri="{FF2B5EF4-FFF2-40B4-BE49-F238E27FC236}">
                  <a16:creationId xmlns:a16="http://schemas.microsoft.com/office/drawing/2014/main" id="{79BCAFA9-F9F3-48F1-9B27-40740B0A6D54}"/>
                </a:ext>
              </a:extLst>
            </p:cNvPr>
            <p:cNvSpPr/>
            <p:nvPr/>
          </p:nvSpPr>
          <p:spPr>
            <a:xfrm>
              <a:off x="1116807" y="1109661"/>
              <a:ext cx="209550" cy="120650"/>
            </a:xfrm>
            <a:prstGeom prst="ellipse">
              <a:avLst/>
            </a:prstGeom>
            <a:noFill/>
            <a:ln w="25400">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 name="Oval 3">
              <a:extLst>
                <a:ext uri="{FF2B5EF4-FFF2-40B4-BE49-F238E27FC236}">
                  <a16:creationId xmlns:a16="http://schemas.microsoft.com/office/drawing/2014/main" id="{9ECDAFA2-21F9-46F3-8471-E50FB2D58C44}"/>
                </a:ext>
              </a:extLst>
            </p:cNvPr>
            <p:cNvSpPr/>
            <p:nvPr/>
          </p:nvSpPr>
          <p:spPr>
            <a:xfrm>
              <a:off x="1066800" y="1225550"/>
              <a:ext cx="209550" cy="100529"/>
            </a:xfrm>
            <a:prstGeom prst="ellipse">
              <a:avLst/>
            </a:prstGeom>
            <a:noFill/>
            <a:ln w="25400">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cxnSp>
          <p:nvCxnSpPr>
            <p:cNvPr id="6" name="Straight Connector 5">
              <a:extLst>
                <a:ext uri="{FF2B5EF4-FFF2-40B4-BE49-F238E27FC236}">
                  <a16:creationId xmlns:a16="http://schemas.microsoft.com/office/drawing/2014/main" id="{A682883C-A06F-4EDD-B95C-2145F9EAE5CF}"/>
                </a:ext>
              </a:extLst>
            </p:cNvPr>
            <p:cNvCxnSpPr>
              <a:cxnSpLocks/>
            </p:cNvCxnSpPr>
            <p:nvPr/>
          </p:nvCxnSpPr>
          <p:spPr>
            <a:xfrm rot="480000">
              <a:off x="1131093" y="969633"/>
              <a:ext cx="80963" cy="12951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0737ECCC-E1C2-4EFB-9F91-9A1D374F10E4}"/>
                </a:ext>
              </a:extLst>
            </p:cNvPr>
            <p:cNvCxnSpPr>
              <a:cxnSpLocks/>
            </p:cNvCxnSpPr>
            <p:nvPr/>
          </p:nvCxnSpPr>
          <p:spPr>
            <a:xfrm rot="-900000">
              <a:off x="950256" y="878600"/>
              <a:ext cx="80963" cy="396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CC1B2478-3950-455E-B061-9456FE2BDCEA}"/>
                </a:ext>
              </a:extLst>
            </p:cNvPr>
            <p:cNvSpPr txBox="1"/>
            <p:nvPr/>
          </p:nvSpPr>
          <p:spPr>
            <a:xfrm>
              <a:off x="1081086" y="791346"/>
              <a:ext cx="1313416" cy="246221"/>
            </a:xfrm>
            <a:prstGeom prst="rect">
              <a:avLst/>
            </a:prstGeom>
            <a:noFill/>
          </p:spPr>
          <p:txBody>
            <a:bodyPr wrap="square" rtlCol="0">
              <a:spAutoFit/>
            </a:bodyPr>
            <a:lstStyle/>
            <a:p>
              <a:r>
                <a:rPr lang="en-IN" sz="1000" b="1" dirty="0">
                  <a:latin typeface="Calibri "/>
                </a:rPr>
                <a:t>Epidermis, Cortex</a:t>
              </a:r>
            </a:p>
          </p:txBody>
        </p:sp>
        <p:sp>
          <p:nvSpPr>
            <p:cNvPr id="10" name="TextBox 9">
              <a:extLst>
                <a:ext uri="{FF2B5EF4-FFF2-40B4-BE49-F238E27FC236}">
                  <a16:creationId xmlns:a16="http://schemas.microsoft.com/office/drawing/2014/main" id="{3564886C-C3A3-401F-B989-CBCDFC63ADEE}"/>
                </a:ext>
              </a:extLst>
            </p:cNvPr>
            <p:cNvSpPr txBox="1"/>
            <p:nvPr/>
          </p:nvSpPr>
          <p:spPr>
            <a:xfrm>
              <a:off x="624670" y="653535"/>
              <a:ext cx="1362880" cy="246221"/>
            </a:xfrm>
            <a:prstGeom prst="rect">
              <a:avLst/>
            </a:prstGeom>
            <a:noFill/>
          </p:spPr>
          <p:txBody>
            <a:bodyPr wrap="square" rtlCol="0">
              <a:spAutoFit/>
            </a:bodyPr>
            <a:lstStyle/>
            <a:p>
              <a:r>
                <a:rPr lang="en-IN" sz="1000" b="1" dirty="0">
                  <a:latin typeface="Calibri "/>
                </a:rPr>
                <a:t>Endodermis, Pericycle</a:t>
              </a:r>
            </a:p>
          </p:txBody>
        </p:sp>
      </p:grpSp>
    </p:spTree>
    <p:extLst>
      <p:ext uri="{BB962C8B-B14F-4D97-AF65-F5344CB8AC3E}">
        <p14:creationId xmlns:p14="http://schemas.microsoft.com/office/powerpoint/2010/main" val="23611935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 name="TextBox 76">
            <a:extLst>
              <a:ext uri="{FF2B5EF4-FFF2-40B4-BE49-F238E27FC236}">
                <a16:creationId xmlns:a16="http://schemas.microsoft.com/office/drawing/2014/main" id="{C47B253B-2AEA-4BEF-8F19-4EDFA2CEE544}"/>
              </a:ext>
            </a:extLst>
          </p:cNvPr>
          <p:cNvSpPr txBox="1"/>
          <p:nvPr/>
        </p:nvSpPr>
        <p:spPr>
          <a:xfrm>
            <a:off x="1393830" y="4176731"/>
            <a:ext cx="6635260" cy="1200329"/>
          </a:xfrm>
          <a:prstGeom prst="rect">
            <a:avLst/>
          </a:prstGeom>
          <a:noFill/>
        </p:spPr>
        <p:txBody>
          <a:bodyPr wrap="square" rtlCol="0">
            <a:spAutoFit/>
          </a:bodyPr>
          <a:lstStyle/>
          <a:p>
            <a:pPr marL="903288" indent="-903288" algn="just"/>
            <a:r>
              <a:rPr lang="en-IN" sz="1200" b="1" dirty="0">
                <a:latin typeface="Times New Roman" panose="02020603050405020304" pitchFamily="18" charset="0"/>
                <a:cs typeface="Times New Roman" panose="02020603050405020304" pitchFamily="18" charset="0"/>
              </a:rPr>
              <a:t>Supp. Fig. 5:	Plant cell osmolarity under As, Hpx and HpxAs-treatment. </a:t>
            </a:r>
            <a:r>
              <a:rPr lang="en-IN" sz="1200" dirty="0">
                <a:latin typeface="Times New Roman" panose="02020603050405020304" pitchFamily="18" charset="0"/>
                <a:cs typeface="Times New Roman" panose="02020603050405020304" pitchFamily="18" charset="0"/>
              </a:rPr>
              <a:t>Root hairs function in nutrient uptake but also in the maintenance of osmotic balance. Osmotic imbalance in the roots can have global impact on plant adaptation under stress. In As-, </a:t>
            </a:r>
            <a:r>
              <a:rPr lang="en-IN" sz="1200" dirty="0" err="1">
                <a:latin typeface="Times New Roman" panose="02020603050405020304" pitchFamily="18" charset="0"/>
                <a:cs typeface="Times New Roman" panose="02020603050405020304" pitchFamily="18" charset="0"/>
              </a:rPr>
              <a:t>Hpx</a:t>
            </a:r>
            <a:r>
              <a:rPr lang="en-IN" sz="1200">
                <a:latin typeface="Times New Roman" panose="02020603050405020304" pitchFamily="18" charset="0"/>
                <a:cs typeface="Times New Roman" panose="02020603050405020304" pitchFamily="18" charset="0"/>
              </a:rPr>
              <a:t>-, </a:t>
            </a:r>
            <a:r>
              <a:rPr lang="en-IN" sz="1200" dirty="0">
                <a:latin typeface="Times New Roman" panose="02020603050405020304" pitchFamily="18" charset="0"/>
                <a:cs typeface="Times New Roman" panose="02020603050405020304" pitchFamily="18" charset="0"/>
              </a:rPr>
              <a:t>or HpxAs-treated Arabidopsis roots, plant cell sap (root and leaves) was extracted and analysed for osmolarity using a micro osmometer (A0800, Knauer). The data presented are means±SE, n=8 (4 independent experiments, Tukey’s test p&lt;0.05). </a:t>
            </a:r>
          </a:p>
        </p:txBody>
      </p:sp>
      <p:grpSp>
        <p:nvGrpSpPr>
          <p:cNvPr id="4" name="Group 3">
            <a:extLst>
              <a:ext uri="{FF2B5EF4-FFF2-40B4-BE49-F238E27FC236}">
                <a16:creationId xmlns:a16="http://schemas.microsoft.com/office/drawing/2014/main" id="{6F42CE82-A740-4EE9-8FB1-CAAFC2B944D1}"/>
              </a:ext>
            </a:extLst>
          </p:cNvPr>
          <p:cNvGrpSpPr/>
          <p:nvPr/>
        </p:nvGrpSpPr>
        <p:grpSpPr>
          <a:xfrm>
            <a:off x="1329240" y="971414"/>
            <a:ext cx="6790283" cy="2677722"/>
            <a:chOff x="1223733" y="10128"/>
            <a:chExt cx="6790283" cy="2677722"/>
          </a:xfrm>
        </p:grpSpPr>
        <p:grpSp>
          <p:nvGrpSpPr>
            <p:cNvPr id="3" name="Group 2">
              <a:extLst>
                <a:ext uri="{FF2B5EF4-FFF2-40B4-BE49-F238E27FC236}">
                  <a16:creationId xmlns:a16="http://schemas.microsoft.com/office/drawing/2014/main" id="{6616E53D-547D-478D-8754-A6328F9B2873}"/>
                </a:ext>
              </a:extLst>
            </p:cNvPr>
            <p:cNvGrpSpPr/>
            <p:nvPr/>
          </p:nvGrpSpPr>
          <p:grpSpPr>
            <a:xfrm>
              <a:off x="1223733" y="10128"/>
              <a:ext cx="6790283" cy="2677722"/>
              <a:chOff x="1224736" y="346398"/>
              <a:chExt cx="6790283" cy="2677722"/>
            </a:xfrm>
          </p:grpSpPr>
          <p:sp>
            <p:nvSpPr>
              <p:cNvPr id="128" name="TextBox 127">
                <a:extLst>
                  <a:ext uri="{FF2B5EF4-FFF2-40B4-BE49-F238E27FC236}">
                    <a16:creationId xmlns:a16="http://schemas.microsoft.com/office/drawing/2014/main" id="{8FC57E31-3552-4AB3-B239-087878EF8CCD}"/>
                  </a:ext>
                </a:extLst>
              </p:cNvPr>
              <p:cNvSpPr txBox="1"/>
              <p:nvPr/>
            </p:nvSpPr>
            <p:spPr>
              <a:xfrm rot="16200000">
                <a:off x="402992" y="1838393"/>
                <a:ext cx="1951265" cy="307777"/>
              </a:xfrm>
              <a:prstGeom prst="rect">
                <a:avLst/>
              </a:prstGeom>
              <a:noFill/>
            </p:spPr>
            <p:txBody>
              <a:bodyPr wrap="square" rtlCol="0">
                <a:spAutoFit/>
              </a:bodyPr>
              <a:lstStyle/>
              <a:p>
                <a:pPr algn="ctr"/>
                <a:r>
                  <a:rPr lang="en-IN" sz="1400" dirty="0">
                    <a:latin typeface="Calibri "/>
                  </a:rPr>
                  <a:t>Osmolarity (mosmol/l)</a:t>
                </a:r>
              </a:p>
            </p:txBody>
          </p:sp>
          <p:grpSp>
            <p:nvGrpSpPr>
              <p:cNvPr id="6169" name="Group 6168">
                <a:extLst>
                  <a:ext uri="{FF2B5EF4-FFF2-40B4-BE49-F238E27FC236}">
                    <a16:creationId xmlns:a16="http://schemas.microsoft.com/office/drawing/2014/main" id="{4EFCAA08-18D1-461F-BB0F-2D1B71FF381E}"/>
                  </a:ext>
                </a:extLst>
              </p:cNvPr>
              <p:cNvGrpSpPr/>
              <p:nvPr/>
            </p:nvGrpSpPr>
            <p:grpSpPr>
              <a:xfrm>
                <a:off x="1644285" y="352624"/>
                <a:ext cx="3031896" cy="2666122"/>
                <a:chOff x="1644285" y="-41076"/>
                <a:chExt cx="3031896" cy="2666122"/>
              </a:xfrm>
            </p:grpSpPr>
            <p:grpSp>
              <p:nvGrpSpPr>
                <p:cNvPr id="6145" name="Group 6144">
                  <a:extLst>
                    <a:ext uri="{FF2B5EF4-FFF2-40B4-BE49-F238E27FC236}">
                      <a16:creationId xmlns:a16="http://schemas.microsoft.com/office/drawing/2014/main" id="{C4B08E29-E0C9-4F9E-B5AC-41B1930BDE39}"/>
                    </a:ext>
                  </a:extLst>
                </p:cNvPr>
                <p:cNvGrpSpPr/>
                <p:nvPr/>
              </p:nvGrpSpPr>
              <p:grpSpPr>
                <a:xfrm>
                  <a:off x="1644285" y="609600"/>
                  <a:ext cx="3031896" cy="2015446"/>
                  <a:chOff x="-3413760" y="888149"/>
                  <a:chExt cx="3031896" cy="2015446"/>
                </a:xfrm>
              </p:grpSpPr>
              <p:sp>
                <p:nvSpPr>
                  <p:cNvPr id="110" name="Rectangle 49">
                    <a:extLst>
                      <a:ext uri="{FF2B5EF4-FFF2-40B4-BE49-F238E27FC236}">
                        <a16:creationId xmlns:a16="http://schemas.microsoft.com/office/drawing/2014/main" id="{E042F74A-BA14-4B6A-A790-FC6458C49E1D}"/>
                      </a:ext>
                    </a:extLst>
                  </p:cNvPr>
                  <p:cNvSpPr>
                    <a:spLocks noChangeArrowheads="1"/>
                  </p:cNvSpPr>
                  <p:nvPr/>
                </p:nvSpPr>
                <p:spPr bwMode="auto">
                  <a:xfrm>
                    <a:off x="-3045190" y="888149"/>
                    <a:ext cx="0" cy="1763253"/>
                  </a:xfrm>
                  <a:prstGeom prst="rect">
                    <a:avLst/>
                  </a:prstGeom>
                  <a:solidFill>
                    <a:schemeClr val="tx1"/>
                  </a:solidFill>
                  <a:ln w="1270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a:p>
                </p:txBody>
              </p:sp>
              <p:sp>
                <p:nvSpPr>
                  <p:cNvPr id="111" name="Freeform 50">
                    <a:extLst>
                      <a:ext uri="{FF2B5EF4-FFF2-40B4-BE49-F238E27FC236}">
                        <a16:creationId xmlns:a16="http://schemas.microsoft.com/office/drawing/2014/main" id="{C462E35F-CADE-4051-A778-0A1E26842F10}"/>
                      </a:ext>
                    </a:extLst>
                  </p:cNvPr>
                  <p:cNvSpPr>
                    <a:spLocks noEditPoints="1"/>
                  </p:cNvSpPr>
                  <p:nvPr/>
                </p:nvSpPr>
                <p:spPr bwMode="auto">
                  <a:xfrm>
                    <a:off x="-3082816" y="1238587"/>
                    <a:ext cx="29511" cy="1416504"/>
                  </a:xfrm>
                  <a:custGeom>
                    <a:avLst/>
                    <a:gdLst/>
                    <a:ahLst/>
                    <a:cxnLst>
                      <a:cxn ang="0">
                        <a:pos x="0" y="1146"/>
                      </a:cxn>
                      <a:cxn ang="0">
                        <a:pos x="24" y="1146"/>
                      </a:cxn>
                      <a:cxn ang="0">
                        <a:pos x="24" y="1152"/>
                      </a:cxn>
                      <a:cxn ang="0">
                        <a:pos x="0" y="1152"/>
                      </a:cxn>
                      <a:cxn ang="0">
                        <a:pos x="0" y="1146"/>
                      </a:cxn>
                      <a:cxn ang="0">
                        <a:pos x="0" y="576"/>
                      </a:cxn>
                      <a:cxn ang="0">
                        <a:pos x="24" y="576"/>
                      </a:cxn>
                      <a:cxn ang="0">
                        <a:pos x="24" y="582"/>
                      </a:cxn>
                      <a:cxn ang="0">
                        <a:pos x="0" y="582"/>
                      </a:cxn>
                      <a:cxn ang="0">
                        <a:pos x="0" y="576"/>
                      </a:cxn>
                      <a:cxn ang="0">
                        <a:pos x="0" y="0"/>
                      </a:cxn>
                      <a:cxn ang="0">
                        <a:pos x="24" y="0"/>
                      </a:cxn>
                      <a:cxn ang="0">
                        <a:pos x="24" y="6"/>
                      </a:cxn>
                      <a:cxn ang="0">
                        <a:pos x="0" y="6"/>
                      </a:cxn>
                      <a:cxn ang="0">
                        <a:pos x="0" y="0"/>
                      </a:cxn>
                    </a:cxnLst>
                    <a:rect l="0" t="0" r="r" b="b"/>
                    <a:pathLst>
                      <a:path w="24" h="1152">
                        <a:moveTo>
                          <a:pt x="0" y="1146"/>
                        </a:moveTo>
                        <a:lnTo>
                          <a:pt x="24" y="1146"/>
                        </a:lnTo>
                        <a:lnTo>
                          <a:pt x="24" y="1152"/>
                        </a:lnTo>
                        <a:lnTo>
                          <a:pt x="0" y="1152"/>
                        </a:lnTo>
                        <a:lnTo>
                          <a:pt x="0" y="1146"/>
                        </a:lnTo>
                        <a:close/>
                        <a:moveTo>
                          <a:pt x="0" y="576"/>
                        </a:moveTo>
                        <a:lnTo>
                          <a:pt x="24" y="576"/>
                        </a:lnTo>
                        <a:lnTo>
                          <a:pt x="24" y="582"/>
                        </a:lnTo>
                        <a:lnTo>
                          <a:pt x="0" y="582"/>
                        </a:lnTo>
                        <a:lnTo>
                          <a:pt x="0" y="576"/>
                        </a:lnTo>
                        <a:close/>
                        <a:moveTo>
                          <a:pt x="0" y="0"/>
                        </a:moveTo>
                        <a:lnTo>
                          <a:pt x="24" y="0"/>
                        </a:lnTo>
                        <a:lnTo>
                          <a:pt x="24" y="6"/>
                        </a:lnTo>
                        <a:lnTo>
                          <a:pt x="0" y="6"/>
                        </a:lnTo>
                        <a:lnTo>
                          <a:pt x="0" y="0"/>
                        </a:lnTo>
                        <a:close/>
                      </a:path>
                    </a:pathLst>
                  </a:custGeom>
                  <a:solidFill>
                    <a:schemeClr val="tx1"/>
                  </a:solidFill>
                  <a:ln w="1270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a:p>
                </p:txBody>
              </p:sp>
              <p:sp>
                <p:nvSpPr>
                  <p:cNvPr id="112" name="Rectangle 51">
                    <a:extLst>
                      <a:ext uri="{FF2B5EF4-FFF2-40B4-BE49-F238E27FC236}">
                        <a16:creationId xmlns:a16="http://schemas.microsoft.com/office/drawing/2014/main" id="{6EF90077-03F9-4546-A042-D2EFB23E27C6}"/>
                      </a:ext>
                    </a:extLst>
                  </p:cNvPr>
                  <p:cNvSpPr>
                    <a:spLocks noChangeArrowheads="1"/>
                  </p:cNvSpPr>
                  <p:nvPr/>
                </p:nvSpPr>
                <p:spPr bwMode="auto">
                  <a:xfrm>
                    <a:off x="-3041501" y="2659517"/>
                    <a:ext cx="2655948" cy="0"/>
                  </a:xfrm>
                  <a:prstGeom prst="rect">
                    <a:avLst/>
                  </a:prstGeom>
                  <a:solidFill>
                    <a:schemeClr val="tx1"/>
                  </a:solidFill>
                  <a:ln w="1270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a:p>
                </p:txBody>
              </p:sp>
              <p:sp>
                <p:nvSpPr>
                  <p:cNvPr id="113" name="Freeform 52">
                    <a:extLst>
                      <a:ext uri="{FF2B5EF4-FFF2-40B4-BE49-F238E27FC236}">
                        <a16:creationId xmlns:a16="http://schemas.microsoft.com/office/drawing/2014/main" id="{BC808DAE-CD22-4C66-98F0-BD04B90ECF72}"/>
                      </a:ext>
                    </a:extLst>
                  </p:cNvPr>
                  <p:cNvSpPr>
                    <a:spLocks noEditPoints="1"/>
                  </p:cNvSpPr>
                  <p:nvPr/>
                </p:nvSpPr>
                <p:spPr bwMode="auto">
                  <a:xfrm>
                    <a:off x="-3045190" y="2657304"/>
                    <a:ext cx="2663326" cy="29511"/>
                  </a:xfrm>
                  <a:custGeom>
                    <a:avLst/>
                    <a:gdLst/>
                    <a:ahLst/>
                    <a:cxnLst>
                      <a:cxn ang="0">
                        <a:pos x="6" y="0"/>
                      </a:cxn>
                      <a:cxn ang="0">
                        <a:pos x="6" y="24"/>
                      </a:cxn>
                      <a:cxn ang="0">
                        <a:pos x="0" y="24"/>
                      </a:cxn>
                      <a:cxn ang="0">
                        <a:pos x="0" y="0"/>
                      </a:cxn>
                      <a:cxn ang="0">
                        <a:pos x="6" y="0"/>
                      </a:cxn>
                      <a:cxn ang="0">
                        <a:pos x="546" y="0"/>
                      </a:cxn>
                      <a:cxn ang="0">
                        <a:pos x="546" y="24"/>
                      </a:cxn>
                      <a:cxn ang="0">
                        <a:pos x="540" y="24"/>
                      </a:cxn>
                      <a:cxn ang="0">
                        <a:pos x="540" y="0"/>
                      </a:cxn>
                      <a:cxn ang="0">
                        <a:pos x="546" y="0"/>
                      </a:cxn>
                      <a:cxn ang="0">
                        <a:pos x="1086" y="0"/>
                      </a:cxn>
                      <a:cxn ang="0">
                        <a:pos x="1086" y="24"/>
                      </a:cxn>
                      <a:cxn ang="0">
                        <a:pos x="1080" y="24"/>
                      </a:cxn>
                      <a:cxn ang="0">
                        <a:pos x="1080" y="0"/>
                      </a:cxn>
                      <a:cxn ang="0">
                        <a:pos x="1086" y="0"/>
                      </a:cxn>
                      <a:cxn ang="0">
                        <a:pos x="1626" y="0"/>
                      </a:cxn>
                      <a:cxn ang="0">
                        <a:pos x="1626" y="24"/>
                      </a:cxn>
                      <a:cxn ang="0">
                        <a:pos x="1620" y="24"/>
                      </a:cxn>
                      <a:cxn ang="0">
                        <a:pos x="1620" y="0"/>
                      </a:cxn>
                      <a:cxn ang="0">
                        <a:pos x="1626" y="0"/>
                      </a:cxn>
                      <a:cxn ang="0">
                        <a:pos x="2166" y="0"/>
                      </a:cxn>
                      <a:cxn ang="0">
                        <a:pos x="2166" y="24"/>
                      </a:cxn>
                      <a:cxn ang="0">
                        <a:pos x="2160" y="24"/>
                      </a:cxn>
                      <a:cxn ang="0">
                        <a:pos x="2160" y="0"/>
                      </a:cxn>
                      <a:cxn ang="0">
                        <a:pos x="2166" y="0"/>
                      </a:cxn>
                    </a:cxnLst>
                    <a:rect l="0" t="0" r="r" b="b"/>
                    <a:pathLst>
                      <a:path w="2166" h="24">
                        <a:moveTo>
                          <a:pt x="6" y="0"/>
                        </a:moveTo>
                        <a:lnTo>
                          <a:pt x="6" y="24"/>
                        </a:lnTo>
                        <a:lnTo>
                          <a:pt x="0" y="24"/>
                        </a:lnTo>
                        <a:lnTo>
                          <a:pt x="0" y="0"/>
                        </a:lnTo>
                        <a:lnTo>
                          <a:pt x="6" y="0"/>
                        </a:lnTo>
                        <a:close/>
                        <a:moveTo>
                          <a:pt x="546" y="0"/>
                        </a:moveTo>
                        <a:lnTo>
                          <a:pt x="546" y="24"/>
                        </a:lnTo>
                        <a:lnTo>
                          <a:pt x="540" y="24"/>
                        </a:lnTo>
                        <a:lnTo>
                          <a:pt x="540" y="0"/>
                        </a:lnTo>
                        <a:lnTo>
                          <a:pt x="546" y="0"/>
                        </a:lnTo>
                        <a:close/>
                        <a:moveTo>
                          <a:pt x="1086" y="0"/>
                        </a:moveTo>
                        <a:lnTo>
                          <a:pt x="1086" y="24"/>
                        </a:lnTo>
                        <a:lnTo>
                          <a:pt x="1080" y="24"/>
                        </a:lnTo>
                        <a:lnTo>
                          <a:pt x="1080" y="0"/>
                        </a:lnTo>
                        <a:lnTo>
                          <a:pt x="1086" y="0"/>
                        </a:lnTo>
                        <a:close/>
                        <a:moveTo>
                          <a:pt x="1626" y="0"/>
                        </a:moveTo>
                        <a:lnTo>
                          <a:pt x="1626" y="24"/>
                        </a:lnTo>
                        <a:lnTo>
                          <a:pt x="1620" y="24"/>
                        </a:lnTo>
                        <a:lnTo>
                          <a:pt x="1620" y="0"/>
                        </a:lnTo>
                        <a:lnTo>
                          <a:pt x="1626" y="0"/>
                        </a:lnTo>
                        <a:close/>
                        <a:moveTo>
                          <a:pt x="2166" y="0"/>
                        </a:moveTo>
                        <a:lnTo>
                          <a:pt x="2166" y="24"/>
                        </a:lnTo>
                        <a:lnTo>
                          <a:pt x="2160" y="24"/>
                        </a:lnTo>
                        <a:lnTo>
                          <a:pt x="2160" y="0"/>
                        </a:lnTo>
                        <a:lnTo>
                          <a:pt x="2166" y="0"/>
                        </a:lnTo>
                        <a:close/>
                      </a:path>
                    </a:pathLst>
                  </a:custGeom>
                  <a:solidFill>
                    <a:schemeClr val="tx1"/>
                  </a:solidFill>
                  <a:ln w="1270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a:p>
                </p:txBody>
              </p:sp>
              <p:sp>
                <p:nvSpPr>
                  <p:cNvPr id="114" name="Rectangle 53">
                    <a:extLst>
                      <a:ext uri="{FF2B5EF4-FFF2-40B4-BE49-F238E27FC236}">
                        <a16:creationId xmlns:a16="http://schemas.microsoft.com/office/drawing/2014/main" id="{809CD2CB-E348-4087-80F8-EBB3E3334311}"/>
                      </a:ext>
                    </a:extLst>
                  </p:cNvPr>
                  <p:cNvSpPr>
                    <a:spLocks noChangeArrowheads="1"/>
                  </p:cNvSpPr>
                  <p:nvPr/>
                </p:nvSpPr>
                <p:spPr bwMode="auto">
                  <a:xfrm>
                    <a:off x="-3184469" y="2548738"/>
                    <a:ext cx="70773" cy="16687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a:ln>
                          <a:noFill/>
                        </a:ln>
                        <a:solidFill>
                          <a:srgbClr val="000000"/>
                        </a:solidFill>
                        <a:effectLst/>
                        <a:latin typeface="Calibri" pitchFamily="34" charset="0"/>
                        <a:cs typeface="Arial" pitchFamily="34" charset="0"/>
                      </a:rPr>
                      <a:t>0</a:t>
                    </a:r>
                    <a:endParaRPr kumimoji="0" lang="en-US" sz="1400" b="0" i="0" u="none" strike="noStrike" cap="none" normalizeH="0" baseline="0">
                      <a:ln>
                        <a:noFill/>
                      </a:ln>
                      <a:solidFill>
                        <a:schemeClr val="tx1"/>
                      </a:solidFill>
                      <a:effectLst/>
                      <a:latin typeface="Arial" pitchFamily="34" charset="0"/>
                      <a:cs typeface="Arial" pitchFamily="34" charset="0"/>
                    </a:endParaRPr>
                  </a:p>
                </p:txBody>
              </p:sp>
              <p:sp>
                <p:nvSpPr>
                  <p:cNvPr id="115" name="Rectangle 54">
                    <a:extLst>
                      <a:ext uri="{FF2B5EF4-FFF2-40B4-BE49-F238E27FC236}">
                        <a16:creationId xmlns:a16="http://schemas.microsoft.com/office/drawing/2014/main" id="{19CED920-5418-4EA2-9BD9-B86F75422A3E}"/>
                      </a:ext>
                    </a:extLst>
                  </p:cNvPr>
                  <p:cNvSpPr>
                    <a:spLocks noChangeArrowheads="1"/>
                  </p:cNvSpPr>
                  <p:nvPr/>
                </p:nvSpPr>
                <p:spPr bwMode="auto">
                  <a:xfrm>
                    <a:off x="-3371864" y="1841001"/>
                    <a:ext cx="274114"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a:ln>
                          <a:noFill/>
                        </a:ln>
                        <a:solidFill>
                          <a:srgbClr val="000000"/>
                        </a:solidFill>
                        <a:effectLst/>
                        <a:latin typeface="Calibri" pitchFamily="34" charset="0"/>
                        <a:cs typeface="Arial" pitchFamily="34" charset="0"/>
                      </a:rPr>
                      <a:t>120</a:t>
                    </a:r>
                    <a:endParaRPr kumimoji="0" lang="en-US" sz="1400" b="0" i="0" u="none" strike="noStrike" cap="none" normalizeH="0" baseline="0">
                      <a:ln>
                        <a:noFill/>
                      </a:ln>
                      <a:solidFill>
                        <a:schemeClr val="tx1"/>
                      </a:solidFill>
                      <a:effectLst/>
                      <a:latin typeface="Arial" pitchFamily="34" charset="0"/>
                      <a:cs typeface="Arial" pitchFamily="34" charset="0"/>
                    </a:endParaRPr>
                  </a:p>
                </p:txBody>
              </p:sp>
              <p:sp>
                <p:nvSpPr>
                  <p:cNvPr id="116" name="Rectangle 55">
                    <a:extLst>
                      <a:ext uri="{FF2B5EF4-FFF2-40B4-BE49-F238E27FC236}">
                        <a16:creationId xmlns:a16="http://schemas.microsoft.com/office/drawing/2014/main" id="{0B952FDF-FB7F-4416-9528-9CEBC1B935B4}"/>
                      </a:ext>
                    </a:extLst>
                  </p:cNvPr>
                  <p:cNvSpPr>
                    <a:spLocks noChangeArrowheads="1"/>
                  </p:cNvSpPr>
                  <p:nvPr/>
                </p:nvSpPr>
                <p:spPr bwMode="auto">
                  <a:xfrm>
                    <a:off x="-3413760" y="1124372"/>
                    <a:ext cx="274114"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a:ln>
                          <a:noFill/>
                        </a:ln>
                        <a:solidFill>
                          <a:srgbClr val="000000"/>
                        </a:solidFill>
                        <a:effectLst/>
                        <a:latin typeface="Calibri" pitchFamily="34" charset="0"/>
                        <a:cs typeface="Arial" pitchFamily="34" charset="0"/>
                      </a:rPr>
                      <a:t>240</a:t>
                    </a:r>
                    <a:endParaRPr kumimoji="0" lang="en-US" sz="1400" b="0" i="0" u="none" strike="noStrike" cap="none" normalizeH="0" baseline="0">
                      <a:ln>
                        <a:noFill/>
                      </a:ln>
                      <a:solidFill>
                        <a:schemeClr val="tx1"/>
                      </a:solidFill>
                      <a:effectLst/>
                      <a:latin typeface="Arial" pitchFamily="34" charset="0"/>
                      <a:cs typeface="Arial" pitchFamily="34" charset="0"/>
                    </a:endParaRPr>
                  </a:p>
                </p:txBody>
              </p:sp>
              <p:sp>
                <p:nvSpPr>
                  <p:cNvPr id="117" name="Rectangle 30">
                    <a:extLst>
                      <a:ext uri="{FF2B5EF4-FFF2-40B4-BE49-F238E27FC236}">
                        <a16:creationId xmlns:a16="http://schemas.microsoft.com/office/drawing/2014/main" id="{77CBE1E0-DCC5-48E1-9008-910DF2B8CB89}"/>
                      </a:ext>
                    </a:extLst>
                  </p:cNvPr>
                  <p:cNvSpPr>
                    <a:spLocks noChangeArrowheads="1"/>
                  </p:cNvSpPr>
                  <p:nvPr/>
                </p:nvSpPr>
                <p:spPr bwMode="auto">
                  <a:xfrm>
                    <a:off x="-2754140" y="2688151"/>
                    <a:ext cx="96181"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i="0" u="none" strike="noStrike" cap="none" normalizeH="0" baseline="0">
                        <a:ln>
                          <a:noFill/>
                        </a:ln>
                        <a:solidFill>
                          <a:srgbClr val="000000"/>
                        </a:solidFill>
                        <a:effectLst/>
                        <a:latin typeface="Calibri" pitchFamily="34" charset="0"/>
                        <a:cs typeface="Arial" pitchFamily="34" charset="0"/>
                      </a:rPr>
                      <a:t>C</a:t>
                    </a:r>
                    <a:endParaRPr kumimoji="0" lang="en-US" sz="1400" i="0" u="none" strike="noStrike" cap="none" normalizeH="0" baseline="0">
                      <a:ln>
                        <a:noFill/>
                      </a:ln>
                      <a:solidFill>
                        <a:schemeClr val="tx1"/>
                      </a:solidFill>
                      <a:effectLst/>
                      <a:latin typeface="Arial" pitchFamily="34" charset="0"/>
                      <a:cs typeface="Arial" pitchFamily="34" charset="0"/>
                    </a:endParaRPr>
                  </a:p>
                </p:txBody>
              </p:sp>
              <p:sp>
                <p:nvSpPr>
                  <p:cNvPr id="118" name="Rectangle 31">
                    <a:extLst>
                      <a:ext uri="{FF2B5EF4-FFF2-40B4-BE49-F238E27FC236}">
                        <a16:creationId xmlns:a16="http://schemas.microsoft.com/office/drawing/2014/main" id="{FD0CEA20-0A3D-4F12-A11A-C4079C064B95}"/>
                      </a:ext>
                    </a:extLst>
                  </p:cNvPr>
                  <p:cNvSpPr>
                    <a:spLocks noChangeArrowheads="1"/>
                  </p:cNvSpPr>
                  <p:nvPr/>
                </p:nvSpPr>
                <p:spPr bwMode="auto">
                  <a:xfrm>
                    <a:off x="-2118680" y="2688151"/>
                    <a:ext cx="174728"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i="0" u="none" strike="noStrike" cap="none" normalizeH="0" baseline="0">
                        <a:ln>
                          <a:noFill/>
                        </a:ln>
                        <a:solidFill>
                          <a:srgbClr val="000000"/>
                        </a:solidFill>
                        <a:effectLst/>
                        <a:latin typeface="Calibri" pitchFamily="34" charset="0"/>
                        <a:cs typeface="Arial" pitchFamily="34" charset="0"/>
                      </a:rPr>
                      <a:t>As</a:t>
                    </a:r>
                    <a:endParaRPr kumimoji="0" lang="en-US" sz="1400" i="0" u="none" strike="noStrike" cap="none" normalizeH="0" baseline="0">
                      <a:ln>
                        <a:noFill/>
                      </a:ln>
                      <a:solidFill>
                        <a:schemeClr val="tx1"/>
                      </a:solidFill>
                      <a:effectLst/>
                      <a:latin typeface="Arial" pitchFamily="34" charset="0"/>
                      <a:cs typeface="Arial" pitchFamily="34" charset="0"/>
                    </a:endParaRPr>
                  </a:p>
                </p:txBody>
              </p:sp>
              <p:sp>
                <p:nvSpPr>
                  <p:cNvPr id="119" name="Rectangle 32">
                    <a:extLst>
                      <a:ext uri="{FF2B5EF4-FFF2-40B4-BE49-F238E27FC236}">
                        <a16:creationId xmlns:a16="http://schemas.microsoft.com/office/drawing/2014/main" id="{8BF9D139-3184-4A42-901F-2C425CFC922C}"/>
                      </a:ext>
                    </a:extLst>
                  </p:cNvPr>
                  <p:cNvSpPr>
                    <a:spLocks noChangeArrowheads="1"/>
                  </p:cNvSpPr>
                  <p:nvPr/>
                </p:nvSpPr>
                <p:spPr bwMode="auto">
                  <a:xfrm>
                    <a:off x="-1516188" y="2688151"/>
                    <a:ext cx="281745"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i="0" u="none" strike="noStrike" cap="none" normalizeH="0" baseline="0">
                        <a:ln>
                          <a:noFill/>
                        </a:ln>
                        <a:solidFill>
                          <a:srgbClr val="000000"/>
                        </a:solidFill>
                        <a:effectLst/>
                        <a:latin typeface="Calibri" pitchFamily="34" charset="0"/>
                        <a:cs typeface="Arial" pitchFamily="34" charset="0"/>
                      </a:rPr>
                      <a:t>Hpx</a:t>
                    </a:r>
                    <a:endParaRPr kumimoji="0" lang="en-US" sz="1400" i="0" u="none" strike="noStrike" cap="none" normalizeH="0" baseline="0">
                      <a:ln>
                        <a:noFill/>
                      </a:ln>
                      <a:solidFill>
                        <a:schemeClr val="tx1"/>
                      </a:solidFill>
                      <a:effectLst/>
                      <a:latin typeface="Arial" pitchFamily="34" charset="0"/>
                      <a:cs typeface="Arial" pitchFamily="34" charset="0"/>
                    </a:endParaRPr>
                  </a:p>
                </p:txBody>
              </p:sp>
              <p:sp>
                <p:nvSpPr>
                  <p:cNvPr id="120" name="Rectangle 33">
                    <a:extLst>
                      <a:ext uri="{FF2B5EF4-FFF2-40B4-BE49-F238E27FC236}">
                        <a16:creationId xmlns:a16="http://schemas.microsoft.com/office/drawing/2014/main" id="{281139FD-0A2D-4E68-BFC4-38AD31138945}"/>
                      </a:ext>
                    </a:extLst>
                  </p:cNvPr>
                  <p:cNvSpPr>
                    <a:spLocks noChangeArrowheads="1"/>
                  </p:cNvSpPr>
                  <p:nvPr/>
                </p:nvSpPr>
                <p:spPr bwMode="auto">
                  <a:xfrm>
                    <a:off x="-931409" y="2688151"/>
                    <a:ext cx="456472"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i="0" u="none" strike="noStrike" cap="none" normalizeH="0" baseline="0">
                        <a:ln>
                          <a:noFill/>
                        </a:ln>
                        <a:solidFill>
                          <a:srgbClr val="000000"/>
                        </a:solidFill>
                        <a:effectLst/>
                        <a:latin typeface="Calibri" pitchFamily="34" charset="0"/>
                        <a:cs typeface="Arial" pitchFamily="34" charset="0"/>
                      </a:rPr>
                      <a:t>HpxAs</a:t>
                    </a:r>
                    <a:endParaRPr kumimoji="0" lang="en-US" sz="1400" i="0" u="none" strike="noStrike" cap="none" normalizeH="0" baseline="0">
                      <a:ln>
                        <a:noFill/>
                      </a:ln>
                      <a:solidFill>
                        <a:schemeClr val="tx1"/>
                      </a:solidFill>
                      <a:effectLst/>
                      <a:latin typeface="Arial" pitchFamily="34" charset="0"/>
                      <a:cs typeface="Arial" pitchFamily="34" charset="0"/>
                    </a:endParaRPr>
                  </a:p>
                </p:txBody>
              </p:sp>
              <p:grpSp>
                <p:nvGrpSpPr>
                  <p:cNvPr id="125" name="Group 124">
                    <a:extLst>
                      <a:ext uri="{FF2B5EF4-FFF2-40B4-BE49-F238E27FC236}">
                        <a16:creationId xmlns:a16="http://schemas.microsoft.com/office/drawing/2014/main" id="{08A33C7F-9425-448E-A1F3-2F031840FA76}"/>
                      </a:ext>
                    </a:extLst>
                  </p:cNvPr>
                  <p:cNvGrpSpPr/>
                  <p:nvPr/>
                </p:nvGrpSpPr>
                <p:grpSpPr>
                  <a:xfrm>
                    <a:off x="-2809000" y="1245481"/>
                    <a:ext cx="265595" cy="1404015"/>
                    <a:chOff x="1420770" y="539472"/>
                    <a:chExt cx="265595" cy="1404015"/>
                  </a:xfrm>
                </p:grpSpPr>
                <p:grpSp>
                  <p:nvGrpSpPr>
                    <p:cNvPr id="124" name="Group 123">
                      <a:extLst>
                        <a:ext uri="{FF2B5EF4-FFF2-40B4-BE49-F238E27FC236}">
                          <a16:creationId xmlns:a16="http://schemas.microsoft.com/office/drawing/2014/main" id="{B036F89E-B2F5-42C0-85B8-3D51ADD87D14}"/>
                        </a:ext>
                      </a:extLst>
                    </p:cNvPr>
                    <p:cNvGrpSpPr/>
                    <p:nvPr/>
                  </p:nvGrpSpPr>
                  <p:grpSpPr>
                    <a:xfrm>
                      <a:off x="1420770" y="544482"/>
                      <a:ext cx="265595" cy="1399005"/>
                      <a:chOff x="957459" y="1649737"/>
                      <a:chExt cx="265595" cy="1399005"/>
                    </a:xfrm>
                  </p:grpSpPr>
                  <p:sp>
                    <p:nvSpPr>
                      <p:cNvPr id="10" name="Freeform 9">
                        <a:extLst>
                          <a:ext uri="{FF2B5EF4-FFF2-40B4-BE49-F238E27FC236}">
                            <a16:creationId xmlns:a16="http://schemas.microsoft.com/office/drawing/2014/main" id="{6D42F8B8-D37E-4469-ADE5-DAE629F1BCB0}"/>
                          </a:ext>
                        </a:extLst>
                      </p:cNvPr>
                      <p:cNvSpPr>
                        <a:spLocks noEditPoints="1"/>
                      </p:cNvSpPr>
                      <p:nvPr/>
                    </p:nvSpPr>
                    <p:spPr bwMode="auto">
                      <a:xfrm>
                        <a:off x="1063784" y="1649737"/>
                        <a:ext cx="52626" cy="145732"/>
                      </a:xfrm>
                      <a:custGeom>
                        <a:avLst/>
                        <a:gdLst>
                          <a:gd name="T0" fmla="*/ 19 w 39"/>
                          <a:gd name="T1" fmla="*/ 54 h 108"/>
                          <a:gd name="T2" fmla="*/ 19 w 39"/>
                          <a:gd name="T3" fmla="*/ 108 h 108"/>
                          <a:gd name="T4" fmla="*/ 19 w 39"/>
                          <a:gd name="T5" fmla="*/ 54 h 108"/>
                          <a:gd name="T6" fmla="*/ 19 w 39"/>
                          <a:gd name="T7" fmla="*/ 54 h 108"/>
                          <a:gd name="T8" fmla="*/ 19 w 39"/>
                          <a:gd name="T9" fmla="*/ 0 h 108"/>
                          <a:gd name="T10" fmla="*/ 19 w 39"/>
                          <a:gd name="T11" fmla="*/ 54 h 108"/>
                          <a:gd name="T12" fmla="*/ 0 w 39"/>
                          <a:gd name="T13" fmla="*/ 108 h 108"/>
                          <a:gd name="T14" fmla="*/ 39 w 39"/>
                          <a:gd name="T15" fmla="*/ 108 h 108"/>
                          <a:gd name="T16" fmla="*/ 0 w 39"/>
                          <a:gd name="T17" fmla="*/ 108 h 108"/>
                          <a:gd name="T18" fmla="*/ 0 w 39"/>
                          <a:gd name="T19" fmla="*/ 0 h 108"/>
                          <a:gd name="T20" fmla="*/ 39 w 39"/>
                          <a:gd name="T21" fmla="*/ 0 h 108"/>
                          <a:gd name="T22" fmla="*/ 0 w 39"/>
                          <a:gd name="T23" fmla="*/ 0 h 10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9" h="108">
                            <a:moveTo>
                              <a:pt x="19" y="54"/>
                            </a:moveTo>
                            <a:lnTo>
                              <a:pt x="19" y="108"/>
                            </a:lnTo>
                            <a:lnTo>
                              <a:pt x="19" y="54"/>
                            </a:lnTo>
                            <a:close/>
                            <a:moveTo>
                              <a:pt x="19" y="54"/>
                            </a:moveTo>
                            <a:lnTo>
                              <a:pt x="19" y="0"/>
                            </a:lnTo>
                            <a:lnTo>
                              <a:pt x="19" y="54"/>
                            </a:lnTo>
                            <a:close/>
                            <a:moveTo>
                              <a:pt x="0" y="108"/>
                            </a:moveTo>
                            <a:lnTo>
                              <a:pt x="39" y="108"/>
                            </a:lnTo>
                            <a:lnTo>
                              <a:pt x="0" y="108"/>
                            </a:lnTo>
                            <a:close/>
                            <a:moveTo>
                              <a:pt x="0" y="0"/>
                            </a:moveTo>
                            <a:lnTo>
                              <a:pt x="39"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IN"/>
                      </a:p>
                    </p:txBody>
                  </p:sp>
                  <p:sp>
                    <p:nvSpPr>
                      <p:cNvPr id="103" name="Rectangle 41">
                        <a:extLst>
                          <a:ext uri="{FF2B5EF4-FFF2-40B4-BE49-F238E27FC236}">
                            <a16:creationId xmlns:a16="http://schemas.microsoft.com/office/drawing/2014/main" id="{968BEB47-7C99-4E57-BD40-C9F5A9D4B353}"/>
                          </a:ext>
                        </a:extLst>
                      </p:cNvPr>
                      <p:cNvSpPr>
                        <a:spLocks noChangeArrowheads="1"/>
                      </p:cNvSpPr>
                      <p:nvPr/>
                    </p:nvSpPr>
                    <p:spPr bwMode="auto">
                      <a:xfrm>
                        <a:off x="957459" y="1720769"/>
                        <a:ext cx="265595" cy="1327973"/>
                      </a:xfrm>
                      <a:prstGeom prst="rect">
                        <a:avLst/>
                      </a:prstGeom>
                      <a:solidFill>
                        <a:srgbClr val="FBEEE6"/>
                      </a:solidFill>
                      <a:ln w="1270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grpSp>
                <p:sp>
                  <p:nvSpPr>
                    <p:cNvPr id="11" name="Freeform 10">
                      <a:extLst>
                        <a:ext uri="{FF2B5EF4-FFF2-40B4-BE49-F238E27FC236}">
                          <a16:creationId xmlns:a16="http://schemas.microsoft.com/office/drawing/2014/main" id="{936998DF-F8B8-45CE-8684-903ACF81BC9E}"/>
                        </a:ext>
                      </a:extLst>
                    </p:cNvPr>
                    <p:cNvSpPr>
                      <a:spLocks noEditPoints="1"/>
                    </p:cNvSpPr>
                    <p:nvPr/>
                  </p:nvSpPr>
                  <p:spPr bwMode="auto">
                    <a:xfrm>
                      <a:off x="1523920" y="539472"/>
                      <a:ext cx="52626" cy="145732"/>
                    </a:xfrm>
                    <a:custGeom>
                      <a:avLst/>
                      <a:gdLst>
                        <a:gd name="T0" fmla="*/ 19 w 39"/>
                        <a:gd name="T1" fmla="*/ 54 h 108"/>
                        <a:gd name="T2" fmla="*/ 19 w 39"/>
                        <a:gd name="T3" fmla="*/ 108 h 108"/>
                        <a:gd name="T4" fmla="*/ 19 w 39"/>
                        <a:gd name="T5" fmla="*/ 54 h 108"/>
                        <a:gd name="T6" fmla="*/ 19 w 39"/>
                        <a:gd name="T7" fmla="*/ 0 h 108"/>
                        <a:gd name="T8" fmla="*/ 0 w 39"/>
                        <a:gd name="T9" fmla="*/ 108 h 108"/>
                        <a:gd name="T10" fmla="*/ 39 w 39"/>
                        <a:gd name="T11" fmla="*/ 108 h 108"/>
                        <a:gd name="T12" fmla="*/ 0 w 39"/>
                        <a:gd name="T13" fmla="*/ 0 h 108"/>
                        <a:gd name="T14" fmla="*/ 39 w 39"/>
                        <a:gd name="T15" fmla="*/ 0 h 108"/>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9" h="108">
                          <a:moveTo>
                            <a:pt x="19" y="54"/>
                          </a:moveTo>
                          <a:lnTo>
                            <a:pt x="19" y="108"/>
                          </a:lnTo>
                          <a:moveTo>
                            <a:pt x="19" y="54"/>
                          </a:moveTo>
                          <a:lnTo>
                            <a:pt x="19" y="0"/>
                          </a:lnTo>
                          <a:moveTo>
                            <a:pt x="0" y="108"/>
                          </a:moveTo>
                          <a:lnTo>
                            <a:pt x="39" y="108"/>
                          </a:lnTo>
                          <a:moveTo>
                            <a:pt x="0" y="0"/>
                          </a:moveTo>
                          <a:lnTo>
                            <a:pt x="39" y="0"/>
                          </a:lnTo>
                        </a:path>
                      </a:pathLst>
                    </a:custGeom>
                    <a:noFill/>
                    <a:ln w="9525"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nvGrpSpPr>
                  <p:cNvPr id="126" name="Group 125">
                    <a:extLst>
                      <a:ext uri="{FF2B5EF4-FFF2-40B4-BE49-F238E27FC236}">
                        <a16:creationId xmlns:a16="http://schemas.microsoft.com/office/drawing/2014/main" id="{63A9E844-22AE-46DC-90C7-C5F734906FBE}"/>
                      </a:ext>
                    </a:extLst>
                  </p:cNvPr>
                  <p:cNvGrpSpPr/>
                  <p:nvPr/>
                </p:nvGrpSpPr>
                <p:grpSpPr>
                  <a:xfrm>
                    <a:off x="-2179961" y="1023843"/>
                    <a:ext cx="265595" cy="1623512"/>
                    <a:chOff x="1878203" y="1429392"/>
                    <a:chExt cx="265595" cy="1623512"/>
                  </a:xfrm>
                </p:grpSpPr>
                <p:sp>
                  <p:nvSpPr>
                    <p:cNvPr id="104" name="Rectangle 43">
                      <a:extLst>
                        <a:ext uri="{FF2B5EF4-FFF2-40B4-BE49-F238E27FC236}">
                          <a16:creationId xmlns:a16="http://schemas.microsoft.com/office/drawing/2014/main" id="{E0D019F2-3269-4E5D-B5E7-B3EE84E54EBA}"/>
                        </a:ext>
                      </a:extLst>
                    </p:cNvPr>
                    <p:cNvSpPr>
                      <a:spLocks noChangeArrowheads="1"/>
                    </p:cNvSpPr>
                    <p:nvPr/>
                  </p:nvSpPr>
                  <p:spPr bwMode="auto">
                    <a:xfrm>
                      <a:off x="1878203" y="1512456"/>
                      <a:ext cx="265595" cy="1540448"/>
                    </a:xfrm>
                    <a:prstGeom prst="rect">
                      <a:avLst/>
                    </a:prstGeom>
                    <a:solidFill>
                      <a:srgbClr val="F6DDCC"/>
                    </a:solidFill>
                    <a:ln w="1270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3" name="Freeform 12">
                      <a:extLst>
                        <a:ext uri="{FF2B5EF4-FFF2-40B4-BE49-F238E27FC236}">
                          <a16:creationId xmlns:a16="http://schemas.microsoft.com/office/drawing/2014/main" id="{E097214B-D01B-4D56-A01D-13249F320072}"/>
                        </a:ext>
                      </a:extLst>
                    </p:cNvPr>
                    <p:cNvSpPr>
                      <a:spLocks noEditPoints="1"/>
                    </p:cNvSpPr>
                    <p:nvPr/>
                  </p:nvSpPr>
                  <p:spPr bwMode="auto">
                    <a:xfrm>
                      <a:off x="1973659" y="1429392"/>
                      <a:ext cx="52626" cy="161925"/>
                    </a:xfrm>
                    <a:custGeom>
                      <a:avLst/>
                      <a:gdLst>
                        <a:gd name="T0" fmla="*/ 20 w 39"/>
                        <a:gd name="T1" fmla="*/ 60 h 120"/>
                        <a:gd name="T2" fmla="*/ 20 w 39"/>
                        <a:gd name="T3" fmla="*/ 120 h 120"/>
                        <a:gd name="T4" fmla="*/ 20 w 39"/>
                        <a:gd name="T5" fmla="*/ 60 h 120"/>
                        <a:gd name="T6" fmla="*/ 20 w 39"/>
                        <a:gd name="T7" fmla="*/ 0 h 120"/>
                        <a:gd name="T8" fmla="*/ 0 w 39"/>
                        <a:gd name="T9" fmla="*/ 120 h 120"/>
                        <a:gd name="T10" fmla="*/ 39 w 39"/>
                        <a:gd name="T11" fmla="*/ 120 h 120"/>
                        <a:gd name="T12" fmla="*/ 0 w 39"/>
                        <a:gd name="T13" fmla="*/ 0 h 120"/>
                        <a:gd name="T14" fmla="*/ 39 w 39"/>
                        <a:gd name="T15" fmla="*/ 0 h 120"/>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9" h="120">
                          <a:moveTo>
                            <a:pt x="20" y="60"/>
                          </a:moveTo>
                          <a:lnTo>
                            <a:pt x="20" y="120"/>
                          </a:lnTo>
                          <a:moveTo>
                            <a:pt x="20" y="60"/>
                          </a:moveTo>
                          <a:lnTo>
                            <a:pt x="20" y="0"/>
                          </a:lnTo>
                          <a:moveTo>
                            <a:pt x="0" y="120"/>
                          </a:moveTo>
                          <a:lnTo>
                            <a:pt x="39" y="120"/>
                          </a:lnTo>
                          <a:moveTo>
                            <a:pt x="0" y="0"/>
                          </a:moveTo>
                          <a:lnTo>
                            <a:pt x="39" y="0"/>
                          </a:lnTo>
                        </a:path>
                      </a:pathLst>
                    </a:custGeom>
                    <a:noFill/>
                    <a:ln w="9525"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nvGrpSpPr>
                  <p:cNvPr id="127" name="Group 126">
                    <a:extLst>
                      <a:ext uri="{FF2B5EF4-FFF2-40B4-BE49-F238E27FC236}">
                        <a16:creationId xmlns:a16="http://schemas.microsoft.com/office/drawing/2014/main" id="{83B31E63-F12D-4FD1-8945-9234155FFAFE}"/>
                      </a:ext>
                    </a:extLst>
                  </p:cNvPr>
                  <p:cNvGrpSpPr/>
                  <p:nvPr/>
                </p:nvGrpSpPr>
                <p:grpSpPr>
                  <a:xfrm>
                    <a:off x="-1511793" y="1439267"/>
                    <a:ext cx="265595" cy="1212135"/>
                    <a:chOff x="2792083" y="1829601"/>
                    <a:chExt cx="265595" cy="1212135"/>
                  </a:xfrm>
                </p:grpSpPr>
                <p:sp>
                  <p:nvSpPr>
                    <p:cNvPr id="105" name="Rectangle 45">
                      <a:extLst>
                        <a:ext uri="{FF2B5EF4-FFF2-40B4-BE49-F238E27FC236}">
                          <a16:creationId xmlns:a16="http://schemas.microsoft.com/office/drawing/2014/main" id="{464C7B15-122F-4FA5-9D69-D9A207B0EA27}"/>
                        </a:ext>
                      </a:extLst>
                    </p:cNvPr>
                    <p:cNvSpPr>
                      <a:spLocks noChangeArrowheads="1"/>
                    </p:cNvSpPr>
                    <p:nvPr/>
                  </p:nvSpPr>
                  <p:spPr bwMode="auto">
                    <a:xfrm>
                      <a:off x="2792083" y="1972275"/>
                      <a:ext cx="265595" cy="1069461"/>
                    </a:xfrm>
                    <a:prstGeom prst="rect">
                      <a:avLst/>
                    </a:prstGeom>
                    <a:solidFill>
                      <a:srgbClr val="EDBB99"/>
                    </a:solidFill>
                    <a:ln w="1270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5" name="Freeform 14">
                      <a:extLst>
                        <a:ext uri="{FF2B5EF4-FFF2-40B4-BE49-F238E27FC236}">
                          <a16:creationId xmlns:a16="http://schemas.microsoft.com/office/drawing/2014/main" id="{F2EB0060-8D7A-4D1D-A7A9-83E653189841}"/>
                        </a:ext>
                      </a:extLst>
                    </p:cNvPr>
                    <p:cNvSpPr>
                      <a:spLocks noEditPoints="1"/>
                    </p:cNvSpPr>
                    <p:nvPr/>
                  </p:nvSpPr>
                  <p:spPr bwMode="auto">
                    <a:xfrm>
                      <a:off x="2897584" y="1829601"/>
                      <a:ext cx="51276" cy="283369"/>
                    </a:xfrm>
                    <a:custGeom>
                      <a:avLst/>
                      <a:gdLst>
                        <a:gd name="T0" fmla="*/ 19 w 38"/>
                        <a:gd name="T1" fmla="*/ 102 h 210"/>
                        <a:gd name="T2" fmla="*/ 19 w 38"/>
                        <a:gd name="T3" fmla="*/ 210 h 210"/>
                        <a:gd name="T4" fmla="*/ 19 w 38"/>
                        <a:gd name="T5" fmla="*/ 102 h 210"/>
                        <a:gd name="T6" fmla="*/ 19 w 38"/>
                        <a:gd name="T7" fmla="*/ 0 h 210"/>
                        <a:gd name="T8" fmla="*/ 0 w 38"/>
                        <a:gd name="T9" fmla="*/ 210 h 210"/>
                        <a:gd name="T10" fmla="*/ 38 w 38"/>
                        <a:gd name="T11" fmla="*/ 210 h 210"/>
                        <a:gd name="T12" fmla="*/ 0 w 38"/>
                        <a:gd name="T13" fmla="*/ 0 h 210"/>
                        <a:gd name="T14" fmla="*/ 38 w 38"/>
                        <a:gd name="T15" fmla="*/ 0 h 210"/>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8" h="210">
                          <a:moveTo>
                            <a:pt x="19" y="102"/>
                          </a:moveTo>
                          <a:lnTo>
                            <a:pt x="19" y="210"/>
                          </a:lnTo>
                          <a:moveTo>
                            <a:pt x="19" y="102"/>
                          </a:moveTo>
                          <a:lnTo>
                            <a:pt x="19" y="0"/>
                          </a:lnTo>
                          <a:moveTo>
                            <a:pt x="0" y="210"/>
                          </a:moveTo>
                          <a:lnTo>
                            <a:pt x="38" y="210"/>
                          </a:lnTo>
                          <a:moveTo>
                            <a:pt x="0" y="0"/>
                          </a:moveTo>
                          <a:lnTo>
                            <a:pt x="38" y="0"/>
                          </a:lnTo>
                        </a:path>
                      </a:pathLst>
                    </a:custGeom>
                    <a:noFill/>
                    <a:ln w="9525"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nvGrpSpPr>
                  <p:cNvPr id="6144" name="Group 6143">
                    <a:extLst>
                      <a:ext uri="{FF2B5EF4-FFF2-40B4-BE49-F238E27FC236}">
                        <a16:creationId xmlns:a16="http://schemas.microsoft.com/office/drawing/2014/main" id="{39C6F97A-8894-4631-845F-4DFD30495D5E}"/>
                      </a:ext>
                    </a:extLst>
                  </p:cNvPr>
                  <p:cNvGrpSpPr/>
                  <p:nvPr/>
                </p:nvGrpSpPr>
                <p:grpSpPr>
                  <a:xfrm>
                    <a:off x="-843567" y="1518893"/>
                    <a:ext cx="265595" cy="1130195"/>
                    <a:chOff x="3742218" y="1908817"/>
                    <a:chExt cx="265595" cy="1130195"/>
                  </a:xfrm>
                </p:grpSpPr>
                <p:sp>
                  <p:nvSpPr>
                    <p:cNvPr id="106" name="Rectangle 47">
                      <a:extLst>
                        <a:ext uri="{FF2B5EF4-FFF2-40B4-BE49-F238E27FC236}">
                          <a16:creationId xmlns:a16="http://schemas.microsoft.com/office/drawing/2014/main" id="{EFA1107F-AB41-4FB0-BC8C-B1792BC9D56C}"/>
                        </a:ext>
                      </a:extLst>
                    </p:cNvPr>
                    <p:cNvSpPr>
                      <a:spLocks noChangeArrowheads="1"/>
                    </p:cNvSpPr>
                    <p:nvPr/>
                  </p:nvSpPr>
                  <p:spPr bwMode="auto">
                    <a:xfrm>
                      <a:off x="3742218" y="2026212"/>
                      <a:ext cx="265595" cy="1012800"/>
                    </a:xfrm>
                    <a:prstGeom prst="rect">
                      <a:avLst/>
                    </a:prstGeom>
                    <a:solidFill>
                      <a:srgbClr val="E59866"/>
                    </a:solidFill>
                    <a:ln w="1270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17" name="Freeform 16">
                      <a:extLst>
                        <a:ext uri="{FF2B5EF4-FFF2-40B4-BE49-F238E27FC236}">
                          <a16:creationId xmlns:a16="http://schemas.microsoft.com/office/drawing/2014/main" id="{FA75543B-A120-40FF-B55D-94B83AF57E73}"/>
                        </a:ext>
                      </a:extLst>
                    </p:cNvPr>
                    <p:cNvSpPr>
                      <a:spLocks noEditPoints="1"/>
                    </p:cNvSpPr>
                    <p:nvPr/>
                  </p:nvSpPr>
                  <p:spPr bwMode="auto">
                    <a:xfrm>
                      <a:off x="3842385" y="1908817"/>
                      <a:ext cx="52626" cy="234791"/>
                    </a:xfrm>
                    <a:custGeom>
                      <a:avLst/>
                      <a:gdLst>
                        <a:gd name="T0" fmla="*/ 19 w 39"/>
                        <a:gd name="T1" fmla="*/ 90 h 174"/>
                        <a:gd name="T2" fmla="*/ 19 w 39"/>
                        <a:gd name="T3" fmla="*/ 174 h 174"/>
                        <a:gd name="T4" fmla="*/ 19 w 39"/>
                        <a:gd name="T5" fmla="*/ 90 h 174"/>
                        <a:gd name="T6" fmla="*/ 19 w 39"/>
                        <a:gd name="T7" fmla="*/ 0 h 174"/>
                        <a:gd name="T8" fmla="*/ 0 w 39"/>
                        <a:gd name="T9" fmla="*/ 174 h 174"/>
                        <a:gd name="T10" fmla="*/ 39 w 39"/>
                        <a:gd name="T11" fmla="*/ 174 h 174"/>
                        <a:gd name="T12" fmla="*/ 0 w 39"/>
                        <a:gd name="T13" fmla="*/ 0 h 174"/>
                        <a:gd name="T14" fmla="*/ 39 w 39"/>
                        <a:gd name="T15" fmla="*/ 0 h 174"/>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9" h="174">
                          <a:moveTo>
                            <a:pt x="19" y="90"/>
                          </a:moveTo>
                          <a:lnTo>
                            <a:pt x="19" y="174"/>
                          </a:lnTo>
                          <a:moveTo>
                            <a:pt x="19" y="90"/>
                          </a:moveTo>
                          <a:lnTo>
                            <a:pt x="19" y="0"/>
                          </a:lnTo>
                          <a:moveTo>
                            <a:pt x="0" y="174"/>
                          </a:moveTo>
                          <a:lnTo>
                            <a:pt x="39" y="174"/>
                          </a:lnTo>
                          <a:moveTo>
                            <a:pt x="0" y="0"/>
                          </a:moveTo>
                          <a:lnTo>
                            <a:pt x="39" y="0"/>
                          </a:lnTo>
                        </a:path>
                      </a:pathLst>
                    </a:custGeom>
                    <a:noFill/>
                    <a:ln w="9525"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sp>
              <p:nvSpPr>
                <p:cNvPr id="129" name="TextBox 128">
                  <a:extLst>
                    <a:ext uri="{FF2B5EF4-FFF2-40B4-BE49-F238E27FC236}">
                      <a16:creationId xmlns:a16="http://schemas.microsoft.com/office/drawing/2014/main" id="{3F0899B2-BA6E-400F-8968-978E33CA9582}"/>
                    </a:ext>
                  </a:extLst>
                </p:cNvPr>
                <p:cNvSpPr txBox="1"/>
                <p:nvPr/>
              </p:nvSpPr>
              <p:spPr>
                <a:xfrm>
                  <a:off x="2911788" y="-41076"/>
                  <a:ext cx="846628" cy="369332"/>
                </a:xfrm>
                <a:prstGeom prst="rect">
                  <a:avLst/>
                </a:prstGeom>
                <a:noFill/>
              </p:spPr>
              <p:txBody>
                <a:bodyPr wrap="square" rtlCol="0">
                  <a:spAutoFit/>
                </a:bodyPr>
                <a:lstStyle/>
                <a:p>
                  <a:pPr algn="ctr"/>
                  <a:r>
                    <a:rPr lang="en-IN" dirty="0"/>
                    <a:t>Roots</a:t>
                  </a:r>
                </a:p>
              </p:txBody>
            </p:sp>
          </p:grpSp>
          <p:grpSp>
            <p:nvGrpSpPr>
              <p:cNvPr id="2" name="Group 1">
                <a:extLst>
                  <a:ext uri="{FF2B5EF4-FFF2-40B4-BE49-F238E27FC236}">
                    <a16:creationId xmlns:a16="http://schemas.microsoft.com/office/drawing/2014/main" id="{C31E4DC6-5586-431F-889B-42F95543FC94}"/>
                  </a:ext>
                </a:extLst>
              </p:cNvPr>
              <p:cNvGrpSpPr/>
              <p:nvPr/>
            </p:nvGrpSpPr>
            <p:grpSpPr>
              <a:xfrm>
                <a:off x="5013208" y="346398"/>
                <a:ext cx="3001811" cy="2677722"/>
                <a:chOff x="5013208" y="346398"/>
                <a:chExt cx="3001811" cy="2677722"/>
              </a:xfrm>
            </p:grpSpPr>
            <p:sp>
              <p:nvSpPr>
                <p:cNvPr id="88" name="Rectangle 49">
                  <a:extLst>
                    <a:ext uri="{FF2B5EF4-FFF2-40B4-BE49-F238E27FC236}">
                      <a16:creationId xmlns:a16="http://schemas.microsoft.com/office/drawing/2014/main" id="{EEDA7325-B3EF-4F8A-8D12-326D70A35122}"/>
                    </a:ext>
                  </a:extLst>
                </p:cNvPr>
                <p:cNvSpPr>
                  <a:spLocks noChangeArrowheads="1"/>
                </p:cNvSpPr>
                <p:nvPr/>
              </p:nvSpPr>
              <p:spPr bwMode="auto">
                <a:xfrm>
                  <a:off x="5351693" y="1008674"/>
                  <a:ext cx="0" cy="1763253"/>
                </a:xfrm>
                <a:prstGeom prst="rect">
                  <a:avLst/>
                </a:prstGeom>
                <a:solidFill>
                  <a:schemeClr val="tx1"/>
                </a:solidFill>
                <a:ln w="1270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a:p>
              </p:txBody>
            </p:sp>
            <p:sp>
              <p:nvSpPr>
                <p:cNvPr id="89" name="Freeform 50">
                  <a:extLst>
                    <a:ext uri="{FF2B5EF4-FFF2-40B4-BE49-F238E27FC236}">
                      <a16:creationId xmlns:a16="http://schemas.microsoft.com/office/drawing/2014/main" id="{20E85F8D-1BD5-4966-97B0-1E551E735114}"/>
                    </a:ext>
                  </a:extLst>
                </p:cNvPr>
                <p:cNvSpPr>
                  <a:spLocks noEditPoints="1"/>
                </p:cNvSpPr>
                <p:nvPr/>
              </p:nvSpPr>
              <p:spPr bwMode="auto">
                <a:xfrm>
                  <a:off x="5314067" y="1359112"/>
                  <a:ext cx="29511" cy="1416504"/>
                </a:xfrm>
                <a:custGeom>
                  <a:avLst/>
                  <a:gdLst/>
                  <a:ahLst/>
                  <a:cxnLst>
                    <a:cxn ang="0">
                      <a:pos x="0" y="1146"/>
                    </a:cxn>
                    <a:cxn ang="0">
                      <a:pos x="24" y="1146"/>
                    </a:cxn>
                    <a:cxn ang="0">
                      <a:pos x="24" y="1152"/>
                    </a:cxn>
                    <a:cxn ang="0">
                      <a:pos x="0" y="1152"/>
                    </a:cxn>
                    <a:cxn ang="0">
                      <a:pos x="0" y="1146"/>
                    </a:cxn>
                    <a:cxn ang="0">
                      <a:pos x="0" y="576"/>
                    </a:cxn>
                    <a:cxn ang="0">
                      <a:pos x="24" y="576"/>
                    </a:cxn>
                    <a:cxn ang="0">
                      <a:pos x="24" y="582"/>
                    </a:cxn>
                    <a:cxn ang="0">
                      <a:pos x="0" y="582"/>
                    </a:cxn>
                    <a:cxn ang="0">
                      <a:pos x="0" y="576"/>
                    </a:cxn>
                    <a:cxn ang="0">
                      <a:pos x="0" y="0"/>
                    </a:cxn>
                    <a:cxn ang="0">
                      <a:pos x="24" y="0"/>
                    </a:cxn>
                    <a:cxn ang="0">
                      <a:pos x="24" y="6"/>
                    </a:cxn>
                    <a:cxn ang="0">
                      <a:pos x="0" y="6"/>
                    </a:cxn>
                    <a:cxn ang="0">
                      <a:pos x="0" y="0"/>
                    </a:cxn>
                  </a:cxnLst>
                  <a:rect l="0" t="0" r="r" b="b"/>
                  <a:pathLst>
                    <a:path w="24" h="1152">
                      <a:moveTo>
                        <a:pt x="0" y="1146"/>
                      </a:moveTo>
                      <a:lnTo>
                        <a:pt x="24" y="1146"/>
                      </a:lnTo>
                      <a:lnTo>
                        <a:pt x="24" y="1152"/>
                      </a:lnTo>
                      <a:lnTo>
                        <a:pt x="0" y="1152"/>
                      </a:lnTo>
                      <a:lnTo>
                        <a:pt x="0" y="1146"/>
                      </a:lnTo>
                      <a:close/>
                      <a:moveTo>
                        <a:pt x="0" y="576"/>
                      </a:moveTo>
                      <a:lnTo>
                        <a:pt x="24" y="576"/>
                      </a:lnTo>
                      <a:lnTo>
                        <a:pt x="24" y="582"/>
                      </a:lnTo>
                      <a:lnTo>
                        <a:pt x="0" y="582"/>
                      </a:lnTo>
                      <a:lnTo>
                        <a:pt x="0" y="576"/>
                      </a:lnTo>
                      <a:close/>
                      <a:moveTo>
                        <a:pt x="0" y="0"/>
                      </a:moveTo>
                      <a:lnTo>
                        <a:pt x="24" y="0"/>
                      </a:lnTo>
                      <a:lnTo>
                        <a:pt x="24" y="6"/>
                      </a:lnTo>
                      <a:lnTo>
                        <a:pt x="0" y="6"/>
                      </a:lnTo>
                      <a:lnTo>
                        <a:pt x="0" y="0"/>
                      </a:lnTo>
                      <a:close/>
                    </a:path>
                  </a:pathLst>
                </a:custGeom>
                <a:solidFill>
                  <a:schemeClr val="tx1"/>
                </a:solidFill>
                <a:ln w="1270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a:p>
              </p:txBody>
            </p:sp>
            <p:sp>
              <p:nvSpPr>
                <p:cNvPr id="90" name="Rectangle 51">
                  <a:extLst>
                    <a:ext uri="{FF2B5EF4-FFF2-40B4-BE49-F238E27FC236}">
                      <a16:creationId xmlns:a16="http://schemas.microsoft.com/office/drawing/2014/main" id="{1FFD48A8-8576-41A7-8DDA-A400C1C59A48}"/>
                    </a:ext>
                  </a:extLst>
                </p:cNvPr>
                <p:cNvSpPr>
                  <a:spLocks noChangeArrowheads="1"/>
                </p:cNvSpPr>
                <p:nvPr/>
              </p:nvSpPr>
              <p:spPr bwMode="auto">
                <a:xfrm>
                  <a:off x="5355382" y="2780042"/>
                  <a:ext cx="2655948" cy="0"/>
                </a:xfrm>
                <a:prstGeom prst="rect">
                  <a:avLst/>
                </a:prstGeom>
                <a:solidFill>
                  <a:schemeClr val="tx1"/>
                </a:solidFill>
                <a:ln w="1270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a:p>
              </p:txBody>
            </p:sp>
            <p:sp>
              <p:nvSpPr>
                <p:cNvPr id="91" name="Freeform 52">
                  <a:extLst>
                    <a:ext uri="{FF2B5EF4-FFF2-40B4-BE49-F238E27FC236}">
                      <a16:creationId xmlns:a16="http://schemas.microsoft.com/office/drawing/2014/main" id="{C7E68A15-C0A9-464F-A12A-5926695CA24D}"/>
                    </a:ext>
                  </a:extLst>
                </p:cNvPr>
                <p:cNvSpPr>
                  <a:spLocks noEditPoints="1"/>
                </p:cNvSpPr>
                <p:nvPr/>
              </p:nvSpPr>
              <p:spPr bwMode="auto">
                <a:xfrm>
                  <a:off x="5351693" y="2784179"/>
                  <a:ext cx="2663326" cy="29511"/>
                </a:xfrm>
                <a:custGeom>
                  <a:avLst/>
                  <a:gdLst/>
                  <a:ahLst/>
                  <a:cxnLst>
                    <a:cxn ang="0">
                      <a:pos x="6" y="0"/>
                    </a:cxn>
                    <a:cxn ang="0">
                      <a:pos x="6" y="24"/>
                    </a:cxn>
                    <a:cxn ang="0">
                      <a:pos x="0" y="24"/>
                    </a:cxn>
                    <a:cxn ang="0">
                      <a:pos x="0" y="0"/>
                    </a:cxn>
                    <a:cxn ang="0">
                      <a:pos x="6" y="0"/>
                    </a:cxn>
                    <a:cxn ang="0">
                      <a:pos x="546" y="0"/>
                    </a:cxn>
                    <a:cxn ang="0">
                      <a:pos x="546" y="24"/>
                    </a:cxn>
                    <a:cxn ang="0">
                      <a:pos x="540" y="24"/>
                    </a:cxn>
                    <a:cxn ang="0">
                      <a:pos x="540" y="0"/>
                    </a:cxn>
                    <a:cxn ang="0">
                      <a:pos x="546" y="0"/>
                    </a:cxn>
                    <a:cxn ang="0">
                      <a:pos x="1086" y="0"/>
                    </a:cxn>
                    <a:cxn ang="0">
                      <a:pos x="1086" y="24"/>
                    </a:cxn>
                    <a:cxn ang="0">
                      <a:pos x="1080" y="24"/>
                    </a:cxn>
                    <a:cxn ang="0">
                      <a:pos x="1080" y="0"/>
                    </a:cxn>
                    <a:cxn ang="0">
                      <a:pos x="1086" y="0"/>
                    </a:cxn>
                    <a:cxn ang="0">
                      <a:pos x="1626" y="0"/>
                    </a:cxn>
                    <a:cxn ang="0">
                      <a:pos x="1626" y="24"/>
                    </a:cxn>
                    <a:cxn ang="0">
                      <a:pos x="1620" y="24"/>
                    </a:cxn>
                    <a:cxn ang="0">
                      <a:pos x="1620" y="0"/>
                    </a:cxn>
                    <a:cxn ang="0">
                      <a:pos x="1626" y="0"/>
                    </a:cxn>
                    <a:cxn ang="0">
                      <a:pos x="2166" y="0"/>
                    </a:cxn>
                    <a:cxn ang="0">
                      <a:pos x="2166" y="24"/>
                    </a:cxn>
                    <a:cxn ang="0">
                      <a:pos x="2160" y="24"/>
                    </a:cxn>
                    <a:cxn ang="0">
                      <a:pos x="2160" y="0"/>
                    </a:cxn>
                    <a:cxn ang="0">
                      <a:pos x="2166" y="0"/>
                    </a:cxn>
                  </a:cxnLst>
                  <a:rect l="0" t="0" r="r" b="b"/>
                  <a:pathLst>
                    <a:path w="2166" h="24">
                      <a:moveTo>
                        <a:pt x="6" y="0"/>
                      </a:moveTo>
                      <a:lnTo>
                        <a:pt x="6" y="24"/>
                      </a:lnTo>
                      <a:lnTo>
                        <a:pt x="0" y="24"/>
                      </a:lnTo>
                      <a:lnTo>
                        <a:pt x="0" y="0"/>
                      </a:lnTo>
                      <a:lnTo>
                        <a:pt x="6" y="0"/>
                      </a:lnTo>
                      <a:close/>
                      <a:moveTo>
                        <a:pt x="546" y="0"/>
                      </a:moveTo>
                      <a:lnTo>
                        <a:pt x="546" y="24"/>
                      </a:lnTo>
                      <a:lnTo>
                        <a:pt x="540" y="24"/>
                      </a:lnTo>
                      <a:lnTo>
                        <a:pt x="540" y="0"/>
                      </a:lnTo>
                      <a:lnTo>
                        <a:pt x="546" y="0"/>
                      </a:lnTo>
                      <a:close/>
                      <a:moveTo>
                        <a:pt x="1086" y="0"/>
                      </a:moveTo>
                      <a:lnTo>
                        <a:pt x="1086" y="24"/>
                      </a:lnTo>
                      <a:lnTo>
                        <a:pt x="1080" y="24"/>
                      </a:lnTo>
                      <a:lnTo>
                        <a:pt x="1080" y="0"/>
                      </a:lnTo>
                      <a:lnTo>
                        <a:pt x="1086" y="0"/>
                      </a:lnTo>
                      <a:close/>
                      <a:moveTo>
                        <a:pt x="1626" y="0"/>
                      </a:moveTo>
                      <a:lnTo>
                        <a:pt x="1626" y="24"/>
                      </a:lnTo>
                      <a:lnTo>
                        <a:pt x="1620" y="24"/>
                      </a:lnTo>
                      <a:lnTo>
                        <a:pt x="1620" y="0"/>
                      </a:lnTo>
                      <a:lnTo>
                        <a:pt x="1626" y="0"/>
                      </a:lnTo>
                      <a:close/>
                      <a:moveTo>
                        <a:pt x="2166" y="0"/>
                      </a:moveTo>
                      <a:lnTo>
                        <a:pt x="2166" y="24"/>
                      </a:lnTo>
                      <a:lnTo>
                        <a:pt x="2160" y="24"/>
                      </a:lnTo>
                      <a:lnTo>
                        <a:pt x="2160" y="0"/>
                      </a:lnTo>
                      <a:lnTo>
                        <a:pt x="2166" y="0"/>
                      </a:lnTo>
                      <a:close/>
                    </a:path>
                  </a:pathLst>
                </a:custGeom>
                <a:solidFill>
                  <a:schemeClr val="tx1"/>
                </a:solidFill>
                <a:ln w="12700" cap="flat">
                  <a:solidFill>
                    <a:schemeClr val="tx1"/>
                  </a:solidFill>
                  <a:prstDash val="solid"/>
                  <a:bevel/>
                  <a:headEnd/>
                  <a:tailEnd/>
                </a:ln>
              </p:spPr>
              <p:txBody>
                <a:bodyPr vert="horz" wrap="square" lIns="91440" tIns="45720" rIns="91440" bIns="45720" numCol="1" anchor="t" anchorCtr="0" compatLnSpc="1">
                  <a:prstTxWarp prst="textNoShape">
                    <a:avLst/>
                  </a:prstTxWarp>
                </a:bodyPr>
                <a:lstStyle/>
                <a:p>
                  <a:endParaRPr lang="en-IN"/>
                </a:p>
              </p:txBody>
            </p:sp>
            <p:sp>
              <p:nvSpPr>
                <p:cNvPr id="92" name="Rectangle 53">
                  <a:extLst>
                    <a:ext uri="{FF2B5EF4-FFF2-40B4-BE49-F238E27FC236}">
                      <a16:creationId xmlns:a16="http://schemas.microsoft.com/office/drawing/2014/main" id="{05F9510A-976C-426E-A5C0-467B86151CD9}"/>
                    </a:ext>
                  </a:extLst>
                </p:cNvPr>
                <p:cNvSpPr>
                  <a:spLocks noChangeArrowheads="1"/>
                </p:cNvSpPr>
                <p:nvPr/>
              </p:nvSpPr>
              <p:spPr bwMode="auto">
                <a:xfrm>
                  <a:off x="5212414" y="2669263"/>
                  <a:ext cx="70773" cy="16687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a:ln>
                        <a:noFill/>
                      </a:ln>
                      <a:solidFill>
                        <a:srgbClr val="000000"/>
                      </a:solidFill>
                      <a:effectLst/>
                      <a:latin typeface="Calibri" pitchFamily="34" charset="0"/>
                      <a:cs typeface="Arial" pitchFamily="34" charset="0"/>
                    </a:rPr>
                    <a:t>0</a:t>
                  </a:r>
                  <a:endParaRPr kumimoji="0" lang="en-US" sz="1400" b="0" i="0" u="none" strike="noStrike" cap="none" normalizeH="0" baseline="0">
                    <a:ln>
                      <a:noFill/>
                    </a:ln>
                    <a:solidFill>
                      <a:schemeClr val="tx1"/>
                    </a:solidFill>
                    <a:effectLst/>
                    <a:latin typeface="Arial" pitchFamily="34" charset="0"/>
                    <a:cs typeface="Arial" pitchFamily="34" charset="0"/>
                  </a:endParaRPr>
                </a:p>
              </p:txBody>
            </p:sp>
            <p:sp>
              <p:nvSpPr>
                <p:cNvPr id="93" name="Rectangle 54">
                  <a:extLst>
                    <a:ext uri="{FF2B5EF4-FFF2-40B4-BE49-F238E27FC236}">
                      <a16:creationId xmlns:a16="http://schemas.microsoft.com/office/drawing/2014/main" id="{23D78771-DED8-4B66-96C8-B0897F0D6C55}"/>
                    </a:ext>
                  </a:extLst>
                </p:cNvPr>
                <p:cNvSpPr>
                  <a:spLocks noChangeArrowheads="1"/>
                </p:cNvSpPr>
                <p:nvPr/>
              </p:nvSpPr>
              <p:spPr bwMode="auto">
                <a:xfrm>
                  <a:off x="5013208" y="1962034"/>
                  <a:ext cx="274114"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a:ln>
                        <a:noFill/>
                      </a:ln>
                      <a:solidFill>
                        <a:srgbClr val="000000"/>
                      </a:solidFill>
                      <a:effectLst/>
                      <a:latin typeface="Calibri" pitchFamily="34" charset="0"/>
                      <a:cs typeface="Arial" pitchFamily="34" charset="0"/>
                    </a:rPr>
                    <a:t>200</a:t>
                  </a:r>
                  <a:endParaRPr kumimoji="0" lang="en-US" sz="1400" b="0" i="0" u="none" strike="noStrike" cap="none" normalizeH="0" baseline="0">
                    <a:ln>
                      <a:noFill/>
                    </a:ln>
                    <a:solidFill>
                      <a:schemeClr val="tx1"/>
                    </a:solidFill>
                    <a:effectLst/>
                    <a:latin typeface="Arial" pitchFamily="34" charset="0"/>
                    <a:cs typeface="Arial" pitchFamily="34" charset="0"/>
                  </a:endParaRPr>
                </a:p>
              </p:txBody>
            </p:sp>
            <p:sp>
              <p:nvSpPr>
                <p:cNvPr id="94" name="Rectangle 55">
                  <a:extLst>
                    <a:ext uri="{FF2B5EF4-FFF2-40B4-BE49-F238E27FC236}">
                      <a16:creationId xmlns:a16="http://schemas.microsoft.com/office/drawing/2014/main" id="{AB3C78E1-A1BA-43E3-AD8D-24A6632A8505}"/>
                    </a:ext>
                  </a:extLst>
                </p:cNvPr>
                <p:cNvSpPr>
                  <a:spLocks noChangeArrowheads="1"/>
                </p:cNvSpPr>
                <p:nvPr/>
              </p:nvSpPr>
              <p:spPr bwMode="auto">
                <a:xfrm>
                  <a:off x="5013208" y="1247945"/>
                  <a:ext cx="274114"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a:ln>
                        <a:noFill/>
                      </a:ln>
                      <a:solidFill>
                        <a:srgbClr val="000000"/>
                      </a:solidFill>
                      <a:effectLst/>
                      <a:latin typeface="Calibri" pitchFamily="34" charset="0"/>
                      <a:cs typeface="Arial" pitchFamily="34" charset="0"/>
                    </a:rPr>
                    <a:t>400</a:t>
                  </a:r>
                  <a:endParaRPr kumimoji="0" lang="en-US" sz="1400" b="0" i="0" u="none" strike="noStrike" cap="none" normalizeH="0" baseline="0">
                    <a:ln>
                      <a:noFill/>
                    </a:ln>
                    <a:solidFill>
                      <a:schemeClr val="tx1"/>
                    </a:solidFill>
                    <a:effectLst/>
                    <a:latin typeface="Arial" pitchFamily="34" charset="0"/>
                    <a:cs typeface="Arial" pitchFamily="34" charset="0"/>
                  </a:endParaRPr>
                </a:p>
              </p:txBody>
            </p:sp>
            <p:sp>
              <p:nvSpPr>
                <p:cNvPr id="95" name="Rectangle 30">
                  <a:extLst>
                    <a:ext uri="{FF2B5EF4-FFF2-40B4-BE49-F238E27FC236}">
                      <a16:creationId xmlns:a16="http://schemas.microsoft.com/office/drawing/2014/main" id="{ED4BFF3B-DB09-42F9-8414-1D2FC1498227}"/>
                    </a:ext>
                  </a:extLst>
                </p:cNvPr>
                <p:cNvSpPr>
                  <a:spLocks noChangeArrowheads="1"/>
                </p:cNvSpPr>
                <p:nvPr/>
              </p:nvSpPr>
              <p:spPr bwMode="auto">
                <a:xfrm>
                  <a:off x="5642743" y="2808676"/>
                  <a:ext cx="96181"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i="0" u="none" strike="noStrike" cap="none" normalizeH="0" baseline="0">
                      <a:ln>
                        <a:noFill/>
                      </a:ln>
                      <a:solidFill>
                        <a:srgbClr val="000000"/>
                      </a:solidFill>
                      <a:effectLst/>
                      <a:latin typeface="Calibri" pitchFamily="34" charset="0"/>
                      <a:cs typeface="Arial" pitchFamily="34" charset="0"/>
                    </a:rPr>
                    <a:t>C</a:t>
                  </a:r>
                  <a:endParaRPr kumimoji="0" lang="en-US" sz="1400" i="0" u="none" strike="noStrike" cap="none" normalizeH="0" baseline="0">
                    <a:ln>
                      <a:noFill/>
                    </a:ln>
                    <a:solidFill>
                      <a:schemeClr val="tx1"/>
                    </a:solidFill>
                    <a:effectLst/>
                    <a:latin typeface="Arial" pitchFamily="34" charset="0"/>
                    <a:cs typeface="Arial" pitchFamily="34" charset="0"/>
                  </a:endParaRPr>
                </a:p>
              </p:txBody>
            </p:sp>
            <p:sp>
              <p:nvSpPr>
                <p:cNvPr id="96" name="Rectangle 31">
                  <a:extLst>
                    <a:ext uri="{FF2B5EF4-FFF2-40B4-BE49-F238E27FC236}">
                      <a16:creationId xmlns:a16="http://schemas.microsoft.com/office/drawing/2014/main" id="{8C279465-6B82-4BD8-B829-CC17C1C12CA2}"/>
                    </a:ext>
                  </a:extLst>
                </p:cNvPr>
                <p:cNvSpPr>
                  <a:spLocks noChangeArrowheads="1"/>
                </p:cNvSpPr>
                <p:nvPr/>
              </p:nvSpPr>
              <p:spPr bwMode="auto">
                <a:xfrm>
                  <a:off x="6278203" y="2808676"/>
                  <a:ext cx="174728"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i="0" u="none" strike="noStrike" cap="none" normalizeH="0" baseline="0">
                      <a:ln>
                        <a:noFill/>
                      </a:ln>
                      <a:solidFill>
                        <a:srgbClr val="000000"/>
                      </a:solidFill>
                      <a:effectLst/>
                      <a:latin typeface="Calibri" pitchFamily="34" charset="0"/>
                      <a:cs typeface="Arial" pitchFamily="34" charset="0"/>
                    </a:rPr>
                    <a:t>As</a:t>
                  </a:r>
                  <a:endParaRPr kumimoji="0" lang="en-US" sz="1400" i="0" u="none" strike="noStrike" cap="none" normalizeH="0" baseline="0">
                    <a:ln>
                      <a:noFill/>
                    </a:ln>
                    <a:solidFill>
                      <a:schemeClr val="tx1"/>
                    </a:solidFill>
                    <a:effectLst/>
                    <a:latin typeface="Arial" pitchFamily="34" charset="0"/>
                    <a:cs typeface="Arial" pitchFamily="34" charset="0"/>
                  </a:endParaRPr>
                </a:p>
              </p:txBody>
            </p:sp>
            <p:sp>
              <p:nvSpPr>
                <p:cNvPr id="97" name="Rectangle 32">
                  <a:extLst>
                    <a:ext uri="{FF2B5EF4-FFF2-40B4-BE49-F238E27FC236}">
                      <a16:creationId xmlns:a16="http://schemas.microsoft.com/office/drawing/2014/main" id="{FFCAA162-D6B2-404D-92B1-EA9AA7046CC6}"/>
                    </a:ext>
                  </a:extLst>
                </p:cNvPr>
                <p:cNvSpPr>
                  <a:spLocks noChangeArrowheads="1"/>
                </p:cNvSpPr>
                <p:nvPr/>
              </p:nvSpPr>
              <p:spPr bwMode="auto">
                <a:xfrm>
                  <a:off x="6880695" y="2808676"/>
                  <a:ext cx="281745"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i="0" u="none" strike="noStrike" cap="none" normalizeH="0" baseline="0">
                      <a:ln>
                        <a:noFill/>
                      </a:ln>
                      <a:solidFill>
                        <a:srgbClr val="000000"/>
                      </a:solidFill>
                      <a:effectLst/>
                      <a:latin typeface="Calibri" pitchFamily="34" charset="0"/>
                      <a:cs typeface="Arial" pitchFamily="34" charset="0"/>
                    </a:rPr>
                    <a:t>Hpx</a:t>
                  </a:r>
                  <a:endParaRPr kumimoji="0" lang="en-US" sz="1400" i="0" u="none" strike="noStrike" cap="none" normalizeH="0" baseline="0">
                    <a:ln>
                      <a:noFill/>
                    </a:ln>
                    <a:solidFill>
                      <a:schemeClr val="tx1"/>
                    </a:solidFill>
                    <a:effectLst/>
                    <a:latin typeface="Arial" pitchFamily="34" charset="0"/>
                    <a:cs typeface="Arial" pitchFamily="34" charset="0"/>
                  </a:endParaRPr>
                </a:p>
              </p:txBody>
            </p:sp>
            <p:sp>
              <p:nvSpPr>
                <p:cNvPr id="98" name="Rectangle 33">
                  <a:extLst>
                    <a:ext uri="{FF2B5EF4-FFF2-40B4-BE49-F238E27FC236}">
                      <a16:creationId xmlns:a16="http://schemas.microsoft.com/office/drawing/2014/main" id="{89616BEA-FCE9-4323-836C-CFE2541E5300}"/>
                    </a:ext>
                  </a:extLst>
                </p:cNvPr>
                <p:cNvSpPr>
                  <a:spLocks noChangeArrowheads="1"/>
                </p:cNvSpPr>
                <p:nvPr/>
              </p:nvSpPr>
              <p:spPr bwMode="auto">
                <a:xfrm>
                  <a:off x="7446424" y="2808676"/>
                  <a:ext cx="456472"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400" i="0" u="none" strike="noStrike" cap="none" normalizeH="0" baseline="0">
                      <a:ln>
                        <a:noFill/>
                      </a:ln>
                      <a:solidFill>
                        <a:srgbClr val="000000"/>
                      </a:solidFill>
                      <a:effectLst/>
                      <a:latin typeface="Calibri" pitchFamily="34" charset="0"/>
                      <a:cs typeface="Arial" pitchFamily="34" charset="0"/>
                    </a:rPr>
                    <a:t>HpxAs</a:t>
                  </a:r>
                  <a:endParaRPr kumimoji="0" lang="en-US" sz="1400" i="0" u="none" strike="noStrike" cap="none" normalizeH="0" baseline="0">
                    <a:ln>
                      <a:noFill/>
                    </a:ln>
                    <a:solidFill>
                      <a:schemeClr val="tx1"/>
                    </a:solidFill>
                    <a:effectLst/>
                    <a:latin typeface="Arial" pitchFamily="34" charset="0"/>
                    <a:cs typeface="Arial" pitchFamily="34" charset="0"/>
                  </a:endParaRPr>
                </a:p>
              </p:txBody>
            </p:sp>
            <p:grpSp>
              <p:nvGrpSpPr>
                <p:cNvPr id="6147" name="Group 6146">
                  <a:extLst>
                    <a:ext uri="{FF2B5EF4-FFF2-40B4-BE49-F238E27FC236}">
                      <a16:creationId xmlns:a16="http://schemas.microsoft.com/office/drawing/2014/main" id="{81B28253-3351-44DF-B808-E33AFD9C1F5F}"/>
                    </a:ext>
                  </a:extLst>
                </p:cNvPr>
                <p:cNvGrpSpPr/>
                <p:nvPr/>
              </p:nvGrpSpPr>
              <p:grpSpPr>
                <a:xfrm>
                  <a:off x="5555326" y="1265656"/>
                  <a:ext cx="265595" cy="1511173"/>
                  <a:chOff x="2054782" y="4159477"/>
                  <a:chExt cx="265595" cy="1511173"/>
                </a:xfrm>
              </p:grpSpPr>
              <p:sp>
                <p:nvSpPr>
                  <p:cNvPr id="83" name="Rectangle 41">
                    <a:extLst>
                      <a:ext uri="{FF2B5EF4-FFF2-40B4-BE49-F238E27FC236}">
                        <a16:creationId xmlns:a16="http://schemas.microsoft.com/office/drawing/2014/main" id="{98BC9CD6-7795-4186-9DF3-7468DDFD3A79}"/>
                      </a:ext>
                    </a:extLst>
                  </p:cNvPr>
                  <p:cNvSpPr>
                    <a:spLocks noChangeArrowheads="1"/>
                  </p:cNvSpPr>
                  <p:nvPr/>
                </p:nvSpPr>
                <p:spPr bwMode="auto">
                  <a:xfrm>
                    <a:off x="2054782" y="4191050"/>
                    <a:ext cx="265595" cy="1479600"/>
                  </a:xfrm>
                  <a:prstGeom prst="rect">
                    <a:avLst/>
                  </a:prstGeom>
                  <a:solidFill>
                    <a:srgbClr val="F5F5F5"/>
                  </a:solidFill>
                  <a:ln w="1270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7" name="Freeform 35">
                    <a:extLst>
                      <a:ext uri="{FF2B5EF4-FFF2-40B4-BE49-F238E27FC236}">
                        <a16:creationId xmlns:a16="http://schemas.microsoft.com/office/drawing/2014/main" id="{5589543A-EAC0-48A4-97A3-478FE4CC3960}"/>
                      </a:ext>
                    </a:extLst>
                  </p:cNvPr>
                  <p:cNvSpPr>
                    <a:spLocks noEditPoints="1"/>
                  </p:cNvSpPr>
                  <p:nvPr/>
                </p:nvSpPr>
                <p:spPr bwMode="auto">
                  <a:xfrm>
                    <a:off x="2166037" y="4159477"/>
                    <a:ext cx="42676" cy="59746"/>
                  </a:xfrm>
                  <a:custGeom>
                    <a:avLst/>
                    <a:gdLst>
                      <a:gd name="T0" fmla="*/ 17 w 35"/>
                      <a:gd name="T1" fmla="*/ 24 h 49"/>
                      <a:gd name="T2" fmla="*/ 17 w 35"/>
                      <a:gd name="T3" fmla="*/ 49 h 49"/>
                      <a:gd name="T4" fmla="*/ 17 w 35"/>
                      <a:gd name="T5" fmla="*/ 24 h 49"/>
                      <a:gd name="T6" fmla="*/ 17 w 35"/>
                      <a:gd name="T7" fmla="*/ 0 h 49"/>
                      <a:gd name="T8" fmla="*/ 0 w 35"/>
                      <a:gd name="T9" fmla="*/ 49 h 49"/>
                      <a:gd name="T10" fmla="*/ 35 w 35"/>
                      <a:gd name="T11" fmla="*/ 49 h 49"/>
                      <a:gd name="T12" fmla="*/ 0 w 35"/>
                      <a:gd name="T13" fmla="*/ 0 h 49"/>
                      <a:gd name="T14" fmla="*/ 35 w 35"/>
                      <a:gd name="T15" fmla="*/ 0 h 49"/>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5" h="49">
                        <a:moveTo>
                          <a:pt x="17" y="24"/>
                        </a:moveTo>
                        <a:lnTo>
                          <a:pt x="17" y="49"/>
                        </a:lnTo>
                        <a:moveTo>
                          <a:pt x="17" y="24"/>
                        </a:moveTo>
                        <a:lnTo>
                          <a:pt x="17" y="0"/>
                        </a:lnTo>
                        <a:moveTo>
                          <a:pt x="0" y="49"/>
                        </a:moveTo>
                        <a:lnTo>
                          <a:pt x="35" y="49"/>
                        </a:lnTo>
                        <a:moveTo>
                          <a:pt x="0" y="0"/>
                        </a:moveTo>
                        <a:lnTo>
                          <a:pt x="35" y="0"/>
                        </a:lnTo>
                      </a:path>
                    </a:pathLst>
                  </a:custGeom>
                  <a:noFill/>
                  <a:ln w="9525"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nvGrpSpPr>
                <p:cNvPr id="6148" name="Group 6147">
                  <a:extLst>
                    <a:ext uri="{FF2B5EF4-FFF2-40B4-BE49-F238E27FC236}">
                      <a16:creationId xmlns:a16="http://schemas.microsoft.com/office/drawing/2014/main" id="{E33051E4-CDF1-4432-987B-3AAED57DA1A0}"/>
                    </a:ext>
                  </a:extLst>
                </p:cNvPr>
                <p:cNvGrpSpPr/>
                <p:nvPr/>
              </p:nvGrpSpPr>
              <p:grpSpPr>
                <a:xfrm>
                  <a:off x="6198515" y="1321048"/>
                  <a:ext cx="265595" cy="1456140"/>
                  <a:chOff x="2838046" y="4211907"/>
                  <a:chExt cx="265595" cy="1456140"/>
                </a:xfrm>
              </p:grpSpPr>
              <p:sp>
                <p:nvSpPr>
                  <p:cNvPr id="85" name="Rectangle 43">
                    <a:extLst>
                      <a:ext uri="{FF2B5EF4-FFF2-40B4-BE49-F238E27FC236}">
                        <a16:creationId xmlns:a16="http://schemas.microsoft.com/office/drawing/2014/main" id="{A9901149-7AF0-46CD-8A1B-FB7912BE443A}"/>
                      </a:ext>
                    </a:extLst>
                  </p:cNvPr>
                  <p:cNvSpPr>
                    <a:spLocks noChangeArrowheads="1"/>
                  </p:cNvSpPr>
                  <p:nvPr/>
                </p:nvSpPr>
                <p:spPr bwMode="auto">
                  <a:xfrm>
                    <a:off x="2838046" y="4256847"/>
                    <a:ext cx="265595" cy="1411200"/>
                  </a:xfrm>
                  <a:prstGeom prst="rect">
                    <a:avLst/>
                  </a:prstGeom>
                  <a:solidFill>
                    <a:srgbClr val="E5F5E0"/>
                  </a:solidFill>
                  <a:ln w="1270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8" name="Freeform 36">
                    <a:extLst>
                      <a:ext uri="{FF2B5EF4-FFF2-40B4-BE49-F238E27FC236}">
                        <a16:creationId xmlns:a16="http://schemas.microsoft.com/office/drawing/2014/main" id="{68AFBE2D-926D-4949-AE99-8BFD9A5F32A8}"/>
                      </a:ext>
                    </a:extLst>
                  </p:cNvPr>
                  <p:cNvSpPr>
                    <a:spLocks noEditPoints="1"/>
                  </p:cNvSpPr>
                  <p:nvPr/>
                </p:nvSpPr>
                <p:spPr bwMode="auto">
                  <a:xfrm>
                    <a:off x="2948771" y="4211907"/>
                    <a:ext cx="45115" cy="86571"/>
                  </a:xfrm>
                  <a:custGeom>
                    <a:avLst/>
                    <a:gdLst>
                      <a:gd name="T0" fmla="*/ 18 w 37"/>
                      <a:gd name="T1" fmla="*/ 36 h 71"/>
                      <a:gd name="T2" fmla="*/ 18 w 37"/>
                      <a:gd name="T3" fmla="*/ 71 h 71"/>
                      <a:gd name="T4" fmla="*/ 18 w 37"/>
                      <a:gd name="T5" fmla="*/ 36 h 71"/>
                      <a:gd name="T6" fmla="*/ 18 w 37"/>
                      <a:gd name="T7" fmla="*/ 0 h 71"/>
                      <a:gd name="T8" fmla="*/ 0 w 37"/>
                      <a:gd name="T9" fmla="*/ 71 h 71"/>
                      <a:gd name="T10" fmla="*/ 37 w 37"/>
                      <a:gd name="T11" fmla="*/ 71 h 71"/>
                      <a:gd name="T12" fmla="*/ 0 w 37"/>
                      <a:gd name="T13" fmla="*/ 0 h 71"/>
                      <a:gd name="T14" fmla="*/ 37 w 37"/>
                      <a:gd name="T15" fmla="*/ 0 h 71"/>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7" h="71">
                        <a:moveTo>
                          <a:pt x="18" y="36"/>
                        </a:moveTo>
                        <a:lnTo>
                          <a:pt x="18" y="71"/>
                        </a:lnTo>
                        <a:moveTo>
                          <a:pt x="18" y="36"/>
                        </a:moveTo>
                        <a:lnTo>
                          <a:pt x="18" y="0"/>
                        </a:lnTo>
                        <a:moveTo>
                          <a:pt x="0" y="71"/>
                        </a:moveTo>
                        <a:lnTo>
                          <a:pt x="37" y="71"/>
                        </a:lnTo>
                        <a:moveTo>
                          <a:pt x="0" y="0"/>
                        </a:moveTo>
                        <a:lnTo>
                          <a:pt x="37" y="0"/>
                        </a:lnTo>
                      </a:path>
                    </a:pathLst>
                  </a:custGeom>
                  <a:noFill/>
                  <a:ln w="9525"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nvGrpSpPr>
                <p:cNvPr id="6149" name="Group 6148">
                  <a:extLst>
                    <a:ext uri="{FF2B5EF4-FFF2-40B4-BE49-F238E27FC236}">
                      <a16:creationId xmlns:a16="http://schemas.microsoft.com/office/drawing/2014/main" id="{FCA71BAD-D444-4BE7-A61E-97C04C5F2F04}"/>
                    </a:ext>
                  </a:extLst>
                </p:cNvPr>
                <p:cNvGrpSpPr/>
                <p:nvPr/>
              </p:nvGrpSpPr>
              <p:grpSpPr>
                <a:xfrm>
                  <a:off x="6898755" y="1153069"/>
                  <a:ext cx="265595" cy="1620989"/>
                  <a:chOff x="3630326" y="4048463"/>
                  <a:chExt cx="265595" cy="1620989"/>
                </a:xfrm>
              </p:grpSpPr>
              <p:sp>
                <p:nvSpPr>
                  <p:cNvPr id="86" name="Rectangle 45">
                    <a:extLst>
                      <a:ext uri="{FF2B5EF4-FFF2-40B4-BE49-F238E27FC236}">
                        <a16:creationId xmlns:a16="http://schemas.microsoft.com/office/drawing/2014/main" id="{B30BFF04-D847-48EB-8558-E5F8D9465CEE}"/>
                      </a:ext>
                    </a:extLst>
                  </p:cNvPr>
                  <p:cNvSpPr>
                    <a:spLocks noChangeArrowheads="1"/>
                  </p:cNvSpPr>
                  <p:nvPr/>
                </p:nvSpPr>
                <p:spPr bwMode="auto">
                  <a:xfrm>
                    <a:off x="3630326" y="4107052"/>
                    <a:ext cx="265595" cy="1562400"/>
                  </a:xfrm>
                  <a:prstGeom prst="rect">
                    <a:avLst/>
                  </a:prstGeom>
                  <a:solidFill>
                    <a:srgbClr val="A1D99B"/>
                  </a:solidFill>
                  <a:ln w="1270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69" name="Freeform 37">
                    <a:extLst>
                      <a:ext uri="{FF2B5EF4-FFF2-40B4-BE49-F238E27FC236}">
                        <a16:creationId xmlns:a16="http://schemas.microsoft.com/office/drawing/2014/main" id="{F08433CA-C0DC-4230-A0D6-48BFB4B0E112}"/>
                      </a:ext>
                    </a:extLst>
                  </p:cNvPr>
                  <p:cNvSpPr>
                    <a:spLocks noEditPoints="1"/>
                  </p:cNvSpPr>
                  <p:nvPr/>
                </p:nvSpPr>
                <p:spPr bwMode="auto">
                  <a:xfrm>
                    <a:off x="3738706" y="4048463"/>
                    <a:ext cx="43895" cy="120711"/>
                  </a:xfrm>
                  <a:custGeom>
                    <a:avLst/>
                    <a:gdLst>
                      <a:gd name="T0" fmla="*/ 18 w 36"/>
                      <a:gd name="T1" fmla="*/ 49 h 99"/>
                      <a:gd name="T2" fmla="*/ 18 w 36"/>
                      <a:gd name="T3" fmla="*/ 99 h 99"/>
                      <a:gd name="T4" fmla="*/ 18 w 36"/>
                      <a:gd name="T5" fmla="*/ 49 h 99"/>
                      <a:gd name="T6" fmla="*/ 18 w 36"/>
                      <a:gd name="T7" fmla="*/ 0 h 99"/>
                      <a:gd name="T8" fmla="*/ 0 w 36"/>
                      <a:gd name="T9" fmla="*/ 99 h 99"/>
                      <a:gd name="T10" fmla="*/ 36 w 36"/>
                      <a:gd name="T11" fmla="*/ 99 h 99"/>
                      <a:gd name="T12" fmla="*/ 0 w 36"/>
                      <a:gd name="T13" fmla="*/ 0 h 99"/>
                      <a:gd name="T14" fmla="*/ 36 w 36"/>
                      <a:gd name="T15" fmla="*/ 0 h 99"/>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99">
                        <a:moveTo>
                          <a:pt x="18" y="49"/>
                        </a:moveTo>
                        <a:lnTo>
                          <a:pt x="18" y="99"/>
                        </a:lnTo>
                        <a:moveTo>
                          <a:pt x="18" y="49"/>
                        </a:moveTo>
                        <a:lnTo>
                          <a:pt x="18" y="0"/>
                        </a:lnTo>
                        <a:moveTo>
                          <a:pt x="0" y="99"/>
                        </a:moveTo>
                        <a:lnTo>
                          <a:pt x="36" y="99"/>
                        </a:lnTo>
                        <a:moveTo>
                          <a:pt x="0" y="0"/>
                        </a:moveTo>
                        <a:lnTo>
                          <a:pt x="36" y="0"/>
                        </a:lnTo>
                      </a:path>
                    </a:pathLst>
                  </a:custGeom>
                  <a:noFill/>
                  <a:ln w="9525"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grpSp>
              <p:nvGrpSpPr>
                <p:cNvPr id="6151" name="Group 6150">
                  <a:extLst>
                    <a:ext uri="{FF2B5EF4-FFF2-40B4-BE49-F238E27FC236}">
                      <a16:creationId xmlns:a16="http://schemas.microsoft.com/office/drawing/2014/main" id="{8D971540-9964-4687-AB1F-87A2974C5994}"/>
                    </a:ext>
                  </a:extLst>
                </p:cNvPr>
                <p:cNvGrpSpPr/>
                <p:nvPr/>
              </p:nvGrpSpPr>
              <p:grpSpPr>
                <a:xfrm>
                  <a:off x="7542397" y="1109982"/>
                  <a:ext cx="265595" cy="1665411"/>
                  <a:chOff x="4402285" y="4003176"/>
                  <a:chExt cx="265595" cy="1665411"/>
                </a:xfrm>
              </p:grpSpPr>
              <p:sp>
                <p:nvSpPr>
                  <p:cNvPr id="87" name="Rectangle 47">
                    <a:extLst>
                      <a:ext uri="{FF2B5EF4-FFF2-40B4-BE49-F238E27FC236}">
                        <a16:creationId xmlns:a16="http://schemas.microsoft.com/office/drawing/2014/main" id="{10DEBBC5-DBF9-4C99-A957-09DFD5BB996C}"/>
                      </a:ext>
                    </a:extLst>
                  </p:cNvPr>
                  <p:cNvSpPr>
                    <a:spLocks noChangeArrowheads="1"/>
                  </p:cNvSpPr>
                  <p:nvPr/>
                </p:nvSpPr>
                <p:spPr bwMode="auto">
                  <a:xfrm>
                    <a:off x="4402285" y="4080987"/>
                    <a:ext cx="265595" cy="1587600"/>
                  </a:xfrm>
                  <a:prstGeom prst="rect">
                    <a:avLst/>
                  </a:prstGeom>
                  <a:solidFill>
                    <a:srgbClr val="31A354"/>
                  </a:solidFill>
                  <a:ln w="1270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IN"/>
                  </a:p>
                </p:txBody>
              </p:sp>
              <p:sp>
                <p:nvSpPr>
                  <p:cNvPr id="70" name="Freeform 38">
                    <a:extLst>
                      <a:ext uri="{FF2B5EF4-FFF2-40B4-BE49-F238E27FC236}">
                        <a16:creationId xmlns:a16="http://schemas.microsoft.com/office/drawing/2014/main" id="{207F2878-3D0C-49F6-BECC-204897AAD255}"/>
                      </a:ext>
                    </a:extLst>
                  </p:cNvPr>
                  <p:cNvSpPr>
                    <a:spLocks noEditPoints="1"/>
                  </p:cNvSpPr>
                  <p:nvPr/>
                </p:nvSpPr>
                <p:spPr bwMode="auto">
                  <a:xfrm>
                    <a:off x="4513136" y="4003176"/>
                    <a:ext cx="43895" cy="158509"/>
                  </a:xfrm>
                  <a:custGeom>
                    <a:avLst/>
                    <a:gdLst>
                      <a:gd name="T0" fmla="*/ 17 w 36"/>
                      <a:gd name="T1" fmla="*/ 65 h 130"/>
                      <a:gd name="T2" fmla="*/ 17 w 36"/>
                      <a:gd name="T3" fmla="*/ 130 h 130"/>
                      <a:gd name="T4" fmla="*/ 17 w 36"/>
                      <a:gd name="T5" fmla="*/ 65 h 130"/>
                      <a:gd name="T6" fmla="*/ 17 w 36"/>
                      <a:gd name="T7" fmla="*/ 0 h 130"/>
                      <a:gd name="T8" fmla="*/ 0 w 36"/>
                      <a:gd name="T9" fmla="*/ 130 h 130"/>
                      <a:gd name="T10" fmla="*/ 36 w 36"/>
                      <a:gd name="T11" fmla="*/ 130 h 130"/>
                      <a:gd name="T12" fmla="*/ 0 w 36"/>
                      <a:gd name="T13" fmla="*/ 0 h 130"/>
                      <a:gd name="T14" fmla="*/ 36 w 36"/>
                      <a:gd name="T15" fmla="*/ 0 h 130"/>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130">
                        <a:moveTo>
                          <a:pt x="17" y="65"/>
                        </a:moveTo>
                        <a:lnTo>
                          <a:pt x="17" y="130"/>
                        </a:lnTo>
                        <a:moveTo>
                          <a:pt x="17" y="65"/>
                        </a:moveTo>
                        <a:lnTo>
                          <a:pt x="17" y="0"/>
                        </a:lnTo>
                        <a:moveTo>
                          <a:pt x="0" y="130"/>
                        </a:moveTo>
                        <a:lnTo>
                          <a:pt x="36" y="130"/>
                        </a:lnTo>
                        <a:moveTo>
                          <a:pt x="0" y="0"/>
                        </a:moveTo>
                        <a:lnTo>
                          <a:pt x="36" y="0"/>
                        </a:lnTo>
                      </a:path>
                    </a:pathLst>
                  </a:custGeom>
                  <a:noFill/>
                  <a:ln w="9525" cap="flat">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IN"/>
                  </a:p>
                </p:txBody>
              </p:sp>
            </p:grpSp>
            <p:sp>
              <p:nvSpPr>
                <p:cNvPr id="130" name="TextBox 129">
                  <a:extLst>
                    <a:ext uri="{FF2B5EF4-FFF2-40B4-BE49-F238E27FC236}">
                      <a16:creationId xmlns:a16="http://schemas.microsoft.com/office/drawing/2014/main" id="{20F79E32-9678-4CA4-BEC6-4FE302A11C64}"/>
                    </a:ext>
                  </a:extLst>
                </p:cNvPr>
                <p:cNvSpPr txBox="1"/>
                <p:nvPr/>
              </p:nvSpPr>
              <p:spPr>
                <a:xfrm>
                  <a:off x="6256804" y="346398"/>
                  <a:ext cx="846628" cy="369332"/>
                </a:xfrm>
                <a:prstGeom prst="rect">
                  <a:avLst/>
                </a:prstGeom>
                <a:noFill/>
              </p:spPr>
              <p:txBody>
                <a:bodyPr wrap="square" rtlCol="0">
                  <a:spAutoFit/>
                </a:bodyPr>
                <a:lstStyle/>
                <a:p>
                  <a:pPr algn="ctr"/>
                  <a:r>
                    <a:rPr lang="en-IN" dirty="0"/>
                    <a:t>Leaves</a:t>
                  </a:r>
                </a:p>
              </p:txBody>
            </p:sp>
          </p:grpSp>
        </p:grpSp>
        <p:sp>
          <p:nvSpPr>
            <p:cNvPr id="79" name="TextBox 78">
              <a:extLst>
                <a:ext uri="{FF2B5EF4-FFF2-40B4-BE49-F238E27FC236}">
                  <a16:creationId xmlns:a16="http://schemas.microsoft.com/office/drawing/2014/main" id="{8CCF493C-76B2-4134-B3D3-74DB8D704E64}"/>
                </a:ext>
              </a:extLst>
            </p:cNvPr>
            <p:cNvSpPr txBox="1"/>
            <p:nvPr/>
          </p:nvSpPr>
          <p:spPr>
            <a:xfrm>
              <a:off x="2848842" y="519654"/>
              <a:ext cx="295105" cy="307777"/>
            </a:xfrm>
            <a:prstGeom prst="rect">
              <a:avLst/>
            </a:prstGeom>
            <a:noFill/>
          </p:spPr>
          <p:txBody>
            <a:bodyPr wrap="square" rtlCol="0">
              <a:spAutoFit/>
            </a:bodyPr>
            <a:lstStyle/>
            <a:p>
              <a:pPr algn="ctr"/>
              <a:r>
                <a:rPr lang="en-IN" sz="1400" dirty="0">
                  <a:latin typeface="Calibri "/>
                </a:rPr>
                <a:t>a</a:t>
              </a:r>
            </a:p>
          </p:txBody>
        </p:sp>
        <p:sp>
          <p:nvSpPr>
            <p:cNvPr id="82" name="TextBox 81">
              <a:extLst>
                <a:ext uri="{FF2B5EF4-FFF2-40B4-BE49-F238E27FC236}">
                  <a16:creationId xmlns:a16="http://schemas.microsoft.com/office/drawing/2014/main" id="{41117237-C045-4244-84D8-EBCCB6994A32}"/>
                </a:ext>
              </a:extLst>
            </p:cNvPr>
            <p:cNvSpPr txBox="1"/>
            <p:nvPr/>
          </p:nvSpPr>
          <p:spPr>
            <a:xfrm>
              <a:off x="2167356" y="764052"/>
              <a:ext cx="432267" cy="307777"/>
            </a:xfrm>
            <a:prstGeom prst="rect">
              <a:avLst/>
            </a:prstGeom>
            <a:noFill/>
          </p:spPr>
          <p:txBody>
            <a:bodyPr wrap="square" rtlCol="0">
              <a:spAutoFit/>
            </a:bodyPr>
            <a:lstStyle/>
            <a:p>
              <a:pPr algn="ctr"/>
              <a:r>
                <a:rPr lang="en-IN" sz="1400" dirty="0">
                  <a:latin typeface="Calibri "/>
                </a:rPr>
                <a:t>ab</a:t>
              </a:r>
            </a:p>
          </p:txBody>
        </p:sp>
        <p:sp>
          <p:nvSpPr>
            <p:cNvPr id="99" name="TextBox 98">
              <a:extLst>
                <a:ext uri="{FF2B5EF4-FFF2-40B4-BE49-F238E27FC236}">
                  <a16:creationId xmlns:a16="http://schemas.microsoft.com/office/drawing/2014/main" id="{22A553D8-21C9-47CB-AD3E-BD3BF3B0A2BB}"/>
                </a:ext>
              </a:extLst>
            </p:cNvPr>
            <p:cNvSpPr txBox="1"/>
            <p:nvPr/>
          </p:nvSpPr>
          <p:spPr>
            <a:xfrm>
              <a:off x="3470942" y="950211"/>
              <a:ext cx="432267" cy="307777"/>
            </a:xfrm>
            <a:prstGeom prst="rect">
              <a:avLst/>
            </a:prstGeom>
            <a:noFill/>
          </p:spPr>
          <p:txBody>
            <a:bodyPr wrap="square" rtlCol="0">
              <a:spAutoFit/>
            </a:bodyPr>
            <a:lstStyle/>
            <a:p>
              <a:pPr algn="ctr"/>
              <a:r>
                <a:rPr lang="en-IN" sz="1400" dirty="0">
                  <a:latin typeface="Calibri "/>
                </a:rPr>
                <a:t>b</a:t>
              </a:r>
            </a:p>
          </p:txBody>
        </p:sp>
        <p:sp>
          <p:nvSpPr>
            <p:cNvPr id="100" name="TextBox 99">
              <a:extLst>
                <a:ext uri="{FF2B5EF4-FFF2-40B4-BE49-F238E27FC236}">
                  <a16:creationId xmlns:a16="http://schemas.microsoft.com/office/drawing/2014/main" id="{EFA34FC7-B58C-48D2-A28C-F7993AAC3DD2}"/>
                </a:ext>
              </a:extLst>
            </p:cNvPr>
            <p:cNvSpPr txBox="1"/>
            <p:nvPr/>
          </p:nvSpPr>
          <p:spPr>
            <a:xfrm>
              <a:off x="4132392" y="1021737"/>
              <a:ext cx="432267" cy="307777"/>
            </a:xfrm>
            <a:prstGeom prst="rect">
              <a:avLst/>
            </a:prstGeom>
            <a:noFill/>
          </p:spPr>
          <p:txBody>
            <a:bodyPr wrap="square" rtlCol="0">
              <a:spAutoFit/>
            </a:bodyPr>
            <a:lstStyle/>
            <a:p>
              <a:pPr algn="ctr"/>
              <a:r>
                <a:rPr lang="en-IN" sz="1400" dirty="0">
                  <a:latin typeface="Calibri "/>
                </a:rPr>
                <a:t>b</a:t>
              </a:r>
            </a:p>
          </p:txBody>
        </p:sp>
      </p:gr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63</TotalTime>
  <Words>882</Words>
  <Application>Microsoft Office PowerPoint</Application>
  <PresentationFormat>On-screen Show (4:3)</PresentationFormat>
  <Paragraphs>216</Paragraphs>
  <Slides>5</Slides>
  <Notes>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 Calibri </vt:lpstr>
      <vt:lpstr>Arial</vt:lpstr>
      <vt:lpstr>Calibri</vt:lpstr>
      <vt:lpstr>Calibri </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jay kumar</dc:creator>
  <cp:lastModifiedBy>vijay kumar</cp:lastModifiedBy>
  <cp:revision>7</cp:revision>
  <dcterms:created xsi:type="dcterms:W3CDTF">2006-08-16T00:00:00Z</dcterms:created>
  <dcterms:modified xsi:type="dcterms:W3CDTF">2020-09-17T19:04:28Z</dcterms:modified>
</cp:coreProperties>
</file>